
<file path=[Content_Types].xml><?xml version="1.0" encoding="utf-8"?>
<Types xmlns="http://schemas.openxmlformats.org/package/2006/content-types">
  <Default Extension="jpeg" ContentType="image/jpeg"/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2"/>
  </p:notesMasterIdLst>
  <p:sldIdLst>
    <p:sldId id="256" r:id="rId2"/>
    <p:sldId id="257" r:id="rId3"/>
    <p:sldId id="258" r:id="rId4"/>
    <p:sldId id="374" r:id="rId5"/>
    <p:sldId id="375" r:id="rId6"/>
    <p:sldId id="376" r:id="rId7"/>
    <p:sldId id="262" r:id="rId8"/>
    <p:sldId id="263" r:id="rId9"/>
    <p:sldId id="264" r:id="rId10"/>
    <p:sldId id="265" r:id="rId11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>
      <p:cViewPr varScale="1">
        <p:scale>
          <a:sx n="50" d="100"/>
          <a:sy n="50" d="100"/>
        </p:scale>
        <p:origin x="221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ACA505-2898-4299-B348-DE27A95A0AFF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6B791F-78CB-4AA9-AA0B-D27DFE7D67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3275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5037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780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177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129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883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660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246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24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954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629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33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6A750C-5820-4DC0-BD60-65196F9BF18E}" type="datetimeFigureOut">
              <a:rPr lang="en-GB" smtClean="0"/>
              <a:t>06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0910B-1649-4145-9D55-0B2B377E5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880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7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13" Type="http://schemas.openxmlformats.org/officeDocument/2006/relationships/image" Target="../media/image23.png"/><Relationship Id="rId3" Type="http://schemas.openxmlformats.org/officeDocument/2006/relationships/image" Target="../media/image13.jpg"/><Relationship Id="rId7" Type="http://schemas.openxmlformats.org/officeDocument/2006/relationships/image" Target="../media/image17.png"/><Relationship Id="rId12" Type="http://schemas.openxmlformats.org/officeDocument/2006/relationships/image" Target="../media/image22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jp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3" Type="http://schemas.openxmlformats.org/officeDocument/2006/relationships/image" Target="../media/image25.png"/><Relationship Id="rId7" Type="http://schemas.openxmlformats.org/officeDocument/2006/relationships/image" Target="../media/image29.jpg"/><Relationship Id="rId12" Type="http://schemas.openxmlformats.org/officeDocument/2006/relationships/image" Target="../media/image34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jp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10" Type="http://schemas.openxmlformats.org/officeDocument/2006/relationships/image" Target="../media/image32.jpg"/><Relationship Id="rId4" Type="http://schemas.openxmlformats.org/officeDocument/2006/relationships/image" Target="../media/image26.png"/><Relationship Id="rId9" Type="http://schemas.openxmlformats.org/officeDocument/2006/relationships/image" Target="../media/image31.jpg"/><Relationship Id="rId14" Type="http://schemas.openxmlformats.org/officeDocument/2006/relationships/image" Target="../media/image3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jpg"/><Relationship Id="rId13" Type="http://schemas.openxmlformats.org/officeDocument/2006/relationships/image" Target="../media/image49.png"/><Relationship Id="rId3" Type="http://schemas.openxmlformats.org/officeDocument/2006/relationships/image" Target="../media/image39.jpg"/><Relationship Id="rId7" Type="http://schemas.openxmlformats.org/officeDocument/2006/relationships/image" Target="../media/image43.jpg"/><Relationship Id="rId12" Type="http://schemas.openxmlformats.org/officeDocument/2006/relationships/image" Target="../media/image48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jpg"/><Relationship Id="rId11" Type="http://schemas.openxmlformats.org/officeDocument/2006/relationships/image" Target="../media/image47.jpg"/><Relationship Id="rId5" Type="http://schemas.openxmlformats.org/officeDocument/2006/relationships/image" Target="../media/image41.jpg"/><Relationship Id="rId10" Type="http://schemas.openxmlformats.org/officeDocument/2006/relationships/image" Target="../media/image46.jpg"/><Relationship Id="rId4" Type="http://schemas.openxmlformats.org/officeDocument/2006/relationships/image" Target="../media/image40.jpg"/><Relationship Id="rId9" Type="http://schemas.openxmlformats.org/officeDocument/2006/relationships/image" Target="../media/image45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3" Type="http://schemas.openxmlformats.org/officeDocument/2006/relationships/image" Target="../media/image50.jpg"/><Relationship Id="rId7" Type="http://schemas.openxmlformats.org/officeDocument/2006/relationships/image" Target="../media/image54.png"/><Relationship Id="rId12" Type="http://schemas.openxmlformats.org/officeDocument/2006/relationships/image" Target="../media/image59.jp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6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jpg"/><Relationship Id="rId11" Type="http://schemas.openxmlformats.org/officeDocument/2006/relationships/image" Target="../media/image58.png"/><Relationship Id="rId5" Type="http://schemas.openxmlformats.org/officeDocument/2006/relationships/image" Target="../media/image52.jp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jpg"/><Relationship Id="rId14" Type="http://schemas.openxmlformats.org/officeDocument/2006/relationships/image" Target="../media/image61.png"/></Relationships>
</file>

<file path=ppt/slides/_rels/slide7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4.jpg"/><Relationship Id="rId18" Type="http://schemas.openxmlformats.org/officeDocument/2006/relationships/image" Target="../media/image79.png"/><Relationship Id="rId26" Type="http://schemas.openxmlformats.org/officeDocument/2006/relationships/image" Target="../media/image87.jpg"/><Relationship Id="rId39" Type="http://schemas.openxmlformats.org/officeDocument/2006/relationships/image" Target="../media/image100.jpg"/><Relationship Id="rId21" Type="http://schemas.openxmlformats.org/officeDocument/2006/relationships/image" Target="../media/image82.jpg"/><Relationship Id="rId34" Type="http://schemas.openxmlformats.org/officeDocument/2006/relationships/image" Target="../media/image95.png"/><Relationship Id="rId42" Type="http://schemas.openxmlformats.org/officeDocument/2006/relationships/image" Target="../media/image103.jpg"/><Relationship Id="rId47" Type="http://schemas.openxmlformats.org/officeDocument/2006/relationships/image" Target="../media/image108.jpg"/><Relationship Id="rId50" Type="http://schemas.openxmlformats.org/officeDocument/2006/relationships/image" Target="../media/image111.png"/><Relationship Id="rId7" Type="http://schemas.openxmlformats.org/officeDocument/2006/relationships/image" Target="../media/image68.png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77.png"/><Relationship Id="rId29" Type="http://schemas.openxmlformats.org/officeDocument/2006/relationships/image" Target="../media/image90.png"/><Relationship Id="rId11" Type="http://schemas.openxmlformats.org/officeDocument/2006/relationships/image" Target="../media/image72.jpg"/><Relationship Id="rId24" Type="http://schemas.openxmlformats.org/officeDocument/2006/relationships/image" Target="../media/image85.jpg"/><Relationship Id="rId32" Type="http://schemas.openxmlformats.org/officeDocument/2006/relationships/image" Target="../media/image93.jpg"/><Relationship Id="rId37" Type="http://schemas.openxmlformats.org/officeDocument/2006/relationships/image" Target="../media/image98.jpg"/><Relationship Id="rId40" Type="http://schemas.openxmlformats.org/officeDocument/2006/relationships/image" Target="../media/image101.jpg"/><Relationship Id="rId45" Type="http://schemas.openxmlformats.org/officeDocument/2006/relationships/image" Target="../media/image106.jpg"/><Relationship Id="rId5" Type="http://schemas.openxmlformats.org/officeDocument/2006/relationships/image" Target="../media/image66.png"/><Relationship Id="rId15" Type="http://schemas.openxmlformats.org/officeDocument/2006/relationships/image" Target="../media/image76.png"/><Relationship Id="rId23" Type="http://schemas.openxmlformats.org/officeDocument/2006/relationships/image" Target="../media/image84.jpg"/><Relationship Id="rId28" Type="http://schemas.openxmlformats.org/officeDocument/2006/relationships/image" Target="../media/image89.png"/><Relationship Id="rId36" Type="http://schemas.openxmlformats.org/officeDocument/2006/relationships/image" Target="../media/image97.jpg"/><Relationship Id="rId49" Type="http://schemas.openxmlformats.org/officeDocument/2006/relationships/image" Target="../media/image110.png"/><Relationship Id="rId10" Type="http://schemas.openxmlformats.org/officeDocument/2006/relationships/image" Target="../media/image71.jpg"/><Relationship Id="rId19" Type="http://schemas.openxmlformats.org/officeDocument/2006/relationships/image" Target="../media/image80.png"/><Relationship Id="rId31" Type="http://schemas.openxmlformats.org/officeDocument/2006/relationships/image" Target="../media/image92.png"/><Relationship Id="rId44" Type="http://schemas.openxmlformats.org/officeDocument/2006/relationships/image" Target="../media/image105.jpg"/><Relationship Id="rId4" Type="http://schemas.openxmlformats.org/officeDocument/2006/relationships/image" Target="../media/image65.jpg"/><Relationship Id="rId9" Type="http://schemas.openxmlformats.org/officeDocument/2006/relationships/image" Target="../media/image70.jpg"/><Relationship Id="rId14" Type="http://schemas.openxmlformats.org/officeDocument/2006/relationships/image" Target="../media/image75.png"/><Relationship Id="rId22" Type="http://schemas.openxmlformats.org/officeDocument/2006/relationships/image" Target="../media/image83.png"/><Relationship Id="rId27" Type="http://schemas.openxmlformats.org/officeDocument/2006/relationships/image" Target="../media/image88.jpg"/><Relationship Id="rId30" Type="http://schemas.openxmlformats.org/officeDocument/2006/relationships/image" Target="../media/image91.png"/><Relationship Id="rId35" Type="http://schemas.openxmlformats.org/officeDocument/2006/relationships/image" Target="../media/image96.png"/><Relationship Id="rId43" Type="http://schemas.openxmlformats.org/officeDocument/2006/relationships/image" Target="../media/image104.jpg"/><Relationship Id="rId48" Type="http://schemas.openxmlformats.org/officeDocument/2006/relationships/image" Target="../media/image109.jpg"/><Relationship Id="rId8" Type="http://schemas.openxmlformats.org/officeDocument/2006/relationships/image" Target="../media/image69.png"/><Relationship Id="rId51" Type="http://schemas.openxmlformats.org/officeDocument/2006/relationships/image" Target="../media/image112.png"/><Relationship Id="rId3" Type="http://schemas.openxmlformats.org/officeDocument/2006/relationships/image" Target="../media/image64.jpg"/><Relationship Id="rId12" Type="http://schemas.openxmlformats.org/officeDocument/2006/relationships/image" Target="../media/image73.jpg"/><Relationship Id="rId17" Type="http://schemas.openxmlformats.org/officeDocument/2006/relationships/image" Target="../media/image78.png"/><Relationship Id="rId25" Type="http://schemas.openxmlformats.org/officeDocument/2006/relationships/image" Target="../media/image86.jpg"/><Relationship Id="rId33" Type="http://schemas.openxmlformats.org/officeDocument/2006/relationships/image" Target="../media/image94.jpg"/><Relationship Id="rId38" Type="http://schemas.openxmlformats.org/officeDocument/2006/relationships/image" Target="../media/image99.jpg"/><Relationship Id="rId46" Type="http://schemas.openxmlformats.org/officeDocument/2006/relationships/image" Target="../media/image107.jpg"/><Relationship Id="rId20" Type="http://schemas.openxmlformats.org/officeDocument/2006/relationships/image" Target="../media/image81.jpg"/><Relationship Id="rId41" Type="http://schemas.openxmlformats.org/officeDocument/2006/relationships/image" Target="../media/image10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8.jpg"/><Relationship Id="rId13" Type="http://schemas.openxmlformats.org/officeDocument/2006/relationships/image" Target="../media/image123.jpg"/><Relationship Id="rId18" Type="http://schemas.openxmlformats.org/officeDocument/2006/relationships/image" Target="../media/image128.jpg"/><Relationship Id="rId3" Type="http://schemas.openxmlformats.org/officeDocument/2006/relationships/image" Target="../media/image113.jpg"/><Relationship Id="rId21" Type="http://schemas.openxmlformats.org/officeDocument/2006/relationships/image" Target="../media/image131.png"/><Relationship Id="rId7" Type="http://schemas.openxmlformats.org/officeDocument/2006/relationships/image" Target="../media/image117.jpg"/><Relationship Id="rId12" Type="http://schemas.openxmlformats.org/officeDocument/2006/relationships/image" Target="../media/image122.jpg"/><Relationship Id="rId17" Type="http://schemas.openxmlformats.org/officeDocument/2006/relationships/image" Target="../media/image127.jpg"/><Relationship Id="rId25" Type="http://schemas.openxmlformats.org/officeDocument/2006/relationships/image" Target="../media/image135.jpg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126.jpg"/><Relationship Id="rId20" Type="http://schemas.openxmlformats.org/officeDocument/2006/relationships/image" Target="../media/image1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6.jpg"/><Relationship Id="rId11" Type="http://schemas.openxmlformats.org/officeDocument/2006/relationships/image" Target="../media/image121.jpg"/><Relationship Id="rId24" Type="http://schemas.openxmlformats.org/officeDocument/2006/relationships/image" Target="../media/image134.jpg"/><Relationship Id="rId5" Type="http://schemas.openxmlformats.org/officeDocument/2006/relationships/image" Target="../media/image115.jpg"/><Relationship Id="rId15" Type="http://schemas.openxmlformats.org/officeDocument/2006/relationships/image" Target="../media/image125.jpg"/><Relationship Id="rId23" Type="http://schemas.openxmlformats.org/officeDocument/2006/relationships/image" Target="../media/image133.jpg"/><Relationship Id="rId10" Type="http://schemas.openxmlformats.org/officeDocument/2006/relationships/image" Target="../media/image120.jpg"/><Relationship Id="rId19" Type="http://schemas.openxmlformats.org/officeDocument/2006/relationships/image" Target="../media/image129.jpg"/><Relationship Id="rId4" Type="http://schemas.openxmlformats.org/officeDocument/2006/relationships/image" Target="../media/image114.png"/><Relationship Id="rId9" Type="http://schemas.openxmlformats.org/officeDocument/2006/relationships/image" Target="../media/image119.jpg"/><Relationship Id="rId14" Type="http://schemas.openxmlformats.org/officeDocument/2006/relationships/image" Target="../media/image124.jpg"/><Relationship Id="rId22" Type="http://schemas.openxmlformats.org/officeDocument/2006/relationships/image" Target="../media/image132.jpg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6.jpg"/><Relationship Id="rId18" Type="http://schemas.openxmlformats.org/officeDocument/2006/relationships/image" Target="../media/image151.png"/><Relationship Id="rId26" Type="http://schemas.openxmlformats.org/officeDocument/2006/relationships/image" Target="../media/image159.jpg"/><Relationship Id="rId39" Type="http://schemas.openxmlformats.org/officeDocument/2006/relationships/image" Target="../media/image172.jpg"/><Relationship Id="rId21" Type="http://schemas.openxmlformats.org/officeDocument/2006/relationships/image" Target="../media/image154.jpg"/><Relationship Id="rId34" Type="http://schemas.openxmlformats.org/officeDocument/2006/relationships/image" Target="../media/image167.jpg"/><Relationship Id="rId42" Type="http://schemas.openxmlformats.org/officeDocument/2006/relationships/image" Target="../media/image175.jpg"/><Relationship Id="rId7" Type="http://schemas.openxmlformats.org/officeDocument/2006/relationships/image" Target="../media/image140.png"/><Relationship Id="rId2" Type="http://schemas.openxmlformats.org/officeDocument/2006/relationships/notesSlide" Target="../notesSlides/notesSlide9.xml"/><Relationship Id="rId16" Type="http://schemas.openxmlformats.org/officeDocument/2006/relationships/image" Target="../media/image149.jpg"/><Relationship Id="rId20" Type="http://schemas.openxmlformats.org/officeDocument/2006/relationships/image" Target="../media/image153.png"/><Relationship Id="rId29" Type="http://schemas.openxmlformats.org/officeDocument/2006/relationships/image" Target="../media/image162.jpg"/><Relationship Id="rId41" Type="http://schemas.openxmlformats.org/officeDocument/2006/relationships/image" Target="../media/image17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9.jpg"/><Relationship Id="rId11" Type="http://schemas.openxmlformats.org/officeDocument/2006/relationships/image" Target="../media/image144.jpg"/><Relationship Id="rId24" Type="http://schemas.openxmlformats.org/officeDocument/2006/relationships/image" Target="../media/image157.jpg"/><Relationship Id="rId32" Type="http://schemas.openxmlformats.org/officeDocument/2006/relationships/image" Target="../media/image165.jpg"/><Relationship Id="rId37" Type="http://schemas.openxmlformats.org/officeDocument/2006/relationships/image" Target="../media/image170.jpg"/><Relationship Id="rId40" Type="http://schemas.openxmlformats.org/officeDocument/2006/relationships/image" Target="../media/image173.jpg"/><Relationship Id="rId5" Type="http://schemas.openxmlformats.org/officeDocument/2006/relationships/image" Target="../media/image138.jpg"/><Relationship Id="rId15" Type="http://schemas.openxmlformats.org/officeDocument/2006/relationships/image" Target="../media/image148.jpg"/><Relationship Id="rId23" Type="http://schemas.openxmlformats.org/officeDocument/2006/relationships/image" Target="../media/image156.jpg"/><Relationship Id="rId28" Type="http://schemas.openxmlformats.org/officeDocument/2006/relationships/image" Target="../media/image161.jpg"/><Relationship Id="rId36" Type="http://schemas.openxmlformats.org/officeDocument/2006/relationships/image" Target="../media/image169.jpg"/><Relationship Id="rId10" Type="http://schemas.openxmlformats.org/officeDocument/2006/relationships/image" Target="../media/image143.jpg"/><Relationship Id="rId19" Type="http://schemas.openxmlformats.org/officeDocument/2006/relationships/image" Target="../media/image152.jpg"/><Relationship Id="rId31" Type="http://schemas.openxmlformats.org/officeDocument/2006/relationships/image" Target="../media/image164.jpg"/><Relationship Id="rId4" Type="http://schemas.openxmlformats.org/officeDocument/2006/relationships/image" Target="../media/image137.jpg"/><Relationship Id="rId9" Type="http://schemas.openxmlformats.org/officeDocument/2006/relationships/image" Target="../media/image142.jpg"/><Relationship Id="rId14" Type="http://schemas.openxmlformats.org/officeDocument/2006/relationships/image" Target="../media/image147.jpg"/><Relationship Id="rId22" Type="http://schemas.openxmlformats.org/officeDocument/2006/relationships/image" Target="../media/image155.png"/><Relationship Id="rId27" Type="http://schemas.openxmlformats.org/officeDocument/2006/relationships/image" Target="../media/image160.jpg"/><Relationship Id="rId30" Type="http://schemas.openxmlformats.org/officeDocument/2006/relationships/image" Target="../media/image163.jpg"/><Relationship Id="rId35" Type="http://schemas.openxmlformats.org/officeDocument/2006/relationships/image" Target="../media/image168.jpg"/><Relationship Id="rId43" Type="http://schemas.openxmlformats.org/officeDocument/2006/relationships/image" Target="../media/image176.png"/><Relationship Id="rId8" Type="http://schemas.openxmlformats.org/officeDocument/2006/relationships/image" Target="../media/image141.jpg"/><Relationship Id="rId3" Type="http://schemas.openxmlformats.org/officeDocument/2006/relationships/image" Target="../media/image136.jpg"/><Relationship Id="rId12" Type="http://schemas.openxmlformats.org/officeDocument/2006/relationships/image" Target="../media/image145.jpg"/><Relationship Id="rId17" Type="http://schemas.openxmlformats.org/officeDocument/2006/relationships/image" Target="../media/image150.jpg"/><Relationship Id="rId25" Type="http://schemas.openxmlformats.org/officeDocument/2006/relationships/image" Target="../media/image158.jpg"/><Relationship Id="rId33" Type="http://schemas.openxmlformats.org/officeDocument/2006/relationships/image" Target="../media/image166.jpg"/><Relationship Id="rId38" Type="http://schemas.openxmlformats.org/officeDocument/2006/relationships/image" Target="../media/image17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112749" y="626432"/>
            <a:ext cx="2647694" cy="36272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2357" spc="-5" dirty="0">
                <a:latin typeface="Times New Roman"/>
                <a:cs typeface="Times New Roman"/>
              </a:rPr>
              <a:t>Sup</a:t>
            </a:r>
            <a:r>
              <a:rPr sz="2357" spc="5" dirty="0">
                <a:latin typeface="Times New Roman"/>
                <a:cs typeface="Times New Roman"/>
              </a:rPr>
              <a:t>p</a:t>
            </a:r>
            <a:r>
              <a:rPr sz="2357" dirty="0">
                <a:latin typeface="Times New Roman"/>
                <a:cs typeface="Times New Roman"/>
              </a:rPr>
              <a:t>l</a:t>
            </a:r>
            <a:r>
              <a:rPr sz="2357" spc="-23" dirty="0">
                <a:latin typeface="Times New Roman"/>
                <a:cs typeface="Times New Roman"/>
              </a:rPr>
              <a:t>e</a:t>
            </a:r>
            <a:r>
              <a:rPr sz="2357" dirty="0">
                <a:latin typeface="Times New Roman"/>
                <a:cs typeface="Times New Roman"/>
              </a:rPr>
              <a:t>me</a:t>
            </a:r>
            <a:r>
              <a:rPr sz="2357" spc="-9" dirty="0">
                <a:latin typeface="Times New Roman"/>
                <a:cs typeface="Times New Roman"/>
              </a:rPr>
              <a:t>n</a:t>
            </a:r>
            <a:r>
              <a:rPr sz="2357" dirty="0">
                <a:latin typeface="Times New Roman"/>
                <a:cs typeface="Times New Roman"/>
              </a:rPr>
              <a:t>t</a:t>
            </a:r>
            <a:r>
              <a:rPr sz="2357" spc="-9" dirty="0">
                <a:latin typeface="Times New Roman"/>
                <a:cs typeface="Times New Roman"/>
              </a:rPr>
              <a:t>a</a:t>
            </a:r>
            <a:r>
              <a:rPr sz="2357" dirty="0">
                <a:latin typeface="Times New Roman"/>
                <a:cs typeface="Times New Roman"/>
              </a:rPr>
              <a:t>l </a:t>
            </a:r>
            <a:r>
              <a:rPr sz="2357" spc="-14" dirty="0">
                <a:latin typeface="Times New Roman"/>
                <a:cs typeface="Times New Roman"/>
              </a:rPr>
              <a:t>f</a:t>
            </a:r>
            <a:r>
              <a:rPr sz="2357" dirty="0">
                <a:latin typeface="Times New Roman"/>
                <a:cs typeface="Times New Roman"/>
              </a:rPr>
              <a:t>igure</a:t>
            </a:r>
            <a:r>
              <a:rPr sz="2357" spc="-14" dirty="0">
                <a:latin typeface="Times New Roman"/>
                <a:cs typeface="Times New Roman"/>
              </a:rPr>
              <a:t>s</a:t>
            </a:r>
            <a:r>
              <a:rPr sz="2357" dirty="0">
                <a:latin typeface="Times New Roman"/>
                <a:cs typeface="Times New Roman"/>
              </a:rPr>
              <a:t>.</a:t>
            </a:r>
            <a:endParaRPr sz="2357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137623" y="7105145"/>
            <a:ext cx="6484606" cy="98001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1400"/>
              </a:lnSpc>
            </a:pPr>
            <a:r>
              <a:rPr sz="1087" b="1" dirty="0">
                <a:latin typeface="Times New Roman"/>
                <a:cs typeface="Times New Roman"/>
              </a:rPr>
              <a:t>Su</a:t>
            </a:r>
            <a:r>
              <a:rPr sz="1087" b="1" spc="-9" dirty="0">
                <a:latin typeface="Times New Roman"/>
                <a:cs typeface="Times New Roman"/>
              </a:rPr>
              <a:t>p</a:t>
            </a:r>
            <a:r>
              <a:rPr sz="1087" b="1" dirty="0">
                <a:latin typeface="Times New Roman"/>
                <a:cs typeface="Times New Roman"/>
              </a:rPr>
              <a:t>p</a:t>
            </a:r>
            <a:r>
              <a:rPr sz="1087" b="1" spc="-9" dirty="0">
                <a:latin typeface="Times New Roman"/>
                <a:cs typeface="Times New Roman"/>
              </a:rPr>
              <a:t>lem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</a:t>
            </a:r>
            <a:r>
              <a:rPr sz="1087" b="1" spc="-5" dirty="0">
                <a:latin typeface="Times New Roman"/>
                <a:cs typeface="Times New Roman"/>
              </a:rPr>
              <a:t>tal</a:t>
            </a:r>
            <a:r>
              <a:rPr sz="1087" b="1" spc="18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figu</a:t>
            </a:r>
            <a:r>
              <a:rPr sz="1087" b="1" spc="-14" dirty="0">
                <a:latin typeface="Times New Roman"/>
                <a:cs typeface="Times New Roman"/>
              </a:rPr>
              <a:t>r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spc="14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9. </a:t>
            </a:r>
            <a:r>
              <a:rPr sz="1087" b="1" spc="50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Ult</a:t>
            </a:r>
            <a:r>
              <a:rPr sz="1087" b="1" spc="-18" dirty="0">
                <a:latin typeface="Times New Roman"/>
                <a:cs typeface="Times New Roman"/>
              </a:rPr>
              <a:t>r</a:t>
            </a:r>
            <a:r>
              <a:rPr sz="1087" b="1" dirty="0">
                <a:latin typeface="Times New Roman"/>
                <a:cs typeface="Times New Roman"/>
              </a:rPr>
              <a:t>as</a:t>
            </a:r>
            <a:r>
              <a:rPr sz="1087" b="1" spc="5" dirty="0">
                <a:latin typeface="Times New Roman"/>
                <a:cs typeface="Times New Roman"/>
              </a:rPr>
              <a:t>t</a:t>
            </a:r>
            <a:r>
              <a:rPr sz="1087" b="1" spc="-14" dirty="0">
                <a:latin typeface="Times New Roman"/>
                <a:cs typeface="Times New Roman"/>
              </a:rPr>
              <a:t>r</a:t>
            </a:r>
            <a:r>
              <a:rPr sz="1087" b="1" dirty="0">
                <a:latin typeface="Times New Roman"/>
                <a:cs typeface="Times New Roman"/>
              </a:rPr>
              <a:t>u</a:t>
            </a:r>
            <a:r>
              <a:rPr sz="1087" b="1" spc="-14" dirty="0">
                <a:latin typeface="Times New Roman"/>
                <a:cs typeface="Times New Roman"/>
              </a:rPr>
              <a:t>c</a:t>
            </a:r>
            <a:r>
              <a:rPr sz="1087" b="1" dirty="0">
                <a:latin typeface="Times New Roman"/>
                <a:cs typeface="Times New Roman"/>
              </a:rPr>
              <a:t>tu</a:t>
            </a:r>
            <a:r>
              <a:rPr sz="1087" b="1" spc="5" dirty="0">
                <a:latin typeface="Times New Roman"/>
                <a:cs typeface="Times New Roman"/>
              </a:rPr>
              <a:t>r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spc="14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of</a:t>
            </a:r>
            <a:r>
              <a:rPr sz="1087" b="1" spc="28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L</a:t>
            </a:r>
            <a:r>
              <a:rPr sz="1087" b="1" spc="-5" dirty="0">
                <a:latin typeface="Times New Roman"/>
                <a:cs typeface="Times New Roman"/>
              </a:rPr>
              <a:t>C</a:t>
            </a:r>
            <a:r>
              <a:rPr sz="1087" b="1" dirty="0">
                <a:latin typeface="Times New Roman"/>
                <a:cs typeface="Times New Roman"/>
              </a:rPr>
              <a:t>3</a:t>
            </a:r>
            <a:r>
              <a:rPr sz="1087" b="1" spc="28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pun</a:t>
            </a:r>
            <a:r>
              <a:rPr sz="1087" b="1" spc="-14" dirty="0">
                <a:latin typeface="Times New Roman"/>
                <a:cs typeface="Times New Roman"/>
              </a:rPr>
              <a:t>c</a:t>
            </a:r>
            <a:r>
              <a:rPr sz="1087" b="1" dirty="0">
                <a:latin typeface="Times New Roman"/>
                <a:cs typeface="Times New Roman"/>
              </a:rPr>
              <a:t>t</a:t>
            </a:r>
            <a:r>
              <a:rPr sz="1087" b="1" spc="23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.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ME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gr</a:t>
            </a:r>
            <a:r>
              <a:rPr sz="1087" spc="5" dirty="0">
                <a:latin typeface="Times New Roman"/>
                <a:cs typeface="Times New Roman"/>
              </a:rPr>
              <a:t>o</a:t>
            </a:r>
            <a:r>
              <a:rPr sz="1087" spc="-5" dirty="0">
                <a:latin typeface="Times New Roman"/>
                <a:cs typeface="Times New Roman"/>
              </a:rPr>
              <a:t>win</a:t>
            </a:r>
            <a:r>
              <a:rPr sz="1087" dirty="0">
                <a:latin typeface="Times New Roman"/>
                <a:cs typeface="Times New Roman"/>
              </a:rPr>
              <a:t>g</a:t>
            </a:r>
            <a:r>
              <a:rPr sz="1087" spc="33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on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grid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dishes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w</a:t>
            </a:r>
            <a:r>
              <a:rPr sz="1087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re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t</a:t>
            </a:r>
            <a:r>
              <a:rPr sz="1087" spc="-5" dirty="0">
                <a:latin typeface="Times New Roman"/>
                <a:cs typeface="Times New Roman"/>
              </a:rPr>
              <a:t>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-9" dirty="0">
                <a:latin typeface="Times New Roman"/>
                <a:cs typeface="Times New Roman"/>
              </a:rPr>
              <a:t>du</a:t>
            </a:r>
            <a:r>
              <a:rPr sz="1087" spc="-14" dirty="0">
                <a:latin typeface="Times New Roman"/>
                <a:cs typeface="Times New Roman"/>
              </a:rPr>
              <a:t>ce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wit</a:t>
            </a:r>
            <a:r>
              <a:rPr sz="1087" spc="-9" dirty="0">
                <a:latin typeface="Times New Roman"/>
                <a:cs typeface="Times New Roman"/>
              </a:rPr>
              <a:t>h</a:t>
            </a:r>
            <a:r>
              <a:rPr sz="1087" spc="23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LC</a:t>
            </a:r>
            <a:r>
              <a:rPr sz="1087" dirty="0">
                <a:latin typeface="Times New Roman"/>
                <a:cs typeface="Times New Roman"/>
              </a:rPr>
              <a:t>3- G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P</a:t>
            </a:r>
            <a:r>
              <a:rPr sz="1087" spc="100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spc="-5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novirus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in</a:t>
            </a:r>
            <a:r>
              <a:rPr sz="1087" spc="5" dirty="0">
                <a:latin typeface="Times New Roman"/>
                <a:cs typeface="Times New Roman"/>
              </a:rPr>
              <a:t>c</a:t>
            </a:r>
            <a:r>
              <a:rPr sz="1087" dirty="0">
                <a:latin typeface="Times New Roman"/>
                <a:cs typeface="Times New Roman"/>
              </a:rPr>
              <a:t>ub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ted</a:t>
            </a:r>
            <a:r>
              <a:rPr sz="1087" spc="91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with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c</a:t>
            </a:r>
            <a:r>
              <a:rPr sz="1087" dirty="0">
                <a:latin typeface="Times New Roman"/>
                <a:cs typeface="Times New Roman"/>
              </a:rPr>
              <a:t>hloroquine</a:t>
            </a:r>
            <a:r>
              <a:rPr sz="1087" spc="100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(100μM).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ixed</a:t>
            </a:r>
            <a:r>
              <a:rPr sz="1087" spc="91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ce</a:t>
            </a:r>
            <a:r>
              <a:rPr sz="1087" dirty="0">
                <a:latin typeface="Times New Roman"/>
                <a:cs typeface="Times New Roman"/>
              </a:rPr>
              <a:t>lls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p</a:t>
            </a:r>
            <a:r>
              <a:rPr sz="1087" spc="-5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rm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bilised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with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ponin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w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re</a:t>
            </a:r>
            <a:r>
              <a:rPr sz="1087" spc="86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incu</a:t>
            </a:r>
            <a:r>
              <a:rPr sz="1087" spc="5" dirty="0">
                <a:latin typeface="Times New Roman"/>
                <a:cs typeface="Times New Roman"/>
              </a:rPr>
              <a:t>b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ted </a:t>
            </a:r>
            <a:r>
              <a:rPr sz="1087" spc="-14" dirty="0">
                <a:latin typeface="Times New Roman"/>
                <a:cs typeface="Times New Roman"/>
              </a:rPr>
              <a:t>wit</a:t>
            </a:r>
            <a:r>
              <a:rPr sz="1087" spc="-9" dirty="0">
                <a:latin typeface="Times New Roman"/>
                <a:cs typeface="Times New Roman"/>
              </a:rPr>
              <a:t>h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bbi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nti</a:t>
            </a:r>
            <a:r>
              <a:rPr sz="1087" dirty="0">
                <a:latin typeface="Times New Roman"/>
                <a:cs typeface="Times New Roman"/>
              </a:rPr>
              <a:t>body 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ins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G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P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follow</a:t>
            </a:r>
            <a:r>
              <a:rPr sz="1087" spc="-18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 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by 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nti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bbi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n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9" dirty="0">
                <a:latin typeface="Times New Roman"/>
                <a:cs typeface="Times New Roman"/>
              </a:rPr>
              <a:t>nogol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 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si</a:t>
            </a:r>
            <a:r>
              <a:rPr sz="1087" dirty="0">
                <a:latin typeface="Times New Roman"/>
                <a:cs typeface="Times New Roman"/>
              </a:rPr>
              <a:t>l</a:t>
            </a:r>
            <a:r>
              <a:rPr sz="1087" spc="-9" dirty="0">
                <a:latin typeface="Times New Roman"/>
                <a:cs typeface="Times New Roman"/>
              </a:rPr>
              <a:t>v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r 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9" dirty="0">
                <a:latin typeface="Times New Roman"/>
                <a:cs typeface="Times New Roman"/>
              </a:rPr>
              <a:t>nh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9" dirty="0">
                <a:latin typeface="Times New Roman"/>
                <a:cs typeface="Times New Roman"/>
              </a:rPr>
              <a:t>n</a:t>
            </a:r>
            <a:r>
              <a:rPr sz="1087" spc="-14" dirty="0">
                <a:latin typeface="Times New Roman"/>
                <a:cs typeface="Times New Roman"/>
              </a:rPr>
              <a:t>ce</a:t>
            </a:r>
            <a:r>
              <a:rPr sz="1087" spc="-9" dirty="0">
                <a:latin typeface="Times New Roman"/>
                <a:cs typeface="Times New Roman"/>
              </a:rPr>
              <a:t>ment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ll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ry 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of 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im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s </a:t>
            </a:r>
            <a:r>
              <a:rPr sz="1087" spc="-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9" dirty="0">
                <a:latin typeface="Times New Roman"/>
                <a:cs typeface="Times New Roman"/>
              </a:rPr>
              <a:t>n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t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 f</a:t>
            </a:r>
            <a:r>
              <a:rPr sz="1087" spc="-9" dirty="0">
                <a:latin typeface="Times New Roman"/>
                <a:cs typeface="Times New Roman"/>
              </a:rPr>
              <a:t>rom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W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(</a:t>
            </a:r>
            <a:r>
              <a:rPr sz="1087" b="1" spc="-9" dirty="0">
                <a:latin typeface="Times New Roman"/>
                <a:cs typeface="Times New Roman"/>
              </a:rPr>
              <a:t>p</a:t>
            </a:r>
            <a:r>
              <a:rPr sz="1087" b="1" spc="-14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n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spc="-5" dirty="0">
                <a:latin typeface="Times New Roman"/>
                <a:cs typeface="Times New Roman"/>
              </a:rPr>
              <a:t>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) 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 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spc="5" dirty="0">
                <a:latin typeface="Times New Roman"/>
                <a:cs typeface="Times New Roman"/>
              </a:rPr>
              <a:t>T</a:t>
            </a:r>
            <a:r>
              <a:rPr sz="1087" spc="-5" dirty="0">
                <a:latin typeface="Times New Roman"/>
                <a:cs typeface="Times New Roman"/>
              </a:rPr>
              <a:t>G16L</a:t>
            </a:r>
            <a:r>
              <a:rPr sz="1087" spc="5" dirty="0">
                <a:latin typeface="Times New Roman"/>
                <a:cs typeface="Times New Roman"/>
              </a:rPr>
              <a:t>1</a:t>
            </a:r>
            <a:r>
              <a:rPr sz="1087" spc="-5" dirty="0">
                <a:latin typeface="Times New Roman"/>
                <a:cs typeface="Times New Roman"/>
              </a:rPr>
              <a:t>-/</a:t>
            </a:r>
            <a:r>
              <a:rPr sz="1087" dirty="0">
                <a:latin typeface="Times New Roman"/>
                <a:cs typeface="Times New Roman"/>
              </a:rPr>
              <a:t>-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M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-18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5" dirty="0">
                <a:latin typeface="Times New Roman"/>
                <a:cs typeface="Times New Roman"/>
              </a:rPr>
              <a:t> (</a:t>
            </a:r>
            <a:r>
              <a:rPr sz="1087" b="1" spc="-5" dirty="0">
                <a:latin typeface="Times New Roman"/>
                <a:cs typeface="Times New Roman"/>
              </a:rPr>
              <a:t>p</a:t>
            </a:r>
            <a:r>
              <a:rPr sz="1087" b="1" spc="-18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n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spc="-5" dirty="0">
                <a:latin typeface="Times New Roman"/>
                <a:cs typeface="Times New Roman"/>
              </a:rPr>
              <a:t>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B</a:t>
            </a:r>
            <a:r>
              <a:rPr sz="1087" dirty="0">
                <a:latin typeface="Times New Roman"/>
                <a:cs typeface="Times New Roman"/>
              </a:rPr>
              <a:t>). </a:t>
            </a:r>
            <a:r>
              <a:rPr sz="1087" spc="-14" dirty="0">
                <a:latin typeface="Times New Roman"/>
                <a:cs typeface="Times New Roman"/>
              </a:rPr>
              <a:t>Sc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l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ba</a:t>
            </a:r>
            <a:r>
              <a:rPr sz="1087" dirty="0">
                <a:latin typeface="Times New Roman"/>
                <a:cs typeface="Times New Roman"/>
              </a:rPr>
              <a:t>r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200n</a:t>
            </a:r>
            <a:r>
              <a:rPr sz="1087" dirty="0">
                <a:latin typeface="Times New Roman"/>
                <a:cs typeface="Times New Roman"/>
              </a:rPr>
              <a:t>m</a:t>
            </a:r>
            <a:r>
              <a:rPr sz="1042" dirty="0">
                <a:latin typeface="Times New Roman"/>
                <a:cs typeface="Times New Roman"/>
              </a:rPr>
              <a:t>.</a:t>
            </a:r>
          </a:p>
        </p:txBody>
      </p:sp>
      <p:sp>
        <p:nvSpPr>
          <p:cNvPr id="4" name="object 4"/>
          <p:cNvSpPr/>
          <p:nvPr/>
        </p:nvSpPr>
        <p:spPr>
          <a:xfrm>
            <a:off x="470167" y="1181087"/>
            <a:ext cx="5512866" cy="544094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639198" y="973059"/>
            <a:ext cx="2110905" cy="210952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" name="object 3"/>
          <p:cNvSpPr/>
          <p:nvPr/>
        </p:nvSpPr>
        <p:spPr>
          <a:xfrm>
            <a:off x="4135512" y="2876959"/>
            <a:ext cx="1231793" cy="872208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" name="object 4"/>
          <p:cNvSpPr/>
          <p:nvPr/>
        </p:nvSpPr>
        <p:spPr>
          <a:xfrm>
            <a:off x="4142993" y="4794552"/>
            <a:ext cx="1231217" cy="0"/>
          </a:xfrm>
          <a:custGeom>
            <a:avLst/>
            <a:gdLst/>
            <a:ahLst/>
            <a:cxnLst/>
            <a:rect l="l" t="t" r="r" b="b"/>
            <a:pathLst>
              <a:path w="1358900">
                <a:moveTo>
                  <a:pt x="0" y="0"/>
                </a:moveTo>
                <a:lnTo>
                  <a:pt x="135851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" name="object 5"/>
          <p:cNvSpPr/>
          <p:nvPr/>
        </p:nvSpPr>
        <p:spPr>
          <a:xfrm>
            <a:off x="4166808" y="3949960"/>
            <a:ext cx="0" cy="869907"/>
          </a:xfrm>
          <a:custGeom>
            <a:avLst/>
            <a:gdLst/>
            <a:ahLst/>
            <a:cxnLst/>
            <a:rect l="l" t="t" r="r" b="b"/>
            <a:pathLst>
              <a:path h="960120">
                <a:moveTo>
                  <a:pt x="0" y="0"/>
                </a:moveTo>
                <a:lnTo>
                  <a:pt x="0" y="96012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" name="object 6"/>
          <p:cNvSpPr/>
          <p:nvPr/>
        </p:nvSpPr>
        <p:spPr>
          <a:xfrm>
            <a:off x="4561721" y="4794552"/>
            <a:ext cx="0" cy="25315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94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" name="object 7"/>
          <p:cNvSpPr/>
          <p:nvPr/>
        </p:nvSpPr>
        <p:spPr>
          <a:xfrm>
            <a:off x="4955135" y="4794552"/>
            <a:ext cx="0" cy="25315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94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" name="object 8"/>
          <p:cNvSpPr/>
          <p:nvPr/>
        </p:nvSpPr>
        <p:spPr>
          <a:xfrm>
            <a:off x="5350044" y="3949960"/>
            <a:ext cx="0" cy="869907"/>
          </a:xfrm>
          <a:custGeom>
            <a:avLst/>
            <a:gdLst/>
            <a:ahLst/>
            <a:cxnLst/>
            <a:rect l="l" t="t" r="r" b="b"/>
            <a:pathLst>
              <a:path h="960120">
                <a:moveTo>
                  <a:pt x="0" y="0"/>
                </a:moveTo>
                <a:lnTo>
                  <a:pt x="0" y="96012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" name="object 9"/>
          <p:cNvSpPr/>
          <p:nvPr/>
        </p:nvSpPr>
        <p:spPr>
          <a:xfrm>
            <a:off x="4142990" y="4514478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289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" name="object 10"/>
          <p:cNvSpPr/>
          <p:nvPr/>
        </p:nvSpPr>
        <p:spPr>
          <a:xfrm>
            <a:off x="4142990" y="4231413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289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" name="object 11"/>
          <p:cNvSpPr/>
          <p:nvPr/>
        </p:nvSpPr>
        <p:spPr>
          <a:xfrm>
            <a:off x="4142990" y="395134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289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" name="object 12"/>
          <p:cNvSpPr/>
          <p:nvPr/>
        </p:nvSpPr>
        <p:spPr>
          <a:xfrm>
            <a:off x="5350045" y="4584439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5350045" y="4372946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5350045" y="4161452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5350045" y="395134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4166811" y="4475700"/>
            <a:ext cx="40273" cy="98382"/>
          </a:xfrm>
          <a:custGeom>
            <a:avLst/>
            <a:gdLst/>
            <a:ahLst/>
            <a:cxnLst/>
            <a:rect l="l" t="t" r="r" b="b"/>
            <a:pathLst>
              <a:path w="44450" h="108585">
                <a:moveTo>
                  <a:pt x="0" y="108585"/>
                </a:moveTo>
                <a:lnTo>
                  <a:pt x="44323" y="0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/>
          <p:nvPr/>
        </p:nvSpPr>
        <p:spPr>
          <a:xfrm>
            <a:off x="4206971" y="4317829"/>
            <a:ext cx="40273" cy="158218"/>
          </a:xfrm>
          <a:custGeom>
            <a:avLst/>
            <a:gdLst/>
            <a:ahLst/>
            <a:cxnLst/>
            <a:rect l="l" t="t" r="r" b="b"/>
            <a:pathLst>
              <a:path w="44450" h="174625">
                <a:moveTo>
                  <a:pt x="0" y="174244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/>
          <p:nvPr/>
        </p:nvSpPr>
        <p:spPr>
          <a:xfrm>
            <a:off x="4247244" y="4119800"/>
            <a:ext cx="40273" cy="198491"/>
          </a:xfrm>
          <a:custGeom>
            <a:avLst/>
            <a:gdLst/>
            <a:ahLst/>
            <a:cxnLst/>
            <a:rect l="l" t="t" r="r" b="b"/>
            <a:pathLst>
              <a:path w="44450" h="219075">
                <a:moveTo>
                  <a:pt x="0" y="218567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/>
          <p:nvPr/>
        </p:nvSpPr>
        <p:spPr>
          <a:xfrm>
            <a:off x="4287517" y="4048228"/>
            <a:ext cx="40273" cy="71917"/>
          </a:xfrm>
          <a:custGeom>
            <a:avLst/>
            <a:gdLst/>
            <a:ahLst/>
            <a:cxnLst/>
            <a:rect l="l" t="t" r="r" b="b"/>
            <a:pathLst>
              <a:path w="44450" h="79375">
                <a:moveTo>
                  <a:pt x="0" y="78994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4327789" y="4048226"/>
            <a:ext cx="120820" cy="0"/>
          </a:xfrm>
          <a:custGeom>
            <a:avLst/>
            <a:gdLst/>
            <a:ahLst/>
            <a:cxnLst/>
            <a:rect l="l" t="t" r="r" b="b"/>
            <a:pathLst>
              <a:path w="133350">
                <a:moveTo>
                  <a:pt x="0" y="0"/>
                </a:moveTo>
                <a:lnTo>
                  <a:pt x="133096" y="0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4448381" y="4048227"/>
            <a:ext cx="41999" cy="205969"/>
          </a:xfrm>
          <a:custGeom>
            <a:avLst/>
            <a:gdLst/>
            <a:ahLst/>
            <a:cxnLst/>
            <a:rect l="l" t="t" r="r" b="b"/>
            <a:pathLst>
              <a:path w="46354" h="227329">
                <a:moveTo>
                  <a:pt x="0" y="0"/>
                </a:moveTo>
                <a:lnTo>
                  <a:pt x="46101" y="226822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/>
          <p:nvPr/>
        </p:nvSpPr>
        <p:spPr>
          <a:xfrm>
            <a:off x="4490150" y="4253736"/>
            <a:ext cx="40273" cy="150738"/>
          </a:xfrm>
          <a:custGeom>
            <a:avLst/>
            <a:gdLst/>
            <a:ahLst/>
            <a:cxnLst/>
            <a:rect l="l" t="t" r="r" b="b"/>
            <a:pathLst>
              <a:path w="44450" h="166370">
                <a:moveTo>
                  <a:pt x="0" y="0"/>
                </a:moveTo>
                <a:lnTo>
                  <a:pt x="44450" y="166116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/>
          <p:nvPr/>
        </p:nvSpPr>
        <p:spPr>
          <a:xfrm>
            <a:off x="4530424" y="4404245"/>
            <a:ext cx="40273" cy="62711"/>
          </a:xfrm>
          <a:custGeom>
            <a:avLst/>
            <a:gdLst/>
            <a:ahLst/>
            <a:cxnLst/>
            <a:rect l="l" t="t" r="r" b="b"/>
            <a:pathLst>
              <a:path w="44450" h="69214">
                <a:moveTo>
                  <a:pt x="0" y="0"/>
                </a:moveTo>
                <a:lnTo>
                  <a:pt x="44323" y="68961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/>
          <p:nvPr/>
        </p:nvSpPr>
        <p:spPr>
          <a:xfrm>
            <a:off x="4570582" y="4466726"/>
            <a:ext cx="40273" cy="74794"/>
          </a:xfrm>
          <a:custGeom>
            <a:avLst/>
            <a:gdLst/>
            <a:ahLst/>
            <a:cxnLst/>
            <a:rect l="l" t="t" r="r" b="b"/>
            <a:pathLst>
              <a:path w="44450" h="82550">
                <a:moveTo>
                  <a:pt x="0" y="0"/>
                </a:moveTo>
                <a:lnTo>
                  <a:pt x="44450" y="82296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4150472" y="455682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385"/>
                </a:lnTo>
                <a:lnTo>
                  <a:pt x="11049" y="36449"/>
                </a:lnTo>
                <a:lnTo>
                  <a:pt x="18034" y="37846"/>
                </a:lnTo>
                <a:lnTo>
                  <a:pt x="25019" y="36449"/>
                </a:lnTo>
                <a:lnTo>
                  <a:pt x="30861" y="32385"/>
                </a:lnTo>
                <a:lnTo>
                  <a:pt x="34671" y="26289"/>
                </a:lnTo>
                <a:lnTo>
                  <a:pt x="36195" y="19050"/>
                </a:lnTo>
                <a:lnTo>
                  <a:pt x="34671" y="11684"/>
                </a:lnTo>
                <a:lnTo>
                  <a:pt x="30861" y="5588"/>
                </a:lnTo>
                <a:lnTo>
                  <a:pt x="25019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4150472" y="455682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9050"/>
                </a:moveTo>
                <a:lnTo>
                  <a:pt x="34671" y="11684"/>
                </a:lnTo>
                <a:lnTo>
                  <a:pt x="30861" y="5588"/>
                </a:lnTo>
                <a:lnTo>
                  <a:pt x="25019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385"/>
                </a:lnTo>
                <a:lnTo>
                  <a:pt x="11049" y="36449"/>
                </a:lnTo>
                <a:lnTo>
                  <a:pt x="18034" y="37846"/>
                </a:lnTo>
                <a:lnTo>
                  <a:pt x="25019" y="36449"/>
                </a:lnTo>
                <a:lnTo>
                  <a:pt x="30861" y="32385"/>
                </a:lnTo>
                <a:lnTo>
                  <a:pt x="34671" y="26289"/>
                </a:lnTo>
                <a:lnTo>
                  <a:pt x="36195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4190631" y="445786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4190631" y="445786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/>
          <p:nvPr/>
        </p:nvSpPr>
        <p:spPr>
          <a:xfrm>
            <a:off x="4229407" y="430068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846" y="19050"/>
                </a:ln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/>
          <p:nvPr/>
        </p:nvSpPr>
        <p:spPr>
          <a:xfrm>
            <a:off x="4229407" y="430068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9050"/>
                </a:move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846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" name="object 31"/>
          <p:cNvSpPr/>
          <p:nvPr/>
        </p:nvSpPr>
        <p:spPr>
          <a:xfrm>
            <a:off x="4271178" y="4101849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385"/>
                </a:lnTo>
                <a:lnTo>
                  <a:pt x="11049" y="36449"/>
                </a:lnTo>
                <a:lnTo>
                  <a:pt x="18034" y="37846"/>
                </a:lnTo>
                <a:lnTo>
                  <a:pt x="25146" y="36449"/>
                </a:lnTo>
                <a:lnTo>
                  <a:pt x="30861" y="32385"/>
                </a:lnTo>
                <a:lnTo>
                  <a:pt x="34798" y="26289"/>
                </a:lnTo>
                <a:lnTo>
                  <a:pt x="36195" y="19050"/>
                </a:lnTo>
                <a:lnTo>
                  <a:pt x="34798" y="11684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4271178" y="4101849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9050"/>
                </a:moveTo>
                <a:lnTo>
                  <a:pt x="34798" y="11684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385"/>
                </a:lnTo>
                <a:lnTo>
                  <a:pt x="11049" y="36449"/>
                </a:lnTo>
                <a:lnTo>
                  <a:pt x="18034" y="37846"/>
                </a:lnTo>
                <a:lnTo>
                  <a:pt x="25146" y="36449"/>
                </a:lnTo>
                <a:lnTo>
                  <a:pt x="30861" y="32385"/>
                </a:lnTo>
                <a:lnTo>
                  <a:pt x="34798" y="26289"/>
                </a:lnTo>
                <a:lnTo>
                  <a:pt x="36195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4311335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397"/>
                </a:lnTo>
                <a:lnTo>
                  <a:pt x="5334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719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/>
          <p:nvPr/>
        </p:nvSpPr>
        <p:spPr>
          <a:xfrm>
            <a:off x="4311335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lnTo>
                  <a:pt x="11049" y="1397"/>
                </a:lnTo>
                <a:lnTo>
                  <a:pt x="5334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719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5" name="object 35"/>
          <p:cNvSpPr/>
          <p:nvPr/>
        </p:nvSpPr>
        <p:spPr>
          <a:xfrm>
            <a:off x="4351608" y="4030393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461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461" y="32258"/>
                </a:lnTo>
                <a:lnTo>
                  <a:pt x="11557" y="36322"/>
                </a:lnTo>
                <a:lnTo>
                  <a:pt x="18923" y="37846"/>
                </a:lnTo>
                <a:lnTo>
                  <a:pt x="26289" y="36322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557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/>
          <p:nvPr/>
        </p:nvSpPr>
        <p:spPr>
          <a:xfrm>
            <a:off x="4351608" y="4030393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557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461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461" y="32258"/>
                </a:lnTo>
                <a:lnTo>
                  <a:pt x="11557" y="36322"/>
                </a:lnTo>
                <a:lnTo>
                  <a:pt x="18923" y="37846"/>
                </a:lnTo>
                <a:lnTo>
                  <a:pt x="26289" y="36322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7" name="object 37"/>
          <p:cNvSpPr/>
          <p:nvPr/>
        </p:nvSpPr>
        <p:spPr>
          <a:xfrm>
            <a:off x="4391768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397"/>
                </a:lnTo>
                <a:lnTo>
                  <a:pt x="5334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719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/>
          <p:nvPr/>
        </p:nvSpPr>
        <p:spPr>
          <a:xfrm>
            <a:off x="4391768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lnTo>
                  <a:pt x="11049" y="1397"/>
                </a:lnTo>
                <a:lnTo>
                  <a:pt x="5334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719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9" name="object 39"/>
          <p:cNvSpPr/>
          <p:nvPr/>
        </p:nvSpPr>
        <p:spPr>
          <a:xfrm>
            <a:off x="4432042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397"/>
                </a:lnTo>
                <a:lnTo>
                  <a:pt x="5207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/>
          <p:nvPr/>
        </p:nvSpPr>
        <p:spPr>
          <a:xfrm>
            <a:off x="4432042" y="40303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lnTo>
                  <a:pt x="11049" y="1397"/>
                </a:lnTo>
                <a:lnTo>
                  <a:pt x="5207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1" name="object 41"/>
          <p:cNvSpPr/>
          <p:nvPr/>
        </p:nvSpPr>
        <p:spPr>
          <a:xfrm>
            <a:off x="4472315" y="4236592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4472315" y="4236592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/>
          <p:nvPr/>
        </p:nvSpPr>
        <p:spPr>
          <a:xfrm>
            <a:off x="4512588" y="43862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430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162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4" name="object 44"/>
          <p:cNvSpPr/>
          <p:nvPr/>
        </p:nvSpPr>
        <p:spPr>
          <a:xfrm>
            <a:off x="4512588" y="43862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719" y="19050"/>
                </a:move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lnTo>
                  <a:pt x="11430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162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5" name="object 45"/>
          <p:cNvSpPr/>
          <p:nvPr/>
        </p:nvSpPr>
        <p:spPr>
          <a:xfrm>
            <a:off x="4552747" y="4448892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6" name="object 46"/>
          <p:cNvSpPr/>
          <p:nvPr/>
        </p:nvSpPr>
        <p:spPr>
          <a:xfrm>
            <a:off x="4552747" y="4448892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7" name="object 47"/>
          <p:cNvSpPr/>
          <p:nvPr/>
        </p:nvSpPr>
        <p:spPr>
          <a:xfrm>
            <a:off x="4593020" y="452414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8" name="object 48"/>
          <p:cNvSpPr/>
          <p:nvPr/>
        </p:nvSpPr>
        <p:spPr>
          <a:xfrm>
            <a:off x="4593020" y="452414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684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9" name="object 49"/>
          <p:cNvSpPr/>
          <p:nvPr/>
        </p:nvSpPr>
        <p:spPr>
          <a:xfrm>
            <a:off x="4166811" y="4626211"/>
            <a:ext cx="40273" cy="90903"/>
          </a:xfrm>
          <a:custGeom>
            <a:avLst/>
            <a:gdLst/>
            <a:ahLst/>
            <a:cxnLst/>
            <a:rect l="l" t="t" r="r" b="b"/>
            <a:pathLst>
              <a:path w="44450" h="100329">
                <a:moveTo>
                  <a:pt x="0" y="100203"/>
                </a:moveTo>
                <a:lnTo>
                  <a:pt x="44323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0" name="object 50"/>
          <p:cNvSpPr/>
          <p:nvPr/>
        </p:nvSpPr>
        <p:spPr>
          <a:xfrm>
            <a:off x="4206971" y="4493652"/>
            <a:ext cx="40273" cy="132904"/>
          </a:xfrm>
          <a:custGeom>
            <a:avLst/>
            <a:gdLst/>
            <a:ahLst/>
            <a:cxnLst/>
            <a:rect l="l" t="t" r="r" b="b"/>
            <a:pathLst>
              <a:path w="44450" h="146685">
                <a:moveTo>
                  <a:pt x="0" y="146304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1" name="object 51"/>
          <p:cNvSpPr/>
          <p:nvPr/>
        </p:nvSpPr>
        <p:spPr>
          <a:xfrm>
            <a:off x="4247244" y="4308969"/>
            <a:ext cx="40273" cy="184683"/>
          </a:xfrm>
          <a:custGeom>
            <a:avLst/>
            <a:gdLst/>
            <a:ahLst/>
            <a:cxnLst/>
            <a:rect l="l" t="t" r="r" b="b"/>
            <a:pathLst>
              <a:path w="44450" h="203835">
                <a:moveTo>
                  <a:pt x="0" y="203835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2" name="object 52"/>
          <p:cNvSpPr/>
          <p:nvPr/>
        </p:nvSpPr>
        <p:spPr>
          <a:xfrm>
            <a:off x="4287517" y="4186768"/>
            <a:ext cx="40273" cy="122546"/>
          </a:xfrm>
          <a:custGeom>
            <a:avLst/>
            <a:gdLst/>
            <a:ahLst/>
            <a:cxnLst/>
            <a:rect l="l" t="t" r="r" b="b"/>
            <a:pathLst>
              <a:path w="44450" h="135254">
                <a:moveTo>
                  <a:pt x="0" y="134874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3" name="object 53"/>
          <p:cNvSpPr/>
          <p:nvPr/>
        </p:nvSpPr>
        <p:spPr>
          <a:xfrm>
            <a:off x="4327791" y="4143619"/>
            <a:ext cx="41999" cy="43150"/>
          </a:xfrm>
          <a:custGeom>
            <a:avLst/>
            <a:gdLst/>
            <a:ahLst/>
            <a:cxnLst/>
            <a:rect l="l" t="t" r="r" b="b"/>
            <a:pathLst>
              <a:path w="46354" h="47625">
                <a:moveTo>
                  <a:pt x="0" y="47625"/>
                </a:moveTo>
                <a:lnTo>
                  <a:pt x="45974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4" name="object 54"/>
          <p:cNvSpPr/>
          <p:nvPr/>
        </p:nvSpPr>
        <p:spPr>
          <a:xfrm>
            <a:off x="4369442" y="4143618"/>
            <a:ext cx="39124" cy="68465"/>
          </a:xfrm>
          <a:custGeom>
            <a:avLst/>
            <a:gdLst/>
            <a:ahLst/>
            <a:cxnLst/>
            <a:rect l="l" t="t" r="r" b="b"/>
            <a:pathLst>
              <a:path w="43179" h="75564">
                <a:moveTo>
                  <a:pt x="0" y="0"/>
                </a:moveTo>
                <a:lnTo>
                  <a:pt x="42799" y="75565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5" name="object 55"/>
          <p:cNvSpPr/>
          <p:nvPr/>
        </p:nvSpPr>
        <p:spPr>
          <a:xfrm>
            <a:off x="4408222" y="4212082"/>
            <a:ext cx="40273" cy="176053"/>
          </a:xfrm>
          <a:custGeom>
            <a:avLst/>
            <a:gdLst/>
            <a:ahLst/>
            <a:cxnLst/>
            <a:rect l="l" t="t" r="r" b="b"/>
            <a:pathLst>
              <a:path w="44450" h="194310">
                <a:moveTo>
                  <a:pt x="0" y="0"/>
                </a:moveTo>
                <a:lnTo>
                  <a:pt x="44323" y="194056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6" name="object 56"/>
          <p:cNvSpPr/>
          <p:nvPr/>
        </p:nvSpPr>
        <p:spPr>
          <a:xfrm>
            <a:off x="4448381" y="4387906"/>
            <a:ext cx="41999" cy="166847"/>
          </a:xfrm>
          <a:custGeom>
            <a:avLst/>
            <a:gdLst/>
            <a:ahLst/>
            <a:cxnLst/>
            <a:rect l="l" t="t" r="r" b="b"/>
            <a:pathLst>
              <a:path w="46354" h="184150">
                <a:moveTo>
                  <a:pt x="0" y="0"/>
                </a:moveTo>
                <a:lnTo>
                  <a:pt x="46101" y="18415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7" name="object 57"/>
          <p:cNvSpPr/>
          <p:nvPr/>
        </p:nvSpPr>
        <p:spPr>
          <a:xfrm>
            <a:off x="4490150" y="4554753"/>
            <a:ext cx="40273" cy="93780"/>
          </a:xfrm>
          <a:custGeom>
            <a:avLst/>
            <a:gdLst/>
            <a:ahLst/>
            <a:cxnLst/>
            <a:rect l="l" t="t" r="r" b="b"/>
            <a:pathLst>
              <a:path w="44450" h="103504">
                <a:moveTo>
                  <a:pt x="0" y="0"/>
                </a:moveTo>
                <a:lnTo>
                  <a:pt x="44450" y="103505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8" name="object 58"/>
          <p:cNvSpPr/>
          <p:nvPr/>
        </p:nvSpPr>
        <p:spPr>
          <a:xfrm>
            <a:off x="4530424" y="4648532"/>
            <a:ext cx="40273" cy="12082"/>
          </a:xfrm>
          <a:custGeom>
            <a:avLst/>
            <a:gdLst/>
            <a:ahLst/>
            <a:cxnLst/>
            <a:rect l="l" t="t" r="r" b="b"/>
            <a:pathLst>
              <a:path w="44450" h="13335">
                <a:moveTo>
                  <a:pt x="0" y="0"/>
                </a:moveTo>
                <a:lnTo>
                  <a:pt x="44323" y="13081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9" name="object 59"/>
          <p:cNvSpPr/>
          <p:nvPr/>
        </p:nvSpPr>
        <p:spPr>
          <a:xfrm>
            <a:off x="4570582" y="4620226"/>
            <a:ext cx="40273" cy="40273"/>
          </a:xfrm>
          <a:custGeom>
            <a:avLst/>
            <a:gdLst/>
            <a:ahLst/>
            <a:cxnLst/>
            <a:rect l="l" t="t" r="r" b="b"/>
            <a:pathLst>
              <a:path w="44450" h="44450">
                <a:moveTo>
                  <a:pt x="0" y="44323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0" name="object 60"/>
          <p:cNvSpPr/>
          <p:nvPr/>
        </p:nvSpPr>
        <p:spPr>
          <a:xfrm>
            <a:off x="4150472" y="4700082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4">
                <a:moveTo>
                  <a:pt x="0" y="37465"/>
                </a:moveTo>
                <a:lnTo>
                  <a:pt x="36195" y="37465"/>
                </a:lnTo>
                <a:lnTo>
                  <a:pt x="361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1" name="object 61"/>
          <p:cNvSpPr/>
          <p:nvPr/>
        </p:nvSpPr>
        <p:spPr>
          <a:xfrm>
            <a:off x="4148314" y="4697926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956" y="42226"/>
                </a:lnTo>
                <a:lnTo>
                  <a:pt x="40956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2" name="object 62"/>
          <p:cNvSpPr/>
          <p:nvPr/>
        </p:nvSpPr>
        <p:spPr>
          <a:xfrm>
            <a:off x="4190631" y="4607709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7"/>
                </a:moveTo>
                <a:lnTo>
                  <a:pt x="36195" y="39087"/>
                </a:lnTo>
                <a:lnTo>
                  <a:pt x="36195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3" name="object 63"/>
          <p:cNvSpPr/>
          <p:nvPr/>
        </p:nvSpPr>
        <p:spPr>
          <a:xfrm>
            <a:off x="4188473" y="4605553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9"/>
                </a:moveTo>
                <a:lnTo>
                  <a:pt x="40956" y="43849"/>
                </a:lnTo>
                <a:lnTo>
                  <a:pt x="40956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4" name="object 64"/>
          <p:cNvSpPr/>
          <p:nvPr/>
        </p:nvSpPr>
        <p:spPr>
          <a:xfrm>
            <a:off x="4229407" y="4476623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465"/>
                </a:moveTo>
                <a:lnTo>
                  <a:pt x="37812" y="37465"/>
                </a:lnTo>
                <a:lnTo>
                  <a:pt x="37812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5" name="object 65"/>
          <p:cNvSpPr/>
          <p:nvPr/>
        </p:nvSpPr>
        <p:spPr>
          <a:xfrm>
            <a:off x="4227249" y="4474466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226"/>
                </a:moveTo>
                <a:lnTo>
                  <a:pt x="42574" y="42226"/>
                </a:lnTo>
                <a:lnTo>
                  <a:pt x="42574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6" name="object 66"/>
          <p:cNvSpPr/>
          <p:nvPr/>
        </p:nvSpPr>
        <p:spPr>
          <a:xfrm>
            <a:off x="4271178" y="4290470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7"/>
                </a:moveTo>
                <a:lnTo>
                  <a:pt x="36195" y="39087"/>
                </a:lnTo>
                <a:lnTo>
                  <a:pt x="36195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7" name="object 67"/>
          <p:cNvSpPr/>
          <p:nvPr/>
        </p:nvSpPr>
        <p:spPr>
          <a:xfrm>
            <a:off x="4269020" y="4288314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9"/>
                </a:moveTo>
                <a:lnTo>
                  <a:pt x="40956" y="43849"/>
                </a:lnTo>
                <a:lnTo>
                  <a:pt x="40956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8" name="object 68"/>
          <p:cNvSpPr/>
          <p:nvPr/>
        </p:nvSpPr>
        <p:spPr>
          <a:xfrm>
            <a:off x="4311335" y="4168272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2"/>
                </a:moveTo>
                <a:lnTo>
                  <a:pt x="36195" y="39082"/>
                </a:lnTo>
                <a:lnTo>
                  <a:pt x="36195" y="0"/>
                </a:lnTo>
                <a:lnTo>
                  <a:pt x="0" y="0"/>
                </a:lnTo>
                <a:lnTo>
                  <a:pt x="0" y="390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9" name="object 69"/>
          <p:cNvSpPr/>
          <p:nvPr/>
        </p:nvSpPr>
        <p:spPr>
          <a:xfrm>
            <a:off x="4309178" y="4166116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4"/>
                </a:moveTo>
                <a:lnTo>
                  <a:pt x="40956" y="43844"/>
                </a:lnTo>
                <a:lnTo>
                  <a:pt x="40956" y="0"/>
                </a:lnTo>
                <a:lnTo>
                  <a:pt x="0" y="0"/>
                </a:lnTo>
                <a:lnTo>
                  <a:pt x="0" y="4384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0" name="object 70"/>
          <p:cNvSpPr/>
          <p:nvPr/>
        </p:nvSpPr>
        <p:spPr>
          <a:xfrm>
            <a:off x="4351608" y="4126592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460"/>
                </a:moveTo>
                <a:lnTo>
                  <a:pt x="37812" y="37460"/>
                </a:lnTo>
                <a:lnTo>
                  <a:pt x="37812" y="0"/>
                </a:lnTo>
                <a:lnTo>
                  <a:pt x="0" y="0"/>
                </a:lnTo>
                <a:lnTo>
                  <a:pt x="0" y="3746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1" name="object 71"/>
          <p:cNvSpPr/>
          <p:nvPr/>
        </p:nvSpPr>
        <p:spPr>
          <a:xfrm>
            <a:off x="4349450" y="4124436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222"/>
                </a:moveTo>
                <a:lnTo>
                  <a:pt x="42574" y="42222"/>
                </a:lnTo>
                <a:lnTo>
                  <a:pt x="42574" y="0"/>
                </a:lnTo>
                <a:lnTo>
                  <a:pt x="0" y="0"/>
                </a:lnTo>
                <a:lnTo>
                  <a:pt x="0" y="4222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2" name="object 72"/>
          <p:cNvSpPr/>
          <p:nvPr/>
        </p:nvSpPr>
        <p:spPr>
          <a:xfrm>
            <a:off x="4391768" y="4193703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2"/>
                </a:moveTo>
                <a:lnTo>
                  <a:pt x="36195" y="39082"/>
                </a:lnTo>
                <a:lnTo>
                  <a:pt x="36195" y="0"/>
                </a:lnTo>
                <a:lnTo>
                  <a:pt x="0" y="0"/>
                </a:lnTo>
                <a:lnTo>
                  <a:pt x="0" y="390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3" name="object 73"/>
          <p:cNvSpPr/>
          <p:nvPr/>
        </p:nvSpPr>
        <p:spPr>
          <a:xfrm>
            <a:off x="4389610" y="4191547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4"/>
                </a:moveTo>
                <a:lnTo>
                  <a:pt x="40956" y="43844"/>
                </a:lnTo>
                <a:lnTo>
                  <a:pt x="40956" y="0"/>
                </a:lnTo>
                <a:lnTo>
                  <a:pt x="0" y="0"/>
                </a:lnTo>
                <a:lnTo>
                  <a:pt x="0" y="4384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4" name="object 74"/>
          <p:cNvSpPr/>
          <p:nvPr/>
        </p:nvSpPr>
        <p:spPr>
          <a:xfrm>
            <a:off x="4432156" y="4370875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4">
                <a:moveTo>
                  <a:pt x="0" y="37465"/>
                </a:moveTo>
                <a:lnTo>
                  <a:pt x="36095" y="37465"/>
                </a:lnTo>
                <a:lnTo>
                  <a:pt x="360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5" name="object 75"/>
          <p:cNvSpPr/>
          <p:nvPr/>
        </p:nvSpPr>
        <p:spPr>
          <a:xfrm>
            <a:off x="4429998" y="4368719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857" y="42226"/>
                </a:lnTo>
                <a:lnTo>
                  <a:pt x="40857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6" name="object 76"/>
          <p:cNvSpPr/>
          <p:nvPr/>
        </p:nvSpPr>
        <p:spPr>
          <a:xfrm>
            <a:off x="4472315" y="4537722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465"/>
                </a:moveTo>
                <a:lnTo>
                  <a:pt x="37817" y="37465"/>
                </a:lnTo>
                <a:lnTo>
                  <a:pt x="37817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7" name="object 77"/>
          <p:cNvSpPr/>
          <p:nvPr/>
        </p:nvSpPr>
        <p:spPr>
          <a:xfrm>
            <a:off x="4470155" y="4535566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226"/>
                </a:moveTo>
                <a:lnTo>
                  <a:pt x="42579" y="42226"/>
                </a:lnTo>
                <a:lnTo>
                  <a:pt x="42579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8" name="object 78"/>
          <p:cNvSpPr/>
          <p:nvPr/>
        </p:nvSpPr>
        <p:spPr>
          <a:xfrm>
            <a:off x="4512588" y="4654473"/>
            <a:ext cx="74794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135" y="0"/>
                </a:lnTo>
              </a:path>
            </a:pathLst>
          </a:custGeom>
          <a:ln w="5063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9" name="object 79"/>
          <p:cNvSpPr/>
          <p:nvPr/>
        </p:nvSpPr>
        <p:spPr>
          <a:xfrm>
            <a:off x="4512588" y="4632109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-2380" y="18906"/>
                </a:moveTo>
                <a:lnTo>
                  <a:pt x="40193" y="18906"/>
                </a:lnTo>
              </a:path>
            </a:pathLst>
          </a:custGeom>
          <a:ln w="43844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0" name="object 80"/>
          <p:cNvSpPr/>
          <p:nvPr/>
        </p:nvSpPr>
        <p:spPr>
          <a:xfrm>
            <a:off x="4552747" y="4644045"/>
            <a:ext cx="34519" cy="32793"/>
          </a:xfrm>
          <a:custGeom>
            <a:avLst/>
            <a:gdLst/>
            <a:ahLst/>
            <a:cxnLst/>
            <a:rect l="l" t="t" r="r" b="b"/>
            <a:pathLst>
              <a:path w="38100" h="36195">
                <a:moveTo>
                  <a:pt x="-2380" y="18097"/>
                </a:moveTo>
                <a:lnTo>
                  <a:pt x="40193" y="18097"/>
                </a:lnTo>
              </a:path>
            </a:pathLst>
          </a:custGeom>
          <a:ln w="42226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1" name="object 81"/>
          <p:cNvSpPr/>
          <p:nvPr/>
        </p:nvSpPr>
        <p:spPr>
          <a:xfrm>
            <a:off x="4593020" y="4601725"/>
            <a:ext cx="34519" cy="35671"/>
          </a:xfrm>
          <a:custGeom>
            <a:avLst/>
            <a:gdLst/>
            <a:ahLst/>
            <a:cxnLst/>
            <a:rect l="l" t="t" r="r" b="b"/>
            <a:pathLst>
              <a:path w="38100" h="39370">
                <a:moveTo>
                  <a:pt x="0" y="39087"/>
                </a:moveTo>
                <a:lnTo>
                  <a:pt x="37906" y="39087"/>
                </a:lnTo>
                <a:lnTo>
                  <a:pt x="37906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2" name="object 82"/>
          <p:cNvSpPr/>
          <p:nvPr/>
        </p:nvSpPr>
        <p:spPr>
          <a:xfrm>
            <a:off x="4590862" y="4599569"/>
            <a:ext cx="39124" cy="40273"/>
          </a:xfrm>
          <a:custGeom>
            <a:avLst/>
            <a:gdLst/>
            <a:ahLst/>
            <a:cxnLst/>
            <a:rect l="l" t="t" r="r" b="b"/>
            <a:pathLst>
              <a:path w="43179" h="44450">
                <a:moveTo>
                  <a:pt x="0" y="43849"/>
                </a:moveTo>
                <a:lnTo>
                  <a:pt x="42668" y="43849"/>
                </a:lnTo>
                <a:lnTo>
                  <a:pt x="42668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3" name="object 83"/>
          <p:cNvSpPr/>
          <p:nvPr/>
        </p:nvSpPr>
        <p:spPr>
          <a:xfrm>
            <a:off x="4171184" y="7019604"/>
            <a:ext cx="1231217" cy="0"/>
          </a:xfrm>
          <a:custGeom>
            <a:avLst/>
            <a:gdLst/>
            <a:ahLst/>
            <a:cxnLst/>
            <a:rect l="l" t="t" r="r" b="b"/>
            <a:pathLst>
              <a:path w="1358900">
                <a:moveTo>
                  <a:pt x="0" y="0"/>
                </a:moveTo>
                <a:lnTo>
                  <a:pt x="1358900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4" name="object 84"/>
          <p:cNvSpPr/>
          <p:nvPr/>
        </p:nvSpPr>
        <p:spPr>
          <a:xfrm>
            <a:off x="4195117" y="6175014"/>
            <a:ext cx="0" cy="869907"/>
          </a:xfrm>
          <a:custGeom>
            <a:avLst/>
            <a:gdLst/>
            <a:ahLst/>
            <a:cxnLst/>
            <a:rect l="l" t="t" r="r" b="b"/>
            <a:pathLst>
              <a:path h="960120">
                <a:moveTo>
                  <a:pt x="0" y="0"/>
                </a:moveTo>
                <a:lnTo>
                  <a:pt x="0" y="959993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5" name="object 85"/>
          <p:cNvSpPr/>
          <p:nvPr/>
        </p:nvSpPr>
        <p:spPr>
          <a:xfrm>
            <a:off x="4590026" y="7019605"/>
            <a:ext cx="0" cy="25315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813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6" name="object 86"/>
          <p:cNvSpPr/>
          <p:nvPr/>
        </p:nvSpPr>
        <p:spPr>
          <a:xfrm>
            <a:off x="4983557" y="7019605"/>
            <a:ext cx="0" cy="25315"/>
          </a:xfrm>
          <a:custGeom>
            <a:avLst/>
            <a:gdLst/>
            <a:ahLst/>
            <a:cxnLst/>
            <a:rect l="l" t="t" r="r" b="b"/>
            <a:pathLst>
              <a:path h="27940">
                <a:moveTo>
                  <a:pt x="0" y="0"/>
                </a:moveTo>
                <a:lnTo>
                  <a:pt x="0" y="27813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7" name="object 87"/>
          <p:cNvSpPr/>
          <p:nvPr/>
        </p:nvSpPr>
        <p:spPr>
          <a:xfrm>
            <a:off x="5378467" y="6175014"/>
            <a:ext cx="0" cy="869907"/>
          </a:xfrm>
          <a:custGeom>
            <a:avLst/>
            <a:gdLst/>
            <a:ahLst/>
            <a:cxnLst/>
            <a:rect l="l" t="t" r="r" b="b"/>
            <a:pathLst>
              <a:path h="960120">
                <a:moveTo>
                  <a:pt x="0" y="0"/>
                </a:moveTo>
                <a:lnTo>
                  <a:pt x="0" y="959993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8" name="object 88"/>
          <p:cNvSpPr/>
          <p:nvPr/>
        </p:nvSpPr>
        <p:spPr>
          <a:xfrm>
            <a:off x="4171182" y="673953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9" name="object 89"/>
          <p:cNvSpPr/>
          <p:nvPr/>
        </p:nvSpPr>
        <p:spPr>
          <a:xfrm>
            <a:off x="4171182" y="6456466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0" name="object 90"/>
          <p:cNvSpPr/>
          <p:nvPr/>
        </p:nvSpPr>
        <p:spPr>
          <a:xfrm>
            <a:off x="4171182" y="6176393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1" name="object 91"/>
          <p:cNvSpPr/>
          <p:nvPr/>
        </p:nvSpPr>
        <p:spPr>
          <a:xfrm>
            <a:off x="5378466" y="6851146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416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2" name="object 92"/>
          <p:cNvSpPr/>
          <p:nvPr/>
        </p:nvSpPr>
        <p:spPr>
          <a:xfrm>
            <a:off x="5378466" y="6682918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416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3" name="object 93"/>
          <p:cNvSpPr/>
          <p:nvPr/>
        </p:nvSpPr>
        <p:spPr>
          <a:xfrm>
            <a:off x="5378466" y="6513079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416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4" name="object 94"/>
          <p:cNvSpPr/>
          <p:nvPr/>
        </p:nvSpPr>
        <p:spPr>
          <a:xfrm>
            <a:off x="5378466" y="6344736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416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5" name="object 95"/>
          <p:cNvSpPr/>
          <p:nvPr/>
        </p:nvSpPr>
        <p:spPr>
          <a:xfrm>
            <a:off x="5378466" y="6175012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416" y="0"/>
                </a:lnTo>
              </a:path>
            </a:pathLst>
          </a:custGeom>
          <a:ln w="8228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6" name="object 96"/>
          <p:cNvSpPr/>
          <p:nvPr/>
        </p:nvSpPr>
        <p:spPr>
          <a:xfrm>
            <a:off x="4195119" y="6894412"/>
            <a:ext cx="40273" cy="67314"/>
          </a:xfrm>
          <a:custGeom>
            <a:avLst/>
            <a:gdLst/>
            <a:ahLst/>
            <a:cxnLst/>
            <a:rect l="l" t="t" r="r" b="b"/>
            <a:pathLst>
              <a:path w="44450" h="74295">
                <a:moveTo>
                  <a:pt x="0" y="74041"/>
                </a:moveTo>
                <a:lnTo>
                  <a:pt x="44323" y="0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7" name="object 97"/>
          <p:cNvSpPr/>
          <p:nvPr/>
        </p:nvSpPr>
        <p:spPr>
          <a:xfrm>
            <a:off x="4235278" y="6717209"/>
            <a:ext cx="40273" cy="177203"/>
          </a:xfrm>
          <a:custGeom>
            <a:avLst/>
            <a:gdLst/>
            <a:ahLst/>
            <a:cxnLst/>
            <a:rect l="l" t="t" r="r" b="b"/>
            <a:pathLst>
              <a:path w="44450" h="195579">
                <a:moveTo>
                  <a:pt x="0" y="195580"/>
                </a:moveTo>
                <a:lnTo>
                  <a:pt x="44450" y="0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8" name="object 98"/>
          <p:cNvSpPr/>
          <p:nvPr/>
        </p:nvSpPr>
        <p:spPr>
          <a:xfrm>
            <a:off x="4275551" y="6432648"/>
            <a:ext cx="40273" cy="284791"/>
          </a:xfrm>
          <a:custGeom>
            <a:avLst/>
            <a:gdLst/>
            <a:ahLst/>
            <a:cxnLst/>
            <a:rect l="l" t="t" r="r" b="b"/>
            <a:pathLst>
              <a:path w="44450" h="314325">
                <a:moveTo>
                  <a:pt x="0" y="314071"/>
                </a:moveTo>
                <a:lnTo>
                  <a:pt x="44450" y="0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9" name="object 99"/>
          <p:cNvSpPr/>
          <p:nvPr/>
        </p:nvSpPr>
        <p:spPr>
          <a:xfrm>
            <a:off x="4315824" y="6273280"/>
            <a:ext cx="40273" cy="159368"/>
          </a:xfrm>
          <a:custGeom>
            <a:avLst/>
            <a:gdLst/>
            <a:ahLst/>
            <a:cxnLst/>
            <a:rect l="l" t="t" r="r" b="b"/>
            <a:pathLst>
              <a:path w="44450" h="175895">
                <a:moveTo>
                  <a:pt x="0" y="175895"/>
                </a:moveTo>
                <a:lnTo>
                  <a:pt x="44323" y="0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0" name="object 100"/>
          <p:cNvSpPr/>
          <p:nvPr/>
        </p:nvSpPr>
        <p:spPr>
          <a:xfrm>
            <a:off x="4355982" y="6273278"/>
            <a:ext cx="80547" cy="0"/>
          </a:xfrm>
          <a:custGeom>
            <a:avLst/>
            <a:gdLst/>
            <a:ahLst/>
            <a:cxnLst/>
            <a:rect l="l" t="t" r="r" b="b"/>
            <a:pathLst>
              <a:path w="88900">
                <a:moveTo>
                  <a:pt x="0" y="0"/>
                </a:moveTo>
                <a:lnTo>
                  <a:pt x="88900" y="0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1" name="object 101"/>
          <p:cNvSpPr/>
          <p:nvPr/>
        </p:nvSpPr>
        <p:spPr>
          <a:xfrm>
            <a:off x="4436529" y="6273281"/>
            <a:ext cx="40273" cy="58109"/>
          </a:xfrm>
          <a:custGeom>
            <a:avLst/>
            <a:gdLst/>
            <a:ahLst/>
            <a:cxnLst/>
            <a:rect l="l" t="t" r="r" b="b"/>
            <a:pathLst>
              <a:path w="44450" h="64134">
                <a:moveTo>
                  <a:pt x="0" y="0"/>
                </a:moveTo>
                <a:lnTo>
                  <a:pt x="44450" y="64008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2" name="object 102"/>
          <p:cNvSpPr/>
          <p:nvPr/>
        </p:nvSpPr>
        <p:spPr>
          <a:xfrm>
            <a:off x="4476802" y="6331274"/>
            <a:ext cx="41999" cy="222080"/>
          </a:xfrm>
          <a:custGeom>
            <a:avLst/>
            <a:gdLst/>
            <a:ahLst/>
            <a:cxnLst/>
            <a:rect l="l" t="t" r="r" b="b"/>
            <a:pathLst>
              <a:path w="46354" h="245109">
                <a:moveTo>
                  <a:pt x="0" y="0"/>
                </a:moveTo>
                <a:lnTo>
                  <a:pt x="46101" y="244983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3" name="object 103"/>
          <p:cNvSpPr/>
          <p:nvPr/>
        </p:nvSpPr>
        <p:spPr>
          <a:xfrm>
            <a:off x="4518572" y="6553238"/>
            <a:ext cx="40273" cy="256600"/>
          </a:xfrm>
          <a:custGeom>
            <a:avLst/>
            <a:gdLst/>
            <a:ahLst/>
            <a:cxnLst/>
            <a:rect l="l" t="t" r="r" b="b"/>
            <a:pathLst>
              <a:path w="44450" h="283209">
                <a:moveTo>
                  <a:pt x="0" y="0"/>
                </a:moveTo>
                <a:lnTo>
                  <a:pt x="44323" y="282829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4" name="object 104"/>
          <p:cNvSpPr/>
          <p:nvPr/>
        </p:nvSpPr>
        <p:spPr>
          <a:xfrm>
            <a:off x="4558730" y="6809492"/>
            <a:ext cx="40273" cy="108738"/>
          </a:xfrm>
          <a:custGeom>
            <a:avLst/>
            <a:gdLst/>
            <a:ahLst/>
            <a:cxnLst/>
            <a:rect l="l" t="t" r="r" b="b"/>
            <a:pathLst>
              <a:path w="44450" h="120015">
                <a:moveTo>
                  <a:pt x="0" y="0"/>
                </a:moveTo>
                <a:lnTo>
                  <a:pt x="44450" y="120015"/>
                </a:lnTo>
              </a:path>
            </a:pathLst>
          </a:custGeom>
          <a:ln w="8228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5" name="object 105"/>
          <p:cNvSpPr/>
          <p:nvPr/>
        </p:nvSpPr>
        <p:spPr>
          <a:xfrm>
            <a:off x="4178663" y="69435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6" name="object 106"/>
          <p:cNvSpPr/>
          <p:nvPr/>
        </p:nvSpPr>
        <p:spPr>
          <a:xfrm>
            <a:off x="4178663" y="69435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7" name="object 107"/>
          <p:cNvSpPr/>
          <p:nvPr/>
        </p:nvSpPr>
        <p:spPr>
          <a:xfrm>
            <a:off x="4218936" y="6876577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8" name="object 108"/>
          <p:cNvSpPr/>
          <p:nvPr/>
        </p:nvSpPr>
        <p:spPr>
          <a:xfrm>
            <a:off x="4218936" y="6876577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9" name="object 109"/>
          <p:cNvSpPr/>
          <p:nvPr/>
        </p:nvSpPr>
        <p:spPr>
          <a:xfrm>
            <a:off x="4257599" y="670006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397"/>
                </a:lnTo>
                <a:lnTo>
                  <a:pt x="5588" y="5461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684" y="36322"/>
                </a:lnTo>
                <a:lnTo>
                  <a:pt x="19050" y="37846"/>
                </a:lnTo>
                <a:lnTo>
                  <a:pt x="26289" y="36322"/>
                </a:lnTo>
                <a:lnTo>
                  <a:pt x="32385" y="32258"/>
                </a:lnTo>
                <a:lnTo>
                  <a:pt x="36449" y="26289"/>
                </a:lnTo>
                <a:lnTo>
                  <a:pt x="37846" y="18923"/>
                </a:lnTo>
                <a:lnTo>
                  <a:pt x="36449" y="11557"/>
                </a:lnTo>
                <a:lnTo>
                  <a:pt x="32385" y="5461"/>
                </a:lnTo>
                <a:lnTo>
                  <a:pt x="26289" y="1397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0" name="object 110"/>
          <p:cNvSpPr/>
          <p:nvPr/>
        </p:nvSpPr>
        <p:spPr>
          <a:xfrm>
            <a:off x="4257599" y="670006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449" y="11557"/>
                </a:lnTo>
                <a:lnTo>
                  <a:pt x="32385" y="5461"/>
                </a:lnTo>
                <a:lnTo>
                  <a:pt x="26289" y="1397"/>
                </a:lnTo>
                <a:lnTo>
                  <a:pt x="18923" y="0"/>
                </a:lnTo>
                <a:lnTo>
                  <a:pt x="11557" y="1397"/>
                </a:lnTo>
                <a:lnTo>
                  <a:pt x="5588" y="5461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684" y="36322"/>
                </a:lnTo>
                <a:lnTo>
                  <a:pt x="19050" y="37846"/>
                </a:lnTo>
                <a:lnTo>
                  <a:pt x="26289" y="36322"/>
                </a:lnTo>
                <a:lnTo>
                  <a:pt x="32385" y="32258"/>
                </a:lnTo>
                <a:lnTo>
                  <a:pt x="36449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1" name="object 111"/>
          <p:cNvSpPr/>
          <p:nvPr/>
        </p:nvSpPr>
        <p:spPr>
          <a:xfrm>
            <a:off x="4299369" y="641550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176" y="1397"/>
                </a:lnTo>
                <a:lnTo>
                  <a:pt x="5334" y="5461"/>
                </a:lnTo>
                <a:lnTo>
                  <a:pt x="1524" y="11557"/>
                </a:lnTo>
                <a:lnTo>
                  <a:pt x="0" y="18796"/>
                </a:lnTo>
                <a:lnTo>
                  <a:pt x="1524" y="26162"/>
                </a:lnTo>
                <a:lnTo>
                  <a:pt x="5334" y="32258"/>
                </a:lnTo>
                <a:lnTo>
                  <a:pt x="11176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2" name="object 112"/>
          <p:cNvSpPr/>
          <p:nvPr/>
        </p:nvSpPr>
        <p:spPr>
          <a:xfrm>
            <a:off x="4299369" y="641550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461"/>
                </a:lnTo>
                <a:lnTo>
                  <a:pt x="25146" y="1397"/>
                </a:lnTo>
                <a:lnTo>
                  <a:pt x="18161" y="0"/>
                </a:lnTo>
                <a:lnTo>
                  <a:pt x="11176" y="1397"/>
                </a:lnTo>
                <a:lnTo>
                  <a:pt x="5334" y="5461"/>
                </a:lnTo>
                <a:lnTo>
                  <a:pt x="1524" y="11557"/>
                </a:lnTo>
                <a:lnTo>
                  <a:pt x="0" y="18796"/>
                </a:lnTo>
                <a:lnTo>
                  <a:pt x="1524" y="26162"/>
                </a:lnTo>
                <a:lnTo>
                  <a:pt x="5334" y="32258"/>
                </a:lnTo>
                <a:lnTo>
                  <a:pt x="11176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3" name="object 113"/>
          <p:cNvSpPr/>
          <p:nvPr/>
        </p:nvSpPr>
        <p:spPr>
          <a:xfrm>
            <a:off x="4339643" y="62554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397"/>
                </a:lnTo>
                <a:lnTo>
                  <a:pt x="5334" y="5461"/>
                </a:lnTo>
                <a:lnTo>
                  <a:pt x="1397" y="11430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162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4" name="object 114"/>
          <p:cNvSpPr/>
          <p:nvPr/>
        </p:nvSpPr>
        <p:spPr>
          <a:xfrm>
            <a:off x="4339643" y="62554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lnTo>
                  <a:pt x="11049" y="1397"/>
                </a:lnTo>
                <a:lnTo>
                  <a:pt x="5334" y="5461"/>
                </a:lnTo>
                <a:lnTo>
                  <a:pt x="1397" y="11430"/>
                </a:lnTo>
                <a:lnTo>
                  <a:pt x="0" y="18796"/>
                </a:lnTo>
                <a:lnTo>
                  <a:pt x="1397" y="26162"/>
                </a:lnTo>
                <a:lnTo>
                  <a:pt x="5334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162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5" name="object 115"/>
          <p:cNvSpPr/>
          <p:nvPr/>
        </p:nvSpPr>
        <p:spPr>
          <a:xfrm>
            <a:off x="4379916" y="625544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397"/>
                </a:lnTo>
                <a:lnTo>
                  <a:pt x="5588" y="5461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322"/>
                </a:lnTo>
                <a:lnTo>
                  <a:pt x="18923" y="37846"/>
                </a:lnTo>
                <a:lnTo>
                  <a:pt x="26289" y="36322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557"/>
                </a:lnTo>
                <a:lnTo>
                  <a:pt x="32258" y="5461"/>
                </a:lnTo>
                <a:lnTo>
                  <a:pt x="26289" y="1397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6" name="object 116"/>
          <p:cNvSpPr/>
          <p:nvPr/>
        </p:nvSpPr>
        <p:spPr>
          <a:xfrm>
            <a:off x="4379916" y="625544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557"/>
                </a:lnTo>
                <a:lnTo>
                  <a:pt x="32258" y="5461"/>
                </a:lnTo>
                <a:lnTo>
                  <a:pt x="26289" y="1397"/>
                </a:lnTo>
                <a:lnTo>
                  <a:pt x="18923" y="0"/>
                </a:lnTo>
                <a:lnTo>
                  <a:pt x="11557" y="1397"/>
                </a:lnTo>
                <a:lnTo>
                  <a:pt x="5588" y="5461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322"/>
                </a:lnTo>
                <a:lnTo>
                  <a:pt x="18923" y="37846"/>
                </a:lnTo>
                <a:lnTo>
                  <a:pt x="26289" y="36322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7" name="object 117"/>
          <p:cNvSpPr/>
          <p:nvPr/>
        </p:nvSpPr>
        <p:spPr>
          <a:xfrm>
            <a:off x="4420190" y="62554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397"/>
                </a:lnTo>
                <a:lnTo>
                  <a:pt x="5207" y="5461"/>
                </a:lnTo>
                <a:lnTo>
                  <a:pt x="1397" y="11430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162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8" name="object 118"/>
          <p:cNvSpPr/>
          <p:nvPr/>
        </p:nvSpPr>
        <p:spPr>
          <a:xfrm>
            <a:off x="4420190" y="6255446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lnTo>
                  <a:pt x="11049" y="1397"/>
                </a:lnTo>
                <a:lnTo>
                  <a:pt x="5207" y="5461"/>
                </a:lnTo>
                <a:lnTo>
                  <a:pt x="1397" y="11430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162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9" name="object 119"/>
          <p:cNvSpPr/>
          <p:nvPr/>
        </p:nvSpPr>
        <p:spPr>
          <a:xfrm>
            <a:off x="4460348" y="631424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0" name="object 120"/>
          <p:cNvSpPr/>
          <p:nvPr/>
        </p:nvSpPr>
        <p:spPr>
          <a:xfrm>
            <a:off x="4460348" y="6314244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1" name="object 121"/>
          <p:cNvSpPr/>
          <p:nvPr/>
        </p:nvSpPr>
        <p:spPr>
          <a:xfrm>
            <a:off x="4500621" y="6536094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9050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973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9050"/>
                </a:lnTo>
                <a:lnTo>
                  <a:pt x="36449" y="11684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2" name="object 122"/>
          <p:cNvSpPr/>
          <p:nvPr/>
        </p:nvSpPr>
        <p:spPr>
          <a:xfrm>
            <a:off x="4500621" y="6536094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9050"/>
                </a:moveTo>
                <a:lnTo>
                  <a:pt x="36449" y="11684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9050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973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3" name="object 123"/>
          <p:cNvSpPr/>
          <p:nvPr/>
        </p:nvSpPr>
        <p:spPr>
          <a:xfrm>
            <a:off x="4540895" y="6791658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4" name="object 124"/>
          <p:cNvSpPr/>
          <p:nvPr/>
        </p:nvSpPr>
        <p:spPr>
          <a:xfrm>
            <a:off x="4540895" y="6791658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5" name="object 125"/>
          <p:cNvSpPr/>
          <p:nvPr/>
        </p:nvSpPr>
        <p:spPr>
          <a:xfrm>
            <a:off x="4581052" y="690039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846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8923"/>
                </a:lnTo>
                <a:lnTo>
                  <a:pt x="36449" y="11557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6" name="object 126"/>
          <p:cNvSpPr/>
          <p:nvPr/>
        </p:nvSpPr>
        <p:spPr>
          <a:xfrm>
            <a:off x="4581052" y="6900396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449" y="11557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846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7" name="object 127"/>
          <p:cNvSpPr/>
          <p:nvPr/>
        </p:nvSpPr>
        <p:spPr>
          <a:xfrm>
            <a:off x="4195119" y="6745516"/>
            <a:ext cx="40273" cy="77670"/>
          </a:xfrm>
          <a:custGeom>
            <a:avLst/>
            <a:gdLst/>
            <a:ahLst/>
            <a:cxnLst/>
            <a:rect l="l" t="t" r="r" b="b"/>
            <a:pathLst>
              <a:path w="44450" h="85725">
                <a:moveTo>
                  <a:pt x="0" y="85471"/>
                </a:moveTo>
                <a:lnTo>
                  <a:pt x="44323" y="0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8" name="object 128"/>
          <p:cNvSpPr/>
          <p:nvPr/>
        </p:nvSpPr>
        <p:spPr>
          <a:xfrm>
            <a:off x="4235278" y="6571189"/>
            <a:ext cx="40273" cy="174327"/>
          </a:xfrm>
          <a:custGeom>
            <a:avLst/>
            <a:gdLst/>
            <a:ahLst/>
            <a:cxnLst/>
            <a:rect l="l" t="t" r="r" b="b"/>
            <a:pathLst>
              <a:path w="44450" h="192404">
                <a:moveTo>
                  <a:pt x="0" y="192405"/>
                </a:moveTo>
                <a:lnTo>
                  <a:pt x="44450" y="0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9" name="object 129"/>
          <p:cNvSpPr/>
          <p:nvPr/>
        </p:nvSpPr>
        <p:spPr>
          <a:xfrm>
            <a:off x="4275551" y="6338868"/>
            <a:ext cx="40273" cy="232436"/>
          </a:xfrm>
          <a:custGeom>
            <a:avLst/>
            <a:gdLst/>
            <a:ahLst/>
            <a:cxnLst/>
            <a:rect l="l" t="t" r="r" b="b"/>
            <a:pathLst>
              <a:path w="44450" h="256540">
                <a:moveTo>
                  <a:pt x="0" y="256413"/>
                </a:moveTo>
                <a:lnTo>
                  <a:pt x="44450" y="0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0" name="object 130"/>
          <p:cNvSpPr/>
          <p:nvPr/>
        </p:nvSpPr>
        <p:spPr>
          <a:xfrm>
            <a:off x="4315824" y="6224146"/>
            <a:ext cx="40273" cy="115067"/>
          </a:xfrm>
          <a:custGeom>
            <a:avLst/>
            <a:gdLst/>
            <a:ahLst/>
            <a:cxnLst/>
            <a:rect l="l" t="t" r="r" b="b"/>
            <a:pathLst>
              <a:path w="44450" h="127000">
                <a:moveTo>
                  <a:pt x="0" y="126619"/>
                </a:moveTo>
                <a:lnTo>
                  <a:pt x="44323" y="0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1" name="object 131"/>
          <p:cNvSpPr/>
          <p:nvPr/>
        </p:nvSpPr>
        <p:spPr>
          <a:xfrm>
            <a:off x="4355981" y="6224145"/>
            <a:ext cx="41999" cy="50630"/>
          </a:xfrm>
          <a:custGeom>
            <a:avLst/>
            <a:gdLst/>
            <a:ahLst/>
            <a:cxnLst/>
            <a:rect l="l" t="t" r="r" b="b"/>
            <a:pathLst>
              <a:path w="46354" h="55879">
                <a:moveTo>
                  <a:pt x="0" y="0"/>
                </a:moveTo>
                <a:lnTo>
                  <a:pt x="46101" y="55880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2" name="object 132"/>
          <p:cNvSpPr/>
          <p:nvPr/>
        </p:nvSpPr>
        <p:spPr>
          <a:xfrm>
            <a:off x="4397749" y="6274776"/>
            <a:ext cx="39124" cy="149012"/>
          </a:xfrm>
          <a:custGeom>
            <a:avLst/>
            <a:gdLst/>
            <a:ahLst/>
            <a:cxnLst/>
            <a:rect l="l" t="t" r="r" b="b"/>
            <a:pathLst>
              <a:path w="43179" h="164465">
                <a:moveTo>
                  <a:pt x="0" y="0"/>
                </a:moveTo>
                <a:lnTo>
                  <a:pt x="42799" y="164465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3" name="object 133"/>
          <p:cNvSpPr/>
          <p:nvPr/>
        </p:nvSpPr>
        <p:spPr>
          <a:xfrm>
            <a:off x="4436529" y="6423787"/>
            <a:ext cx="40273" cy="186410"/>
          </a:xfrm>
          <a:custGeom>
            <a:avLst/>
            <a:gdLst/>
            <a:ahLst/>
            <a:cxnLst/>
            <a:rect l="l" t="t" r="r" b="b"/>
            <a:pathLst>
              <a:path w="44450" h="205740">
                <a:moveTo>
                  <a:pt x="0" y="0"/>
                </a:moveTo>
                <a:lnTo>
                  <a:pt x="44450" y="205486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4" name="object 134"/>
          <p:cNvSpPr/>
          <p:nvPr/>
        </p:nvSpPr>
        <p:spPr>
          <a:xfrm>
            <a:off x="4476802" y="6609968"/>
            <a:ext cx="41999" cy="180655"/>
          </a:xfrm>
          <a:custGeom>
            <a:avLst/>
            <a:gdLst/>
            <a:ahLst/>
            <a:cxnLst/>
            <a:rect l="l" t="t" r="r" b="b"/>
            <a:pathLst>
              <a:path w="46354" h="199390">
                <a:moveTo>
                  <a:pt x="0" y="0"/>
                </a:moveTo>
                <a:lnTo>
                  <a:pt x="46101" y="198882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5" name="object 135"/>
          <p:cNvSpPr/>
          <p:nvPr/>
        </p:nvSpPr>
        <p:spPr>
          <a:xfrm>
            <a:off x="4518572" y="6790161"/>
            <a:ext cx="40273" cy="102984"/>
          </a:xfrm>
          <a:custGeom>
            <a:avLst/>
            <a:gdLst/>
            <a:ahLst/>
            <a:cxnLst/>
            <a:rect l="l" t="t" r="r" b="b"/>
            <a:pathLst>
              <a:path w="44450" h="113665">
                <a:moveTo>
                  <a:pt x="0" y="0"/>
                </a:moveTo>
                <a:lnTo>
                  <a:pt x="44323" y="113411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6" name="object 136"/>
          <p:cNvSpPr/>
          <p:nvPr/>
        </p:nvSpPr>
        <p:spPr>
          <a:xfrm>
            <a:off x="4558730" y="6892916"/>
            <a:ext cx="40273" cy="56958"/>
          </a:xfrm>
          <a:custGeom>
            <a:avLst/>
            <a:gdLst/>
            <a:ahLst/>
            <a:cxnLst/>
            <a:rect l="l" t="t" r="r" b="b"/>
            <a:pathLst>
              <a:path w="44450" h="62865">
                <a:moveTo>
                  <a:pt x="0" y="0"/>
                </a:moveTo>
                <a:lnTo>
                  <a:pt x="44450" y="62484"/>
                </a:lnTo>
              </a:path>
            </a:pathLst>
          </a:custGeom>
          <a:ln w="8228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7" name="object 137"/>
          <p:cNvSpPr/>
          <p:nvPr/>
        </p:nvSpPr>
        <p:spPr>
          <a:xfrm>
            <a:off x="4178663" y="6806015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5">
                <a:moveTo>
                  <a:pt x="0" y="37365"/>
                </a:moveTo>
                <a:lnTo>
                  <a:pt x="36195" y="37365"/>
                </a:lnTo>
                <a:lnTo>
                  <a:pt x="36195" y="0"/>
                </a:lnTo>
                <a:lnTo>
                  <a:pt x="0" y="0"/>
                </a:lnTo>
                <a:lnTo>
                  <a:pt x="0" y="373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8" name="object 138"/>
          <p:cNvSpPr/>
          <p:nvPr/>
        </p:nvSpPr>
        <p:spPr>
          <a:xfrm>
            <a:off x="4176506" y="6803859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127"/>
                </a:moveTo>
                <a:lnTo>
                  <a:pt x="40956" y="42127"/>
                </a:lnTo>
                <a:lnTo>
                  <a:pt x="40956" y="0"/>
                </a:lnTo>
                <a:lnTo>
                  <a:pt x="0" y="0"/>
                </a:lnTo>
                <a:lnTo>
                  <a:pt x="0" y="4212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9" name="object 139"/>
          <p:cNvSpPr/>
          <p:nvPr/>
        </p:nvSpPr>
        <p:spPr>
          <a:xfrm>
            <a:off x="4218936" y="6728486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5">
                <a:moveTo>
                  <a:pt x="0" y="37465"/>
                </a:moveTo>
                <a:lnTo>
                  <a:pt x="36195" y="37465"/>
                </a:lnTo>
                <a:lnTo>
                  <a:pt x="361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0" name="object 140"/>
          <p:cNvSpPr/>
          <p:nvPr/>
        </p:nvSpPr>
        <p:spPr>
          <a:xfrm>
            <a:off x="4216780" y="6726329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956" y="42226"/>
                </a:lnTo>
                <a:lnTo>
                  <a:pt x="40956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1" name="object 141"/>
          <p:cNvSpPr/>
          <p:nvPr/>
        </p:nvSpPr>
        <p:spPr>
          <a:xfrm>
            <a:off x="4257599" y="6552689"/>
            <a:ext cx="34519" cy="35671"/>
          </a:xfrm>
          <a:custGeom>
            <a:avLst/>
            <a:gdLst/>
            <a:ahLst/>
            <a:cxnLst/>
            <a:rect l="l" t="t" r="r" b="b"/>
            <a:pathLst>
              <a:path w="38100" h="39370">
                <a:moveTo>
                  <a:pt x="0" y="39087"/>
                </a:moveTo>
                <a:lnTo>
                  <a:pt x="37812" y="39087"/>
                </a:lnTo>
                <a:lnTo>
                  <a:pt x="37812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2" name="object 142"/>
          <p:cNvSpPr/>
          <p:nvPr/>
        </p:nvSpPr>
        <p:spPr>
          <a:xfrm>
            <a:off x="4255441" y="6550532"/>
            <a:ext cx="39124" cy="40273"/>
          </a:xfrm>
          <a:custGeom>
            <a:avLst/>
            <a:gdLst/>
            <a:ahLst/>
            <a:cxnLst/>
            <a:rect l="l" t="t" r="r" b="b"/>
            <a:pathLst>
              <a:path w="43179" h="44450">
                <a:moveTo>
                  <a:pt x="0" y="43849"/>
                </a:moveTo>
                <a:lnTo>
                  <a:pt x="42574" y="43849"/>
                </a:lnTo>
                <a:lnTo>
                  <a:pt x="42574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3" name="object 143"/>
          <p:cNvSpPr/>
          <p:nvPr/>
        </p:nvSpPr>
        <p:spPr>
          <a:xfrm>
            <a:off x="4299369" y="6320372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2"/>
                </a:moveTo>
                <a:lnTo>
                  <a:pt x="36195" y="39082"/>
                </a:lnTo>
                <a:lnTo>
                  <a:pt x="36195" y="0"/>
                </a:lnTo>
                <a:lnTo>
                  <a:pt x="0" y="0"/>
                </a:lnTo>
                <a:lnTo>
                  <a:pt x="0" y="390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4" name="object 144"/>
          <p:cNvSpPr/>
          <p:nvPr/>
        </p:nvSpPr>
        <p:spPr>
          <a:xfrm>
            <a:off x="4297211" y="6318216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4"/>
                </a:moveTo>
                <a:lnTo>
                  <a:pt x="40956" y="43844"/>
                </a:lnTo>
                <a:lnTo>
                  <a:pt x="40956" y="0"/>
                </a:lnTo>
                <a:lnTo>
                  <a:pt x="0" y="0"/>
                </a:lnTo>
                <a:lnTo>
                  <a:pt x="0" y="4384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5" name="object 145"/>
          <p:cNvSpPr/>
          <p:nvPr/>
        </p:nvSpPr>
        <p:spPr>
          <a:xfrm>
            <a:off x="4339643" y="6205762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7"/>
                </a:moveTo>
                <a:lnTo>
                  <a:pt x="36195" y="39087"/>
                </a:lnTo>
                <a:lnTo>
                  <a:pt x="36195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6" name="object 146"/>
          <p:cNvSpPr/>
          <p:nvPr/>
        </p:nvSpPr>
        <p:spPr>
          <a:xfrm>
            <a:off x="4337484" y="6203605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9"/>
                </a:moveTo>
                <a:lnTo>
                  <a:pt x="40956" y="43849"/>
                </a:lnTo>
                <a:lnTo>
                  <a:pt x="40956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7" name="object 147"/>
          <p:cNvSpPr/>
          <p:nvPr/>
        </p:nvSpPr>
        <p:spPr>
          <a:xfrm>
            <a:off x="4379801" y="6257832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5">
                <a:moveTo>
                  <a:pt x="0" y="37370"/>
                </a:moveTo>
                <a:lnTo>
                  <a:pt x="37906" y="37370"/>
                </a:lnTo>
                <a:lnTo>
                  <a:pt x="37906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8" name="object 148"/>
          <p:cNvSpPr/>
          <p:nvPr/>
        </p:nvSpPr>
        <p:spPr>
          <a:xfrm>
            <a:off x="4377642" y="6255675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32"/>
                </a:moveTo>
                <a:lnTo>
                  <a:pt x="42668" y="42132"/>
                </a:lnTo>
                <a:lnTo>
                  <a:pt x="42668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9" name="object 149"/>
          <p:cNvSpPr/>
          <p:nvPr/>
        </p:nvSpPr>
        <p:spPr>
          <a:xfrm>
            <a:off x="4420190" y="6406844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5">
                <a:moveTo>
                  <a:pt x="0" y="37370"/>
                </a:moveTo>
                <a:lnTo>
                  <a:pt x="36195" y="37370"/>
                </a:lnTo>
                <a:lnTo>
                  <a:pt x="36195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0" name="object 150"/>
          <p:cNvSpPr/>
          <p:nvPr/>
        </p:nvSpPr>
        <p:spPr>
          <a:xfrm>
            <a:off x="4418031" y="6404687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132"/>
                </a:moveTo>
                <a:lnTo>
                  <a:pt x="40956" y="42132"/>
                </a:lnTo>
                <a:lnTo>
                  <a:pt x="40956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1" name="object 151"/>
          <p:cNvSpPr/>
          <p:nvPr/>
        </p:nvSpPr>
        <p:spPr>
          <a:xfrm>
            <a:off x="4460348" y="6592937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5">
                <a:moveTo>
                  <a:pt x="0" y="37465"/>
                </a:moveTo>
                <a:lnTo>
                  <a:pt x="36195" y="37465"/>
                </a:lnTo>
                <a:lnTo>
                  <a:pt x="361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2" name="object 152"/>
          <p:cNvSpPr/>
          <p:nvPr/>
        </p:nvSpPr>
        <p:spPr>
          <a:xfrm>
            <a:off x="4458190" y="6590780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956" y="42226"/>
                </a:lnTo>
                <a:lnTo>
                  <a:pt x="40956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3" name="object 153"/>
          <p:cNvSpPr/>
          <p:nvPr/>
        </p:nvSpPr>
        <p:spPr>
          <a:xfrm>
            <a:off x="4500621" y="6771782"/>
            <a:ext cx="34519" cy="35671"/>
          </a:xfrm>
          <a:custGeom>
            <a:avLst/>
            <a:gdLst/>
            <a:ahLst/>
            <a:cxnLst/>
            <a:rect l="l" t="t" r="r" b="b"/>
            <a:pathLst>
              <a:path w="38100" h="39370">
                <a:moveTo>
                  <a:pt x="0" y="39082"/>
                </a:moveTo>
                <a:lnTo>
                  <a:pt x="37906" y="39082"/>
                </a:lnTo>
                <a:lnTo>
                  <a:pt x="37906" y="0"/>
                </a:lnTo>
                <a:lnTo>
                  <a:pt x="0" y="0"/>
                </a:lnTo>
                <a:lnTo>
                  <a:pt x="0" y="390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4" name="object 154"/>
          <p:cNvSpPr/>
          <p:nvPr/>
        </p:nvSpPr>
        <p:spPr>
          <a:xfrm>
            <a:off x="4498462" y="6769625"/>
            <a:ext cx="39124" cy="40273"/>
          </a:xfrm>
          <a:custGeom>
            <a:avLst/>
            <a:gdLst/>
            <a:ahLst/>
            <a:cxnLst/>
            <a:rect l="l" t="t" r="r" b="b"/>
            <a:pathLst>
              <a:path w="43179" h="44450">
                <a:moveTo>
                  <a:pt x="0" y="43844"/>
                </a:moveTo>
                <a:lnTo>
                  <a:pt x="42668" y="43844"/>
                </a:lnTo>
                <a:lnTo>
                  <a:pt x="42668" y="0"/>
                </a:lnTo>
                <a:lnTo>
                  <a:pt x="0" y="0"/>
                </a:lnTo>
                <a:lnTo>
                  <a:pt x="0" y="4384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5" name="object 155"/>
          <p:cNvSpPr/>
          <p:nvPr/>
        </p:nvSpPr>
        <p:spPr>
          <a:xfrm>
            <a:off x="4540895" y="6875972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5">
                <a:moveTo>
                  <a:pt x="0" y="37370"/>
                </a:moveTo>
                <a:lnTo>
                  <a:pt x="37812" y="37370"/>
                </a:lnTo>
                <a:lnTo>
                  <a:pt x="37812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6" name="object 156"/>
          <p:cNvSpPr/>
          <p:nvPr/>
        </p:nvSpPr>
        <p:spPr>
          <a:xfrm>
            <a:off x="4538735" y="6873816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32"/>
                </a:moveTo>
                <a:lnTo>
                  <a:pt x="42574" y="42132"/>
                </a:lnTo>
                <a:lnTo>
                  <a:pt x="42574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7" name="object 157"/>
          <p:cNvSpPr/>
          <p:nvPr/>
        </p:nvSpPr>
        <p:spPr>
          <a:xfrm>
            <a:off x="4581052" y="6932590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5">
                <a:moveTo>
                  <a:pt x="0" y="37365"/>
                </a:moveTo>
                <a:lnTo>
                  <a:pt x="37817" y="37365"/>
                </a:lnTo>
                <a:lnTo>
                  <a:pt x="37817" y="0"/>
                </a:lnTo>
                <a:lnTo>
                  <a:pt x="0" y="0"/>
                </a:lnTo>
                <a:lnTo>
                  <a:pt x="0" y="373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8" name="object 158"/>
          <p:cNvSpPr/>
          <p:nvPr/>
        </p:nvSpPr>
        <p:spPr>
          <a:xfrm>
            <a:off x="4578895" y="6930433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27"/>
                </a:moveTo>
                <a:lnTo>
                  <a:pt x="42579" y="42127"/>
                </a:lnTo>
                <a:lnTo>
                  <a:pt x="42579" y="0"/>
                </a:lnTo>
                <a:lnTo>
                  <a:pt x="0" y="0"/>
                </a:lnTo>
                <a:lnTo>
                  <a:pt x="0" y="4212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9" name="object 159"/>
          <p:cNvSpPr txBox="1"/>
          <p:nvPr/>
        </p:nvSpPr>
        <p:spPr>
          <a:xfrm>
            <a:off x="3935642" y="785696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3935642" y="1064850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3974303" y="134791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5360976" y="78569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5360976" y="995811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15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5360976" y="1207072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1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5360976" y="1418336"/>
            <a:ext cx="123697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</a:t>
            </a:r>
            <a:r>
              <a:rPr sz="498" b="1" spc="-33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6" name="object 166"/>
          <p:cNvSpPr txBox="1"/>
          <p:nvPr/>
        </p:nvSpPr>
        <p:spPr>
          <a:xfrm>
            <a:off x="4075102" y="1632360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3946688" y="1867099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8" name="object 168"/>
          <p:cNvSpPr txBox="1"/>
          <p:nvPr/>
        </p:nvSpPr>
        <p:spPr>
          <a:xfrm>
            <a:off x="3946688" y="2147398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69" name="object 169"/>
          <p:cNvSpPr txBox="1"/>
          <p:nvPr/>
        </p:nvSpPr>
        <p:spPr>
          <a:xfrm>
            <a:off x="3985349" y="2429085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0" name="object 170"/>
          <p:cNvSpPr txBox="1"/>
          <p:nvPr/>
        </p:nvSpPr>
        <p:spPr>
          <a:xfrm>
            <a:off x="4087531" y="2725956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1" name="object 171"/>
          <p:cNvSpPr txBox="1"/>
          <p:nvPr/>
        </p:nvSpPr>
        <p:spPr>
          <a:xfrm>
            <a:off x="3948069" y="2901664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2" name="object 172"/>
          <p:cNvSpPr txBox="1"/>
          <p:nvPr/>
        </p:nvSpPr>
        <p:spPr>
          <a:xfrm>
            <a:off x="3948069" y="3183351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3" name="object 173"/>
          <p:cNvSpPr txBox="1"/>
          <p:nvPr/>
        </p:nvSpPr>
        <p:spPr>
          <a:xfrm>
            <a:off x="4117905" y="1702779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4" name="object 174"/>
          <p:cNvSpPr txBox="1"/>
          <p:nvPr/>
        </p:nvSpPr>
        <p:spPr>
          <a:xfrm>
            <a:off x="4512815" y="1702779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1</a:t>
            </a:r>
            <a:endParaRPr sz="498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4908070" y="1702779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5302985" y="1702779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4130334" y="278257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4525242" y="278257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1</a:t>
            </a:r>
            <a:endParaRPr sz="498">
              <a:latin typeface="Arial"/>
              <a:cs typeface="Arial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4920499" y="278257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5312647" y="278257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5360976" y="163235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2" name="object 182"/>
          <p:cNvSpPr txBox="1"/>
          <p:nvPr/>
        </p:nvSpPr>
        <p:spPr>
          <a:xfrm>
            <a:off x="5372024" y="186709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4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5372023" y="207697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3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5372023" y="2289621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5" name="object 185"/>
          <p:cNvSpPr txBox="1"/>
          <p:nvPr/>
        </p:nvSpPr>
        <p:spPr>
          <a:xfrm>
            <a:off x="5372022" y="249950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1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6" name="object 186"/>
          <p:cNvSpPr txBox="1"/>
          <p:nvPr/>
        </p:nvSpPr>
        <p:spPr>
          <a:xfrm>
            <a:off x="5372023" y="2710766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7" name="object 187"/>
          <p:cNvSpPr txBox="1"/>
          <p:nvPr/>
        </p:nvSpPr>
        <p:spPr>
          <a:xfrm>
            <a:off x="5374782" y="290718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6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8" name="object 188"/>
          <p:cNvSpPr txBox="1"/>
          <p:nvPr/>
        </p:nvSpPr>
        <p:spPr>
          <a:xfrm>
            <a:off x="5374782" y="3188870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4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89" name="object 189"/>
          <p:cNvSpPr txBox="1"/>
          <p:nvPr/>
        </p:nvSpPr>
        <p:spPr>
          <a:xfrm>
            <a:off x="3979824" y="340151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0" name="object 190"/>
          <p:cNvSpPr txBox="1"/>
          <p:nvPr/>
        </p:nvSpPr>
        <p:spPr>
          <a:xfrm>
            <a:off x="5373401" y="340151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1" name="object 191"/>
          <p:cNvSpPr txBox="1"/>
          <p:nvPr/>
        </p:nvSpPr>
        <p:spPr>
          <a:xfrm>
            <a:off x="4080623" y="3681821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2" name="object 192"/>
          <p:cNvSpPr txBox="1"/>
          <p:nvPr/>
        </p:nvSpPr>
        <p:spPr>
          <a:xfrm>
            <a:off x="5373405" y="3681821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3" name="object 193"/>
          <p:cNvSpPr txBox="1"/>
          <p:nvPr/>
        </p:nvSpPr>
        <p:spPr>
          <a:xfrm>
            <a:off x="4133091" y="375362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4" name="object 194"/>
          <p:cNvSpPr txBox="1"/>
          <p:nvPr/>
        </p:nvSpPr>
        <p:spPr>
          <a:xfrm>
            <a:off x="4526620" y="375362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1</a:t>
            </a:r>
            <a:endParaRPr sz="498">
              <a:latin typeface="Arial"/>
              <a:cs typeface="Arial"/>
            </a:endParaRPr>
          </a:p>
        </p:txBody>
      </p:sp>
      <p:sp>
        <p:nvSpPr>
          <p:cNvPr id="195" name="object 195"/>
          <p:cNvSpPr txBox="1"/>
          <p:nvPr/>
        </p:nvSpPr>
        <p:spPr>
          <a:xfrm>
            <a:off x="4920495" y="375362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</p:txBody>
      </p:sp>
      <p:sp>
        <p:nvSpPr>
          <p:cNvPr id="196" name="object 196"/>
          <p:cNvSpPr txBox="1"/>
          <p:nvPr/>
        </p:nvSpPr>
        <p:spPr>
          <a:xfrm>
            <a:off x="5316788" y="3753622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3954968" y="3909655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3954965" y="4119531"/>
            <a:ext cx="1586776" cy="29328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4602" algn="r">
              <a:lnSpc>
                <a:spcPts val="580"/>
              </a:lnSpc>
            </a:pPr>
            <a:r>
              <a:rPr sz="498" b="1" spc="-18" dirty="0">
                <a:latin typeface="Arial"/>
                <a:cs typeface="Arial"/>
              </a:rPr>
              <a:t>6000</a:t>
            </a:r>
            <a:endParaRPr sz="498">
              <a:latin typeface="Arial"/>
              <a:cs typeface="Arial"/>
            </a:endParaRPr>
          </a:p>
          <a:p>
            <a:pPr marL="11506">
              <a:lnSpc>
                <a:spcPts val="580"/>
              </a:lnSpc>
            </a:pPr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  <a:p>
            <a:pPr>
              <a:spcBef>
                <a:spcPts val="31"/>
              </a:spcBef>
            </a:pPr>
            <a:endParaRPr sz="408">
              <a:latin typeface="Times New Roman"/>
              <a:cs typeface="Times New Roman"/>
            </a:endParaRPr>
          </a:p>
          <a:p>
            <a:pPr marR="4602" algn="r"/>
            <a:r>
              <a:rPr sz="498" b="1" spc="-18" dirty="0">
                <a:latin typeface="Arial"/>
                <a:cs typeface="Arial"/>
              </a:rPr>
              <a:t>4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199" name="object 199"/>
          <p:cNvSpPr txBox="1"/>
          <p:nvPr/>
        </p:nvSpPr>
        <p:spPr>
          <a:xfrm>
            <a:off x="3993628" y="447163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0" name="object 200"/>
          <p:cNvSpPr txBox="1"/>
          <p:nvPr/>
        </p:nvSpPr>
        <p:spPr>
          <a:xfrm>
            <a:off x="5385829" y="3909651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8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1" name="object 201"/>
          <p:cNvSpPr txBox="1"/>
          <p:nvPr/>
        </p:nvSpPr>
        <p:spPr>
          <a:xfrm>
            <a:off x="5385829" y="454205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2" name="object 202"/>
          <p:cNvSpPr txBox="1"/>
          <p:nvPr/>
        </p:nvSpPr>
        <p:spPr>
          <a:xfrm>
            <a:off x="4087527" y="4826735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3" name="object 203"/>
          <p:cNvSpPr txBox="1"/>
          <p:nvPr/>
        </p:nvSpPr>
        <p:spPr>
          <a:xfrm>
            <a:off x="5380309" y="4826735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4" name="object 204"/>
          <p:cNvSpPr txBox="1"/>
          <p:nvPr/>
        </p:nvSpPr>
        <p:spPr>
          <a:xfrm>
            <a:off x="4138615" y="4899914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5" name="object 205"/>
          <p:cNvSpPr txBox="1"/>
          <p:nvPr/>
        </p:nvSpPr>
        <p:spPr>
          <a:xfrm>
            <a:off x="4533525" y="4899914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1</a:t>
            </a:r>
            <a:endParaRPr sz="498">
              <a:latin typeface="Arial"/>
              <a:cs typeface="Arial"/>
            </a:endParaRPr>
          </a:p>
        </p:txBody>
      </p:sp>
      <p:sp>
        <p:nvSpPr>
          <p:cNvPr id="206" name="object 206"/>
          <p:cNvSpPr txBox="1"/>
          <p:nvPr/>
        </p:nvSpPr>
        <p:spPr>
          <a:xfrm>
            <a:off x="4927399" y="4899914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</p:txBody>
      </p:sp>
      <p:sp>
        <p:nvSpPr>
          <p:cNvPr id="207" name="object 207"/>
          <p:cNvSpPr txBox="1"/>
          <p:nvPr/>
        </p:nvSpPr>
        <p:spPr>
          <a:xfrm>
            <a:off x="5322309" y="4899914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208" name="object 208"/>
          <p:cNvSpPr txBox="1"/>
          <p:nvPr/>
        </p:nvSpPr>
        <p:spPr>
          <a:xfrm>
            <a:off x="3961392" y="5082183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09" name="object 209"/>
          <p:cNvSpPr txBox="1"/>
          <p:nvPr/>
        </p:nvSpPr>
        <p:spPr>
          <a:xfrm>
            <a:off x="3961392" y="5362480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0" name="object 210"/>
          <p:cNvSpPr txBox="1"/>
          <p:nvPr/>
        </p:nvSpPr>
        <p:spPr>
          <a:xfrm>
            <a:off x="4000052" y="564416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1" name="object 211"/>
          <p:cNvSpPr txBox="1"/>
          <p:nvPr/>
        </p:nvSpPr>
        <p:spPr>
          <a:xfrm>
            <a:off x="4102232" y="5925846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2" name="object 212"/>
          <p:cNvSpPr txBox="1"/>
          <p:nvPr/>
        </p:nvSpPr>
        <p:spPr>
          <a:xfrm>
            <a:off x="3985345" y="6135728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5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3" name="object 213"/>
          <p:cNvSpPr txBox="1"/>
          <p:nvPr/>
        </p:nvSpPr>
        <p:spPr>
          <a:xfrm>
            <a:off x="3985345" y="6417413"/>
            <a:ext cx="195038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9" dirty="0">
                <a:latin typeface="Arial"/>
                <a:cs typeface="Arial"/>
              </a:rPr>
              <a:t>100</a:t>
            </a:r>
            <a:r>
              <a:rPr sz="498" b="1" spc="-18" dirty="0">
                <a:latin typeface="Arial"/>
                <a:cs typeface="Arial"/>
              </a:rPr>
              <a:t>0</a:t>
            </a:r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4" name="object 214"/>
          <p:cNvSpPr txBox="1"/>
          <p:nvPr/>
        </p:nvSpPr>
        <p:spPr>
          <a:xfrm>
            <a:off x="4024006" y="6697719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5" name="object 215"/>
          <p:cNvSpPr txBox="1"/>
          <p:nvPr/>
        </p:nvSpPr>
        <p:spPr>
          <a:xfrm>
            <a:off x="4146416" y="599488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16" name="object 216"/>
          <p:cNvSpPr txBox="1"/>
          <p:nvPr/>
        </p:nvSpPr>
        <p:spPr>
          <a:xfrm>
            <a:off x="4541326" y="599488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1</a:t>
            </a:r>
            <a:endParaRPr sz="498">
              <a:latin typeface="Arial"/>
              <a:cs typeface="Arial"/>
            </a:endParaRPr>
          </a:p>
        </p:txBody>
      </p:sp>
      <p:sp>
        <p:nvSpPr>
          <p:cNvPr id="217" name="object 217"/>
          <p:cNvSpPr txBox="1"/>
          <p:nvPr/>
        </p:nvSpPr>
        <p:spPr>
          <a:xfrm>
            <a:off x="4935200" y="599488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5330114" y="599488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5388106" y="5082178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6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5388105" y="5362480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4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1" name="object 221"/>
          <p:cNvSpPr txBox="1"/>
          <p:nvPr/>
        </p:nvSpPr>
        <p:spPr>
          <a:xfrm>
            <a:off x="5388105" y="5644165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2" name="object 222"/>
          <p:cNvSpPr txBox="1"/>
          <p:nvPr/>
        </p:nvSpPr>
        <p:spPr>
          <a:xfrm>
            <a:off x="5388105" y="5925844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3" name="object 223"/>
          <p:cNvSpPr txBox="1"/>
          <p:nvPr/>
        </p:nvSpPr>
        <p:spPr>
          <a:xfrm>
            <a:off x="5410676" y="6134347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5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4" name="object 224"/>
          <p:cNvSpPr txBox="1"/>
          <p:nvPr/>
        </p:nvSpPr>
        <p:spPr>
          <a:xfrm>
            <a:off x="5410676" y="6304188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4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5" name="object 225"/>
          <p:cNvSpPr txBox="1"/>
          <p:nvPr/>
        </p:nvSpPr>
        <p:spPr>
          <a:xfrm>
            <a:off x="5410676" y="6471264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3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6" name="object 226"/>
          <p:cNvSpPr txBox="1"/>
          <p:nvPr/>
        </p:nvSpPr>
        <p:spPr>
          <a:xfrm>
            <a:off x="5410676" y="6641106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2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7" name="object 227"/>
          <p:cNvSpPr txBox="1"/>
          <p:nvPr/>
        </p:nvSpPr>
        <p:spPr>
          <a:xfrm>
            <a:off x="5410676" y="6809913"/>
            <a:ext cx="155916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spc="-18" dirty="0">
                <a:latin typeface="Arial"/>
                <a:cs typeface="Arial"/>
              </a:rPr>
              <a:t>100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8" name="object 228"/>
          <p:cNvSpPr txBox="1"/>
          <p:nvPr/>
        </p:nvSpPr>
        <p:spPr>
          <a:xfrm>
            <a:off x="4116518" y="701150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29" name="object 229"/>
          <p:cNvSpPr txBox="1"/>
          <p:nvPr/>
        </p:nvSpPr>
        <p:spPr>
          <a:xfrm>
            <a:off x="5410677" y="701150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30" name="object 230"/>
          <p:cNvSpPr txBox="1"/>
          <p:nvPr/>
        </p:nvSpPr>
        <p:spPr>
          <a:xfrm>
            <a:off x="4167605" y="708330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0</a:t>
            </a:r>
            <a:endParaRPr sz="498">
              <a:latin typeface="Arial"/>
              <a:cs typeface="Arial"/>
            </a:endParaRPr>
          </a:p>
        </p:txBody>
      </p:sp>
      <p:sp>
        <p:nvSpPr>
          <p:cNvPr id="231" name="object 231"/>
          <p:cNvSpPr txBox="1"/>
          <p:nvPr/>
        </p:nvSpPr>
        <p:spPr>
          <a:xfrm>
            <a:off x="4561135" y="7083310"/>
            <a:ext cx="471199" cy="18601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>
              <a:tabLst>
                <a:tab pos="405024" algn="l"/>
              </a:tabLst>
            </a:pPr>
            <a:r>
              <a:rPr sz="498" b="1" dirty="0">
                <a:latin typeface="Arial"/>
                <a:cs typeface="Arial"/>
              </a:rPr>
              <a:t>1</a:t>
            </a:r>
            <a:r>
              <a:rPr sz="498" b="1" dirty="0">
                <a:latin typeface="Times New Roman"/>
                <a:cs typeface="Times New Roman"/>
              </a:rPr>
              <a:t>	</a:t>
            </a:r>
            <a:r>
              <a:rPr sz="498" b="1" dirty="0">
                <a:latin typeface="Arial"/>
                <a:cs typeface="Arial"/>
              </a:rPr>
              <a:t>2</a:t>
            </a:r>
            <a:endParaRPr sz="498">
              <a:latin typeface="Arial"/>
              <a:cs typeface="Arial"/>
            </a:endParaRPr>
          </a:p>
          <a:p>
            <a:pPr marL="16684">
              <a:spcBef>
                <a:spcPts val="226"/>
              </a:spcBef>
            </a:pPr>
            <a:r>
              <a:rPr sz="544" b="1" spc="-14" dirty="0">
                <a:latin typeface="Arial"/>
                <a:cs typeface="Arial"/>
              </a:rPr>
              <a:t>d</a:t>
            </a:r>
            <a:r>
              <a:rPr sz="544" b="1" spc="-18" dirty="0">
                <a:latin typeface="Arial"/>
                <a:cs typeface="Arial"/>
              </a:rPr>
              <a:t>i</a:t>
            </a:r>
            <a:r>
              <a:rPr sz="544" b="1" spc="-9" dirty="0">
                <a:latin typeface="Arial"/>
                <a:cs typeface="Arial"/>
              </a:rPr>
              <a:t>sta</a:t>
            </a:r>
            <a:r>
              <a:rPr sz="544" b="1" spc="-14" dirty="0">
                <a:latin typeface="Arial"/>
                <a:cs typeface="Arial"/>
              </a:rPr>
              <a:t>n</a:t>
            </a:r>
            <a:r>
              <a:rPr sz="544" b="1" spc="-9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e</a:t>
            </a:r>
            <a:r>
              <a:rPr sz="544" b="1" spc="33" dirty="0">
                <a:latin typeface="Times New Roman"/>
                <a:cs typeface="Times New Roman"/>
              </a:rPr>
              <a:t> </a:t>
            </a:r>
            <a:r>
              <a:rPr sz="544" b="1" dirty="0">
                <a:latin typeface="Arial"/>
                <a:cs typeface="Arial"/>
              </a:rPr>
              <a:t>(</a:t>
            </a:r>
            <a:r>
              <a:rPr sz="544" b="1" spc="-59" dirty="0">
                <a:latin typeface="Times New Roman"/>
                <a:cs typeface="Times New Roman"/>
              </a:rPr>
              <a:t> </a:t>
            </a:r>
            <a:r>
              <a:rPr sz="544" b="1" spc="-28" dirty="0">
                <a:latin typeface="Symbol"/>
                <a:cs typeface="Symbol"/>
              </a:rPr>
              <a:t></a:t>
            </a:r>
            <a:r>
              <a:rPr sz="544" b="1" spc="-28" dirty="0">
                <a:latin typeface="Arial"/>
                <a:cs typeface="Arial"/>
              </a:rPr>
              <a:t>m)</a:t>
            </a:r>
            <a:endParaRPr sz="544">
              <a:latin typeface="Arial"/>
              <a:cs typeface="Arial"/>
            </a:endParaRPr>
          </a:p>
        </p:txBody>
      </p:sp>
      <p:sp>
        <p:nvSpPr>
          <p:cNvPr id="232" name="object 232"/>
          <p:cNvSpPr txBox="1"/>
          <p:nvPr/>
        </p:nvSpPr>
        <p:spPr>
          <a:xfrm>
            <a:off x="5349918" y="7083308"/>
            <a:ext cx="58683" cy="7662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98" b="1" dirty="0">
                <a:latin typeface="Arial"/>
                <a:cs typeface="Arial"/>
              </a:rPr>
              <a:t>3</a:t>
            </a:r>
            <a:endParaRPr sz="498">
              <a:latin typeface="Arial"/>
              <a:cs typeface="Arial"/>
            </a:endParaRPr>
          </a:p>
        </p:txBody>
      </p:sp>
      <p:sp>
        <p:nvSpPr>
          <p:cNvPr id="233" name="object 233"/>
          <p:cNvSpPr txBox="1"/>
          <p:nvPr/>
        </p:nvSpPr>
        <p:spPr>
          <a:xfrm>
            <a:off x="202518" y="7875639"/>
            <a:ext cx="6420170" cy="81054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>
              <a:lnSpc>
                <a:spcPct val="1236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spc="-3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3" dirty="0">
                <a:latin typeface="Times New Roman"/>
                <a:cs typeface="Times New Roman"/>
              </a:rPr>
              <a:t>u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8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1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23" dirty="0">
                <a:latin typeface="Times New Roman"/>
                <a:cs typeface="Times New Roman"/>
              </a:rPr>
              <a:t>o</a:t>
            </a:r>
            <a:r>
              <a:rPr sz="1087" b="1" spc="14" dirty="0">
                <a:latin typeface="Times New Roman"/>
                <a:cs typeface="Times New Roman"/>
              </a:rPr>
              <a:t>ro</a:t>
            </a:r>
            <a:r>
              <a:rPr sz="1087" b="1" spc="28" dirty="0">
                <a:latin typeface="Times New Roman"/>
                <a:cs typeface="Times New Roman"/>
              </a:rPr>
              <a:t>qu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spc="-23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du</a:t>
            </a:r>
            <a:r>
              <a:rPr sz="1087" b="1" spc="14" dirty="0">
                <a:latin typeface="Times New Roman"/>
                <a:cs typeface="Times New Roman"/>
              </a:rPr>
              <a:t>ces</a:t>
            </a:r>
            <a:r>
              <a:rPr sz="1087" b="1" spc="-18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23" dirty="0">
                <a:latin typeface="Times New Roman"/>
                <a:cs typeface="Times New Roman"/>
              </a:rPr>
              <a:t>e</a:t>
            </a:r>
            <a:r>
              <a:rPr sz="1087" b="1" spc="14" dirty="0">
                <a:latin typeface="Times New Roman"/>
                <a:cs typeface="Times New Roman"/>
              </a:rPr>
              <a:t>cr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9" dirty="0">
                <a:latin typeface="Times New Roman"/>
                <a:cs typeface="Times New Roman"/>
              </a:rPr>
              <a:t>it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spc="-18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of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36" dirty="0">
                <a:latin typeface="Times New Roman"/>
                <a:cs typeface="Times New Roman"/>
              </a:rPr>
              <a:t>L</a:t>
            </a:r>
            <a:r>
              <a:rPr sz="1087" b="1" spc="18" dirty="0">
                <a:latin typeface="Times New Roman"/>
                <a:cs typeface="Times New Roman"/>
              </a:rPr>
              <a:t>C3 to</a:t>
            </a:r>
            <a:r>
              <a:rPr sz="1087" b="1" spc="9" dirty="0">
                <a:latin typeface="Times New Roman"/>
                <a:cs typeface="Times New Roman"/>
              </a:rPr>
              <a:t> s</a:t>
            </a:r>
            <a:r>
              <a:rPr sz="1087" b="1" spc="45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ll</a:t>
            </a:r>
            <a:r>
              <a:rPr sz="1087" b="1" spc="-36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pun</a:t>
            </a:r>
            <a:r>
              <a:rPr sz="1087" b="1" spc="14" dirty="0">
                <a:latin typeface="Times New Roman"/>
                <a:cs typeface="Times New Roman"/>
              </a:rPr>
              <a:t>c</a:t>
            </a:r>
            <a:r>
              <a:rPr sz="1087" b="1" spc="18" dirty="0">
                <a:latin typeface="Times New Roman"/>
                <a:cs typeface="Times New Roman"/>
              </a:rPr>
              <a:t>ta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oca</a:t>
            </a:r>
            <a:r>
              <a:rPr sz="1087" b="1" spc="23" dirty="0">
                <a:latin typeface="Times New Roman"/>
                <a:cs typeface="Times New Roman"/>
              </a:rPr>
              <a:t>t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3" dirty="0">
                <a:latin typeface="Times New Roman"/>
                <a:cs typeface="Times New Roman"/>
              </a:rPr>
              <a:t>d</a:t>
            </a:r>
            <a:r>
              <a:rPr sz="1087" b="1" spc="-28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c</a:t>
            </a:r>
            <a:r>
              <a:rPr sz="1087" b="1" spc="18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os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spc="-28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to</a:t>
            </a:r>
            <a:r>
              <a:rPr sz="1087" b="1" spc="-28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s</a:t>
            </a:r>
            <a:r>
              <a:rPr sz="1087" b="1" spc="28" dirty="0">
                <a:latin typeface="Times New Roman"/>
                <a:cs typeface="Times New Roman"/>
              </a:rPr>
              <a:t>w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9" dirty="0">
                <a:latin typeface="Times New Roman"/>
                <a:cs typeface="Times New Roman"/>
              </a:rPr>
              <a:t>lle</a:t>
            </a:r>
            <a:r>
              <a:rPr sz="1087" b="1" spc="23" dirty="0">
                <a:latin typeface="Times New Roman"/>
                <a:cs typeface="Times New Roman"/>
              </a:rPr>
              <a:t>n</a:t>
            </a:r>
            <a:r>
              <a:rPr sz="1087" b="1" spc="9" dirty="0">
                <a:latin typeface="Times New Roman"/>
                <a:cs typeface="Times New Roman"/>
              </a:rPr>
              <a:t> l</a:t>
            </a:r>
            <a:r>
              <a:rPr sz="1087" b="1" spc="14" dirty="0">
                <a:latin typeface="Times New Roman"/>
                <a:cs typeface="Times New Roman"/>
              </a:rPr>
              <a:t>ysoso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s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-50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-/-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incu</a:t>
            </a:r>
            <a:r>
              <a:rPr sz="1087" spc="23" dirty="0">
                <a:latin typeface="Times New Roman"/>
                <a:cs typeface="Times New Roman"/>
              </a:rPr>
              <a:t>b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-6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h</a:t>
            </a:r>
            <a:r>
              <a:rPr sz="1087" spc="18" dirty="0">
                <a:latin typeface="Times New Roman"/>
                <a:cs typeface="Times New Roman"/>
              </a:rPr>
              <a:t>ours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in</a:t>
            </a:r>
            <a:r>
              <a:rPr sz="1087" spc="-6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9" dirty="0">
                <a:latin typeface="Times New Roman"/>
                <a:cs typeface="Times New Roman"/>
              </a:rPr>
              <a:t>tr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a</a:t>
            </a:r>
            <a:r>
              <a:rPr sz="1087" spc="-6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o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ing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qu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spc="18" dirty="0">
                <a:latin typeface="Times New Roman"/>
                <a:cs typeface="Times New Roman"/>
              </a:rPr>
              <a:t>1</a:t>
            </a:r>
            <a:r>
              <a:rPr sz="1087" spc="33" dirty="0">
                <a:latin typeface="Times New Roman"/>
                <a:cs typeface="Times New Roman"/>
              </a:rPr>
              <a:t>0</a:t>
            </a:r>
            <a:r>
              <a:rPr sz="1087" spc="18" dirty="0">
                <a:latin typeface="Times New Roman"/>
                <a:cs typeface="Times New Roman"/>
              </a:rPr>
              <a:t>0</a:t>
            </a:r>
            <a:r>
              <a:rPr sz="1087" spc="28" dirty="0">
                <a:latin typeface="Times New Roman"/>
                <a:cs typeface="Times New Roman"/>
              </a:rPr>
              <a:t>µ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14" dirty="0">
                <a:latin typeface="Times New Roman"/>
                <a:cs typeface="Times New Roman"/>
              </a:rPr>
              <a:t>). </a:t>
            </a:r>
            <a:r>
              <a:rPr sz="1087" spc="28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e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w</a:t>
            </a:r>
            <a:r>
              <a:rPr sz="1087" spc="14" dirty="0">
                <a:latin typeface="Times New Roman"/>
                <a:cs typeface="Times New Roman"/>
              </a:rPr>
              <a:t>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fix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i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8" dirty="0">
                <a:latin typeface="Times New Roman"/>
                <a:cs typeface="Times New Roman"/>
              </a:rPr>
              <a:t>mu</a:t>
            </a:r>
            <a:r>
              <a:rPr sz="1087" spc="9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33" dirty="0">
                <a:latin typeface="Times New Roman"/>
                <a:cs typeface="Times New Roman"/>
              </a:rPr>
              <a:t>C</a:t>
            </a:r>
            <a:r>
              <a:rPr sz="1087" spc="28" dirty="0">
                <a:latin typeface="Times New Roman"/>
                <a:cs typeface="Times New Roman"/>
              </a:rPr>
              <a:t>3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LAMP1.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14" dirty="0">
                <a:latin typeface="Times New Roman"/>
                <a:cs typeface="Times New Roman"/>
              </a:rPr>
              <a:t> r</a:t>
            </a:r>
            <a:r>
              <a:rPr sz="1087" spc="18" dirty="0">
                <a:latin typeface="Times New Roman"/>
                <a:cs typeface="Times New Roman"/>
              </a:rPr>
              <a:t>egions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i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st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d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3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28" dirty="0">
                <a:latin typeface="Times New Roman"/>
                <a:cs typeface="Times New Roman"/>
              </a:rPr>
              <a:t>ed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o</a:t>
            </a:r>
            <a:r>
              <a:rPr sz="1087" spc="18" dirty="0">
                <a:latin typeface="Times New Roman"/>
                <a:cs typeface="Times New Roman"/>
              </a:rPr>
              <a:t> gen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 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pr</a:t>
            </a:r>
            <a:r>
              <a:rPr sz="1087" spc="23" dirty="0">
                <a:latin typeface="Times New Roman"/>
                <a:cs typeface="Times New Roman"/>
              </a:rPr>
              <a:t>of</a:t>
            </a:r>
            <a:r>
              <a:rPr sz="1087" spc="9" dirty="0">
                <a:latin typeface="Times New Roman"/>
                <a:cs typeface="Times New Roman"/>
              </a:rPr>
              <a:t>i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6" dirty="0">
                <a:latin typeface="Times New Roman"/>
                <a:cs typeface="Times New Roman"/>
              </a:rPr>
              <a:t>w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stri</a:t>
            </a:r>
            <a:r>
              <a:rPr sz="1087" spc="18" dirty="0">
                <a:latin typeface="Times New Roman"/>
                <a:cs typeface="Times New Roman"/>
              </a:rPr>
              <a:t>bu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ion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L</a:t>
            </a:r>
            <a:r>
              <a:rPr sz="1087" spc="23" dirty="0">
                <a:latin typeface="Times New Roman"/>
                <a:cs typeface="Times New Roman"/>
              </a:rPr>
              <a:t>C3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LAMP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all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p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36" dirty="0">
                <a:latin typeface="Times New Roman"/>
                <a:cs typeface="Times New Roman"/>
              </a:rPr>
              <a:t>w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y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somes.</a:t>
            </a:r>
            <a:endParaRPr sz="1087">
              <a:latin typeface="Times New Roman"/>
              <a:cs typeface="Times New Roman"/>
            </a:endParaRPr>
          </a:p>
        </p:txBody>
      </p:sp>
      <p:sp>
        <p:nvSpPr>
          <p:cNvPr id="234" name="object 234"/>
          <p:cNvSpPr/>
          <p:nvPr/>
        </p:nvSpPr>
        <p:spPr>
          <a:xfrm>
            <a:off x="2487061" y="2508743"/>
            <a:ext cx="211723" cy="212874"/>
          </a:xfrm>
          <a:custGeom>
            <a:avLst/>
            <a:gdLst/>
            <a:ahLst/>
            <a:cxnLst/>
            <a:rect l="l" t="t" r="r" b="b"/>
            <a:pathLst>
              <a:path w="233680" h="234950">
                <a:moveTo>
                  <a:pt x="0" y="234697"/>
                </a:moveTo>
                <a:lnTo>
                  <a:pt x="233174" y="234697"/>
                </a:lnTo>
                <a:lnTo>
                  <a:pt x="233174" y="0"/>
                </a:lnTo>
                <a:lnTo>
                  <a:pt x="0" y="0"/>
                </a:lnTo>
                <a:lnTo>
                  <a:pt x="0" y="234697"/>
                </a:lnTo>
                <a:close/>
              </a:path>
            </a:pathLst>
          </a:custGeom>
          <a:ln w="609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5" name="object 235"/>
          <p:cNvSpPr/>
          <p:nvPr/>
        </p:nvSpPr>
        <p:spPr>
          <a:xfrm>
            <a:off x="4153672" y="5963864"/>
            <a:ext cx="1231217" cy="0"/>
          </a:xfrm>
          <a:custGeom>
            <a:avLst/>
            <a:gdLst/>
            <a:ahLst/>
            <a:cxnLst/>
            <a:rect l="l" t="t" r="r" b="b"/>
            <a:pathLst>
              <a:path w="1358900">
                <a:moveTo>
                  <a:pt x="0" y="0"/>
                </a:moveTo>
                <a:lnTo>
                  <a:pt x="135851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6" name="object 236"/>
          <p:cNvSpPr/>
          <p:nvPr/>
        </p:nvSpPr>
        <p:spPr>
          <a:xfrm>
            <a:off x="4177606" y="5120077"/>
            <a:ext cx="0" cy="869332"/>
          </a:xfrm>
          <a:custGeom>
            <a:avLst/>
            <a:gdLst/>
            <a:ahLst/>
            <a:cxnLst/>
            <a:rect l="l" t="t" r="r" b="b"/>
            <a:pathLst>
              <a:path h="959485">
                <a:moveTo>
                  <a:pt x="0" y="0"/>
                </a:moveTo>
                <a:lnTo>
                  <a:pt x="0" y="959231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7" name="object 237"/>
          <p:cNvSpPr/>
          <p:nvPr/>
        </p:nvSpPr>
        <p:spPr>
          <a:xfrm>
            <a:off x="4572401" y="5963865"/>
            <a:ext cx="0" cy="25315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94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8" name="object 238"/>
          <p:cNvSpPr/>
          <p:nvPr/>
        </p:nvSpPr>
        <p:spPr>
          <a:xfrm>
            <a:off x="4965816" y="5963865"/>
            <a:ext cx="0" cy="25315"/>
          </a:xfrm>
          <a:custGeom>
            <a:avLst/>
            <a:gdLst/>
            <a:ahLst/>
            <a:cxnLst/>
            <a:rect l="l" t="t" r="r" b="b"/>
            <a:pathLst>
              <a:path h="27939">
                <a:moveTo>
                  <a:pt x="0" y="0"/>
                </a:moveTo>
                <a:lnTo>
                  <a:pt x="0" y="2794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9" name="object 239"/>
          <p:cNvSpPr/>
          <p:nvPr/>
        </p:nvSpPr>
        <p:spPr>
          <a:xfrm>
            <a:off x="5360726" y="5120077"/>
            <a:ext cx="0" cy="869332"/>
          </a:xfrm>
          <a:custGeom>
            <a:avLst/>
            <a:gdLst/>
            <a:ahLst/>
            <a:cxnLst/>
            <a:rect l="l" t="t" r="r" b="b"/>
            <a:pathLst>
              <a:path h="959485">
                <a:moveTo>
                  <a:pt x="0" y="0"/>
                </a:moveTo>
                <a:lnTo>
                  <a:pt x="0" y="959231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0" name="object 240"/>
          <p:cNvSpPr/>
          <p:nvPr/>
        </p:nvSpPr>
        <p:spPr>
          <a:xfrm>
            <a:off x="4153670" y="568402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1" name="object 241"/>
          <p:cNvSpPr/>
          <p:nvPr/>
        </p:nvSpPr>
        <p:spPr>
          <a:xfrm>
            <a:off x="4153670" y="540130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2" name="object 242"/>
          <p:cNvSpPr/>
          <p:nvPr/>
        </p:nvSpPr>
        <p:spPr>
          <a:xfrm>
            <a:off x="4153670" y="5121573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26416" y="0"/>
                </a:moveTo>
                <a:lnTo>
                  <a:pt x="0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3" name="object 243"/>
          <p:cNvSpPr/>
          <p:nvPr/>
        </p:nvSpPr>
        <p:spPr>
          <a:xfrm>
            <a:off x="5360726" y="568402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4" name="object 244"/>
          <p:cNvSpPr/>
          <p:nvPr/>
        </p:nvSpPr>
        <p:spPr>
          <a:xfrm>
            <a:off x="5360726" y="5401301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5" name="object 245"/>
          <p:cNvSpPr/>
          <p:nvPr/>
        </p:nvSpPr>
        <p:spPr>
          <a:xfrm>
            <a:off x="5360726" y="5121573"/>
            <a:ext cx="24165" cy="0"/>
          </a:xfrm>
          <a:custGeom>
            <a:avLst/>
            <a:gdLst/>
            <a:ahLst/>
            <a:cxnLst/>
            <a:rect l="l" t="t" r="r" b="b"/>
            <a:pathLst>
              <a:path w="26670">
                <a:moveTo>
                  <a:pt x="0" y="0"/>
                </a:moveTo>
                <a:lnTo>
                  <a:pt x="26289" y="0"/>
                </a:lnTo>
              </a:path>
            </a:pathLst>
          </a:custGeom>
          <a:ln w="821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6" name="object 246"/>
          <p:cNvSpPr/>
          <p:nvPr/>
        </p:nvSpPr>
        <p:spPr>
          <a:xfrm>
            <a:off x="4173808" y="5214547"/>
            <a:ext cx="371033" cy="351184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7" name="object 247"/>
          <p:cNvSpPr/>
          <p:nvPr/>
        </p:nvSpPr>
        <p:spPr>
          <a:xfrm>
            <a:off x="4541104" y="5340315"/>
            <a:ext cx="40273" cy="237037"/>
          </a:xfrm>
          <a:custGeom>
            <a:avLst/>
            <a:gdLst/>
            <a:ahLst/>
            <a:cxnLst/>
            <a:rect l="l" t="t" r="r" b="b"/>
            <a:pathLst>
              <a:path w="44450" h="261620">
                <a:moveTo>
                  <a:pt x="0" y="0"/>
                </a:moveTo>
                <a:lnTo>
                  <a:pt x="44450" y="261239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8" name="object 248"/>
          <p:cNvSpPr/>
          <p:nvPr/>
        </p:nvSpPr>
        <p:spPr>
          <a:xfrm>
            <a:off x="4581378" y="5577008"/>
            <a:ext cx="40273" cy="83424"/>
          </a:xfrm>
          <a:custGeom>
            <a:avLst/>
            <a:gdLst/>
            <a:ahLst/>
            <a:cxnLst/>
            <a:rect l="l" t="t" r="r" b="b"/>
            <a:pathLst>
              <a:path w="44450" h="92075">
                <a:moveTo>
                  <a:pt x="0" y="0"/>
                </a:moveTo>
                <a:lnTo>
                  <a:pt x="44323" y="91948"/>
                </a:lnTo>
              </a:path>
            </a:pathLst>
          </a:custGeom>
          <a:ln w="8219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9" name="object 249"/>
          <p:cNvSpPr/>
          <p:nvPr/>
        </p:nvSpPr>
        <p:spPr>
          <a:xfrm>
            <a:off x="4161038" y="5527760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0" name="object 250"/>
          <p:cNvSpPr/>
          <p:nvPr/>
        </p:nvSpPr>
        <p:spPr>
          <a:xfrm>
            <a:off x="4161038" y="5527760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334" y="32258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322"/>
                </a:lnTo>
                <a:lnTo>
                  <a:pt x="30988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1" name="object 251"/>
          <p:cNvSpPr/>
          <p:nvPr/>
        </p:nvSpPr>
        <p:spPr>
          <a:xfrm>
            <a:off x="4201426" y="554421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397"/>
                </a:lnTo>
                <a:lnTo>
                  <a:pt x="5207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2" name="object 252"/>
          <p:cNvSpPr/>
          <p:nvPr/>
        </p:nvSpPr>
        <p:spPr>
          <a:xfrm>
            <a:off x="4201426" y="554421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461"/>
                </a:lnTo>
                <a:lnTo>
                  <a:pt x="25146" y="1397"/>
                </a:lnTo>
                <a:lnTo>
                  <a:pt x="18034" y="0"/>
                </a:lnTo>
                <a:lnTo>
                  <a:pt x="11049" y="1397"/>
                </a:lnTo>
                <a:lnTo>
                  <a:pt x="5207" y="5461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162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719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3" name="object 253"/>
          <p:cNvSpPr/>
          <p:nvPr/>
        </p:nvSpPr>
        <p:spPr>
          <a:xfrm>
            <a:off x="4240088" y="5432600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846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8923"/>
                </a:lnTo>
                <a:lnTo>
                  <a:pt x="36449" y="11557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4" name="object 254"/>
          <p:cNvSpPr/>
          <p:nvPr/>
        </p:nvSpPr>
        <p:spPr>
          <a:xfrm>
            <a:off x="4240088" y="5432600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449" y="11557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846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5" name="object 255"/>
          <p:cNvSpPr/>
          <p:nvPr/>
        </p:nvSpPr>
        <p:spPr>
          <a:xfrm>
            <a:off x="4281858" y="52316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6" name="object 256"/>
          <p:cNvSpPr/>
          <p:nvPr/>
        </p:nvSpPr>
        <p:spPr>
          <a:xfrm>
            <a:off x="4281858" y="5231693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8923"/>
                </a:moveTo>
                <a:lnTo>
                  <a:pt x="34798" y="11557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207" y="5588"/>
                </a:lnTo>
                <a:lnTo>
                  <a:pt x="1397" y="11557"/>
                </a:lnTo>
                <a:lnTo>
                  <a:pt x="0" y="18796"/>
                </a:lnTo>
                <a:lnTo>
                  <a:pt x="1397" y="26289"/>
                </a:lnTo>
                <a:lnTo>
                  <a:pt x="5207" y="32258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322"/>
                </a:lnTo>
                <a:lnTo>
                  <a:pt x="30861" y="32258"/>
                </a:lnTo>
                <a:lnTo>
                  <a:pt x="34798" y="26289"/>
                </a:lnTo>
                <a:lnTo>
                  <a:pt x="36195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7" name="object 257"/>
          <p:cNvSpPr/>
          <p:nvPr/>
        </p:nvSpPr>
        <p:spPr>
          <a:xfrm>
            <a:off x="4322016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449"/>
                </a:lnTo>
                <a:lnTo>
                  <a:pt x="30988" y="32385"/>
                </a:lnTo>
                <a:lnTo>
                  <a:pt x="34798" y="26289"/>
                </a:lnTo>
                <a:lnTo>
                  <a:pt x="36195" y="19050"/>
                </a:lnTo>
                <a:lnTo>
                  <a:pt x="34798" y="11684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8" name="object 258"/>
          <p:cNvSpPr/>
          <p:nvPr/>
        </p:nvSpPr>
        <p:spPr>
          <a:xfrm>
            <a:off x="4322016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9050"/>
                </a:moveTo>
                <a:lnTo>
                  <a:pt x="34798" y="11684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449"/>
                </a:lnTo>
                <a:lnTo>
                  <a:pt x="30988" y="32385"/>
                </a:lnTo>
                <a:lnTo>
                  <a:pt x="34798" y="26289"/>
                </a:lnTo>
                <a:lnTo>
                  <a:pt x="36195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9" name="object 259"/>
          <p:cNvSpPr/>
          <p:nvPr/>
        </p:nvSpPr>
        <p:spPr>
          <a:xfrm>
            <a:off x="4362289" y="52003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9050"/>
                </a:lnTo>
                <a:lnTo>
                  <a:pt x="1524" y="26416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973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416"/>
                </a:lnTo>
                <a:lnTo>
                  <a:pt x="37846" y="19050"/>
                </a:lnTo>
                <a:lnTo>
                  <a:pt x="36449" y="11684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0" name="object 260"/>
          <p:cNvSpPr/>
          <p:nvPr/>
        </p:nvSpPr>
        <p:spPr>
          <a:xfrm>
            <a:off x="4362289" y="52003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9050"/>
                </a:moveTo>
                <a:lnTo>
                  <a:pt x="36449" y="11684"/>
                </a:lnTo>
                <a:lnTo>
                  <a:pt x="32385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684"/>
                </a:lnTo>
                <a:lnTo>
                  <a:pt x="0" y="19050"/>
                </a:lnTo>
                <a:lnTo>
                  <a:pt x="1524" y="26416"/>
                </a:lnTo>
                <a:lnTo>
                  <a:pt x="5588" y="32385"/>
                </a:lnTo>
                <a:lnTo>
                  <a:pt x="11684" y="36449"/>
                </a:lnTo>
                <a:lnTo>
                  <a:pt x="19050" y="37973"/>
                </a:lnTo>
                <a:lnTo>
                  <a:pt x="26289" y="36449"/>
                </a:lnTo>
                <a:lnTo>
                  <a:pt x="32385" y="32385"/>
                </a:lnTo>
                <a:lnTo>
                  <a:pt x="36449" y="26416"/>
                </a:lnTo>
                <a:lnTo>
                  <a:pt x="37846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1" name="object 261"/>
          <p:cNvSpPr/>
          <p:nvPr/>
        </p:nvSpPr>
        <p:spPr>
          <a:xfrm>
            <a:off x="4402563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034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449"/>
                </a:lnTo>
                <a:lnTo>
                  <a:pt x="30861" y="32385"/>
                </a:lnTo>
                <a:lnTo>
                  <a:pt x="34798" y="26289"/>
                </a:lnTo>
                <a:lnTo>
                  <a:pt x="36195" y="19050"/>
                </a:lnTo>
                <a:lnTo>
                  <a:pt x="34798" y="11684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2" name="object 262"/>
          <p:cNvSpPr/>
          <p:nvPr/>
        </p:nvSpPr>
        <p:spPr>
          <a:xfrm>
            <a:off x="4402563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9050"/>
                </a:moveTo>
                <a:lnTo>
                  <a:pt x="34798" y="11684"/>
                </a:lnTo>
                <a:lnTo>
                  <a:pt x="30861" y="5588"/>
                </a:lnTo>
                <a:lnTo>
                  <a:pt x="25146" y="1524"/>
                </a:lnTo>
                <a:lnTo>
                  <a:pt x="18034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397" y="11557"/>
                </a:lnTo>
                <a:lnTo>
                  <a:pt x="0" y="18923"/>
                </a:lnTo>
                <a:lnTo>
                  <a:pt x="1397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034" y="37846"/>
                </a:lnTo>
                <a:lnTo>
                  <a:pt x="25146" y="36449"/>
                </a:lnTo>
                <a:lnTo>
                  <a:pt x="30861" y="32385"/>
                </a:lnTo>
                <a:lnTo>
                  <a:pt x="34798" y="26289"/>
                </a:lnTo>
                <a:lnTo>
                  <a:pt x="36195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3" name="object 263"/>
          <p:cNvSpPr/>
          <p:nvPr/>
        </p:nvSpPr>
        <p:spPr>
          <a:xfrm>
            <a:off x="4442723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18161" y="0"/>
                </a:moveTo>
                <a:lnTo>
                  <a:pt x="11049" y="1524"/>
                </a:lnTo>
                <a:lnTo>
                  <a:pt x="5334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449"/>
                </a:lnTo>
                <a:lnTo>
                  <a:pt x="30988" y="32385"/>
                </a:lnTo>
                <a:lnTo>
                  <a:pt x="34798" y="26289"/>
                </a:lnTo>
                <a:lnTo>
                  <a:pt x="36195" y="19050"/>
                </a:lnTo>
                <a:lnTo>
                  <a:pt x="34798" y="11684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4" name="object 264"/>
          <p:cNvSpPr/>
          <p:nvPr/>
        </p:nvSpPr>
        <p:spPr>
          <a:xfrm>
            <a:off x="4442723" y="5200395"/>
            <a:ext cx="32793" cy="34519"/>
          </a:xfrm>
          <a:custGeom>
            <a:avLst/>
            <a:gdLst/>
            <a:ahLst/>
            <a:cxnLst/>
            <a:rect l="l" t="t" r="r" b="b"/>
            <a:pathLst>
              <a:path w="36195" h="38100">
                <a:moveTo>
                  <a:pt x="36195" y="19050"/>
                </a:moveTo>
                <a:lnTo>
                  <a:pt x="34798" y="11684"/>
                </a:lnTo>
                <a:lnTo>
                  <a:pt x="30988" y="5588"/>
                </a:lnTo>
                <a:lnTo>
                  <a:pt x="25146" y="1524"/>
                </a:lnTo>
                <a:lnTo>
                  <a:pt x="18161" y="0"/>
                </a:lnTo>
                <a:lnTo>
                  <a:pt x="11049" y="1524"/>
                </a:lnTo>
                <a:lnTo>
                  <a:pt x="5334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334" y="32385"/>
                </a:lnTo>
                <a:lnTo>
                  <a:pt x="11049" y="36322"/>
                </a:lnTo>
                <a:lnTo>
                  <a:pt x="18161" y="37846"/>
                </a:lnTo>
                <a:lnTo>
                  <a:pt x="25146" y="36449"/>
                </a:lnTo>
                <a:lnTo>
                  <a:pt x="30988" y="32385"/>
                </a:lnTo>
                <a:lnTo>
                  <a:pt x="34798" y="26289"/>
                </a:lnTo>
                <a:lnTo>
                  <a:pt x="36195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5" name="object 265"/>
          <p:cNvSpPr/>
          <p:nvPr/>
        </p:nvSpPr>
        <p:spPr>
          <a:xfrm>
            <a:off x="4483109" y="52003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6" name="object 266"/>
          <p:cNvSpPr/>
          <p:nvPr/>
        </p:nvSpPr>
        <p:spPr>
          <a:xfrm>
            <a:off x="4483109" y="5200395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719" y="19050"/>
                </a:move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7" name="object 267"/>
          <p:cNvSpPr/>
          <p:nvPr/>
        </p:nvSpPr>
        <p:spPr>
          <a:xfrm>
            <a:off x="4523268" y="5323171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449"/>
                </a:lnTo>
                <a:lnTo>
                  <a:pt x="18923" y="37846"/>
                </a:lnTo>
                <a:lnTo>
                  <a:pt x="26289" y="36449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8" name="object 268"/>
          <p:cNvSpPr/>
          <p:nvPr/>
        </p:nvSpPr>
        <p:spPr>
          <a:xfrm>
            <a:off x="4523268" y="5323171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449"/>
                </a:lnTo>
                <a:lnTo>
                  <a:pt x="18923" y="37846"/>
                </a:lnTo>
                <a:lnTo>
                  <a:pt x="26289" y="36449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9" name="object 269"/>
          <p:cNvSpPr/>
          <p:nvPr/>
        </p:nvSpPr>
        <p:spPr>
          <a:xfrm>
            <a:off x="4563543" y="5559059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796" y="0"/>
                </a:move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0" name="object 270"/>
          <p:cNvSpPr/>
          <p:nvPr/>
        </p:nvSpPr>
        <p:spPr>
          <a:xfrm>
            <a:off x="4563543" y="5559059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719" y="19050"/>
                </a:moveTo>
                <a:lnTo>
                  <a:pt x="36322" y="11684"/>
                </a:lnTo>
                <a:lnTo>
                  <a:pt x="32258" y="5588"/>
                </a:lnTo>
                <a:lnTo>
                  <a:pt x="26162" y="1524"/>
                </a:lnTo>
                <a:lnTo>
                  <a:pt x="18796" y="0"/>
                </a:lnTo>
                <a:lnTo>
                  <a:pt x="11557" y="1524"/>
                </a:lnTo>
                <a:lnTo>
                  <a:pt x="5461" y="5588"/>
                </a:lnTo>
                <a:lnTo>
                  <a:pt x="1397" y="11684"/>
                </a:lnTo>
                <a:lnTo>
                  <a:pt x="0" y="19050"/>
                </a:lnTo>
                <a:lnTo>
                  <a:pt x="1397" y="26416"/>
                </a:lnTo>
                <a:lnTo>
                  <a:pt x="5461" y="32385"/>
                </a:lnTo>
                <a:lnTo>
                  <a:pt x="11557" y="36449"/>
                </a:lnTo>
                <a:lnTo>
                  <a:pt x="18923" y="37973"/>
                </a:lnTo>
                <a:lnTo>
                  <a:pt x="26289" y="36449"/>
                </a:lnTo>
                <a:lnTo>
                  <a:pt x="32258" y="32385"/>
                </a:lnTo>
                <a:lnTo>
                  <a:pt x="36322" y="26416"/>
                </a:lnTo>
                <a:lnTo>
                  <a:pt x="37719" y="19050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1" name="object 271"/>
          <p:cNvSpPr/>
          <p:nvPr/>
        </p:nvSpPr>
        <p:spPr>
          <a:xfrm>
            <a:off x="4603701" y="5643173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18923" y="0"/>
                </a:move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449"/>
                </a:lnTo>
                <a:lnTo>
                  <a:pt x="18923" y="37846"/>
                </a:lnTo>
                <a:lnTo>
                  <a:pt x="26289" y="36449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close/>
              </a:path>
            </a:pathLst>
          </a:custGeom>
          <a:solidFill>
            <a:srgbClr val="00BF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2" name="object 272"/>
          <p:cNvSpPr/>
          <p:nvPr/>
        </p:nvSpPr>
        <p:spPr>
          <a:xfrm>
            <a:off x="4603701" y="5643173"/>
            <a:ext cx="34519" cy="34519"/>
          </a:xfrm>
          <a:custGeom>
            <a:avLst/>
            <a:gdLst/>
            <a:ahLst/>
            <a:cxnLst/>
            <a:rect l="l" t="t" r="r" b="b"/>
            <a:pathLst>
              <a:path w="38100" h="38100">
                <a:moveTo>
                  <a:pt x="37846" y="18923"/>
                </a:moveTo>
                <a:lnTo>
                  <a:pt x="36322" y="11557"/>
                </a:lnTo>
                <a:lnTo>
                  <a:pt x="32258" y="5588"/>
                </a:lnTo>
                <a:lnTo>
                  <a:pt x="26289" y="1524"/>
                </a:lnTo>
                <a:lnTo>
                  <a:pt x="18923" y="0"/>
                </a:lnTo>
                <a:lnTo>
                  <a:pt x="11557" y="1524"/>
                </a:lnTo>
                <a:lnTo>
                  <a:pt x="5588" y="5588"/>
                </a:lnTo>
                <a:lnTo>
                  <a:pt x="1524" y="11557"/>
                </a:lnTo>
                <a:lnTo>
                  <a:pt x="0" y="18923"/>
                </a:lnTo>
                <a:lnTo>
                  <a:pt x="1524" y="26289"/>
                </a:lnTo>
                <a:lnTo>
                  <a:pt x="5588" y="32258"/>
                </a:lnTo>
                <a:lnTo>
                  <a:pt x="11557" y="36449"/>
                </a:lnTo>
                <a:lnTo>
                  <a:pt x="18923" y="37846"/>
                </a:lnTo>
                <a:lnTo>
                  <a:pt x="26289" y="36449"/>
                </a:lnTo>
                <a:lnTo>
                  <a:pt x="32258" y="32258"/>
                </a:lnTo>
                <a:lnTo>
                  <a:pt x="36322" y="26289"/>
                </a:lnTo>
                <a:lnTo>
                  <a:pt x="37846" y="18923"/>
                </a:lnTo>
                <a:close/>
              </a:path>
            </a:pathLst>
          </a:custGeom>
          <a:ln w="4761">
            <a:solidFill>
              <a:srgbClr val="00B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3" name="object 273"/>
          <p:cNvSpPr/>
          <p:nvPr/>
        </p:nvSpPr>
        <p:spPr>
          <a:xfrm>
            <a:off x="4177607" y="5563548"/>
            <a:ext cx="40273" cy="82273"/>
          </a:xfrm>
          <a:custGeom>
            <a:avLst/>
            <a:gdLst/>
            <a:ahLst/>
            <a:cxnLst/>
            <a:rect l="l" t="t" r="r" b="b"/>
            <a:pathLst>
              <a:path w="44450" h="90804">
                <a:moveTo>
                  <a:pt x="0" y="90297"/>
                </a:moveTo>
                <a:lnTo>
                  <a:pt x="44323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4" name="object 274"/>
          <p:cNvSpPr/>
          <p:nvPr/>
        </p:nvSpPr>
        <p:spPr>
          <a:xfrm>
            <a:off x="4217765" y="5386458"/>
            <a:ext cx="40273" cy="177203"/>
          </a:xfrm>
          <a:custGeom>
            <a:avLst/>
            <a:gdLst/>
            <a:ahLst/>
            <a:cxnLst/>
            <a:rect l="l" t="t" r="r" b="b"/>
            <a:pathLst>
              <a:path w="44450" h="195579">
                <a:moveTo>
                  <a:pt x="0" y="195453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5" name="object 275"/>
          <p:cNvSpPr/>
          <p:nvPr/>
        </p:nvSpPr>
        <p:spPr>
          <a:xfrm>
            <a:off x="4258039" y="5224213"/>
            <a:ext cx="40273" cy="162245"/>
          </a:xfrm>
          <a:custGeom>
            <a:avLst/>
            <a:gdLst/>
            <a:ahLst/>
            <a:cxnLst/>
            <a:rect l="l" t="t" r="r" b="b"/>
            <a:pathLst>
              <a:path w="44450" h="179070">
                <a:moveTo>
                  <a:pt x="0" y="179070"/>
                </a:moveTo>
                <a:lnTo>
                  <a:pt x="44323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6" name="object 276"/>
          <p:cNvSpPr/>
          <p:nvPr/>
        </p:nvSpPr>
        <p:spPr>
          <a:xfrm>
            <a:off x="4298197" y="5175196"/>
            <a:ext cx="40273" cy="49478"/>
          </a:xfrm>
          <a:custGeom>
            <a:avLst/>
            <a:gdLst/>
            <a:ahLst/>
            <a:cxnLst/>
            <a:rect l="l" t="t" r="r" b="b"/>
            <a:pathLst>
              <a:path w="44450" h="54610">
                <a:moveTo>
                  <a:pt x="0" y="54102"/>
                </a:moveTo>
                <a:lnTo>
                  <a:pt x="44450" y="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7" name="object 277"/>
          <p:cNvSpPr/>
          <p:nvPr/>
        </p:nvSpPr>
        <p:spPr>
          <a:xfrm>
            <a:off x="4338470" y="5175196"/>
            <a:ext cx="41999" cy="17834"/>
          </a:xfrm>
          <a:custGeom>
            <a:avLst/>
            <a:gdLst/>
            <a:ahLst/>
            <a:cxnLst/>
            <a:rect l="l" t="t" r="r" b="b"/>
            <a:pathLst>
              <a:path w="46354" h="19685">
                <a:moveTo>
                  <a:pt x="0" y="0"/>
                </a:moveTo>
                <a:lnTo>
                  <a:pt x="46101" y="19685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8" name="object 278"/>
          <p:cNvSpPr/>
          <p:nvPr/>
        </p:nvSpPr>
        <p:spPr>
          <a:xfrm>
            <a:off x="4380238" y="5193030"/>
            <a:ext cx="39124" cy="40273"/>
          </a:xfrm>
          <a:custGeom>
            <a:avLst/>
            <a:gdLst/>
            <a:ahLst/>
            <a:cxnLst/>
            <a:rect l="l" t="t" r="r" b="b"/>
            <a:pathLst>
              <a:path w="43179" h="44450">
                <a:moveTo>
                  <a:pt x="0" y="0"/>
                </a:moveTo>
                <a:lnTo>
                  <a:pt x="42672" y="44323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9" name="object 279"/>
          <p:cNvSpPr/>
          <p:nvPr/>
        </p:nvSpPr>
        <p:spPr>
          <a:xfrm>
            <a:off x="4418903" y="5233189"/>
            <a:ext cx="40273" cy="88025"/>
          </a:xfrm>
          <a:custGeom>
            <a:avLst/>
            <a:gdLst/>
            <a:ahLst/>
            <a:cxnLst/>
            <a:rect l="l" t="t" r="r" b="b"/>
            <a:pathLst>
              <a:path w="44450" h="97154">
                <a:moveTo>
                  <a:pt x="0" y="0"/>
                </a:moveTo>
                <a:lnTo>
                  <a:pt x="44450" y="96901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0" name="object 280"/>
          <p:cNvSpPr/>
          <p:nvPr/>
        </p:nvSpPr>
        <p:spPr>
          <a:xfrm>
            <a:off x="4459177" y="5320984"/>
            <a:ext cx="41999" cy="136930"/>
          </a:xfrm>
          <a:custGeom>
            <a:avLst/>
            <a:gdLst/>
            <a:ahLst/>
            <a:cxnLst/>
            <a:rect l="l" t="t" r="r" b="b"/>
            <a:pathLst>
              <a:path w="46354" h="151129">
                <a:moveTo>
                  <a:pt x="0" y="0"/>
                </a:moveTo>
                <a:lnTo>
                  <a:pt x="46101" y="151130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1" name="object 281"/>
          <p:cNvSpPr/>
          <p:nvPr/>
        </p:nvSpPr>
        <p:spPr>
          <a:xfrm>
            <a:off x="4500946" y="5457914"/>
            <a:ext cx="40273" cy="139807"/>
          </a:xfrm>
          <a:custGeom>
            <a:avLst/>
            <a:gdLst/>
            <a:ahLst/>
            <a:cxnLst/>
            <a:rect l="l" t="t" r="r" b="b"/>
            <a:pathLst>
              <a:path w="44450" h="154304">
                <a:moveTo>
                  <a:pt x="0" y="0"/>
                </a:moveTo>
                <a:lnTo>
                  <a:pt x="44323" y="154305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2" name="object 282"/>
          <p:cNvSpPr/>
          <p:nvPr/>
        </p:nvSpPr>
        <p:spPr>
          <a:xfrm>
            <a:off x="4541104" y="5597720"/>
            <a:ext cx="40273" cy="116219"/>
          </a:xfrm>
          <a:custGeom>
            <a:avLst/>
            <a:gdLst/>
            <a:ahLst/>
            <a:cxnLst/>
            <a:rect l="l" t="t" r="r" b="b"/>
            <a:pathLst>
              <a:path w="44450" h="128270">
                <a:moveTo>
                  <a:pt x="0" y="0"/>
                </a:moveTo>
                <a:lnTo>
                  <a:pt x="44450" y="128143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3" name="object 283"/>
          <p:cNvSpPr/>
          <p:nvPr/>
        </p:nvSpPr>
        <p:spPr>
          <a:xfrm>
            <a:off x="4581378" y="5713824"/>
            <a:ext cx="40273" cy="59835"/>
          </a:xfrm>
          <a:custGeom>
            <a:avLst/>
            <a:gdLst/>
            <a:ahLst/>
            <a:cxnLst/>
            <a:rect l="l" t="t" r="r" b="b"/>
            <a:pathLst>
              <a:path w="44450" h="66039">
                <a:moveTo>
                  <a:pt x="0" y="0"/>
                </a:moveTo>
                <a:lnTo>
                  <a:pt x="44323" y="65786"/>
                </a:lnTo>
              </a:path>
            </a:pathLst>
          </a:custGeom>
          <a:ln w="821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4" name="object 284"/>
          <p:cNvSpPr/>
          <p:nvPr/>
        </p:nvSpPr>
        <p:spPr>
          <a:xfrm>
            <a:off x="4161153" y="5626974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7"/>
                </a:moveTo>
                <a:lnTo>
                  <a:pt x="36100" y="39087"/>
                </a:lnTo>
                <a:lnTo>
                  <a:pt x="36100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5" name="object 285"/>
          <p:cNvSpPr/>
          <p:nvPr/>
        </p:nvSpPr>
        <p:spPr>
          <a:xfrm>
            <a:off x="4158994" y="5624817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9"/>
                </a:moveTo>
                <a:lnTo>
                  <a:pt x="40862" y="43849"/>
                </a:lnTo>
                <a:lnTo>
                  <a:pt x="40862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6" name="object 286"/>
          <p:cNvSpPr/>
          <p:nvPr/>
        </p:nvSpPr>
        <p:spPr>
          <a:xfrm>
            <a:off x="4201426" y="5545136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8987"/>
                </a:moveTo>
                <a:lnTo>
                  <a:pt x="36195" y="38987"/>
                </a:lnTo>
                <a:lnTo>
                  <a:pt x="36195" y="0"/>
                </a:lnTo>
                <a:lnTo>
                  <a:pt x="0" y="0"/>
                </a:lnTo>
                <a:lnTo>
                  <a:pt x="0" y="389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7" name="object 287"/>
          <p:cNvSpPr/>
          <p:nvPr/>
        </p:nvSpPr>
        <p:spPr>
          <a:xfrm>
            <a:off x="4199267" y="5542980"/>
            <a:ext cx="37397" cy="39698"/>
          </a:xfrm>
          <a:custGeom>
            <a:avLst/>
            <a:gdLst/>
            <a:ahLst/>
            <a:cxnLst/>
            <a:rect l="l" t="t" r="r" b="b"/>
            <a:pathLst>
              <a:path w="41275" h="43814">
                <a:moveTo>
                  <a:pt x="0" y="43749"/>
                </a:moveTo>
                <a:lnTo>
                  <a:pt x="40956" y="43749"/>
                </a:lnTo>
                <a:lnTo>
                  <a:pt x="40956" y="0"/>
                </a:lnTo>
                <a:lnTo>
                  <a:pt x="0" y="0"/>
                </a:lnTo>
                <a:lnTo>
                  <a:pt x="0" y="437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8" name="object 288"/>
          <p:cNvSpPr/>
          <p:nvPr/>
        </p:nvSpPr>
        <p:spPr>
          <a:xfrm>
            <a:off x="4240088" y="5369513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370"/>
                </a:moveTo>
                <a:lnTo>
                  <a:pt x="37812" y="37370"/>
                </a:lnTo>
                <a:lnTo>
                  <a:pt x="37812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9" name="object 289"/>
          <p:cNvSpPr/>
          <p:nvPr/>
        </p:nvSpPr>
        <p:spPr>
          <a:xfrm>
            <a:off x="4237930" y="5367357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32"/>
                </a:moveTo>
                <a:lnTo>
                  <a:pt x="42574" y="42132"/>
                </a:lnTo>
                <a:lnTo>
                  <a:pt x="42574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0" name="object 290"/>
          <p:cNvSpPr/>
          <p:nvPr/>
        </p:nvSpPr>
        <p:spPr>
          <a:xfrm>
            <a:off x="4281858" y="5207298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4">
                <a:moveTo>
                  <a:pt x="0" y="37465"/>
                </a:moveTo>
                <a:lnTo>
                  <a:pt x="36195" y="37465"/>
                </a:lnTo>
                <a:lnTo>
                  <a:pt x="361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1" name="object 291"/>
          <p:cNvSpPr/>
          <p:nvPr/>
        </p:nvSpPr>
        <p:spPr>
          <a:xfrm>
            <a:off x="4279700" y="5205142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956" y="42226"/>
                </a:lnTo>
                <a:lnTo>
                  <a:pt x="40956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2" name="object 292"/>
          <p:cNvSpPr/>
          <p:nvPr/>
        </p:nvSpPr>
        <p:spPr>
          <a:xfrm>
            <a:off x="4322015" y="5184058"/>
            <a:ext cx="74794" cy="0"/>
          </a:xfrm>
          <a:custGeom>
            <a:avLst/>
            <a:gdLst/>
            <a:ahLst/>
            <a:cxnLst/>
            <a:rect l="l" t="t" r="r" b="b"/>
            <a:pathLst>
              <a:path w="82550">
                <a:moveTo>
                  <a:pt x="0" y="0"/>
                </a:moveTo>
                <a:lnTo>
                  <a:pt x="82262" y="0"/>
                </a:lnTo>
              </a:path>
            </a:pathLst>
          </a:custGeom>
          <a:ln w="57145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3" name="object 293"/>
          <p:cNvSpPr/>
          <p:nvPr/>
        </p:nvSpPr>
        <p:spPr>
          <a:xfrm>
            <a:off x="4322016" y="5158746"/>
            <a:ext cx="32793" cy="32793"/>
          </a:xfrm>
          <a:custGeom>
            <a:avLst/>
            <a:gdLst/>
            <a:ahLst/>
            <a:cxnLst/>
            <a:rect l="l" t="t" r="r" b="b"/>
            <a:pathLst>
              <a:path w="36195" h="36195">
                <a:moveTo>
                  <a:pt x="-2380" y="18095"/>
                </a:moveTo>
                <a:lnTo>
                  <a:pt x="38575" y="18095"/>
                </a:lnTo>
              </a:path>
            </a:pathLst>
          </a:custGeom>
          <a:ln w="42222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4" name="object 294"/>
          <p:cNvSpPr/>
          <p:nvPr/>
        </p:nvSpPr>
        <p:spPr>
          <a:xfrm>
            <a:off x="4362289" y="5176581"/>
            <a:ext cx="34519" cy="32793"/>
          </a:xfrm>
          <a:custGeom>
            <a:avLst/>
            <a:gdLst/>
            <a:ahLst/>
            <a:cxnLst/>
            <a:rect l="l" t="t" r="r" b="b"/>
            <a:pathLst>
              <a:path w="38100" h="36195">
                <a:moveTo>
                  <a:pt x="-2380" y="18095"/>
                </a:moveTo>
                <a:lnTo>
                  <a:pt x="40193" y="18095"/>
                </a:lnTo>
              </a:path>
            </a:pathLst>
          </a:custGeom>
          <a:ln w="42222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5" name="object 295"/>
          <p:cNvSpPr/>
          <p:nvPr/>
        </p:nvSpPr>
        <p:spPr>
          <a:xfrm>
            <a:off x="4402563" y="5214689"/>
            <a:ext cx="32793" cy="35671"/>
          </a:xfrm>
          <a:custGeom>
            <a:avLst/>
            <a:gdLst/>
            <a:ahLst/>
            <a:cxnLst/>
            <a:rect l="l" t="t" r="r" b="b"/>
            <a:pathLst>
              <a:path w="36195" h="39370">
                <a:moveTo>
                  <a:pt x="0" y="39087"/>
                </a:moveTo>
                <a:lnTo>
                  <a:pt x="36195" y="39087"/>
                </a:lnTo>
                <a:lnTo>
                  <a:pt x="36195" y="0"/>
                </a:lnTo>
                <a:lnTo>
                  <a:pt x="0" y="0"/>
                </a:lnTo>
                <a:lnTo>
                  <a:pt x="0" y="39087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6" name="object 296"/>
          <p:cNvSpPr/>
          <p:nvPr/>
        </p:nvSpPr>
        <p:spPr>
          <a:xfrm>
            <a:off x="4400405" y="5212532"/>
            <a:ext cx="37397" cy="40273"/>
          </a:xfrm>
          <a:custGeom>
            <a:avLst/>
            <a:gdLst/>
            <a:ahLst/>
            <a:cxnLst/>
            <a:rect l="l" t="t" r="r" b="b"/>
            <a:pathLst>
              <a:path w="41275" h="44450">
                <a:moveTo>
                  <a:pt x="0" y="43849"/>
                </a:moveTo>
                <a:lnTo>
                  <a:pt x="40956" y="43849"/>
                </a:lnTo>
                <a:lnTo>
                  <a:pt x="40956" y="0"/>
                </a:lnTo>
                <a:lnTo>
                  <a:pt x="0" y="0"/>
                </a:lnTo>
                <a:lnTo>
                  <a:pt x="0" y="43849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7" name="object 297"/>
          <p:cNvSpPr/>
          <p:nvPr/>
        </p:nvSpPr>
        <p:spPr>
          <a:xfrm>
            <a:off x="4442723" y="5304070"/>
            <a:ext cx="32793" cy="33945"/>
          </a:xfrm>
          <a:custGeom>
            <a:avLst/>
            <a:gdLst/>
            <a:ahLst/>
            <a:cxnLst/>
            <a:rect l="l" t="t" r="r" b="b"/>
            <a:pathLst>
              <a:path w="36195" h="37464">
                <a:moveTo>
                  <a:pt x="0" y="37465"/>
                </a:moveTo>
                <a:lnTo>
                  <a:pt x="36195" y="37465"/>
                </a:lnTo>
                <a:lnTo>
                  <a:pt x="36195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8" name="object 298"/>
          <p:cNvSpPr/>
          <p:nvPr/>
        </p:nvSpPr>
        <p:spPr>
          <a:xfrm>
            <a:off x="4440563" y="5301913"/>
            <a:ext cx="37397" cy="38547"/>
          </a:xfrm>
          <a:custGeom>
            <a:avLst/>
            <a:gdLst/>
            <a:ahLst/>
            <a:cxnLst/>
            <a:rect l="l" t="t" r="r" b="b"/>
            <a:pathLst>
              <a:path w="41275" h="42545">
                <a:moveTo>
                  <a:pt x="0" y="42226"/>
                </a:moveTo>
                <a:lnTo>
                  <a:pt x="40956" y="42226"/>
                </a:lnTo>
                <a:lnTo>
                  <a:pt x="40956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9" name="object 299"/>
          <p:cNvSpPr/>
          <p:nvPr/>
        </p:nvSpPr>
        <p:spPr>
          <a:xfrm>
            <a:off x="4482996" y="5440970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370"/>
                </a:moveTo>
                <a:lnTo>
                  <a:pt x="37911" y="37370"/>
                </a:lnTo>
                <a:lnTo>
                  <a:pt x="37911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0" name="object 300"/>
          <p:cNvSpPr/>
          <p:nvPr/>
        </p:nvSpPr>
        <p:spPr>
          <a:xfrm>
            <a:off x="4480836" y="5438813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32"/>
                </a:moveTo>
                <a:lnTo>
                  <a:pt x="42673" y="42132"/>
                </a:lnTo>
                <a:lnTo>
                  <a:pt x="42673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1" name="object 301"/>
          <p:cNvSpPr/>
          <p:nvPr/>
        </p:nvSpPr>
        <p:spPr>
          <a:xfrm>
            <a:off x="4523268" y="5579340"/>
            <a:ext cx="34519" cy="35671"/>
          </a:xfrm>
          <a:custGeom>
            <a:avLst/>
            <a:gdLst/>
            <a:ahLst/>
            <a:cxnLst/>
            <a:rect l="l" t="t" r="r" b="b"/>
            <a:pathLst>
              <a:path w="38100" h="39370">
                <a:moveTo>
                  <a:pt x="0" y="39082"/>
                </a:moveTo>
                <a:lnTo>
                  <a:pt x="37812" y="39082"/>
                </a:lnTo>
                <a:lnTo>
                  <a:pt x="37812" y="0"/>
                </a:lnTo>
                <a:lnTo>
                  <a:pt x="0" y="0"/>
                </a:lnTo>
                <a:lnTo>
                  <a:pt x="0" y="3908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2" name="object 302"/>
          <p:cNvSpPr/>
          <p:nvPr/>
        </p:nvSpPr>
        <p:spPr>
          <a:xfrm>
            <a:off x="4521109" y="5577184"/>
            <a:ext cx="39124" cy="40273"/>
          </a:xfrm>
          <a:custGeom>
            <a:avLst/>
            <a:gdLst/>
            <a:ahLst/>
            <a:cxnLst/>
            <a:rect l="l" t="t" r="r" b="b"/>
            <a:pathLst>
              <a:path w="43179" h="44450">
                <a:moveTo>
                  <a:pt x="0" y="43844"/>
                </a:moveTo>
                <a:lnTo>
                  <a:pt x="42574" y="43844"/>
                </a:lnTo>
                <a:lnTo>
                  <a:pt x="42574" y="0"/>
                </a:lnTo>
                <a:lnTo>
                  <a:pt x="0" y="0"/>
                </a:lnTo>
                <a:lnTo>
                  <a:pt x="0" y="4384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3" name="object 303"/>
          <p:cNvSpPr/>
          <p:nvPr/>
        </p:nvSpPr>
        <p:spPr>
          <a:xfrm>
            <a:off x="4563543" y="5696995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370"/>
                </a:moveTo>
                <a:lnTo>
                  <a:pt x="37812" y="37370"/>
                </a:lnTo>
                <a:lnTo>
                  <a:pt x="37812" y="0"/>
                </a:lnTo>
                <a:lnTo>
                  <a:pt x="0" y="0"/>
                </a:lnTo>
                <a:lnTo>
                  <a:pt x="0" y="37370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4" name="object 304"/>
          <p:cNvSpPr/>
          <p:nvPr/>
        </p:nvSpPr>
        <p:spPr>
          <a:xfrm>
            <a:off x="4561383" y="5694838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132"/>
                </a:moveTo>
                <a:lnTo>
                  <a:pt x="42574" y="42132"/>
                </a:lnTo>
                <a:lnTo>
                  <a:pt x="42574" y="0"/>
                </a:lnTo>
                <a:lnTo>
                  <a:pt x="0" y="0"/>
                </a:lnTo>
                <a:lnTo>
                  <a:pt x="0" y="42132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5" name="object 305"/>
          <p:cNvSpPr/>
          <p:nvPr/>
        </p:nvSpPr>
        <p:spPr>
          <a:xfrm>
            <a:off x="4603701" y="5756398"/>
            <a:ext cx="34519" cy="33945"/>
          </a:xfrm>
          <a:custGeom>
            <a:avLst/>
            <a:gdLst/>
            <a:ahLst/>
            <a:cxnLst/>
            <a:rect l="l" t="t" r="r" b="b"/>
            <a:pathLst>
              <a:path w="38100" h="37464">
                <a:moveTo>
                  <a:pt x="0" y="37465"/>
                </a:moveTo>
                <a:lnTo>
                  <a:pt x="37812" y="37465"/>
                </a:lnTo>
                <a:lnTo>
                  <a:pt x="37812" y="0"/>
                </a:lnTo>
                <a:lnTo>
                  <a:pt x="0" y="0"/>
                </a:lnTo>
                <a:lnTo>
                  <a:pt x="0" y="37465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6" name="object 306"/>
          <p:cNvSpPr/>
          <p:nvPr/>
        </p:nvSpPr>
        <p:spPr>
          <a:xfrm>
            <a:off x="4601542" y="5754242"/>
            <a:ext cx="39124" cy="38547"/>
          </a:xfrm>
          <a:custGeom>
            <a:avLst/>
            <a:gdLst/>
            <a:ahLst/>
            <a:cxnLst/>
            <a:rect l="l" t="t" r="r" b="b"/>
            <a:pathLst>
              <a:path w="43179" h="42545">
                <a:moveTo>
                  <a:pt x="0" y="42226"/>
                </a:moveTo>
                <a:lnTo>
                  <a:pt x="42574" y="42226"/>
                </a:lnTo>
                <a:lnTo>
                  <a:pt x="42574" y="0"/>
                </a:lnTo>
                <a:lnTo>
                  <a:pt x="0" y="0"/>
                </a:lnTo>
                <a:lnTo>
                  <a:pt x="0" y="42226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7" name="object 307"/>
          <p:cNvSpPr/>
          <p:nvPr/>
        </p:nvSpPr>
        <p:spPr>
          <a:xfrm>
            <a:off x="1634530" y="2705623"/>
            <a:ext cx="211148" cy="211148"/>
          </a:xfrm>
          <a:custGeom>
            <a:avLst/>
            <a:gdLst/>
            <a:ahLst/>
            <a:cxnLst/>
            <a:rect l="l" t="t" r="r" b="b"/>
            <a:pathLst>
              <a:path w="233044" h="233044">
                <a:moveTo>
                  <a:pt x="0" y="232539"/>
                </a:moveTo>
                <a:lnTo>
                  <a:pt x="232539" y="232539"/>
                </a:lnTo>
                <a:lnTo>
                  <a:pt x="232539" y="0"/>
                </a:lnTo>
                <a:lnTo>
                  <a:pt x="0" y="0"/>
                </a:lnTo>
                <a:lnTo>
                  <a:pt x="0" y="232539"/>
                </a:lnTo>
                <a:close/>
              </a:path>
            </a:pathLst>
          </a:custGeom>
          <a:ln w="609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8" name="object 308"/>
          <p:cNvSpPr/>
          <p:nvPr/>
        </p:nvSpPr>
        <p:spPr>
          <a:xfrm>
            <a:off x="2315150" y="1474410"/>
            <a:ext cx="211148" cy="209997"/>
          </a:xfrm>
          <a:custGeom>
            <a:avLst/>
            <a:gdLst/>
            <a:ahLst/>
            <a:cxnLst/>
            <a:rect l="l" t="t" r="r" b="b"/>
            <a:pathLst>
              <a:path w="233044" h="231775">
                <a:moveTo>
                  <a:pt x="0" y="231645"/>
                </a:moveTo>
                <a:lnTo>
                  <a:pt x="232539" y="231645"/>
                </a:lnTo>
                <a:lnTo>
                  <a:pt x="232539" y="0"/>
                </a:lnTo>
                <a:lnTo>
                  <a:pt x="0" y="0"/>
                </a:lnTo>
                <a:lnTo>
                  <a:pt x="0" y="231645"/>
                </a:lnTo>
                <a:close/>
              </a:path>
            </a:pathLst>
          </a:custGeom>
          <a:ln w="609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9" name="object 309"/>
          <p:cNvSpPr/>
          <p:nvPr/>
        </p:nvSpPr>
        <p:spPr>
          <a:xfrm>
            <a:off x="2105729" y="2329928"/>
            <a:ext cx="211148" cy="211148"/>
          </a:xfrm>
          <a:custGeom>
            <a:avLst/>
            <a:gdLst/>
            <a:ahLst/>
            <a:cxnLst/>
            <a:rect l="l" t="t" r="r" b="b"/>
            <a:pathLst>
              <a:path w="233044" h="233044">
                <a:moveTo>
                  <a:pt x="0" y="232539"/>
                </a:moveTo>
                <a:lnTo>
                  <a:pt x="232539" y="232539"/>
                </a:lnTo>
                <a:lnTo>
                  <a:pt x="232539" y="0"/>
                </a:lnTo>
                <a:lnTo>
                  <a:pt x="0" y="0"/>
                </a:lnTo>
                <a:lnTo>
                  <a:pt x="0" y="232539"/>
                </a:lnTo>
                <a:close/>
              </a:path>
            </a:pathLst>
          </a:custGeom>
          <a:ln w="609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0" name="object 310"/>
          <p:cNvSpPr/>
          <p:nvPr/>
        </p:nvSpPr>
        <p:spPr>
          <a:xfrm>
            <a:off x="1388862" y="2328207"/>
            <a:ext cx="211148" cy="211148"/>
          </a:xfrm>
          <a:custGeom>
            <a:avLst/>
            <a:gdLst/>
            <a:ahLst/>
            <a:cxnLst/>
            <a:rect l="l" t="t" r="r" b="b"/>
            <a:pathLst>
              <a:path w="233044" h="233044">
                <a:moveTo>
                  <a:pt x="0" y="232534"/>
                </a:moveTo>
                <a:lnTo>
                  <a:pt x="232539" y="232534"/>
                </a:lnTo>
                <a:lnTo>
                  <a:pt x="232539" y="0"/>
                </a:lnTo>
                <a:lnTo>
                  <a:pt x="0" y="0"/>
                </a:lnTo>
                <a:lnTo>
                  <a:pt x="0" y="232534"/>
                </a:lnTo>
                <a:close/>
              </a:path>
            </a:pathLst>
          </a:custGeom>
          <a:ln w="609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1" name="object 311"/>
          <p:cNvSpPr/>
          <p:nvPr/>
        </p:nvSpPr>
        <p:spPr>
          <a:xfrm>
            <a:off x="2276603" y="2798826"/>
            <a:ext cx="211148" cy="211148"/>
          </a:xfrm>
          <a:custGeom>
            <a:avLst/>
            <a:gdLst/>
            <a:ahLst/>
            <a:cxnLst/>
            <a:rect l="l" t="t" r="r" b="b"/>
            <a:pathLst>
              <a:path w="233044" h="233044">
                <a:moveTo>
                  <a:pt x="0" y="232539"/>
                </a:moveTo>
                <a:lnTo>
                  <a:pt x="232539" y="232539"/>
                </a:lnTo>
                <a:lnTo>
                  <a:pt x="232539" y="0"/>
                </a:lnTo>
                <a:lnTo>
                  <a:pt x="0" y="0"/>
                </a:lnTo>
                <a:lnTo>
                  <a:pt x="0" y="232539"/>
                </a:lnTo>
                <a:close/>
              </a:path>
            </a:pathLst>
          </a:custGeom>
          <a:ln w="609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2" name="object 312"/>
          <p:cNvSpPr/>
          <p:nvPr/>
        </p:nvSpPr>
        <p:spPr>
          <a:xfrm>
            <a:off x="3011308" y="2988345"/>
            <a:ext cx="702829" cy="704209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3" name="object 313"/>
          <p:cNvSpPr/>
          <p:nvPr/>
        </p:nvSpPr>
        <p:spPr>
          <a:xfrm>
            <a:off x="3217048" y="3119521"/>
            <a:ext cx="352105" cy="433803"/>
          </a:xfrm>
          <a:custGeom>
            <a:avLst/>
            <a:gdLst/>
            <a:ahLst/>
            <a:cxnLst/>
            <a:rect l="l" t="t" r="r" b="b"/>
            <a:pathLst>
              <a:path w="388620" h="478789">
                <a:moveTo>
                  <a:pt x="388620" y="0"/>
                </a:moveTo>
                <a:lnTo>
                  <a:pt x="0" y="478536"/>
                </a:lnTo>
              </a:path>
            </a:pathLst>
          </a:custGeom>
          <a:ln w="1981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4" name="object 314"/>
          <p:cNvSpPr/>
          <p:nvPr/>
        </p:nvSpPr>
        <p:spPr>
          <a:xfrm>
            <a:off x="3000376" y="1986225"/>
            <a:ext cx="704209" cy="70420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5" name="object 315"/>
          <p:cNvSpPr/>
          <p:nvPr/>
        </p:nvSpPr>
        <p:spPr>
          <a:xfrm>
            <a:off x="3255826" y="2048360"/>
            <a:ext cx="291695" cy="538514"/>
          </a:xfrm>
          <a:custGeom>
            <a:avLst/>
            <a:gdLst/>
            <a:ahLst/>
            <a:cxnLst/>
            <a:rect l="l" t="t" r="r" b="b"/>
            <a:pathLst>
              <a:path w="321945" h="594360">
                <a:moveTo>
                  <a:pt x="0" y="0"/>
                </a:moveTo>
                <a:lnTo>
                  <a:pt x="321564" y="594360"/>
                </a:lnTo>
              </a:path>
            </a:pathLst>
          </a:custGeom>
          <a:ln w="1981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6" name="object 316"/>
          <p:cNvSpPr/>
          <p:nvPr/>
        </p:nvSpPr>
        <p:spPr>
          <a:xfrm>
            <a:off x="3000376" y="975936"/>
            <a:ext cx="704209" cy="704209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7" name="object 317"/>
          <p:cNvSpPr/>
          <p:nvPr/>
        </p:nvSpPr>
        <p:spPr>
          <a:xfrm>
            <a:off x="3137075" y="1181675"/>
            <a:ext cx="491912" cy="357859"/>
          </a:xfrm>
          <a:custGeom>
            <a:avLst/>
            <a:gdLst/>
            <a:ahLst/>
            <a:cxnLst/>
            <a:rect l="l" t="t" r="r" b="b"/>
            <a:pathLst>
              <a:path w="542925" h="394969">
                <a:moveTo>
                  <a:pt x="0" y="394716"/>
                </a:moveTo>
                <a:lnTo>
                  <a:pt x="542544" y="0"/>
                </a:lnTo>
              </a:path>
            </a:pathLst>
          </a:custGeom>
          <a:ln w="1981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8" name="object 318"/>
          <p:cNvSpPr/>
          <p:nvPr/>
        </p:nvSpPr>
        <p:spPr>
          <a:xfrm>
            <a:off x="4121128" y="823276"/>
            <a:ext cx="1232138" cy="871023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9" name="object 319"/>
          <p:cNvSpPr/>
          <p:nvPr/>
        </p:nvSpPr>
        <p:spPr>
          <a:xfrm>
            <a:off x="4121704" y="753396"/>
            <a:ext cx="1231678" cy="941708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0" name="object 320"/>
          <p:cNvSpPr txBox="1"/>
          <p:nvPr/>
        </p:nvSpPr>
        <p:spPr>
          <a:xfrm>
            <a:off x="4351263" y="751553"/>
            <a:ext cx="279613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00AF50"/>
                </a:solidFill>
                <a:latin typeface="Calibri"/>
                <a:cs typeface="Calibri"/>
              </a:rPr>
              <a:t>LC</a:t>
            </a:r>
            <a:r>
              <a:rPr sz="997" b="1" spc="-9" dirty="0">
                <a:solidFill>
                  <a:srgbClr val="00AF50"/>
                </a:solidFill>
                <a:latin typeface="Calibri"/>
                <a:cs typeface="Calibri"/>
              </a:rPr>
              <a:t>3</a:t>
            </a:r>
            <a:r>
              <a:rPr sz="997" b="1" dirty="0">
                <a:solidFill>
                  <a:srgbClr val="00AF50"/>
                </a:solidFill>
                <a:latin typeface="Calibri"/>
                <a:cs typeface="Calibri"/>
              </a:rPr>
              <a:t>B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321" name="object 321"/>
          <p:cNvSpPr txBox="1"/>
          <p:nvPr/>
        </p:nvSpPr>
        <p:spPr>
          <a:xfrm>
            <a:off x="4700607" y="751553"/>
            <a:ext cx="391803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spc="-14" dirty="0">
                <a:solidFill>
                  <a:srgbClr val="FF0000"/>
                </a:solidFill>
                <a:latin typeface="Calibri"/>
                <a:cs typeface="Calibri"/>
              </a:rPr>
              <a:t>L</a:t>
            </a:r>
            <a:r>
              <a:rPr sz="997" b="1" spc="-9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r>
              <a:rPr sz="997" b="1" spc="-18" dirty="0">
                <a:solidFill>
                  <a:srgbClr val="FF0000"/>
                </a:solidFill>
                <a:latin typeface="Calibri"/>
                <a:cs typeface="Calibri"/>
              </a:rPr>
              <a:t>M</a:t>
            </a:r>
            <a:r>
              <a:rPr sz="997" b="1" spc="-14" dirty="0">
                <a:solidFill>
                  <a:srgbClr val="FF0000"/>
                </a:solidFill>
                <a:latin typeface="Calibri"/>
                <a:cs typeface="Calibri"/>
              </a:rPr>
              <a:t>P</a:t>
            </a:r>
            <a:r>
              <a:rPr sz="997" b="1" dirty="0">
                <a:solidFill>
                  <a:srgbClr val="FF0000"/>
                </a:solidFill>
                <a:latin typeface="Calibri"/>
                <a:cs typeface="Calibri"/>
              </a:rPr>
              <a:t>1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322" name="object 322"/>
          <p:cNvSpPr/>
          <p:nvPr/>
        </p:nvSpPr>
        <p:spPr>
          <a:xfrm>
            <a:off x="3021088" y="5144012"/>
            <a:ext cx="704209" cy="704209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3" name="object 323"/>
          <p:cNvSpPr/>
          <p:nvPr/>
        </p:nvSpPr>
        <p:spPr>
          <a:xfrm>
            <a:off x="3014184" y="4073082"/>
            <a:ext cx="704209" cy="703634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4" name="object 324"/>
          <p:cNvSpPr/>
          <p:nvPr/>
        </p:nvSpPr>
        <p:spPr>
          <a:xfrm>
            <a:off x="3021088" y="6170065"/>
            <a:ext cx="704209" cy="704209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5" name="object 325"/>
          <p:cNvSpPr txBox="1"/>
          <p:nvPr/>
        </p:nvSpPr>
        <p:spPr>
          <a:xfrm>
            <a:off x="5592313" y="1965512"/>
            <a:ext cx="83741" cy="700759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8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26" name="object 326"/>
          <p:cNvSpPr txBox="1"/>
          <p:nvPr/>
        </p:nvSpPr>
        <p:spPr>
          <a:xfrm>
            <a:off x="5554549" y="5180603"/>
            <a:ext cx="83741" cy="700759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8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27" name="object 327"/>
          <p:cNvSpPr txBox="1"/>
          <p:nvPr/>
        </p:nvSpPr>
        <p:spPr>
          <a:xfrm>
            <a:off x="5581266" y="3006984"/>
            <a:ext cx="83741" cy="700759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8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28" name="object 328"/>
          <p:cNvSpPr txBox="1"/>
          <p:nvPr/>
        </p:nvSpPr>
        <p:spPr>
          <a:xfrm>
            <a:off x="5584027" y="6234156"/>
            <a:ext cx="83741" cy="700759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8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29" name="object 329"/>
          <p:cNvSpPr txBox="1"/>
          <p:nvPr/>
        </p:nvSpPr>
        <p:spPr>
          <a:xfrm>
            <a:off x="5567458" y="884111"/>
            <a:ext cx="83741" cy="701334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4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0" name="object 330"/>
          <p:cNvSpPr txBox="1"/>
          <p:nvPr/>
        </p:nvSpPr>
        <p:spPr>
          <a:xfrm>
            <a:off x="5553648" y="4008068"/>
            <a:ext cx="83741" cy="700759"/>
          </a:xfrm>
          <a:prstGeom prst="rect">
            <a:avLst/>
          </a:prstGeom>
        </p:spPr>
        <p:txBody>
          <a:bodyPr vert="vert" wrap="square" lIns="0" tIns="0" rIns="0" bIns="0" rtlCol="0">
            <a:spAutoFit/>
          </a:bodyPr>
          <a:lstStyle/>
          <a:p>
            <a:pPr marL="11506"/>
            <a:r>
              <a:rPr sz="544" b="1" spc="-9" dirty="0">
                <a:latin typeface="Arial"/>
                <a:cs typeface="Arial"/>
              </a:rPr>
              <a:t>L</a:t>
            </a:r>
            <a:r>
              <a:rPr sz="544" b="1" spc="-14" dirty="0">
                <a:latin typeface="Arial"/>
                <a:cs typeface="Arial"/>
              </a:rPr>
              <a:t>A</a:t>
            </a:r>
            <a:r>
              <a:rPr sz="544" b="1" spc="-9" dirty="0">
                <a:latin typeface="Arial"/>
                <a:cs typeface="Arial"/>
              </a:rPr>
              <a:t>M</a:t>
            </a:r>
            <a:r>
              <a:rPr sz="544" b="1" spc="-18" dirty="0">
                <a:latin typeface="Arial"/>
                <a:cs typeface="Arial"/>
              </a:rPr>
              <a:t>P</a:t>
            </a:r>
            <a:r>
              <a:rPr sz="544" b="1" dirty="0">
                <a:latin typeface="Arial"/>
                <a:cs typeface="Arial"/>
              </a:rPr>
              <a:t>1</a:t>
            </a:r>
            <a:r>
              <a:rPr sz="544" b="1" spc="-18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1" name="object 331"/>
          <p:cNvSpPr txBox="1"/>
          <p:nvPr/>
        </p:nvSpPr>
        <p:spPr>
          <a:xfrm>
            <a:off x="443125" y="1727192"/>
            <a:ext cx="188193" cy="68004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1223" spc="-41" dirty="0">
                <a:latin typeface="Calibri"/>
                <a:cs typeface="Calibri"/>
              </a:rPr>
              <a:t>A</a:t>
            </a:r>
            <a:r>
              <a:rPr sz="1223" spc="-36" dirty="0">
                <a:latin typeface="Calibri"/>
                <a:cs typeface="Calibri"/>
              </a:rPr>
              <a:t>TG16</a:t>
            </a:r>
            <a:r>
              <a:rPr sz="1223" spc="-33" dirty="0">
                <a:latin typeface="Calibri"/>
                <a:cs typeface="Calibri"/>
              </a:rPr>
              <a:t>l</a:t>
            </a:r>
            <a:r>
              <a:rPr sz="1223" spc="-41" dirty="0">
                <a:latin typeface="Calibri"/>
                <a:cs typeface="Calibri"/>
              </a:rPr>
              <a:t>1</a:t>
            </a:r>
            <a:r>
              <a:rPr sz="1223" spc="-33" dirty="0">
                <a:latin typeface="Calibri"/>
                <a:cs typeface="Calibri"/>
              </a:rPr>
              <a:t>-</a:t>
            </a:r>
            <a:r>
              <a:rPr sz="1223" spc="-18" dirty="0">
                <a:latin typeface="Calibri"/>
                <a:cs typeface="Calibri"/>
              </a:rPr>
              <a:t>/</a:t>
            </a:r>
            <a:r>
              <a:rPr sz="1223" dirty="0">
                <a:latin typeface="Calibri"/>
                <a:cs typeface="Calibri"/>
              </a:rPr>
              <a:t>-</a:t>
            </a:r>
            <a:endParaRPr sz="1223">
              <a:latin typeface="Calibri"/>
              <a:cs typeface="Calibri"/>
            </a:endParaRPr>
          </a:p>
        </p:txBody>
      </p:sp>
      <p:sp>
        <p:nvSpPr>
          <p:cNvPr id="332" name="object 332"/>
          <p:cNvSpPr txBox="1"/>
          <p:nvPr/>
        </p:nvSpPr>
        <p:spPr>
          <a:xfrm>
            <a:off x="3796848" y="2048631"/>
            <a:ext cx="83741" cy="58626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5" dirty="0">
                <a:latin typeface="Arial"/>
                <a:cs typeface="Arial"/>
              </a:rPr>
              <a:t>L</a:t>
            </a:r>
            <a:r>
              <a:rPr sz="544" b="1" spc="-5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14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18" dirty="0">
                <a:latin typeface="Arial"/>
                <a:cs typeface="Arial"/>
              </a:rPr>
              <a:t>u</a:t>
            </a:r>
            <a:r>
              <a:rPr sz="544" b="1" spc="-9" dirty="0">
                <a:latin typeface="Arial"/>
                <a:cs typeface="Arial"/>
              </a:rPr>
              <a:t>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3" name="object 333"/>
          <p:cNvSpPr txBox="1"/>
          <p:nvPr/>
        </p:nvSpPr>
        <p:spPr>
          <a:xfrm>
            <a:off x="3807894" y="966083"/>
            <a:ext cx="83741" cy="58626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5" dirty="0">
                <a:latin typeface="Arial"/>
                <a:cs typeface="Arial"/>
              </a:rPr>
              <a:t>L</a:t>
            </a:r>
            <a:r>
              <a:rPr sz="544" b="1" spc="-5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14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18" dirty="0">
                <a:latin typeface="Arial"/>
                <a:cs typeface="Arial"/>
              </a:rPr>
              <a:t>u</a:t>
            </a:r>
            <a:r>
              <a:rPr sz="544" b="1" spc="-9" dirty="0">
                <a:latin typeface="Arial"/>
                <a:cs typeface="Arial"/>
              </a:rPr>
              <a:t>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4" name="object 334"/>
          <p:cNvSpPr txBox="1"/>
          <p:nvPr/>
        </p:nvSpPr>
        <p:spPr>
          <a:xfrm>
            <a:off x="3824463" y="3063872"/>
            <a:ext cx="83741" cy="58626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5" dirty="0">
                <a:latin typeface="Arial"/>
                <a:cs typeface="Arial"/>
              </a:rPr>
              <a:t>L</a:t>
            </a:r>
            <a:r>
              <a:rPr sz="544" b="1" spc="-5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5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5" name="object 335"/>
          <p:cNvSpPr txBox="1"/>
          <p:nvPr/>
        </p:nvSpPr>
        <p:spPr>
          <a:xfrm>
            <a:off x="3835512" y="4116041"/>
            <a:ext cx="83741" cy="58626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5" dirty="0">
                <a:latin typeface="Arial"/>
                <a:cs typeface="Arial"/>
              </a:rPr>
              <a:t>L</a:t>
            </a:r>
            <a:r>
              <a:rPr sz="544" b="1" spc="-5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5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9" dirty="0">
                <a:latin typeface="Arial"/>
                <a:cs typeface="Arial"/>
              </a:rPr>
              <a:t>u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6" name="object 336"/>
          <p:cNvSpPr txBox="1"/>
          <p:nvPr/>
        </p:nvSpPr>
        <p:spPr>
          <a:xfrm>
            <a:off x="3842415" y="6288157"/>
            <a:ext cx="83741" cy="586841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-23" dirty="0">
                <a:latin typeface="Arial"/>
                <a:cs typeface="Arial"/>
              </a:rPr>
              <a:t>L</a:t>
            </a:r>
            <a:r>
              <a:rPr sz="544" b="1" spc="-18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-5" dirty="0">
                <a:latin typeface="Times New Roman"/>
                <a:cs typeface="Times New Roman"/>
              </a:rPr>
              <a:t> </a:t>
            </a:r>
            <a:r>
              <a:rPr sz="544" b="1" spc="-18" dirty="0">
                <a:latin typeface="Arial"/>
                <a:cs typeface="Arial"/>
              </a:rPr>
              <a:t>f</a:t>
            </a:r>
            <a:r>
              <a:rPr sz="544" b="1" spc="-28" dirty="0">
                <a:latin typeface="Arial"/>
                <a:cs typeface="Arial"/>
              </a:rPr>
              <a:t>l</a:t>
            </a:r>
            <a:r>
              <a:rPr sz="544" b="1" spc="-23" dirty="0">
                <a:latin typeface="Arial"/>
                <a:cs typeface="Arial"/>
              </a:rPr>
              <a:t>uo</a:t>
            </a:r>
            <a:r>
              <a:rPr sz="544" b="1" spc="-28" dirty="0">
                <a:latin typeface="Arial"/>
                <a:cs typeface="Arial"/>
              </a:rPr>
              <a:t>r</a:t>
            </a:r>
            <a:r>
              <a:rPr sz="544" b="1" spc="-23" dirty="0">
                <a:latin typeface="Arial"/>
                <a:cs typeface="Arial"/>
              </a:rPr>
              <a:t>e</a:t>
            </a:r>
            <a:r>
              <a:rPr sz="544" b="1" spc="-14" dirty="0">
                <a:latin typeface="Arial"/>
                <a:cs typeface="Arial"/>
              </a:rPr>
              <a:t>s</a:t>
            </a:r>
            <a:r>
              <a:rPr sz="544" b="1" spc="-23" dirty="0">
                <a:latin typeface="Arial"/>
                <a:cs typeface="Arial"/>
              </a:rPr>
              <a:t>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7" name="object 337"/>
          <p:cNvSpPr txBox="1"/>
          <p:nvPr/>
        </p:nvSpPr>
        <p:spPr>
          <a:xfrm>
            <a:off x="3839653" y="5262341"/>
            <a:ext cx="83741" cy="586267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544" b="1" spc="5" dirty="0">
                <a:latin typeface="Arial"/>
                <a:cs typeface="Arial"/>
              </a:rPr>
              <a:t>L</a:t>
            </a:r>
            <a:r>
              <a:rPr sz="544" b="1" spc="-5" dirty="0">
                <a:latin typeface="Arial"/>
                <a:cs typeface="Arial"/>
              </a:rPr>
              <a:t>C</a:t>
            </a:r>
            <a:r>
              <a:rPr sz="544" b="1" dirty="0">
                <a:latin typeface="Arial"/>
                <a:cs typeface="Arial"/>
              </a:rPr>
              <a:t>3</a:t>
            </a:r>
            <a:r>
              <a:rPr sz="544" b="1" spc="14" dirty="0">
                <a:latin typeface="Times New Roman"/>
                <a:cs typeface="Times New Roman"/>
              </a:rPr>
              <a:t> </a:t>
            </a:r>
            <a:r>
              <a:rPr sz="544" b="1" spc="-9" dirty="0">
                <a:latin typeface="Arial"/>
                <a:cs typeface="Arial"/>
              </a:rPr>
              <a:t>f</a:t>
            </a:r>
            <a:r>
              <a:rPr sz="544" b="1" spc="-14" dirty="0">
                <a:latin typeface="Arial"/>
                <a:cs typeface="Arial"/>
              </a:rPr>
              <a:t>l</a:t>
            </a:r>
            <a:r>
              <a:rPr sz="544" b="1" spc="-18" dirty="0">
                <a:latin typeface="Arial"/>
                <a:cs typeface="Arial"/>
              </a:rPr>
              <a:t>u</a:t>
            </a:r>
            <a:r>
              <a:rPr sz="544" b="1" spc="-9" dirty="0">
                <a:latin typeface="Arial"/>
                <a:cs typeface="Arial"/>
              </a:rPr>
              <a:t>o</a:t>
            </a:r>
            <a:r>
              <a:rPr sz="544" b="1" spc="-18" dirty="0">
                <a:latin typeface="Arial"/>
                <a:cs typeface="Arial"/>
              </a:rPr>
              <a:t>r</a:t>
            </a:r>
            <a:r>
              <a:rPr sz="544" b="1" spc="-9" dirty="0">
                <a:latin typeface="Arial"/>
                <a:cs typeface="Arial"/>
              </a:rPr>
              <a:t>escenc</a:t>
            </a:r>
            <a:r>
              <a:rPr sz="544" b="1" dirty="0">
                <a:latin typeface="Arial"/>
                <a:cs typeface="Arial"/>
              </a:rPr>
              <a:t>e</a:t>
            </a:r>
            <a:endParaRPr sz="544">
              <a:latin typeface="Arial"/>
              <a:cs typeface="Arial"/>
            </a:endParaRPr>
          </a:p>
        </p:txBody>
      </p:sp>
      <p:sp>
        <p:nvSpPr>
          <p:cNvPr id="338" name="object 338"/>
          <p:cNvSpPr/>
          <p:nvPr/>
        </p:nvSpPr>
        <p:spPr>
          <a:xfrm>
            <a:off x="4133212" y="1905920"/>
            <a:ext cx="1231793" cy="871274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9" name="object 339"/>
          <p:cNvSpPr txBox="1"/>
          <p:nvPr/>
        </p:nvSpPr>
        <p:spPr>
          <a:xfrm>
            <a:off x="781350" y="2895139"/>
            <a:ext cx="279613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00B050"/>
                </a:solidFill>
                <a:latin typeface="Calibri"/>
                <a:cs typeface="Calibri"/>
              </a:rPr>
              <a:t>LC</a:t>
            </a:r>
            <a:r>
              <a:rPr sz="997" b="1" spc="-9" dirty="0">
                <a:solidFill>
                  <a:srgbClr val="00B050"/>
                </a:solidFill>
                <a:latin typeface="Calibri"/>
                <a:cs typeface="Calibri"/>
              </a:rPr>
              <a:t>3</a:t>
            </a:r>
            <a:r>
              <a:rPr sz="997" b="1" dirty="0">
                <a:solidFill>
                  <a:srgbClr val="00B050"/>
                </a:solidFill>
                <a:latin typeface="Calibri"/>
                <a:cs typeface="Calibri"/>
              </a:rPr>
              <a:t>B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340" name="object 340"/>
          <p:cNvSpPr txBox="1"/>
          <p:nvPr/>
        </p:nvSpPr>
        <p:spPr>
          <a:xfrm>
            <a:off x="1123794" y="2895139"/>
            <a:ext cx="395830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0000"/>
                </a:solidFill>
                <a:latin typeface="Calibri"/>
                <a:cs typeface="Calibri"/>
              </a:rPr>
              <a:t>LA</a:t>
            </a:r>
            <a:r>
              <a:rPr sz="997" b="1" spc="-5" dirty="0">
                <a:solidFill>
                  <a:srgbClr val="FF0000"/>
                </a:solidFill>
                <a:latin typeface="Calibri"/>
                <a:cs typeface="Calibri"/>
              </a:rPr>
              <a:t>M</a:t>
            </a:r>
            <a:r>
              <a:rPr sz="997" b="1" spc="-14" dirty="0">
                <a:solidFill>
                  <a:srgbClr val="FF0000"/>
                </a:solidFill>
                <a:latin typeface="Calibri"/>
                <a:cs typeface="Calibri"/>
              </a:rPr>
              <a:t>P</a:t>
            </a:r>
            <a:r>
              <a:rPr sz="997" b="1" dirty="0">
                <a:solidFill>
                  <a:srgbClr val="FF0000"/>
                </a:solidFill>
                <a:latin typeface="Calibri"/>
                <a:cs typeface="Calibri"/>
              </a:rPr>
              <a:t>1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341" name="object 341"/>
          <p:cNvSpPr txBox="1"/>
          <p:nvPr/>
        </p:nvSpPr>
        <p:spPr>
          <a:xfrm>
            <a:off x="3200821" y="768123"/>
            <a:ext cx="208846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dirty="0">
                <a:latin typeface="Calibri"/>
                <a:cs typeface="Calibri"/>
              </a:rPr>
              <a:t>ROI</a:t>
            </a:r>
            <a:endParaRPr sz="997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816913" y="624521"/>
            <a:ext cx="227258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33" dirty="0">
                <a:latin typeface="Calibri"/>
                <a:cs typeface="Calibri"/>
              </a:rPr>
              <a:t>WT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3180115" y="618997"/>
            <a:ext cx="485008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59" dirty="0">
                <a:latin typeface="Calibri"/>
                <a:cs typeface="Calibri"/>
              </a:rPr>
              <a:t>A</a:t>
            </a:r>
            <a:r>
              <a:rPr sz="1178" b="1" spc="-50" dirty="0">
                <a:latin typeface="Calibri"/>
                <a:cs typeface="Calibri"/>
              </a:rPr>
              <a:t>T</a:t>
            </a:r>
            <a:r>
              <a:rPr sz="1178" b="1" spc="-54" dirty="0">
                <a:latin typeface="Calibri"/>
                <a:cs typeface="Calibri"/>
              </a:rPr>
              <a:t>G</a:t>
            </a:r>
            <a:r>
              <a:rPr sz="1178" b="1" spc="-41" dirty="0">
                <a:latin typeface="Calibri"/>
                <a:cs typeface="Calibri"/>
              </a:rPr>
              <a:t>4</a:t>
            </a:r>
            <a:r>
              <a:rPr sz="1178" b="1" spc="-50" dirty="0">
                <a:latin typeface="Calibri"/>
                <a:cs typeface="Calibri"/>
              </a:rPr>
              <a:t>-</a:t>
            </a:r>
            <a:r>
              <a:rPr sz="1178" b="1" spc="-36" dirty="0">
                <a:latin typeface="Calibri"/>
                <a:cs typeface="Calibri"/>
              </a:rPr>
              <a:t>/</a:t>
            </a:r>
            <a:r>
              <a:rPr sz="1178" b="1" spc="-5" dirty="0">
                <a:latin typeface="Calibri"/>
                <a:cs typeface="Calibri"/>
              </a:rPr>
              <a:t>-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00191" y="5108801"/>
            <a:ext cx="5165363" cy="155677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496500" algn="ctr"/>
            <a:r>
              <a:rPr sz="1178" b="1" spc="-9" dirty="0">
                <a:solidFill>
                  <a:srgbClr val="00AF50"/>
                </a:solidFill>
                <a:latin typeface="Calibri"/>
                <a:cs typeface="Calibri"/>
              </a:rPr>
              <a:t>LC3</a:t>
            </a:r>
            <a:r>
              <a:rPr sz="1178" b="1" spc="86" dirty="0">
                <a:solidFill>
                  <a:srgbClr val="00AF50"/>
                </a:solidFill>
                <a:latin typeface="Times New Roman"/>
                <a:cs typeface="Times New Roman"/>
              </a:rPr>
              <a:t> </a:t>
            </a:r>
            <a:r>
              <a:rPr sz="1178" b="1" spc="-23" dirty="0">
                <a:solidFill>
                  <a:srgbClr val="0070BF"/>
                </a:solidFill>
                <a:latin typeface="Calibri"/>
                <a:cs typeface="Calibri"/>
              </a:rPr>
              <a:t>D</a:t>
            </a:r>
            <a:r>
              <a:rPr sz="1178" b="1" spc="-36" dirty="0">
                <a:solidFill>
                  <a:srgbClr val="0070BF"/>
                </a:solidFill>
                <a:latin typeface="Calibri"/>
                <a:cs typeface="Calibri"/>
              </a:rPr>
              <a:t>A</a:t>
            </a:r>
            <a:r>
              <a:rPr sz="1178" b="1" spc="-18" dirty="0">
                <a:solidFill>
                  <a:srgbClr val="0070BF"/>
                </a:solidFill>
                <a:latin typeface="Calibri"/>
                <a:cs typeface="Calibri"/>
              </a:rPr>
              <a:t>P</a:t>
            </a:r>
            <a:r>
              <a:rPr sz="1178" b="1" spc="-5" dirty="0">
                <a:solidFill>
                  <a:srgbClr val="0070BF"/>
                </a:solidFill>
                <a:latin typeface="Calibri"/>
                <a:cs typeface="Calibri"/>
              </a:rPr>
              <a:t>I</a:t>
            </a:r>
            <a:endParaRPr sz="1178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1178" dirty="0">
              <a:latin typeface="Times New Roman"/>
              <a:cs typeface="Times New Roman"/>
            </a:endParaRPr>
          </a:p>
          <a:p>
            <a:endParaRPr sz="1403" dirty="0">
              <a:latin typeface="Times New Roman"/>
              <a:cs typeface="Times New Roman"/>
            </a:endParaRPr>
          </a:p>
          <a:p>
            <a:pPr marL="11506" marR="4602" algn="just">
              <a:lnSpc>
                <a:spcPct val="118500"/>
              </a:lnSpc>
            </a:pPr>
            <a:r>
              <a:rPr sz="1087" b="1" dirty="0">
                <a:latin typeface="Times New Roman"/>
                <a:cs typeface="Times New Roman"/>
              </a:rPr>
              <a:t>Su</a:t>
            </a:r>
            <a:r>
              <a:rPr sz="1087" b="1" spc="-9" dirty="0">
                <a:latin typeface="Times New Roman"/>
                <a:cs typeface="Times New Roman"/>
              </a:rPr>
              <a:t>p</a:t>
            </a:r>
            <a:r>
              <a:rPr sz="1087" b="1" dirty="0">
                <a:latin typeface="Times New Roman"/>
                <a:cs typeface="Times New Roman"/>
              </a:rPr>
              <a:t>p</a:t>
            </a:r>
            <a:r>
              <a:rPr sz="1087" b="1" spc="-9" dirty="0">
                <a:latin typeface="Times New Roman"/>
                <a:cs typeface="Times New Roman"/>
              </a:rPr>
              <a:t>lem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</a:t>
            </a:r>
            <a:r>
              <a:rPr sz="1087" b="1" spc="-5" dirty="0">
                <a:latin typeface="Times New Roman"/>
                <a:cs typeface="Times New Roman"/>
              </a:rPr>
              <a:t>tal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figu</a:t>
            </a:r>
            <a:r>
              <a:rPr sz="1087" b="1" spc="-14" dirty="0">
                <a:latin typeface="Times New Roman"/>
                <a:cs typeface="Times New Roman"/>
              </a:rPr>
              <a:t>r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spc="-18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2. </a:t>
            </a:r>
            <a:r>
              <a:rPr sz="1087" b="1" spc="-113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AT</a:t>
            </a:r>
            <a:r>
              <a:rPr sz="1087" b="1" spc="-9" dirty="0">
                <a:latin typeface="Times New Roman"/>
                <a:cs typeface="Times New Roman"/>
              </a:rPr>
              <a:t>G16L</a:t>
            </a:r>
            <a:r>
              <a:rPr sz="1087" b="1" dirty="0">
                <a:latin typeface="Times New Roman"/>
                <a:cs typeface="Times New Roman"/>
              </a:rPr>
              <a:t>1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i</a:t>
            </a:r>
            <a:r>
              <a:rPr sz="1087" b="1" spc="-14" dirty="0">
                <a:latin typeface="Times New Roman"/>
                <a:cs typeface="Times New Roman"/>
              </a:rPr>
              <a:t>n</a:t>
            </a:r>
            <a:r>
              <a:rPr sz="1087" b="1" dirty="0">
                <a:latin typeface="Times New Roman"/>
                <a:cs typeface="Times New Roman"/>
              </a:rPr>
              <a:t>d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p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d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t</a:t>
            </a:r>
            <a:r>
              <a:rPr sz="1087" b="1" spc="-28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in</a:t>
            </a:r>
            <a:r>
              <a:rPr sz="1087" b="1" dirty="0">
                <a:latin typeface="Times New Roman"/>
                <a:cs typeface="Times New Roman"/>
              </a:rPr>
              <a:t>du</a:t>
            </a:r>
            <a:r>
              <a:rPr sz="1087" b="1" spc="-14" dirty="0">
                <a:latin typeface="Times New Roman"/>
                <a:cs typeface="Times New Roman"/>
              </a:rPr>
              <a:t>c</a:t>
            </a:r>
            <a:r>
              <a:rPr sz="1087" b="1" spc="-5" dirty="0">
                <a:latin typeface="Times New Roman"/>
                <a:cs typeface="Times New Roman"/>
              </a:rPr>
              <a:t>tion</a:t>
            </a:r>
            <a:r>
              <a:rPr sz="1087" b="1" spc="-23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of</a:t>
            </a:r>
            <a:r>
              <a:rPr sz="1087" b="1" spc="-18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L</a:t>
            </a:r>
            <a:r>
              <a:rPr sz="1087" b="1" spc="-5" dirty="0">
                <a:latin typeface="Times New Roman"/>
                <a:cs typeface="Times New Roman"/>
              </a:rPr>
              <a:t>C</a:t>
            </a:r>
            <a:r>
              <a:rPr sz="1087" b="1" dirty="0">
                <a:latin typeface="Times New Roman"/>
                <a:cs typeface="Times New Roman"/>
              </a:rPr>
              <a:t>3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p</a:t>
            </a:r>
            <a:r>
              <a:rPr sz="1087" b="1" dirty="0">
                <a:latin typeface="Times New Roman"/>
                <a:cs typeface="Times New Roman"/>
              </a:rPr>
              <a:t>un</a:t>
            </a:r>
            <a:r>
              <a:rPr sz="1087" b="1" spc="-14" dirty="0">
                <a:latin typeface="Times New Roman"/>
                <a:cs typeface="Times New Roman"/>
              </a:rPr>
              <a:t>c</a:t>
            </a:r>
            <a:r>
              <a:rPr sz="1087" b="1" dirty="0">
                <a:latin typeface="Times New Roman"/>
                <a:cs typeface="Times New Roman"/>
              </a:rPr>
              <a:t>ta</a:t>
            </a:r>
            <a:r>
              <a:rPr sz="1087" b="1" spc="-18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by</a:t>
            </a:r>
            <a:r>
              <a:rPr sz="1087" b="1" spc="-14" dirty="0">
                <a:latin typeface="Times New Roman"/>
                <a:cs typeface="Times New Roman"/>
              </a:rPr>
              <a:t> c</a:t>
            </a:r>
            <a:r>
              <a:rPr sz="1087" b="1" dirty="0">
                <a:latin typeface="Times New Roman"/>
                <a:cs typeface="Times New Roman"/>
              </a:rPr>
              <a:t>h</a:t>
            </a:r>
            <a:r>
              <a:rPr sz="1087" b="1" spc="-9" dirty="0">
                <a:latin typeface="Times New Roman"/>
                <a:cs typeface="Times New Roman"/>
              </a:rPr>
              <a:t>loroq</a:t>
            </a:r>
            <a:r>
              <a:rPr sz="1087" b="1" spc="-18" dirty="0">
                <a:latin typeface="Times New Roman"/>
                <a:cs typeface="Times New Roman"/>
              </a:rPr>
              <a:t>u</a:t>
            </a:r>
            <a:r>
              <a:rPr sz="1087" b="1" spc="-5" dirty="0">
                <a:latin typeface="Times New Roman"/>
                <a:cs typeface="Times New Roman"/>
              </a:rPr>
              <a:t>i</a:t>
            </a:r>
            <a:r>
              <a:rPr sz="1087" b="1" spc="-14" dirty="0">
                <a:latin typeface="Times New Roman"/>
                <a:cs typeface="Times New Roman"/>
              </a:rPr>
              <a:t>n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spc="-5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re</a:t>
            </a:r>
            <a:r>
              <a:rPr sz="1087" b="1" dirty="0">
                <a:latin typeface="Times New Roman"/>
                <a:cs typeface="Times New Roman"/>
              </a:rPr>
              <a:t>qu</a:t>
            </a:r>
            <a:r>
              <a:rPr sz="1087" b="1" spc="-5" dirty="0">
                <a:latin typeface="Times New Roman"/>
                <a:cs typeface="Times New Roman"/>
              </a:rPr>
              <a:t>ir</a:t>
            </a:r>
            <a:r>
              <a:rPr sz="1087" b="1" spc="-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s</a:t>
            </a:r>
            <a:r>
              <a:rPr sz="1087" b="1" spc="73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AT</a:t>
            </a:r>
            <a:r>
              <a:rPr sz="1087" b="1" spc="-9" dirty="0">
                <a:latin typeface="Times New Roman"/>
                <a:cs typeface="Times New Roman"/>
              </a:rPr>
              <a:t>G</a:t>
            </a:r>
            <a:r>
              <a:rPr sz="1087" b="1" dirty="0">
                <a:latin typeface="Times New Roman"/>
                <a:cs typeface="Times New Roman"/>
              </a:rPr>
              <a:t>4. </a:t>
            </a:r>
            <a:r>
              <a:rPr sz="1087" b="1" spc="45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Contr</a:t>
            </a:r>
            <a:r>
              <a:rPr sz="1087" spc="-5" dirty="0">
                <a:latin typeface="Times New Roman"/>
                <a:cs typeface="Times New Roman"/>
              </a:rPr>
              <a:t>ol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(</a:t>
            </a:r>
            <a:r>
              <a:rPr sz="1087" spc="-23" dirty="0">
                <a:latin typeface="Times New Roman"/>
                <a:cs typeface="Times New Roman"/>
              </a:rPr>
              <a:t>W</a:t>
            </a:r>
            <a:r>
              <a:rPr sz="1087" spc="-9" dirty="0">
                <a:latin typeface="Times New Roman"/>
                <a:cs typeface="Times New Roman"/>
              </a:rPr>
              <a:t>T)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</a:t>
            </a:r>
            <a:r>
              <a:rPr sz="1087" spc="8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tetra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kno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dirty="0">
                <a:latin typeface="Times New Roman"/>
                <a:cs typeface="Times New Roman"/>
              </a:rPr>
              <a:t>k</a:t>
            </a:r>
            <a:r>
              <a:rPr sz="1087" spc="9" dirty="0">
                <a:latin typeface="Times New Roman"/>
                <a:cs typeface="Times New Roman"/>
              </a:rPr>
              <a:t>o</a:t>
            </a:r>
            <a:r>
              <a:rPr sz="1087" spc="-5" dirty="0">
                <a:latin typeface="Times New Roman"/>
                <a:cs typeface="Times New Roman"/>
              </a:rPr>
              <a:t>ut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ATG</a:t>
            </a:r>
            <a:r>
              <a:rPr sz="1087" dirty="0">
                <a:latin typeface="Times New Roman"/>
                <a:cs typeface="Times New Roman"/>
              </a:rPr>
              <a:t>4</a:t>
            </a:r>
            <a:r>
              <a:rPr sz="1087" spc="8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H</a:t>
            </a:r>
            <a:r>
              <a:rPr sz="1087" spc="-9" dirty="0">
                <a:latin typeface="Times New Roman"/>
                <a:cs typeface="Times New Roman"/>
              </a:rPr>
              <a:t>eLa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c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ll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7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w</a:t>
            </a:r>
            <a:r>
              <a:rPr sz="1087" dirty="0">
                <a:latin typeface="Times New Roman"/>
                <a:cs typeface="Times New Roman"/>
              </a:rPr>
              <a:t>e</a:t>
            </a:r>
            <a:r>
              <a:rPr sz="1087" spc="5" dirty="0">
                <a:latin typeface="Times New Roman"/>
                <a:cs typeface="Times New Roman"/>
              </a:rPr>
              <a:t>r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68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incub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t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spc="73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f</a:t>
            </a:r>
            <a:r>
              <a:rPr sz="1087" spc="5" dirty="0">
                <a:latin typeface="Times New Roman"/>
                <a:cs typeface="Times New Roman"/>
              </a:rPr>
              <a:t>o</a:t>
            </a:r>
            <a:r>
              <a:rPr sz="1087" dirty="0">
                <a:latin typeface="Times New Roman"/>
                <a:cs typeface="Times New Roman"/>
              </a:rPr>
              <a:t>r</a:t>
            </a:r>
            <a:r>
              <a:rPr sz="1087" spc="6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2 hours 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in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nutri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n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medi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(</a:t>
            </a:r>
            <a:r>
              <a:rPr sz="1087" b="1" spc="-5" dirty="0">
                <a:latin typeface="Times New Roman"/>
                <a:cs typeface="Times New Roman"/>
              </a:rPr>
              <a:t>i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45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a</a:t>
            </a:r>
            <a:r>
              <a:rPr sz="1087" b="1" dirty="0">
                <a:latin typeface="Times New Roman"/>
                <a:cs typeface="Times New Roman"/>
              </a:rPr>
              <a:t>nd </a:t>
            </a:r>
            <a:r>
              <a:rPr sz="1087" b="1" spc="-50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iv</a:t>
            </a:r>
            <a:r>
              <a:rPr sz="1087" spc="-5" dirty="0">
                <a:latin typeface="Times New Roman"/>
                <a:cs typeface="Times New Roman"/>
              </a:rPr>
              <a:t>),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EB</a:t>
            </a:r>
            <a:r>
              <a:rPr sz="1087" spc="-5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S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(</a:t>
            </a:r>
            <a:r>
              <a:rPr sz="1087" b="1" spc="-5" dirty="0">
                <a:latin typeface="Times New Roman"/>
                <a:cs typeface="Times New Roman"/>
              </a:rPr>
              <a:t>ii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54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&amp;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54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v</a:t>
            </a:r>
            <a:r>
              <a:rPr sz="1087" dirty="0">
                <a:latin typeface="Times New Roman"/>
                <a:cs typeface="Times New Roman"/>
              </a:rPr>
              <a:t>) 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or 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nutri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n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medi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containing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100µM 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spc="-9" dirty="0">
                <a:latin typeface="Times New Roman"/>
                <a:cs typeface="Times New Roman"/>
              </a:rPr>
              <a:t>hloroquin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(</a:t>
            </a:r>
            <a:r>
              <a:rPr sz="1087" b="1" spc="-5" dirty="0">
                <a:latin typeface="Times New Roman"/>
                <a:cs typeface="Times New Roman"/>
              </a:rPr>
              <a:t>ii</a:t>
            </a:r>
            <a:r>
              <a:rPr sz="1087" b="1" dirty="0">
                <a:latin typeface="Times New Roman"/>
                <a:cs typeface="Times New Roman"/>
              </a:rPr>
              <a:t>i</a:t>
            </a:r>
            <a:r>
              <a:rPr sz="1087" b="1" spc="-5" dirty="0">
                <a:latin typeface="Times New Roman"/>
                <a:cs typeface="Times New Roman"/>
              </a:rPr>
              <a:t>-vi</a:t>
            </a:r>
            <a:r>
              <a:rPr sz="1087" spc="-5" dirty="0">
                <a:latin typeface="Times New Roman"/>
                <a:cs typeface="Times New Roman"/>
              </a:rPr>
              <a:t>)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s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i</a:t>
            </a:r>
            <a:r>
              <a:rPr sz="1087" dirty="0">
                <a:latin typeface="Times New Roman"/>
                <a:cs typeface="Times New Roman"/>
              </a:rPr>
              <a:t>n</a:t>
            </a:r>
            <a:r>
              <a:rPr sz="1087" spc="-5" dirty="0">
                <a:latin typeface="Times New Roman"/>
                <a:cs typeface="Times New Roman"/>
              </a:rPr>
              <a:t>dic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ted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C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ll</a:t>
            </a:r>
            <a:r>
              <a:rPr sz="1087" dirty="0">
                <a:latin typeface="Times New Roman"/>
                <a:cs typeface="Times New Roman"/>
              </a:rPr>
              <a:t>s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w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r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fixe</a:t>
            </a:r>
            <a:r>
              <a:rPr sz="1087" dirty="0">
                <a:latin typeface="Times New Roman"/>
                <a:cs typeface="Times New Roman"/>
              </a:rPr>
              <a:t>d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immunostain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for</a:t>
            </a:r>
            <a:r>
              <a:rPr sz="1087" spc="131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LC3.</a:t>
            </a:r>
            <a:r>
              <a:rPr sz="1087" dirty="0">
                <a:latin typeface="Times New Roman"/>
                <a:cs typeface="Times New Roman"/>
              </a:rPr>
              <a:t>  </a:t>
            </a:r>
            <a:r>
              <a:rPr sz="1087" spc="-109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14" dirty="0">
                <a:latin typeface="Times New Roman"/>
                <a:cs typeface="Times New Roman"/>
              </a:rPr>
              <a:t>ca</a:t>
            </a:r>
            <a:r>
              <a:rPr sz="1087" spc="-5" dirty="0">
                <a:latin typeface="Times New Roman"/>
                <a:cs typeface="Times New Roman"/>
              </a:rPr>
              <a:t>l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b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r </a:t>
            </a:r>
            <a:r>
              <a:rPr sz="1087" spc="-9" dirty="0">
                <a:latin typeface="Times New Roman"/>
                <a:cs typeface="Times New Roman"/>
              </a:rPr>
              <a:t>20</a:t>
            </a:r>
            <a:r>
              <a:rPr lang="en-GB" sz="1087" dirty="0">
                <a:latin typeface="Times New Roman"/>
                <a:cs typeface="Times New Roman"/>
              </a:rPr>
              <a:t>µ</a:t>
            </a:r>
            <a:r>
              <a:rPr sz="1087" spc="-5" dirty="0">
                <a:latin typeface="Times New Roman"/>
                <a:cs typeface="Times New Roman"/>
              </a:rPr>
              <a:t>m</a:t>
            </a:r>
            <a:r>
              <a:rPr sz="997" dirty="0">
                <a:latin typeface="Times New Roman"/>
                <a:cs typeface="Times New Roman"/>
              </a:rPr>
              <a:t>.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1137555" y="4280119"/>
            <a:ext cx="181268" cy="25660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1178" b="1" spc="-28" dirty="0">
                <a:latin typeface="Calibri"/>
                <a:cs typeface="Calibri"/>
              </a:rPr>
              <a:t>C</a:t>
            </a:r>
            <a:r>
              <a:rPr sz="1178" b="1" spc="-23" dirty="0">
                <a:latin typeface="Calibri"/>
                <a:cs typeface="Calibri"/>
              </a:rPr>
              <a:t>h</a:t>
            </a:r>
            <a:r>
              <a:rPr sz="1178" b="1" dirty="0">
                <a:latin typeface="Calibri"/>
                <a:cs typeface="Calibri"/>
              </a:rPr>
              <a:t>q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1140315" y="1260809"/>
            <a:ext cx="181268" cy="414816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1178" b="1" spc="-9" dirty="0">
                <a:latin typeface="Calibri"/>
                <a:cs typeface="Calibri"/>
              </a:rPr>
              <a:t>M</a:t>
            </a:r>
            <a:r>
              <a:rPr sz="1178" b="1" spc="-18" dirty="0">
                <a:latin typeface="Calibri"/>
                <a:cs typeface="Calibri"/>
              </a:rPr>
              <a:t>e</a:t>
            </a:r>
            <a:r>
              <a:rPr sz="1178" b="1" spc="-14" dirty="0">
                <a:latin typeface="Calibri"/>
                <a:cs typeface="Calibri"/>
              </a:rPr>
              <a:t>d</a:t>
            </a:r>
            <a:r>
              <a:rPr sz="1178" b="1" spc="-9" dirty="0">
                <a:latin typeface="Calibri"/>
                <a:cs typeface="Calibri"/>
              </a:rPr>
              <a:t>i</a:t>
            </a:r>
            <a:r>
              <a:rPr sz="1178" b="1" dirty="0">
                <a:latin typeface="Calibri"/>
                <a:cs typeface="Calibri"/>
              </a:rPr>
              <a:t>a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1357792" y="886183"/>
            <a:ext cx="1296230" cy="129508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" name="object 8"/>
          <p:cNvSpPr/>
          <p:nvPr/>
        </p:nvSpPr>
        <p:spPr>
          <a:xfrm>
            <a:off x="2320444" y="2074368"/>
            <a:ext cx="310106" cy="0"/>
          </a:xfrm>
          <a:custGeom>
            <a:avLst/>
            <a:gdLst/>
            <a:ahLst/>
            <a:cxnLst/>
            <a:rect l="l" t="t" r="r" b="b"/>
            <a:pathLst>
              <a:path w="342264">
                <a:moveTo>
                  <a:pt x="0" y="0"/>
                </a:moveTo>
                <a:lnTo>
                  <a:pt x="341754" y="0"/>
                </a:lnTo>
              </a:path>
            </a:pathLst>
          </a:custGeom>
          <a:ln w="1650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" name="object 9"/>
          <p:cNvSpPr/>
          <p:nvPr/>
        </p:nvSpPr>
        <p:spPr>
          <a:xfrm>
            <a:off x="1412564" y="961897"/>
            <a:ext cx="142223" cy="149127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" name="object 10"/>
          <p:cNvSpPr txBox="1"/>
          <p:nvPr/>
        </p:nvSpPr>
        <p:spPr>
          <a:xfrm>
            <a:off x="1401286" y="957525"/>
            <a:ext cx="148437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28" dirty="0">
                <a:solidFill>
                  <a:srgbClr val="F2F2F2"/>
                </a:solidFill>
                <a:latin typeface="Calibri"/>
                <a:cs typeface="Calibri"/>
              </a:rPr>
              <a:t>(</a:t>
            </a:r>
            <a:r>
              <a:rPr sz="1178" b="1" spc="-23" dirty="0">
                <a:solidFill>
                  <a:srgbClr val="F2F2F2"/>
                </a:solidFill>
                <a:latin typeface="Calibri"/>
                <a:cs typeface="Calibri"/>
              </a:rPr>
              <a:t>i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2397079" y="2091396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" name="object 12"/>
          <p:cNvSpPr txBox="1"/>
          <p:nvPr/>
        </p:nvSpPr>
        <p:spPr>
          <a:xfrm>
            <a:off x="2386148" y="2084217"/>
            <a:ext cx="180655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13" name="object 13"/>
          <p:cNvSpPr/>
          <p:nvPr/>
        </p:nvSpPr>
        <p:spPr>
          <a:xfrm>
            <a:off x="2777722" y="886759"/>
            <a:ext cx="1295195" cy="129519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3742214" y="2069461"/>
            <a:ext cx="310680" cy="0"/>
          </a:xfrm>
          <a:custGeom>
            <a:avLst/>
            <a:gdLst/>
            <a:ahLst/>
            <a:cxnLst/>
            <a:rect l="l" t="t" r="r" b="b"/>
            <a:pathLst>
              <a:path w="342900">
                <a:moveTo>
                  <a:pt x="0" y="0"/>
                </a:moveTo>
                <a:lnTo>
                  <a:pt x="342418" y="0"/>
                </a:lnTo>
              </a:path>
            </a:pathLst>
          </a:custGeom>
          <a:ln w="15651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2809939" y="949469"/>
            <a:ext cx="212643" cy="150508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 txBox="1"/>
          <p:nvPr/>
        </p:nvSpPr>
        <p:spPr>
          <a:xfrm>
            <a:off x="2799008" y="945097"/>
            <a:ext cx="216326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28" dirty="0">
                <a:solidFill>
                  <a:srgbClr val="F2F2F2"/>
                </a:solidFill>
                <a:latin typeface="Calibri"/>
                <a:cs typeface="Calibri"/>
              </a:rPr>
              <a:t>(</a:t>
            </a:r>
            <a:r>
              <a:rPr sz="1178" b="1" spc="-23" dirty="0">
                <a:solidFill>
                  <a:srgbClr val="F2F2F2"/>
                </a:solidFill>
                <a:latin typeface="Calibri"/>
                <a:cs typeface="Calibri"/>
              </a:rPr>
              <a:t>i</a:t>
            </a:r>
            <a:r>
              <a:rPr sz="1178" b="1" spc="-33" dirty="0">
                <a:solidFill>
                  <a:srgbClr val="F2F2F2"/>
                </a:solidFill>
                <a:latin typeface="Calibri"/>
                <a:cs typeface="Calibri"/>
              </a:rPr>
              <a:t>v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17" name="object 17"/>
          <p:cNvSpPr/>
          <p:nvPr/>
        </p:nvSpPr>
        <p:spPr>
          <a:xfrm>
            <a:off x="3819309" y="2085872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 txBox="1"/>
          <p:nvPr/>
        </p:nvSpPr>
        <p:spPr>
          <a:xfrm>
            <a:off x="3808607" y="2078695"/>
            <a:ext cx="182381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spc="9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19" name="object 19"/>
          <p:cNvSpPr/>
          <p:nvPr/>
        </p:nvSpPr>
        <p:spPr>
          <a:xfrm>
            <a:off x="1357792" y="2330391"/>
            <a:ext cx="1296230" cy="1295080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2320444" y="3515669"/>
            <a:ext cx="310106" cy="0"/>
          </a:xfrm>
          <a:custGeom>
            <a:avLst/>
            <a:gdLst/>
            <a:ahLst/>
            <a:cxnLst/>
            <a:rect l="l" t="t" r="r" b="b"/>
            <a:pathLst>
              <a:path w="342264">
                <a:moveTo>
                  <a:pt x="0" y="0"/>
                </a:moveTo>
                <a:lnTo>
                  <a:pt x="341754" y="0"/>
                </a:lnTo>
              </a:path>
            </a:pathLst>
          </a:custGeom>
          <a:ln w="1555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1420850" y="2410361"/>
            <a:ext cx="179505" cy="150508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 txBox="1"/>
          <p:nvPr/>
        </p:nvSpPr>
        <p:spPr>
          <a:xfrm>
            <a:off x="1409573" y="2405990"/>
            <a:ext cx="182957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28" dirty="0">
                <a:solidFill>
                  <a:srgbClr val="F2F2F2"/>
                </a:solidFill>
                <a:latin typeface="Calibri"/>
                <a:cs typeface="Calibri"/>
              </a:rPr>
              <a:t>(</a:t>
            </a:r>
            <a:r>
              <a:rPr sz="1178" b="1" spc="-23" dirty="0">
                <a:solidFill>
                  <a:srgbClr val="F2F2F2"/>
                </a:solidFill>
                <a:latin typeface="Calibri"/>
                <a:cs typeface="Calibri"/>
              </a:rPr>
              <a:t>ii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23" name="object 23"/>
          <p:cNvSpPr/>
          <p:nvPr/>
        </p:nvSpPr>
        <p:spPr>
          <a:xfrm>
            <a:off x="2397079" y="3532956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 txBox="1"/>
          <p:nvPr/>
        </p:nvSpPr>
        <p:spPr>
          <a:xfrm>
            <a:off x="2386148" y="3526123"/>
            <a:ext cx="180655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25" name="object 25"/>
          <p:cNvSpPr/>
          <p:nvPr/>
        </p:nvSpPr>
        <p:spPr>
          <a:xfrm>
            <a:off x="2777722" y="2327974"/>
            <a:ext cx="1295195" cy="1295195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3750842" y="3516272"/>
            <a:ext cx="309531" cy="0"/>
          </a:xfrm>
          <a:custGeom>
            <a:avLst/>
            <a:gdLst/>
            <a:ahLst/>
            <a:cxnLst/>
            <a:rect l="l" t="t" r="r" b="b"/>
            <a:pathLst>
              <a:path w="341629">
                <a:moveTo>
                  <a:pt x="0" y="0"/>
                </a:moveTo>
                <a:lnTo>
                  <a:pt x="341466" y="0"/>
                </a:lnTo>
              </a:path>
            </a:pathLst>
          </a:custGeom>
          <a:ln w="1651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2825129" y="2399315"/>
            <a:ext cx="175362" cy="150508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 txBox="1"/>
          <p:nvPr/>
        </p:nvSpPr>
        <p:spPr>
          <a:xfrm>
            <a:off x="2814197" y="2394942"/>
            <a:ext cx="181806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33" dirty="0">
                <a:solidFill>
                  <a:srgbClr val="F2F2F2"/>
                </a:solidFill>
                <a:latin typeface="Calibri"/>
                <a:cs typeface="Calibri"/>
              </a:rPr>
              <a:t>(v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29" name="object 29"/>
          <p:cNvSpPr/>
          <p:nvPr/>
        </p:nvSpPr>
        <p:spPr>
          <a:xfrm>
            <a:off x="3827594" y="3532956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 txBox="1"/>
          <p:nvPr/>
        </p:nvSpPr>
        <p:spPr>
          <a:xfrm>
            <a:off x="3816892" y="3526123"/>
            <a:ext cx="180655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31" name="object 31"/>
          <p:cNvSpPr/>
          <p:nvPr/>
        </p:nvSpPr>
        <p:spPr>
          <a:xfrm>
            <a:off x="1355492" y="3749053"/>
            <a:ext cx="1296575" cy="1295195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2334828" y="4951158"/>
            <a:ext cx="310680" cy="0"/>
          </a:xfrm>
          <a:custGeom>
            <a:avLst/>
            <a:gdLst/>
            <a:ahLst/>
            <a:cxnLst/>
            <a:rect l="l" t="t" r="r" b="b"/>
            <a:pathLst>
              <a:path w="342900">
                <a:moveTo>
                  <a:pt x="0" y="0"/>
                </a:moveTo>
                <a:lnTo>
                  <a:pt x="342795" y="0"/>
                </a:lnTo>
              </a:path>
            </a:pathLst>
          </a:custGeom>
          <a:ln w="1651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1429132" y="3824306"/>
            <a:ext cx="215406" cy="149126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 txBox="1"/>
          <p:nvPr/>
        </p:nvSpPr>
        <p:spPr>
          <a:xfrm>
            <a:off x="1417859" y="3820279"/>
            <a:ext cx="223229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14" dirty="0">
                <a:solidFill>
                  <a:srgbClr val="F2F2F2"/>
                </a:solidFill>
                <a:latin typeface="Calibri"/>
                <a:cs typeface="Calibri"/>
              </a:rPr>
              <a:t>(iii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35" name="object 35"/>
          <p:cNvSpPr/>
          <p:nvPr/>
        </p:nvSpPr>
        <p:spPr>
          <a:xfrm>
            <a:off x="2412267" y="4967614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 txBox="1"/>
          <p:nvPr/>
        </p:nvSpPr>
        <p:spPr>
          <a:xfrm>
            <a:off x="2401337" y="4961009"/>
            <a:ext cx="180655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37" name="object 37"/>
          <p:cNvSpPr/>
          <p:nvPr/>
        </p:nvSpPr>
        <p:spPr>
          <a:xfrm>
            <a:off x="2774268" y="3747212"/>
            <a:ext cx="1295080" cy="1295080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/>
          <p:nvPr/>
        </p:nvSpPr>
        <p:spPr>
          <a:xfrm>
            <a:off x="3752455" y="4952280"/>
            <a:ext cx="310680" cy="0"/>
          </a:xfrm>
          <a:custGeom>
            <a:avLst/>
            <a:gdLst/>
            <a:ahLst/>
            <a:cxnLst/>
            <a:rect l="l" t="t" r="r" b="b"/>
            <a:pathLst>
              <a:path w="342900">
                <a:moveTo>
                  <a:pt x="0" y="0"/>
                </a:moveTo>
                <a:lnTo>
                  <a:pt x="342389" y="0"/>
                </a:lnTo>
              </a:path>
            </a:pathLst>
          </a:custGeom>
          <a:ln w="15557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9" name="object 39"/>
          <p:cNvSpPr/>
          <p:nvPr/>
        </p:nvSpPr>
        <p:spPr>
          <a:xfrm>
            <a:off x="2803036" y="3792548"/>
            <a:ext cx="214025" cy="149127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 txBox="1"/>
          <p:nvPr/>
        </p:nvSpPr>
        <p:spPr>
          <a:xfrm>
            <a:off x="2792103" y="3788521"/>
            <a:ext cx="216326" cy="18126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178" b="1" spc="-33" dirty="0">
                <a:solidFill>
                  <a:srgbClr val="F2F2F2"/>
                </a:solidFill>
                <a:latin typeface="Calibri"/>
                <a:cs typeface="Calibri"/>
              </a:rPr>
              <a:t>(v</a:t>
            </a:r>
            <a:r>
              <a:rPr sz="1178" b="1" spc="-23" dirty="0">
                <a:solidFill>
                  <a:srgbClr val="F2F2F2"/>
                </a:solidFill>
                <a:latin typeface="Calibri"/>
                <a:cs typeface="Calibri"/>
              </a:rPr>
              <a:t>i</a:t>
            </a:r>
            <a:r>
              <a:rPr sz="1178" b="1" spc="-5" dirty="0">
                <a:solidFill>
                  <a:srgbClr val="F2F2F2"/>
                </a:solidFill>
                <a:latin typeface="Calibri"/>
                <a:cs typeface="Calibri"/>
              </a:rPr>
              <a:t>)</a:t>
            </a:r>
            <a:endParaRPr sz="1178">
              <a:latin typeface="Calibri"/>
              <a:cs typeface="Calibri"/>
            </a:endParaRPr>
          </a:p>
        </p:txBody>
      </p:sp>
      <p:sp>
        <p:nvSpPr>
          <p:cNvPr id="41" name="object 41"/>
          <p:cNvSpPr/>
          <p:nvPr/>
        </p:nvSpPr>
        <p:spPr>
          <a:xfrm>
            <a:off x="3828973" y="4970375"/>
            <a:ext cx="175362" cy="6351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 txBox="1"/>
          <p:nvPr/>
        </p:nvSpPr>
        <p:spPr>
          <a:xfrm>
            <a:off x="3818273" y="4962390"/>
            <a:ext cx="182381" cy="696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453" b="1" spc="-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453" b="1" dirty="0">
                <a:solidFill>
                  <a:srgbClr val="FFFFFF"/>
                </a:solidFill>
                <a:latin typeface="Arial"/>
                <a:cs typeface="Arial"/>
              </a:rPr>
              <a:t>0</a:t>
            </a:r>
            <a:r>
              <a:rPr sz="453" b="1" spc="9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453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453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1155850" y="2869819"/>
            <a:ext cx="188193" cy="32046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1223" b="1" spc="-36" dirty="0">
                <a:latin typeface="Calibri"/>
                <a:cs typeface="Calibri"/>
              </a:rPr>
              <a:t>EB</a:t>
            </a:r>
            <a:r>
              <a:rPr sz="1223" b="1" spc="-41" dirty="0">
                <a:latin typeface="Calibri"/>
                <a:cs typeface="Calibri"/>
              </a:rPr>
              <a:t>S</a:t>
            </a:r>
            <a:r>
              <a:rPr sz="1223" b="1" dirty="0">
                <a:latin typeface="Calibri"/>
                <a:cs typeface="Calibri"/>
              </a:rPr>
              <a:t>S</a:t>
            </a:r>
            <a:endParaRPr sz="1223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57384" y="745682"/>
            <a:ext cx="153615" cy="27193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767" dirty="0">
                <a:latin typeface="Calibri"/>
                <a:cs typeface="Calibri"/>
              </a:rPr>
              <a:t>A</a:t>
            </a:r>
            <a:endParaRPr sz="1767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220405" y="860638"/>
            <a:ext cx="150163" cy="1603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42" spc="-23" dirty="0">
                <a:latin typeface="Calibri"/>
                <a:cs typeface="Calibri"/>
              </a:rPr>
              <a:t>T0</a:t>
            </a:r>
            <a:endParaRPr sz="1042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949519" y="860638"/>
            <a:ext cx="168573" cy="16036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42" spc="-18" dirty="0">
                <a:latin typeface="Calibri"/>
                <a:cs typeface="Calibri"/>
              </a:rPr>
              <a:t>2H</a:t>
            </a:r>
            <a:endParaRPr sz="1042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4041963" y="1922712"/>
            <a:ext cx="69616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b="1" spc="9" dirty="0">
                <a:latin typeface="Arial"/>
                <a:cs typeface="Arial"/>
              </a:rPr>
              <a:t>3</a:t>
            </a:r>
            <a:endParaRPr sz="634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6085899" y="1998248"/>
            <a:ext cx="482131" cy="32573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>
              <a:lnSpc>
                <a:spcPct val="156200"/>
              </a:lnSpc>
            </a:pPr>
            <a:r>
              <a:rPr sz="725" spc="-5" dirty="0">
                <a:latin typeface="Arial"/>
                <a:cs typeface="Arial"/>
              </a:rPr>
              <a:t>WT</a:t>
            </a:r>
            <a:r>
              <a:rPr sz="725" spc="-5" dirty="0">
                <a:latin typeface="Times New Roman"/>
                <a:cs typeface="Times New Roman"/>
              </a:rPr>
              <a:t> </a:t>
            </a:r>
            <a:r>
              <a:rPr sz="725" spc="-18" dirty="0">
                <a:latin typeface="Arial"/>
                <a:cs typeface="Arial"/>
              </a:rPr>
              <a:t>A</a:t>
            </a:r>
            <a:r>
              <a:rPr sz="725" spc="-36" dirty="0">
                <a:latin typeface="Arial"/>
                <a:cs typeface="Arial"/>
              </a:rPr>
              <a:t>T</a:t>
            </a:r>
            <a:r>
              <a:rPr sz="725" spc="-28" dirty="0">
                <a:latin typeface="Arial"/>
                <a:cs typeface="Arial"/>
              </a:rPr>
              <a:t>G16L</a:t>
            </a:r>
            <a:r>
              <a:rPr sz="725" spc="-23" dirty="0">
                <a:latin typeface="Arial"/>
                <a:cs typeface="Arial"/>
              </a:rPr>
              <a:t>1</a:t>
            </a:r>
            <a:r>
              <a:rPr sz="725" spc="-28" dirty="0">
                <a:latin typeface="Arial"/>
                <a:cs typeface="Arial"/>
              </a:rPr>
              <a:t>-</a:t>
            </a:r>
            <a:r>
              <a:rPr sz="725" dirty="0">
                <a:latin typeface="Arial"/>
                <a:cs typeface="Arial"/>
              </a:rPr>
              <a:t>/-</a:t>
            </a:r>
            <a:endParaRPr sz="725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4041963" y="2343858"/>
            <a:ext cx="69616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b="1" spc="9" dirty="0">
                <a:latin typeface="Arial"/>
                <a:cs typeface="Arial"/>
              </a:rPr>
              <a:t>2</a:t>
            </a:r>
            <a:endParaRPr sz="634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4044724" y="2713913"/>
            <a:ext cx="69616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b="1" spc="9" dirty="0">
                <a:latin typeface="Arial"/>
                <a:cs typeface="Arial"/>
              </a:rPr>
              <a:t>1</a:t>
            </a:r>
            <a:endParaRPr sz="634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4044724" y="3084314"/>
            <a:ext cx="69616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b="1" spc="9" dirty="0">
                <a:latin typeface="Arial"/>
                <a:cs typeface="Arial"/>
              </a:rPr>
              <a:t>0</a:t>
            </a:r>
            <a:endParaRPr sz="634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434497" y="4923127"/>
            <a:ext cx="5789602" cy="106772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33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3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3" dirty="0">
                <a:latin typeface="Times New Roman"/>
                <a:cs typeface="Times New Roman"/>
              </a:rPr>
              <a:t>r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8" dirty="0">
                <a:latin typeface="Times New Roman"/>
                <a:cs typeface="Times New Roman"/>
              </a:rPr>
              <a:t>qu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in</a:t>
            </a:r>
            <a:r>
              <a:rPr sz="1087" b="1" spc="14" dirty="0">
                <a:latin typeface="Times New Roman"/>
                <a:cs typeface="Times New Roman"/>
              </a:rPr>
              <a:t>d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ces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86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ysoso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s</a:t>
            </a:r>
            <a:r>
              <a:rPr sz="1087" b="1" spc="33" dirty="0">
                <a:latin typeface="Times New Roman"/>
                <a:cs typeface="Times New Roman"/>
              </a:rPr>
              <a:t>w</a:t>
            </a:r>
            <a:r>
              <a:rPr sz="1087" b="1" spc="14" dirty="0">
                <a:latin typeface="Times New Roman"/>
                <a:cs typeface="Times New Roman"/>
              </a:rPr>
              <a:t>elling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33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59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on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ro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91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WT)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At</a:t>
            </a:r>
            <a:r>
              <a:rPr sz="1087" spc="18" dirty="0">
                <a:latin typeface="Times New Roman"/>
                <a:cs typeface="Times New Roman"/>
              </a:rPr>
              <a:t>g1</a:t>
            </a:r>
            <a:r>
              <a:rPr sz="1087" spc="33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3" dirty="0">
                <a:latin typeface="Times New Roman"/>
                <a:cs typeface="Times New Roman"/>
              </a:rPr>
              <a:t>v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23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33" dirty="0">
                <a:latin typeface="Times New Roman"/>
                <a:cs typeface="Times New Roman"/>
              </a:rPr>
              <a:t>h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in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D</a:t>
            </a:r>
            <a:r>
              <a:rPr sz="1087" spc="28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x</a:t>
            </a:r>
            <a:r>
              <a:rPr sz="1087" spc="14" dirty="0">
                <a:latin typeface="Times New Roman"/>
                <a:cs typeface="Times New Roman"/>
              </a:rPr>
              <a:t>tran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dirty="0">
                <a:latin typeface="Times New Roman"/>
                <a:cs typeface="Times New Roman"/>
              </a:rPr>
              <a:t>   </a:t>
            </a:r>
            <a:r>
              <a:rPr sz="1087" spc="-13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3</a:t>
            </a:r>
            <a:r>
              <a:rPr sz="1087" spc="33" dirty="0">
                <a:latin typeface="Times New Roman"/>
                <a:cs typeface="Times New Roman"/>
              </a:rPr>
              <a:t>0</a:t>
            </a:r>
            <a:r>
              <a:rPr sz="1087" spc="28" dirty="0">
                <a:latin typeface="Times New Roman"/>
                <a:cs typeface="Times New Roman"/>
              </a:rPr>
              <a:t>0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µ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/ml)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3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23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e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cu</a:t>
            </a:r>
            <a:r>
              <a:rPr sz="1087" spc="33" dirty="0">
                <a:latin typeface="Times New Roman"/>
                <a:cs typeface="Times New Roman"/>
              </a:rPr>
              <a:t>b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urs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o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i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qu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spc="18" dirty="0">
                <a:latin typeface="Times New Roman"/>
                <a:cs typeface="Times New Roman"/>
              </a:rPr>
              <a:t>1</a:t>
            </a:r>
            <a:r>
              <a:rPr sz="1087" spc="33" dirty="0">
                <a:latin typeface="Times New Roman"/>
                <a:cs typeface="Times New Roman"/>
              </a:rPr>
              <a:t>0</a:t>
            </a:r>
            <a:r>
              <a:rPr sz="1087" spc="50" dirty="0">
                <a:latin typeface="Times New Roman"/>
                <a:cs typeface="Times New Roman"/>
              </a:rPr>
              <a:t>0</a:t>
            </a:r>
            <a:r>
              <a:rPr sz="1087" spc="33" dirty="0">
                <a:latin typeface="Agency FB"/>
                <a:cs typeface="Agency FB"/>
              </a:rPr>
              <a:t>m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fix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50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mi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osc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py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endParaRPr sz="1087" dirty="0">
              <a:latin typeface="Times New Roman"/>
              <a:cs typeface="Times New Roman"/>
            </a:endParaRPr>
          </a:p>
          <a:p>
            <a:pPr>
              <a:spcBef>
                <a:spcPts val="33"/>
              </a:spcBef>
            </a:pPr>
            <a:endParaRPr sz="861" dirty="0">
              <a:latin typeface="Times New Roman"/>
              <a:cs typeface="Times New Roman"/>
            </a:endParaRPr>
          </a:p>
          <a:p>
            <a:pPr marL="11506" algn="just"/>
            <a:r>
              <a:rPr sz="1087" b="1" spc="23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 </a:t>
            </a:r>
            <a:r>
              <a:rPr sz="1087" b="1" spc="18" dirty="0">
                <a:latin typeface="Times New Roman"/>
                <a:cs typeface="Times New Roman"/>
              </a:rPr>
              <a:t>B.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yso</a:t>
            </a:r>
            <a:r>
              <a:rPr sz="1087" spc="23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23" dirty="0">
                <a:latin typeface="Times New Roman"/>
                <a:cs typeface="Times New Roman"/>
              </a:rPr>
              <a:t>me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rea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µ</a:t>
            </a:r>
            <a:r>
              <a:rPr sz="1087" spc="36" dirty="0">
                <a:latin typeface="Times New Roman"/>
                <a:cs typeface="Times New Roman"/>
              </a:rPr>
              <a:t>m</a:t>
            </a:r>
            <a:r>
              <a:rPr sz="1631" spc="28" baseline="16203" dirty="0">
                <a:latin typeface="Times New Roman"/>
                <a:cs typeface="Times New Roman"/>
              </a:rPr>
              <a:t>2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w</a:t>
            </a:r>
            <a:r>
              <a:rPr sz="1087" spc="14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s d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rmin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b</a:t>
            </a:r>
            <a:r>
              <a:rPr sz="1087" spc="28" dirty="0">
                <a:latin typeface="Times New Roman"/>
                <a:cs typeface="Times New Roman"/>
              </a:rPr>
              <a:t>y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9" dirty="0">
                <a:latin typeface="Times New Roman"/>
                <a:cs typeface="Times New Roman"/>
              </a:rPr>
              <a:t>i</a:t>
            </a:r>
            <a:r>
              <a:rPr sz="1087" spc="5" dirty="0">
                <a:latin typeface="Times New Roman"/>
                <a:cs typeface="Times New Roman"/>
              </a:rPr>
              <a:t>j</a:t>
            </a:r>
            <a:r>
              <a:rPr sz="1087" spc="9" dirty="0">
                <a:latin typeface="Times New Roman"/>
                <a:cs typeface="Times New Roman"/>
              </a:rPr>
              <a:t>i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b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5</a:t>
            </a:r>
            <a:r>
              <a:rPr sz="1087" spc="33" dirty="0">
                <a:latin typeface="Symbol"/>
                <a:cs typeface="Symbol"/>
              </a:rPr>
              <a:t></a:t>
            </a:r>
            <a:r>
              <a:rPr sz="1087" spc="18" dirty="0">
                <a:latin typeface="Times New Roman"/>
                <a:cs typeface="Times New Roman"/>
              </a:rPr>
              <a:t>m.</a:t>
            </a:r>
            <a:endParaRPr sz="1087" dirty="0">
              <a:latin typeface="Times New Roman"/>
              <a:cs typeface="Times New Roman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5909848" y="2015506"/>
            <a:ext cx="134214" cy="7531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" name="object 12"/>
          <p:cNvSpPr/>
          <p:nvPr/>
        </p:nvSpPr>
        <p:spPr>
          <a:xfrm>
            <a:off x="5909848" y="2186096"/>
            <a:ext cx="134064" cy="77094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4842138" y="5211709"/>
            <a:ext cx="82272" cy="38393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640348" y="2666961"/>
            <a:ext cx="1532118" cy="1532118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2215617" y="2666961"/>
            <a:ext cx="1532118" cy="1532118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2308706" y="3972053"/>
            <a:ext cx="233356" cy="109084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/>
          <p:nvPr/>
        </p:nvSpPr>
        <p:spPr>
          <a:xfrm>
            <a:off x="2313080" y="3993687"/>
            <a:ext cx="47177" cy="66739"/>
          </a:xfrm>
          <a:custGeom>
            <a:avLst/>
            <a:gdLst/>
            <a:ahLst/>
            <a:cxnLst/>
            <a:rect l="l" t="t" r="r" b="b"/>
            <a:pathLst>
              <a:path w="52069" h="73660">
                <a:moveTo>
                  <a:pt x="14605" y="51943"/>
                </a:moveTo>
                <a:lnTo>
                  <a:pt x="0" y="53340"/>
                </a:lnTo>
                <a:lnTo>
                  <a:pt x="762" y="59436"/>
                </a:lnTo>
                <a:lnTo>
                  <a:pt x="3429" y="64262"/>
                </a:lnTo>
                <a:lnTo>
                  <a:pt x="8001" y="67945"/>
                </a:lnTo>
                <a:lnTo>
                  <a:pt x="12446" y="71628"/>
                </a:lnTo>
                <a:lnTo>
                  <a:pt x="18161" y="73406"/>
                </a:lnTo>
                <a:lnTo>
                  <a:pt x="34163" y="73406"/>
                </a:lnTo>
                <a:lnTo>
                  <a:pt x="41021" y="70104"/>
                </a:lnTo>
                <a:lnTo>
                  <a:pt x="46101" y="63754"/>
                </a:lnTo>
                <a:lnTo>
                  <a:pt x="47360" y="62103"/>
                </a:lnTo>
                <a:lnTo>
                  <a:pt x="22733" y="62103"/>
                </a:lnTo>
                <a:lnTo>
                  <a:pt x="20320" y="61214"/>
                </a:lnTo>
                <a:lnTo>
                  <a:pt x="18288" y="59436"/>
                </a:lnTo>
                <a:lnTo>
                  <a:pt x="16256" y="57531"/>
                </a:lnTo>
                <a:lnTo>
                  <a:pt x="14986" y="54991"/>
                </a:lnTo>
                <a:lnTo>
                  <a:pt x="14605" y="51943"/>
                </a:lnTo>
                <a:close/>
              </a:path>
              <a:path w="52069" h="73660">
                <a:moveTo>
                  <a:pt x="49149" y="34417"/>
                </a:moveTo>
                <a:lnTo>
                  <a:pt x="28448" y="34417"/>
                </a:lnTo>
                <a:lnTo>
                  <a:pt x="31115" y="35560"/>
                </a:lnTo>
                <a:lnTo>
                  <a:pt x="33274" y="37719"/>
                </a:lnTo>
                <a:lnTo>
                  <a:pt x="35433" y="40005"/>
                </a:lnTo>
                <a:lnTo>
                  <a:pt x="36449" y="43307"/>
                </a:lnTo>
                <a:lnTo>
                  <a:pt x="36449" y="52705"/>
                </a:lnTo>
                <a:lnTo>
                  <a:pt x="35306" y="56261"/>
                </a:lnTo>
                <a:lnTo>
                  <a:pt x="31115" y="60960"/>
                </a:lnTo>
                <a:lnTo>
                  <a:pt x="28448" y="62103"/>
                </a:lnTo>
                <a:lnTo>
                  <a:pt x="47360" y="62103"/>
                </a:lnTo>
                <a:lnTo>
                  <a:pt x="49784" y="58928"/>
                </a:lnTo>
                <a:lnTo>
                  <a:pt x="51562" y="53594"/>
                </a:lnTo>
                <a:lnTo>
                  <a:pt x="51562" y="40386"/>
                </a:lnTo>
                <a:lnTo>
                  <a:pt x="49276" y="34544"/>
                </a:lnTo>
                <a:lnTo>
                  <a:pt x="49149" y="34417"/>
                </a:lnTo>
                <a:close/>
              </a:path>
              <a:path w="52069" h="73660">
                <a:moveTo>
                  <a:pt x="48133" y="0"/>
                </a:moveTo>
                <a:lnTo>
                  <a:pt x="9271" y="0"/>
                </a:lnTo>
                <a:lnTo>
                  <a:pt x="1778" y="38100"/>
                </a:lnTo>
                <a:lnTo>
                  <a:pt x="13716" y="39751"/>
                </a:lnTo>
                <a:lnTo>
                  <a:pt x="17018" y="36195"/>
                </a:lnTo>
                <a:lnTo>
                  <a:pt x="20828" y="34417"/>
                </a:lnTo>
                <a:lnTo>
                  <a:pt x="49149" y="34417"/>
                </a:lnTo>
                <a:lnTo>
                  <a:pt x="40259" y="25527"/>
                </a:lnTo>
                <a:lnTo>
                  <a:pt x="18161" y="25527"/>
                </a:lnTo>
                <a:lnTo>
                  <a:pt x="20447" y="13208"/>
                </a:lnTo>
                <a:lnTo>
                  <a:pt x="48133" y="13208"/>
                </a:lnTo>
                <a:lnTo>
                  <a:pt x="48133" y="0"/>
                </a:lnTo>
                <a:close/>
              </a:path>
              <a:path w="52069" h="73660">
                <a:moveTo>
                  <a:pt x="34671" y="23241"/>
                </a:moveTo>
                <a:lnTo>
                  <a:pt x="24765" y="23241"/>
                </a:lnTo>
                <a:lnTo>
                  <a:pt x="21336" y="24003"/>
                </a:lnTo>
                <a:lnTo>
                  <a:pt x="18161" y="25527"/>
                </a:lnTo>
                <a:lnTo>
                  <a:pt x="40259" y="25527"/>
                </a:lnTo>
                <a:lnTo>
                  <a:pt x="34671" y="2324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/>
          <p:nvPr/>
        </p:nvSpPr>
        <p:spPr>
          <a:xfrm>
            <a:off x="2392706" y="4010025"/>
            <a:ext cx="127724" cy="67890"/>
          </a:xfrm>
          <a:custGeom>
            <a:avLst/>
            <a:gdLst/>
            <a:ahLst/>
            <a:cxnLst/>
            <a:rect l="l" t="t" r="r" b="b"/>
            <a:pathLst>
              <a:path w="140969" h="74929">
                <a:moveTo>
                  <a:pt x="14605" y="1143"/>
                </a:moveTo>
                <a:lnTo>
                  <a:pt x="0" y="1143"/>
                </a:lnTo>
                <a:lnTo>
                  <a:pt x="0" y="74422"/>
                </a:lnTo>
                <a:lnTo>
                  <a:pt x="14605" y="74422"/>
                </a:lnTo>
                <a:lnTo>
                  <a:pt x="14605" y="47752"/>
                </a:lnTo>
                <a:lnTo>
                  <a:pt x="50546" y="47752"/>
                </a:lnTo>
                <a:lnTo>
                  <a:pt x="50546" y="44069"/>
                </a:lnTo>
                <a:lnTo>
                  <a:pt x="21336" y="44069"/>
                </a:lnTo>
                <a:lnTo>
                  <a:pt x="18669" y="42418"/>
                </a:lnTo>
                <a:lnTo>
                  <a:pt x="16764" y="39243"/>
                </a:lnTo>
                <a:lnTo>
                  <a:pt x="15367" y="36703"/>
                </a:lnTo>
                <a:lnTo>
                  <a:pt x="14605" y="32004"/>
                </a:lnTo>
                <a:lnTo>
                  <a:pt x="14605" y="1143"/>
                </a:lnTo>
                <a:close/>
              </a:path>
              <a:path w="140969" h="74929">
                <a:moveTo>
                  <a:pt x="36830" y="47752"/>
                </a:moveTo>
                <a:lnTo>
                  <a:pt x="14605" y="47752"/>
                </a:lnTo>
                <a:lnTo>
                  <a:pt x="16256" y="50546"/>
                </a:lnTo>
                <a:lnTo>
                  <a:pt x="17653" y="52451"/>
                </a:lnTo>
                <a:lnTo>
                  <a:pt x="19050" y="53467"/>
                </a:lnTo>
                <a:lnTo>
                  <a:pt x="20955" y="54737"/>
                </a:lnTo>
                <a:lnTo>
                  <a:pt x="23241" y="55372"/>
                </a:lnTo>
                <a:lnTo>
                  <a:pt x="27051" y="55372"/>
                </a:lnTo>
                <a:lnTo>
                  <a:pt x="36830" y="47752"/>
                </a:lnTo>
                <a:close/>
              </a:path>
              <a:path w="140969" h="74929">
                <a:moveTo>
                  <a:pt x="50546" y="47752"/>
                </a:moveTo>
                <a:lnTo>
                  <a:pt x="36830" y="47752"/>
                </a:lnTo>
                <a:lnTo>
                  <a:pt x="36830" y="54102"/>
                </a:lnTo>
                <a:lnTo>
                  <a:pt x="50546" y="54102"/>
                </a:lnTo>
                <a:lnTo>
                  <a:pt x="50546" y="47752"/>
                </a:lnTo>
                <a:close/>
              </a:path>
              <a:path w="140969" h="74929">
                <a:moveTo>
                  <a:pt x="50546" y="1143"/>
                </a:moveTo>
                <a:lnTo>
                  <a:pt x="35687" y="1143"/>
                </a:lnTo>
                <a:lnTo>
                  <a:pt x="35687" y="31115"/>
                </a:lnTo>
                <a:lnTo>
                  <a:pt x="35306" y="35179"/>
                </a:lnTo>
                <a:lnTo>
                  <a:pt x="34417" y="37338"/>
                </a:lnTo>
                <a:lnTo>
                  <a:pt x="33528" y="39370"/>
                </a:lnTo>
                <a:lnTo>
                  <a:pt x="32258" y="41148"/>
                </a:lnTo>
                <a:lnTo>
                  <a:pt x="30480" y="42291"/>
                </a:lnTo>
                <a:lnTo>
                  <a:pt x="28829" y="43434"/>
                </a:lnTo>
                <a:lnTo>
                  <a:pt x="26924" y="44069"/>
                </a:lnTo>
                <a:lnTo>
                  <a:pt x="50546" y="44069"/>
                </a:lnTo>
                <a:lnTo>
                  <a:pt x="50546" y="1143"/>
                </a:lnTo>
                <a:close/>
              </a:path>
              <a:path w="140969" h="74929">
                <a:moveTo>
                  <a:pt x="72263" y="1143"/>
                </a:moveTo>
                <a:lnTo>
                  <a:pt x="58674" y="1143"/>
                </a:lnTo>
                <a:lnTo>
                  <a:pt x="58674" y="54102"/>
                </a:lnTo>
                <a:lnTo>
                  <a:pt x="73406" y="54102"/>
                </a:lnTo>
                <a:lnTo>
                  <a:pt x="73406" y="23241"/>
                </a:lnTo>
                <a:lnTo>
                  <a:pt x="73787" y="19685"/>
                </a:lnTo>
                <a:lnTo>
                  <a:pt x="74549" y="17399"/>
                </a:lnTo>
                <a:lnTo>
                  <a:pt x="75311" y="15240"/>
                </a:lnTo>
                <a:lnTo>
                  <a:pt x="76581" y="13589"/>
                </a:lnTo>
                <a:lnTo>
                  <a:pt x="78486" y="12446"/>
                </a:lnTo>
                <a:lnTo>
                  <a:pt x="80264" y="11303"/>
                </a:lnTo>
                <a:lnTo>
                  <a:pt x="82296" y="10668"/>
                </a:lnTo>
                <a:lnTo>
                  <a:pt x="139558" y="10668"/>
                </a:lnTo>
                <a:lnTo>
                  <a:pt x="138938" y="9271"/>
                </a:lnTo>
                <a:lnTo>
                  <a:pt x="138530" y="8382"/>
                </a:lnTo>
                <a:lnTo>
                  <a:pt x="72263" y="8382"/>
                </a:lnTo>
                <a:lnTo>
                  <a:pt x="72263" y="1143"/>
                </a:lnTo>
                <a:close/>
              </a:path>
              <a:path w="140969" h="74929">
                <a:moveTo>
                  <a:pt x="115824" y="10668"/>
                </a:moveTo>
                <a:lnTo>
                  <a:pt x="86487" y="10668"/>
                </a:lnTo>
                <a:lnTo>
                  <a:pt x="88011" y="11049"/>
                </a:lnTo>
                <a:lnTo>
                  <a:pt x="89027" y="11811"/>
                </a:lnTo>
                <a:lnTo>
                  <a:pt x="90170" y="12446"/>
                </a:lnTo>
                <a:lnTo>
                  <a:pt x="90932" y="13589"/>
                </a:lnTo>
                <a:lnTo>
                  <a:pt x="91440" y="15113"/>
                </a:lnTo>
                <a:lnTo>
                  <a:pt x="92075" y="16637"/>
                </a:lnTo>
                <a:lnTo>
                  <a:pt x="92329" y="19939"/>
                </a:lnTo>
                <a:lnTo>
                  <a:pt x="92329" y="54102"/>
                </a:lnTo>
                <a:lnTo>
                  <a:pt x="106934" y="54102"/>
                </a:lnTo>
                <a:lnTo>
                  <a:pt x="106934" y="23749"/>
                </a:lnTo>
                <a:lnTo>
                  <a:pt x="107442" y="20066"/>
                </a:lnTo>
                <a:lnTo>
                  <a:pt x="108204" y="17780"/>
                </a:lnTo>
                <a:lnTo>
                  <a:pt x="108966" y="15367"/>
                </a:lnTo>
                <a:lnTo>
                  <a:pt x="110363" y="13716"/>
                </a:lnTo>
                <a:lnTo>
                  <a:pt x="112141" y="12446"/>
                </a:lnTo>
                <a:lnTo>
                  <a:pt x="113919" y="11303"/>
                </a:lnTo>
                <a:lnTo>
                  <a:pt x="115824" y="10668"/>
                </a:lnTo>
                <a:close/>
              </a:path>
              <a:path w="140969" h="74929">
                <a:moveTo>
                  <a:pt x="139558" y="10668"/>
                </a:moveTo>
                <a:lnTo>
                  <a:pt x="120777" y="10668"/>
                </a:lnTo>
                <a:lnTo>
                  <a:pt x="122809" y="11684"/>
                </a:lnTo>
                <a:lnTo>
                  <a:pt x="124206" y="13716"/>
                </a:lnTo>
                <a:lnTo>
                  <a:pt x="125222" y="15240"/>
                </a:lnTo>
                <a:lnTo>
                  <a:pt x="125730" y="18542"/>
                </a:lnTo>
                <a:lnTo>
                  <a:pt x="125730" y="54102"/>
                </a:lnTo>
                <a:lnTo>
                  <a:pt x="140462" y="54102"/>
                </a:lnTo>
                <a:lnTo>
                  <a:pt x="140462" y="15240"/>
                </a:lnTo>
                <a:lnTo>
                  <a:pt x="139954" y="11557"/>
                </a:lnTo>
                <a:lnTo>
                  <a:pt x="139558" y="10668"/>
                </a:lnTo>
                <a:close/>
              </a:path>
              <a:path w="140969" h="74929">
                <a:moveTo>
                  <a:pt x="93091" y="0"/>
                </a:moveTo>
                <a:lnTo>
                  <a:pt x="82804" y="0"/>
                </a:lnTo>
                <a:lnTo>
                  <a:pt x="77089" y="2794"/>
                </a:lnTo>
                <a:lnTo>
                  <a:pt x="72263" y="8382"/>
                </a:lnTo>
                <a:lnTo>
                  <a:pt x="105283" y="8382"/>
                </a:lnTo>
                <a:lnTo>
                  <a:pt x="103632" y="5588"/>
                </a:lnTo>
                <a:lnTo>
                  <a:pt x="101473" y="3429"/>
                </a:lnTo>
                <a:lnTo>
                  <a:pt x="96139" y="635"/>
                </a:lnTo>
                <a:lnTo>
                  <a:pt x="93091" y="0"/>
                </a:lnTo>
                <a:close/>
              </a:path>
              <a:path w="140969" h="74929">
                <a:moveTo>
                  <a:pt x="126365" y="0"/>
                </a:moveTo>
                <a:lnTo>
                  <a:pt x="118999" y="0"/>
                </a:lnTo>
                <a:lnTo>
                  <a:pt x="115951" y="635"/>
                </a:lnTo>
                <a:lnTo>
                  <a:pt x="110363" y="3429"/>
                </a:lnTo>
                <a:lnTo>
                  <a:pt x="107696" y="5588"/>
                </a:lnTo>
                <a:lnTo>
                  <a:pt x="105283" y="8382"/>
                </a:lnTo>
                <a:lnTo>
                  <a:pt x="138530" y="8382"/>
                </a:lnTo>
                <a:lnTo>
                  <a:pt x="126365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/>
          <p:nvPr/>
        </p:nvSpPr>
        <p:spPr>
          <a:xfrm>
            <a:off x="2308707" y="4073541"/>
            <a:ext cx="215751" cy="0"/>
          </a:xfrm>
          <a:custGeom>
            <a:avLst/>
            <a:gdLst/>
            <a:ahLst/>
            <a:cxnLst/>
            <a:rect l="l" t="t" r="r" b="b"/>
            <a:pathLst>
              <a:path w="238125">
                <a:moveTo>
                  <a:pt x="0" y="0"/>
                </a:moveTo>
                <a:lnTo>
                  <a:pt x="237747" y="0"/>
                </a:lnTo>
              </a:path>
            </a:pathLst>
          </a:custGeom>
          <a:ln w="11936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2215618" y="1030593"/>
            <a:ext cx="1532694" cy="1532694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630567" y="1030590"/>
            <a:ext cx="1532118" cy="1532118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/>
          <p:nvPr/>
        </p:nvSpPr>
        <p:spPr>
          <a:xfrm>
            <a:off x="730445" y="1106881"/>
            <a:ext cx="422526" cy="124272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 txBox="1"/>
          <p:nvPr/>
        </p:nvSpPr>
        <p:spPr>
          <a:xfrm>
            <a:off x="719215" y="1103890"/>
            <a:ext cx="3427273" cy="66229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51" b="1" spc="-9" dirty="0">
                <a:solidFill>
                  <a:srgbClr val="BF0000"/>
                </a:solidFill>
                <a:latin typeface="Calibri"/>
                <a:cs typeface="Calibri"/>
              </a:rPr>
              <a:t>D</a:t>
            </a:r>
            <a:r>
              <a:rPr sz="951" b="1" spc="-18" dirty="0">
                <a:solidFill>
                  <a:srgbClr val="BF0000"/>
                </a:solidFill>
                <a:latin typeface="Calibri"/>
                <a:cs typeface="Calibri"/>
              </a:rPr>
              <a:t>ex</a:t>
            </a:r>
            <a:r>
              <a:rPr sz="951" b="1" spc="-9" dirty="0">
                <a:solidFill>
                  <a:srgbClr val="BF0000"/>
                </a:solidFill>
                <a:latin typeface="Calibri"/>
                <a:cs typeface="Calibri"/>
              </a:rPr>
              <a:t>t</a:t>
            </a:r>
            <a:r>
              <a:rPr sz="951" b="1" spc="-18" dirty="0">
                <a:solidFill>
                  <a:srgbClr val="BF0000"/>
                </a:solidFill>
                <a:latin typeface="Calibri"/>
                <a:cs typeface="Calibri"/>
              </a:rPr>
              <a:t>ra</a:t>
            </a:r>
            <a:r>
              <a:rPr sz="951" b="1" dirty="0">
                <a:solidFill>
                  <a:srgbClr val="BF0000"/>
                </a:solidFill>
                <a:latin typeface="Calibri"/>
                <a:cs typeface="Calibri"/>
              </a:rPr>
              <a:t>n</a:t>
            </a:r>
            <a:endParaRPr sz="951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6">
              <a:latin typeface="Times New Roman"/>
              <a:cs typeface="Times New Roman"/>
            </a:endParaRPr>
          </a:p>
          <a:p>
            <a:pPr>
              <a:spcBef>
                <a:spcPts val="35"/>
              </a:spcBef>
            </a:pPr>
            <a:endParaRPr sz="680">
              <a:latin typeface="Times New Roman"/>
              <a:cs typeface="Times New Roman"/>
            </a:endParaRPr>
          </a:p>
          <a:p>
            <a:pPr marR="4602" algn="r"/>
            <a:r>
              <a:rPr sz="1767" dirty="0">
                <a:latin typeface="Calibri"/>
                <a:cs typeface="Calibri"/>
              </a:rPr>
              <a:t>B</a:t>
            </a:r>
            <a:endParaRPr sz="1767">
              <a:latin typeface="Calibri"/>
              <a:cs typeface="Calibri"/>
            </a:endParaRPr>
          </a:p>
        </p:txBody>
      </p:sp>
      <p:sp>
        <p:nvSpPr>
          <p:cNvPr id="24" name="object 24"/>
          <p:cNvSpPr/>
          <p:nvPr/>
        </p:nvSpPr>
        <p:spPr>
          <a:xfrm>
            <a:off x="734589" y="2391030"/>
            <a:ext cx="198836" cy="96656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731249" y="2417727"/>
            <a:ext cx="177896" cy="66394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4208465" y="2894339"/>
            <a:ext cx="277887" cy="196189"/>
          </a:xfrm>
          <a:custGeom>
            <a:avLst/>
            <a:gdLst/>
            <a:ahLst/>
            <a:cxnLst/>
            <a:rect l="l" t="t" r="r" b="b"/>
            <a:pathLst>
              <a:path w="306704" h="216535">
                <a:moveTo>
                  <a:pt x="0" y="216405"/>
                </a:moveTo>
                <a:lnTo>
                  <a:pt x="306327" y="216405"/>
                </a:lnTo>
                <a:lnTo>
                  <a:pt x="306327" y="0"/>
                </a:lnTo>
                <a:lnTo>
                  <a:pt x="0" y="0"/>
                </a:lnTo>
                <a:lnTo>
                  <a:pt x="0" y="216405"/>
                </a:lnTo>
                <a:close/>
              </a:path>
            </a:pathLst>
          </a:custGeom>
          <a:solidFill>
            <a:srgbClr val="A0A0A3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4200411" y="3079016"/>
            <a:ext cx="16685" cy="16685"/>
          </a:xfrm>
          <a:custGeom>
            <a:avLst/>
            <a:gdLst/>
            <a:ahLst/>
            <a:cxnLst/>
            <a:rect l="l" t="t" r="r" b="b"/>
            <a:pathLst>
              <a:path w="18414" h="18414">
                <a:moveTo>
                  <a:pt x="9144" y="0"/>
                </a:moveTo>
                <a:lnTo>
                  <a:pt x="2667" y="2667"/>
                </a:lnTo>
                <a:lnTo>
                  <a:pt x="0" y="9144"/>
                </a:lnTo>
                <a:lnTo>
                  <a:pt x="2667" y="15621"/>
                </a:lnTo>
                <a:lnTo>
                  <a:pt x="9144" y="18415"/>
                </a:lnTo>
                <a:lnTo>
                  <a:pt x="15621" y="15621"/>
                </a:lnTo>
                <a:lnTo>
                  <a:pt x="18288" y="9144"/>
                </a:lnTo>
                <a:lnTo>
                  <a:pt x="15621" y="2667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4208695" y="2894220"/>
            <a:ext cx="0" cy="193312"/>
          </a:xfrm>
          <a:custGeom>
            <a:avLst/>
            <a:gdLst/>
            <a:ahLst/>
            <a:cxnLst/>
            <a:rect l="l" t="t" r="r" b="b"/>
            <a:pathLst>
              <a:path h="213360">
                <a:moveTo>
                  <a:pt x="0" y="213106"/>
                </a:moveTo>
                <a:lnTo>
                  <a:pt x="0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/>
          <p:nvPr/>
        </p:nvSpPr>
        <p:spPr>
          <a:xfrm>
            <a:off x="4208695" y="2894218"/>
            <a:ext cx="276736" cy="0"/>
          </a:xfrm>
          <a:custGeom>
            <a:avLst/>
            <a:gdLst/>
            <a:ahLst/>
            <a:cxnLst/>
            <a:rect l="l" t="t" r="r" b="b"/>
            <a:pathLst>
              <a:path w="305435">
                <a:moveTo>
                  <a:pt x="0" y="0"/>
                </a:moveTo>
                <a:lnTo>
                  <a:pt x="305054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/>
          <p:nvPr/>
        </p:nvSpPr>
        <p:spPr>
          <a:xfrm>
            <a:off x="4485085" y="2894220"/>
            <a:ext cx="0" cy="193312"/>
          </a:xfrm>
          <a:custGeom>
            <a:avLst/>
            <a:gdLst/>
            <a:ahLst/>
            <a:cxnLst/>
            <a:rect l="l" t="t" r="r" b="b"/>
            <a:pathLst>
              <a:path h="213360">
                <a:moveTo>
                  <a:pt x="0" y="0"/>
                </a:moveTo>
                <a:lnTo>
                  <a:pt x="0" y="213106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" name="object 31"/>
          <p:cNvSpPr/>
          <p:nvPr/>
        </p:nvSpPr>
        <p:spPr>
          <a:xfrm>
            <a:off x="4278080" y="2874737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74" y="0"/>
                </a:lnTo>
              </a:path>
            </a:pathLst>
          </a:custGeom>
          <a:ln w="1963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4347349" y="2874772"/>
            <a:ext cx="0" cy="39124"/>
          </a:xfrm>
          <a:custGeom>
            <a:avLst/>
            <a:gdLst/>
            <a:ahLst/>
            <a:cxnLst/>
            <a:rect l="l" t="t" r="r" b="b"/>
            <a:pathLst>
              <a:path h="43180">
                <a:moveTo>
                  <a:pt x="0" y="0"/>
                </a:moveTo>
                <a:lnTo>
                  <a:pt x="0" y="42926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4278080" y="2913629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74" y="0"/>
                </a:lnTo>
              </a:path>
            </a:pathLst>
          </a:custGeom>
          <a:ln w="1963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/>
          <p:nvPr/>
        </p:nvSpPr>
        <p:spPr>
          <a:xfrm>
            <a:off x="4616379" y="3079016"/>
            <a:ext cx="16685" cy="16685"/>
          </a:xfrm>
          <a:custGeom>
            <a:avLst/>
            <a:gdLst/>
            <a:ahLst/>
            <a:cxnLst/>
            <a:rect l="l" t="t" r="r" b="b"/>
            <a:pathLst>
              <a:path w="18414" h="18414">
                <a:moveTo>
                  <a:pt x="9271" y="0"/>
                </a:moveTo>
                <a:lnTo>
                  <a:pt x="2794" y="2667"/>
                </a:lnTo>
                <a:lnTo>
                  <a:pt x="0" y="9144"/>
                </a:lnTo>
                <a:lnTo>
                  <a:pt x="2794" y="15621"/>
                </a:lnTo>
                <a:lnTo>
                  <a:pt x="9271" y="18415"/>
                </a:lnTo>
                <a:lnTo>
                  <a:pt x="15748" y="15621"/>
                </a:lnTo>
                <a:lnTo>
                  <a:pt x="18415" y="9144"/>
                </a:lnTo>
                <a:lnTo>
                  <a:pt x="15748" y="2667"/>
                </a:lnTo>
                <a:lnTo>
                  <a:pt x="927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5" name="object 35"/>
          <p:cNvSpPr/>
          <p:nvPr/>
        </p:nvSpPr>
        <p:spPr>
          <a:xfrm>
            <a:off x="4624777" y="2951522"/>
            <a:ext cx="0" cy="135779"/>
          </a:xfrm>
          <a:custGeom>
            <a:avLst/>
            <a:gdLst/>
            <a:ahLst/>
            <a:cxnLst/>
            <a:rect l="l" t="t" r="r" b="b"/>
            <a:pathLst>
              <a:path h="149860">
                <a:moveTo>
                  <a:pt x="0" y="149860"/>
                </a:moveTo>
                <a:lnTo>
                  <a:pt x="0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/>
          <p:nvPr/>
        </p:nvSpPr>
        <p:spPr>
          <a:xfrm>
            <a:off x="4624778" y="2951522"/>
            <a:ext cx="276736" cy="0"/>
          </a:xfrm>
          <a:custGeom>
            <a:avLst/>
            <a:gdLst/>
            <a:ahLst/>
            <a:cxnLst/>
            <a:rect l="l" t="t" r="r" b="b"/>
            <a:pathLst>
              <a:path w="305435">
                <a:moveTo>
                  <a:pt x="0" y="0"/>
                </a:moveTo>
                <a:lnTo>
                  <a:pt x="305181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7" name="object 37"/>
          <p:cNvSpPr/>
          <p:nvPr/>
        </p:nvSpPr>
        <p:spPr>
          <a:xfrm>
            <a:off x="4901284" y="2951522"/>
            <a:ext cx="0" cy="135779"/>
          </a:xfrm>
          <a:custGeom>
            <a:avLst/>
            <a:gdLst/>
            <a:ahLst/>
            <a:cxnLst/>
            <a:rect l="l" t="t" r="r" b="b"/>
            <a:pathLst>
              <a:path h="149860">
                <a:moveTo>
                  <a:pt x="0" y="0"/>
                </a:moveTo>
                <a:lnTo>
                  <a:pt x="0" y="14986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/>
          <p:nvPr/>
        </p:nvSpPr>
        <p:spPr>
          <a:xfrm>
            <a:off x="4694163" y="2951482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74" y="0"/>
                </a:lnTo>
              </a:path>
            </a:pathLst>
          </a:custGeom>
          <a:ln w="41997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9" name="object 39"/>
          <p:cNvSpPr/>
          <p:nvPr/>
        </p:nvSpPr>
        <p:spPr>
          <a:xfrm>
            <a:off x="4755111" y="2951465"/>
            <a:ext cx="16685" cy="0"/>
          </a:xfrm>
          <a:custGeom>
            <a:avLst/>
            <a:gdLst/>
            <a:ahLst/>
            <a:cxnLst/>
            <a:rect l="l" t="t" r="r" b="b"/>
            <a:pathLst>
              <a:path w="18414">
                <a:moveTo>
                  <a:pt x="0" y="0"/>
                </a:moveTo>
                <a:lnTo>
                  <a:pt x="18373" y="0"/>
                </a:lnTo>
              </a:path>
            </a:pathLst>
          </a:custGeom>
          <a:ln w="2247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/>
          <p:nvPr/>
        </p:nvSpPr>
        <p:spPr>
          <a:xfrm>
            <a:off x="5041091" y="2192886"/>
            <a:ext cx="277887" cy="897523"/>
          </a:xfrm>
          <a:custGeom>
            <a:avLst/>
            <a:gdLst/>
            <a:ahLst/>
            <a:cxnLst/>
            <a:rect l="l" t="t" r="r" b="b"/>
            <a:pathLst>
              <a:path w="306704" h="990600">
                <a:moveTo>
                  <a:pt x="0" y="990600"/>
                </a:moveTo>
                <a:lnTo>
                  <a:pt x="306322" y="990600"/>
                </a:lnTo>
                <a:lnTo>
                  <a:pt x="306322" y="0"/>
                </a:lnTo>
                <a:lnTo>
                  <a:pt x="0" y="0"/>
                </a:lnTo>
                <a:lnTo>
                  <a:pt x="0" y="990600"/>
                </a:lnTo>
                <a:close/>
              </a:path>
            </a:pathLst>
          </a:custGeom>
          <a:solidFill>
            <a:srgbClr val="A0A0A3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1" name="object 41"/>
          <p:cNvSpPr/>
          <p:nvPr/>
        </p:nvSpPr>
        <p:spPr>
          <a:xfrm>
            <a:off x="5032576" y="3079016"/>
            <a:ext cx="16685" cy="16685"/>
          </a:xfrm>
          <a:custGeom>
            <a:avLst/>
            <a:gdLst/>
            <a:ahLst/>
            <a:cxnLst/>
            <a:rect l="l" t="t" r="r" b="b"/>
            <a:pathLst>
              <a:path w="18414" h="18414">
                <a:moveTo>
                  <a:pt x="9144" y="0"/>
                </a:moveTo>
                <a:lnTo>
                  <a:pt x="2667" y="2667"/>
                </a:lnTo>
                <a:lnTo>
                  <a:pt x="0" y="9144"/>
                </a:lnTo>
                <a:lnTo>
                  <a:pt x="2667" y="15621"/>
                </a:lnTo>
                <a:lnTo>
                  <a:pt x="9144" y="18415"/>
                </a:lnTo>
                <a:lnTo>
                  <a:pt x="15621" y="15621"/>
                </a:lnTo>
                <a:lnTo>
                  <a:pt x="18415" y="9144"/>
                </a:lnTo>
                <a:lnTo>
                  <a:pt x="15621" y="2667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5040860" y="2192887"/>
            <a:ext cx="0" cy="894646"/>
          </a:xfrm>
          <a:custGeom>
            <a:avLst/>
            <a:gdLst/>
            <a:ahLst/>
            <a:cxnLst/>
            <a:rect l="l" t="t" r="r" b="b"/>
            <a:pathLst>
              <a:path h="987425">
                <a:moveTo>
                  <a:pt x="0" y="987171"/>
                </a:moveTo>
                <a:lnTo>
                  <a:pt x="0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/>
          <p:nvPr/>
        </p:nvSpPr>
        <p:spPr>
          <a:xfrm>
            <a:off x="5040861" y="2192884"/>
            <a:ext cx="276736" cy="0"/>
          </a:xfrm>
          <a:custGeom>
            <a:avLst/>
            <a:gdLst/>
            <a:ahLst/>
            <a:cxnLst/>
            <a:rect l="l" t="t" r="r" b="b"/>
            <a:pathLst>
              <a:path w="305435">
                <a:moveTo>
                  <a:pt x="0" y="0"/>
                </a:moveTo>
                <a:lnTo>
                  <a:pt x="305054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4" name="object 44"/>
          <p:cNvSpPr/>
          <p:nvPr/>
        </p:nvSpPr>
        <p:spPr>
          <a:xfrm>
            <a:off x="5317251" y="2192887"/>
            <a:ext cx="0" cy="894646"/>
          </a:xfrm>
          <a:custGeom>
            <a:avLst/>
            <a:gdLst/>
            <a:ahLst/>
            <a:cxnLst/>
            <a:rect l="l" t="t" r="r" b="b"/>
            <a:pathLst>
              <a:path h="987425">
                <a:moveTo>
                  <a:pt x="0" y="0"/>
                </a:moveTo>
                <a:lnTo>
                  <a:pt x="0" y="987171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5" name="object 45"/>
          <p:cNvSpPr/>
          <p:nvPr/>
        </p:nvSpPr>
        <p:spPr>
          <a:xfrm>
            <a:off x="5110132" y="2142910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74" y="0"/>
                </a:lnTo>
              </a:path>
            </a:pathLst>
          </a:custGeom>
          <a:ln w="1963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6" name="object 46"/>
          <p:cNvSpPr/>
          <p:nvPr/>
        </p:nvSpPr>
        <p:spPr>
          <a:xfrm>
            <a:off x="5179516" y="2142946"/>
            <a:ext cx="0" cy="98958"/>
          </a:xfrm>
          <a:custGeom>
            <a:avLst/>
            <a:gdLst/>
            <a:ahLst/>
            <a:cxnLst/>
            <a:rect l="l" t="t" r="r" b="b"/>
            <a:pathLst>
              <a:path h="109219">
                <a:moveTo>
                  <a:pt x="0" y="0"/>
                </a:moveTo>
                <a:lnTo>
                  <a:pt x="0" y="109093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7" name="object 47"/>
          <p:cNvSpPr/>
          <p:nvPr/>
        </p:nvSpPr>
        <p:spPr>
          <a:xfrm>
            <a:off x="5110132" y="2241748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74" y="0"/>
                </a:lnTo>
              </a:path>
            </a:pathLst>
          </a:custGeom>
          <a:ln w="1964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8" name="object 48"/>
          <p:cNvSpPr/>
          <p:nvPr/>
        </p:nvSpPr>
        <p:spPr>
          <a:xfrm>
            <a:off x="5448659" y="3079016"/>
            <a:ext cx="16685" cy="16685"/>
          </a:xfrm>
          <a:custGeom>
            <a:avLst/>
            <a:gdLst/>
            <a:ahLst/>
            <a:cxnLst/>
            <a:rect l="l" t="t" r="r" b="b"/>
            <a:pathLst>
              <a:path w="18414" h="18414">
                <a:moveTo>
                  <a:pt x="9144" y="0"/>
                </a:moveTo>
                <a:lnTo>
                  <a:pt x="2667" y="2667"/>
                </a:lnTo>
                <a:lnTo>
                  <a:pt x="0" y="9144"/>
                </a:lnTo>
                <a:lnTo>
                  <a:pt x="2667" y="15621"/>
                </a:lnTo>
                <a:lnTo>
                  <a:pt x="9144" y="18415"/>
                </a:lnTo>
                <a:lnTo>
                  <a:pt x="15621" y="15621"/>
                </a:lnTo>
                <a:lnTo>
                  <a:pt x="18288" y="9144"/>
                </a:lnTo>
                <a:lnTo>
                  <a:pt x="15621" y="2667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9" name="object 49"/>
          <p:cNvSpPr/>
          <p:nvPr/>
        </p:nvSpPr>
        <p:spPr>
          <a:xfrm>
            <a:off x="5456942" y="2292649"/>
            <a:ext cx="0" cy="795113"/>
          </a:xfrm>
          <a:custGeom>
            <a:avLst/>
            <a:gdLst/>
            <a:ahLst/>
            <a:cxnLst/>
            <a:rect l="l" t="t" r="r" b="b"/>
            <a:pathLst>
              <a:path h="877570">
                <a:moveTo>
                  <a:pt x="0" y="877062"/>
                </a:moveTo>
                <a:lnTo>
                  <a:pt x="0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0" name="object 50"/>
          <p:cNvSpPr/>
          <p:nvPr/>
        </p:nvSpPr>
        <p:spPr>
          <a:xfrm>
            <a:off x="5456943" y="2292647"/>
            <a:ext cx="276736" cy="0"/>
          </a:xfrm>
          <a:custGeom>
            <a:avLst/>
            <a:gdLst/>
            <a:ahLst/>
            <a:cxnLst/>
            <a:rect l="l" t="t" r="r" b="b"/>
            <a:pathLst>
              <a:path w="305435">
                <a:moveTo>
                  <a:pt x="0" y="0"/>
                </a:moveTo>
                <a:lnTo>
                  <a:pt x="305054" y="0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1" name="object 51"/>
          <p:cNvSpPr/>
          <p:nvPr/>
        </p:nvSpPr>
        <p:spPr>
          <a:xfrm>
            <a:off x="5733334" y="2292649"/>
            <a:ext cx="0" cy="795113"/>
          </a:xfrm>
          <a:custGeom>
            <a:avLst/>
            <a:gdLst/>
            <a:ahLst/>
            <a:cxnLst/>
            <a:rect l="l" t="t" r="r" b="b"/>
            <a:pathLst>
              <a:path h="877570">
                <a:moveTo>
                  <a:pt x="0" y="0"/>
                </a:moveTo>
                <a:lnTo>
                  <a:pt x="0" y="877062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2" name="object 52"/>
          <p:cNvSpPr/>
          <p:nvPr/>
        </p:nvSpPr>
        <p:spPr>
          <a:xfrm>
            <a:off x="5526213" y="2216786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69" y="0"/>
                </a:lnTo>
              </a:path>
            </a:pathLst>
          </a:custGeom>
          <a:ln w="1963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3" name="object 53"/>
          <p:cNvSpPr/>
          <p:nvPr/>
        </p:nvSpPr>
        <p:spPr>
          <a:xfrm>
            <a:off x="5595600" y="2216818"/>
            <a:ext cx="0" cy="151889"/>
          </a:xfrm>
          <a:custGeom>
            <a:avLst/>
            <a:gdLst/>
            <a:ahLst/>
            <a:cxnLst/>
            <a:rect l="l" t="t" r="r" b="b"/>
            <a:pathLst>
              <a:path h="167639">
                <a:moveTo>
                  <a:pt x="0" y="0"/>
                </a:moveTo>
                <a:lnTo>
                  <a:pt x="0" y="167259"/>
                </a:lnTo>
              </a:path>
            </a:pathLst>
          </a:custGeom>
          <a:ln w="18373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4" name="object 54"/>
          <p:cNvSpPr/>
          <p:nvPr/>
        </p:nvSpPr>
        <p:spPr>
          <a:xfrm>
            <a:off x="5526213" y="2368325"/>
            <a:ext cx="139231" cy="0"/>
          </a:xfrm>
          <a:custGeom>
            <a:avLst/>
            <a:gdLst/>
            <a:ahLst/>
            <a:cxnLst/>
            <a:rect l="l" t="t" r="r" b="b"/>
            <a:pathLst>
              <a:path w="153670">
                <a:moveTo>
                  <a:pt x="0" y="0"/>
                </a:moveTo>
                <a:lnTo>
                  <a:pt x="153069" y="0"/>
                </a:lnTo>
              </a:path>
            </a:pathLst>
          </a:custGeom>
          <a:ln w="1963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5" name="object 55"/>
          <p:cNvSpPr/>
          <p:nvPr/>
        </p:nvSpPr>
        <p:spPr>
          <a:xfrm>
            <a:off x="4107897" y="3090983"/>
            <a:ext cx="1696089" cy="0"/>
          </a:xfrm>
          <a:custGeom>
            <a:avLst/>
            <a:gdLst/>
            <a:ahLst/>
            <a:cxnLst/>
            <a:rect l="l" t="t" r="r" b="b"/>
            <a:pathLst>
              <a:path w="1871979">
                <a:moveTo>
                  <a:pt x="0" y="0"/>
                </a:moveTo>
                <a:lnTo>
                  <a:pt x="1871599" y="0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6" name="object 56"/>
          <p:cNvSpPr/>
          <p:nvPr/>
        </p:nvSpPr>
        <p:spPr>
          <a:xfrm>
            <a:off x="4347349" y="3090985"/>
            <a:ext cx="0" cy="31643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671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7" name="object 57"/>
          <p:cNvSpPr/>
          <p:nvPr/>
        </p:nvSpPr>
        <p:spPr>
          <a:xfrm>
            <a:off x="4763433" y="3090985"/>
            <a:ext cx="0" cy="31643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671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8" name="object 58"/>
          <p:cNvSpPr/>
          <p:nvPr/>
        </p:nvSpPr>
        <p:spPr>
          <a:xfrm>
            <a:off x="5179516" y="3090985"/>
            <a:ext cx="0" cy="31643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671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9" name="object 59"/>
          <p:cNvSpPr/>
          <p:nvPr/>
        </p:nvSpPr>
        <p:spPr>
          <a:xfrm>
            <a:off x="5595600" y="3090985"/>
            <a:ext cx="0" cy="31643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0"/>
                </a:moveTo>
                <a:lnTo>
                  <a:pt x="0" y="34671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0" name="object 60"/>
          <p:cNvSpPr/>
          <p:nvPr/>
        </p:nvSpPr>
        <p:spPr>
          <a:xfrm>
            <a:off x="4139309" y="1982197"/>
            <a:ext cx="0" cy="1109247"/>
          </a:xfrm>
          <a:custGeom>
            <a:avLst/>
            <a:gdLst/>
            <a:ahLst/>
            <a:cxnLst/>
            <a:rect l="l" t="t" r="r" b="b"/>
            <a:pathLst>
              <a:path h="1224279">
                <a:moveTo>
                  <a:pt x="0" y="1223772"/>
                </a:moveTo>
                <a:lnTo>
                  <a:pt x="0" y="0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1" name="object 61"/>
          <p:cNvSpPr/>
          <p:nvPr/>
        </p:nvSpPr>
        <p:spPr>
          <a:xfrm>
            <a:off x="4107899" y="2721386"/>
            <a:ext cx="31643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671" y="0"/>
                </a:moveTo>
                <a:lnTo>
                  <a:pt x="0" y="0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2" name="object 62"/>
          <p:cNvSpPr/>
          <p:nvPr/>
        </p:nvSpPr>
        <p:spPr>
          <a:xfrm>
            <a:off x="4107899" y="2351792"/>
            <a:ext cx="31643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671" y="0"/>
                </a:moveTo>
                <a:lnTo>
                  <a:pt x="0" y="0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3" name="object 63"/>
          <p:cNvSpPr/>
          <p:nvPr/>
        </p:nvSpPr>
        <p:spPr>
          <a:xfrm>
            <a:off x="4107899" y="1982196"/>
            <a:ext cx="31643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34671" y="0"/>
                </a:moveTo>
                <a:lnTo>
                  <a:pt x="0" y="0"/>
                </a:lnTo>
              </a:path>
            </a:pathLst>
          </a:custGeom>
          <a:ln w="12249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4" name="object 64"/>
          <p:cNvSpPr txBox="1"/>
          <p:nvPr/>
        </p:nvSpPr>
        <p:spPr>
          <a:xfrm>
            <a:off x="401355" y="1621930"/>
            <a:ext cx="146322" cy="185832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951" b="1" spc="-33" dirty="0">
                <a:latin typeface="Calibri"/>
                <a:cs typeface="Calibri"/>
              </a:rPr>
              <a:t>WT</a:t>
            </a:r>
            <a:endParaRPr sz="951">
              <a:latin typeface="Calibri"/>
              <a:cs typeface="Calibri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433115" y="3087153"/>
            <a:ext cx="146322" cy="58511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951" b="1" spc="-18" dirty="0">
                <a:latin typeface="Calibri"/>
                <a:cs typeface="Calibri"/>
              </a:rPr>
              <a:t>A</a:t>
            </a:r>
            <a:r>
              <a:rPr sz="951" b="1" spc="-9" dirty="0">
                <a:latin typeface="Calibri"/>
                <a:cs typeface="Calibri"/>
              </a:rPr>
              <a:t>T</a:t>
            </a:r>
            <a:r>
              <a:rPr sz="951" b="1" spc="-14" dirty="0">
                <a:latin typeface="Calibri"/>
                <a:cs typeface="Calibri"/>
              </a:rPr>
              <a:t>G</a:t>
            </a:r>
            <a:r>
              <a:rPr sz="951" b="1" spc="-9" dirty="0">
                <a:latin typeface="Calibri"/>
                <a:cs typeface="Calibri"/>
              </a:rPr>
              <a:t>16</a:t>
            </a:r>
            <a:r>
              <a:rPr sz="951" b="1" spc="-28" dirty="0">
                <a:latin typeface="Calibri"/>
                <a:cs typeface="Calibri"/>
              </a:rPr>
              <a:t>L</a:t>
            </a:r>
            <a:r>
              <a:rPr sz="951" b="1" spc="-9" dirty="0">
                <a:latin typeface="Calibri"/>
                <a:cs typeface="Calibri"/>
              </a:rPr>
              <a:t>1</a:t>
            </a:r>
            <a:r>
              <a:rPr sz="951" b="1" spc="-14" dirty="0">
                <a:latin typeface="Calibri"/>
                <a:cs typeface="Calibri"/>
              </a:rPr>
              <a:t>-</a:t>
            </a:r>
            <a:r>
              <a:rPr sz="951" b="1" spc="-9" dirty="0">
                <a:latin typeface="Calibri"/>
                <a:cs typeface="Calibri"/>
              </a:rPr>
              <a:t>/</a:t>
            </a:r>
            <a:r>
              <a:rPr sz="951" b="1" dirty="0">
                <a:latin typeface="Calibri"/>
                <a:cs typeface="Calibri"/>
              </a:rPr>
              <a:t>-</a:t>
            </a:r>
            <a:endParaRPr sz="951">
              <a:latin typeface="Calibri"/>
              <a:cs typeface="Calibri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3915908" y="2237190"/>
            <a:ext cx="111569" cy="6092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725" b="1" spc="-5" dirty="0">
                <a:latin typeface="Arial"/>
                <a:cs typeface="Arial"/>
              </a:rPr>
              <a:t>Dextra</a:t>
            </a:r>
            <a:r>
              <a:rPr sz="725" b="1" dirty="0">
                <a:latin typeface="Arial"/>
                <a:cs typeface="Arial"/>
              </a:rPr>
              <a:t>m</a:t>
            </a:r>
            <a:r>
              <a:rPr sz="725" b="1" spc="-14" dirty="0">
                <a:latin typeface="Times New Roman"/>
                <a:cs typeface="Times New Roman"/>
              </a:rPr>
              <a:t> </a:t>
            </a:r>
            <a:r>
              <a:rPr sz="725" b="1" spc="-28" dirty="0">
                <a:latin typeface="Arial"/>
                <a:cs typeface="Arial"/>
              </a:rPr>
              <a:t>A</a:t>
            </a:r>
            <a:r>
              <a:rPr sz="725" b="1" spc="-23" dirty="0">
                <a:latin typeface="Arial"/>
                <a:cs typeface="Arial"/>
              </a:rPr>
              <a:t>r</a:t>
            </a:r>
            <a:r>
              <a:rPr sz="725" b="1" spc="-28" dirty="0">
                <a:latin typeface="Arial"/>
                <a:cs typeface="Arial"/>
              </a:rPr>
              <a:t>e</a:t>
            </a:r>
            <a:r>
              <a:rPr sz="725" b="1" dirty="0">
                <a:latin typeface="Arial"/>
                <a:cs typeface="Arial"/>
              </a:rPr>
              <a:t>a</a:t>
            </a:r>
            <a:endParaRPr sz="725">
              <a:latin typeface="Arial"/>
              <a:cs typeface="Arial"/>
            </a:endParaRPr>
          </a:p>
        </p:txBody>
      </p:sp>
      <p:sp>
        <p:nvSpPr>
          <p:cNvPr id="67" name="object 67"/>
          <p:cNvSpPr/>
          <p:nvPr/>
        </p:nvSpPr>
        <p:spPr>
          <a:xfrm>
            <a:off x="4251201" y="3200177"/>
            <a:ext cx="128881" cy="12888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8" name="object 68"/>
          <p:cNvSpPr/>
          <p:nvPr/>
        </p:nvSpPr>
        <p:spPr>
          <a:xfrm>
            <a:off x="4268301" y="3232287"/>
            <a:ext cx="90903" cy="75944"/>
          </a:xfrm>
          <a:custGeom>
            <a:avLst/>
            <a:gdLst/>
            <a:ahLst/>
            <a:cxnLst/>
            <a:rect l="l" t="t" r="r" b="b"/>
            <a:pathLst>
              <a:path w="100329" h="83820">
                <a:moveTo>
                  <a:pt x="15367" y="25527"/>
                </a:moveTo>
                <a:lnTo>
                  <a:pt x="10541" y="27432"/>
                </a:lnTo>
                <a:lnTo>
                  <a:pt x="6096" y="31750"/>
                </a:lnTo>
                <a:lnTo>
                  <a:pt x="1778" y="36068"/>
                </a:lnTo>
                <a:lnTo>
                  <a:pt x="0" y="41021"/>
                </a:lnTo>
                <a:lnTo>
                  <a:pt x="837" y="47810"/>
                </a:lnTo>
                <a:lnTo>
                  <a:pt x="26528" y="79113"/>
                </a:lnTo>
                <a:lnTo>
                  <a:pt x="42291" y="83566"/>
                </a:lnTo>
                <a:lnTo>
                  <a:pt x="47498" y="81788"/>
                </a:lnTo>
                <a:lnTo>
                  <a:pt x="56134" y="73152"/>
                </a:lnTo>
                <a:lnTo>
                  <a:pt x="56475" y="72263"/>
                </a:lnTo>
                <a:lnTo>
                  <a:pt x="39497" y="72263"/>
                </a:lnTo>
                <a:lnTo>
                  <a:pt x="37592" y="71628"/>
                </a:lnTo>
                <a:lnTo>
                  <a:pt x="11303" y="44069"/>
                </a:lnTo>
                <a:lnTo>
                  <a:pt x="11430" y="42672"/>
                </a:lnTo>
                <a:lnTo>
                  <a:pt x="18542" y="36957"/>
                </a:lnTo>
                <a:lnTo>
                  <a:pt x="39844" y="36957"/>
                </a:lnTo>
                <a:lnTo>
                  <a:pt x="31046" y="29938"/>
                </a:lnTo>
                <a:lnTo>
                  <a:pt x="20955" y="26162"/>
                </a:lnTo>
                <a:lnTo>
                  <a:pt x="15367" y="25527"/>
                </a:lnTo>
                <a:close/>
              </a:path>
              <a:path w="100329" h="83820">
                <a:moveTo>
                  <a:pt x="39844" y="36957"/>
                </a:moveTo>
                <a:lnTo>
                  <a:pt x="18542" y="36957"/>
                </a:lnTo>
                <a:lnTo>
                  <a:pt x="20447" y="37592"/>
                </a:lnTo>
                <a:lnTo>
                  <a:pt x="22987" y="38989"/>
                </a:lnTo>
                <a:lnTo>
                  <a:pt x="44831" y="61087"/>
                </a:lnTo>
                <a:lnTo>
                  <a:pt x="46101" y="63246"/>
                </a:lnTo>
                <a:lnTo>
                  <a:pt x="46609" y="65024"/>
                </a:lnTo>
                <a:lnTo>
                  <a:pt x="46355" y="68072"/>
                </a:lnTo>
                <a:lnTo>
                  <a:pt x="45720" y="69215"/>
                </a:lnTo>
                <a:lnTo>
                  <a:pt x="44704" y="70358"/>
                </a:lnTo>
                <a:lnTo>
                  <a:pt x="43688" y="71374"/>
                </a:lnTo>
                <a:lnTo>
                  <a:pt x="42418" y="72009"/>
                </a:lnTo>
                <a:lnTo>
                  <a:pt x="39497" y="72263"/>
                </a:lnTo>
                <a:lnTo>
                  <a:pt x="56475" y="72263"/>
                </a:lnTo>
                <a:lnTo>
                  <a:pt x="58039" y="68199"/>
                </a:lnTo>
                <a:lnTo>
                  <a:pt x="57083" y="60845"/>
                </a:lnTo>
                <a:lnTo>
                  <a:pt x="52476" y="50847"/>
                </a:lnTo>
                <a:lnTo>
                  <a:pt x="42438" y="39026"/>
                </a:lnTo>
                <a:lnTo>
                  <a:pt x="39844" y="36957"/>
                </a:lnTo>
                <a:close/>
              </a:path>
              <a:path w="100329" h="83820">
                <a:moveTo>
                  <a:pt x="34544" y="3683"/>
                </a:moveTo>
                <a:lnTo>
                  <a:pt x="25908" y="12319"/>
                </a:lnTo>
                <a:lnTo>
                  <a:pt x="70739" y="57023"/>
                </a:lnTo>
                <a:lnTo>
                  <a:pt x="79248" y="48514"/>
                </a:lnTo>
                <a:lnTo>
                  <a:pt x="62992" y="32258"/>
                </a:lnTo>
                <a:lnTo>
                  <a:pt x="60325" y="29464"/>
                </a:lnTo>
                <a:lnTo>
                  <a:pt x="58547" y="27178"/>
                </a:lnTo>
                <a:lnTo>
                  <a:pt x="56769" y="23368"/>
                </a:lnTo>
                <a:lnTo>
                  <a:pt x="56515" y="21463"/>
                </a:lnTo>
                <a:lnTo>
                  <a:pt x="56877" y="20193"/>
                </a:lnTo>
                <a:lnTo>
                  <a:pt x="51054" y="20193"/>
                </a:lnTo>
                <a:lnTo>
                  <a:pt x="34544" y="3683"/>
                </a:lnTo>
                <a:close/>
              </a:path>
              <a:path w="100329" h="83820">
                <a:moveTo>
                  <a:pt x="84836" y="12192"/>
                </a:moveTo>
                <a:lnTo>
                  <a:pt x="65024" y="12192"/>
                </a:lnTo>
                <a:lnTo>
                  <a:pt x="66294" y="12446"/>
                </a:lnTo>
                <a:lnTo>
                  <a:pt x="67564" y="12954"/>
                </a:lnTo>
                <a:lnTo>
                  <a:pt x="68834" y="13589"/>
                </a:lnTo>
                <a:lnTo>
                  <a:pt x="71120" y="15621"/>
                </a:lnTo>
                <a:lnTo>
                  <a:pt x="74549" y="18923"/>
                </a:lnTo>
                <a:lnTo>
                  <a:pt x="91694" y="36068"/>
                </a:lnTo>
                <a:lnTo>
                  <a:pt x="100203" y="27559"/>
                </a:lnTo>
                <a:lnTo>
                  <a:pt x="84836" y="12192"/>
                </a:lnTo>
                <a:close/>
              </a:path>
              <a:path w="100329" h="83820">
                <a:moveTo>
                  <a:pt x="66929" y="0"/>
                </a:moveTo>
                <a:lnTo>
                  <a:pt x="50546" y="14224"/>
                </a:lnTo>
                <a:lnTo>
                  <a:pt x="51054" y="20193"/>
                </a:lnTo>
                <a:lnTo>
                  <a:pt x="56877" y="20193"/>
                </a:lnTo>
                <a:lnTo>
                  <a:pt x="57023" y="19685"/>
                </a:lnTo>
                <a:lnTo>
                  <a:pt x="57404" y="17907"/>
                </a:lnTo>
                <a:lnTo>
                  <a:pt x="58293" y="16256"/>
                </a:lnTo>
                <a:lnTo>
                  <a:pt x="60960" y="13589"/>
                </a:lnTo>
                <a:lnTo>
                  <a:pt x="62357" y="12827"/>
                </a:lnTo>
                <a:lnTo>
                  <a:pt x="63627" y="12573"/>
                </a:lnTo>
                <a:lnTo>
                  <a:pt x="65024" y="12192"/>
                </a:lnTo>
                <a:lnTo>
                  <a:pt x="84836" y="12192"/>
                </a:lnTo>
                <a:lnTo>
                  <a:pt x="81153" y="8509"/>
                </a:lnTo>
                <a:lnTo>
                  <a:pt x="78359" y="5588"/>
                </a:lnTo>
                <a:lnTo>
                  <a:pt x="75946" y="3556"/>
                </a:lnTo>
                <a:lnTo>
                  <a:pt x="74295" y="2540"/>
                </a:lnTo>
                <a:lnTo>
                  <a:pt x="72644" y="1397"/>
                </a:lnTo>
                <a:lnTo>
                  <a:pt x="70866" y="762"/>
                </a:lnTo>
                <a:lnTo>
                  <a:pt x="68834" y="381"/>
                </a:lnTo>
                <a:lnTo>
                  <a:pt x="6692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9" name="object 69"/>
          <p:cNvSpPr/>
          <p:nvPr/>
        </p:nvSpPr>
        <p:spPr>
          <a:xfrm>
            <a:off x="4665559" y="3199949"/>
            <a:ext cx="130832" cy="130834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0" name="object 70"/>
          <p:cNvSpPr/>
          <p:nvPr/>
        </p:nvSpPr>
        <p:spPr>
          <a:xfrm>
            <a:off x="4682657" y="3234128"/>
            <a:ext cx="90903" cy="75944"/>
          </a:xfrm>
          <a:custGeom>
            <a:avLst/>
            <a:gdLst/>
            <a:ahLst/>
            <a:cxnLst/>
            <a:rect l="l" t="t" r="r" b="b"/>
            <a:pathLst>
              <a:path w="100329" h="83820">
                <a:moveTo>
                  <a:pt x="15494" y="25527"/>
                </a:moveTo>
                <a:lnTo>
                  <a:pt x="10541" y="27305"/>
                </a:lnTo>
                <a:lnTo>
                  <a:pt x="6223" y="31623"/>
                </a:lnTo>
                <a:lnTo>
                  <a:pt x="1905" y="36068"/>
                </a:lnTo>
                <a:lnTo>
                  <a:pt x="0" y="40894"/>
                </a:lnTo>
                <a:lnTo>
                  <a:pt x="839" y="47719"/>
                </a:lnTo>
                <a:lnTo>
                  <a:pt x="26575" y="79039"/>
                </a:lnTo>
                <a:lnTo>
                  <a:pt x="42418" y="83566"/>
                </a:lnTo>
                <a:lnTo>
                  <a:pt x="47498" y="81661"/>
                </a:lnTo>
                <a:lnTo>
                  <a:pt x="51943" y="77343"/>
                </a:lnTo>
                <a:lnTo>
                  <a:pt x="56261" y="73025"/>
                </a:lnTo>
                <a:lnTo>
                  <a:pt x="56580" y="72136"/>
                </a:lnTo>
                <a:lnTo>
                  <a:pt x="39624" y="72136"/>
                </a:lnTo>
                <a:lnTo>
                  <a:pt x="37592" y="71501"/>
                </a:lnTo>
                <a:lnTo>
                  <a:pt x="35179" y="70104"/>
                </a:lnTo>
                <a:lnTo>
                  <a:pt x="32639" y="68707"/>
                </a:lnTo>
                <a:lnTo>
                  <a:pt x="28829" y="65405"/>
                </a:lnTo>
                <a:lnTo>
                  <a:pt x="18288" y="54864"/>
                </a:lnTo>
                <a:lnTo>
                  <a:pt x="14859" y="50800"/>
                </a:lnTo>
                <a:lnTo>
                  <a:pt x="11938" y="45847"/>
                </a:lnTo>
                <a:lnTo>
                  <a:pt x="11430" y="44069"/>
                </a:lnTo>
                <a:lnTo>
                  <a:pt x="11557" y="42545"/>
                </a:lnTo>
                <a:lnTo>
                  <a:pt x="17018" y="37084"/>
                </a:lnTo>
                <a:lnTo>
                  <a:pt x="18542" y="36830"/>
                </a:lnTo>
                <a:lnTo>
                  <a:pt x="39815" y="36830"/>
                </a:lnTo>
                <a:lnTo>
                  <a:pt x="31073" y="29894"/>
                </a:lnTo>
                <a:lnTo>
                  <a:pt x="20955" y="26162"/>
                </a:lnTo>
                <a:lnTo>
                  <a:pt x="15494" y="25527"/>
                </a:lnTo>
                <a:close/>
              </a:path>
              <a:path w="100329" h="83820">
                <a:moveTo>
                  <a:pt x="39815" y="36830"/>
                </a:moveTo>
                <a:lnTo>
                  <a:pt x="18542" y="36830"/>
                </a:lnTo>
                <a:lnTo>
                  <a:pt x="20574" y="37465"/>
                </a:lnTo>
                <a:lnTo>
                  <a:pt x="22987" y="38989"/>
                </a:lnTo>
                <a:lnTo>
                  <a:pt x="46736" y="65024"/>
                </a:lnTo>
                <a:lnTo>
                  <a:pt x="46609" y="66548"/>
                </a:lnTo>
                <a:lnTo>
                  <a:pt x="39624" y="72136"/>
                </a:lnTo>
                <a:lnTo>
                  <a:pt x="56580" y="72136"/>
                </a:lnTo>
                <a:lnTo>
                  <a:pt x="58039" y="68072"/>
                </a:lnTo>
                <a:lnTo>
                  <a:pt x="57098" y="60776"/>
                </a:lnTo>
                <a:lnTo>
                  <a:pt x="52559" y="50814"/>
                </a:lnTo>
                <a:lnTo>
                  <a:pt x="42499" y="38958"/>
                </a:lnTo>
                <a:lnTo>
                  <a:pt x="39815" y="36830"/>
                </a:lnTo>
                <a:close/>
              </a:path>
              <a:path w="100329" h="83820">
                <a:moveTo>
                  <a:pt x="34544" y="3683"/>
                </a:moveTo>
                <a:lnTo>
                  <a:pt x="26035" y="12192"/>
                </a:lnTo>
                <a:lnTo>
                  <a:pt x="70739" y="57023"/>
                </a:lnTo>
                <a:lnTo>
                  <a:pt x="79375" y="48387"/>
                </a:lnTo>
                <a:lnTo>
                  <a:pt x="63119" y="32131"/>
                </a:lnTo>
                <a:lnTo>
                  <a:pt x="60325" y="29464"/>
                </a:lnTo>
                <a:lnTo>
                  <a:pt x="58547" y="27051"/>
                </a:lnTo>
                <a:lnTo>
                  <a:pt x="56769" y="23241"/>
                </a:lnTo>
                <a:lnTo>
                  <a:pt x="56642" y="21463"/>
                </a:lnTo>
                <a:lnTo>
                  <a:pt x="56921" y="20066"/>
                </a:lnTo>
                <a:lnTo>
                  <a:pt x="51054" y="20066"/>
                </a:lnTo>
                <a:lnTo>
                  <a:pt x="34544" y="3683"/>
                </a:lnTo>
                <a:close/>
              </a:path>
              <a:path w="100329" h="83820">
                <a:moveTo>
                  <a:pt x="84987" y="12192"/>
                </a:moveTo>
                <a:lnTo>
                  <a:pt x="65024" y="12192"/>
                </a:lnTo>
                <a:lnTo>
                  <a:pt x="66421" y="12319"/>
                </a:lnTo>
                <a:lnTo>
                  <a:pt x="67564" y="12954"/>
                </a:lnTo>
                <a:lnTo>
                  <a:pt x="68834" y="13462"/>
                </a:lnTo>
                <a:lnTo>
                  <a:pt x="71247" y="15494"/>
                </a:lnTo>
                <a:lnTo>
                  <a:pt x="74549" y="18923"/>
                </a:lnTo>
                <a:lnTo>
                  <a:pt x="91694" y="36068"/>
                </a:lnTo>
                <a:lnTo>
                  <a:pt x="100330" y="27432"/>
                </a:lnTo>
                <a:lnTo>
                  <a:pt x="84987" y="12192"/>
                </a:lnTo>
                <a:close/>
              </a:path>
              <a:path w="100329" h="83820">
                <a:moveTo>
                  <a:pt x="67056" y="0"/>
                </a:moveTo>
                <a:lnTo>
                  <a:pt x="64897" y="254"/>
                </a:lnTo>
                <a:lnTo>
                  <a:pt x="62611" y="1143"/>
                </a:lnTo>
                <a:lnTo>
                  <a:pt x="60198" y="1905"/>
                </a:lnTo>
                <a:lnTo>
                  <a:pt x="58039" y="3302"/>
                </a:lnTo>
                <a:lnTo>
                  <a:pt x="56134" y="5334"/>
                </a:lnTo>
                <a:lnTo>
                  <a:pt x="52324" y="9144"/>
                </a:lnTo>
                <a:lnTo>
                  <a:pt x="50546" y="14097"/>
                </a:lnTo>
                <a:lnTo>
                  <a:pt x="51054" y="20066"/>
                </a:lnTo>
                <a:lnTo>
                  <a:pt x="56921" y="20066"/>
                </a:lnTo>
                <a:lnTo>
                  <a:pt x="57023" y="19558"/>
                </a:lnTo>
                <a:lnTo>
                  <a:pt x="57404" y="17780"/>
                </a:lnTo>
                <a:lnTo>
                  <a:pt x="58420" y="16129"/>
                </a:lnTo>
                <a:lnTo>
                  <a:pt x="61087" y="13462"/>
                </a:lnTo>
                <a:lnTo>
                  <a:pt x="62357" y="12700"/>
                </a:lnTo>
                <a:lnTo>
                  <a:pt x="63754" y="12446"/>
                </a:lnTo>
                <a:lnTo>
                  <a:pt x="65024" y="12192"/>
                </a:lnTo>
                <a:lnTo>
                  <a:pt x="84987" y="12192"/>
                </a:lnTo>
                <a:lnTo>
                  <a:pt x="78359" y="5588"/>
                </a:lnTo>
                <a:lnTo>
                  <a:pt x="68961" y="254"/>
                </a:lnTo>
                <a:lnTo>
                  <a:pt x="6705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1" name="object 71"/>
          <p:cNvSpPr/>
          <p:nvPr/>
        </p:nvSpPr>
        <p:spPr>
          <a:xfrm>
            <a:off x="5082562" y="3200928"/>
            <a:ext cx="129857" cy="129857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2" name="object 72"/>
          <p:cNvSpPr/>
          <p:nvPr/>
        </p:nvSpPr>
        <p:spPr>
          <a:xfrm>
            <a:off x="5098624" y="3234128"/>
            <a:ext cx="92054" cy="83999"/>
          </a:xfrm>
          <a:custGeom>
            <a:avLst/>
            <a:gdLst/>
            <a:ahLst/>
            <a:cxnLst/>
            <a:rect l="l" t="t" r="r" b="b"/>
            <a:pathLst>
              <a:path w="101600" h="92710">
                <a:moveTo>
                  <a:pt x="38817" y="36068"/>
                </a:moveTo>
                <a:lnTo>
                  <a:pt x="22352" y="36068"/>
                </a:lnTo>
                <a:lnTo>
                  <a:pt x="24384" y="36957"/>
                </a:lnTo>
                <a:lnTo>
                  <a:pt x="28067" y="40640"/>
                </a:lnTo>
                <a:lnTo>
                  <a:pt x="29210" y="42926"/>
                </a:lnTo>
                <a:lnTo>
                  <a:pt x="29718" y="45847"/>
                </a:lnTo>
                <a:lnTo>
                  <a:pt x="30226" y="48006"/>
                </a:lnTo>
                <a:lnTo>
                  <a:pt x="30226" y="52832"/>
                </a:lnTo>
                <a:lnTo>
                  <a:pt x="29972" y="60325"/>
                </a:lnTo>
                <a:lnTo>
                  <a:pt x="29591" y="69596"/>
                </a:lnTo>
                <a:lnTo>
                  <a:pt x="29972" y="76327"/>
                </a:lnTo>
                <a:lnTo>
                  <a:pt x="31115" y="80772"/>
                </a:lnTo>
                <a:lnTo>
                  <a:pt x="32131" y="85090"/>
                </a:lnTo>
                <a:lnTo>
                  <a:pt x="34036" y="88900"/>
                </a:lnTo>
                <a:lnTo>
                  <a:pt x="36703" y="92202"/>
                </a:lnTo>
                <a:lnTo>
                  <a:pt x="57658" y="71247"/>
                </a:lnTo>
                <a:lnTo>
                  <a:pt x="41783" y="71247"/>
                </a:lnTo>
                <a:lnTo>
                  <a:pt x="41402" y="69977"/>
                </a:lnTo>
                <a:lnTo>
                  <a:pt x="41275" y="68580"/>
                </a:lnTo>
                <a:lnTo>
                  <a:pt x="41021" y="65532"/>
                </a:lnTo>
                <a:lnTo>
                  <a:pt x="41148" y="62230"/>
                </a:lnTo>
                <a:lnTo>
                  <a:pt x="41275" y="57023"/>
                </a:lnTo>
                <a:lnTo>
                  <a:pt x="41529" y="51816"/>
                </a:lnTo>
                <a:lnTo>
                  <a:pt x="41529" y="48006"/>
                </a:lnTo>
                <a:lnTo>
                  <a:pt x="41275" y="45720"/>
                </a:lnTo>
                <a:lnTo>
                  <a:pt x="40767" y="42037"/>
                </a:lnTo>
                <a:lnTo>
                  <a:pt x="40005" y="38989"/>
                </a:lnTo>
                <a:lnTo>
                  <a:pt x="38989" y="36449"/>
                </a:lnTo>
                <a:lnTo>
                  <a:pt x="38817" y="36068"/>
                </a:lnTo>
                <a:close/>
              </a:path>
              <a:path w="101600" h="92710">
                <a:moveTo>
                  <a:pt x="58801" y="54229"/>
                </a:moveTo>
                <a:lnTo>
                  <a:pt x="41783" y="71247"/>
                </a:lnTo>
                <a:lnTo>
                  <a:pt x="57658" y="71247"/>
                </a:lnTo>
                <a:lnTo>
                  <a:pt x="66802" y="62103"/>
                </a:lnTo>
                <a:lnTo>
                  <a:pt x="58801" y="54229"/>
                </a:lnTo>
                <a:close/>
              </a:path>
              <a:path w="101600" h="92710">
                <a:moveTo>
                  <a:pt x="26543" y="24384"/>
                </a:moveTo>
                <a:lnTo>
                  <a:pt x="0" y="49276"/>
                </a:lnTo>
                <a:lnTo>
                  <a:pt x="1778" y="54229"/>
                </a:lnTo>
                <a:lnTo>
                  <a:pt x="5969" y="59563"/>
                </a:lnTo>
                <a:lnTo>
                  <a:pt x="15367" y="51816"/>
                </a:lnTo>
                <a:lnTo>
                  <a:pt x="13081" y="49149"/>
                </a:lnTo>
                <a:lnTo>
                  <a:pt x="11938" y="46736"/>
                </a:lnTo>
                <a:lnTo>
                  <a:pt x="11811" y="44577"/>
                </a:lnTo>
                <a:lnTo>
                  <a:pt x="11811" y="42545"/>
                </a:lnTo>
                <a:lnTo>
                  <a:pt x="12700" y="40513"/>
                </a:lnTo>
                <a:lnTo>
                  <a:pt x="14478" y="38735"/>
                </a:lnTo>
                <a:lnTo>
                  <a:pt x="16383" y="36957"/>
                </a:lnTo>
                <a:lnTo>
                  <a:pt x="18288" y="36068"/>
                </a:lnTo>
                <a:lnTo>
                  <a:pt x="38817" y="36068"/>
                </a:lnTo>
                <a:lnTo>
                  <a:pt x="37846" y="33909"/>
                </a:lnTo>
                <a:lnTo>
                  <a:pt x="36322" y="31623"/>
                </a:lnTo>
                <a:lnTo>
                  <a:pt x="34290" y="29718"/>
                </a:lnTo>
                <a:lnTo>
                  <a:pt x="30734" y="26162"/>
                </a:lnTo>
                <a:lnTo>
                  <a:pt x="26543" y="24384"/>
                </a:lnTo>
                <a:close/>
              </a:path>
              <a:path w="101600" h="92710">
                <a:moveTo>
                  <a:pt x="35687" y="3683"/>
                </a:moveTo>
                <a:lnTo>
                  <a:pt x="27178" y="12192"/>
                </a:lnTo>
                <a:lnTo>
                  <a:pt x="71882" y="57023"/>
                </a:lnTo>
                <a:lnTo>
                  <a:pt x="80518" y="48387"/>
                </a:lnTo>
                <a:lnTo>
                  <a:pt x="64262" y="32131"/>
                </a:lnTo>
                <a:lnTo>
                  <a:pt x="61468" y="29464"/>
                </a:lnTo>
                <a:lnTo>
                  <a:pt x="59690" y="27051"/>
                </a:lnTo>
                <a:lnTo>
                  <a:pt x="57912" y="23241"/>
                </a:lnTo>
                <a:lnTo>
                  <a:pt x="57785" y="21463"/>
                </a:lnTo>
                <a:lnTo>
                  <a:pt x="58064" y="20066"/>
                </a:lnTo>
                <a:lnTo>
                  <a:pt x="52197" y="20066"/>
                </a:lnTo>
                <a:lnTo>
                  <a:pt x="35687" y="3683"/>
                </a:lnTo>
                <a:close/>
              </a:path>
              <a:path w="101600" h="92710">
                <a:moveTo>
                  <a:pt x="86130" y="12192"/>
                </a:moveTo>
                <a:lnTo>
                  <a:pt x="66167" y="12192"/>
                </a:lnTo>
                <a:lnTo>
                  <a:pt x="67564" y="12319"/>
                </a:lnTo>
                <a:lnTo>
                  <a:pt x="68707" y="12954"/>
                </a:lnTo>
                <a:lnTo>
                  <a:pt x="69977" y="13462"/>
                </a:lnTo>
                <a:lnTo>
                  <a:pt x="72390" y="15494"/>
                </a:lnTo>
                <a:lnTo>
                  <a:pt x="75692" y="18923"/>
                </a:lnTo>
                <a:lnTo>
                  <a:pt x="92837" y="36068"/>
                </a:lnTo>
                <a:lnTo>
                  <a:pt x="101473" y="27432"/>
                </a:lnTo>
                <a:lnTo>
                  <a:pt x="86130" y="12192"/>
                </a:lnTo>
                <a:close/>
              </a:path>
              <a:path w="101600" h="92710">
                <a:moveTo>
                  <a:pt x="68199" y="0"/>
                </a:moveTo>
                <a:lnTo>
                  <a:pt x="66040" y="254"/>
                </a:lnTo>
                <a:lnTo>
                  <a:pt x="63754" y="1143"/>
                </a:lnTo>
                <a:lnTo>
                  <a:pt x="61341" y="1905"/>
                </a:lnTo>
                <a:lnTo>
                  <a:pt x="59182" y="3302"/>
                </a:lnTo>
                <a:lnTo>
                  <a:pt x="57277" y="5334"/>
                </a:lnTo>
                <a:lnTo>
                  <a:pt x="53467" y="9144"/>
                </a:lnTo>
                <a:lnTo>
                  <a:pt x="51689" y="14097"/>
                </a:lnTo>
                <a:lnTo>
                  <a:pt x="52197" y="20066"/>
                </a:lnTo>
                <a:lnTo>
                  <a:pt x="58064" y="20066"/>
                </a:lnTo>
                <a:lnTo>
                  <a:pt x="58166" y="19558"/>
                </a:lnTo>
                <a:lnTo>
                  <a:pt x="58547" y="17780"/>
                </a:lnTo>
                <a:lnTo>
                  <a:pt x="59563" y="16129"/>
                </a:lnTo>
                <a:lnTo>
                  <a:pt x="62230" y="13462"/>
                </a:lnTo>
                <a:lnTo>
                  <a:pt x="63500" y="12700"/>
                </a:lnTo>
                <a:lnTo>
                  <a:pt x="64897" y="12446"/>
                </a:lnTo>
                <a:lnTo>
                  <a:pt x="66167" y="12192"/>
                </a:lnTo>
                <a:lnTo>
                  <a:pt x="86130" y="12192"/>
                </a:lnTo>
                <a:lnTo>
                  <a:pt x="79502" y="5588"/>
                </a:lnTo>
                <a:lnTo>
                  <a:pt x="70104" y="254"/>
                </a:lnTo>
                <a:lnTo>
                  <a:pt x="6819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3" name="object 73"/>
          <p:cNvSpPr/>
          <p:nvPr/>
        </p:nvSpPr>
        <p:spPr>
          <a:xfrm>
            <a:off x="5499449" y="3200177"/>
            <a:ext cx="128881" cy="12888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4" name="object 74"/>
          <p:cNvSpPr/>
          <p:nvPr/>
        </p:nvSpPr>
        <p:spPr>
          <a:xfrm>
            <a:off x="5515512" y="3232287"/>
            <a:ext cx="92054" cy="83999"/>
          </a:xfrm>
          <a:custGeom>
            <a:avLst/>
            <a:gdLst/>
            <a:ahLst/>
            <a:cxnLst/>
            <a:rect l="l" t="t" r="r" b="b"/>
            <a:pathLst>
              <a:path w="101600" h="92710">
                <a:moveTo>
                  <a:pt x="38658" y="36068"/>
                </a:moveTo>
                <a:lnTo>
                  <a:pt x="22352" y="36068"/>
                </a:lnTo>
                <a:lnTo>
                  <a:pt x="24257" y="37084"/>
                </a:lnTo>
                <a:lnTo>
                  <a:pt x="26162" y="38989"/>
                </a:lnTo>
                <a:lnTo>
                  <a:pt x="30226" y="52959"/>
                </a:lnTo>
                <a:lnTo>
                  <a:pt x="29972" y="60452"/>
                </a:lnTo>
                <a:lnTo>
                  <a:pt x="29591" y="69596"/>
                </a:lnTo>
                <a:lnTo>
                  <a:pt x="29972" y="76454"/>
                </a:lnTo>
                <a:lnTo>
                  <a:pt x="32004" y="85090"/>
                </a:lnTo>
                <a:lnTo>
                  <a:pt x="33909" y="88900"/>
                </a:lnTo>
                <a:lnTo>
                  <a:pt x="36576" y="92202"/>
                </a:lnTo>
                <a:lnTo>
                  <a:pt x="57619" y="71247"/>
                </a:lnTo>
                <a:lnTo>
                  <a:pt x="41656" y="71247"/>
                </a:lnTo>
                <a:lnTo>
                  <a:pt x="41402" y="70104"/>
                </a:lnTo>
                <a:lnTo>
                  <a:pt x="41148" y="68707"/>
                </a:lnTo>
                <a:lnTo>
                  <a:pt x="41021" y="67183"/>
                </a:lnTo>
                <a:lnTo>
                  <a:pt x="41021" y="62230"/>
                </a:lnTo>
                <a:lnTo>
                  <a:pt x="41529" y="51816"/>
                </a:lnTo>
                <a:lnTo>
                  <a:pt x="41402" y="48133"/>
                </a:lnTo>
                <a:lnTo>
                  <a:pt x="41148" y="45720"/>
                </a:lnTo>
                <a:lnTo>
                  <a:pt x="40767" y="42164"/>
                </a:lnTo>
                <a:lnTo>
                  <a:pt x="40005" y="39116"/>
                </a:lnTo>
                <a:lnTo>
                  <a:pt x="38862" y="36576"/>
                </a:lnTo>
                <a:lnTo>
                  <a:pt x="38658" y="36068"/>
                </a:lnTo>
                <a:close/>
              </a:path>
              <a:path w="101600" h="92710">
                <a:moveTo>
                  <a:pt x="58674" y="54229"/>
                </a:moveTo>
                <a:lnTo>
                  <a:pt x="41656" y="71247"/>
                </a:lnTo>
                <a:lnTo>
                  <a:pt x="57619" y="71247"/>
                </a:lnTo>
                <a:lnTo>
                  <a:pt x="66675" y="62230"/>
                </a:lnTo>
                <a:lnTo>
                  <a:pt x="58674" y="54229"/>
                </a:lnTo>
                <a:close/>
              </a:path>
              <a:path w="101600" h="92710">
                <a:moveTo>
                  <a:pt x="26416" y="24511"/>
                </a:moveTo>
                <a:lnTo>
                  <a:pt x="16637" y="24765"/>
                </a:lnTo>
                <a:lnTo>
                  <a:pt x="11938" y="27051"/>
                </a:lnTo>
                <a:lnTo>
                  <a:pt x="7620" y="31496"/>
                </a:lnTo>
                <a:lnTo>
                  <a:pt x="3556" y="35433"/>
                </a:lnTo>
                <a:lnTo>
                  <a:pt x="1270" y="39878"/>
                </a:lnTo>
                <a:lnTo>
                  <a:pt x="635" y="44577"/>
                </a:lnTo>
                <a:lnTo>
                  <a:pt x="0" y="49403"/>
                </a:lnTo>
                <a:lnTo>
                  <a:pt x="1778" y="54356"/>
                </a:lnTo>
                <a:lnTo>
                  <a:pt x="5969" y="59563"/>
                </a:lnTo>
                <a:lnTo>
                  <a:pt x="15367" y="51943"/>
                </a:lnTo>
                <a:lnTo>
                  <a:pt x="12954" y="49276"/>
                </a:lnTo>
                <a:lnTo>
                  <a:pt x="11811" y="46863"/>
                </a:lnTo>
                <a:lnTo>
                  <a:pt x="11811" y="42545"/>
                </a:lnTo>
                <a:lnTo>
                  <a:pt x="12700" y="40640"/>
                </a:lnTo>
                <a:lnTo>
                  <a:pt x="14478" y="38735"/>
                </a:lnTo>
                <a:lnTo>
                  <a:pt x="16256" y="36957"/>
                </a:lnTo>
                <a:lnTo>
                  <a:pt x="18161" y="36068"/>
                </a:lnTo>
                <a:lnTo>
                  <a:pt x="38658" y="36068"/>
                </a:lnTo>
                <a:lnTo>
                  <a:pt x="37846" y="34036"/>
                </a:lnTo>
                <a:lnTo>
                  <a:pt x="36195" y="31750"/>
                </a:lnTo>
                <a:lnTo>
                  <a:pt x="34163" y="29718"/>
                </a:lnTo>
                <a:lnTo>
                  <a:pt x="30734" y="26162"/>
                </a:lnTo>
                <a:lnTo>
                  <a:pt x="26416" y="24511"/>
                </a:lnTo>
                <a:close/>
              </a:path>
              <a:path w="101600" h="92710">
                <a:moveTo>
                  <a:pt x="35687" y="3683"/>
                </a:moveTo>
                <a:lnTo>
                  <a:pt x="27051" y="12319"/>
                </a:lnTo>
                <a:lnTo>
                  <a:pt x="71882" y="57023"/>
                </a:lnTo>
                <a:lnTo>
                  <a:pt x="80391" y="48514"/>
                </a:lnTo>
                <a:lnTo>
                  <a:pt x="64135" y="32258"/>
                </a:lnTo>
                <a:lnTo>
                  <a:pt x="61468" y="29464"/>
                </a:lnTo>
                <a:lnTo>
                  <a:pt x="59690" y="27178"/>
                </a:lnTo>
                <a:lnTo>
                  <a:pt x="57912" y="23368"/>
                </a:lnTo>
                <a:lnTo>
                  <a:pt x="57658" y="21463"/>
                </a:lnTo>
                <a:lnTo>
                  <a:pt x="58020" y="20193"/>
                </a:lnTo>
                <a:lnTo>
                  <a:pt x="52197" y="20193"/>
                </a:lnTo>
                <a:lnTo>
                  <a:pt x="35687" y="3683"/>
                </a:lnTo>
                <a:close/>
              </a:path>
              <a:path w="101600" h="92710">
                <a:moveTo>
                  <a:pt x="85979" y="12192"/>
                </a:moveTo>
                <a:lnTo>
                  <a:pt x="66167" y="12192"/>
                </a:lnTo>
                <a:lnTo>
                  <a:pt x="67437" y="12446"/>
                </a:lnTo>
                <a:lnTo>
                  <a:pt x="68707" y="12954"/>
                </a:lnTo>
                <a:lnTo>
                  <a:pt x="69977" y="13589"/>
                </a:lnTo>
                <a:lnTo>
                  <a:pt x="72263" y="15621"/>
                </a:lnTo>
                <a:lnTo>
                  <a:pt x="75692" y="18923"/>
                </a:lnTo>
                <a:lnTo>
                  <a:pt x="92837" y="36068"/>
                </a:lnTo>
                <a:lnTo>
                  <a:pt x="101346" y="27559"/>
                </a:lnTo>
                <a:lnTo>
                  <a:pt x="85979" y="12192"/>
                </a:lnTo>
                <a:close/>
              </a:path>
              <a:path w="101600" h="92710">
                <a:moveTo>
                  <a:pt x="68072" y="0"/>
                </a:moveTo>
                <a:lnTo>
                  <a:pt x="51689" y="14224"/>
                </a:lnTo>
                <a:lnTo>
                  <a:pt x="52197" y="20193"/>
                </a:lnTo>
                <a:lnTo>
                  <a:pt x="58020" y="20193"/>
                </a:lnTo>
                <a:lnTo>
                  <a:pt x="58166" y="19685"/>
                </a:lnTo>
                <a:lnTo>
                  <a:pt x="58547" y="17907"/>
                </a:lnTo>
                <a:lnTo>
                  <a:pt x="59436" y="16256"/>
                </a:lnTo>
                <a:lnTo>
                  <a:pt x="60960" y="14859"/>
                </a:lnTo>
                <a:lnTo>
                  <a:pt x="62103" y="13589"/>
                </a:lnTo>
                <a:lnTo>
                  <a:pt x="63500" y="12827"/>
                </a:lnTo>
                <a:lnTo>
                  <a:pt x="64770" y="12573"/>
                </a:lnTo>
                <a:lnTo>
                  <a:pt x="66167" y="12192"/>
                </a:lnTo>
                <a:lnTo>
                  <a:pt x="85979" y="12192"/>
                </a:lnTo>
                <a:lnTo>
                  <a:pt x="82296" y="8509"/>
                </a:lnTo>
                <a:lnTo>
                  <a:pt x="79502" y="5588"/>
                </a:lnTo>
                <a:lnTo>
                  <a:pt x="77089" y="3556"/>
                </a:lnTo>
                <a:lnTo>
                  <a:pt x="75438" y="2540"/>
                </a:lnTo>
                <a:lnTo>
                  <a:pt x="73787" y="1397"/>
                </a:lnTo>
                <a:lnTo>
                  <a:pt x="72009" y="762"/>
                </a:lnTo>
                <a:lnTo>
                  <a:pt x="69977" y="381"/>
                </a:lnTo>
                <a:lnTo>
                  <a:pt x="6807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37033" y="4927262"/>
            <a:ext cx="6194062" cy="100501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50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4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R</a:t>
            </a:r>
            <a:r>
              <a:rPr sz="1087" b="1" spc="28" dirty="0">
                <a:latin typeface="Times New Roman"/>
                <a:cs typeface="Times New Roman"/>
              </a:rPr>
              <a:t>up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e</a:t>
            </a:r>
            <a:r>
              <a:rPr sz="1087" b="1" spc="23" dirty="0">
                <a:latin typeface="Times New Roman"/>
                <a:cs typeface="Times New Roman"/>
              </a:rPr>
              <a:t>d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73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ysoso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s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23" dirty="0">
                <a:latin typeface="Times New Roman"/>
                <a:cs typeface="Times New Roman"/>
              </a:rPr>
              <a:t>ec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9" dirty="0">
                <a:latin typeface="Times New Roman"/>
                <a:cs typeface="Times New Roman"/>
              </a:rPr>
              <a:t>it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ga</a:t>
            </a:r>
            <a:r>
              <a:rPr sz="1087" b="1" spc="18" dirty="0">
                <a:latin typeface="Times New Roman"/>
                <a:cs typeface="Times New Roman"/>
              </a:rPr>
              <a:t>l</a:t>
            </a:r>
            <a:r>
              <a:rPr sz="1087" b="1" spc="23" dirty="0">
                <a:latin typeface="Times New Roman"/>
                <a:cs typeface="Times New Roman"/>
              </a:rPr>
              <a:t>e</a:t>
            </a:r>
            <a:r>
              <a:rPr sz="1087" b="1" spc="14" dirty="0">
                <a:latin typeface="Times New Roman"/>
                <a:cs typeface="Times New Roman"/>
              </a:rPr>
              <a:t>ctin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3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t</a:t>
            </a:r>
            <a:r>
              <a:rPr sz="1087" b="1" spc="18" dirty="0">
                <a:latin typeface="Times New Roman"/>
                <a:cs typeface="Times New Roman"/>
              </a:rPr>
              <a:t>o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s</a:t>
            </a:r>
            <a:r>
              <a:rPr sz="1087" b="1" spc="45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l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c</a:t>
            </a:r>
            <a:r>
              <a:rPr sz="1087" b="1" spc="18" dirty="0">
                <a:latin typeface="Times New Roman"/>
                <a:cs typeface="Times New Roman"/>
              </a:rPr>
              <a:t>ta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14" dirty="0">
                <a:latin typeface="Times New Roman"/>
                <a:cs typeface="Times New Roman"/>
              </a:rPr>
              <a:t>at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r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3" dirty="0">
                <a:latin typeface="Times New Roman"/>
                <a:cs typeface="Times New Roman"/>
              </a:rPr>
              <a:t>t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18" dirty="0">
                <a:latin typeface="Times New Roman"/>
                <a:cs typeface="Times New Roman"/>
              </a:rPr>
              <a:t>in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5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54" dirty="0">
                <a:latin typeface="Times New Roman"/>
                <a:cs typeface="Times New Roman"/>
              </a:rPr>
              <a:t>V</a:t>
            </a:r>
            <a:r>
              <a:rPr sz="1087" b="1" spc="14" dirty="0">
                <a:latin typeface="Times New Roman"/>
                <a:cs typeface="Times New Roman"/>
              </a:rPr>
              <a:t>-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A</a:t>
            </a:r>
            <a:r>
              <a:rPr sz="1087" b="1" spc="23" dirty="0">
                <a:latin typeface="Times New Roman"/>
                <a:cs typeface="Times New Roman"/>
              </a:rPr>
              <a:t>TPas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36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in</a:t>
            </a:r>
            <a:r>
              <a:rPr sz="1087" spc="18" dirty="0">
                <a:latin typeface="Times New Roman"/>
                <a:cs typeface="Times New Roman"/>
              </a:rPr>
              <a:t>cu</a:t>
            </a:r>
            <a:r>
              <a:rPr sz="1087" spc="33" dirty="0">
                <a:latin typeface="Times New Roman"/>
                <a:cs typeface="Times New Roman"/>
              </a:rPr>
              <a:t>b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urs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in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qu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33" dirty="0">
                <a:latin typeface="Times New Roman"/>
                <a:cs typeface="Times New Roman"/>
              </a:rPr>
              <a:t>2</a:t>
            </a:r>
            <a:r>
              <a:rPr sz="1087" spc="18" dirty="0">
                <a:latin typeface="Times New Roman"/>
                <a:cs typeface="Times New Roman"/>
              </a:rPr>
              <a:t>0</a:t>
            </a:r>
            <a:r>
              <a:rPr sz="1087" spc="33" dirty="0">
                <a:latin typeface="Times New Roman"/>
                <a:cs typeface="Times New Roman"/>
              </a:rPr>
              <a:t>0</a:t>
            </a:r>
            <a:r>
              <a:rPr sz="1087" spc="28" dirty="0">
                <a:latin typeface="Times New Roman"/>
                <a:cs typeface="Times New Roman"/>
              </a:rPr>
              <a:t>µ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x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e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imm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ined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ct</a:t>
            </a:r>
            <a:r>
              <a:rPr sz="1087" spc="5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3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n)</a:t>
            </a:r>
            <a:r>
              <a:rPr sz="1087" spc="9" dirty="0">
                <a:latin typeface="Times New Roman"/>
                <a:cs typeface="Times New Roman"/>
              </a:rPr>
              <a:t> a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V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33" dirty="0">
                <a:latin typeface="Times New Roman"/>
                <a:cs typeface="Times New Roman"/>
              </a:rPr>
              <a:t>ATP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on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s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he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rig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h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6" dirty="0">
                <a:latin typeface="Times New Roman"/>
                <a:cs typeface="Times New Roman"/>
              </a:rPr>
              <a:t>w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all </a:t>
            </a:r>
            <a:r>
              <a:rPr sz="1087" spc="18" dirty="0">
                <a:latin typeface="Times New Roman"/>
                <a:cs typeface="Times New Roman"/>
              </a:rPr>
              <a:t>pun</a:t>
            </a:r>
            <a:r>
              <a:rPr sz="1087" spc="14" dirty="0">
                <a:latin typeface="Times New Roman"/>
                <a:cs typeface="Times New Roman"/>
              </a:rPr>
              <a:t>ct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h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r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ec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3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ig</a:t>
            </a:r>
            <a:r>
              <a:rPr sz="1087" spc="2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al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 c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c</a:t>
            </a:r>
            <a:r>
              <a:rPr sz="1087" spc="9" dirty="0">
                <a:latin typeface="Times New Roman"/>
                <a:cs typeface="Times New Roman"/>
              </a:rPr>
              <a:t>al</a:t>
            </a:r>
            <a:r>
              <a:rPr sz="1087" spc="5" dirty="0">
                <a:latin typeface="Times New Roman"/>
                <a:cs typeface="Times New Roman"/>
              </a:rPr>
              <a:t>i</a:t>
            </a:r>
            <a:r>
              <a:rPr sz="1087" spc="23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wit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V-</a:t>
            </a:r>
            <a:r>
              <a:rPr sz="1087" spc="33" dirty="0">
                <a:latin typeface="Times New Roman"/>
                <a:cs typeface="Times New Roman"/>
              </a:rPr>
              <a:t>ATP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se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endParaRPr sz="1087">
              <a:latin typeface="Times New Roman"/>
              <a:cs typeface="Times New Roman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993031" y="1721064"/>
            <a:ext cx="2274853" cy="2282977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" name="object 4"/>
          <p:cNvSpPr/>
          <p:nvPr/>
        </p:nvSpPr>
        <p:spPr>
          <a:xfrm>
            <a:off x="3984199" y="1856890"/>
            <a:ext cx="651832" cy="658758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" name="object 5"/>
          <p:cNvSpPr/>
          <p:nvPr/>
        </p:nvSpPr>
        <p:spPr>
          <a:xfrm>
            <a:off x="4668273" y="1850564"/>
            <a:ext cx="651832" cy="658753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" name="object 6"/>
          <p:cNvSpPr/>
          <p:nvPr/>
        </p:nvSpPr>
        <p:spPr>
          <a:xfrm>
            <a:off x="2361178" y="1901766"/>
            <a:ext cx="489035" cy="489035"/>
          </a:xfrm>
          <a:custGeom>
            <a:avLst/>
            <a:gdLst/>
            <a:ahLst/>
            <a:cxnLst/>
            <a:rect l="l" t="t" r="r" b="b"/>
            <a:pathLst>
              <a:path w="539750" h="539750">
                <a:moveTo>
                  <a:pt x="0" y="539750"/>
                </a:moveTo>
                <a:lnTo>
                  <a:pt x="539750" y="539750"/>
                </a:lnTo>
                <a:lnTo>
                  <a:pt x="539750" y="0"/>
                </a:lnTo>
                <a:lnTo>
                  <a:pt x="0" y="0"/>
                </a:lnTo>
                <a:lnTo>
                  <a:pt x="0" y="539750"/>
                </a:lnTo>
                <a:close/>
              </a:path>
            </a:pathLst>
          </a:custGeom>
          <a:ln w="952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" name="object 7"/>
          <p:cNvSpPr/>
          <p:nvPr/>
        </p:nvSpPr>
        <p:spPr>
          <a:xfrm>
            <a:off x="1414751" y="2589293"/>
            <a:ext cx="489035" cy="489035"/>
          </a:xfrm>
          <a:custGeom>
            <a:avLst/>
            <a:gdLst/>
            <a:ahLst/>
            <a:cxnLst/>
            <a:rect l="l" t="t" r="r" b="b"/>
            <a:pathLst>
              <a:path w="539750" h="539750">
                <a:moveTo>
                  <a:pt x="0" y="539750"/>
                </a:moveTo>
                <a:lnTo>
                  <a:pt x="539750" y="539750"/>
                </a:lnTo>
                <a:lnTo>
                  <a:pt x="539750" y="0"/>
                </a:lnTo>
                <a:lnTo>
                  <a:pt x="0" y="0"/>
                </a:lnTo>
                <a:lnTo>
                  <a:pt x="0" y="539750"/>
                </a:lnTo>
                <a:close/>
              </a:path>
            </a:pathLst>
          </a:custGeom>
          <a:ln w="952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" name="object 8"/>
          <p:cNvSpPr/>
          <p:nvPr/>
        </p:nvSpPr>
        <p:spPr>
          <a:xfrm>
            <a:off x="1319247" y="3283723"/>
            <a:ext cx="489035" cy="489035"/>
          </a:xfrm>
          <a:custGeom>
            <a:avLst/>
            <a:gdLst/>
            <a:ahLst/>
            <a:cxnLst/>
            <a:rect l="l" t="t" r="r" b="b"/>
            <a:pathLst>
              <a:path w="539750" h="539750">
                <a:moveTo>
                  <a:pt x="0" y="539750"/>
                </a:moveTo>
                <a:lnTo>
                  <a:pt x="539750" y="539750"/>
                </a:lnTo>
                <a:lnTo>
                  <a:pt x="539750" y="0"/>
                </a:lnTo>
                <a:lnTo>
                  <a:pt x="0" y="0"/>
                </a:lnTo>
                <a:lnTo>
                  <a:pt x="0" y="539750"/>
                </a:lnTo>
                <a:close/>
              </a:path>
            </a:pathLst>
          </a:custGeom>
          <a:ln w="952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" name="object 9"/>
          <p:cNvSpPr/>
          <p:nvPr/>
        </p:nvSpPr>
        <p:spPr>
          <a:xfrm>
            <a:off x="4667698" y="2547868"/>
            <a:ext cx="651855" cy="65185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" name="object 10"/>
          <p:cNvSpPr/>
          <p:nvPr/>
        </p:nvSpPr>
        <p:spPr>
          <a:xfrm>
            <a:off x="4667698" y="3238283"/>
            <a:ext cx="651855" cy="651843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" name="object 11"/>
          <p:cNvSpPr/>
          <p:nvPr/>
        </p:nvSpPr>
        <p:spPr>
          <a:xfrm>
            <a:off x="3983624" y="2547879"/>
            <a:ext cx="651832" cy="651843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" name="object 12"/>
          <p:cNvSpPr/>
          <p:nvPr/>
        </p:nvSpPr>
        <p:spPr>
          <a:xfrm>
            <a:off x="3983625" y="3241159"/>
            <a:ext cx="651855" cy="651843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3299551" y="1856901"/>
            <a:ext cx="651855" cy="651843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3299551" y="2547868"/>
            <a:ext cx="651855" cy="651855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3299551" y="3238283"/>
            <a:ext cx="651855" cy="651843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 txBox="1"/>
          <p:nvPr/>
        </p:nvSpPr>
        <p:spPr>
          <a:xfrm>
            <a:off x="1061657" y="1766677"/>
            <a:ext cx="798566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spc="-5" dirty="0">
                <a:solidFill>
                  <a:srgbClr val="FF0000"/>
                </a:solidFill>
                <a:latin typeface="Calibri"/>
                <a:cs typeface="Calibri"/>
              </a:rPr>
              <a:t>V-</a:t>
            </a:r>
            <a:r>
              <a:rPr sz="997" dirty="0">
                <a:solidFill>
                  <a:srgbClr val="FF0000"/>
                </a:solidFill>
                <a:latin typeface="Calibri"/>
                <a:cs typeface="Calibri"/>
              </a:rPr>
              <a:t>ATPase</a:t>
            </a:r>
            <a:r>
              <a:rPr sz="997" dirty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sz="997" spc="-50" dirty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sz="997" dirty="0">
                <a:solidFill>
                  <a:srgbClr val="00B050"/>
                </a:solidFill>
                <a:latin typeface="Calibri"/>
                <a:cs typeface="Calibri"/>
              </a:rPr>
              <a:t>Ga</a:t>
            </a:r>
            <a:r>
              <a:rPr sz="997" spc="-14" dirty="0">
                <a:solidFill>
                  <a:srgbClr val="00B050"/>
                </a:solidFill>
                <a:latin typeface="Calibri"/>
                <a:cs typeface="Calibri"/>
              </a:rPr>
              <a:t>l</a:t>
            </a:r>
            <a:r>
              <a:rPr sz="997" dirty="0">
                <a:solidFill>
                  <a:srgbClr val="00B050"/>
                </a:solidFill>
                <a:latin typeface="Calibri"/>
                <a:cs typeface="Calibri"/>
              </a:rPr>
              <a:t>3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17" name="object 17"/>
          <p:cNvSpPr/>
          <p:nvPr/>
        </p:nvSpPr>
        <p:spPr>
          <a:xfrm>
            <a:off x="683556" y="2123038"/>
            <a:ext cx="225070" cy="1166781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 txBox="1"/>
          <p:nvPr/>
        </p:nvSpPr>
        <p:spPr>
          <a:xfrm>
            <a:off x="709896" y="2363693"/>
            <a:ext cx="223138" cy="85552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1450" spc="-109" dirty="0">
                <a:latin typeface="Calibri"/>
                <a:cs typeface="Calibri"/>
              </a:rPr>
              <a:t>A</a:t>
            </a:r>
            <a:r>
              <a:rPr sz="1450" spc="-41" dirty="0">
                <a:latin typeface="Calibri"/>
                <a:cs typeface="Calibri"/>
              </a:rPr>
              <a:t>T</a:t>
            </a:r>
            <a:r>
              <a:rPr sz="1450" dirty="0">
                <a:latin typeface="Calibri"/>
                <a:cs typeface="Calibri"/>
              </a:rPr>
              <a:t>G1</a:t>
            </a:r>
            <a:r>
              <a:rPr sz="1450" spc="-9" dirty="0">
                <a:latin typeface="Calibri"/>
                <a:cs typeface="Calibri"/>
              </a:rPr>
              <a:t>6</a:t>
            </a:r>
            <a:r>
              <a:rPr sz="1450" spc="9" dirty="0">
                <a:latin typeface="Calibri"/>
                <a:cs typeface="Calibri"/>
              </a:rPr>
              <a:t>L</a:t>
            </a:r>
            <a:r>
              <a:rPr sz="1450" spc="-5" dirty="0">
                <a:latin typeface="Calibri"/>
                <a:cs typeface="Calibri"/>
              </a:rPr>
              <a:t>1</a:t>
            </a:r>
            <a:r>
              <a:rPr sz="1450" dirty="0">
                <a:latin typeface="Calibri"/>
                <a:cs typeface="Calibri"/>
              </a:rPr>
              <a:t>-</a:t>
            </a:r>
            <a:r>
              <a:rPr sz="1450" spc="-5" dirty="0">
                <a:latin typeface="Calibri"/>
                <a:cs typeface="Calibri"/>
              </a:rPr>
              <a:t>/</a:t>
            </a:r>
            <a:r>
              <a:rPr sz="1450" dirty="0">
                <a:latin typeface="Calibri"/>
                <a:cs typeface="Calibri"/>
              </a:rPr>
              <a:t>-</a:t>
            </a:r>
            <a:endParaRPr sz="145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4742031" y="1664497"/>
            <a:ext cx="509172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dirty="0">
                <a:solidFill>
                  <a:srgbClr val="FF0000"/>
                </a:solidFill>
                <a:latin typeface="Calibri"/>
                <a:cs typeface="Calibri"/>
              </a:rPr>
              <a:t>V</a:t>
            </a:r>
            <a:r>
              <a:rPr sz="997" spc="-5" dirty="0">
                <a:solidFill>
                  <a:srgbClr val="FF0000"/>
                </a:solidFill>
                <a:latin typeface="Calibri"/>
                <a:cs typeface="Calibri"/>
              </a:rPr>
              <a:t>-</a:t>
            </a:r>
            <a:r>
              <a:rPr sz="997" dirty="0">
                <a:solidFill>
                  <a:srgbClr val="FF0000"/>
                </a:solidFill>
                <a:latin typeface="Calibri"/>
                <a:cs typeface="Calibri"/>
              </a:rPr>
              <a:t>ATPase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4155188" y="1664497"/>
            <a:ext cx="257750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dirty="0">
                <a:solidFill>
                  <a:srgbClr val="00B050"/>
                </a:solidFill>
                <a:latin typeface="Calibri"/>
                <a:cs typeface="Calibri"/>
              </a:rPr>
              <a:t>Ga</a:t>
            </a:r>
            <a:r>
              <a:rPr sz="997" spc="-5" dirty="0">
                <a:solidFill>
                  <a:srgbClr val="00B050"/>
                </a:solidFill>
                <a:latin typeface="Calibri"/>
                <a:cs typeface="Calibri"/>
              </a:rPr>
              <a:t>l</a:t>
            </a:r>
            <a:r>
              <a:rPr sz="997" dirty="0">
                <a:solidFill>
                  <a:srgbClr val="00B050"/>
                </a:solidFill>
                <a:latin typeface="Calibri"/>
                <a:cs typeface="Calibri"/>
              </a:rPr>
              <a:t>3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3513113" y="1663115"/>
            <a:ext cx="208846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dirty="0">
                <a:latin typeface="Calibri"/>
                <a:cs typeface="Calibri"/>
              </a:rPr>
              <a:t>ROI</a:t>
            </a:r>
            <a:endParaRPr sz="997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680893" y="3184997"/>
            <a:ext cx="0" cy="102410"/>
          </a:xfrm>
          <a:custGeom>
            <a:avLst/>
            <a:gdLst/>
            <a:ahLst/>
            <a:cxnLst/>
            <a:rect l="l" t="t" r="r" b="b"/>
            <a:pathLst>
              <a:path h="113029">
                <a:moveTo>
                  <a:pt x="0" y="0"/>
                </a:moveTo>
                <a:lnTo>
                  <a:pt x="0" y="112772"/>
                </a:lnTo>
              </a:path>
            </a:pathLst>
          </a:custGeom>
          <a:ln w="55502">
            <a:solidFill>
              <a:srgbClr val="FFFF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" name="object 3"/>
          <p:cNvSpPr txBox="1"/>
          <p:nvPr/>
        </p:nvSpPr>
        <p:spPr>
          <a:xfrm>
            <a:off x="3276766" y="1389371"/>
            <a:ext cx="265805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dirty="0">
                <a:solidFill>
                  <a:srgbClr val="D101B3"/>
                </a:solidFill>
                <a:latin typeface="Calibri"/>
                <a:cs typeface="Calibri"/>
              </a:rPr>
              <a:t>g</a:t>
            </a:r>
            <a:r>
              <a:rPr sz="816" b="1" spc="-9" dirty="0">
                <a:solidFill>
                  <a:srgbClr val="D101B3"/>
                </a:solidFill>
                <a:latin typeface="Calibri"/>
                <a:cs typeface="Calibri"/>
              </a:rPr>
              <a:t>R</a:t>
            </a:r>
            <a:r>
              <a:rPr sz="816" b="1" spc="-5" dirty="0">
                <a:solidFill>
                  <a:srgbClr val="D101B3"/>
                </a:solidFill>
                <a:latin typeface="Calibri"/>
                <a:cs typeface="Calibri"/>
              </a:rPr>
              <a:t>N</a:t>
            </a:r>
            <a:r>
              <a:rPr sz="816" b="1" spc="18" dirty="0">
                <a:solidFill>
                  <a:srgbClr val="D101B3"/>
                </a:solidFill>
                <a:latin typeface="Calibri"/>
                <a:cs typeface="Calibri"/>
              </a:rPr>
              <a:t>A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235591" y="1580268"/>
            <a:ext cx="134053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spc="-9" dirty="0">
                <a:latin typeface="Calibri"/>
                <a:cs typeface="Calibri"/>
              </a:rPr>
              <a:t>A.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1453758" y="1934790"/>
            <a:ext cx="391803" cy="13939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06" b="1" dirty="0">
                <a:latin typeface="Calibri"/>
                <a:cs typeface="Calibri"/>
              </a:rPr>
              <a:t>T</a:t>
            </a:r>
            <a:r>
              <a:rPr sz="906" b="1" spc="9" dirty="0">
                <a:latin typeface="Calibri"/>
                <a:cs typeface="Calibri"/>
              </a:rPr>
              <a:t>E</a:t>
            </a:r>
            <a:r>
              <a:rPr sz="906" b="1" spc="5" dirty="0">
                <a:latin typeface="Calibri"/>
                <a:cs typeface="Calibri"/>
              </a:rPr>
              <a:t>C</a:t>
            </a:r>
            <a:r>
              <a:rPr sz="906" b="1" spc="14" dirty="0">
                <a:latin typeface="Calibri"/>
                <a:cs typeface="Calibri"/>
              </a:rPr>
              <a:t>P</a:t>
            </a:r>
            <a:r>
              <a:rPr sz="906" b="1" spc="5" dirty="0">
                <a:latin typeface="Calibri"/>
                <a:cs typeface="Calibri"/>
              </a:rPr>
              <a:t>R</a:t>
            </a:r>
            <a:r>
              <a:rPr sz="906" b="1" spc="18" dirty="0">
                <a:latin typeface="Calibri"/>
                <a:cs typeface="Calibri"/>
              </a:rPr>
              <a:t>1</a:t>
            </a:r>
            <a:endParaRPr sz="906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1235590" y="2879952"/>
            <a:ext cx="392954" cy="30232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7835"/>
            <a:r>
              <a:rPr sz="997" b="1" spc="-5" dirty="0">
                <a:latin typeface="Calibri"/>
                <a:cs typeface="Calibri"/>
              </a:rPr>
              <a:t>B.</a:t>
            </a:r>
            <a:endParaRPr sz="997">
              <a:latin typeface="Calibri"/>
              <a:cs typeface="Calibri"/>
            </a:endParaRPr>
          </a:p>
          <a:p>
            <a:pPr marL="11506">
              <a:spcBef>
                <a:spcPts val="448"/>
              </a:spcBef>
            </a:pPr>
            <a:r>
              <a:rPr sz="634" spc="-5" dirty="0">
                <a:latin typeface="Calibri"/>
                <a:cs typeface="Calibri"/>
              </a:rPr>
              <a:t>WT</a:t>
            </a:r>
            <a:r>
              <a:rPr sz="634" spc="-5" dirty="0">
                <a:latin typeface="Times New Roman"/>
                <a:cs typeface="Times New Roman"/>
              </a:rPr>
              <a:t> </a:t>
            </a:r>
            <a:r>
              <a:rPr sz="634" spc="-18" dirty="0">
                <a:latin typeface="Calibri"/>
                <a:cs typeface="Calibri"/>
              </a:rPr>
              <a:t>Te</a:t>
            </a:r>
            <a:r>
              <a:rPr sz="634" spc="-14" dirty="0">
                <a:latin typeface="Calibri"/>
                <a:cs typeface="Calibri"/>
              </a:rPr>
              <a:t>c</a:t>
            </a:r>
            <a:r>
              <a:rPr sz="634" dirty="0">
                <a:latin typeface="Calibri"/>
                <a:cs typeface="Calibri"/>
              </a:rPr>
              <a:t>p</a:t>
            </a:r>
            <a:r>
              <a:rPr sz="634" spc="-18" dirty="0">
                <a:latin typeface="Calibri"/>
                <a:cs typeface="Calibri"/>
              </a:rPr>
              <a:t>r</a:t>
            </a:r>
            <a:r>
              <a:rPr sz="634" spc="-23" dirty="0">
                <a:latin typeface="Calibri"/>
                <a:cs typeface="Calibri"/>
              </a:rPr>
              <a:t>1</a:t>
            </a:r>
            <a:r>
              <a:rPr sz="634" spc="-5" dirty="0">
                <a:latin typeface="Calibri"/>
                <a:cs typeface="Calibri"/>
              </a:rPr>
              <a:t>:</a:t>
            </a:r>
            <a:endParaRPr sz="634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1696782" y="3093286"/>
            <a:ext cx="3575711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spc="-18" dirty="0">
                <a:latin typeface="Calibri"/>
                <a:cs typeface="Calibri"/>
              </a:rPr>
              <a:t>CT</a:t>
            </a:r>
            <a:r>
              <a:rPr sz="634" spc="-14" dirty="0">
                <a:latin typeface="Calibri"/>
                <a:cs typeface="Calibri"/>
              </a:rPr>
              <a:t>GG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</a:t>
            </a:r>
            <a:r>
              <a:rPr sz="634" spc="-9" dirty="0">
                <a:solidFill>
                  <a:srgbClr val="D101B3"/>
                </a:solidFill>
                <a:latin typeface="Calibri"/>
                <a:cs typeface="Calibri"/>
              </a:rPr>
              <a:t>T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TC</a:t>
            </a:r>
            <a:r>
              <a:rPr sz="634" spc="-5" dirty="0">
                <a:solidFill>
                  <a:srgbClr val="D101B3"/>
                </a:solidFill>
                <a:latin typeface="Calibri"/>
                <a:cs typeface="Calibri"/>
              </a:rPr>
              <a:t>A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GG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G</a:t>
            </a:r>
            <a:r>
              <a:rPr sz="634" spc="-9" dirty="0">
                <a:solidFill>
                  <a:srgbClr val="D101B3"/>
                </a:solidFill>
                <a:latin typeface="Calibri"/>
                <a:cs typeface="Calibri"/>
              </a:rPr>
              <a:t>A</a:t>
            </a:r>
            <a:r>
              <a:rPr sz="634" spc="-18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00AF50"/>
                </a:solidFill>
                <a:latin typeface="Calibri"/>
                <a:cs typeface="Calibri"/>
              </a:rPr>
              <a:t>GG</a:t>
            </a:r>
            <a:r>
              <a:rPr sz="634" spc="-14" dirty="0">
                <a:latin typeface="Calibri"/>
                <a:cs typeface="Calibri"/>
              </a:rPr>
              <a:t>GG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GAGA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G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C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T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9" dirty="0">
                <a:latin typeface="Calibri"/>
                <a:cs typeface="Calibri"/>
              </a:rPr>
              <a:t>T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5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G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G</a:t>
            </a:r>
            <a:r>
              <a:rPr sz="634" spc="-5" dirty="0">
                <a:latin typeface="Calibri"/>
                <a:cs typeface="Calibri"/>
              </a:rPr>
              <a:t>G</a:t>
            </a:r>
            <a:r>
              <a:rPr sz="634" spc="-18" dirty="0">
                <a:latin typeface="Calibri"/>
                <a:cs typeface="Calibri"/>
              </a:rPr>
              <a:t>TC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GAGGAGAAGAAGG</a:t>
            </a:r>
            <a:r>
              <a:rPr sz="634" spc="-5" dirty="0">
                <a:latin typeface="Calibri"/>
                <a:cs typeface="Calibri"/>
              </a:rPr>
              <a:t>T</a:t>
            </a:r>
            <a:endParaRPr sz="634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1301870" y="3323877"/>
            <a:ext cx="4176936" cy="26045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>
              <a:tabLst>
                <a:tab pos="566113" algn="l"/>
              </a:tabLst>
            </a:pPr>
            <a:r>
              <a:rPr sz="634" spc="-9" dirty="0">
                <a:latin typeface="Calibri"/>
                <a:cs typeface="Calibri"/>
              </a:rPr>
              <a:t>M</a:t>
            </a:r>
            <a:r>
              <a:rPr sz="634" dirty="0">
                <a:latin typeface="Calibri"/>
                <a:cs typeface="Calibri"/>
              </a:rPr>
              <a:t>u</a:t>
            </a:r>
            <a:r>
              <a:rPr sz="634" spc="-5" dirty="0">
                <a:latin typeface="Calibri"/>
                <a:cs typeface="Calibri"/>
              </a:rPr>
              <a:t>t</a:t>
            </a:r>
            <a:r>
              <a:rPr sz="634" dirty="0">
                <a:latin typeface="Times New Roman"/>
                <a:cs typeface="Times New Roman"/>
              </a:rPr>
              <a:t>  </a:t>
            </a:r>
            <a:r>
              <a:rPr sz="634" spc="-78" dirty="0">
                <a:latin typeface="Times New Roman"/>
                <a:cs typeface="Times New Roman"/>
              </a:rPr>
              <a:t> </a:t>
            </a:r>
            <a:r>
              <a:rPr sz="634" spc="-9" dirty="0">
                <a:latin typeface="Calibri"/>
                <a:cs typeface="Calibri"/>
              </a:rPr>
              <a:t>T</a:t>
            </a:r>
            <a:r>
              <a:rPr sz="634" spc="-5" dirty="0">
                <a:latin typeface="Calibri"/>
                <a:cs typeface="Calibri"/>
              </a:rPr>
              <a:t>e</a:t>
            </a:r>
            <a:r>
              <a:rPr sz="634" dirty="0">
                <a:latin typeface="Calibri"/>
                <a:cs typeface="Calibri"/>
              </a:rPr>
              <a:t>cp</a:t>
            </a:r>
            <a:r>
              <a:rPr sz="634" spc="-9" dirty="0">
                <a:latin typeface="Calibri"/>
                <a:cs typeface="Calibri"/>
              </a:rPr>
              <a:t>r1</a:t>
            </a:r>
            <a:r>
              <a:rPr sz="634" spc="-5" dirty="0">
                <a:latin typeface="Calibri"/>
                <a:cs typeface="Calibri"/>
              </a:rPr>
              <a:t>:</a:t>
            </a:r>
            <a:r>
              <a:rPr sz="634" dirty="0">
                <a:latin typeface="Times New Roman"/>
                <a:cs typeface="Times New Roman"/>
              </a:rPr>
              <a:t>	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G</a:t>
            </a:r>
            <a:r>
              <a:rPr sz="634" spc="-9" dirty="0">
                <a:latin typeface="Calibri"/>
                <a:cs typeface="Calibri"/>
              </a:rPr>
              <a:t>G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</a:t>
            </a:r>
            <a:r>
              <a:rPr sz="634" spc="-9" dirty="0">
                <a:solidFill>
                  <a:srgbClr val="D101B3"/>
                </a:solidFill>
                <a:latin typeface="Calibri"/>
                <a:cs typeface="Calibri"/>
              </a:rPr>
              <a:t>T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T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GG</a:t>
            </a:r>
            <a:r>
              <a:rPr sz="634" spc="-5" dirty="0">
                <a:solidFill>
                  <a:srgbClr val="D101B3"/>
                </a:solidFill>
                <a:latin typeface="Calibri"/>
                <a:cs typeface="Calibri"/>
              </a:rPr>
              <a:t>G</a:t>
            </a:r>
            <a:r>
              <a:rPr sz="634" spc="-9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AA</a:t>
            </a:r>
            <a:r>
              <a:rPr sz="634" spc="-18" dirty="0">
                <a:solidFill>
                  <a:srgbClr val="D101B3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D101B3"/>
                </a:solidFill>
                <a:latin typeface="Calibri"/>
                <a:cs typeface="Calibri"/>
              </a:rPr>
              <a:t>GA</a:t>
            </a:r>
            <a:r>
              <a:rPr sz="634" spc="-18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634" spc="-14" dirty="0">
                <a:solidFill>
                  <a:srgbClr val="00AF50"/>
                </a:solidFill>
                <a:latin typeface="Calibri"/>
                <a:cs typeface="Calibri"/>
              </a:rPr>
              <a:t>GG</a:t>
            </a:r>
            <a:r>
              <a:rPr sz="634" spc="-14" dirty="0">
                <a:latin typeface="Calibri"/>
                <a:cs typeface="Calibri"/>
              </a:rPr>
              <a:t>GG</a:t>
            </a:r>
            <a:r>
              <a:rPr sz="634" spc="-18" dirty="0">
                <a:latin typeface="Calibri"/>
                <a:cs typeface="Calibri"/>
              </a:rPr>
              <a:t>CTC</a:t>
            </a:r>
            <a:r>
              <a:rPr sz="634" spc="-14" dirty="0">
                <a:latin typeface="Calibri"/>
                <a:cs typeface="Calibri"/>
              </a:rPr>
              <a:t>GAGA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5" dirty="0">
                <a:latin typeface="Calibri"/>
                <a:cs typeface="Calibri"/>
              </a:rPr>
              <a:t>G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C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9" dirty="0">
                <a:latin typeface="Calibri"/>
                <a:cs typeface="Calibri"/>
              </a:rPr>
              <a:t>CT</a:t>
            </a:r>
            <a:r>
              <a:rPr sz="634" spc="-23" dirty="0">
                <a:latin typeface="Calibri"/>
                <a:cs typeface="Calibri"/>
              </a:rPr>
              <a:t>T</a:t>
            </a:r>
            <a:r>
              <a:rPr sz="634" spc="-18" dirty="0">
                <a:latin typeface="Calibri"/>
                <a:cs typeface="Calibri"/>
              </a:rPr>
              <a:t>C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9" dirty="0">
                <a:latin typeface="Calibri"/>
                <a:cs typeface="Calibri"/>
              </a:rPr>
              <a:t>T</a:t>
            </a:r>
            <a:r>
              <a:rPr sz="634" spc="-18" dirty="0">
                <a:latin typeface="Calibri"/>
                <a:cs typeface="Calibri"/>
              </a:rPr>
              <a:t>CT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9" dirty="0">
                <a:latin typeface="Calibri"/>
                <a:cs typeface="Calibri"/>
              </a:rPr>
              <a:t>T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A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5" dirty="0">
                <a:latin typeface="Calibri"/>
                <a:cs typeface="Calibri"/>
              </a:rPr>
              <a:t>G</a:t>
            </a:r>
            <a:r>
              <a:rPr sz="634" spc="-18" dirty="0">
                <a:latin typeface="Calibri"/>
                <a:cs typeface="Calibri"/>
              </a:rPr>
              <a:t>T</a:t>
            </a:r>
            <a:r>
              <a:rPr sz="634" spc="-14" dirty="0">
                <a:latin typeface="Calibri"/>
                <a:cs typeface="Calibri"/>
              </a:rPr>
              <a:t>G</a:t>
            </a:r>
            <a:r>
              <a:rPr sz="634" spc="-5" dirty="0">
                <a:latin typeface="Calibri"/>
                <a:cs typeface="Calibri"/>
              </a:rPr>
              <a:t>G</a:t>
            </a:r>
            <a:r>
              <a:rPr sz="634" spc="-18" dirty="0">
                <a:latin typeface="Calibri"/>
                <a:cs typeface="Calibri"/>
              </a:rPr>
              <a:t>TCC</a:t>
            </a:r>
            <a:r>
              <a:rPr sz="634" dirty="0">
                <a:latin typeface="Calibri"/>
                <a:cs typeface="Calibri"/>
              </a:rPr>
              <a:t>A</a:t>
            </a:r>
            <a:r>
              <a:rPr sz="634" spc="-18" dirty="0">
                <a:solidFill>
                  <a:srgbClr val="BF0000"/>
                </a:solidFill>
                <a:latin typeface="Calibri"/>
                <a:cs typeface="Calibri"/>
              </a:rPr>
              <a:t>T</a:t>
            </a:r>
            <a:r>
              <a:rPr sz="634" spc="-14" dirty="0">
                <a:solidFill>
                  <a:srgbClr val="BF0000"/>
                </a:solidFill>
                <a:latin typeface="Calibri"/>
                <a:cs typeface="Calibri"/>
              </a:rPr>
              <a:t>G</a:t>
            </a:r>
            <a:r>
              <a:rPr sz="634" spc="-9" dirty="0">
                <a:solidFill>
                  <a:srgbClr val="BF0000"/>
                </a:solidFill>
                <a:latin typeface="Calibri"/>
                <a:cs typeface="Calibri"/>
              </a:rPr>
              <a:t>A</a:t>
            </a:r>
            <a:r>
              <a:rPr sz="634" spc="-14" dirty="0">
                <a:latin typeface="Calibri"/>
                <a:cs typeface="Calibri"/>
              </a:rPr>
              <a:t>GGAGAAGAAGGT</a:t>
            </a:r>
            <a:endParaRPr sz="634">
              <a:latin typeface="Calibri"/>
              <a:cs typeface="Calibri"/>
            </a:endParaRPr>
          </a:p>
          <a:p>
            <a:pPr marR="510883" algn="r">
              <a:spcBef>
                <a:spcPts val="420"/>
              </a:spcBef>
            </a:pPr>
            <a:r>
              <a:rPr sz="725" b="1" spc="-9" dirty="0">
                <a:solidFill>
                  <a:srgbClr val="BF0000"/>
                </a:solidFill>
                <a:latin typeface="Calibri"/>
                <a:cs typeface="Calibri"/>
              </a:rPr>
              <a:t>S</a:t>
            </a:r>
            <a:r>
              <a:rPr sz="725" b="1" spc="-5" dirty="0">
                <a:solidFill>
                  <a:srgbClr val="BF0000"/>
                </a:solidFill>
                <a:latin typeface="Calibri"/>
                <a:cs typeface="Calibri"/>
              </a:rPr>
              <a:t>to</a:t>
            </a:r>
            <a:r>
              <a:rPr sz="725" b="1" spc="9" dirty="0">
                <a:solidFill>
                  <a:srgbClr val="BF0000"/>
                </a:solidFill>
                <a:latin typeface="Calibri"/>
                <a:cs typeface="Calibri"/>
              </a:rPr>
              <a:t>p</a:t>
            </a:r>
            <a:endParaRPr sz="725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1235591" y="3776093"/>
            <a:ext cx="132904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b="1" spc="-14" dirty="0">
                <a:latin typeface="Calibri"/>
                <a:cs typeface="Calibri"/>
              </a:rPr>
              <a:t>C.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1666402" y="3790937"/>
            <a:ext cx="554048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spc="23" dirty="0">
                <a:latin typeface="Calibri"/>
                <a:cs typeface="Calibri"/>
              </a:rPr>
              <a:t>M</a:t>
            </a:r>
            <a:r>
              <a:rPr sz="816" spc="9" dirty="0">
                <a:latin typeface="Calibri"/>
                <a:cs typeface="Calibri"/>
              </a:rPr>
              <a:t>u</a:t>
            </a:r>
            <a:r>
              <a:rPr sz="816" spc="5" dirty="0">
                <a:latin typeface="Calibri"/>
                <a:cs typeface="Calibri"/>
              </a:rPr>
              <a:t>t</a:t>
            </a:r>
            <a:r>
              <a:rPr sz="816" spc="-28" dirty="0">
                <a:latin typeface="Times New Roman"/>
                <a:cs typeface="Times New Roman"/>
              </a:rPr>
              <a:t> </a:t>
            </a:r>
            <a:r>
              <a:rPr sz="816" spc="9" dirty="0">
                <a:latin typeface="Calibri"/>
                <a:cs typeface="Calibri"/>
              </a:rPr>
              <a:t>T</a:t>
            </a:r>
            <a:r>
              <a:rPr sz="816" dirty="0">
                <a:latin typeface="Calibri"/>
                <a:cs typeface="Calibri"/>
              </a:rPr>
              <a:t>e</a:t>
            </a:r>
            <a:r>
              <a:rPr sz="816" spc="5" dirty="0">
                <a:latin typeface="Calibri"/>
                <a:cs typeface="Calibri"/>
              </a:rPr>
              <a:t>c</a:t>
            </a:r>
            <a:r>
              <a:rPr sz="816" dirty="0">
                <a:latin typeface="Calibri"/>
                <a:cs typeface="Calibri"/>
              </a:rPr>
              <a:t>p</a:t>
            </a:r>
            <a:r>
              <a:rPr sz="816" spc="5" dirty="0">
                <a:latin typeface="Calibri"/>
                <a:cs typeface="Calibri"/>
              </a:rPr>
              <a:t>r</a:t>
            </a:r>
            <a:r>
              <a:rPr sz="816" spc="-5" dirty="0">
                <a:latin typeface="Calibri"/>
                <a:cs typeface="Calibri"/>
              </a:rPr>
              <a:t>1</a:t>
            </a:r>
            <a:r>
              <a:rPr sz="816" dirty="0">
                <a:latin typeface="Calibri"/>
                <a:cs typeface="Calibri"/>
              </a:rPr>
              <a:t>: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37038" y="6538971"/>
            <a:ext cx="6192912" cy="182351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907756"/>
            <a:r>
              <a:rPr sz="816" spc="9" dirty="0">
                <a:latin typeface="Calibri"/>
                <a:cs typeface="Calibri"/>
              </a:rPr>
              <a:t>S</a:t>
            </a:r>
            <a:r>
              <a:rPr sz="816" spc="14" dirty="0">
                <a:latin typeface="Calibri"/>
                <a:cs typeface="Calibri"/>
              </a:rPr>
              <a:t>a</a:t>
            </a:r>
            <a:r>
              <a:rPr sz="816" spc="9" dirty="0">
                <a:latin typeface="Calibri"/>
                <a:cs typeface="Calibri"/>
              </a:rPr>
              <a:t>nge</a:t>
            </a:r>
            <a:r>
              <a:rPr sz="816" spc="5" dirty="0">
                <a:latin typeface="Calibri"/>
                <a:cs typeface="Calibri"/>
              </a:rPr>
              <a:t>r</a:t>
            </a:r>
            <a:r>
              <a:rPr sz="816" spc="-50" dirty="0">
                <a:latin typeface="Times New Roman"/>
                <a:cs typeface="Times New Roman"/>
              </a:rPr>
              <a:t> </a:t>
            </a:r>
            <a:r>
              <a:rPr sz="816" dirty="0">
                <a:latin typeface="Calibri"/>
                <a:cs typeface="Calibri"/>
              </a:rPr>
              <a:t>se</a:t>
            </a:r>
            <a:r>
              <a:rPr sz="816" spc="9" dirty="0">
                <a:latin typeface="Calibri"/>
                <a:cs typeface="Calibri"/>
              </a:rPr>
              <a:t>q</a:t>
            </a:r>
            <a:r>
              <a:rPr sz="816" dirty="0">
                <a:latin typeface="Calibri"/>
                <a:cs typeface="Calibri"/>
              </a:rPr>
              <a:t>uen</a:t>
            </a:r>
            <a:r>
              <a:rPr sz="816" spc="5" dirty="0">
                <a:latin typeface="Calibri"/>
                <a:cs typeface="Calibri"/>
              </a:rPr>
              <a:t>ci</a:t>
            </a:r>
            <a:r>
              <a:rPr sz="816" dirty="0">
                <a:latin typeface="Calibri"/>
                <a:cs typeface="Calibri"/>
              </a:rPr>
              <a:t>n</a:t>
            </a:r>
            <a:r>
              <a:rPr sz="816" spc="5" dirty="0">
                <a:latin typeface="Calibri"/>
                <a:cs typeface="Calibri"/>
              </a:rPr>
              <a:t>g</a:t>
            </a:r>
            <a:endParaRPr sz="816" dirty="0">
              <a:latin typeface="Calibri"/>
              <a:cs typeface="Calibri"/>
            </a:endParaRPr>
          </a:p>
          <a:p>
            <a:pPr>
              <a:spcBef>
                <a:spcPts val="8"/>
              </a:spcBef>
            </a:pPr>
            <a:endParaRPr sz="1133" dirty="0">
              <a:latin typeface="Times New Roman"/>
              <a:cs typeface="Times New Roman"/>
            </a:endParaRPr>
          </a:p>
          <a:p>
            <a:pPr marL="11506" marR="4602" algn="just">
              <a:lnSpc>
                <a:spcPct val="1548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spc="59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3" dirty="0">
                <a:latin typeface="Times New Roman"/>
                <a:cs typeface="Times New Roman"/>
              </a:rPr>
              <a:t>u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spc="68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5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73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14" dirty="0">
                <a:latin typeface="Times New Roman"/>
                <a:cs typeface="Times New Roman"/>
              </a:rPr>
              <a:t>ris</a:t>
            </a:r>
            <a:r>
              <a:rPr sz="1087" b="1" spc="33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/</a:t>
            </a:r>
            <a:r>
              <a:rPr sz="1087" b="1" spc="28" dirty="0">
                <a:latin typeface="Times New Roman"/>
                <a:cs typeface="Times New Roman"/>
              </a:rPr>
              <a:t>C</a:t>
            </a:r>
            <a:r>
              <a:rPr sz="1087" b="1" spc="14" dirty="0">
                <a:latin typeface="Times New Roman"/>
                <a:cs typeface="Times New Roman"/>
              </a:rPr>
              <a:t>as</a:t>
            </a:r>
            <a:r>
              <a:rPr sz="1087" b="1" spc="18" dirty="0">
                <a:latin typeface="Times New Roman"/>
                <a:cs typeface="Times New Roman"/>
              </a:rPr>
              <a:t>9</a:t>
            </a:r>
            <a:r>
              <a:rPr sz="1087" b="1" spc="7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g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spc="78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d</a:t>
            </a:r>
            <a:r>
              <a:rPr sz="1087" b="1" spc="9" dirty="0">
                <a:latin typeface="Times New Roman"/>
                <a:cs typeface="Times New Roman"/>
              </a:rPr>
              <a:t>it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g</a:t>
            </a:r>
            <a:r>
              <a:rPr sz="1087" b="1" spc="59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of</a:t>
            </a:r>
            <a:r>
              <a:rPr sz="1087" b="1" spc="73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T</a:t>
            </a:r>
            <a:r>
              <a:rPr sz="1087" b="1" spc="23" dirty="0">
                <a:latin typeface="Times New Roman"/>
                <a:cs typeface="Times New Roman"/>
              </a:rPr>
              <a:t>e</a:t>
            </a:r>
            <a:r>
              <a:rPr sz="1087" b="1" spc="14" dirty="0">
                <a:latin typeface="Times New Roman"/>
                <a:cs typeface="Times New Roman"/>
              </a:rPr>
              <a:t>c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1</a:t>
            </a:r>
            <a:r>
              <a:rPr sz="1087" b="1" spc="68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9" dirty="0">
                <a:latin typeface="Times New Roman"/>
                <a:cs typeface="Times New Roman"/>
              </a:rPr>
              <a:t>si</a:t>
            </a:r>
            <a:r>
              <a:rPr sz="1087" b="1" spc="33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g</a:t>
            </a:r>
            <a:r>
              <a:rPr sz="1087" b="1" spc="59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cu</a:t>
            </a:r>
            <a:r>
              <a:rPr sz="1087" b="1" spc="9" dirty="0">
                <a:latin typeface="Times New Roman"/>
                <a:cs typeface="Times New Roman"/>
              </a:rPr>
              <a:t>s</a:t>
            </a:r>
            <a:r>
              <a:rPr sz="1087" b="1" spc="14" dirty="0">
                <a:latin typeface="Times New Roman"/>
                <a:cs typeface="Times New Roman"/>
              </a:rPr>
              <a:t>to</a:t>
            </a:r>
            <a:r>
              <a:rPr sz="1087" b="1" spc="36" dirty="0">
                <a:latin typeface="Times New Roman"/>
                <a:cs typeface="Times New Roman"/>
              </a:rPr>
              <a:t>m</a:t>
            </a:r>
            <a:r>
              <a:rPr sz="1087" b="1" spc="68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R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33" dirty="0">
                <a:latin typeface="Times New Roman"/>
                <a:cs typeface="Times New Roman"/>
              </a:rPr>
              <a:t>S</a:t>
            </a:r>
            <a:r>
              <a:rPr sz="1087" b="1" spc="28" dirty="0">
                <a:latin typeface="Times New Roman"/>
                <a:cs typeface="Times New Roman"/>
              </a:rPr>
              <a:t>PR</a:t>
            </a:r>
            <a:r>
              <a:rPr sz="1087" b="1" spc="68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g</a:t>
            </a:r>
            <a:r>
              <a:rPr sz="1087" b="1" spc="28" dirty="0">
                <a:latin typeface="Times New Roman"/>
                <a:cs typeface="Times New Roman"/>
              </a:rPr>
              <a:t>RNA</a:t>
            </a:r>
            <a:r>
              <a:rPr sz="1087" b="1" spc="63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ivir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s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tr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9" dirty="0">
                <a:latin typeface="Times New Roman"/>
                <a:cs typeface="Times New Roman"/>
              </a:rPr>
              <a:t>s</a:t>
            </a:r>
            <a:r>
              <a:rPr sz="1087" b="1" spc="33" dirty="0">
                <a:latin typeface="Times New Roman"/>
                <a:cs typeface="Times New Roman"/>
              </a:rPr>
              <a:t>d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ctio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68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A</a:t>
            </a:r>
            <a:r>
              <a:rPr sz="1087" spc="6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sequence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sc</a:t>
            </a:r>
            <a:r>
              <a:rPr sz="1087" spc="33" dirty="0">
                <a:latin typeface="Times New Roman"/>
                <a:cs typeface="Times New Roman"/>
              </a:rPr>
              <a:t>h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3" dirty="0">
                <a:latin typeface="Times New Roman"/>
                <a:cs typeface="Times New Roman"/>
              </a:rPr>
              <a:t>ma</a:t>
            </a:r>
            <a:r>
              <a:rPr sz="1087" spc="14" dirty="0">
                <a:latin typeface="Times New Roman"/>
                <a:cs typeface="Times New Roman"/>
              </a:rPr>
              <a:t>tic</a:t>
            </a:r>
            <a:r>
              <a:rPr sz="1087" spc="6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high</a:t>
            </a:r>
            <a:r>
              <a:rPr sz="1087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gh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i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q</a:t>
            </a:r>
            <a:r>
              <a:rPr sz="1087" spc="18" dirty="0">
                <a:latin typeface="Times New Roman"/>
                <a:cs typeface="Times New Roman"/>
              </a:rPr>
              <a:t>uence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6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6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36" dirty="0">
                <a:latin typeface="Times New Roman"/>
                <a:cs typeface="Times New Roman"/>
              </a:rPr>
              <a:t>RNA</a:t>
            </a:r>
            <a:r>
              <a:rPr sz="1087" spc="6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loc</a:t>
            </a:r>
            <a:r>
              <a:rPr sz="1087" spc="5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ion</a:t>
            </a:r>
            <a:r>
              <a:rPr sz="1087" spc="5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6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54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spc="9" dirty="0">
                <a:latin typeface="Times New Roman"/>
                <a:cs typeface="Times New Roman"/>
              </a:rPr>
              <a:t> sit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</a:t>
            </a:r>
            <a:r>
              <a:rPr sz="1087" spc="14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p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28" dirty="0">
                <a:latin typeface="Times New Roman"/>
                <a:cs typeface="Times New Roman"/>
              </a:rPr>
              <a:t>1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b="1" spc="18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l</a:t>
            </a:r>
            <a:r>
              <a:rPr sz="1087" b="1" spc="36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A</a:t>
            </a:r>
            <a:r>
              <a:rPr sz="1087" spc="23" dirty="0">
                <a:latin typeface="Times New Roman"/>
                <a:cs typeface="Times New Roman"/>
              </a:rPr>
              <a:t>)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r>
              <a:rPr sz="1087" spc="41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q</a:t>
            </a:r>
            <a:r>
              <a:rPr sz="1087" spc="18" dirty="0">
                <a:latin typeface="Times New Roman"/>
                <a:cs typeface="Times New Roman"/>
              </a:rPr>
              <a:t>ue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l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gn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18" dirty="0">
                <a:latin typeface="Times New Roman"/>
                <a:cs typeface="Times New Roman"/>
              </a:rPr>
              <a:t>en</a:t>
            </a:r>
            <a:r>
              <a:rPr sz="1087" spc="14" dirty="0">
                <a:latin typeface="Times New Roman"/>
                <a:cs typeface="Times New Roman"/>
              </a:rPr>
              <a:t>ts</a:t>
            </a:r>
            <a:r>
              <a:rPr sz="1087" spc="41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50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he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18" dirty="0">
                <a:latin typeface="Times New Roman"/>
                <a:cs typeface="Times New Roman"/>
              </a:rPr>
              <a:t>gion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se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tant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b="1" spc="18" dirty="0">
                <a:latin typeface="Times New Roman"/>
                <a:cs typeface="Times New Roman"/>
              </a:rPr>
              <a:t>pan</a:t>
            </a:r>
            <a:r>
              <a:rPr sz="1087" b="1" spc="9" dirty="0">
                <a:latin typeface="Times New Roman"/>
                <a:cs typeface="Times New Roman"/>
              </a:rPr>
              <a:t>el</a:t>
            </a:r>
            <a:r>
              <a:rPr sz="1087" b="1" spc="50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B</a:t>
            </a:r>
            <a:r>
              <a:rPr sz="1087" spc="23" dirty="0">
                <a:latin typeface="Times New Roman"/>
                <a:cs typeface="Times New Roman"/>
              </a:rPr>
              <a:t>).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A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in</a:t>
            </a:r>
            <a:r>
              <a:rPr sz="1087" spc="18" dirty="0">
                <a:latin typeface="Times New Roman"/>
                <a:cs typeface="Times New Roman"/>
              </a:rPr>
              <a:t>se</a:t>
            </a:r>
            <a:r>
              <a:rPr sz="1087" spc="9" dirty="0">
                <a:latin typeface="Times New Roman"/>
                <a:cs typeface="Times New Roman"/>
              </a:rPr>
              <a:t>rt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8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d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tec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8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h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36" dirty="0">
                <a:latin typeface="Times New Roman"/>
                <a:cs typeface="Times New Roman"/>
              </a:rPr>
              <a:t>RN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28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q</a:t>
            </a:r>
            <a:r>
              <a:rPr sz="1087" spc="33" dirty="0">
                <a:latin typeface="Times New Roman"/>
                <a:cs typeface="Times New Roman"/>
              </a:rPr>
              <a:t>u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,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h</a:t>
            </a:r>
            <a:r>
              <a:rPr sz="1087" spc="5" dirty="0">
                <a:latin typeface="Times New Roman"/>
                <a:cs typeface="Times New Roman"/>
              </a:rPr>
              <a:t>i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28" dirty="0">
                <a:latin typeface="Times New Roman"/>
                <a:cs typeface="Times New Roman"/>
              </a:rPr>
              <a:t>h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8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33" dirty="0">
                <a:latin typeface="Times New Roman"/>
                <a:cs typeface="Times New Roman"/>
              </a:rPr>
              <a:t>du</a:t>
            </a:r>
            <a:r>
              <a:rPr sz="1087" spc="9" dirty="0">
                <a:latin typeface="Times New Roman"/>
                <a:cs typeface="Times New Roman"/>
              </a:rPr>
              <a:t>ce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50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sh</a:t>
            </a:r>
            <a:r>
              <a:rPr sz="1087" spc="9" dirty="0">
                <a:latin typeface="Times New Roman"/>
                <a:cs typeface="Times New Roman"/>
              </a:rPr>
              <a:t>if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p</a:t>
            </a:r>
            <a:r>
              <a:rPr sz="1087" spc="14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a</a:t>
            </a:r>
            <a:r>
              <a:rPr sz="1087" spc="9" dirty="0">
                <a:latin typeface="Times New Roman"/>
                <a:cs typeface="Times New Roman"/>
              </a:rPr>
              <a:t>tu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to</a:t>
            </a:r>
            <a:r>
              <a:rPr sz="1087" spc="28" dirty="0">
                <a:latin typeface="Times New Roman"/>
                <a:cs typeface="Times New Roman"/>
              </a:rPr>
              <a:t>p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2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o</a:t>
            </a:r>
            <a:r>
              <a:rPr sz="1087" spc="33" dirty="0">
                <a:latin typeface="Times New Roman"/>
                <a:cs typeface="Times New Roman"/>
              </a:rPr>
              <a:t>d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 wit</a:t>
            </a:r>
            <a:r>
              <a:rPr sz="1087" spc="9" dirty="0">
                <a:latin typeface="Times New Roman"/>
                <a:cs typeface="Times New Roman"/>
              </a:rPr>
              <a:t>h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ex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1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he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36" dirty="0">
                <a:latin typeface="Times New Roman"/>
                <a:cs typeface="Times New Roman"/>
              </a:rPr>
              <a:t>H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do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cpr</a:t>
            </a:r>
            <a:r>
              <a:rPr sz="1087" spc="33" dirty="0">
                <a:latin typeface="Times New Roman"/>
                <a:cs typeface="Times New Roman"/>
              </a:rPr>
              <a:t>1</a:t>
            </a:r>
            <a:r>
              <a:rPr sz="1087" spc="14" dirty="0">
                <a:latin typeface="Times New Roman"/>
                <a:cs typeface="Times New Roman"/>
              </a:rPr>
              <a:t>,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su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5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ing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r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ated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cpr</a:t>
            </a:r>
            <a:r>
              <a:rPr sz="1087" spc="45" dirty="0">
                <a:latin typeface="Times New Roman"/>
                <a:cs typeface="Times New Roman"/>
              </a:rPr>
              <a:t>1</a:t>
            </a:r>
            <a:r>
              <a:rPr sz="1087" spc="33" dirty="0">
                <a:latin typeface="Times New Roman"/>
                <a:cs typeface="Times New Roman"/>
              </a:rPr>
              <a:t>*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b="1" spc="18" dirty="0">
                <a:latin typeface="Times New Roman"/>
                <a:cs typeface="Times New Roman"/>
              </a:rPr>
              <a:t>pan</a:t>
            </a:r>
            <a:r>
              <a:rPr sz="1087" b="1" spc="9" dirty="0">
                <a:latin typeface="Times New Roman"/>
                <a:cs typeface="Times New Roman"/>
              </a:rPr>
              <a:t>el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C</a:t>
            </a:r>
            <a:r>
              <a:rPr sz="1087" spc="23" dirty="0">
                <a:latin typeface="Times New Roman"/>
                <a:cs typeface="Times New Roman"/>
              </a:rPr>
              <a:t>).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S</a:t>
            </a:r>
            <a:r>
              <a:rPr sz="1087" spc="18" dirty="0">
                <a:latin typeface="Times New Roman"/>
                <a:cs typeface="Times New Roman"/>
              </a:rPr>
              <a:t>an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seq</a:t>
            </a:r>
            <a:r>
              <a:rPr sz="1087" spc="33" dirty="0">
                <a:latin typeface="Times New Roman"/>
                <a:cs typeface="Times New Roman"/>
              </a:rPr>
              <a:t>u</a:t>
            </a:r>
            <a:r>
              <a:rPr sz="1087" spc="18" dirty="0">
                <a:latin typeface="Times New Roman"/>
                <a:cs typeface="Times New Roman"/>
              </a:rPr>
              <a:t>e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 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su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5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b="1" spc="18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l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D</a:t>
            </a:r>
            <a:r>
              <a:rPr sz="1087" spc="18" dirty="0">
                <a:latin typeface="Times New Roman"/>
                <a:cs typeface="Times New Roman"/>
              </a:rPr>
              <a:t>).</a:t>
            </a:r>
            <a:endParaRPr sz="1087" dirty="0">
              <a:latin typeface="Times New Roman"/>
              <a:cs typeface="Times New Roman"/>
            </a:endParaRPr>
          </a:p>
        </p:txBody>
      </p:sp>
      <p:sp>
        <p:nvSpPr>
          <p:cNvPr id="12" name="object 12"/>
          <p:cNvSpPr/>
          <p:nvPr/>
        </p:nvSpPr>
        <p:spPr>
          <a:xfrm>
            <a:off x="1624748" y="3908536"/>
            <a:ext cx="3717818" cy="621362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3323025" y="1485108"/>
            <a:ext cx="111843" cy="151888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1921507" y="1483727"/>
            <a:ext cx="2684284" cy="745634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1891129" y="2131324"/>
            <a:ext cx="2605580" cy="546799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2102392" y="3037132"/>
            <a:ext cx="25315" cy="25315"/>
          </a:xfrm>
          <a:custGeom>
            <a:avLst/>
            <a:gdLst/>
            <a:ahLst/>
            <a:cxnLst/>
            <a:rect l="l" t="t" r="r" b="b"/>
            <a:pathLst>
              <a:path w="27939" h="27939">
                <a:moveTo>
                  <a:pt x="18288" y="0"/>
                </a:moveTo>
                <a:lnTo>
                  <a:pt x="0" y="9144"/>
                </a:lnTo>
                <a:lnTo>
                  <a:pt x="9144" y="27432"/>
                </a:lnTo>
                <a:lnTo>
                  <a:pt x="27432" y="18288"/>
                </a:lnTo>
                <a:lnTo>
                  <a:pt x="18288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/>
          <p:nvPr/>
        </p:nvSpPr>
        <p:spPr>
          <a:xfrm>
            <a:off x="2168671" y="2976378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1628" y="0"/>
                </a:moveTo>
                <a:lnTo>
                  <a:pt x="0" y="38100"/>
                </a:lnTo>
                <a:lnTo>
                  <a:pt x="9144" y="56388"/>
                </a:lnTo>
                <a:lnTo>
                  <a:pt x="82296" y="18288"/>
                </a:lnTo>
                <a:lnTo>
                  <a:pt x="71628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/>
          <p:nvPr/>
        </p:nvSpPr>
        <p:spPr>
          <a:xfrm>
            <a:off x="2283278" y="2915622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3152" y="0"/>
                </a:moveTo>
                <a:lnTo>
                  <a:pt x="0" y="38100"/>
                </a:lnTo>
                <a:lnTo>
                  <a:pt x="9144" y="56388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/>
          <p:nvPr/>
        </p:nvSpPr>
        <p:spPr>
          <a:xfrm>
            <a:off x="2397882" y="2854867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3152" y="0"/>
                </a:moveTo>
                <a:lnTo>
                  <a:pt x="0" y="38100"/>
                </a:lnTo>
                <a:lnTo>
                  <a:pt x="10668" y="56388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2513872" y="2792730"/>
            <a:ext cx="74794" cy="52931"/>
          </a:xfrm>
          <a:custGeom>
            <a:avLst/>
            <a:gdLst/>
            <a:ahLst/>
            <a:cxnLst/>
            <a:rect l="l" t="t" r="r" b="b"/>
            <a:pathLst>
              <a:path w="82550" h="58419">
                <a:moveTo>
                  <a:pt x="73152" y="0"/>
                </a:moveTo>
                <a:lnTo>
                  <a:pt x="0" y="39624"/>
                </a:lnTo>
                <a:lnTo>
                  <a:pt x="9144" y="57912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2628478" y="2731976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3152" y="0"/>
                </a:moveTo>
                <a:lnTo>
                  <a:pt x="0" y="38100"/>
                </a:lnTo>
                <a:lnTo>
                  <a:pt x="10668" y="56388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/>
          <p:nvPr/>
        </p:nvSpPr>
        <p:spPr>
          <a:xfrm>
            <a:off x="2704423" y="2321877"/>
            <a:ext cx="26465" cy="26465"/>
          </a:xfrm>
          <a:custGeom>
            <a:avLst/>
            <a:gdLst/>
            <a:ahLst/>
            <a:cxnLst/>
            <a:rect l="l" t="t" r="r" b="b"/>
            <a:pathLst>
              <a:path w="29210" h="29210">
                <a:moveTo>
                  <a:pt x="16764" y="0"/>
                </a:moveTo>
                <a:lnTo>
                  <a:pt x="0" y="12192"/>
                </a:lnTo>
                <a:lnTo>
                  <a:pt x="12192" y="28956"/>
                </a:lnTo>
                <a:lnTo>
                  <a:pt x="28956" y="16764"/>
                </a:lnTo>
                <a:lnTo>
                  <a:pt x="16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/>
          <p:nvPr/>
        </p:nvSpPr>
        <p:spPr>
          <a:xfrm>
            <a:off x="2744467" y="2671220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3152" y="0"/>
                </a:moveTo>
                <a:lnTo>
                  <a:pt x="0" y="38100"/>
                </a:lnTo>
                <a:lnTo>
                  <a:pt x="9144" y="56388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/>
          <p:nvPr/>
        </p:nvSpPr>
        <p:spPr>
          <a:xfrm>
            <a:off x="2763799" y="2241789"/>
            <a:ext cx="70766" cy="60985"/>
          </a:xfrm>
          <a:custGeom>
            <a:avLst/>
            <a:gdLst/>
            <a:ahLst/>
            <a:cxnLst/>
            <a:rect l="l" t="t" r="r" b="b"/>
            <a:pathLst>
              <a:path w="78105" h="67310">
                <a:moveTo>
                  <a:pt x="64008" y="0"/>
                </a:moveTo>
                <a:lnTo>
                  <a:pt x="0" y="50292"/>
                </a:lnTo>
                <a:lnTo>
                  <a:pt x="12192" y="67056"/>
                </a:lnTo>
                <a:lnTo>
                  <a:pt x="77724" y="16764"/>
                </a:lnTo>
                <a:lnTo>
                  <a:pt x="64008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2859073" y="2610464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3152" y="0"/>
                </a:moveTo>
                <a:lnTo>
                  <a:pt x="0" y="38100"/>
                </a:lnTo>
                <a:lnTo>
                  <a:pt x="10668" y="56388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2865977" y="2163083"/>
            <a:ext cx="70766" cy="59835"/>
          </a:xfrm>
          <a:custGeom>
            <a:avLst/>
            <a:gdLst/>
            <a:ahLst/>
            <a:cxnLst/>
            <a:rect l="l" t="t" r="r" b="b"/>
            <a:pathLst>
              <a:path w="78105" h="66039">
                <a:moveTo>
                  <a:pt x="65532" y="0"/>
                </a:moveTo>
                <a:lnTo>
                  <a:pt x="0" y="50292"/>
                </a:lnTo>
                <a:lnTo>
                  <a:pt x="13716" y="65532"/>
                </a:lnTo>
                <a:lnTo>
                  <a:pt x="77724" y="15240"/>
                </a:lnTo>
                <a:lnTo>
                  <a:pt x="6553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2969538" y="2082996"/>
            <a:ext cx="70766" cy="60985"/>
          </a:xfrm>
          <a:custGeom>
            <a:avLst/>
            <a:gdLst/>
            <a:ahLst/>
            <a:cxnLst/>
            <a:rect l="l" t="t" r="r" b="b"/>
            <a:pathLst>
              <a:path w="78104" h="67310">
                <a:moveTo>
                  <a:pt x="65532" y="0"/>
                </a:moveTo>
                <a:lnTo>
                  <a:pt x="0" y="50292"/>
                </a:lnTo>
                <a:lnTo>
                  <a:pt x="12192" y="67056"/>
                </a:lnTo>
                <a:lnTo>
                  <a:pt x="77724" y="16764"/>
                </a:lnTo>
                <a:lnTo>
                  <a:pt x="6553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2975060" y="2549709"/>
            <a:ext cx="74794" cy="51205"/>
          </a:xfrm>
          <a:custGeom>
            <a:avLst/>
            <a:gdLst/>
            <a:ahLst/>
            <a:cxnLst/>
            <a:rect l="l" t="t" r="r" b="b"/>
            <a:pathLst>
              <a:path w="82550" h="56514">
                <a:moveTo>
                  <a:pt x="71628" y="0"/>
                </a:moveTo>
                <a:lnTo>
                  <a:pt x="0" y="38100"/>
                </a:lnTo>
                <a:lnTo>
                  <a:pt x="9144" y="56388"/>
                </a:lnTo>
                <a:lnTo>
                  <a:pt x="82296" y="18288"/>
                </a:lnTo>
                <a:lnTo>
                  <a:pt x="71628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/>
          <p:nvPr/>
        </p:nvSpPr>
        <p:spPr>
          <a:xfrm>
            <a:off x="3073098" y="2002909"/>
            <a:ext cx="70766" cy="60985"/>
          </a:xfrm>
          <a:custGeom>
            <a:avLst/>
            <a:gdLst/>
            <a:ahLst/>
            <a:cxnLst/>
            <a:rect l="l" t="t" r="r" b="b"/>
            <a:pathLst>
              <a:path w="78104" h="67310">
                <a:moveTo>
                  <a:pt x="65532" y="0"/>
                </a:moveTo>
                <a:lnTo>
                  <a:pt x="0" y="50292"/>
                </a:lnTo>
                <a:lnTo>
                  <a:pt x="12192" y="67056"/>
                </a:lnTo>
                <a:lnTo>
                  <a:pt x="77724" y="16764"/>
                </a:lnTo>
                <a:lnTo>
                  <a:pt x="6553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/>
          <p:nvPr/>
        </p:nvSpPr>
        <p:spPr>
          <a:xfrm>
            <a:off x="3089668" y="2487573"/>
            <a:ext cx="74794" cy="52931"/>
          </a:xfrm>
          <a:custGeom>
            <a:avLst/>
            <a:gdLst/>
            <a:ahLst/>
            <a:cxnLst/>
            <a:rect l="l" t="t" r="r" b="b"/>
            <a:pathLst>
              <a:path w="82550" h="58419">
                <a:moveTo>
                  <a:pt x="73152" y="0"/>
                </a:moveTo>
                <a:lnTo>
                  <a:pt x="0" y="39624"/>
                </a:lnTo>
                <a:lnTo>
                  <a:pt x="10668" y="57912"/>
                </a:lnTo>
                <a:lnTo>
                  <a:pt x="82296" y="18288"/>
                </a:lnTo>
                <a:lnTo>
                  <a:pt x="7315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" name="object 31"/>
          <p:cNvSpPr/>
          <p:nvPr/>
        </p:nvSpPr>
        <p:spPr>
          <a:xfrm>
            <a:off x="3176659" y="1924203"/>
            <a:ext cx="70766" cy="59835"/>
          </a:xfrm>
          <a:custGeom>
            <a:avLst/>
            <a:gdLst/>
            <a:ahLst/>
            <a:cxnLst/>
            <a:rect l="l" t="t" r="r" b="b"/>
            <a:pathLst>
              <a:path w="78104" h="66039">
                <a:moveTo>
                  <a:pt x="65532" y="0"/>
                </a:moveTo>
                <a:lnTo>
                  <a:pt x="0" y="50292"/>
                </a:lnTo>
                <a:lnTo>
                  <a:pt x="12192" y="65532"/>
                </a:lnTo>
                <a:lnTo>
                  <a:pt x="77724" y="16764"/>
                </a:lnTo>
                <a:lnTo>
                  <a:pt x="6553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3334070" y="2482049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3820" y="35052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3451438" y="2538661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3820" y="36576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/>
          <p:nvPr/>
        </p:nvSpPr>
        <p:spPr>
          <a:xfrm>
            <a:off x="3510814" y="1917299"/>
            <a:ext cx="71917" cy="60985"/>
          </a:xfrm>
          <a:custGeom>
            <a:avLst/>
            <a:gdLst/>
            <a:ahLst/>
            <a:cxnLst/>
            <a:rect l="l" t="t" r="r" b="b"/>
            <a:pathLst>
              <a:path w="79375" h="67310">
                <a:moveTo>
                  <a:pt x="13716" y="0"/>
                </a:moveTo>
                <a:lnTo>
                  <a:pt x="0" y="16764"/>
                </a:lnTo>
                <a:lnTo>
                  <a:pt x="67056" y="67056"/>
                </a:lnTo>
                <a:lnTo>
                  <a:pt x="79248" y="50292"/>
                </a:lnTo>
                <a:lnTo>
                  <a:pt x="1371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5" name="object 35"/>
          <p:cNvSpPr/>
          <p:nvPr/>
        </p:nvSpPr>
        <p:spPr>
          <a:xfrm>
            <a:off x="3568806" y="2595274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9812"/>
                </a:lnTo>
                <a:lnTo>
                  <a:pt x="74676" y="54864"/>
                </a:lnTo>
                <a:lnTo>
                  <a:pt x="83820" y="36576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/>
          <p:nvPr/>
        </p:nvSpPr>
        <p:spPr>
          <a:xfrm>
            <a:off x="3615755" y="1996005"/>
            <a:ext cx="70766" cy="59835"/>
          </a:xfrm>
          <a:custGeom>
            <a:avLst/>
            <a:gdLst/>
            <a:ahLst/>
            <a:cxnLst/>
            <a:rect l="l" t="t" r="r" b="b"/>
            <a:pathLst>
              <a:path w="78104" h="66039">
                <a:moveTo>
                  <a:pt x="12192" y="0"/>
                </a:moveTo>
                <a:lnTo>
                  <a:pt x="0" y="16764"/>
                </a:lnTo>
                <a:lnTo>
                  <a:pt x="65532" y="65532"/>
                </a:lnTo>
                <a:lnTo>
                  <a:pt x="77724" y="48768"/>
                </a:lnTo>
                <a:lnTo>
                  <a:pt x="121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7" name="object 37"/>
          <p:cNvSpPr/>
          <p:nvPr/>
        </p:nvSpPr>
        <p:spPr>
          <a:xfrm>
            <a:off x="3686175" y="2653268"/>
            <a:ext cx="75944" cy="48328"/>
          </a:xfrm>
          <a:custGeom>
            <a:avLst/>
            <a:gdLst/>
            <a:ahLst/>
            <a:cxnLst/>
            <a:rect l="l" t="t" r="r" b="b"/>
            <a:pathLst>
              <a:path w="83820" h="53339">
                <a:moveTo>
                  <a:pt x="9144" y="0"/>
                </a:moveTo>
                <a:lnTo>
                  <a:pt x="0" y="18288"/>
                </a:lnTo>
                <a:lnTo>
                  <a:pt x="74676" y="53340"/>
                </a:lnTo>
                <a:lnTo>
                  <a:pt x="83820" y="35052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/>
          <p:nvPr/>
        </p:nvSpPr>
        <p:spPr>
          <a:xfrm>
            <a:off x="3720696" y="2073330"/>
            <a:ext cx="70766" cy="60985"/>
          </a:xfrm>
          <a:custGeom>
            <a:avLst/>
            <a:gdLst/>
            <a:ahLst/>
            <a:cxnLst/>
            <a:rect l="l" t="t" r="r" b="b"/>
            <a:pathLst>
              <a:path w="78104" h="67310">
                <a:moveTo>
                  <a:pt x="12192" y="0"/>
                </a:moveTo>
                <a:lnTo>
                  <a:pt x="0" y="16764"/>
                </a:lnTo>
                <a:lnTo>
                  <a:pt x="65532" y="67056"/>
                </a:lnTo>
                <a:lnTo>
                  <a:pt x="77724" y="50292"/>
                </a:lnTo>
                <a:lnTo>
                  <a:pt x="121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9" name="object 39"/>
          <p:cNvSpPr/>
          <p:nvPr/>
        </p:nvSpPr>
        <p:spPr>
          <a:xfrm>
            <a:off x="3803545" y="2709882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3820" y="35052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/>
          <p:nvPr/>
        </p:nvSpPr>
        <p:spPr>
          <a:xfrm>
            <a:off x="3825638" y="2152036"/>
            <a:ext cx="70766" cy="59835"/>
          </a:xfrm>
          <a:custGeom>
            <a:avLst/>
            <a:gdLst/>
            <a:ahLst/>
            <a:cxnLst/>
            <a:rect l="l" t="t" r="r" b="b"/>
            <a:pathLst>
              <a:path w="78104" h="66039">
                <a:moveTo>
                  <a:pt x="12192" y="0"/>
                </a:moveTo>
                <a:lnTo>
                  <a:pt x="0" y="16764"/>
                </a:lnTo>
                <a:lnTo>
                  <a:pt x="65532" y="65532"/>
                </a:lnTo>
                <a:lnTo>
                  <a:pt x="77724" y="48768"/>
                </a:lnTo>
                <a:lnTo>
                  <a:pt x="121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1" name="object 41"/>
          <p:cNvSpPr/>
          <p:nvPr/>
        </p:nvSpPr>
        <p:spPr>
          <a:xfrm>
            <a:off x="3920913" y="2766495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3820" y="36576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3929199" y="2229362"/>
            <a:ext cx="71917" cy="60985"/>
          </a:xfrm>
          <a:custGeom>
            <a:avLst/>
            <a:gdLst/>
            <a:ahLst/>
            <a:cxnLst/>
            <a:rect l="l" t="t" r="r" b="b"/>
            <a:pathLst>
              <a:path w="79375" h="67310">
                <a:moveTo>
                  <a:pt x="12192" y="0"/>
                </a:moveTo>
                <a:lnTo>
                  <a:pt x="0" y="16764"/>
                </a:lnTo>
                <a:lnTo>
                  <a:pt x="65532" y="67056"/>
                </a:lnTo>
                <a:lnTo>
                  <a:pt x="79248" y="50292"/>
                </a:lnTo>
                <a:lnTo>
                  <a:pt x="121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/>
          <p:nvPr/>
        </p:nvSpPr>
        <p:spPr>
          <a:xfrm>
            <a:off x="4034137" y="2308069"/>
            <a:ext cx="44302" cy="40273"/>
          </a:xfrm>
          <a:custGeom>
            <a:avLst/>
            <a:gdLst/>
            <a:ahLst/>
            <a:cxnLst/>
            <a:rect l="l" t="t" r="r" b="b"/>
            <a:pathLst>
              <a:path w="48895" h="44450">
                <a:moveTo>
                  <a:pt x="12192" y="0"/>
                </a:moveTo>
                <a:lnTo>
                  <a:pt x="0" y="16764"/>
                </a:lnTo>
                <a:lnTo>
                  <a:pt x="36576" y="44196"/>
                </a:lnTo>
                <a:lnTo>
                  <a:pt x="48768" y="27432"/>
                </a:lnTo>
                <a:lnTo>
                  <a:pt x="121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4" name="object 44"/>
          <p:cNvSpPr/>
          <p:nvPr/>
        </p:nvSpPr>
        <p:spPr>
          <a:xfrm>
            <a:off x="4038282" y="2823107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9812"/>
                </a:lnTo>
                <a:lnTo>
                  <a:pt x="74676" y="54864"/>
                </a:lnTo>
                <a:lnTo>
                  <a:pt x="83820" y="36576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5" name="object 45"/>
          <p:cNvSpPr/>
          <p:nvPr/>
        </p:nvSpPr>
        <p:spPr>
          <a:xfrm>
            <a:off x="4155649" y="2881102"/>
            <a:ext cx="75944" cy="48328"/>
          </a:xfrm>
          <a:custGeom>
            <a:avLst/>
            <a:gdLst/>
            <a:ahLst/>
            <a:cxnLst/>
            <a:rect l="l" t="t" r="r" b="b"/>
            <a:pathLst>
              <a:path w="83820" h="53339">
                <a:moveTo>
                  <a:pt x="9144" y="0"/>
                </a:moveTo>
                <a:lnTo>
                  <a:pt x="0" y="18288"/>
                </a:lnTo>
                <a:lnTo>
                  <a:pt x="74676" y="53340"/>
                </a:lnTo>
                <a:lnTo>
                  <a:pt x="83820" y="35052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6" name="object 46"/>
          <p:cNvSpPr/>
          <p:nvPr/>
        </p:nvSpPr>
        <p:spPr>
          <a:xfrm>
            <a:off x="4273018" y="2937715"/>
            <a:ext cx="75944" cy="50053"/>
          </a:xfrm>
          <a:custGeom>
            <a:avLst/>
            <a:gdLst/>
            <a:ahLst/>
            <a:cxnLst/>
            <a:rect l="l" t="t" r="r" b="b"/>
            <a:pathLst>
              <a:path w="8382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3820" y="35052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7" name="object 47"/>
          <p:cNvSpPr/>
          <p:nvPr/>
        </p:nvSpPr>
        <p:spPr>
          <a:xfrm>
            <a:off x="4390387" y="2994328"/>
            <a:ext cx="74794" cy="50053"/>
          </a:xfrm>
          <a:custGeom>
            <a:avLst/>
            <a:gdLst/>
            <a:ahLst/>
            <a:cxnLst/>
            <a:rect l="l" t="t" r="r" b="b"/>
            <a:pathLst>
              <a:path w="82550" h="55244">
                <a:moveTo>
                  <a:pt x="9144" y="0"/>
                </a:moveTo>
                <a:lnTo>
                  <a:pt x="0" y="18288"/>
                </a:lnTo>
                <a:lnTo>
                  <a:pt x="74676" y="54864"/>
                </a:lnTo>
                <a:lnTo>
                  <a:pt x="82296" y="36576"/>
                </a:lnTo>
                <a:lnTo>
                  <a:pt x="914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8" name="object 48"/>
          <p:cNvSpPr/>
          <p:nvPr/>
        </p:nvSpPr>
        <p:spPr>
          <a:xfrm>
            <a:off x="3072294" y="1675773"/>
            <a:ext cx="190551" cy="828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9" name="object 49"/>
          <p:cNvSpPr/>
          <p:nvPr/>
        </p:nvSpPr>
        <p:spPr>
          <a:xfrm>
            <a:off x="2312849" y="3009631"/>
            <a:ext cx="172601" cy="71802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0" name="object 50"/>
          <p:cNvSpPr/>
          <p:nvPr/>
        </p:nvSpPr>
        <p:spPr>
          <a:xfrm>
            <a:off x="2776570" y="4912761"/>
            <a:ext cx="1517620" cy="481406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1" name="object 51"/>
          <p:cNvSpPr/>
          <p:nvPr/>
        </p:nvSpPr>
        <p:spPr>
          <a:xfrm>
            <a:off x="4290047" y="5000638"/>
            <a:ext cx="0" cy="212874"/>
          </a:xfrm>
          <a:custGeom>
            <a:avLst/>
            <a:gdLst/>
            <a:ahLst/>
            <a:cxnLst/>
            <a:rect l="l" t="t" r="r" b="b"/>
            <a:pathLst>
              <a:path h="234950">
                <a:moveTo>
                  <a:pt x="0" y="0"/>
                </a:moveTo>
                <a:lnTo>
                  <a:pt x="0" y="234696"/>
                </a:lnTo>
              </a:path>
            </a:pathLst>
          </a:custGeom>
          <a:ln w="30480">
            <a:solidFill>
              <a:srgbClr val="BF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2" name="object 52"/>
          <p:cNvSpPr/>
          <p:nvPr/>
        </p:nvSpPr>
        <p:spPr>
          <a:xfrm>
            <a:off x="3833002" y="4647155"/>
            <a:ext cx="0" cy="209997"/>
          </a:xfrm>
          <a:custGeom>
            <a:avLst/>
            <a:gdLst/>
            <a:ahLst/>
            <a:cxnLst/>
            <a:rect l="l" t="t" r="r" b="b"/>
            <a:pathLst>
              <a:path h="231775">
                <a:moveTo>
                  <a:pt x="0" y="0"/>
                </a:moveTo>
                <a:lnTo>
                  <a:pt x="0" y="231645"/>
                </a:lnTo>
              </a:path>
            </a:pathLst>
          </a:custGeom>
          <a:ln w="3175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3" name="object 53"/>
          <p:cNvSpPr/>
          <p:nvPr/>
        </p:nvSpPr>
        <p:spPr>
          <a:xfrm>
            <a:off x="3791577" y="4843226"/>
            <a:ext cx="77095" cy="82849"/>
          </a:xfrm>
          <a:custGeom>
            <a:avLst/>
            <a:gdLst/>
            <a:ahLst/>
            <a:cxnLst/>
            <a:rect l="l" t="t" r="r" b="b"/>
            <a:pathLst>
              <a:path w="85089" h="91439">
                <a:moveTo>
                  <a:pt x="30480" y="0"/>
                </a:moveTo>
                <a:lnTo>
                  <a:pt x="0" y="0"/>
                </a:lnTo>
                <a:lnTo>
                  <a:pt x="45720" y="91440"/>
                </a:lnTo>
                <a:lnTo>
                  <a:pt x="85090" y="15240"/>
                </a:lnTo>
                <a:lnTo>
                  <a:pt x="30480" y="15240"/>
                </a:lnTo>
                <a:lnTo>
                  <a:pt x="30480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4" name="object 54"/>
          <p:cNvSpPr/>
          <p:nvPr/>
        </p:nvSpPr>
        <p:spPr>
          <a:xfrm>
            <a:off x="3846809" y="4843225"/>
            <a:ext cx="29341" cy="13808"/>
          </a:xfrm>
          <a:custGeom>
            <a:avLst/>
            <a:gdLst/>
            <a:ahLst/>
            <a:cxnLst/>
            <a:rect l="l" t="t" r="r" b="b"/>
            <a:pathLst>
              <a:path w="32385" h="15239">
                <a:moveTo>
                  <a:pt x="32004" y="0"/>
                </a:moveTo>
                <a:lnTo>
                  <a:pt x="0" y="0"/>
                </a:lnTo>
                <a:lnTo>
                  <a:pt x="0" y="15240"/>
                </a:lnTo>
                <a:lnTo>
                  <a:pt x="24130" y="15240"/>
                </a:lnTo>
                <a:lnTo>
                  <a:pt x="3200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5" name="object 55"/>
          <p:cNvSpPr/>
          <p:nvPr/>
        </p:nvSpPr>
        <p:spPr>
          <a:xfrm>
            <a:off x="4199029" y="4861291"/>
            <a:ext cx="191932" cy="95275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6" name="object 56"/>
          <p:cNvSpPr/>
          <p:nvPr/>
        </p:nvSpPr>
        <p:spPr>
          <a:xfrm>
            <a:off x="4202021" y="4877746"/>
            <a:ext cx="169840" cy="75944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7" name="object 57"/>
          <p:cNvSpPr/>
          <p:nvPr/>
        </p:nvSpPr>
        <p:spPr>
          <a:xfrm>
            <a:off x="3949104" y="4944141"/>
            <a:ext cx="190551" cy="82847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8" name="object 58"/>
          <p:cNvSpPr txBox="1"/>
          <p:nvPr/>
        </p:nvSpPr>
        <p:spPr>
          <a:xfrm>
            <a:off x="1974323" y="4939652"/>
            <a:ext cx="2150604" cy="24981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4602" algn="r"/>
            <a:r>
              <a:rPr sz="634" spc="-23" dirty="0">
                <a:latin typeface="Calibri"/>
                <a:cs typeface="Calibri"/>
              </a:rPr>
              <a:t>AFIM</a:t>
            </a:r>
            <a:endParaRPr sz="634">
              <a:latin typeface="Calibri"/>
              <a:cs typeface="Calibri"/>
            </a:endParaRPr>
          </a:p>
          <a:p>
            <a:pPr marL="11506">
              <a:spcBef>
                <a:spcPts val="86"/>
              </a:spcBef>
            </a:pPr>
            <a:r>
              <a:rPr sz="906" b="1" dirty="0">
                <a:latin typeface="Calibri"/>
                <a:cs typeface="Calibri"/>
              </a:rPr>
              <a:t>T</a:t>
            </a:r>
            <a:r>
              <a:rPr sz="906" b="1" spc="9" dirty="0">
                <a:latin typeface="Calibri"/>
                <a:cs typeface="Calibri"/>
              </a:rPr>
              <a:t>E</a:t>
            </a:r>
            <a:r>
              <a:rPr sz="906" b="1" spc="5" dirty="0">
                <a:latin typeface="Calibri"/>
                <a:cs typeface="Calibri"/>
              </a:rPr>
              <a:t>C</a:t>
            </a:r>
            <a:r>
              <a:rPr sz="906" b="1" spc="14" dirty="0">
                <a:latin typeface="Calibri"/>
                <a:cs typeface="Calibri"/>
              </a:rPr>
              <a:t>P</a:t>
            </a:r>
            <a:r>
              <a:rPr sz="906" b="1" spc="5" dirty="0">
                <a:latin typeface="Calibri"/>
                <a:cs typeface="Calibri"/>
              </a:rPr>
              <a:t>R</a:t>
            </a:r>
            <a:r>
              <a:rPr sz="906" b="1" spc="18" dirty="0">
                <a:latin typeface="Calibri"/>
                <a:cs typeface="Calibri"/>
              </a:rPr>
              <a:t>1</a:t>
            </a:r>
            <a:r>
              <a:rPr sz="906" b="1" spc="5" dirty="0">
                <a:latin typeface="Calibri"/>
                <a:cs typeface="Calibri"/>
              </a:rPr>
              <a:t>*</a:t>
            </a:r>
            <a:r>
              <a:rPr sz="906" b="1" spc="9" dirty="0">
                <a:latin typeface="Calibri"/>
                <a:cs typeface="Calibri"/>
              </a:rPr>
              <a:t>/</a:t>
            </a:r>
            <a:r>
              <a:rPr sz="906" b="1" spc="18" dirty="0">
                <a:latin typeface="Calibri"/>
                <a:cs typeface="Calibri"/>
              </a:rPr>
              <a:t>*</a:t>
            </a:r>
            <a:endParaRPr sz="906">
              <a:latin typeface="Calibri"/>
              <a:cs typeface="Calibri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1242495" y="5692882"/>
            <a:ext cx="146135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b="1" spc="-9" dirty="0">
                <a:latin typeface="Calibri"/>
                <a:cs typeface="Calibri"/>
              </a:rPr>
              <a:t>D.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1825195" y="5753291"/>
            <a:ext cx="518377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spc="18" dirty="0">
                <a:latin typeface="Calibri"/>
                <a:cs typeface="Calibri"/>
              </a:rPr>
              <a:t>W</a:t>
            </a:r>
            <a:r>
              <a:rPr sz="816" spc="5" dirty="0">
                <a:latin typeface="Calibri"/>
                <a:cs typeface="Calibri"/>
              </a:rPr>
              <a:t>T</a:t>
            </a:r>
            <a:r>
              <a:rPr sz="816" spc="-14" dirty="0">
                <a:latin typeface="Times New Roman"/>
                <a:cs typeface="Times New Roman"/>
              </a:rPr>
              <a:t> </a:t>
            </a:r>
            <a:r>
              <a:rPr sz="816" spc="9" dirty="0">
                <a:latin typeface="Calibri"/>
                <a:cs typeface="Calibri"/>
              </a:rPr>
              <a:t>T</a:t>
            </a:r>
            <a:r>
              <a:rPr sz="816" dirty="0">
                <a:latin typeface="Calibri"/>
                <a:cs typeface="Calibri"/>
              </a:rPr>
              <a:t>e</a:t>
            </a:r>
            <a:r>
              <a:rPr sz="816" spc="5" dirty="0">
                <a:latin typeface="Calibri"/>
                <a:cs typeface="Calibri"/>
              </a:rPr>
              <a:t>c</a:t>
            </a:r>
            <a:r>
              <a:rPr sz="816" dirty="0">
                <a:latin typeface="Calibri"/>
                <a:cs typeface="Calibri"/>
              </a:rPr>
              <a:t>p</a:t>
            </a:r>
            <a:r>
              <a:rPr sz="816" spc="5" dirty="0">
                <a:latin typeface="Calibri"/>
                <a:cs typeface="Calibri"/>
              </a:rPr>
              <a:t>r</a:t>
            </a:r>
            <a:r>
              <a:rPr sz="816" spc="-5" dirty="0">
                <a:latin typeface="Calibri"/>
                <a:cs typeface="Calibri"/>
              </a:rPr>
              <a:t>1</a:t>
            </a:r>
            <a:r>
              <a:rPr sz="816" dirty="0">
                <a:latin typeface="Calibri"/>
                <a:cs typeface="Calibri"/>
              </a:rPr>
              <a:t>: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3061360" y="1670711"/>
            <a:ext cx="186410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spc="-23" dirty="0">
                <a:latin typeface="Calibri"/>
                <a:cs typeface="Calibri"/>
              </a:rPr>
              <a:t>AFIM</a:t>
            </a:r>
            <a:endParaRPr sz="634">
              <a:latin typeface="Calibri"/>
              <a:cs typeface="Calibri"/>
            </a:endParaRPr>
          </a:p>
        </p:txBody>
      </p:sp>
      <p:sp>
        <p:nvSpPr>
          <p:cNvPr id="62" name="object 62"/>
          <p:cNvSpPr/>
          <p:nvPr/>
        </p:nvSpPr>
        <p:spPr>
          <a:xfrm>
            <a:off x="3701709" y="5893329"/>
            <a:ext cx="1384947" cy="519181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3" name="object 63"/>
          <p:cNvSpPr/>
          <p:nvPr/>
        </p:nvSpPr>
        <p:spPr>
          <a:xfrm>
            <a:off x="4636514" y="5780102"/>
            <a:ext cx="84228" cy="135318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4" name="object 64"/>
          <p:cNvSpPr/>
          <p:nvPr/>
        </p:nvSpPr>
        <p:spPr>
          <a:xfrm>
            <a:off x="3701939" y="5769862"/>
            <a:ext cx="1384949" cy="643455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5" name="object 65"/>
          <p:cNvSpPr/>
          <p:nvPr/>
        </p:nvSpPr>
        <p:spPr>
          <a:xfrm>
            <a:off x="3719314" y="5790918"/>
            <a:ext cx="514580" cy="84344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6" name="object 66"/>
          <p:cNvSpPr/>
          <p:nvPr/>
        </p:nvSpPr>
        <p:spPr>
          <a:xfrm>
            <a:off x="1831868" y="5898621"/>
            <a:ext cx="1356640" cy="515500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140315" y="981342"/>
            <a:ext cx="464871" cy="20928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0" spc="-28" dirty="0">
                <a:latin typeface="Calibri"/>
                <a:cs typeface="Calibri"/>
              </a:rPr>
              <a:t>Me</a:t>
            </a:r>
            <a:r>
              <a:rPr sz="1360" spc="-9" dirty="0">
                <a:latin typeface="Calibri"/>
                <a:cs typeface="Calibri"/>
              </a:rPr>
              <a:t>di</a:t>
            </a:r>
            <a:r>
              <a:rPr sz="1360" dirty="0">
                <a:latin typeface="Calibri"/>
                <a:cs typeface="Calibri"/>
              </a:rPr>
              <a:t>a</a:t>
            </a:r>
            <a:endParaRPr sz="136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41183" y="1235411"/>
            <a:ext cx="169149" cy="20928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0" b="1" spc="-28" dirty="0">
                <a:latin typeface="Calibri"/>
                <a:cs typeface="Calibri"/>
              </a:rPr>
              <a:t>A.</a:t>
            </a:r>
            <a:endParaRPr sz="136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571127" y="1283050"/>
            <a:ext cx="65012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dirty="0">
                <a:solidFill>
                  <a:srgbClr val="00AF50"/>
                </a:solidFill>
                <a:latin typeface="Calibri"/>
                <a:cs typeface="Calibri"/>
              </a:rPr>
              <a:t>T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E</a:t>
            </a:r>
            <a:r>
              <a:rPr sz="861" spc="-9" dirty="0">
                <a:solidFill>
                  <a:srgbClr val="00AF50"/>
                </a:solidFill>
                <a:latin typeface="Calibri"/>
                <a:cs typeface="Calibri"/>
              </a:rPr>
              <a:t>CPR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861" spc="-9" dirty="0">
                <a:solidFill>
                  <a:srgbClr val="00AF50"/>
                </a:solidFill>
                <a:latin typeface="Times New Roman"/>
                <a:cs typeface="Times New Roman"/>
              </a:rPr>
              <a:t> </a:t>
            </a:r>
            <a:r>
              <a:rPr sz="861" spc="-5" dirty="0">
                <a:latin typeface="Calibri"/>
                <a:cs typeface="Calibri"/>
              </a:rPr>
              <a:t>/</a:t>
            </a:r>
            <a:r>
              <a:rPr sz="861" spc="5" dirty="0">
                <a:latin typeface="Times New Roman"/>
                <a:cs typeface="Times New Roman"/>
              </a:rPr>
              <a:t> </a:t>
            </a:r>
            <a:r>
              <a:rPr sz="861" spc="-33" dirty="0">
                <a:solidFill>
                  <a:srgbClr val="FF0000"/>
                </a:solidFill>
                <a:latin typeface="Calibri"/>
                <a:cs typeface="Calibri"/>
              </a:rPr>
              <a:t>Ga</a:t>
            </a:r>
            <a:r>
              <a:rPr sz="861" spc="-23" dirty="0">
                <a:solidFill>
                  <a:srgbClr val="FF0000"/>
                </a:solidFill>
                <a:latin typeface="Calibri"/>
                <a:cs typeface="Calibri"/>
              </a:rPr>
              <a:t>l</a:t>
            </a:r>
            <a:r>
              <a:rPr sz="861" spc="-5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4204898" y="981342"/>
            <a:ext cx="289969" cy="20928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0" spc="-18" dirty="0">
                <a:latin typeface="Calibri"/>
                <a:cs typeface="Calibri"/>
              </a:rPr>
              <a:t>Chq</a:t>
            </a:r>
            <a:endParaRPr sz="136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3466167" y="1274765"/>
            <a:ext cx="76634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dirty="0">
                <a:solidFill>
                  <a:srgbClr val="00AF50"/>
                </a:solidFill>
                <a:latin typeface="Calibri"/>
                <a:cs typeface="Calibri"/>
              </a:rPr>
              <a:t>T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E</a:t>
            </a:r>
            <a:r>
              <a:rPr sz="861" spc="-9" dirty="0">
                <a:solidFill>
                  <a:srgbClr val="00AF50"/>
                </a:solidFill>
                <a:latin typeface="Calibri"/>
                <a:cs typeface="Calibri"/>
              </a:rPr>
              <a:t>CPR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861" spc="-9" dirty="0">
                <a:solidFill>
                  <a:srgbClr val="00AF50"/>
                </a:solidFill>
                <a:latin typeface="Times New Roman"/>
                <a:cs typeface="Times New Roman"/>
              </a:rPr>
              <a:t> </a:t>
            </a:r>
            <a:r>
              <a:rPr sz="861" spc="-5" dirty="0">
                <a:latin typeface="Calibri"/>
                <a:cs typeface="Calibri"/>
              </a:rPr>
              <a:t>/</a:t>
            </a:r>
            <a:r>
              <a:rPr sz="861" spc="5" dirty="0">
                <a:latin typeface="Times New Roman"/>
                <a:cs typeface="Times New Roman"/>
              </a:rPr>
              <a:t> </a:t>
            </a:r>
            <a:r>
              <a:rPr sz="861" spc="-18" dirty="0">
                <a:solidFill>
                  <a:srgbClr val="FF0000"/>
                </a:solidFill>
                <a:latin typeface="Calibri"/>
                <a:cs typeface="Calibri"/>
              </a:rPr>
              <a:t>LAMP</a:t>
            </a:r>
            <a:r>
              <a:rPr sz="861" spc="-5" dirty="0">
                <a:solidFill>
                  <a:srgbClr val="FF0000"/>
                </a:solidFill>
                <a:latin typeface="Calibri"/>
                <a:cs typeface="Calibri"/>
              </a:rPr>
              <a:t>1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5084816" y="1274765"/>
            <a:ext cx="65012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dirty="0">
                <a:solidFill>
                  <a:srgbClr val="00AF50"/>
                </a:solidFill>
                <a:latin typeface="Calibri"/>
                <a:cs typeface="Calibri"/>
              </a:rPr>
              <a:t>T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E</a:t>
            </a:r>
            <a:r>
              <a:rPr sz="861" spc="-9" dirty="0">
                <a:solidFill>
                  <a:srgbClr val="00AF50"/>
                </a:solidFill>
                <a:latin typeface="Calibri"/>
                <a:cs typeface="Calibri"/>
              </a:rPr>
              <a:t>CPR</a:t>
            </a:r>
            <a:r>
              <a:rPr sz="861" spc="-5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861" spc="-9" dirty="0">
                <a:solidFill>
                  <a:srgbClr val="00AF50"/>
                </a:solidFill>
                <a:latin typeface="Times New Roman"/>
                <a:cs typeface="Times New Roman"/>
              </a:rPr>
              <a:t> </a:t>
            </a:r>
            <a:r>
              <a:rPr sz="861" spc="-5" dirty="0">
                <a:latin typeface="Calibri"/>
                <a:cs typeface="Calibri"/>
              </a:rPr>
              <a:t>/</a:t>
            </a:r>
            <a:r>
              <a:rPr sz="861" spc="5" dirty="0">
                <a:latin typeface="Times New Roman"/>
                <a:cs typeface="Times New Roman"/>
              </a:rPr>
              <a:t> </a:t>
            </a:r>
            <a:r>
              <a:rPr sz="861" spc="-33" dirty="0">
                <a:solidFill>
                  <a:srgbClr val="FF0000"/>
                </a:solidFill>
                <a:latin typeface="Calibri"/>
                <a:cs typeface="Calibri"/>
              </a:rPr>
              <a:t>Ga</a:t>
            </a:r>
            <a:r>
              <a:rPr sz="861" spc="-23" dirty="0">
                <a:solidFill>
                  <a:srgbClr val="FF0000"/>
                </a:solidFill>
                <a:latin typeface="Calibri"/>
                <a:cs typeface="Calibri"/>
              </a:rPr>
              <a:t>l</a:t>
            </a:r>
            <a:r>
              <a:rPr sz="861" spc="-5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45322" y="2411513"/>
            <a:ext cx="131178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b="1" spc="-28" dirty="0">
                <a:latin typeface="Calibri"/>
                <a:cs typeface="Calibri"/>
              </a:rPr>
              <a:t>B.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241183" y="3534798"/>
            <a:ext cx="146135" cy="19511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268" b="1" spc="-28" dirty="0">
                <a:latin typeface="Calibri"/>
                <a:cs typeface="Calibri"/>
              </a:rPr>
              <a:t>C.</a:t>
            </a:r>
            <a:endParaRPr sz="1268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248087" y="4557631"/>
            <a:ext cx="141533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b="1" spc="-28" dirty="0">
                <a:latin typeface="Calibri"/>
                <a:cs typeface="Calibri"/>
              </a:rPr>
              <a:t>D.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79840" y="6041579"/>
            <a:ext cx="6385073" cy="152362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45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1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6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3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23" dirty="0">
                <a:latin typeface="Times New Roman"/>
                <a:cs typeface="Times New Roman"/>
              </a:rPr>
              <a:t>o</a:t>
            </a:r>
            <a:r>
              <a:rPr sz="1087" b="1" spc="14" dirty="0">
                <a:latin typeface="Times New Roman"/>
                <a:cs typeface="Times New Roman"/>
              </a:rPr>
              <a:t>ro</a:t>
            </a:r>
            <a:r>
              <a:rPr sz="1087" b="1" spc="28" dirty="0">
                <a:latin typeface="Times New Roman"/>
                <a:cs typeface="Times New Roman"/>
              </a:rPr>
              <a:t>qu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78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du</a:t>
            </a:r>
            <a:r>
              <a:rPr sz="1087" b="1" dirty="0">
                <a:latin typeface="Times New Roman"/>
                <a:cs typeface="Times New Roman"/>
              </a:rPr>
              <a:t>c</a:t>
            </a:r>
            <a:r>
              <a:rPr sz="1087" b="1" spc="14" dirty="0">
                <a:latin typeface="Times New Roman"/>
                <a:cs typeface="Times New Roman"/>
              </a:rPr>
              <a:t>es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T</a:t>
            </a:r>
            <a:r>
              <a:rPr sz="1087" b="1" spc="33" dirty="0">
                <a:latin typeface="Times New Roman"/>
                <a:cs typeface="Times New Roman"/>
              </a:rPr>
              <a:t>G1</a:t>
            </a:r>
            <a:r>
              <a:rPr sz="1087" b="1" spc="14" dirty="0">
                <a:latin typeface="Times New Roman"/>
                <a:cs typeface="Times New Roman"/>
              </a:rPr>
              <a:t>6</a:t>
            </a:r>
            <a:r>
              <a:rPr sz="1087" b="1" spc="28" dirty="0">
                <a:latin typeface="Times New Roman"/>
                <a:cs typeface="Times New Roman"/>
              </a:rPr>
              <a:t>L</a:t>
            </a:r>
            <a:r>
              <a:rPr sz="1087" b="1" spc="33" dirty="0">
                <a:latin typeface="Times New Roman"/>
                <a:cs typeface="Times New Roman"/>
              </a:rPr>
              <a:t>1</a:t>
            </a:r>
            <a:r>
              <a:rPr sz="1087" b="1" spc="9" dirty="0">
                <a:latin typeface="Times New Roman"/>
                <a:cs typeface="Times New Roman"/>
              </a:rPr>
              <a:t>-i</a:t>
            </a:r>
            <a:r>
              <a:rPr sz="1087" b="1" spc="28" dirty="0">
                <a:latin typeface="Times New Roman"/>
                <a:cs typeface="Times New Roman"/>
              </a:rPr>
              <a:t>nd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d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tr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9" dirty="0">
                <a:latin typeface="Times New Roman"/>
                <a:cs typeface="Times New Roman"/>
              </a:rPr>
              <a:t>sloc</a:t>
            </a:r>
            <a:r>
              <a:rPr sz="1087" b="1" spc="14" dirty="0">
                <a:latin typeface="Times New Roman"/>
                <a:cs typeface="Times New Roman"/>
              </a:rPr>
              <a:t>at</a:t>
            </a:r>
            <a:r>
              <a:rPr sz="1087" b="1" spc="18" dirty="0">
                <a:latin typeface="Times New Roman"/>
                <a:cs typeface="Times New Roman"/>
              </a:rPr>
              <a:t>i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3" dirty="0">
                <a:latin typeface="Times New Roman"/>
                <a:cs typeface="Times New Roman"/>
              </a:rPr>
              <a:t>n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1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of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TE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33" dirty="0">
                <a:latin typeface="Times New Roman"/>
                <a:cs typeface="Times New Roman"/>
              </a:rPr>
              <a:t>P</a:t>
            </a:r>
            <a:r>
              <a:rPr sz="1087" b="1" spc="18" dirty="0">
                <a:latin typeface="Times New Roman"/>
                <a:cs typeface="Times New Roman"/>
              </a:rPr>
              <a:t>R1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t</a:t>
            </a:r>
            <a:r>
              <a:rPr sz="1087" b="1" spc="18" dirty="0">
                <a:latin typeface="Times New Roman"/>
                <a:cs typeface="Times New Roman"/>
              </a:rPr>
              <a:t>o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sw</a:t>
            </a:r>
            <a:r>
              <a:rPr sz="1087" b="1" spc="9" dirty="0">
                <a:latin typeface="Times New Roman"/>
                <a:cs typeface="Times New Roman"/>
              </a:rPr>
              <a:t>ol</a:t>
            </a:r>
            <a:r>
              <a:rPr sz="1087" b="1" spc="14" dirty="0">
                <a:latin typeface="Times New Roman"/>
                <a:cs typeface="Times New Roman"/>
              </a:rPr>
              <a:t>le</a:t>
            </a:r>
            <a:r>
              <a:rPr sz="1087" b="1" spc="23" dirty="0">
                <a:latin typeface="Times New Roman"/>
                <a:cs typeface="Times New Roman"/>
              </a:rPr>
              <a:t>n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73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ysoso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s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73" dirty="0">
                <a:latin typeface="Times New Roman"/>
                <a:cs typeface="Times New Roman"/>
              </a:rPr>
              <a:t> </a:t>
            </a:r>
            <a:r>
              <a:rPr sz="1087" spc="50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7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7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tu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9" dirty="0">
                <a:latin typeface="Times New Roman"/>
                <a:cs typeface="Times New Roman"/>
              </a:rPr>
              <a:t>tr</a:t>
            </a:r>
            <a:r>
              <a:rPr sz="1087" spc="5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en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7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7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incu</a:t>
            </a:r>
            <a:r>
              <a:rPr sz="1087" spc="23" dirty="0">
                <a:latin typeface="Times New Roman"/>
                <a:cs typeface="Times New Roman"/>
              </a:rPr>
              <a:t>b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n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o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h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qu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00</a:t>
            </a:r>
            <a:r>
              <a:rPr sz="1087" spc="28" dirty="0">
                <a:latin typeface="Times New Roman"/>
                <a:cs typeface="Times New Roman"/>
              </a:rPr>
              <a:t>µ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rs.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e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fix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t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gen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u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</a:t>
            </a:r>
            <a:r>
              <a:rPr sz="1087" spc="33" dirty="0">
                <a:latin typeface="Times New Roman"/>
                <a:cs typeface="Times New Roman"/>
              </a:rPr>
              <a:t>CP</a:t>
            </a:r>
            <a:r>
              <a:rPr sz="1087" spc="23" dirty="0">
                <a:latin typeface="Times New Roman"/>
                <a:cs typeface="Times New Roman"/>
              </a:rPr>
              <a:t>R1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n)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a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ect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9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3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LAMP</a:t>
            </a:r>
            <a:r>
              <a:rPr sz="1087" spc="28" dirty="0">
                <a:latin typeface="Times New Roman"/>
                <a:cs typeface="Times New Roman"/>
              </a:rPr>
              <a:t>1</a:t>
            </a:r>
            <a:r>
              <a:rPr sz="1087" spc="14" dirty="0">
                <a:latin typeface="Times New Roman"/>
                <a:cs typeface="Times New Roman"/>
              </a:rPr>
              <a:t> (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r>
              <a:rPr sz="1087" spc="50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S</a:t>
            </a:r>
            <a:r>
              <a:rPr lang="en-GB" sz="1087" spc="18" dirty="0">
                <a:latin typeface="Times New Roman"/>
                <a:cs typeface="Times New Roman"/>
              </a:rPr>
              <a:t>c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4" dirty="0">
                <a:latin typeface="Times New Roman"/>
                <a:cs typeface="Times New Roman"/>
              </a:rPr>
              <a:t>l</a:t>
            </a:r>
            <a:r>
              <a:rPr lang="en-GB" sz="1087" spc="18" dirty="0">
                <a:latin typeface="Times New Roman"/>
                <a:cs typeface="Times New Roman"/>
              </a:rPr>
              <a:t>e</a:t>
            </a:r>
            <a:r>
              <a:rPr lang="en-GB" sz="1087" spc="-5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b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8" dirty="0">
                <a:latin typeface="Times New Roman"/>
                <a:cs typeface="Times New Roman"/>
              </a:rPr>
              <a:t>r</a:t>
            </a:r>
            <a:r>
              <a:rPr lang="en-GB" sz="1087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5</a:t>
            </a:r>
            <a:r>
              <a:rPr lang="en-GB" sz="1087" spc="33" dirty="0">
                <a:latin typeface="Symbol"/>
                <a:cs typeface="Symbol"/>
              </a:rPr>
              <a:t></a:t>
            </a:r>
            <a:r>
              <a:rPr lang="en-GB" sz="1087" spc="18" dirty="0">
                <a:latin typeface="Times New Roman"/>
                <a:cs typeface="Times New Roman"/>
              </a:rPr>
              <a:t>m.</a:t>
            </a:r>
            <a:r>
              <a:rPr sz="1087" spc="18" dirty="0">
                <a:latin typeface="Times New Roman"/>
                <a:cs typeface="Times New Roman"/>
              </a:rPr>
              <a:t>.</a:t>
            </a:r>
            <a:r>
              <a:rPr sz="1087" dirty="0">
                <a:latin typeface="Times New Roman"/>
                <a:cs typeface="Times New Roman"/>
              </a:rPr>
              <a:t>  </a:t>
            </a:r>
            <a:r>
              <a:rPr sz="1087" spc="-59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 </a:t>
            </a:r>
            <a:r>
              <a:rPr sz="1087" b="1" spc="33" dirty="0">
                <a:latin typeface="Times New Roman"/>
                <a:cs typeface="Times New Roman"/>
              </a:rPr>
              <a:t>A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Co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ro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8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F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WT)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b="1" spc="33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 </a:t>
            </a:r>
            <a:r>
              <a:rPr sz="1087" b="1" spc="18" dirty="0">
                <a:latin typeface="Times New Roman"/>
                <a:cs typeface="Times New Roman"/>
              </a:rPr>
              <a:t>B.</a:t>
            </a:r>
            <a:r>
              <a:rPr sz="1087" b="1" spc="-5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ro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8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Fs</a:t>
            </a:r>
            <a:r>
              <a:rPr sz="1087" spc="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exp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ssi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ru</a:t>
            </a:r>
            <a:r>
              <a:rPr sz="1087" spc="18" dirty="0">
                <a:latin typeface="Times New Roman"/>
                <a:cs typeface="Times New Roman"/>
              </a:rPr>
              <a:t>nc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spc="-5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T</a:t>
            </a:r>
            <a:r>
              <a:rPr sz="1087" spc="23" dirty="0">
                <a:latin typeface="Times New Roman"/>
                <a:cs typeface="Times New Roman"/>
              </a:rPr>
              <a:t>ECPR1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TECR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18" dirty="0">
                <a:latin typeface="Times New Roman"/>
                <a:cs typeface="Times New Roman"/>
              </a:rPr>
              <a:t>1*</a:t>
            </a:r>
            <a:r>
              <a:rPr sz="1087" spc="9" dirty="0">
                <a:latin typeface="Times New Roman"/>
                <a:cs typeface="Times New Roman"/>
              </a:rPr>
              <a:t>/*</a:t>
            </a:r>
            <a:r>
              <a:rPr sz="1087" spc="23" dirty="0">
                <a:latin typeface="Times New Roman"/>
                <a:cs typeface="Times New Roman"/>
              </a:rPr>
              <a:t>)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8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Pan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63" dirty="0">
                <a:latin typeface="Times New Roman"/>
                <a:cs typeface="Times New Roman"/>
              </a:rPr>
              <a:t> </a:t>
            </a:r>
            <a:r>
              <a:rPr sz="1087" b="1" spc="33" dirty="0">
                <a:latin typeface="Times New Roman"/>
                <a:cs typeface="Times New Roman"/>
              </a:rPr>
              <a:t>C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10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128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s.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10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31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D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spc="12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8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1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31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 </a:t>
            </a:r>
            <a:r>
              <a:rPr sz="1087" spc="-109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x</a:t>
            </a:r>
            <a:r>
              <a:rPr sz="1087" spc="18" dirty="0">
                <a:latin typeface="Times New Roman"/>
                <a:cs typeface="Times New Roman"/>
              </a:rPr>
              <a:t>p</a:t>
            </a:r>
            <a:r>
              <a:rPr sz="1087" spc="14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ss</a:t>
            </a:r>
            <a:r>
              <a:rPr sz="1087" spc="23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11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r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ed</a:t>
            </a:r>
            <a:r>
              <a:rPr sz="1087" spc="118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C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23" dirty="0">
                <a:latin typeface="Times New Roman"/>
                <a:cs typeface="Times New Roman"/>
              </a:rPr>
              <a:t>R1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(</a:t>
            </a:r>
            <a:r>
              <a:rPr sz="1087" spc="14" dirty="0">
                <a:latin typeface="Times New Roman"/>
                <a:cs typeface="Times New Roman"/>
              </a:rPr>
              <a:t>TECR</a:t>
            </a:r>
            <a:r>
              <a:rPr sz="1087" spc="18" dirty="0">
                <a:latin typeface="Times New Roman"/>
                <a:cs typeface="Times New Roman"/>
              </a:rPr>
              <a:t>P1</a:t>
            </a:r>
            <a:r>
              <a:rPr sz="1087" spc="9" dirty="0">
                <a:latin typeface="Times New Roman"/>
                <a:cs typeface="Times New Roman"/>
              </a:rPr>
              <a:t>*/</a:t>
            </a:r>
            <a:r>
              <a:rPr sz="1087" spc="-5" dirty="0">
                <a:latin typeface="Times New Roman"/>
                <a:cs typeface="Times New Roman"/>
              </a:rPr>
              <a:t>*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endParaRPr sz="1087" dirty="0">
              <a:latin typeface="Times New Roman"/>
              <a:cs typeface="Times New Roman"/>
            </a:endParaRPr>
          </a:p>
        </p:txBody>
      </p:sp>
      <p:sp>
        <p:nvSpPr>
          <p:cNvPr id="12" name="object 12"/>
          <p:cNvSpPr/>
          <p:nvPr/>
        </p:nvSpPr>
        <p:spPr>
          <a:xfrm>
            <a:off x="512624" y="1192952"/>
            <a:ext cx="1760527" cy="0"/>
          </a:xfrm>
          <a:custGeom>
            <a:avLst/>
            <a:gdLst/>
            <a:ahLst/>
            <a:cxnLst/>
            <a:rect l="l" t="t" r="r" b="b"/>
            <a:pathLst>
              <a:path w="1943100">
                <a:moveTo>
                  <a:pt x="0" y="0"/>
                </a:moveTo>
                <a:lnTo>
                  <a:pt x="1943100" y="0"/>
                </a:lnTo>
              </a:path>
            </a:pathLst>
          </a:custGeom>
          <a:ln w="1981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1527171" y="1580613"/>
            <a:ext cx="774631" cy="77325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462570" y="1580613"/>
            <a:ext cx="1034222" cy="773250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1410494" y="2309448"/>
            <a:ext cx="36246" cy="0"/>
          </a:xfrm>
          <a:custGeom>
            <a:avLst/>
            <a:gdLst/>
            <a:ahLst/>
            <a:cxnLst/>
            <a:rect l="l" t="t" r="r" b="b"/>
            <a:pathLst>
              <a:path w="40005">
                <a:moveTo>
                  <a:pt x="0" y="0"/>
                </a:moveTo>
                <a:lnTo>
                  <a:pt x="39497" y="0"/>
                </a:lnTo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484662" y="1603971"/>
            <a:ext cx="316204" cy="99417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 txBox="1"/>
          <p:nvPr/>
        </p:nvSpPr>
        <p:spPr>
          <a:xfrm>
            <a:off x="473155" y="1599253"/>
            <a:ext cx="319887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492948" y="2206001"/>
            <a:ext cx="106321" cy="113226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 txBox="1"/>
          <p:nvPr/>
        </p:nvSpPr>
        <p:spPr>
          <a:xfrm>
            <a:off x="481439" y="2202665"/>
            <a:ext cx="10873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20" name="object 20"/>
          <p:cNvSpPr/>
          <p:nvPr/>
        </p:nvSpPr>
        <p:spPr>
          <a:xfrm>
            <a:off x="1554786" y="2211526"/>
            <a:ext cx="132557" cy="11184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 txBox="1"/>
          <p:nvPr/>
        </p:nvSpPr>
        <p:spPr>
          <a:xfrm>
            <a:off x="1543509" y="2208188"/>
            <a:ext cx="132327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22" name="object 22"/>
          <p:cNvSpPr/>
          <p:nvPr/>
        </p:nvSpPr>
        <p:spPr>
          <a:xfrm>
            <a:off x="1411183" y="2294375"/>
            <a:ext cx="46946" cy="15187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/>
          <p:nvPr/>
        </p:nvSpPr>
        <p:spPr>
          <a:xfrm>
            <a:off x="1411874" y="2299782"/>
            <a:ext cx="6329" cy="7479"/>
          </a:xfrm>
          <a:custGeom>
            <a:avLst/>
            <a:gdLst/>
            <a:ahLst/>
            <a:cxnLst/>
            <a:rect l="l" t="t" r="r" b="b"/>
            <a:pathLst>
              <a:path w="6984" h="8255">
                <a:moveTo>
                  <a:pt x="762" y="6350"/>
                </a:moveTo>
                <a:lnTo>
                  <a:pt x="0" y="6350"/>
                </a:lnTo>
                <a:lnTo>
                  <a:pt x="0" y="7239"/>
                </a:lnTo>
                <a:lnTo>
                  <a:pt x="127" y="7366"/>
                </a:lnTo>
                <a:lnTo>
                  <a:pt x="127" y="7493"/>
                </a:lnTo>
                <a:lnTo>
                  <a:pt x="381" y="7493"/>
                </a:lnTo>
                <a:lnTo>
                  <a:pt x="508" y="7620"/>
                </a:lnTo>
                <a:lnTo>
                  <a:pt x="762" y="7620"/>
                </a:lnTo>
                <a:lnTo>
                  <a:pt x="1016" y="7747"/>
                </a:lnTo>
                <a:lnTo>
                  <a:pt x="1524" y="7747"/>
                </a:lnTo>
                <a:lnTo>
                  <a:pt x="1778" y="7874"/>
                </a:lnTo>
                <a:lnTo>
                  <a:pt x="3937" y="7874"/>
                </a:lnTo>
                <a:lnTo>
                  <a:pt x="4953" y="7620"/>
                </a:lnTo>
                <a:lnTo>
                  <a:pt x="5334" y="7366"/>
                </a:lnTo>
                <a:lnTo>
                  <a:pt x="5715" y="7239"/>
                </a:lnTo>
                <a:lnTo>
                  <a:pt x="6096" y="6985"/>
                </a:lnTo>
                <a:lnTo>
                  <a:pt x="6350" y="6731"/>
                </a:lnTo>
                <a:lnTo>
                  <a:pt x="6392" y="6604"/>
                </a:lnTo>
                <a:lnTo>
                  <a:pt x="1651" y="6604"/>
                </a:lnTo>
                <a:lnTo>
                  <a:pt x="1397" y="6477"/>
                </a:lnTo>
                <a:lnTo>
                  <a:pt x="1016" y="6477"/>
                </a:lnTo>
                <a:lnTo>
                  <a:pt x="762" y="6350"/>
                </a:lnTo>
                <a:close/>
              </a:path>
              <a:path w="6984" h="8255">
                <a:moveTo>
                  <a:pt x="6096" y="127"/>
                </a:moveTo>
                <a:lnTo>
                  <a:pt x="508" y="127"/>
                </a:lnTo>
                <a:lnTo>
                  <a:pt x="508" y="254"/>
                </a:lnTo>
                <a:lnTo>
                  <a:pt x="381" y="381"/>
                </a:lnTo>
                <a:lnTo>
                  <a:pt x="381" y="3937"/>
                </a:lnTo>
                <a:lnTo>
                  <a:pt x="508" y="4064"/>
                </a:lnTo>
                <a:lnTo>
                  <a:pt x="508" y="4191"/>
                </a:lnTo>
                <a:lnTo>
                  <a:pt x="3429" y="4191"/>
                </a:lnTo>
                <a:lnTo>
                  <a:pt x="3683" y="4318"/>
                </a:lnTo>
                <a:lnTo>
                  <a:pt x="3937" y="4318"/>
                </a:lnTo>
                <a:lnTo>
                  <a:pt x="4064" y="4445"/>
                </a:lnTo>
                <a:lnTo>
                  <a:pt x="4318" y="4572"/>
                </a:lnTo>
                <a:lnTo>
                  <a:pt x="4318" y="4699"/>
                </a:lnTo>
                <a:lnTo>
                  <a:pt x="4572" y="4953"/>
                </a:lnTo>
                <a:lnTo>
                  <a:pt x="4572" y="5842"/>
                </a:lnTo>
                <a:lnTo>
                  <a:pt x="4064" y="6350"/>
                </a:lnTo>
                <a:lnTo>
                  <a:pt x="3810" y="6477"/>
                </a:lnTo>
                <a:lnTo>
                  <a:pt x="3683" y="6477"/>
                </a:lnTo>
                <a:lnTo>
                  <a:pt x="3429" y="6604"/>
                </a:lnTo>
                <a:lnTo>
                  <a:pt x="6392" y="6604"/>
                </a:lnTo>
                <a:lnTo>
                  <a:pt x="6477" y="6350"/>
                </a:lnTo>
                <a:lnTo>
                  <a:pt x="6731" y="6096"/>
                </a:lnTo>
                <a:lnTo>
                  <a:pt x="6858" y="5715"/>
                </a:lnTo>
                <a:lnTo>
                  <a:pt x="6858" y="4826"/>
                </a:lnTo>
                <a:lnTo>
                  <a:pt x="6604" y="4318"/>
                </a:lnTo>
                <a:lnTo>
                  <a:pt x="6477" y="3937"/>
                </a:lnTo>
                <a:lnTo>
                  <a:pt x="6223" y="3810"/>
                </a:lnTo>
                <a:lnTo>
                  <a:pt x="5969" y="3556"/>
                </a:lnTo>
                <a:lnTo>
                  <a:pt x="4826" y="3175"/>
                </a:lnTo>
                <a:lnTo>
                  <a:pt x="4318" y="3048"/>
                </a:lnTo>
                <a:lnTo>
                  <a:pt x="2159" y="3048"/>
                </a:lnTo>
                <a:lnTo>
                  <a:pt x="2159" y="1397"/>
                </a:lnTo>
                <a:lnTo>
                  <a:pt x="5969" y="1397"/>
                </a:lnTo>
                <a:lnTo>
                  <a:pt x="6223" y="1143"/>
                </a:lnTo>
                <a:lnTo>
                  <a:pt x="6223" y="254"/>
                </a:lnTo>
                <a:lnTo>
                  <a:pt x="6096" y="254"/>
                </a:lnTo>
                <a:lnTo>
                  <a:pt x="6096" y="127"/>
                </a:lnTo>
                <a:close/>
              </a:path>
              <a:path w="6984" h="8255">
                <a:moveTo>
                  <a:pt x="508" y="6223"/>
                </a:moveTo>
                <a:lnTo>
                  <a:pt x="127" y="6223"/>
                </a:lnTo>
                <a:lnTo>
                  <a:pt x="127" y="6350"/>
                </a:lnTo>
                <a:lnTo>
                  <a:pt x="635" y="6350"/>
                </a:lnTo>
                <a:lnTo>
                  <a:pt x="508" y="6223"/>
                </a:lnTo>
                <a:close/>
              </a:path>
              <a:path w="6984" h="8255">
                <a:moveTo>
                  <a:pt x="5969" y="0"/>
                </a:moveTo>
                <a:lnTo>
                  <a:pt x="762" y="0"/>
                </a:lnTo>
                <a:lnTo>
                  <a:pt x="635" y="127"/>
                </a:lnTo>
                <a:lnTo>
                  <a:pt x="5969" y="127"/>
                </a:lnTo>
                <a:lnTo>
                  <a:pt x="5969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/>
          <p:nvPr/>
        </p:nvSpPr>
        <p:spPr>
          <a:xfrm>
            <a:off x="1421771" y="2301508"/>
            <a:ext cx="16108" cy="7479"/>
          </a:xfrm>
          <a:custGeom>
            <a:avLst/>
            <a:gdLst/>
            <a:ahLst/>
            <a:cxnLst/>
            <a:rect l="l" t="t" r="r" b="b"/>
            <a:pathLst>
              <a:path w="17780" h="8255">
                <a:moveTo>
                  <a:pt x="1778" y="7874"/>
                </a:moveTo>
                <a:lnTo>
                  <a:pt x="254" y="7874"/>
                </a:lnTo>
                <a:lnTo>
                  <a:pt x="254" y="8001"/>
                </a:lnTo>
                <a:lnTo>
                  <a:pt x="1778" y="8001"/>
                </a:lnTo>
                <a:lnTo>
                  <a:pt x="1778" y="7874"/>
                </a:lnTo>
                <a:close/>
              </a:path>
              <a:path w="17780" h="8255">
                <a:moveTo>
                  <a:pt x="2032" y="254"/>
                </a:moveTo>
                <a:lnTo>
                  <a:pt x="0" y="254"/>
                </a:lnTo>
                <a:lnTo>
                  <a:pt x="0" y="7874"/>
                </a:lnTo>
                <a:lnTo>
                  <a:pt x="2032" y="7874"/>
                </a:lnTo>
                <a:lnTo>
                  <a:pt x="2032" y="6350"/>
                </a:lnTo>
                <a:lnTo>
                  <a:pt x="1905" y="6223"/>
                </a:lnTo>
                <a:lnTo>
                  <a:pt x="1905" y="5588"/>
                </a:lnTo>
                <a:lnTo>
                  <a:pt x="4318" y="5588"/>
                </a:lnTo>
                <a:lnTo>
                  <a:pt x="5080" y="5080"/>
                </a:lnTo>
                <a:lnTo>
                  <a:pt x="6096" y="5080"/>
                </a:lnTo>
                <a:lnTo>
                  <a:pt x="6096" y="4699"/>
                </a:lnTo>
                <a:lnTo>
                  <a:pt x="2794" y="4699"/>
                </a:lnTo>
                <a:lnTo>
                  <a:pt x="2540" y="4572"/>
                </a:lnTo>
                <a:lnTo>
                  <a:pt x="2159" y="4191"/>
                </a:lnTo>
                <a:lnTo>
                  <a:pt x="2032" y="3937"/>
                </a:lnTo>
                <a:lnTo>
                  <a:pt x="2032" y="254"/>
                </a:lnTo>
                <a:close/>
              </a:path>
              <a:path w="17780" h="8255">
                <a:moveTo>
                  <a:pt x="4318" y="5588"/>
                </a:moveTo>
                <a:lnTo>
                  <a:pt x="1905" y="5588"/>
                </a:lnTo>
                <a:lnTo>
                  <a:pt x="2159" y="5842"/>
                </a:lnTo>
                <a:lnTo>
                  <a:pt x="2286" y="5842"/>
                </a:lnTo>
                <a:lnTo>
                  <a:pt x="2540" y="5969"/>
                </a:lnTo>
                <a:lnTo>
                  <a:pt x="3302" y="5969"/>
                </a:lnTo>
                <a:lnTo>
                  <a:pt x="3683" y="5842"/>
                </a:lnTo>
                <a:lnTo>
                  <a:pt x="3937" y="5715"/>
                </a:lnTo>
                <a:lnTo>
                  <a:pt x="4318" y="5588"/>
                </a:lnTo>
                <a:close/>
              </a:path>
              <a:path w="17780" h="8255">
                <a:moveTo>
                  <a:pt x="6096" y="5080"/>
                </a:moveTo>
                <a:lnTo>
                  <a:pt x="5080" y="5080"/>
                </a:lnTo>
                <a:lnTo>
                  <a:pt x="5207" y="5461"/>
                </a:lnTo>
                <a:lnTo>
                  <a:pt x="5334" y="5588"/>
                </a:lnTo>
                <a:lnTo>
                  <a:pt x="5715" y="5715"/>
                </a:lnTo>
                <a:lnTo>
                  <a:pt x="5969" y="5842"/>
                </a:lnTo>
                <a:lnTo>
                  <a:pt x="6350" y="5969"/>
                </a:lnTo>
                <a:lnTo>
                  <a:pt x="7620" y="5969"/>
                </a:lnTo>
                <a:lnTo>
                  <a:pt x="7747" y="5842"/>
                </a:lnTo>
                <a:lnTo>
                  <a:pt x="6223" y="5842"/>
                </a:lnTo>
                <a:lnTo>
                  <a:pt x="6223" y="5715"/>
                </a:lnTo>
                <a:lnTo>
                  <a:pt x="6096" y="5715"/>
                </a:lnTo>
                <a:lnTo>
                  <a:pt x="6096" y="5080"/>
                </a:lnTo>
                <a:close/>
              </a:path>
              <a:path w="17780" h="8255">
                <a:moveTo>
                  <a:pt x="8001" y="5715"/>
                </a:moveTo>
                <a:lnTo>
                  <a:pt x="6223" y="5715"/>
                </a:lnTo>
                <a:lnTo>
                  <a:pt x="6223" y="5842"/>
                </a:lnTo>
                <a:lnTo>
                  <a:pt x="8001" y="5842"/>
                </a:lnTo>
                <a:lnTo>
                  <a:pt x="8001" y="5715"/>
                </a:lnTo>
                <a:close/>
              </a:path>
              <a:path w="17780" h="8255">
                <a:moveTo>
                  <a:pt x="12700" y="5715"/>
                </a:moveTo>
                <a:lnTo>
                  <a:pt x="10922" y="5715"/>
                </a:lnTo>
                <a:lnTo>
                  <a:pt x="10922" y="5842"/>
                </a:lnTo>
                <a:lnTo>
                  <a:pt x="12700" y="5842"/>
                </a:lnTo>
                <a:lnTo>
                  <a:pt x="12700" y="5715"/>
                </a:lnTo>
                <a:close/>
              </a:path>
              <a:path w="17780" h="8255">
                <a:moveTo>
                  <a:pt x="17335" y="1270"/>
                </a:moveTo>
                <a:lnTo>
                  <a:pt x="14732" y="1270"/>
                </a:lnTo>
                <a:lnTo>
                  <a:pt x="14859" y="1397"/>
                </a:lnTo>
                <a:lnTo>
                  <a:pt x="14986" y="1397"/>
                </a:lnTo>
                <a:lnTo>
                  <a:pt x="15240" y="1651"/>
                </a:lnTo>
                <a:lnTo>
                  <a:pt x="15240" y="1778"/>
                </a:lnTo>
                <a:lnTo>
                  <a:pt x="15367" y="1905"/>
                </a:lnTo>
                <a:lnTo>
                  <a:pt x="15367" y="2032"/>
                </a:lnTo>
                <a:lnTo>
                  <a:pt x="15494" y="2159"/>
                </a:lnTo>
                <a:lnTo>
                  <a:pt x="15494" y="5715"/>
                </a:lnTo>
                <a:lnTo>
                  <a:pt x="15621" y="5842"/>
                </a:lnTo>
                <a:lnTo>
                  <a:pt x="17399" y="5842"/>
                </a:lnTo>
                <a:lnTo>
                  <a:pt x="17399" y="5715"/>
                </a:lnTo>
                <a:lnTo>
                  <a:pt x="17526" y="5715"/>
                </a:lnTo>
                <a:lnTo>
                  <a:pt x="17526" y="1905"/>
                </a:lnTo>
                <a:lnTo>
                  <a:pt x="17399" y="1651"/>
                </a:lnTo>
                <a:lnTo>
                  <a:pt x="17399" y="1397"/>
                </a:lnTo>
                <a:lnTo>
                  <a:pt x="17335" y="1270"/>
                </a:lnTo>
                <a:close/>
              </a:path>
              <a:path w="17780" h="8255">
                <a:moveTo>
                  <a:pt x="6858" y="254"/>
                </a:moveTo>
                <a:lnTo>
                  <a:pt x="6096" y="254"/>
                </a:lnTo>
                <a:lnTo>
                  <a:pt x="6096" y="5715"/>
                </a:lnTo>
                <a:lnTo>
                  <a:pt x="8128" y="5715"/>
                </a:lnTo>
                <a:lnTo>
                  <a:pt x="8128" y="4699"/>
                </a:lnTo>
                <a:lnTo>
                  <a:pt x="7112" y="4699"/>
                </a:lnTo>
                <a:lnTo>
                  <a:pt x="6985" y="4572"/>
                </a:lnTo>
                <a:lnTo>
                  <a:pt x="6985" y="4445"/>
                </a:lnTo>
                <a:lnTo>
                  <a:pt x="6858" y="4445"/>
                </a:lnTo>
                <a:lnTo>
                  <a:pt x="6858" y="254"/>
                </a:lnTo>
                <a:close/>
              </a:path>
              <a:path w="17780" h="8255">
                <a:moveTo>
                  <a:pt x="14097" y="1270"/>
                </a:moveTo>
                <a:lnTo>
                  <a:pt x="10033" y="1270"/>
                </a:lnTo>
                <a:lnTo>
                  <a:pt x="10160" y="1397"/>
                </a:lnTo>
                <a:lnTo>
                  <a:pt x="10287" y="1397"/>
                </a:lnTo>
                <a:lnTo>
                  <a:pt x="10541" y="1651"/>
                </a:lnTo>
                <a:lnTo>
                  <a:pt x="10541" y="1778"/>
                </a:lnTo>
                <a:lnTo>
                  <a:pt x="10668" y="1905"/>
                </a:lnTo>
                <a:lnTo>
                  <a:pt x="10668" y="2032"/>
                </a:lnTo>
                <a:lnTo>
                  <a:pt x="10795" y="2159"/>
                </a:lnTo>
                <a:lnTo>
                  <a:pt x="10795" y="5715"/>
                </a:lnTo>
                <a:lnTo>
                  <a:pt x="12827" y="5715"/>
                </a:lnTo>
                <a:lnTo>
                  <a:pt x="12827" y="2159"/>
                </a:lnTo>
                <a:lnTo>
                  <a:pt x="13335" y="1651"/>
                </a:lnTo>
                <a:lnTo>
                  <a:pt x="14097" y="1270"/>
                </a:lnTo>
                <a:close/>
              </a:path>
              <a:path w="17780" h="8255">
                <a:moveTo>
                  <a:pt x="6096" y="254"/>
                </a:moveTo>
                <a:lnTo>
                  <a:pt x="4826" y="254"/>
                </a:lnTo>
                <a:lnTo>
                  <a:pt x="4826" y="3810"/>
                </a:lnTo>
                <a:lnTo>
                  <a:pt x="4572" y="4191"/>
                </a:lnTo>
                <a:lnTo>
                  <a:pt x="4064" y="4445"/>
                </a:lnTo>
                <a:lnTo>
                  <a:pt x="3683" y="4572"/>
                </a:lnTo>
                <a:lnTo>
                  <a:pt x="3429" y="4699"/>
                </a:lnTo>
                <a:lnTo>
                  <a:pt x="6096" y="4699"/>
                </a:lnTo>
                <a:lnTo>
                  <a:pt x="6096" y="254"/>
                </a:lnTo>
                <a:close/>
              </a:path>
              <a:path w="17780" h="8255">
                <a:moveTo>
                  <a:pt x="7874" y="254"/>
                </a:moveTo>
                <a:lnTo>
                  <a:pt x="6858" y="254"/>
                </a:lnTo>
                <a:lnTo>
                  <a:pt x="6858" y="4445"/>
                </a:lnTo>
                <a:lnTo>
                  <a:pt x="6985" y="4445"/>
                </a:lnTo>
                <a:lnTo>
                  <a:pt x="6985" y="4572"/>
                </a:lnTo>
                <a:lnTo>
                  <a:pt x="7112" y="4699"/>
                </a:lnTo>
                <a:lnTo>
                  <a:pt x="8128" y="4699"/>
                </a:lnTo>
                <a:lnTo>
                  <a:pt x="8128" y="2159"/>
                </a:lnTo>
                <a:lnTo>
                  <a:pt x="8636" y="1651"/>
                </a:lnTo>
                <a:lnTo>
                  <a:pt x="9398" y="1270"/>
                </a:lnTo>
                <a:lnTo>
                  <a:pt x="17335" y="1270"/>
                </a:lnTo>
                <a:lnTo>
                  <a:pt x="17208" y="1016"/>
                </a:lnTo>
                <a:lnTo>
                  <a:pt x="12446" y="1016"/>
                </a:lnTo>
                <a:lnTo>
                  <a:pt x="12446" y="889"/>
                </a:lnTo>
                <a:lnTo>
                  <a:pt x="7874" y="889"/>
                </a:lnTo>
                <a:lnTo>
                  <a:pt x="7874" y="254"/>
                </a:lnTo>
                <a:close/>
              </a:path>
              <a:path w="17780" h="8255">
                <a:moveTo>
                  <a:pt x="15875" y="0"/>
                </a:moveTo>
                <a:lnTo>
                  <a:pt x="14351" y="0"/>
                </a:lnTo>
                <a:lnTo>
                  <a:pt x="14097" y="127"/>
                </a:lnTo>
                <a:lnTo>
                  <a:pt x="13970" y="127"/>
                </a:lnTo>
                <a:lnTo>
                  <a:pt x="13716" y="254"/>
                </a:lnTo>
                <a:lnTo>
                  <a:pt x="13462" y="254"/>
                </a:lnTo>
                <a:lnTo>
                  <a:pt x="13335" y="381"/>
                </a:lnTo>
                <a:lnTo>
                  <a:pt x="13081" y="508"/>
                </a:lnTo>
                <a:lnTo>
                  <a:pt x="12954" y="635"/>
                </a:lnTo>
                <a:lnTo>
                  <a:pt x="12700" y="762"/>
                </a:lnTo>
                <a:lnTo>
                  <a:pt x="12446" y="1016"/>
                </a:lnTo>
                <a:lnTo>
                  <a:pt x="17208" y="1016"/>
                </a:lnTo>
                <a:lnTo>
                  <a:pt x="17145" y="889"/>
                </a:lnTo>
                <a:lnTo>
                  <a:pt x="16510" y="254"/>
                </a:lnTo>
                <a:lnTo>
                  <a:pt x="16129" y="127"/>
                </a:lnTo>
                <a:lnTo>
                  <a:pt x="15875" y="0"/>
                </a:lnTo>
                <a:close/>
              </a:path>
              <a:path w="17780" h="8255">
                <a:moveTo>
                  <a:pt x="11049" y="0"/>
                </a:moveTo>
                <a:lnTo>
                  <a:pt x="9779" y="0"/>
                </a:lnTo>
                <a:lnTo>
                  <a:pt x="8636" y="381"/>
                </a:lnTo>
                <a:lnTo>
                  <a:pt x="7874" y="889"/>
                </a:lnTo>
                <a:lnTo>
                  <a:pt x="12446" y="889"/>
                </a:lnTo>
                <a:lnTo>
                  <a:pt x="12446" y="762"/>
                </a:lnTo>
                <a:lnTo>
                  <a:pt x="12065" y="381"/>
                </a:lnTo>
                <a:lnTo>
                  <a:pt x="11811" y="381"/>
                </a:lnTo>
                <a:lnTo>
                  <a:pt x="11684" y="254"/>
                </a:lnTo>
                <a:lnTo>
                  <a:pt x="11430" y="127"/>
                </a:lnTo>
                <a:lnTo>
                  <a:pt x="11303" y="127"/>
                </a:lnTo>
                <a:lnTo>
                  <a:pt x="11049" y="0"/>
                </a:lnTo>
                <a:close/>
              </a:path>
              <a:path w="17780" h="8255">
                <a:moveTo>
                  <a:pt x="1905" y="127"/>
                </a:moveTo>
                <a:lnTo>
                  <a:pt x="127" y="127"/>
                </a:lnTo>
                <a:lnTo>
                  <a:pt x="127" y="254"/>
                </a:lnTo>
                <a:lnTo>
                  <a:pt x="1905" y="254"/>
                </a:lnTo>
                <a:lnTo>
                  <a:pt x="1905" y="127"/>
                </a:lnTo>
                <a:close/>
              </a:path>
              <a:path w="17780" h="8255">
                <a:moveTo>
                  <a:pt x="6223" y="127"/>
                </a:moveTo>
                <a:lnTo>
                  <a:pt x="4953" y="127"/>
                </a:lnTo>
                <a:lnTo>
                  <a:pt x="4953" y="254"/>
                </a:lnTo>
                <a:lnTo>
                  <a:pt x="6223" y="254"/>
                </a:lnTo>
                <a:lnTo>
                  <a:pt x="6223" y="127"/>
                </a:lnTo>
                <a:close/>
              </a:path>
              <a:path w="17780" h="8255">
                <a:moveTo>
                  <a:pt x="6731" y="127"/>
                </a:moveTo>
                <a:lnTo>
                  <a:pt x="6223" y="127"/>
                </a:lnTo>
                <a:lnTo>
                  <a:pt x="6223" y="254"/>
                </a:lnTo>
                <a:lnTo>
                  <a:pt x="6731" y="254"/>
                </a:lnTo>
                <a:lnTo>
                  <a:pt x="6731" y="127"/>
                </a:lnTo>
                <a:close/>
              </a:path>
              <a:path w="17780" h="8255">
                <a:moveTo>
                  <a:pt x="7747" y="127"/>
                </a:moveTo>
                <a:lnTo>
                  <a:pt x="6731" y="127"/>
                </a:lnTo>
                <a:lnTo>
                  <a:pt x="6731" y="254"/>
                </a:lnTo>
                <a:lnTo>
                  <a:pt x="7747" y="254"/>
                </a:lnTo>
                <a:lnTo>
                  <a:pt x="7747" y="12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5866467" y="1581188"/>
            <a:ext cx="774631" cy="772676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3452819" y="1581190"/>
            <a:ext cx="774631" cy="774055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4264732" y="1581190"/>
            <a:ext cx="774631" cy="774055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5068360" y="1581188"/>
            <a:ext cx="774631" cy="772676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/>
          <p:nvPr/>
        </p:nvSpPr>
        <p:spPr>
          <a:xfrm>
            <a:off x="2388219" y="1581188"/>
            <a:ext cx="1034222" cy="772676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/>
          <p:nvPr/>
        </p:nvSpPr>
        <p:spPr>
          <a:xfrm>
            <a:off x="3292991" y="2290231"/>
            <a:ext cx="35671" cy="0"/>
          </a:xfrm>
          <a:custGeom>
            <a:avLst/>
            <a:gdLst/>
            <a:ahLst/>
            <a:cxnLst/>
            <a:rect l="l" t="t" r="r" b="b"/>
            <a:pathLst>
              <a:path w="39370">
                <a:moveTo>
                  <a:pt x="0" y="0"/>
                </a:moveTo>
                <a:lnTo>
                  <a:pt x="39370" y="0"/>
                </a:lnTo>
              </a:path>
            </a:pathLst>
          </a:custGeom>
          <a:ln w="328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" name="object 31"/>
          <p:cNvSpPr/>
          <p:nvPr/>
        </p:nvSpPr>
        <p:spPr>
          <a:xfrm>
            <a:off x="3843586" y="1808859"/>
            <a:ext cx="246244" cy="245668"/>
          </a:xfrm>
          <a:custGeom>
            <a:avLst/>
            <a:gdLst/>
            <a:ahLst/>
            <a:cxnLst/>
            <a:rect l="l" t="t" r="r" b="b"/>
            <a:pathLst>
              <a:path w="271779" h="271144">
                <a:moveTo>
                  <a:pt x="0" y="271070"/>
                </a:moveTo>
                <a:lnTo>
                  <a:pt x="271269" y="271070"/>
                </a:lnTo>
                <a:lnTo>
                  <a:pt x="271269" y="0"/>
                </a:lnTo>
                <a:lnTo>
                  <a:pt x="0" y="0"/>
                </a:lnTo>
                <a:lnTo>
                  <a:pt x="0" y="271070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5420468" y="1784086"/>
            <a:ext cx="352105" cy="352105"/>
          </a:xfrm>
          <a:custGeom>
            <a:avLst/>
            <a:gdLst/>
            <a:ahLst/>
            <a:cxnLst/>
            <a:rect l="l" t="t" r="r" b="b"/>
            <a:pathLst>
              <a:path w="388620" h="388619">
                <a:moveTo>
                  <a:pt x="0" y="388327"/>
                </a:moveTo>
                <a:lnTo>
                  <a:pt x="388620" y="388327"/>
                </a:lnTo>
                <a:lnTo>
                  <a:pt x="388620" y="0"/>
                </a:lnTo>
                <a:lnTo>
                  <a:pt x="0" y="0"/>
                </a:lnTo>
                <a:lnTo>
                  <a:pt x="0" y="388327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2427456" y="1598448"/>
            <a:ext cx="316204" cy="99417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 txBox="1"/>
          <p:nvPr/>
        </p:nvSpPr>
        <p:spPr>
          <a:xfrm>
            <a:off x="2415143" y="1593730"/>
            <a:ext cx="319887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35" name="object 35"/>
          <p:cNvSpPr/>
          <p:nvPr/>
        </p:nvSpPr>
        <p:spPr>
          <a:xfrm>
            <a:off x="2419172" y="2212906"/>
            <a:ext cx="158793" cy="113226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 txBox="1"/>
          <p:nvPr/>
        </p:nvSpPr>
        <p:spPr>
          <a:xfrm>
            <a:off x="2408239" y="2209569"/>
            <a:ext cx="15821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37" name="object 37"/>
          <p:cNvSpPr/>
          <p:nvPr/>
        </p:nvSpPr>
        <p:spPr>
          <a:xfrm>
            <a:off x="3482391" y="2218429"/>
            <a:ext cx="157412" cy="111845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 txBox="1"/>
          <p:nvPr/>
        </p:nvSpPr>
        <p:spPr>
          <a:xfrm>
            <a:off x="3471690" y="2215092"/>
            <a:ext cx="15591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v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39" name="object 39"/>
          <p:cNvSpPr/>
          <p:nvPr/>
        </p:nvSpPr>
        <p:spPr>
          <a:xfrm>
            <a:off x="4055427" y="2212908"/>
            <a:ext cx="120128" cy="53851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 txBox="1"/>
          <p:nvPr/>
        </p:nvSpPr>
        <p:spPr>
          <a:xfrm>
            <a:off x="4044724" y="2206132"/>
            <a:ext cx="124272" cy="5552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361" b="1" spc="-5" dirty="0">
                <a:solidFill>
                  <a:srgbClr val="FFFFFF"/>
                </a:solidFill>
                <a:latin typeface="Arial"/>
                <a:cs typeface="Arial"/>
              </a:rPr>
              <a:t>5</a:t>
            </a:r>
            <a:r>
              <a:rPr sz="361" b="1" spc="-5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361" b="1" spc="-1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endParaRPr sz="361">
              <a:latin typeface="Arial"/>
              <a:cs typeface="Arial"/>
            </a:endParaRPr>
          </a:p>
        </p:txBody>
      </p:sp>
      <p:sp>
        <p:nvSpPr>
          <p:cNvPr id="41" name="object 41"/>
          <p:cNvSpPr/>
          <p:nvPr/>
        </p:nvSpPr>
        <p:spPr>
          <a:xfrm>
            <a:off x="4080281" y="2260543"/>
            <a:ext cx="75944" cy="0"/>
          </a:xfrm>
          <a:custGeom>
            <a:avLst/>
            <a:gdLst/>
            <a:ahLst/>
            <a:cxnLst/>
            <a:rect l="l" t="t" r="r" b="b"/>
            <a:pathLst>
              <a:path w="83820">
                <a:moveTo>
                  <a:pt x="0" y="0"/>
                </a:moveTo>
                <a:lnTo>
                  <a:pt x="83820" y="0"/>
                </a:lnTo>
              </a:path>
            </a:pathLst>
          </a:custGeom>
          <a:ln w="5843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4279116" y="2215668"/>
            <a:ext cx="131176" cy="113226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 txBox="1"/>
          <p:nvPr/>
        </p:nvSpPr>
        <p:spPr>
          <a:xfrm>
            <a:off x="4268416" y="2212332"/>
            <a:ext cx="13347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44" name="object 44"/>
          <p:cNvSpPr/>
          <p:nvPr/>
        </p:nvSpPr>
        <p:spPr>
          <a:xfrm>
            <a:off x="5088268" y="2217048"/>
            <a:ext cx="157412" cy="111845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5" name="object 45"/>
          <p:cNvSpPr txBox="1"/>
          <p:nvPr/>
        </p:nvSpPr>
        <p:spPr>
          <a:xfrm>
            <a:off x="5077911" y="2213711"/>
            <a:ext cx="15591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46" name="object 46"/>
          <p:cNvSpPr/>
          <p:nvPr/>
        </p:nvSpPr>
        <p:spPr>
          <a:xfrm>
            <a:off x="5703531" y="2247427"/>
            <a:ext cx="97233" cy="42804"/>
          </a:xfrm>
          <a:prstGeom prst="rect">
            <a:avLst/>
          </a:prstGeom>
          <a:blipFill>
            <a:blip r:embed="rId1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7" name="object 47"/>
          <p:cNvSpPr/>
          <p:nvPr/>
        </p:nvSpPr>
        <p:spPr>
          <a:xfrm>
            <a:off x="5879469" y="2215668"/>
            <a:ext cx="182266" cy="113226"/>
          </a:xfrm>
          <a:prstGeom prst="rect">
            <a:avLst/>
          </a:prstGeom>
          <a:blipFill>
            <a:blip r:embed="rId1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8" name="object 48"/>
          <p:cNvSpPr txBox="1"/>
          <p:nvPr/>
        </p:nvSpPr>
        <p:spPr>
          <a:xfrm>
            <a:off x="5867734" y="2212332"/>
            <a:ext cx="17892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49" name="object 49"/>
          <p:cNvSpPr/>
          <p:nvPr/>
        </p:nvSpPr>
        <p:spPr>
          <a:xfrm>
            <a:off x="3286317" y="2266759"/>
            <a:ext cx="57994" cy="22092"/>
          </a:xfrm>
          <a:prstGeom prst="rect">
            <a:avLst/>
          </a:prstGeom>
          <a:blipFill>
            <a:blip r:embed="rId1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0" name="object 50"/>
          <p:cNvSpPr/>
          <p:nvPr/>
        </p:nvSpPr>
        <p:spPr>
          <a:xfrm>
            <a:off x="3287236" y="2272051"/>
            <a:ext cx="10356" cy="13232"/>
          </a:xfrm>
          <a:custGeom>
            <a:avLst/>
            <a:gdLst/>
            <a:ahLst/>
            <a:cxnLst/>
            <a:rect l="l" t="t" r="r" b="b"/>
            <a:pathLst>
              <a:path w="11429" h="14605">
                <a:moveTo>
                  <a:pt x="3048" y="10033"/>
                </a:moveTo>
                <a:lnTo>
                  <a:pt x="0" y="10287"/>
                </a:lnTo>
                <a:lnTo>
                  <a:pt x="127" y="11557"/>
                </a:lnTo>
                <a:lnTo>
                  <a:pt x="762" y="12446"/>
                </a:lnTo>
                <a:lnTo>
                  <a:pt x="1651" y="13208"/>
                </a:lnTo>
                <a:lnTo>
                  <a:pt x="2667" y="13843"/>
                </a:lnTo>
                <a:lnTo>
                  <a:pt x="3937" y="14224"/>
                </a:lnTo>
                <a:lnTo>
                  <a:pt x="7239" y="14224"/>
                </a:lnTo>
                <a:lnTo>
                  <a:pt x="8763" y="13589"/>
                </a:lnTo>
                <a:lnTo>
                  <a:pt x="9779" y="12319"/>
                </a:lnTo>
                <a:lnTo>
                  <a:pt x="9996" y="12065"/>
                </a:lnTo>
                <a:lnTo>
                  <a:pt x="4826" y="12065"/>
                </a:lnTo>
                <a:lnTo>
                  <a:pt x="4318" y="11811"/>
                </a:lnTo>
                <a:lnTo>
                  <a:pt x="3937" y="11557"/>
                </a:lnTo>
                <a:lnTo>
                  <a:pt x="3429" y="11176"/>
                </a:lnTo>
                <a:lnTo>
                  <a:pt x="3175" y="10668"/>
                </a:lnTo>
                <a:lnTo>
                  <a:pt x="3048" y="10033"/>
                </a:lnTo>
                <a:close/>
              </a:path>
              <a:path w="11429" h="14605">
                <a:moveTo>
                  <a:pt x="10395" y="6604"/>
                </a:moveTo>
                <a:lnTo>
                  <a:pt x="6096" y="6604"/>
                </a:lnTo>
                <a:lnTo>
                  <a:pt x="6604" y="6858"/>
                </a:lnTo>
                <a:lnTo>
                  <a:pt x="7112" y="7239"/>
                </a:lnTo>
                <a:lnTo>
                  <a:pt x="7493" y="7747"/>
                </a:lnTo>
                <a:lnTo>
                  <a:pt x="7747" y="8382"/>
                </a:lnTo>
                <a:lnTo>
                  <a:pt x="7747" y="10160"/>
                </a:lnTo>
                <a:lnTo>
                  <a:pt x="7493" y="10922"/>
                </a:lnTo>
                <a:lnTo>
                  <a:pt x="6604" y="11811"/>
                </a:lnTo>
                <a:lnTo>
                  <a:pt x="6096" y="12065"/>
                </a:lnTo>
                <a:lnTo>
                  <a:pt x="9996" y="12065"/>
                </a:lnTo>
                <a:lnTo>
                  <a:pt x="10541" y="11430"/>
                </a:lnTo>
                <a:lnTo>
                  <a:pt x="10922" y="10414"/>
                </a:lnTo>
                <a:lnTo>
                  <a:pt x="10922" y="7874"/>
                </a:lnTo>
                <a:lnTo>
                  <a:pt x="10541" y="6731"/>
                </a:lnTo>
                <a:lnTo>
                  <a:pt x="10395" y="6604"/>
                </a:lnTo>
                <a:close/>
              </a:path>
              <a:path w="11429" h="14605">
                <a:moveTo>
                  <a:pt x="10287" y="0"/>
                </a:moveTo>
                <a:lnTo>
                  <a:pt x="2032" y="0"/>
                </a:lnTo>
                <a:lnTo>
                  <a:pt x="381" y="7366"/>
                </a:lnTo>
                <a:lnTo>
                  <a:pt x="2921" y="7620"/>
                </a:lnTo>
                <a:lnTo>
                  <a:pt x="3683" y="6985"/>
                </a:lnTo>
                <a:lnTo>
                  <a:pt x="4445" y="6604"/>
                </a:lnTo>
                <a:lnTo>
                  <a:pt x="10395" y="6604"/>
                </a:lnTo>
                <a:lnTo>
                  <a:pt x="8509" y="4953"/>
                </a:lnTo>
                <a:lnTo>
                  <a:pt x="3810" y="4953"/>
                </a:lnTo>
                <a:lnTo>
                  <a:pt x="4318" y="2540"/>
                </a:lnTo>
                <a:lnTo>
                  <a:pt x="10287" y="2540"/>
                </a:lnTo>
                <a:lnTo>
                  <a:pt x="10287" y="0"/>
                </a:lnTo>
                <a:close/>
              </a:path>
              <a:path w="11429" h="14605">
                <a:moveTo>
                  <a:pt x="7366" y="4445"/>
                </a:moveTo>
                <a:lnTo>
                  <a:pt x="5207" y="4445"/>
                </a:lnTo>
                <a:lnTo>
                  <a:pt x="4572" y="4572"/>
                </a:lnTo>
                <a:lnTo>
                  <a:pt x="3810" y="4953"/>
                </a:lnTo>
                <a:lnTo>
                  <a:pt x="8509" y="4953"/>
                </a:lnTo>
                <a:lnTo>
                  <a:pt x="7366" y="4445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1" name="object 51"/>
          <p:cNvSpPr/>
          <p:nvPr/>
        </p:nvSpPr>
        <p:spPr>
          <a:xfrm>
            <a:off x="3304036" y="2275157"/>
            <a:ext cx="24165" cy="13232"/>
          </a:xfrm>
          <a:custGeom>
            <a:avLst/>
            <a:gdLst/>
            <a:ahLst/>
            <a:cxnLst/>
            <a:rect l="l" t="t" r="r" b="b"/>
            <a:pathLst>
              <a:path w="26670" h="14605">
                <a:moveTo>
                  <a:pt x="3048" y="254"/>
                </a:moveTo>
                <a:lnTo>
                  <a:pt x="0" y="254"/>
                </a:lnTo>
                <a:lnTo>
                  <a:pt x="0" y="14478"/>
                </a:lnTo>
                <a:lnTo>
                  <a:pt x="3048" y="14478"/>
                </a:lnTo>
                <a:lnTo>
                  <a:pt x="3048" y="9271"/>
                </a:lnTo>
                <a:lnTo>
                  <a:pt x="9271" y="9271"/>
                </a:lnTo>
                <a:lnTo>
                  <a:pt x="9271" y="8636"/>
                </a:lnTo>
                <a:lnTo>
                  <a:pt x="4572" y="8636"/>
                </a:lnTo>
                <a:lnTo>
                  <a:pt x="3937" y="8255"/>
                </a:lnTo>
                <a:lnTo>
                  <a:pt x="3556" y="7620"/>
                </a:lnTo>
                <a:lnTo>
                  <a:pt x="3175" y="7112"/>
                </a:lnTo>
                <a:lnTo>
                  <a:pt x="3048" y="6223"/>
                </a:lnTo>
                <a:lnTo>
                  <a:pt x="3048" y="254"/>
                </a:lnTo>
                <a:close/>
              </a:path>
              <a:path w="26670" h="14605">
                <a:moveTo>
                  <a:pt x="7747" y="9271"/>
                </a:moveTo>
                <a:lnTo>
                  <a:pt x="3048" y="9271"/>
                </a:lnTo>
                <a:lnTo>
                  <a:pt x="3429" y="9906"/>
                </a:lnTo>
                <a:lnTo>
                  <a:pt x="3683" y="10287"/>
                </a:lnTo>
                <a:lnTo>
                  <a:pt x="4064" y="10414"/>
                </a:lnTo>
                <a:lnTo>
                  <a:pt x="4445" y="10668"/>
                </a:lnTo>
                <a:lnTo>
                  <a:pt x="4953" y="10795"/>
                </a:lnTo>
                <a:lnTo>
                  <a:pt x="5715" y="10795"/>
                </a:lnTo>
                <a:lnTo>
                  <a:pt x="5969" y="10668"/>
                </a:lnTo>
                <a:lnTo>
                  <a:pt x="6731" y="10414"/>
                </a:lnTo>
                <a:lnTo>
                  <a:pt x="6985" y="10287"/>
                </a:lnTo>
                <a:lnTo>
                  <a:pt x="7620" y="9652"/>
                </a:lnTo>
                <a:lnTo>
                  <a:pt x="7747" y="9271"/>
                </a:lnTo>
                <a:close/>
              </a:path>
              <a:path w="26670" h="14605">
                <a:moveTo>
                  <a:pt x="9271" y="9271"/>
                </a:moveTo>
                <a:lnTo>
                  <a:pt x="7747" y="9271"/>
                </a:lnTo>
                <a:lnTo>
                  <a:pt x="7747" y="10541"/>
                </a:lnTo>
                <a:lnTo>
                  <a:pt x="9271" y="10541"/>
                </a:lnTo>
                <a:lnTo>
                  <a:pt x="9271" y="9271"/>
                </a:lnTo>
                <a:close/>
              </a:path>
              <a:path w="26670" h="14605">
                <a:moveTo>
                  <a:pt x="10668" y="254"/>
                </a:moveTo>
                <a:lnTo>
                  <a:pt x="9271" y="254"/>
                </a:lnTo>
                <a:lnTo>
                  <a:pt x="9271" y="10541"/>
                </a:lnTo>
                <a:lnTo>
                  <a:pt x="10668" y="10541"/>
                </a:lnTo>
                <a:lnTo>
                  <a:pt x="10668" y="254"/>
                </a:lnTo>
                <a:close/>
              </a:path>
              <a:path w="26670" h="14605">
                <a:moveTo>
                  <a:pt x="12192" y="254"/>
                </a:moveTo>
                <a:lnTo>
                  <a:pt x="10668" y="254"/>
                </a:lnTo>
                <a:lnTo>
                  <a:pt x="10668" y="10541"/>
                </a:lnTo>
                <a:lnTo>
                  <a:pt x="12446" y="10541"/>
                </a:lnTo>
                <a:lnTo>
                  <a:pt x="12446" y="3810"/>
                </a:lnTo>
                <a:lnTo>
                  <a:pt x="12700" y="3429"/>
                </a:lnTo>
                <a:lnTo>
                  <a:pt x="14351" y="2159"/>
                </a:lnTo>
                <a:lnTo>
                  <a:pt x="26458" y="2159"/>
                </a:lnTo>
                <a:lnTo>
                  <a:pt x="26289" y="1905"/>
                </a:lnTo>
                <a:lnTo>
                  <a:pt x="26187" y="1651"/>
                </a:lnTo>
                <a:lnTo>
                  <a:pt x="12192" y="1651"/>
                </a:lnTo>
                <a:lnTo>
                  <a:pt x="12192" y="254"/>
                </a:lnTo>
                <a:close/>
              </a:path>
              <a:path w="26670" h="14605">
                <a:moveTo>
                  <a:pt x="21463" y="2159"/>
                </a:moveTo>
                <a:lnTo>
                  <a:pt x="15494" y="2159"/>
                </a:lnTo>
                <a:lnTo>
                  <a:pt x="16002" y="2413"/>
                </a:lnTo>
                <a:lnTo>
                  <a:pt x="16256" y="2921"/>
                </a:lnTo>
                <a:lnTo>
                  <a:pt x="16383" y="3302"/>
                </a:lnTo>
                <a:lnTo>
                  <a:pt x="16383" y="10541"/>
                </a:lnTo>
                <a:lnTo>
                  <a:pt x="19558" y="10541"/>
                </a:lnTo>
                <a:lnTo>
                  <a:pt x="19558" y="4699"/>
                </a:lnTo>
                <a:lnTo>
                  <a:pt x="19685" y="3937"/>
                </a:lnTo>
                <a:lnTo>
                  <a:pt x="21082" y="2286"/>
                </a:lnTo>
                <a:lnTo>
                  <a:pt x="21463" y="2159"/>
                </a:lnTo>
                <a:close/>
              </a:path>
              <a:path w="26670" h="14605">
                <a:moveTo>
                  <a:pt x="26458" y="2159"/>
                </a:moveTo>
                <a:lnTo>
                  <a:pt x="22479" y="2159"/>
                </a:lnTo>
                <a:lnTo>
                  <a:pt x="22860" y="2286"/>
                </a:lnTo>
                <a:lnTo>
                  <a:pt x="23241" y="2667"/>
                </a:lnTo>
                <a:lnTo>
                  <a:pt x="23368" y="3048"/>
                </a:lnTo>
                <a:lnTo>
                  <a:pt x="23495" y="3683"/>
                </a:lnTo>
                <a:lnTo>
                  <a:pt x="23495" y="10541"/>
                </a:lnTo>
                <a:lnTo>
                  <a:pt x="26670" y="10541"/>
                </a:lnTo>
                <a:lnTo>
                  <a:pt x="26670" y="3048"/>
                </a:lnTo>
                <a:lnTo>
                  <a:pt x="26543" y="2286"/>
                </a:lnTo>
                <a:lnTo>
                  <a:pt x="26458" y="2159"/>
                </a:lnTo>
                <a:close/>
              </a:path>
              <a:path w="26670" h="14605">
                <a:moveTo>
                  <a:pt x="9271" y="254"/>
                </a:moveTo>
                <a:lnTo>
                  <a:pt x="7493" y="254"/>
                </a:lnTo>
                <a:lnTo>
                  <a:pt x="7493" y="6858"/>
                </a:lnTo>
                <a:lnTo>
                  <a:pt x="7239" y="7239"/>
                </a:lnTo>
                <a:lnTo>
                  <a:pt x="7112" y="7747"/>
                </a:lnTo>
                <a:lnTo>
                  <a:pt x="6858" y="8001"/>
                </a:lnTo>
                <a:lnTo>
                  <a:pt x="6096" y="8509"/>
                </a:lnTo>
                <a:lnTo>
                  <a:pt x="5715" y="8636"/>
                </a:lnTo>
                <a:lnTo>
                  <a:pt x="9271" y="8636"/>
                </a:lnTo>
                <a:lnTo>
                  <a:pt x="9271" y="254"/>
                </a:lnTo>
                <a:close/>
              </a:path>
              <a:path w="26670" h="14605">
                <a:moveTo>
                  <a:pt x="16637" y="0"/>
                </a:moveTo>
                <a:lnTo>
                  <a:pt x="14478" y="0"/>
                </a:lnTo>
                <a:lnTo>
                  <a:pt x="13208" y="635"/>
                </a:lnTo>
                <a:lnTo>
                  <a:pt x="12192" y="1651"/>
                </a:lnTo>
                <a:lnTo>
                  <a:pt x="19177" y="1651"/>
                </a:lnTo>
                <a:lnTo>
                  <a:pt x="16637" y="0"/>
                </a:lnTo>
                <a:close/>
              </a:path>
              <a:path w="26670" h="14605">
                <a:moveTo>
                  <a:pt x="23622" y="0"/>
                </a:moveTo>
                <a:lnTo>
                  <a:pt x="22098" y="0"/>
                </a:lnTo>
                <a:lnTo>
                  <a:pt x="21463" y="127"/>
                </a:lnTo>
                <a:lnTo>
                  <a:pt x="20828" y="381"/>
                </a:lnTo>
                <a:lnTo>
                  <a:pt x="20193" y="762"/>
                </a:lnTo>
                <a:lnTo>
                  <a:pt x="19685" y="1143"/>
                </a:lnTo>
                <a:lnTo>
                  <a:pt x="19177" y="1651"/>
                </a:lnTo>
                <a:lnTo>
                  <a:pt x="26187" y="1651"/>
                </a:lnTo>
                <a:lnTo>
                  <a:pt x="26035" y="1270"/>
                </a:lnTo>
                <a:lnTo>
                  <a:pt x="25527" y="762"/>
                </a:lnTo>
                <a:lnTo>
                  <a:pt x="25019" y="508"/>
                </a:lnTo>
                <a:lnTo>
                  <a:pt x="24384" y="127"/>
                </a:lnTo>
                <a:lnTo>
                  <a:pt x="23622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2" name="object 52"/>
          <p:cNvSpPr/>
          <p:nvPr/>
        </p:nvSpPr>
        <p:spPr>
          <a:xfrm>
            <a:off x="1525445" y="3716144"/>
            <a:ext cx="774631" cy="774631"/>
          </a:xfrm>
          <a:prstGeom prst="rect">
            <a:avLst/>
          </a:prstGeom>
          <a:blipFill>
            <a:blip r:embed="rId2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3" name="object 53"/>
          <p:cNvSpPr/>
          <p:nvPr/>
        </p:nvSpPr>
        <p:spPr>
          <a:xfrm>
            <a:off x="460844" y="3721667"/>
            <a:ext cx="1034222" cy="774631"/>
          </a:xfrm>
          <a:prstGeom prst="rect">
            <a:avLst/>
          </a:prstGeom>
          <a:blipFill>
            <a:blip r:embed="rId2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4" name="object 54"/>
          <p:cNvSpPr/>
          <p:nvPr/>
        </p:nvSpPr>
        <p:spPr>
          <a:xfrm>
            <a:off x="1422229" y="4456944"/>
            <a:ext cx="35671" cy="0"/>
          </a:xfrm>
          <a:custGeom>
            <a:avLst/>
            <a:gdLst/>
            <a:ahLst/>
            <a:cxnLst/>
            <a:rect l="l" t="t" r="r" b="b"/>
            <a:pathLst>
              <a:path w="39369">
                <a:moveTo>
                  <a:pt x="0" y="0"/>
                </a:moveTo>
                <a:lnTo>
                  <a:pt x="39370" y="0"/>
                </a:lnTo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5" name="object 55"/>
          <p:cNvSpPr/>
          <p:nvPr/>
        </p:nvSpPr>
        <p:spPr>
          <a:xfrm>
            <a:off x="501234" y="3749743"/>
            <a:ext cx="316204" cy="99417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6" name="object 56"/>
          <p:cNvSpPr txBox="1"/>
          <p:nvPr/>
        </p:nvSpPr>
        <p:spPr>
          <a:xfrm>
            <a:off x="489727" y="3745371"/>
            <a:ext cx="319887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57" name="object 57"/>
          <p:cNvSpPr/>
          <p:nvPr/>
        </p:nvSpPr>
        <p:spPr>
          <a:xfrm>
            <a:off x="490185" y="4353154"/>
            <a:ext cx="104941" cy="11184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8" name="object 58"/>
          <p:cNvSpPr txBox="1"/>
          <p:nvPr/>
        </p:nvSpPr>
        <p:spPr>
          <a:xfrm>
            <a:off x="478678" y="4350163"/>
            <a:ext cx="10873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59" name="object 59"/>
          <p:cNvSpPr/>
          <p:nvPr/>
        </p:nvSpPr>
        <p:spPr>
          <a:xfrm>
            <a:off x="1547883" y="4355916"/>
            <a:ext cx="132557" cy="11184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0" name="object 60"/>
          <p:cNvSpPr txBox="1"/>
          <p:nvPr/>
        </p:nvSpPr>
        <p:spPr>
          <a:xfrm>
            <a:off x="1536605" y="4352924"/>
            <a:ext cx="132327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61" name="object 61"/>
          <p:cNvSpPr/>
          <p:nvPr/>
        </p:nvSpPr>
        <p:spPr>
          <a:xfrm>
            <a:off x="1423612" y="4441527"/>
            <a:ext cx="45566" cy="16569"/>
          </a:xfrm>
          <a:prstGeom prst="rect">
            <a:avLst/>
          </a:prstGeom>
          <a:blipFill>
            <a:blip r:embed="rId2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2" name="object 62"/>
          <p:cNvSpPr/>
          <p:nvPr/>
        </p:nvSpPr>
        <p:spPr>
          <a:xfrm>
            <a:off x="1424300" y="4446936"/>
            <a:ext cx="6329" cy="7479"/>
          </a:xfrm>
          <a:custGeom>
            <a:avLst/>
            <a:gdLst/>
            <a:ahLst/>
            <a:cxnLst/>
            <a:rect l="l" t="t" r="r" b="b"/>
            <a:pathLst>
              <a:path w="6984" h="8254">
                <a:moveTo>
                  <a:pt x="1016" y="6350"/>
                </a:moveTo>
                <a:lnTo>
                  <a:pt x="0" y="6350"/>
                </a:lnTo>
                <a:lnTo>
                  <a:pt x="0" y="7239"/>
                </a:lnTo>
                <a:lnTo>
                  <a:pt x="127" y="7366"/>
                </a:lnTo>
                <a:lnTo>
                  <a:pt x="127" y="7493"/>
                </a:lnTo>
                <a:lnTo>
                  <a:pt x="381" y="7493"/>
                </a:lnTo>
                <a:lnTo>
                  <a:pt x="508" y="7620"/>
                </a:lnTo>
                <a:lnTo>
                  <a:pt x="762" y="7620"/>
                </a:lnTo>
                <a:lnTo>
                  <a:pt x="1016" y="7747"/>
                </a:lnTo>
                <a:lnTo>
                  <a:pt x="1524" y="7747"/>
                </a:lnTo>
                <a:lnTo>
                  <a:pt x="1778" y="7874"/>
                </a:lnTo>
                <a:lnTo>
                  <a:pt x="3937" y="7874"/>
                </a:lnTo>
                <a:lnTo>
                  <a:pt x="4953" y="7620"/>
                </a:lnTo>
                <a:lnTo>
                  <a:pt x="5334" y="7366"/>
                </a:lnTo>
                <a:lnTo>
                  <a:pt x="5715" y="7239"/>
                </a:lnTo>
                <a:lnTo>
                  <a:pt x="6096" y="6985"/>
                </a:lnTo>
                <a:lnTo>
                  <a:pt x="6350" y="6731"/>
                </a:lnTo>
                <a:lnTo>
                  <a:pt x="6392" y="6604"/>
                </a:lnTo>
                <a:lnTo>
                  <a:pt x="1651" y="6604"/>
                </a:lnTo>
                <a:lnTo>
                  <a:pt x="1397" y="6477"/>
                </a:lnTo>
                <a:lnTo>
                  <a:pt x="1143" y="6477"/>
                </a:lnTo>
                <a:lnTo>
                  <a:pt x="1016" y="6350"/>
                </a:lnTo>
                <a:close/>
              </a:path>
              <a:path w="6984" h="8254">
                <a:moveTo>
                  <a:pt x="6096" y="127"/>
                </a:moveTo>
                <a:lnTo>
                  <a:pt x="508" y="127"/>
                </a:lnTo>
                <a:lnTo>
                  <a:pt x="508" y="254"/>
                </a:lnTo>
                <a:lnTo>
                  <a:pt x="381" y="381"/>
                </a:lnTo>
                <a:lnTo>
                  <a:pt x="381" y="3937"/>
                </a:lnTo>
                <a:lnTo>
                  <a:pt x="508" y="4064"/>
                </a:lnTo>
                <a:lnTo>
                  <a:pt x="508" y="4191"/>
                </a:lnTo>
                <a:lnTo>
                  <a:pt x="3429" y="4191"/>
                </a:lnTo>
                <a:lnTo>
                  <a:pt x="3683" y="4318"/>
                </a:lnTo>
                <a:lnTo>
                  <a:pt x="3937" y="4318"/>
                </a:lnTo>
                <a:lnTo>
                  <a:pt x="4064" y="4445"/>
                </a:lnTo>
                <a:lnTo>
                  <a:pt x="4318" y="4572"/>
                </a:lnTo>
                <a:lnTo>
                  <a:pt x="4318" y="4699"/>
                </a:lnTo>
                <a:lnTo>
                  <a:pt x="4572" y="4953"/>
                </a:lnTo>
                <a:lnTo>
                  <a:pt x="4572" y="5715"/>
                </a:lnTo>
                <a:lnTo>
                  <a:pt x="4445" y="5969"/>
                </a:lnTo>
                <a:lnTo>
                  <a:pt x="4064" y="6350"/>
                </a:lnTo>
                <a:lnTo>
                  <a:pt x="3810" y="6477"/>
                </a:lnTo>
                <a:lnTo>
                  <a:pt x="3683" y="6477"/>
                </a:lnTo>
                <a:lnTo>
                  <a:pt x="3429" y="6604"/>
                </a:lnTo>
                <a:lnTo>
                  <a:pt x="6392" y="6604"/>
                </a:lnTo>
                <a:lnTo>
                  <a:pt x="6477" y="6350"/>
                </a:lnTo>
                <a:lnTo>
                  <a:pt x="6731" y="6096"/>
                </a:lnTo>
                <a:lnTo>
                  <a:pt x="6858" y="5715"/>
                </a:lnTo>
                <a:lnTo>
                  <a:pt x="6858" y="4826"/>
                </a:lnTo>
                <a:lnTo>
                  <a:pt x="6604" y="4318"/>
                </a:lnTo>
                <a:lnTo>
                  <a:pt x="6477" y="3937"/>
                </a:lnTo>
                <a:lnTo>
                  <a:pt x="6223" y="3810"/>
                </a:lnTo>
                <a:lnTo>
                  <a:pt x="5969" y="3556"/>
                </a:lnTo>
                <a:lnTo>
                  <a:pt x="4826" y="3175"/>
                </a:lnTo>
                <a:lnTo>
                  <a:pt x="4318" y="3048"/>
                </a:lnTo>
                <a:lnTo>
                  <a:pt x="2159" y="3048"/>
                </a:lnTo>
                <a:lnTo>
                  <a:pt x="2159" y="1397"/>
                </a:lnTo>
                <a:lnTo>
                  <a:pt x="5969" y="1397"/>
                </a:lnTo>
                <a:lnTo>
                  <a:pt x="6223" y="1143"/>
                </a:lnTo>
                <a:lnTo>
                  <a:pt x="6223" y="254"/>
                </a:lnTo>
                <a:lnTo>
                  <a:pt x="6096" y="254"/>
                </a:lnTo>
                <a:lnTo>
                  <a:pt x="6096" y="127"/>
                </a:lnTo>
                <a:close/>
              </a:path>
              <a:path w="6984" h="8254">
                <a:moveTo>
                  <a:pt x="508" y="6223"/>
                </a:moveTo>
                <a:lnTo>
                  <a:pt x="127" y="6223"/>
                </a:lnTo>
                <a:lnTo>
                  <a:pt x="127" y="6350"/>
                </a:lnTo>
                <a:lnTo>
                  <a:pt x="635" y="6350"/>
                </a:lnTo>
                <a:lnTo>
                  <a:pt x="508" y="6223"/>
                </a:lnTo>
                <a:close/>
              </a:path>
              <a:path w="6984" h="8254">
                <a:moveTo>
                  <a:pt x="5969" y="0"/>
                </a:moveTo>
                <a:lnTo>
                  <a:pt x="762" y="0"/>
                </a:lnTo>
                <a:lnTo>
                  <a:pt x="635" y="127"/>
                </a:lnTo>
                <a:lnTo>
                  <a:pt x="5969" y="127"/>
                </a:lnTo>
                <a:lnTo>
                  <a:pt x="5969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3" name="object 63"/>
          <p:cNvSpPr/>
          <p:nvPr/>
        </p:nvSpPr>
        <p:spPr>
          <a:xfrm>
            <a:off x="1434197" y="4448661"/>
            <a:ext cx="16108" cy="7479"/>
          </a:xfrm>
          <a:custGeom>
            <a:avLst/>
            <a:gdLst/>
            <a:ahLst/>
            <a:cxnLst/>
            <a:rect l="l" t="t" r="r" b="b"/>
            <a:pathLst>
              <a:path w="17780" h="8254">
                <a:moveTo>
                  <a:pt x="1778" y="7874"/>
                </a:moveTo>
                <a:lnTo>
                  <a:pt x="254" y="7874"/>
                </a:lnTo>
                <a:lnTo>
                  <a:pt x="254" y="8001"/>
                </a:lnTo>
                <a:lnTo>
                  <a:pt x="1778" y="8001"/>
                </a:lnTo>
                <a:lnTo>
                  <a:pt x="1778" y="7874"/>
                </a:lnTo>
                <a:close/>
              </a:path>
              <a:path w="17780" h="8254">
                <a:moveTo>
                  <a:pt x="2032" y="254"/>
                </a:moveTo>
                <a:lnTo>
                  <a:pt x="0" y="254"/>
                </a:lnTo>
                <a:lnTo>
                  <a:pt x="0" y="7874"/>
                </a:lnTo>
                <a:lnTo>
                  <a:pt x="2032" y="7874"/>
                </a:lnTo>
                <a:lnTo>
                  <a:pt x="2032" y="6350"/>
                </a:lnTo>
                <a:lnTo>
                  <a:pt x="1905" y="6223"/>
                </a:lnTo>
                <a:lnTo>
                  <a:pt x="1905" y="5588"/>
                </a:lnTo>
                <a:lnTo>
                  <a:pt x="4318" y="5588"/>
                </a:lnTo>
                <a:lnTo>
                  <a:pt x="5080" y="5080"/>
                </a:lnTo>
                <a:lnTo>
                  <a:pt x="6096" y="5080"/>
                </a:lnTo>
                <a:lnTo>
                  <a:pt x="6096" y="4699"/>
                </a:lnTo>
                <a:lnTo>
                  <a:pt x="2794" y="4699"/>
                </a:lnTo>
                <a:lnTo>
                  <a:pt x="2540" y="4572"/>
                </a:lnTo>
                <a:lnTo>
                  <a:pt x="2159" y="4191"/>
                </a:lnTo>
                <a:lnTo>
                  <a:pt x="2032" y="3937"/>
                </a:lnTo>
                <a:lnTo>
                  <a:pt x="2032" y="254"/>
                </a:lnTo>
                <a:close/>
              </a:path>
              <a:path w="17780" h="8254">
                <a:moveTo>
                  <a:pt x="4318" y="5588"/>
                </a:moveTo>
                <a:lnTo>
                  <a:pt x="1905" y="5588"/>
                </a:lnTo>
                <a:lnTo>
                  <a:pt x="2159" y="5842"/>
                </a:lnTo>
                <a:lnTo>
                  <a:pt x="2286" y="5842"/>
                </a:lnTo>
                <a:lnTo>
                  <a:pt x="2540" y="5969"/>
                </a:lnTo>
                <a:lnTo>
                  <a:pt x="3302" y="5969"/>
                </a:lnTo>
                <a:lnTo>
                  <a:pt x="3683" y="5842"/>
                </a:lnTo>
                <a:lnTo>
                  <a:pt x="3937" y="5715"/>
                </a:lnTo>
                <a:lnTo>
                  <a:pt x="4318" y="5588"/>
                </a:lnTo>
                <a:close/>
              </a:path>
              <a:path w="17780" h="8254">
                <a:moveTo>
                  <a:pt x="6096" y="5080"/>
                </a:moveTo>
                <a:lnTo>
                  <a:pt x="5080" y="5080"/>
                </a:lnTo>
                <a:lnTo>
                  <a:pt x="5207" y="5461"/>
                </a:lnTo>
                <a:lnTo>
                  <a:pt x="5334" y="5588"/>
                </a:lnTo>
                <a:lnTo>
                  <a:pt x="5715" y="5715"/>
                </a:lnTo>
                <a:lnTo>
                  <a:pt x="5969" y="5842"/>
                </a:lnTo>
                <a:lnTo>
                  <a:pt x="6350" y="5969"/>
                </a:lnTo>
                <a:lnTo>
                  <a:pt x="7620" y="5969"/>
                </a:lnTo>
                <a:lnTo>
                  <a:pt x="7747" y="5842"/>
                </a:lnTo>
                <a:lnTo>
                  <a:pt x="6223" y="5842"/>
                </a:lnTo>
                <a:lnTo>
                  <a:pt x="6223" y="5715"/>
                </a:lnTo>
                <a:lnTo>
                  <a:pt x="6096" y="5715"/>
                </a:lnTo>
                <a:lnTo>
                  <a:pt x="6096" y="5080"/>
                </a:lnTo>
                <a:close/>
              </a:path>
              <a:path w="17780" h="8254">
                <a:moveTo>
                  <a:pt x="8001" y="5715"/>
                </a:moveTo>
                <a:lnTo>
                  <a:pt x="6223" y="5715"/>
                </a:lnTo>
                <a:lnTo>
                  <a:pt x="6223" y="5842"/>
                </a:lnTo>
                <a:lnTo>
                  <a:pt x="8001" y="5842"/>
                </a:lnTo>
                <a:lnTo>
                  <a:pt x="8001" y="5715"/>
                </a:lnTo>
                <a:close/>
              </a:path>
              <a:path w="17780" h="8254">
                <a:moveTo>
                  <a:pt x="12700" y="5715"/>
                </a:moveTo>
                <a:lnTo>
                  <a:pt x="10922" y="5715"/>
                </a:lnTo>
                <a:lnTo>
                  <a:pt x="10922" y="5842"/>
                </a:lnTo>
                <a:lnTo>
                  <a:pt x="12700" y="5842"/>
                </a:lnTo>
                <a:lnTo>
                  <a:pt x="12700" y="5715"/>
                </a:lnTo>
                <a:close/>
              </a:path>
              <a:path w="17780" h="8254">
                <a:moveTo>
                  <a:pt x="17335" y="1270"/>
                </a:moveTo>
                <a:lnTo>
                  <a:pt x="14732" y="1270"/>
                </a:lnTo>
                <a:lnTo>
                  <a:pt x="14859" y="1397"/>
                </a:lnTo>
                <a:lnTo>
                  <a:pt x="14986" y="1397"/>
                </a:lnTo>
                <a:lnTo>
                  <a:pt x="15240" y="1651"/>
                </a:lnTo>
                <a:lnTo>
                  <a:pt x="15240" y="1778"/>
                </a:lnTo>
                <a:lnTo>
                  <a:pt x="15367" y="1905"/>
                </a:lnTo>
                <a:lnTo>
                  <a:pt x="15367" y="2032"/>
                </a:lnTo>
                <a:lnTo>
                  <a:pt x="15494" y="2159"/>
                </a:lnTo>
                <a:lnTo>
                  <a:pt x="15494" y="5715"/>
                </a:lnTo>
                <a:lnTo>
                  <a:pt x="15621" y="5842"/>
                </a:lnTo>
                <a:lnTo>
                  <a:pt x="17399" y="5842"/>
                </a:lnTo>
                <a:lnTo>
                  <a:pt x="17399" y="5715"/>
                </a:lnTo>
                <a:lnTo>
                  <a:pt x="17526" y="5715"/>
                </a:lnTo>
                <a:lnTo>
                  <a:pt x="17526" y="1905"/>
                </a:lnTo>
                <a:lnTo>
                  <a:pt x="17399" y="1651"/>
                </a:lnTo>
                <a:lnTo>
                  <a:pt x="17399" y="1397"/>
                </a:lnTo>
                <a:lnTo>
                  <a:pt x="17335" y="1270"/>
                </a:lnTo>
                <a:close/>
              </a:path>
              <a:path w="17780" h="8254">
                <a:moveTo>
                  <a:pt x="6731" y="127"/>
                </a:moveTo>
                <a:lnTo>
                  <a:pt x="6223" y="127"/>
                </a:lnTo>
                <a:lnTo>
                  <a:pt x="6096" y="254"/>
                </a:lnTo>
                <a:lnTo>
                  <a:pt x="6096" y="5715"/>
                </a:lnTo>
                <a:lnTo>
                  <a:pt x="8128" y="5715"/>
                </a:lnTo>
                <a:lnTo>
                  <a:pt x="8128" y="4699"/>
                </a:lnTo>
                <a:lnTo>
                  <a:pt x="7112" y="4699"/>
                </a:lnTo>
                <a:lnTo>
                  <a:pt x="6985" y="4572"/>
                </a:lnTo>
                <a:lnTo>
                  <a:pt x="6985" y="4445"/>
                </a:lnTo>
                <a:lnTo>
                  <a:pt x="6858" y="4445"/>
                </a:lnTo>
                <a:lnTo>
                  <a:pt x="6858" y="254"/>
                </a:lnTo>
                <a:lnTo>
                  <a:pt x="6731" y="254"/>
                </a:lnTo>
                <a:lnTo>
                  <a:pt x="6731" y="127"/>
                </a:lnTo>
                <a:close/>
              </a:path>
              <a:path w="17780" h="8254">
                <a:moveTo>
                  <a:pt x="14097" y="1270"/>
                </a:moveTo>
                <a:lnTo>
                  <a:pt x="10033" y="1270"/>
                </a:lnTo>
                <a:lnTo>
                  <a:pt x="10160" y="1397"/>
                </a:lnTo>
                <a:lnTo>
                  <a:pt x="10287" y="1397"/>
                </a:lnTo>
                <a:lnTo>
                  <a:pt x="10541" y="1651"/>
                </a:lnTo>
                <a:lnTo>
                  <a:pt x="10541" y="1778"/>
                </a:lnTo>
                <a:lnTo>
                  <a:pt x="10668" y="1905"/>
                </a:lnTo>
                <a:lnTo>
                  <a:pt x="10668" y="2032"/>
                </a:lnTo>
                <a:lnTo>
                  <a:pt x="10795" y="2159"/>
                </a:lnTo>
                <a:lnTo>
                  <a:pt x="10795" y="5715"/>
                </a:lnTo>
                <a:lnTo>
                  <a:pt x="12827" y="5715"/>
                </a:lnTo>
                <a:lnTo>
                  <a:pt x="12827" y="2159"/>
                </a:lnTo>
                <a:lnTo>
                  <a:pt x="13335" y="1651"/>
                </a:lnTo>
                <a:lnTo>
                  <a:pt x="14097" y="1270"/>
                </a:lnTo>
                <a:close/>
              </a:path>
              <a:path w="17780" h="8254">
                <a:moveTo>
                  <a:pt x="6223" y="127"/>
                </a:moveTo>
                <a:lnTo>
                  <a:pt x="4953" y="127"/>
                </a:lnTo>
                <a:lnTo>
                  <a:pt x="4953" y="254"/>
                </a:lnTo>
                <a:lnTo>
                  <a:pt x="4826" y="254"/>
                </a:lnTo>
                <a:lnTo>
                  <a:pt x="4826" y="3810"/>
                </a:lnTo>
                <a:lnTo>
                  <a:pt x="4572" y="4191"/>
                </a:lnTo>
                <a:lnTo>
                  <a:pt x="4064" y="4445"/>
                </a:lnTo>
                <a:lnTo>
                  <a:pt x="3683" y="4572"/>
                </a:lnTo>
                <a:lnTo>
                  <a:pt x="3429" y="4699"/>
                </a:lnTo>
                <a:lnTo>
                  <a:pt x="6096" y="4699"/>
                </a:lnTo>
                <a:lnTo>
                  <a:pt x="6096" y="254"/>
                </a:lnTo>
                <a:lnTo>
                  <a:pt x="6223" y="127"/>
                </a:lnTo>
                <a:close/>
              </a:path>
              <a:path w="17780" h="8254">
                <a:moveTo>
                  <a:pt x="7874" y="254"/>
                </a:moveTo>
                <a:lnTo>
                  <a:pt x="6858" y="254"/>
                </a:lnTo>
                <a:lnTo>
                  <a:pt x="6858" y="4445"/>
                </a:lnTo>
                <a:lnTo>
                  <a:pt x="6985" y="4445"/>
                </a:lnTo>
                <a:lnTo>
                  <a:pt x="6985" y="4572"/>
                </a:lnTo>
                <a:lnTo>
                  <a:pt x="7112" y="4699"/>
                </a:lnTo>
                <a:lnTo>
                  <a:pt x="8128" y="4699"/>
                </a:lnTo>
                <a:lnTo>
                  <a:pt x="8128" y="2159"/>
                </a:lnTo>
                <a:lnTo>
                  <a:pt x="8636" y="1651"/>
                </a:lnTo>
                <a:lnTo>
                  <a:pt x="9398" y="1270"/>
                </a:lnTo>
                <a:lnTo>
                  <a:pt x="17335" y="1270"/>
                </a:lnTo>
                <a:lnTo>
                  <a:pt x="17208" y="1016"/>
                </a:lnTo>
                <a:lnTo>
                  <a:pt x="12446" y="1016"/>
                </a:lnTo>
                <a:lnTo>
                  <a:pt x="12446" y="889"/>
                </a:lnTo>
                <a:lnTo>
                  <a:pt x="7874" y="889"/>
                </a:lnTo>
                <a:lnTo>
                  <a:pt x="7874" y="254"/>
                </a:lnTo>
                <a:close/>
              </a:path>
              <a:path w="17780" h="8254">
                <a:moveTo>
                  <a:pt x="15875" y="0"/>
                </a:moveTo>
                <a:lnTo>
                  <a:pt x="14351" y="0"/>
                </a:lnTo>
                <a:lnTo>
                  <a:pt x="14097" y="127"/>
                </a:lnTo>
                <a:lnTo>
                  <a:pt x="13970" y="127"/>
                </a:lnTo>
                <a:lnTo>
                  <a:pt x="13716" y="254"/>
                </a:lnTo>
                <a:lnTo>
                  <a:pt x="13462" y="254"/>
                </a:lnTo>
                <a:lnTo>
                  <a:pt x="13335" y="381"/>
                </a:lnTo>
                <a:lnTo>
                  <a:pt x="13081" y="508"/>
                </a:lnTo>
                <a:lnTo>
                  <a:pt x="12954" y="635"/>
                </a:lnTo>
                <a:lnTo>
                  <a:pt x="12700" y="762"/>
                </a:lnTo>
                <a:lnTo>
                  <a:pt x="12446" y="1016"/>
                </a:lnTo>
                <a:lnTo>
                  <a:pt x="17208" y="1016"/>
                </a:lnTo>
                <a:lnTo>
                  <a:pt x="17145" y="889"/>
                </a:lnTo>
                <a:lnTo>
                  <a:pt x="16510" y="254"/>
                </a:lnTo>
                <a:lnTo>
                  <a:pt x="16129" y="127"/>
                </a:lnTo>
                <a:lnTo>
                  <a:pt x="15875" y="0"/>
                </a:lnTo>
                <a:close/>
              </a:path>
              <a:path w="17780" h="8254">
                <a:moveTo>
                  <a:pt x="11049" y="0"/>
                </a:moveTo>
                <a:lnTo>
                  <a:pt x="9779" y="0"/>
                </a:lnTo>
                <a:lnTo>
                  <a:pt x="8636" y="381"/>
                </a:lnTo>
                <a:lnTo>
                  <a:pt x="7874" y="889"/>
                </a:lnTo>
                <a:lnTo>
                  <a:pt x="12446" y="889"/>
                </a:lnTo>
                <a:lnTo>
                  <a:pt x="12446" y="762"/>
                </a:lnTo>
                <a:lnTo>
                  <a:pt x="12065" y="381"/>
                </a:lnTo>
                <a:lnTo>
                  <a:pt x="11811" y="381"/>
                </a:lnTo>
                <a:lnTo>
                  <a:pt x="11684" y="254"/>
                </a:lnTo>
                <a:lnTo>
                  <a:pt x="11430" y="127"/>
                </a:lnTo>
                <a:lnTo>
                  <a:pt x="11303" y="127"/>
                </a:lnTo>
                <a:lnTo>
                  <a:pt x="11049" y="0"/>
                </a:lnTo>
                <a:close/>
              </a:path>
              <a:path w="17780" h="8254">
                <a:moveTo>
                  <a:pt x="1905" y="127"/>
                </a:moveTo>
                <a:lnTo>
                  <a:pt x="127" y="127"/>
                </a:lnTo>
                <a:lnTo>
                  <a:pt x="127" y="254"/>
                </a:lnTo>
                <a:lnTo>
                  <a:pt x="1905" y="254"/>
                </a:lnTo>
                <a:lnTo>
                  <a:pt x="1905" y="127"/>
                </a:lnTo>
                <a:close/>
              </a:path>
              <a:path w="17780" h="8254">
                <a:moveTo>
                  <a:pt x="7747" y="127"/>
                </a:moveTo>
                <a:lnTo>
                  <a:pt x="6731" y="127"/>
                </a:lnTo>
                <a:lnTo>
                  <a:pt x="6731" y="254"/>
                </a:lnTo>
                <a:lnTo>
                  <a:pt x="7747" y="254"/>
                </a:lnTo>
                <a:lnTo>
                  <a:pt x="7747" y="12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4" name="object 64"/>
          <p:cNvSpPr/>
          <p:nvPr/>
        </p:nvSpPr>
        <p:spPr>
          <a:xfrm>
            <a:off x="5865891" y="3713267"/>
            <a:ext cx="774585" cy="774171"/>
          </a:xfrm>
          <a:prstGeom prst="rect">
            <a:avLst/>
          </a:prstGeom>
          <a:blipFill>
            <a:blip r:embed="rId2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5" name="object 65"/>
          <p:cNvSpPr/>
          <p:nvPr/>
        </p:nvSpPr>
        <p:spPr>
          <a:xfrm>
            <a:off x="3448218" y="3716032"/>
            <a:ext cx="773205" cy="774168"/>
          </a:xfrm>
          <a:prstGeom prst="rect">
            <a:avLst/>
          </a:prstGeom>
          <a:blipFill>
            <a:blip r:embed="rId2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6" name="object 66"/>
          <p:cNvSpPr/>
          <p:nvPr/>
        </p:nvSpPr>
        <p:spPr>
          <a:xfrm>
            <a:off x="4071190" y="4407466"/>
            <a:ext cx="89751" cy="0"/>
          </a:xfrm>
          <a:custGeom>
            <a:avLst/>
            <a:gdLst/>
            <a:ahLst/>
            <a:cxnLst/>
            <a:rect l="l" t="t" r="r" b="b"/>
            <a:pathLst>
              <a:path w="99060">
                <a:moveTo>
                  <a:pt x="0" y="0"/>
                </a:moveTo>
                <a:lnTo>
                  <a:pt x="98679" y="0"/>
                </a:lnTo>
              </a:path>
            </a:pathLst>
          </a:custGeom>
          <a:ln w="821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7" name="object 67"/>
          <p:cNvSpPr/>
          <p:nvPr/>
        </p:nvSpPr>
        <p:spPr>
          <a:xfrm>
            <a:off x="2386493" y="3721552"/>
            <a:ext cx="1034165" cy="774171"/>
          </a:xfrm>
          <a:prstGeom prst="rect">
            <a:avLst/>
          </a:prstGeom>
          <a:blipFill>
            <a:blip r:embed="rId2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8" name="object 68"/>
          <p:cNvSpPr/>
          <p:nvPr/>
        </p:nvSpPr>
        <p:spPr>
          <a:xfrm>
            <a:off x="3325441" y="4445322"/>
            <a:ext cx="36246" cy="0"/>
          </a:xfrm>
          <a:custGeom>
            <a:avLst/>
            <a:gdLst/>
            <a:ahLst/>
            <a:cxnLst/>
            <a:rect l="l" t="t" r="r" b="b"/>
            <a:pathLst>
              <a:path w="40004">
                <a:moveTo>
                  <a:pt x="0" y="0"/>
                </a:moveTo>
                <a:lnTo>
                  <a:pt x="39497" y="0"/>
                </a:lnTo>
              </a:path>
            </a:pathLst>
          </a:custGeom>
          <a:ln w="328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9" name="object 69"/>
          <p:cNvSpPr/>
          <p:nvPr/>
        </p:nvSpPr>
        <p:spPr>
          <a:xfrm>
            <a:off x="5067900" y="3713267"/>
            <a:ext cx="774585" cy="774171"/>
          </a:xfrm>
          <a:prstGeom prst="rect">
            <a:avLst/>
          </a:prstGeom>
          <a:blipFill>
            <a:blip r:embed="rId2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0" name="object 70"/>
          <p:cNvSpPr/>
          <p:nvPr/>
        </p:nvSpPr>
        <p:spPr>
          <a:xfrm>
            <a:off x="4258749" y="3714648"/>
            <a:ext cx="774585" cy="774171"/>
          </a:xfrm>
          <a:prstGeom prst="rect">
            <a:avLst/>
          </a:prstGeom>
          <a:blipFill>
            <a:blip r:embed="rId2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1" name="object 71"/>
          <p:cNvSpPr/>
          <p:nvPr/>
        </p:nvSpPr>
        <p:spPr>
          <a:xfrm>
            <a:off x="3513115" y="3888583"/>
            <a:ext cx="317585" cy="317585"/>
          </a:xfrm>
          <a:custGeom>
            <a:avLst/>
            <a:gdLst/>
            <a:ahLst/>
            <a:cxnLst/>
            <a:rect l="l" t="t" r="r" b="b"/>
            <a:pathLst>
              <a:path w="350520" h="350520">
                <a:moveTo>
                  <a:pt x="0" y="350316"/>
                </a:moveTo>
                <a:lnTo>
                  <a:pt x="350504" y="350316"/>
                </a:lnTo>
                <a:lnTo>
                  <a:pt x="350504" y="0"/>
                </a:lnTo>
                <a:lnTo>
                  <a:pt x="0" y="0"/>
                </a:lnTo>
                <a:lnTo>
                  <a:pt x="0" y="350316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2" name="object 72"/>
          <p:cNvSpPr/>
          <p:nvPr/>
        </p:nvSpPr>
        <p:spPr>
          <a:xfrm>
            <a:off x="5102420" y="4063807"/>
            <a:ext cx="281914" cy="281914"/>
          </a:xfrm>
          <a:custGeom>
            <a:avLst/>
            <a:gdLst/>
            <a:ahLst/>
            <a:cxnLst/>
            <a:rect l="l" t="t" r="r" b="b"/>
            <a:pathLst>
              <a:path w="311150" h="311150">
                <a:moveTo>
                  <a:pt x="0" y="310718"/>
                </a:moveTo>
                <a:lnTo>
                  <a:pt x="310882" y="310718"/>
                </a:lnTo>
                <a:lnTo>
                  <a:pt x="310882" y="0"/>
                </a:lnTo>
                <a:lnTo>
                  <a:pt x="0" y="0"/>
                </a:lnTo>
                <a:lnTo>
                  <a:pt x="0" y="310718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3" name="object 73"/>
          <p:cNvSpPr/>
          <p:nvPr/>
        </p:nvSpPr>
        <p:spPr>
          <a:xfrm>
            <a:off x="2427456" y="3744219"/>
            <a:ext cx="316204" cy="100798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4" name="object 74"/>
          <p:cNvSpPr txBox="1"/>
          <p:nvPr/>
        </p:nvSpPr>
        <p:spPr>
          <a:xfrm>
            <a:off x="2415143" y="3739847"/>
            <a:ext cx="319887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75" name="object 75"/>
          <p:cNvSpPr/>
          <p:nvPr/>
        </p:nvSpPr>
        <p:spPr>
          <a:xfrm>
            <a:off x="2402602" y="4351773"/>
            <a:ext cx="158793" cy="113226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6" name="object 76"/>
          <p:cNvSpPr txBox="1"/>
          <p:nvPr/>
        </p:nvSpPr>
        <p:spPr>
          <a:xfrm>
            <a:off x="2391671" y="4348782"/>
            <a:ext cx="15821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77" name="object 77"/>
          <p:cNvSpPr/>
          <p:nvPr/>
        </p:nvSpPr>
        <p:spPr>
          <a:xfrm>
            <a:off x="4055425" y="4349013"/>
            <a:ext cx="128415" cy="56613"/>
          </a:xfrm>
          <a:prstGeom prst="rect">
            <a:avLst/>
          </a:prstGeom>
          <a:blipFill>
            <a:blip r:embed="rId2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8" name="object 78"/>
          <p:cNvSpPr/>
          <p:nvPr/>
        </p:nvSpPr>
        <p:spPr>
          <a:xfrm>
            <a:off x="4057611" y="4362361"/>
            <a:ext cx="24165" cy="32793"/>
          </a:xfrm>
          <a:custGeom>
            <a:avLst/>
            <a:gdLst/>
            <a:ahLst/>
            <a:cxnLst/>
            <a:rect l="l" t="t" r="r" b="b"/>
            <a:pathLst>
              <a:path w="26670" h="36195">
                <a:moveTo>
                  <a:pt x="7620" y="25527"/>
                </a:moveTo>
                <a:lnTo>
                  <a:pt x="0" y="26289"/>
                </a:lnTo>
                <a:lnTo>
                  <a:pt x="508" y="29337"/>
                </a:lnTo>
                <a:lnTo>
                  <a:pt x="1905" y="31750"/>
                </a:lnTo>
                <a:lnTo>
                  <a:pt x="6477" y="35306"/>
                </a:lnTo>
                <a:lnTo>
                  <a:pt x="9525" y="36195"/>
                </a:lnTo>
                <a:lnTo>
                  <a:pt x="17653" y="36195"/>
                </a:lnTo>
                <a:lnTo>
                  <a:pt x="21209" y="34544"/>
                </a:lnTo>
                <a:lnTo>
                  <a:pt x="24511" y="30607"/>
                </a:lnTo>
                <a:lnTo>
                  <a:pt x="11811" y="30607"/>
                </a:lnTo>
                <a:lnTo>
                  <a:pt x="10541" y="30226"/>
                </a:lnTo>
                <a:lnTo>
                  <a:pt x="9525" y="29337"/>
                </a:lnTo>
                <a:lnTo>
                  <a:pt x="8509" y="28321"/>
                </a:lnTo>
                <a:lnTo>
                  <a:pt x="7874" y="27178"/>
                </a:lnTo>
                <a:lnTo>
                  <a:pt x="7620" y="25527"/>
                </a:lnTo>
                <a:close/>
              </a:path>
              <a:path w="26670" h="36195">
                <a:moveTo>
                  <a:pt x="25527" y="17018"/>
                </a:moveTo>
                <a:lnTo>
                  <a:pt x="14732" y="17018"/>
                </a:lnTo>
                <a:lnTo>
                  <a:pt x="16129" y="17526"/>
                </a:lnTo>
                <a:lnTo>
                  <a:pt x="18288" y="19685"/>
                </a:lnTo>
                <a:lnTo>
                  <a:pt x="18923" y="21336"/>
                </a:lnTo>
                <a:lnTo>
                  <a:pt x="18923" y="25908"/>
                </a:lnTo>
                <a:lnTo>
                  <a:pt x="18288" y="27686"/>
                </a:lnTo>
                <a:lnTo>
                  <a:pt x="17272" y="28956"/>
                </a:lnTo>
                <a:lnTo>
                  <a:pt x="16129" y="30099"/>
                </a:lnTo>
                <a:lnTo>
                  <a:pt x="14732" y="30607"/>
                </a:lnTo>
                <a:lnTo>
                  <a:pt x="24511" y="30607"/>
                </a:lnTo>
                <a:lnTo>
                  <a:pt x="25781" y="29083"/>
                </a:lnTo>
                <a:lnTo>
                  <a:pt x="26670" y="26416"/>
                </a:lnTo>
                <a:lnTo>
                  <a:pt x="26670" y="19939"/>
                </a:lnTo>
                <a:lnTo>
                  <a:pt x="25527" y="17018"/>
                </a:lnTo>
                <a:close/>
              </a:path>
              <a:path w="26670" h="36195">
                <a:moveTo>
                  <a:pt x="24892" y="0"/>
                </a:moveTo>
                <a:lnTo>
                  <a:pt x="4826" y="0"/>
                </a:lnTo>
                <a:lnTo>
                  <a:pt x="1016" y="18796"/>
                </a:lnTo>
                <a:lnTo>
                  <a:pt x="7112" y="19558"/>
                </a:lnTo>
                <a:lnTo>
                  <a:pt x="8890" y="17907"/>
                </a:lnTo>
                <a:lnTo>
                  <a:pt x="10795" y="17018"/>
                </a:lnTo>
                <a:lnTo>
                  <a:pt x="25527" y="17018"/>
                </a:lnTo>
                <a:lnTo>
                  <a:pt x="23114" y="14859"/>
                </a:lnTo>
                <a:lnTo>
                  <a:pt x="20828" y="12573"/>
                </a:lnTo>
                <a:lnTo>
                  <a:pt x="9398" y="12573"/>
                </a:lnTo>
                <a:lnTo>
                  <a:pt x="10668" y="6477"/>
                </a:lnTo>
                <a:lnTo>
                  <a:pt x="24892" y="6477"/>
                </a:lnTo>
                <a:lnTo>
                  <a:pt x="24892" y="0"/>
                </a:lnTo>
                <a:close/>
              </a:path>
              <a:path w="26670" h="36195">
                <a:moveTo>
                  <a:pt x="18034" y="11430"/>
                </a:moveTo>
                <a:lnTo>
                  <a:pt x="12827" y="11430"/>
                </a:lnTo>
                <a:lnTo>
                  <a:pt x="11049" y="11811"/>
                </a:lnTo>
                <a:lnTo>
                  <a:pt x="9398" y="12573"/>
                </a:lnTo>
                <a:lnTo>
                  <a:pt x="20828" y="12573"/>
                </a:lnTo>
                <a:lnTo>
                  <a:pt x="18034" y="1143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9" name="object 79"/>
          <p:cNvSpPr/>
          <p:nvPr/>
        </p:nvSpPr>
        <p:spPr>
          <a:xfrm>
            <a:off x="4100992" y="4370417"/>
            <a:ext cx="65013" cy="33369"/>
          </a:xfrm>
          <a:custGeom>
            <a:avLst/>
            <a:gdLst/>
            <a:ahLst/>
            <a:cxnLst/>
            <a:rect l="l" t="t" r="r" b="b"/>
            <a:pathLst>
              <a:path w="71754" h="36829">
                <a:moveTo>
                  <a:pt x="7493" y="635"/>
                </a:moveTo>
                <a:lnTo>
                  <a:pt x="0" y="635"/>
                </a:lnTo>
                <a:lnTo>
                  <a:pt x="0" y="36703"/>
                </a:lnTo>
                <a:lnTo>
                  <a:pt x="7493" y="36703"/>
                </a:lnTo>
                <a:lnTo>
                  <a:pt x="7493" y="23495"/>
                </a:lnTo>
                <a:lnTo>
                  <a:pt x="26035" y="23495"/>
                </a:lnTo>
                <a:lnTo>
                  <a:pt x="26035" y="21717"/>
                </a:lnTo>
                <a:lnTo>
                  <a:pt x="11049" y="21717"/>
                </a:lnTo>
                <a:lnTo>
                  <a:pt x="9525" y="20955"/>
                </a:lnTo>
                <a:lnTo>
                  <a:pt x="8636" y="19304"/>
                </a:lnTo>
                <a:lnTo>
                  <a:pt x="7874" y="18161"/>
                </a:lnTo>
                <a:lnTo>
                  <a:pt x="7493" y="15748"/>
                </a:lnTo>
                <a:lnTo>
                  <a:pt x="7493" y="635"/>
                </a:lnTo>
                <a:close/>
              </a:path>
              <a:path w="71754" h="36829">
                <a:moveTo>
                  <a:pt x="18923" y="23495"/>
                </a:moveTo>
                <a:lnTo>
                  <a:pt x="7493" y="23495"/>
                </a:lnTo>
                <a:lnTo>
                  <a:pt x="8382" y="24892"/>
                </a:lnTo>
                <a:lnTo>
                  <a:pt x="9144" y="25908"/>
                </a:lnTo>
                <a:lnTo>
                  <a:pt x="9779" y="26289"/>
                </a:lnTo>
                <a:lnTo>
                  <a:pt x="10795" y="27051"/>
                </a:lnTo>
                <a:lnTo>
                  <a:pt x="11938" y="27305"/>
                </a:lnTo>
                <a:lnTo>
                  <a:pt x="13843" y="27305"/>
                </a:lnTo>
                <a:lnTo>
                  <a:pt x="17399" y="25527"/>
                </a:lnTo>
                <a:lnTo>
                  <a:pt x="17907" y="25146"/>
                </a:lnTo>
                <a:lnTo>
                  <a:pt x="18415" y="24384"/>
                </a:lnTo>
                <a:lnTo>
                  <a:pt x="18923" y="23495"/>
                </a:lnTo>
                <a:close/>
              </a:path>
              <a:path w="71754" h="36829">
                <a:moveTo>
                  <a:pt x="26035" y="23495"/>
                </a:moveTo>
                <a:lnTo>
                  <a:pt x="18923" y="23495"/>
                </a:lnTo>
                <a:lnTo>
                  <a:pt x="18923" y="26670"/>
                </a:lnTo>
                <a:lnTo>
                  <a:pt x="26035" y="26670"/>
                </a:lnTo>
                <a:lnTo>
                  <a:pt x="26035" y="23495"/>
                </a:lnTo>
                <a:close/>
              </a:path>
              <a:path w="71754" h="36829">
                <a:moveTo>
                  <a:pt x="26035" y="635"/>
                </a:moveTo>
                <a:lnTo>
                  <a:pt x="18415" y="635"/>
                </a:lnTo>
                <a:lnTo>
                  <a:pt x="18415" y="15367"/>
                </a:lnTo>
                <a:lnTo>
                  <a:pt x="18161" y="17399"/>
                </a:lnTo>
                <a:lnTo>
                  <a:pt x="17780" y="18415"/>
                </a:lnTo>
                <a:lnTo>
                  <a:pt x="17272" y="19431"/>
                </a:lnTo>
                <a:lnTo>
                  <a:pt x="16637" y="20320"/>
                </a:lnTo>
                <a:lnTo>
                  <a:pt x="15748" y="20828"/>
                </a:lnTo>
                <a:lnTo>
                  <a:pt x="14859" y="21463"/>
                </a:lnTo>
                <a:lnTo>
                  <a:pt x="13843" y="21717"/>
                </a:lnTo>
                <a:lnTo>
                  <a:pt x="26035" y="21717"/>
                </a:lnTo>
                <a:lnTo>
                  <a:pt x="26035" y="635"/>
                </a:lnTo>
                <a:close/>
              </a:path>
              <a:path w="71754" h="36829">
                <a:moveTo>
                  <a:pt x="36322" y="635"/>
                </a:moveTo>
                <a:lnTo>
                  <a:pt x="29337" y="635"/>
                </a:lnTo>
                <a:lnTo>
                  <a:pt x="29337" y="26670"/>
                </a:lnTo>
                <a:lnTo>
                  <a:pt x="36957" y="26670"/>
                </a:lnTo>
                <a:lnTo>
                  <a:pt x="36957" y="11557"/>
                </a:lnTo>
                <a:lnTo>
                  <a:pt x="37084" y="9652"/>
                </a:lnTo>
                <a:lnTo>
                  <a:pt x="41529" y="5334"/>
                </a:lnTo>
                <a:lnTo>
                  <a:pt x="71077" y="5334"/>
                </a:lnTo>
                <a:lnTo>
                  <a:pt x="70739" y="4572"/>
                </a:lnTo>
                <a:lnTo>
                  <a:pt x="70548" y="4191"/>
                </a:lnTo>
                <a:lnTo>
                  <a:pt x="36322" y="4191"/>
                </a:lnTo>
                <a:lnTo>
                  <a:pt x="36322" y="635"/>
                </a:lnTo>
                <a:close/>
              </a:path>
              <a:path w="71754" h="36829">
                <a:moveTo>
                  <a:pt x="58801" y="5334"/>
                </a:moveTo>
                <a:lnTo>
                  <a:pt x="43688" y="5334"/>
                </a:lnTo>
                <a:lnTo>
                  <a:pt x="44450" y="5461"/>
                </a:lnTo>
                <a:lnTo>
                  <a:pt x="44958" y="5842"/>
                </a:lnTo>
                <a:lnTo>
                  <a:pt x="46609" y="26670"/>
                </a:lnTo>
                <a:lnTo>
                  <a:pt x="54229" y="26670"/>
                </a:lnTo>
                <a:lnTo>
                  <a:pt x="54229" y="11684"/>
                </a:lnTo>
                <a:lnTo>
                  <a:pt x="54483" y="9906"/>
                </a:lnTo>
                <a:lnTo>
                  <a:pt x="55245" y="7620"/>
                </a:lnTo>
                <a:lnTo>
                  <a:pt x="56007" y="6731"/>
                </a:lnTo>
                <a:lnTo>
                  <a:pt x="56896" y="6223"/>
                </a:lnTo>
                <a:lnTo>
                  <a:pt x="57785" y="5588"/>
                </a:lnTo>
                <a:lnTo>
                  <a:pt x="58801" y="5334"/>
                </a:lnTo>
                <a:close/>
              </a:path>
              <a:path w="71754" h="36829">
                <a:moveTo>
                  <a:pt x="71077" y="5334"/>
                </a:moveTo>
                <a:lnTo>
                  <a:pt x="61341" y="5334"/>
                </a:lnTo>
                <a:lnTo>
                  <a:pt x="62484" y="5715"/>
                </a:lnTo>
                <a:lnTo>
                  <a:pt x="63119" y="6731"/>
                </a:lnTo>
                <a:lnTo>
                  <a:pt x="63627" y="7493"/>
                </a:lnTo>
                <a:lnTo>
                  <a:pt x="63881" y="9144"/>
                </a:lnTo>
                <a:lnTo>
                  <a:pt x="63881" y="26670"/>
                </a:lnTo>
                <a:lnTo>
                  <a:pt x="71501" y="26670"/>
                </a:lnTo>
                <a:lnTo>
                  <a:pt x="71501" y="7493"/>
                </a:lnTo>
                <a:lnTo>
                  <a:pt x="71247" y="5715"/>
                </a:lnTo>
                <a:lnTo>
                  <a:pt x="71077" y="5334"/>
                </a:lnTo>
                <a:close/>
              </a:path>
              <a:path w="71754" h="36829">
                <a:moveTo>
                  <a:pt x="47117" y="0"/>
                </a:moveTo>
                <a:lnTo>
                  <a:pt x="41783" y="0"/>
                </a:lnTo>
                <a:lnTo>
                  <a:pt x="38862" y="1397"/>
                </a:lnTo>
                <a:lnTo>
                  <a:pt x="36322" y="4191"/>
                </a:lnTo>
                <a:lnTo>
                  <a:pt x="53340" y="4191"/>
                </a:lnTo>
                <a:lnTo>
                  <a:pt x="47117" y="0"/>
                </a:lnTo>
                <a:close/>
              </a:path>
              <a:path w="71754" h="36829">
                <a:moveTo>
                  <a:pt x="64262" y="0"/>
                </a:moveTo>
                <a:lnTo>
                  <a:pt x="60452" y="0"/>
                </a:lnTo>
                <a:lnTo>
                  <a:pt x="58928" y="381"/>
                </a:lnTo>
                <a:lnTo>
                  <a:pt x="57404" y="1016"/>
                </a:lnTo>
                <a:lnTo>
                  <a:pt x="56007" y="1778"/>
                </a:lnTo>
                <a:lnTo>
                  <a:pt x="54610" y="2794"/>
                </a:lnTo>
                <a:lnTo>
                  <a:pt x="53340" y="4191"/>
                </a:lnTo>
                <a:lnTo>
                  <a:pt x="70548" y="4191"/>
                </a:lnTo>
                <a:lnTo>
                  <a:pt x="69977" y="3048"/>
                </a:lnTo>
                <a:lnTo>
                  <a:pt x="68961" y="1905"/>
                </a:lnTo>
                <a:lnTo>
                  <a:pt x="67437" y="1143"/>
                </a:lnTo>
                <a:lnTo>
                  <a:pt x="66040" y="381"/>
                </a:lnTo>
                <a:lnTo>
                  <a:pt x="64262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0" name="object 80"/>
          <p:cNvSpPr/>
          <p:nvPr/>
        </p:nvSpPr>
        <p:spPr>
          <a:xfrm>
            <a:off x="4273593" y="4355916"/>
            <a:ext cx="132556" cy="11184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1" name="object 81"/>
          <p:cNvSpPr txBox="1"/>
          <p:nvPr/>
        </p:nvSpPr>
        <p:spPr>
          <a:xfrm>
            <a:off x="4262891" y="4352924"/>
            <a:ext cx="13347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82" name="object 82"/>
          <p:cNvSpPr/>
          <p:nvPr/>
        </p:nvSpPr>
        <p:spPr>
          <a:xfrm>
            <a:off x="5084123" y="4351773"/>
            <a:ext cx="157412" cy="113226"/>
          </a:xfrm>
          <a:prstGeom prst="rect">
            <a:avLst/>
          </a:prstGeom>
          <a:blipFill>
            <a:blip r:embed="rId2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3" name="object 83"/>
          <p:cNvSpPr txBox="1"/>
          <p:nvPr/>
        </p:nvSpPr>
        <p:spPr>
          <a:xfrm>
            <a:off x="5073770" y="4348782"/>
            <a:ext cx="15591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84" name="object 84"/>
          <p:cNvSpPr/>
          <p:nvPr/>
        </p:nvSpPr>
        <p:spPr>
          <a:xfrm>
            <a:off x="5680060" y="4364202"/>
            <a:ext cx="97230" cy="42804"/>
          </a:xfrm>
          <a:prstGeom prst="rect">
            <a:avLst/>
          </a:prstGeom>
          <a:blipFill>
            <a:blip r:embed="rId3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5" name="object 85"/>
          <p:cNvSpPr/>
          <p:nvPr/>
        </p:nvSpPr>
        <p:spPr>
          <a:xfrm>
            <a:off x="5880850" y="4355916"/>
            <a:ext cx="183647" cy="111845"/>
          </a:xfrm>
          <a:prstGeom prst="rect">
            <a:avLst/>
          </a:prstGeom>
          <a:blipFill>
            <a:blip r:embed="rId3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6" name="object 86"/>
          <p:cNvSpPr txBox="1"/>
          <p:nvPr/>
        </p:nvSpPr>
        <p:spPr>
          <a:xfrm>
            <a:off x="5870495" y="4352924"/>
            <a:ext cx="17892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87" name="object 87"/>
          <p:cNvSpPr/>
          <p:nvPr/>
        </p:nvSpPr>
        <p:spPr>
          <a:xfrm>
            <a:off x="2403751" y="1200776"/>
            <a:ext cx="4225264" cy="0"/>
          </a:xfrm>
          <a:custGeom>
            <a:avLst/>
            <a:gdLst/>
            <a:ahLst/>
            <a:cxnLst/>
            <a:rect l="l" t="t" r="r" b="b"/>
            <a:pathLst>
              <a:path w="4663440">
                <a:moveTo>
                  <a:pt x="0" y="0"/>
                </a:moveTo>
                <a:lnTo>
                  <a:pt x="4663440" y="0"/>
                </a:lnTo>
              </a:path>
            </a:pathLst>
          </a:custGeom>
          <a:ln w="1981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8" name="object 88"/>
          <p:cNvSpPr txBox="1"/>
          <p:nvPr/>
        </p:nvSpPr>
        <p:spPr>
          <a:xfrm>
            <a:off x="307113" y="4752302"/>
            <a:ext cx="132472" cy="1090836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dirty="0">
                <a:latin typeface="Calibri"/>
                <a:cs typeface="Calibri"/>
              </a:rPr>
              <a:t>A</a:t>
            </a:r>
            <a:r>
              <a:rPr sz="861" spc="-9" dirty="0">
                <a:latin typeface="Calibri"/>
                <a:cs typeface="Calibri"/>
              </a:rPr>
              <a:t>T</a:t>
            </a:r>
            <a:r>
              <a:rPr sz="861" dirty="0">
                <a:latin typeface="Calibri"/>
                <a:cs typeface="Calibri"/>
              </a:rPr>
              <a:t>G116L</a:t>
            </a:r>
            <a:r>
              <a:rPr sz="861" spc="-5" dirty="0">
                <a:latin typeface="Calibri"/>
                <a:cs typeface="Calibri"/>
              </a:rPr>
              <a:t>1-</a:t>
            </a:r>
            <a:r>
              <a:rPr sz="861" spc="5" dirty="0">
                <a:latin typeface="Calibri"/>
                <a:cs typeface="Calibri"/>
              </a:rPr>
              <a:t>/</a:t>
            </a:r>
            <a:r>
              <a:rPr sz="861" dirty="0">
                <a:latin typeface="Calibri"/>
                <a:cs typeface="Calibri"/>
              </a:rPr>
              <a:t>-</a:t>
            </a:r>
            <a:r>
              <a:rPr sz="861" spc="9" dirty="0">
                <a:latin typeface="Times New Roman"/>
                <a:cs typeface="Times New Roman"/>
              </a:rPr>
              <a:t> </a:t>
            </a:r>
            <a:r>
              <a:rPr sz="861" spc="-18" dirty="0">
                <a:latin typeface="Calibri"/>
                <a:cs typeface="Calibri"/>
              </a:rPr>
              <a:t>T</a:t>
            </a:r>
            <a:r>
              <a:rPr sz="861" spc="-9" dirty="0">
                <a:latin typeface="Calibri"/>
                <a:cs typeface="Calibri"/>
              </a:rPr>
              <a:t>E</a:t>
            </a:r>
            <a:r>
              <a:rPr sz="861" spc="-14" dirty="0">
                <a:latin typeface="Calibri"/>
                <a:cs typeface="Calibri"/>
              </a:rPr>
              <a:t>C</a:t>
            </a:r>
            <a:r>
              <a:rPr sz="861" spc="-9" dirty="0">
                <a:latin typeface="Calibri"/>
                <a:cs typeface="Calibri"/>
              </a:rPr>
              <a:t>P</a:t>
            </a:r>
            <a:r>
              <a:rPr sz="861" dirty="0">
                <a:latin typeface="Calibri"/>
                <a:cs typeface="Calibri"/>
              </a:rPr>
              <a:t>R</a:t>
            </a:r>
            <a:r>
              <a:rPr sz="861" spc="-14" dirty="0">
                <a:latin typeface="Calibri"/>
                <a:cs typeface="Calibri"/>
              </a:rPr>
              <a:t>1</a:t>
            </a:r>
            <a:r>
              <a:rPr sz="861" spc="-18" dirty="0">
                <a:latin typeface="Calibri"/>
                <a:cs typeface="Calibri"/>
              </a:rPr>
              <a:t>*</a:t>
            </a:r>
            <a:r>
              <a:rPr sz="861" dirty="0">
                <a:latin typeface="Calibri"/>
                <a:cs typeface="Calibri"/>
              </a:rPr>
              <a:t>/*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307113" y="3833830"/>
            <a:ext cx="132472" cy="58166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dirty="0">
                <a:latin typeface="Calibri"/>
                <a:cs typeface="Calibri"/>
              </a:rPr>
              <a:t>A</a:t>
            </a:r>
            <a:r>
              <a:rPr sz="861" spc="-9" dirty="0">
                <a:latin typeface="Calibri"/>
                <a:cs typeface="Calibri"/>
              </a:rPr>
              <a:t>T</a:t>
            </a:r>
            <a:r>
              <a:rPr sz="861" dirty="0">
                <a:latin typeface="Calibri"/>
                <a:cs typeface="Calibri"/>
              </a:rPr>
              <a:t>G116L</a:t>
            </a:r>
            <a:r>
              <a:rPr sz="861" spc="-5" dirty="0">
                <a:latin typeface="Calibri"/>
                <a:cs typeface="Calibri"/>
              </a:rPr>
              <a:t>1-</a:t>
            </a:r>
            <a:r>
              <a:rPr sz="861" spc="-18" dirty="0">
                <a:latin typeface="Calibri"/>
                <a:cs typeface="Calibri"/>
              </a:rPr>
              <a:t>/</a:t>
            </a:r>
            <a:r>
              <a:rPr sz="861" dirty="0">
                <a:latin typeface="Calibri"/>
                <a:cs typeface="Calibri"/>
              </a:rPr>
              <a:t>-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308494" y="2707099"/>
            <a:ext cx="132472" cy="678321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spc="-5" dirty="0">
                <a:latin typeface="Calibri"/>
                <a:cs typeface="Calibri"/>
              </a:rPr>
              <a:t>W</a:t>
            </a:r>
            <a:r>
              <a:rPr sz="861" dirty="0">
                <a:latin typeface="Calibri"/>
                <a:cs typeface="Calibri"/>
              </a:rPr>
              <a:t>T</a:t>
            </a:r>
            <a:r>
              <a:rPr sz="861" spc="-5" dirty="0">
                <a:latin typeface="Times New Roman"/>
                <a:cs typeface="Times New Roman"/>
              </a:rPr>
              <a:t> </a:t>
            </a:r>
            <a:r>
              <a:rPr sz="861" spc="-18" dirty="0">
                <a:latin typeface="Calibri"/>
                <a:cs typeface="Calibri"/>
              </a:rPr>
              <a:t>T</a:t>
            </a:r>
            <a:r>
              <a:rPr sz="861" spc="-9" dirty="0">
                <a:latin typeface="Calibri"/>
                <a:cs typeface="Calibri"/>
              </a:rPr>
              <a:t>E</a:t>
            </a:r>
            <a:r>
              <a:rPr sz="861" spc="-14" dirty="0">
                <a:latin typeface="Calibri"/>
                <a:cs typeface="Calibri"/>
              </a:rPr>
              <a:t>C</a:t>
            </a:r>
            <a:r>
              <a:rPr sz="861" spc="-9" dirty="0">
                <a:latin typeface="Calibri"/>
                <a:cs typeface="Calibri"/>
              </a:rPr>
              <a:t>P</a:t>
            </a:r>
            <a:r>
              <a:rPr sz="861" dirty="0">
                <a:latin typeface="Calibri"/>
                <a:cs typeface="Calibri"/>
              </a:rPr>
              <a:t>R</a:t>
            </a:r>
            <a:r>
              <a:rPr sz="861" spc="-14" dirty="0">
                <a:latin typeface="Calibri"/>
                <a:cs typeface="Calibri"/>
              </a:rPr>
              <a:t>1</a:t>
            </a:r>
            <a:r>
              <a:rPr sz="861" spc="-18" dirty="0">
                <a:latin typeface="Calibri"/>
                <a:cs typeface="Calibri"/>
              </a:rPr>
              <a:t>*</a:t>
            </a:r>
            <a:r>
              <a:rPr sz="861" dirty="0">
                <a:latin typeface="Calibri"/>
                <a:cs typeface="Calibri"/>
              </a:rPr>
              <a:t>/*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307113" y="1845081"/>
            <a:ext cx="132472" cy="16742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spc="-28" dirty="0">
                <a:latin typeface="Calibri"/>
                <a:cs typeface="Calibri"/>
              </a:rPr>
              <a:t>WT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92" name="object 92"/>
          <p:cNvSpPr/>
          <p:nvPr/>
        </p:nvSpPr>
        <p:spPr>
          <a:xfrm>
            <a:off x="1526825" y="2639232"/>
            <a:ext cx="773250" cy="774055"/>
          </a:xfrm>
          <a:prstGeom prst="rect">
            <a:avLst/>
          </a:prstGeom>
          <a:blipFill>
            <a:blip r:embed="rId3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3" name="object 93"/>
          <p:cNvSpPr/>
          <p:nvPr/>
        </p:nvSpPr>
        <p:spPr>
          <a:xfrm>
            <a:off x="460844" y="2639232"/>
            <a:ext cx="1034222" cy="774055"/>
          </a:xfrm>
          <a:prstGeom prst="rect">
            <a:avLst/>
          </a:prstGeom>
          <a:blipFill>
            <a:blip r:embed="rId3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4" name="object 94"/>
          <p:cNvSpPr/>
          <p:nvPr/>
        </p:nvSpPr>
        <p:spPr>
          <a:xfrm>
            <a:off x="1406581" y="3375545"/>
            <a:ext cx="36246" cy="0"/>
          </a:xfrm>
          <a:custGeom>
            <a:avLst/>
            <a:gdLst/>
            <a:ahLst/>
            <a:cxnLst/>
            <a:rect l="l" t="t" r="r" b="b"/>
            <a:pathLst>
              <a:path w="40005">
                <a:moveTo>
                  <a:pt x="0" y="0"/>
                </a:moveTo>
                <a:lnTo>
                  <a:pt x="39497" y="0"/>
                </a:lnTo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5" name="object 95"/>
          <p:cNvSpPr/>
          <p:nvPr/>
        </p:nvSpPr>
        <p:spPr>
          <a:xfrm>
            <a:off x="491567" y="2667191"/>
            <a:ext cx="454286" cy="100798"/>
          </a:xfrm>
          <a:prstGeom prst="rect">
            <a:avLst/>
          </a:prstGeom>
          <a:blipFill>
            <a:blip r:embed="rId3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6" name="object 96"/>
          <p:cNvSpPr txBox="1"/>
          <p:nvPr/>
        </p:nvSpPr>
        <p:spPr>
          <a:xfrm>
            <a:off x="480059" y="2662474"/>
            <a:ext cx="450488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770" spc="-18" dirty="0">
                <a:solidFill>
                  <a:srgbClr val="00AF50"/>
                </a:solidFill>
                <a:latin typeface="Calibri"/>
                <a:cs typeface="Calibri"/>
              </a:rPr>
              <a:t>*/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*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97" name="object 97"/>
          <p:cNvSpPr/>
          <p:nvPr/>
        </p:nvSpPr>
        <p:spPr>
          <a:xfrm>
            <a:off x="494328" y="3271985"/>
            <a:ext cx="106321" cy="11184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8" name="object 98"/>
          <p:cNvSpPr txBox="1"/>
          <p:nvPr/>
        </p:nvSpPr>
        <p:spPr>
          <a:xfrm>
            <a:off x="482823" y="3268992"/>
            <a:ext cx="10873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99" name="object 99"/>
          <p:cNvSpPr/>
          <p:nvPr/>
        </p:nvSpPr>
        <p:spPr>
          <a:xfrm>
            <a:off x="1560311" y="3277508"/>
            <a:ext cx="132557" cy="11184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0" name="object 100"/>
          <p:cNvSpPr txBox="1"/>
          <p:nvPr/>
        </p:nvSpPr>
        <p:spPr>
          <a:xfrm>
            <a:off x="1549034" y="3274515"/>
            <a:ext cx="132327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01" name="object 101"/>
          <p:cNvSpPr/>
          <p:nvPr/>
        </p:nvSpPr>
        <p:spPr>
          <a:xfrm>
            <a:off x="1408423" y="3360355"/>
            <a:ext cx="45566" cy="15189"/>
          </a:xfrm>
          <a:prstGeom prst="rect">
            <a:avLst/>
          </a:prstGeom>
          <a:blipFill>
            <a:blip r:embed="rId3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2" name="object 102"/>
          <p:cNvSpPr/>
          <p:nvPr/>
        </p:nvSpPr>
        <p:spPr>
          <a:xfrm>
            <a:off x="1409111" y="3365764"/>
            <a:ext cx="6329" cy="7479"/>
          </a:xfrm>
          <a:custGeom>
            <a:avLst/>
            <a:gdLst/>
            <a:ahLst/>
            <a:cxnLst/>
            <a:rect l="l" t="t" r="r" b="b"/>
            <a:pathLst>
              <a:path w="6984" h="8254">
                <a:moveTo>
                  <a:pt x="762" y="6350"/>
                </a:moveTo>
                <a:lnTo>
                  <a:pt x="0" y="6350"/>
                </a:lnTo>
                <a:lnTo>
                  <a:pt x="0" y="7239"/>
                </a:lnTo>
                <a:lnTo>
                  <a:pt x="127" y="7366"/>
                </a:lnTo>
                <a:lnTo>
                  <a:pt x="127" y="7493"/>
                </a:lnTo>
                <a:lnTo>
                  <a:pt x="381" y="7493"/>
                </a:lnTo>
                <a:lnTo>
                  <a:pt x="508" y="7620"/>
                </a:lnTo>
                <a:lnTo>
                  <a:pt x="762" y="7620"/>
                </a:lnTo>
                <a:lnTo>
                  <a:pt x="1016" y="7747"/>
                </a:lnTo>
                <a:lnTo>
                  <a:pt x="1524" y="7747"/>
                </a:lnTo>
                <a:lnTo>
                  <a:pt x="1778" y="7874"/>
                </a:lnTo>
                <a:lnTo>
                  <a:pt x="3937" y="7874"/>
                </a:lnTo>
                <a:lnTo>
                  <a:pt x="4953" y="7620"/>
                </a:lnTo>
                <a:lnTo>
                  <a:pt x="5334" y="7366"/>
                </a:lnTo>
                <a:lnTo>
                  <a:pt x="5715" y="7239"/>
                </a:lnTo>
                <a:lnTo>
                  <a:pt x="6096" y="6985"/>
                </a:lnTo>
                <a:lnTo>
                  <a:pt x="6350" y="6731"/>
                </a:lnTo>
                <a:lnTo>
                  <a:pt x="6392" y="6604"/>
                </a:lnTo>
                <a:lnTo>
                  <a:pt x="1651" y="6604"/>
                </a:lnTo>
                <a:lnTo>
                  <a:pt x="1397" y="6477"/>
                </a:lnTo>
                <a:lnTo>
                  <a:pt x="1016" y="6477"/>
                </a:lnTo>
                <a:lnTo>
                  <a:pt x="762" y="6350"/>
                </a:lnTo>
                <a:close/>
              </a:path>
              <a:path w="6984" h="8254">
                <a:moveTo>
                  <a:pt x="6096" y="127"/>
                </a:moveTo>
                <a:lnTo>
                  <a:pt x="508" y="127"/>
                </a:lnTo>
                <a:lnTo>
                  <a:pt x="508" y="254"/>
                </a:lnTo>
                <a:lnTo>
                  <a:pt x="381" y="381"/>
                </a:lnTo>
                <a:lnTo>
                  <a:pt x="381" y="3937"/>
                </a:lnTo>
                <a:lnTo>
                  <a:pt x="508" y="4064"/>
                </a:lnTo>
                <a:lnTo>
                  <a:pt x="508" y="4191"/>
                </a:lnTo>
                <a:lnTo>
                  <a:pt x="3429" y="4191"/>
                </a:lnTo>
                <a:lnTo>
                  <a:pt x="3683" y="4318"/>
                </a:lnTo>
                <a:lnTo>
                  <a:pt x="3937" y="4318"/>
                </a:lnTo>
                <a:lnTo>
                  <a:pt x="4064" y="4445"/>
                </a:lnTo>
                <a:lnTo>
                  <a:pt x="4318" y="4572"/>
                </a:lnTo>
                <a:lnTo>
                  <a:pt x="4318" y="4699"/>
                </a:lnTo>
                <a:lnTo>
                  <a:pt x="4572" y="4953"/>
                </a:lnTo>
                <a:lnTo>
                  <a:pt x="4572" y="5715"/>
                </a:lnTo>
                <a:lnTo>
                  <a:pt x="4445" y="5969"/>
                </a:lnTo>
                <a:lnTo>
                  <a:pt x="4064" y="6350"/>
                </a:lnTo>
                <a:lnTo>
                  <a:pt x="3810" y="6477"/>
                </a:lnTo>
                <a:lnTo>
                  <a:pt x="3683" y="6477"/>
                </a:lnTo>
                <a:lnTo>
                  <a:pt x="3429" y="6604"/>
                </a:lnTo>
                <a:lnTo>
                  <a:pt x="6392" y="6604"/>
                </a:lnTo>
                <a:lnTo>
                  <a:pt x="6477" y="6350"/>
                </a:lnTo>
                <a:lnTo>
                  <a:pt x="6731" y="6096"/>
                </a:lnTo>
                <a:lnTo>
                  <a:pt x="6858" y="5715"/>
                </a:lnTo>
                <a:lnTo>
                  <a:pt x="6858" y="4826"/>
                </a:lnTo>
                <a:lnTo>
                  <a:pt x="6604" y="4318"/>
                </a:lnTo>
                <a:lnTo>
                  <a:pt x="6477" y="3937"/>
                </a:lnTo>
                <a:lnTo>
                  <a:pt x="6223" y="3810"/>
                </a:lnTo>
                <a:lnTo>
                  <a:pt x="5969" y="3556"/>
                </a:lnTo>
                <a:lnTo>
                  <a:pt x="4826" y="3175"/>
                </a:lnTo>
                <a:lnTo>
                  <a:pt x="4318" y="3048"/>
                </a:lnTo>
                <a:lnTo>
                  <a:pt x="2159" y="3048"/>
                </a:lnTo>
                <a:lnTo>
                  <a:pt x="2159" y="1397"/>
                </a:lnTo>
                <a:lnTo>
                  <a:pt x="5969" y="1397"/>
                </a:lnTo>
                <a:lnTo>
                  <a:pt x="6223" y="1143"/>
                </a:lnTo>
                <a:lnTo>
                  <a:pt x="6223" y="254"/>
                </a:lnTo>
                <a:lnTo>
                  <a:pt x="6096" y="254"/>
                </a:lnTo>
                <a:lnTo>
                  <a:pt x="6096" y="127"/>
                </a:lnTo>
                <a:close/>
              </a:path>
              <a:path w="6984" h="8254">
                <a:moveTo>
                  <a:pt x="508" y="6223"/>
                </a:moveTo>
                <a:lnTo>
                  <a:pt x="127" y="6223"/>
                </a:lnTo>
                <a:lnTo>
                  <a:pt x="127" y="6350"/>
                </a:lnTo>
                <a:lnTo>
                  <a:pt x="635" y="6350"/>
                </a:lnTo>
                <a:lnTo>
                  <a:pt x="508" y="6223"/>
                </a:lnTo>
                <a:close/>
              </a:path>
              <a:path w="6984" h="8254">
                <a:moveTo>
                  <a:pt x="5969" y="0"/>
                </a:moveTo>
                <a:lnTo>
                  <a:pt x="762" y="0"/>
                </a:lnTo>
                <a:lnTo>
                  <a:pt x="635" y="127"/>
                </a:lnTo>
                <a:lnTo>
                  <a:pt x="5969" y="127"/>
                </a:lnTo>
                <a:lnTo>
                  <a:pt x="5969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3" name="object 103"/>
          <p:cNvSpPr/>
          <p:nvPr/>
        </p:nvSpPr>
        <p:spPr>
          <a:xfrm>
            <a:off x="1420391" y="3367490"/>
            <a:ext cx="16108" cy="7479"/>
          </a:xfrm>
          <a:custGeom>
            <a:avLst/>
            <a:gdLst/>
            <a:ahLst/>
            <a:cxnLst/>
            <a:rect l="l" t="t" r="r" b="b"/>
            <a:pathLst>
              <a:path w="17780" h="8254">
                <a:moveTo>
                  <a:pt x="1778" y="7874"/>
                </a:moveTo>
                <a:lnTo>
                  <a:pt x="254" y="7874"/>
                </a:lnTo>
                <a:lnTo>
                  <a:pt x="254" y="8001"/>
                </a:lnTo>
                <a:lnTo>
                  <a:pt x="1778" y="8001"/>
                </a:lnTo>
                <a:lnTo>
                  <a:pt x="1778" y="7874"/>
                </a:lnTo>
                <a:close/>
              </a:path>
              <a:path w="17780" h="8254">
                <a:moveTo>
                  <a:pt x="2032" y="254"/>
                </a:moveTo>
                <a:lnTo>
                  <a:pt x="0" y="254"/>
                </a:lnTo>
                <a:lnTo>
                  <a:pt x="0" y="7874"/>
                </a:lnTo>
                <a:lnTo>
                  <a:pt x="2032" y="7874"/>
                </a:lnTo>
                <a:lnTo>
                  <a:pt x="2032" y="6350"/>
                </a:lnTo>
                <a:lnTo>
                  <a:pt x="1905" y="6223"/>
                </a:lnTo>
                <a:lnTo>
                  <a:pt x="1905" y="5588"/>
                </a:lnTo>
                <a:lnTo>
                  <a:pt x="4318" y="5588"/>
                </a:lnTo>
                <a:lnTo>
                  <a:pt x="5080" y="5080"/>
                </a:lnTo>
                <a:lnTo>
                  <a:pt x="6096" y="5080"/>
                </a:lnTo>
                <a:lnTo>
                  <a:pt x="6096" y="4699"/>
                </a:lnTo>
                <a:lnTo>
                  <a:pt x="2794" y="4699"/>
                </a:lnTo>
                <a:lnTo>
                  <a:pt x="2540" y="4572"/>
                </a:lnTo>
                <a:lnTo>
                  <a:pt x="2159" y="4191"/>
                </a:lnTo>
                <a:lnTo>
                  <a:pt x="2032" y="3937"/>
                </a:lnTo>
                <a:lnTo>
                  <a:pt x="2032" y="254"/>
                </a:lnTo>
                <a:close/>
              </a:path>
              <a:path w="17780" h="8254">
                <a:moveTo>
                  <a:pt x="4318" y="5588"/>
                </a:moveTo>
                <a:lnTo>
                  <a:pt x="1905" y="5588"/>
                </a:lnTo>
                <a:lnTo>
                  <a:pt x="2159" y="5842"/>
                </a:lnTo>
                <a:lnTo>
                  <a:pt x="2286" y="5842"/>
                </a:lnTo>
                <a:lnTo>
                  <a:pt x="2540" y="5969"/>
                </a:lnTo>
                <a:lnTo>
                  <a:pt x="3302" y="5969"/>
                </a:lnTo>
                <a:lnTo>
                  <a:pt x="3683" y="5842"/>
                </a:lnTo>
                <a:lnTo>
                  <a:pt x="3937" y="5715"/>
                </a:lnTo>
                <a:lnTo>
                  <a:pt x="4318" y="5588"/>
                </a:lnTo>
                <a:close/>
              </a:path>
              <a:path w="17780" h="8254">
                <a:moveTo>
                  <a:pt x="6096" y="5080"/>
                </a:moveTo>
                <a:lnTo>
                  <a:pt x="5080" y="5080"/>
                </a:lnTo>
                <a:lnTo>
                  <a:pt x="5207" y="5461"/>
                </a:lnTo>
                <a:lnTo>
                  <a:pt x="5334" y="5588"/>
                </a:lnTo>
                <a:lnTo>
                  <a:pt x="5715" y="5715"/>
                </a:lnTo>
                <a:lnTo>
                  <a:pt x="5969" y="5842"/>
                </a:lnTo>
                <a:lnTo>
                  <a:pt x="6350" y="5969"/>
                </a:lnTo>
                <a:lnTo>
                  <a:pt x="7620" y="5969"/>
                </a:lnTo>
                <a:lnTo>
                  <a:pt x="7747" y="5842"/>
                </a:lnTo>
                <a:lnTo>
                  <a:pt x="6223" y="5842"/>
                </a:lnTo>
                <a:lnTo>
                  <a:pt x="6223" y="5715"/>
                </a:lnTo>
                <a:lnTo>
                  <a:pt x="6096" y="5715"/>
                </a:lnTo>
                <a:lnTo>
                  <a:pt x="6096" y="5080"/>
                </a:lnTo>
                <a:close/>
              </a:path>
              <a:path w="17780" h="8254">
                <a:moveTo>
                  <a:pt x="8001" y="5715"/>
                </a:moveTo>
                <a:lnTo>
                  <a:pt x="6223" y="5715"/>
                </a:lnTo>
                <a:lnTo>
                  <a:pt x="6223" y="5842"/>
                </a:lnTo>
                <a:lnTo>
                  <a:pt x="8001" y="5842"/>
                </a:lnTo>
                <a:lnTo>
                  <a:pt x="8001" y="5715"/>
                </a:lnTo>
                <a:close/>
              </a:path>
              <a:path w="17780" h="8254">
                <a:moveTo>
                  <a:pt x="12700" y="5715"/>
                </a:moveTo>
                <a:lnTo>
                  <a:pt x="10922" y="5715"/>
                </a:lnTo>
                <a:lnTo>
                  <a:pt x="10922" y="5842"/>
                </a:lnTo>
                <a:lnTo>
                  <a:pt x="12700" y="5842"/>
                </a:lnTo>
                <a:lnTo>
                  <a:pt x="12700" y="5715"/>
                </a:lnTo>
                <a:close/>
              </a:path>
              <a:path w="17780" h="8254">
                <a:moveTo>
                  <a:pt x="17335" y="1270"/>
                </a:moveTo>
                <a:lnTo>
                  <a:pt x="14732" y="1270"/>
                </a:lnTo>
                <a:lnTo>
                  <a:pt x="14859" y="1397"/>
                </a:lnTo>
                <a:lnTo>
                  <a:pt x="14986" y="1397"/>
                </a:lnTo>
                <a:lnTo>
                  <a:pt x="15240" y="1651"/>
                </a:lnTo>
                <a:lnTo>
                  <a:pt x="15240" y="1778"/>
                </a:lnTo>
                <a:lnTo>
                  <a:pt x="15367" y="1905"/>
                </a:lnTo>
                <a:lnTo>
                  <a:pt x="15367" y="2032"/>
                </a:lnTo>
                <a:lnTo>
                  <a:pt x="15494" y="2159"/>
                </a:lnTo>
                <a:lnTo>
                  <a:pt x="15494" y="5715"/>
                </a:lnTo>
                <a:lnTo>
                  <a:pt x="15621" y="5842"/>
                </a:lnTo>
                <a:lnTo>
                  <a:pt x="17399" y="5842"/>
                </a:lnTo>
                <a:lnTo>
                  <a:pt x="17399" y="5715"/>
                </a:lnTo>
                <a:lnTo>
                  <a:pt x="17526" y="5715"/>
                </a:lnTo>
                <a:lnTo>
                  <a:pt x="17526" y="1905"/>
                </a:lnTo>
                <a:lnTo>
                  <a:pt x="17399" y="1651"/>
                </a:lnTo>
                <a:lnTo>
                  <a:pt x="17399" y="1397"/>
                </a:lnTo>
                <a:lnTo>
                  <a:pt x="17335" y="1270"/>
                </a:lnTo>
                <a:close/>
              </a:path>
              <a:path w="17780" h="8254">
                <a:moveTo>
                  <a:pt x="6858" y="254"/>
                </a:moveTo>
                <a:lnTo>
                  <a:pt x="6096" y="254"/>
                </a:lnTo>
                <a:lnTo>
                  <a:pt x="6096" y="5715"/>
                </a:lnTo>
                <a:lnTo>
                  <a:pt x="8128" y="5715"/>
                </a:lnTo>
                <a:lnTo>
                  <a:pt x="8128" y="4699"/>
                </a:lnTo>
                <a:lnTo>
                  <a:pt x="7112" y="4699"/>
                </a:lnTo>
                <a:lnTo>
                  <a:pt x="6985" y="4572"/>
                </a:lnTo>
                <a:lnTo>
                  <a:pt x="6985" y="4445"/>
                </a:lnTo>
                <a:lnTo>
                  <a:pt x="6858" y="4445"/>
                </a:lnTo>
                <a:lnTo>
                  <a:pt x="6858" y="254"/>
                </a:lnTo>
                <a:close/>
              </a:path>
              <a:path w="17780" h="8254">
                <a:moveTo>
                  <a:pt x="14097" y="1270"/>
                </a:moveTo>
                <a:lnTo>
                  <a:pt x="10033" y="1270"/>
                </a:lnTo>
                <a:lnTo>
                  <a:pt x="10160" y="1397"/>
                </a:lnTo>
                <a:lnTo>
                  <a:pt x="10287" y="1397"/>
                </a:lnTo>
                <a:lnTo>
                  <a:pt x="10541" y="1651"/>
                </a:lnTo>
                <a:lnTo>
                  <a:pt x="10541" y="1778"/>
                </a:lnTo>
                <a:lnTo>
                  <a:pt x="10668" y="1905"/>
                </a:lnTo>
                <a:lnTo>
                  <a:pt x="10668" y="2032"/>
                </a:lnTo>
                <a:lnTo>
                  <a:pt x="10795" y="2159"/>
                </a:lnTo>
                <a:lnTo>
                  <a:pt x="10795" y="5715"/>
                </a:lnTo>
                <a:lnTo>
                  <a:pt x="12827" y="5715"/>
                </a:lnTo>
                <a:lnTo>
                  <a:pt x="12827" y="2159"/>
                </a:lnTo>
                <a:lnTo>
                  <a:pt x="13335" y="1651"/>
                </a:lnTo>
                <a:lnTo>
                  <a:pt x="14097" y="1270"/>
                </a:lnTo>
                <a:close/>
              </a:path>
              <a:path w="17780" h="8254">
                <a:moveTo>
                  <a:pt x="6096" y="254"/>
                </a:moveTo>
                <a:lnTo>
                  <a:pt x="4826" y="254"/>
                </a:lnTo>
                <a:lnTo>
                  <a:pt x="4826" y="3810"/>
                </a:lnTo>
                <a:lnTo>
                  <a:pt x="4572" y="4191"/>
                </a:lnTo>
                <a:lnTo>
                  <a:pt x="4064" y="4445"/>
                </a:lnTo>
                <a:lnTo>
                  <a:pt x="3683" y="4572"/>
                </a:lnTo>
                <a:lnTo>
                  <a:pt x="3429" y="4699"/>
                </a:lnTo>
                <a:lnTo>
                  <a:pt x="6096" y="4699"/>
                </a:lnTo>
                <a:lnTo>
                  <a:pt x="6096" y="254"/>
                </a:lnTo>
                <a:close/>
              </a:path>
              <a:path w="17780" h="8254">
                <a:moveTo>
                  <a:pt x="7874" y="254"/>
                </a:moveTo>
                <a:lnTo>
                  <a:pt x="6858" y="254"/>
                </a:lnTo>
                <a:lnTo>
                  <a:pt x="6858" y="4445"/>
                </a:lnTo>
                <a:lnTo>
                  <a:pt x="6985" y="4445"/>
                </a:lnTo>
                <a:lnTo>
                  <a:pt x="6985" y="4572"/>
                </a:lnTo>
                <a:lnTo>
                  <a:pt x="7112" y="4699"/>
                </a:lnTo>
                <a:lnTo>
                  <a:pt x="8128" y="4699"/>
                </a:lnTo>
                <a:lnTo>
                  <a:pt x="8128" y="2159"/>
                </a:lnTo>
                <a:lnTo>
                  <a:pt x="8636" y="1651"/>
                </a:lnTo>
                <a:lnTo>
                  <a:pt x="9398" y="1270"/>
                </a:lnTo>
                <a:lnTo>
                  <a:pt x="17335" y="1270"/>
                </a:lnTo>
                <a:lnTo>
                  <a:pt x="17208" y="1016"/>
                </a:lnTo>
                <a:lnTo>
                  <a:pt x="12446" y="1016"/>
                </a:lnTo>
                <a:lnTo>
                  <a:pt x="12446" y="889"/>
                </a:lnTo>
                <a:lnTo>
                  <a:pt x="7874" y="889"/>
                </a:lnTo>
                <a:lnTo>
                  <a:pt x="7874" y="254"/>
                </a:lnTo>
                <a:close/>
              </a:path>
              <a:path w="17780" h="8254">
                <a:moveTo>
                  <a:pt x="15875" y="0"/>
                </a:moveTo>
                <a:lnTo>
                  <a:pt x="14351" y="0"/>
                </a:lnTo>
                <a:lnTo>
                  <a:pt x="14097" y="127"/>
                </a:lnTo>
                <a:lnTo>
                  <a:pt x="13970" y="127"/>
                </a:lnTo>
                <a:lnTo>
                  <a:pt x="13716" y="254"/>
                </a:lnTo>
                <a:lnTo>
                  <a:pt x="13462" y="254"/>
                </a:lnTo>
                <a:lnTo>
                  <a:pt x="13335" y="381"/>
                </a:lnTo>
                <a:lnTo>
                  <a:pt x="13081" y="508"/>
                </a:lnTo>
                <a:lnTo>
                  <a:pt x="12954" y="635"/>
                </a:lnTo>
                <a:lnTo>
                  <a:pt x="12700" y="762"/>
                </a:lnTo>
                <a:lnTo>
                  <a:pt x="12446" y="1016"/>
                </a:lnTo>
                <a:lnTo>
                  <a:pt x="17208" y="1016"/>
                </a:lnTo>
                <a:lnTo>
                  <a:pt x="17145" y="889"/>
                </a:lnTo>
                <a:lnTo>
                  <a:pt x="16510" y="254"/>
                </a:lnTo>
                <a:lnTo>
                  <a:pt x="16129" y="127"/>
                </a:lnTo>
                <a:lnTo>
                  <a:pt x="15875" y="0"/>
                </a:lnTo>
                <a:close/>
              </a:path>
              <a:path w="17780" h="8254">
                <a:moveTo>
                  <a:pt x="11049" y="0"/>
                </a:moveTo>
                <a:lnTo>
                  <a:pt x="9779" y="0"/>
                </a:lnTo>
                <a:lnTo>
                  <a:pt x="8636" y="381"/>
                </a:lnTo>
                <a:lnTo>
                  <a:pt x="7874" y="889"/>
                </a:lnTo>
                <a:lnTo>
                  <a:pt x="12446" y="889"/>
                </a:lnTo>
                <a:lnTo>
                  <a:pt x="12446" y="762"/>
                </a:lnTo>
                <a:lnTo>
                  <a:pt x="12065" y="381"/>
                </a:lnTo>
                <a:lnTo>
                  <a:pt x="11811" y="381"/>
                </a:lnTo>
                <a:lnTo>
                  <a:pt x="11684" y="254"/>
                </a:lnTo>
                <a:lnTo>
                  <a:pt x="11430" y="127"/>
                </a:lnTo>
                <a:lnTo>
                  <a:pt x="11303" y="127"/>
                </a:lnTo>
                <a:lnTo>
                  <a:pt x="11049" y="0"/>
                </a:lnTo>
                <a:close/>
              </a:path>
              <a:path w="17780" h="8254">
                <a:moveTo>
                  <a:pt x="1905" y="127"/>
                </a:moveTo>
                <a:lnTo>
                  <a:pt x="127" y="127"/>
                </a:lnTo>
                <a:lnTo>
                  <a:pt x="127" y="254"/>
                </a:lnTo>
                <a:lnTo>
                  <a:pt x="1905" y="254"/>
                </a:lnTo>
                <a:lnTo>
                  <a:pt x="1905" y="127"/>
                </a:lnTo>
                <a:close/>
              </a:path>
              <a:path w="17780" h="8254">
                <a:moveTo>
                  <a:pt x="6223" y="127"/>
                </a:moveTo>
                <a:lnTo>
                  <a:pt x="4953" y="127"/>
                </a:lnTo>
                <a:lnTo>
                  <a:pt x="4953" y="254"/>
                </a:lnTo>
                <a:lnTo>
                  <a:pt x="6223" y="254"/>
                </a:lnTo>
                <a:lnTo>
                  <a:pt x="6223" y="127"/>
                </a:lnTo>
                <a:close/>
              </a:path>
              <a:path w="17780" h="8254">
                <a:moveTo>
                  <a:pt x="6731" y="127"/>
                </a:moveTo>
                <a:lnTo>
                  <a:pt x="6223" y="127"/>
                </a:lnTo>
                <a:lnTo>
                  <a:pt x="6223" y="254"/>
                </a:lnTo>
                <a:lnTo>
                  <a:pt x="6731" y="254"/>
                </a:lnTo>
                <a:lnTo>
                  <a:pt x="6731" y="127"/>
                </a:lnTo>
                <a:close/>
              </a:path>
              <a:path w="17780" h="8254">
                <a:moveTo>
                  <a:pt x="7747" y="127"/>
                </a:moveTo>
                <a:lnTo>
                  <a:pt x="6731" y="127"/>
                </a:lnTo>
                <a:lnTo>
                  <a:pt x="6731" y="254"/>
                </a:lnTo>
                <a:lnTo>
                  <a:pt x="7747" y="254"/>
                </a:lnTo>
                <a:lnTo>
                  <a:pt x="7747" y="12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4" name="object 104"/>
          <p:cNvSpPr/>
          <p:nvPr/>
        </p:nvSpPr>
        <p:spPr>
          <a:xfrm>
            <a:off x="5883151" y="2639232"/>
            <a:ext cx="774631" cy="774055"/>
          </a:xfrm>
          <a:prstGeom prst="rect">
            <a:avLst/>
          </a:prstGeom>
          <a:blipFill>
            <a:blip r:embed="rId3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5" name="object 105"/>
          <p:cNvSpPr/>
          <p:nvPr/>
        </p:nvSpPr>
        <p:spPr>
          <a:xfrm>
            <a:off x="4275894" y="2639232"/>
            <a:ext cx="774631" cy="774055"/>
          </a:xfrm>
          <a:prstGeom prst="rect">
            <a:avLst/>
          </a:prstGeom>
          <a:blipFill>
            <a:blip r:embed="rId3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6" name="object 106"/>
          <p:cNvSpPr/>
          <p:nvPr/>
        </p:nvSpPr>
        <p:spPr>
          <a:xfrm>
            <a:off x="5085045" y="2639232"/>
            <a:ext cx="774631" cy="774055"/>
          </a:xfrm>
          <a:prstGeom prst="rect">
            <a:avLst/>
          </a:prstGeom>
          <a:blipFill>
            <a:blip r:embed="rId3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7" name="object 107"/>
          <p:cNvSpPr/>
          <p:nvPr/>
        </p:nvSpPr>
        <p:spPr>
          <a:xfrm>
            <a:off x="2404903" y="2639232"/>
            <a:ext cx="1034222" cy="774055"/>
          </a:xfrm>
          <a:prstGeom prst="rect">
            <a:avLst/>
          </a:prstGeom>
          <a:blipFill>
            <a:blip r:embed="rId3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8" name="object 108"/>
          <p:cNvSpPr/>
          <p:nvPr/>
        </p:nvSpPr>
        <p:spPr>
          <a:xfrm>
            <a:off x="3310481" y="3362887"/>
            <a:ext cx="35671" cy="0"/>
          </a:xfrm>
          <a:custGeom>
            <a:avLst/>
            <a:gdLst/>
            <a:ahLst/>
            <a:cxnLst/>
            <a:rect l="l" t="t" r="r" b="b"/>
            <a:pathLst>
              <a:path w="39370">
                <a:moveTo>
                  <a:pt x="0" y="0"/>
                </a:moveTo>
                <a:lnTo>
                  <a:pt x="39370" y="0"/>
                </a:lnTo>
              </a:path>
            </a:pathLst>
          </a:custGeom>
          <a:ln w="328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9" name="object 109"/>
          <p:cNvSpPr/>
          <p:nvPr/>
        </p:nvSpPr>
        <p:spPr>
          <a:xfrm>
            <a:off x="3466740" y="2639232"/>
            <a:ext cx="774631" cy="774055"/>
          </a:xfrm>
          <a:prstGeom prst="rect">
            <a:avLst/>
          </a:prstGeom>
          <a:blipFill>
            <a:blip r:embed="rId4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0" name="object 110"/>
          <p:cNvSpPr/>
          <p:nvPr/>
        </p:nvSpPr>
        <p:spPr>
          <a:xfrm>
            <a:off x="5500668" y="2970461"/>
            <a:ext cx="246244" cy="245668"/>
          </a:xfrm>
          <a:custGeom>
            <a:avLst/>
            <a:gdLst/>
            <a:ahLst/>
            <a:cxnLst/>
            <a:rect l="l" t="t" r="r" b="b"/>
            <a:pathLst>
              <a:path w="271779" h="271145">
                <a:moveTo>
                  <a:pt x="0" y="271070"/>
                </a:moveTo>
                <a:lnTo>
                  <a:pt x="271274" y="271070"/>
                </a:lnTo>
                <a:lnTo>
                  <a:pt x="271274" y="0"/>
                </a:lnTo>
                <a:lnTo>
                  <a:pt x="0" y="0"/>
                </a:lnTo>
                <a:lnTo>
                  <a:pt x="0" y="271070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1" name="object 111"/>
          <p:cNvSpPr/>
          <p:nvPr/>
        </p:nvSpPr>
        <p:spPr>
          <a:xfrm>
            <a:off x="3865794" y="2959416"/>
            <a:ext cx="246244" cy="245668"/>
          </a:xfrm>
          <a:custGeom>
            <a:avLst/>
            <a:gdLst/>
            <a:ahLst/>
            <a:cxnLst/>
            <a:rect l="l" t="t" r="r" b="b"/>
            <a:pathLst>
              <a:path w="271779" h="271145">
                <a:moveTo>
                  <a:pt x="0" y="271070"/>
                </a:moveTo>
                <a:lnTo>
                  <a:pt x="271269" y="271070"/>
                </a:lnTo>
                <a:lnTo>
                  <a:pt x="271269" y="0"/>
                </a:lnTo>
                <a:lnTo>
                  <a:pt x="0" y="0"/>
                </a:lnTo>
                <a:lnTo>
                  <a:pt x="0" y="271070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2" name="object 112"/>
          <p:cNvSpPr/>
          <p:nvPr/>
        </p:nvSpPr>
        <p:spPr>
          <a:xfrm>
            <a:off x="2435740" y="2664431"/>
            <a:ext cx="454284" cy="99417"/>
          </a:xfrm>
          <a:prstGeom prst="rect">
            <a:avLst/>
          </a:prstGeom>
          <a:blipFill>
            <a:blip r:embed="rId3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3" name="object 113"/>
          <p:cNvSpPr txBox="1"/>
          <p:nvPr/>
        </p:nvSpPr>
        <p:spPr>
          <a:xfrm>
            <a:off x="2424809" y="2659712"/>
            <a:ext cx="450488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770" spc="-18" dirty="0">
                <a:solidFill>
                  <a:srgbClr val="00AF50"/>
                </a:solidFill>
                <a:latin typeface="Calibri"/>
                <a:cs typeface="Calibri"/>
              </a:rPr>
              <a:t>*/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*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114" name="object 114"/>
          <p:cNvSpPr/>
          <p:nvPr/>
        </p:nvSpPr>
        <p:spPr>
          <a:xfrm>
            <a:off x="2435741" y="3271985"/>
            <a:ext cx="158793" cy="113226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5" name="object 115"/>
          <p:cNvSpPr txBox="1"/>
          <p:nvPr/>
        </p:nvSpPr>
        <p:spPr>
          <a:xfrm>
            <a:off x="2424809" y="3268992"/>
            <a:ext cx="15821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16" name="object 116"/>
          <p:cNvSpPr/>
          <p:nvPr/>
        </p:nvSpPr>
        <p:spPr>
          <a:xfrm>
            <a:off x="3304269" y="3274745"/>
            <a:ext cx="342440" cy="111845"/>
          </a:xfrm>
          <a:prstGeom prst="rect">
            <a:avLst/>
          </a:prstGeom>
          <a:blipFill>
            <a:blip r:embed="rId4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7" name="object 117"/>
          <p:cNvSpPr/>
          <p:nvPr/>
        </p:nvSpPr>
        <p:spPr>
          <a:xfrm>
            <a:off x="3305188" y="3351841"/>
            <a:ext cx="9781" cy="13232"/>
          </a:xfrm>
          <a:custGeom>
            <a:avLst/>
            <a:gdLst/>
            <a:ahLst/>
            <a:cxnLst/>
            <a:rect l="l" t="t" r="r" b="b"/>
            <a:pathLst>
              <a:path w="10795" h="14604">
                <a:moveTo>
                  <a:pt x="2921" y="10033"/>
                </a:moveTo>
                <a:lnTo>
                  <a:pt x="0" y="10287"/>
                </a:lnTo>
                <a:lnTo>
                  <a:pt x="127" y="11557"/>
                </a:lnTo>
                <a:lnTo>
                  <a:pt x="635" y="12446"/>
                </a:lnTo>
                <a:lnTo>
                  <a:pt x="1524" y="13208"/>
                </a:lnTo>
                <a:lnTo>
                  <a:pt x="2540" y="13843"/>
                </a:lnTo>
                <a:lnTo>
                  <a:pt x="3683" y="14224"/>
                </a:lnTo>
                <a:lnTo>
                  <a:pt x="6858" y="14224"/>
                </a:lnTo>
                <a:lnTo>
                  <a:pt x="8255" y="13589"/>
                </a:lnTo>
                <a:lnTo>
                  <a:pt x="9271" y="12319"/>
                </a:lnTo>
                <a:lnTo>
                  <a:pt x="9488" y="12065"/>
                </a:lnTo>
                <a:lnTo>
                  <a:pt x="4572" y="12065"/>
                </a:lnTo>
                <a:lnTo>
                  <a:pt x="4064" y="11811"/>
                </a:lnTo>
                <a:lnTo>
                  <a:pt x="3683" y="11557"/>
                </a:lnTo>
                <a:lnTo>
                  <a:pt x="3302" y="11176"/>
                </a:lnTo>
                <a:lnTo>
                  <a:pt x="3048" y="10668"/>
                </a:lnTo>
                <a:lnTo>
                  <a:pt x="2921" y="10033"/>
                </a:lnTo>
                <a:close/>
              </a:path>
              <a:path w="10795" h="14604">
                <a:moveTo>
                  <a:pt x="9887" y="6604"/>
                </a:moveTo>
                <a:lnTo>
                  <a:pt x="5715" y="6604"/>
                </a:lnTo>
                <a:lnTo>
                  <a:pt x="6350" y="6858"/>
                </a:lnTo>
                <a:lnTo>
                  <a:pt x="6731" y="7239"/>
                </a:lnTo>
                <a:lnTo>
                  <a:pt x="7112" y="7747"/>
                </a:lnTo>
                <a:lnTo>
                  <a:pt x="7366" y="8382"/>
                </a:lnTo>
                <a:lnTo>
                  <a:pt x="7366" y="10160"/>
                </a:lnTo>
                <a:lnTo>
                  <a:pt x="7112" y="10922"/>
                </a:lnTo>
                <a:lnTo>
                  <a:pt x="6731" y="11303"/>
                </a:lnTo>
                <a:lnTo>
                  <a:pt x="6350" y="11811"/>
                </a:lnTo>
                <a:lnTo>
                  <a:pt x="5715" y="12065"/>
                </a:lnTo>
                <a:lnTo>
                  <a:pt x="9488" y="12065"/>
                </a:lnTo>
                <a:lnTo>
                  <a:pt x="10033" y="11430"/>
                </a:lnTo>
                <a:lnTo>
                  <a:pt x="10414" y="10414"/>
                </a:lnTo>
                <a:lnTo>
                  <a:pt x="10414" y="7874"/>
                </a:lnTo>
                <a:lnTo>
                  <a:pt x="10033" y="6731"/>
                </a:lnTo>
                <a:lnTo>
                  <a:pt x="9887" y="6604"/>
                </a:lnTo>
                <a:close/>
              </a:path>
              <a:path w="10795" h="14604">
                <a:moveTo>
                  <a:pt x="9779" y="0"/>
                </a:moveTo>
                <a:lnTo>
                  <a:pt x="1905" y="0"/>
                </a:lnTo>
                <a:lnTo>
                  <a:pt x="254" y="7366"/>
                </a:lnTo>
                <a:lnTo>
                  <a:pt x="2794" y="7620"/>
                </a:lnTo>
                <a:lnTo>
                  <a:pt x="3429" y="6985"/>
                </a:lnTo>
                <a:lnTo>
                  <a:pt x="4191" y="6604"/>
                </a:lnTo>
                <a:lnTo>
                  <a:pt x="9887" y="6604"/>
                </a:lnTo>
                <a:lnTo>
                  <a:pt x="9017" y="5842"/>
                </a:lnTo>
                <a:lnTo>
                  <a:pt x="8128" y="4953"/>
                </a:lnTo>
                <a:lnTo>
                  <a:pt x="3683" y="4953"/>
                </a:lnTo>
                <a:lnTo>
                  <a:pt x="4064" y="2540"/>
                </a:lnTo>
                <a:lnTo>
                  <a:pt x="9779" y="2540"/>
                </a:lnTo>
                <a:lnTo>
                  <a:pt x="9779" y="0"/>
                </a:lnTo>
                <a:close/>
              </a:path>
              <a:path w="10795" h="14604">
                <a:moveTo>
                  <a:pt x="6985" y="4445"/>
                </a:moveTo>
                <a:lnTo>
                  <a:pt x="4953" y="4445"/>
                </a:lnTo>
                <a:lnTo>
                  <a:pt x="4318" y="4572"/>
                </a:lnTo>
                <a:lnTo>
                  <a:pt x="3683" y="4953"/>
                </a:lnTo>
                <a:lnTo>
                  <a:pt x="8128" y="4953"/>
                </a:lnTo>
                <a:lnTo>
                  <a:pt x="6985" y="4445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8" name="object 118"/>
          <p:cNvSpPr/>
          <p:nvPr/>
        </p:nvSpPr>
        <p:spPr>
          <a:xfrm>
            <a:off x="3320493" y="3354948"/>
            <a:ext cx="22438" cy="13232"/>
          </a:xfrm>
          <a:custGeom>
            <a:avLst/>
            <a:gdLst/>
            <a:ahLst/>
            <a:cxnLst/>
            <a:rect l="l" t="t" r="r" b="b"/>
            <a:pathLst>
              <a:path w="24764" h="14604">
                <a:moveTo>
                  <a:pt x="3048" y="254"/>
                </a:moveTo>
                <a:lnTo>
                  <a:pt x="0" y="254"/>
                </a:lnTo>
                <a:lnTo>
                  <a:pt x="0" y="14478"/>
                </a:lnTo>
                <a:lnTo>
                  <a:pt x="3048" y="14478"/>
                </a:lnTo>
                <a:lnTo>
                  <a:pt x="3048" y="9271"/>
                </a:lnTo>
                <a:lnTo>
                  <a:pt x="7874" y="9271"/>
                </a:lnTo>
                <a:lnTo>
                  <a:pt x="7874" y="8636"/>
                </a:lnTo>
                <a:lnTo>
                  <a:pt x="4445" y="8636"/>
                </a:lnTo>
                <a:lnTo>
                  <a:pt x="3810" y="8255"/>
                </a:lnTo>
                <a:lnTo>
                  <a:pt x="3429" y="7620"/>
                </a:lnTo>
                <a:lnTo>
                  <a:pt x="3175" y="7112"/>
                </a:lnTo>
                <a:lnTo>
                  <a:pt x="3048" y="6223"/>
                </a:lnTo>
                <a:lnTo>
                  <a:pt x="3048" y="254"/>
                </a:lnTo>
                <a:close/>
              </a:path>
              <a:path w="24764" h="14604">
                <a:moveTo>
                  <a:pt x="7493" y="9271"/>
                </a:moveTo>
                <a:lnTo>
                  <a:pt x="3048" y="9271"/>
                </a:lnTo>
                <a:lnTo>
                  <a:pt x="3302" y="9906"/>
                </a:lnTo>
                <a:lnTo>
                  <a:pt x="3683" y="10287"/>
                </a:lnTo>
                <a:lnTo>
                  <a:pt x="3937" y="10414"/>
                </a:lnTo>
                <a:lnTo>
                  <a:pt x="4318" y="10668"/>
                </a:lnTo>
                <a:lnTo>
                  <a:pt x="4699" y="10795"/>
                </a:lnTo>
                <a:lnTo>
                  <a:pt x="5588" y="10795"/>
                </a:lnTo>
                <a:lnTo>
                  <a:pt x="6096" y="10541"/>
                </a:lnTo>
                <a:lnTo>
                  <a:pt x="6477" y="10414"/>
                </a:lnTo>
                <a:lnTo>
                  <a:pt x="6985" y="10160"/>
                </a:lnTo>
                <a:lnTo>
                  <a:pt x="7112" y="9906"/>
                </a:lnTo>
                <a:lnTo>
                  <a:pt x="7366" y="9652"/>
                </a:lnTo>
                <a:lnTo>
                  <a:pt x="7493" y="9271"/>
                </a:lnTo>
                <a:close/>
              </a:path>
              <a:path w="24764" h="14604">
                <a:moveTo>
                  <a:pt x="7874" y="9271"/>
                </a:moveTo>
                <a:lnTo>
                  <a:pt x="7493" y="9271"/>
                </a:lnTo>
                <a:lnTo>
                  <a:pt x="7493" y="10541"/>
                </a:lnTo>
                <a:lnTo>
                  <a:pt x="7874" y="10541"/>
                </a:lnTo>
                <a:lnTo>
                  <a:pt x="7874" y="9271"/>
                </a:lnTo>
                <a:close/>
              </a:path>
              <a:path w="24764" h="14604">
                <a:moveTo>
                  <a:pt x="10287" y="254"/>
                </a:moveTo>
                <a:lnTo>
                  <a:pt x="7874" y="254"/>
                </a:lnTo>
                <a:lnTo>
                  <a:pt x="7874" y="10541"/>
                </a:lnTo>
                <a:lnTo>
                  <a:pt x="10287" y="10541"/>
                </a:lnTo>
                <a:lnTo>
                  <a:pt x="10287" y="254"/>
                </a:lnTo>
                <a:close/>
              </a:path>
              <a:path w="24764" h="14604">
                <a:moveTo>
                  <a:pt x="10541" y="254"/>
                </a:moveTo>
                <a:lnTo>
                  <a:pt x="10287" y="254"/>
                </a:lnTo>
                <a:lnTo>
                  <a:pt x="10287" y="10541"/>
                </a:lnTo>
                <a:lnTo>
                  <a:pt x="10795" y="10541"/>
                </a:lnTo>
                <a:lnTo>
                  <a:pt x="10795" y="4572"/>
                </a:lnTo>
                <a:lnTo>
                  <a:pt x="10922" y="3810"/>
                </a:lnTo>
                <a:lnTo>
                  <a:pt x="11176" y="3048"/>
                </a:lnTo>
                <a:lnTo>
                  <a:pt x="11430" y="2667"/>
                </a:lnTo>
                <a:lnTo>
                  <a:pt x="11811" y="2413"/>
                </a:lnTo>
                <a:lnTo>
                  <a:pt x="12573" y="2159"/>
                </a:lnTo>
                <a:lnTo>
                  <a:pt x="24299" y="2159"/>
                </a:lnTo>
                <a:lnTo>
                  <a:pt x="24130" y="1905"/>
                </a:lnTo>
                <a:lnTo>
                  <a:pt x="24028" y="1651"/>
                </a:lnTo>
                <a:lnTo>
                  <a:pt x="10541" y="1651"/>
                </a:lnTo>
                <a:lnTo>
                  <a:pt x="10541" y="254"/>
                </a:lnTo>
                <a:close/>
              </a:path>
              <a:path w="24764" h="14604">
                <a:moveTo>
                  <a:pt x="19431" y="2159"/>
                </a:moveTo>
                <a:lnTo>
                  <a:pt x="13716" y="2159"/>
                </a:lnTo>
                <a:lnTo>
                  <a:pt x="14224" y="2413"/>
                </a:lnTo>
                <a:lnTo>
                  <a:pt x="14478" y="2921"/>
                </a:lnTo>
                <a:lnTo>
                  <a:pt x="14605" y="3302"/>
                </a:lnTo>
                <a:lnTo>
                  <a:pt x="14605" y="10541"/>
                </a:lnTo>
                <a:lnTo>
                  <a:pt x="17653" y="10541"/>
                </a:lnTo>
                <a:lnTo>
                  <a:pt x="17653" y="4699"/>
                </a:lnTo>
                <a:lnTo>
                  <a:pt x="17780" y="3937"/>
                </a:lnTo>
                <a:lnTo>
                  <a:pt x="17907" y="3429"/>
                </a:lnTo>
                <a:lnTo>
                  <a:pt x="18034" y="3048"/>
                </a:lnTo>
                <a:lnTo>
                  <a:pt x="18288" y="2667"/>
                </a:lnTo>
                <a:lnTo>
                  <a:pt x="18669" y="2413"/>
                </a:lnTo>
                <a:lnTo>
                  <a:pt x="19431" y="2159"/>
                </a:lnTo>
                <a:close/>
              </a:path>
              <a:path w="24764" h="14604">
                <a:moveTo>
                  <a:pt x="24299" y="2159"/>
                </a:moveTo>
                <a:lnTo>
                  <a:pt x="20447" y="2159"/>
                </a:lnTo>
                <a:lnTo>
                  <a:pt x="20828" y="2286"/>
                </a:lnTo>
                <a:lnTo>
                  <a:pt x="21336" y="3048"/>
                </a:lnTo>
                <a:lnTo>
                  <a:pt x="21463" y="3683"/>
                </a:lnTo>
                <a:lnTo>
                  <a:pt x="21463" y="10541"/>
                </a:lnTo>
                <a:lnTo>
                  <a:pt x="24384" y="10541"/>
                </a:lnTo>
                <a:lnTo>
                  <a:pt x="24384" y="2286"/>
                </a:lnTo>
                <a:lnTo>
                  <a:pt x="24299" y="2159"/>
                </a:lnTo>
                <a:close/>
              </a:path>
              <a:path w="24764" h="14604">
                <a:moveTo>
                  <a:pt x="7874" y="254"/>
                </a:moveTo>
                <a:lnTo>
                  <a:pt x="7239" y="254"/>
                </a:lnTo>
                <a:lnTo>
                  <a:pt x="7239" y="6858"/>
                </a:lnTo>
                <a:lnTo>
                  <a:pt x="6985" y="7239"/>
                </a:lnTo>
                <a:lnTo>
                  <a:pt x="6858" y="7747"/>
                </a:lnTo>
                <a:lnTo>
                  <a:pt x="6604" y="8001"/>
                </a:lnTo>
                <a:lnTo>
                  <a:pt x="5842" y="8509"/>
                </a:lnTo>
                <a:lnTo>
                  <a:pt x="5461" y="8636"/>
                </a:lnTo>
                <a:lnTo>
                  <a:pt x="7874" y="8636"/>
                </a:lnTo>
                <a:lnTo>
                  <a:pt x="7874" y="254"/>
                </a:lnTo>
                <a:close/>
              </a:path>
              <a:path w="24764" h="14604">
                <a:moveTo>
                  <a:pt x="14859" y="0"/>
                </a:moveTo>
                <a:lnTo>
                  <a:pt x="12700" y="0"/>
                </a:lnTo>
                <a:lnTo>
                  <a:pt x="11557" y="635"/>
                </a:lnTo>
                <a:lnTo>
                  <a:pt x="10541" y="1651"/>
                </a:lnTo>
                <a:lnTo>
                  <a:pt x="17272" y="1651"/>
                </a:lnTo>
                <a:lnTo>
                  <a:pt x="14859" y="0"/>
                </a:lnTo>
                <a:close/>
              </a:path>
              <a:path w="24764" h="14604">
                <a:moveTo>
                  <a:pt x="21590" y="0"/>
                </a:moveTo>
                <a:lnTo>
                  <a:pt x="20066" y="0"/>
                </a:lnTo>
                <a:lnTo>
                  <a:pt x="19431" y="127"/>
                </a:lnTo>
                <a:lnTo>
                  <a:pt x="18923" y="381"/>
                </a:lnTo>
                <a:lnTo>
                  <a:pt x="18288" y="762"/>
                </a:lnTo>
                <a:lnTo>
                  <a:pt x="17780" y="1143"/>
                </a:lnTo>
                <a:lnTo>
                  <a:pt x="17272" y="1651"/>
                </a:lnTo>
                <a:lnTo>
                  <a:pt x="24028" y="1651"/>
                </a:lnTo>
                <a:lnTo>
                  <a:pt x="23876" y="1270"/>
                </a:lnTo>
                <a:lnTo>
                  <a:pt x="23368" y="762"/>
                </a:lnTo>
                <a:lnTo>
                  <a:pt x="22860" y="508"/>
                </a:lnTo>
                <a:lnTo>
                  <a:pt x="22225" y="127"/>
                </a:lnTo>
                <a:lnTo>
                  <a:pt x="2159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9" name="object 119"/>
          <p:cNvSpPr/>
          <p:nvPr/>
        </p:nvSpPr>
        <p:spPr>
          <a:xfrm>
            <a:off x="3497120" y="3288899"/>
            <a:ext cx="131178" cy="94354"/>
          </a:xfrm>
          <a:custGeom>
            <a:avLst/>
            <a:gdLst/>
            <a:ahLst/>
            <a:cxnLst/>
            <a:rect l="l" t="t" r="r" b="b"/>
            <a:pathLst>
              <a:path w="144779" h="104139">
                <a:moveTo>
                  <a:pt x="21209" y="103632"/>
                </a:moveTo>
                <a:lnTo>
                  <a:pt x="17272" y="103632"/>
                </a:lnTo>
                <a:lnTo>
                  <a:pt x="17780" y="103759"/>
                </a:lnTo>
                <a:lnTo>
                  <a:pt x="20320" y="103759"/>
                </a:lnTo>
                <a:lnTo>
                  <a:pt x="21209" y="103632"/>
                </a:lnTo>
                <a:close/>
              </a:path>
              <a:path w="144779" h="104139">
                <a:moveTo>
                  <a:pt x="20193" y="0"/>
                </a:moveTo>
                <a:lnTo>
                  <a:pt x="17399" y="0"/>
                </a:lnTo>
                <a:lnTo>
                  <a:pt x="16891" y="127"/>
                </a:lnTo>
                <a:lnTo>
                  <a:pt x="16256" y="127"/>
                </a:lnTo>
                <a:lnTo>
                  <a:pt x="1016" y="38735"/>
                </a:lnTo>
                <a:lnTo>
                  <a:pt x="254" y="43053"/>
                </a:lnTo>
                <a:lnTo>
                  <a:pt x="0" y="47498"/>
                </a:lnTo>
                <a:lnTo>
                  <a:pt x="0" y="56261"/>
                </a:lnTo>
                <a:lnTo>
                  <a:pt x="8001" y="90297"/>
                </a:lnTo>
                <a:lnTo>
                  <a:pt x="9779" y="94488"/>
                </a:lnTo>
                <a:lnTo>
                  <a:pt x="11811" y="98425"/>
                </a:lnTo>
                <a:lnTo>
                  <a:pt x="14224" y="102489"/>
                </a:lnTo>
                <a:lnTo>
                  <a:pt x="14351" y="102743"/>
                </a:lnTo>
                <a:lnTo>
                  <a:pt x="14478" y="102870"/>
                </a:lnTo>
                <a:lnTo>
                  <a:pt x="14986" y="103124"/>
                </a:lnTo>
                <a:lnTo>
                  <a:pt x="16129" y="103505"/>
                </a:lnTo>
                <a:lnTo>
                  <a:pt x="16637" y="103632"/>
                </a:lnTo>
                <a:lnTo>
                  <a:pt x="21844" y="103632"/>
                </a:lnTo>
                <a:lnTo>
                  <a:pt x="22860" y="103378"/>
                </a:lnTo>
                <a:lnTo>
                  <a:pt x="23241" y="103124"/>
                </a:lnTo>
                <a:lnTo>
                  <a:pt x="23495" y="102870"/>
                </a:lnTo>
                <a:lnTo>
                  <a:pt x="23622" y="102616"/>
                </a:lnTo>
                <a:lnTo>
                  <a:pt x="23622" y="101981"/>
                </a:lnTo>
                <a:lnTo>
                  <a:pt x="23495" y="101600"/>
                </a:lnTo>
                <a:lnTo>
                  <a:pt x="22935" y="100466"/>
                </a:lnTo>
                <a:lnTo>
                  <a:pt x="17962" y="88661"/>
                </a:lnTo>
                <a:lnTo>
                  <a:pt x="14319" y="76586"/>
                </a:lnTo>
                <a:lnTo>
                  <a:pt x="11946" y="64145"/>
                </a:lnTo>
                <a:lnTo>
                  <a:pt x="11176" y="51380"/>
                </a:lnTo>
                <a:lnTo>
                  <a:pt x="11972" y="38913"/>
                </a:lnTo>
                <a:lnTo>
                  <a:pt x="14348" y="26170"/>
                </a:lnTo>
                <a:lnTo>
                  <a:pt x="18126" y="14153"/>
                </a:lnTo>
                <a:lnTo>
                  <a:pt x="23368" y="2413"/>
                </a:lnTo>
                <a:lnTo>
                  <a:pt x="23495" y="2032"/>
                </a:lnTo>
                <a:lnTo>
                  <a:pt x="23622" y="1778"/>
                </a:lnTo>
                <a:lnTo>
                  <a:pt x="23622" y="1397"/>
                </a:lnTo>
                <a:lnTo>
                  <a:pt x="23368" y="889"/>
                </a:lnTo>
                <a:lnTo>
                  <a:pt x="22987" y="635"/>
                </a:lnTo>
                <a:lnTo>
                  <a:pt x="22606" y="508"/>
                </a:lnTo>
                <a:lnTo>
                  <a:pt x="22225" y="254"/>
                </a:lnTo>
                <a:lnTo>
                  <a:pt x="21590" y="254"/>
                </a:lnTo>
                <a:lnTo>
                  <a:pt x="20955" y="127"/>
                </a:lnTo>
                <a:lnTo>
                  <a:pt x="20193" y="0"/>
                </a:lnTo>
                <a:close/>
              </a:path>
              <a:path w="144779" h="104139">
                <a:moveTo>
                  <a:pt x="45085" y="83693"/>
                </a:moveTo>
                <a:lnTo>
                  <a:pt x="41275" y="83693"/>
                </a:lnTo>
                <a:lnTo>
                  <a:pt x="42164" y="83820"/>
                </a:lnTo>
                <a:lnTo>
                  <a:pt x="44196" y="83820"/>
                </a:lnTo>
                <a:lnTo>
                  <a:pt x="45085" y="83693"/>
                </a:lnTo>
                <a:close/>
              </a:path>
              <a:path w="144779" h="104139">
                <a:moveTo>
                  <a:pt x="45847" y="27305"/>
                </a:moveTo>
                <a:lnTo>
                  <a:pt x="40513" y="27305"/>
                </a:lnTo>
                <a:lnTo>
                  <a:pt x="39878" y="27432"/>
                </a:lnTo>
                <a:lnTo>
                  <a:pt x="38862" y="27686"/>
                </a:lnTo>
                <a:lnTo>
                  <a:pt x="38481" y="27813"/>
                </a:lnTo>
                <a:lnTo>
                  <a:pt x="38227" y="28067"/>
                </a:lnTo>
                <a:lnTo>
                  <a:pt x="38100" y="28321"/>
                </a:lnTo>
                <a:lnTo>
                  <a:pt x="37846" y="28575"/>
                </a:lnTo>
                <a:lnTo>
                  <a:pt x="37846" y="82550"/>
                </a:lnTo>
                <a:lnTo>
                  <a:pt x="38481" y="83185"/>
                </a:lnTo>
                <a:lnTo>
                  <a:pt x="38862" y="83312"/>
                </a:lnTo>
                <a:lnTo>
                  <a:pt x="39878" y="83566"/>
                </a:lnTo>
                <a:lnTo>
                  <a:pt x="40513" y="83693"/>
                </a:lnTo>
                <a:lnTo>
                  <a:pt x="45847" y="83693"/>
                </a:lnTo>
                <a:lnTo>
                  <a:pt x="48514" y="82296"/>
                </a:lnTo>
                <a:lnTo>
                  <a:pt x="48514" y="28829"/>
                </a:lnTo>
                <a:lnTo>
                  <a:pt x="48133" y="28067"/>
                </a:lnTo>
                <a:lnTo>
                  <a:pt x="47752" y="27813"/>
                </a:lnTo>
                <a:lnTo>
                  <a:pt x="46990" y="27559"/>
                </a:lnTo>
                <a:lnTo>
                  <a:pt x="46482" y="27432"/>
                </a:lnTo>
                <a:lnTo>
                  <a:pt x="45847" y="27305"/>
                </a:lnTo>
                <a:close/>
              </a:path>
              <a:path w="144779" h="104139">
                <a:moveTo>
                  <a:pt x="44196" y="27178"/>
                </a:moveTo>
                <a:lnTo>
                  <a:pt x="42164" y="27178"/>
                </a:lnTo>
                <a:lnTo>
                  <a:pt x="41275" y="27305"/>
                </a:lnTo>
                <a:lnTo>
                  <a:pt x="45085" y="27305"/>
                </a:lnTo>
                <a:lnTo>
                  <a:pt x="44196" y="27178"/>
                </a:lnTo>
                <a:close/>
              </a:path>
              <a:path w="144779" h="104139">
                <a:moveTo>
                  <a:pt x="45720" y="5461"/>
                </a:moveTo>
                <a:lnTo>
                  <a:pt x="40640" y="5461"/>
                </a:lnTo>
                <a:lnTo>
                  <a:pt x="38862" y="5842"/>
                </a:lnTo>
                <a:lnTo>
                  <a:pt x="37973" y="6604"/>
                </a:lnTo>
                <a:lnTo>
                  <a:pt x="36957" y="7493"/>
                </a:lnTo>
                <a:lnTo>
                  <a:pt x="36576" y="9017"/>
                </a:lnTo>
                <a:lnTo>
                  <a:pt x="36576" y="13589"/>
                </a:lnTo>
                <a:lnTo>
                  <a:pt x="36957" y="15113"/>
                </a:lnTo>
                <a:lnTo>
                  <a:pt x="37973" y="15875"/>
                </a:lnTo>
                <a:lnTo>
                  <a:pt x="38862" y="16637"/>
                </a:lnTo>
                <a:lnTo>
                  <a:pt x="40513" y="17018"/>
                </a:lnTo>
                <a:lnTo>
                  <a:pt x="45593" y="17018"/>
                </a:lnTo>
                <a:lnTo>
                  <a:pt x="47371" y="16637"/>
                </a:lnTo>
                <a:lnTo>
                  <a:pt x="48260" y="15875"/>
                </a:lnTo>
                <a:lnTo>
                  <a:pt x="49276" y="14986"/>
                </a:lnTo>
                <a:lnTo>
                  <a:pt x="49784" y="13462"/>
                </a:lnTo>
                <a:lnTo>
                  <a:pt x="49784" y="9017"/>
                </a:lnTo>
                <a:lnTo>
                  <a:pt x="49276" y="7493"/>
                </a:lnTo>
                <a:lnTo>
                  <a:pt x="48387" y="6604"/>
                </a:lnTo>
                <a:lnTo>
                  <a:pt x="47371" y="5842"/>
                </a:lnTo>
                <a:lnTo>
                  <a:pt x="45720" y="5461"/>
                </a:lnTo>
                <a:close/>
              </a:path>
              <a:path w="144779" h="104139">
                <a:moveTo>
                  <a:pt x="88519" y="83693"/>
                </a:moveTo>
                <a:lnTo>
                  <a:pt x="82931" y="83693"/>
                </a:lnTo>
                <a:lnTo>
                  <a:pt x="84074" y="83820"/>
                </a:lnTo>
                <a:lnTo>
                  <a:pt x="87630" y="83820"/>
                </a:lnTo>
                <a:lnTo>
                  <a:pt x="88519" y="83693"/>
                </a:lnTo>
                <a:close/>
              </a:path>
              <a:path w="144779" h="104139">
                <a:moveTo>
                  <a:pt x="65786" y="27305"/>
                </a:moveTo>
                <a:lnTo>
                  <a:pt x="59690" y="27305"/>
                </a:lnTo>
                <a:lnTo>
                  <a:pt x="59055" y="27432"/>
                </a:lnTo>
                <a:lnTo>
                  <a:pt x="58293" y="27686"/>
                </a:lnTo>
                <a:lnTo>
                  <a:pt x="58039" y="27940"/>
                </a:lnTo>
                <a:lnTo>
                  <a:pt x="57785" y="28067"/>
                </a:lnTo>
                <a:lnTo>
                  <a:pt x="57531" y="28575"/>
                </a:lnTo>
                <a:lnTo>
                  <a:pt x="57531" y="29210"/>
                </a:lnTo>
                <a:lnTo>
                  <a:pt x="57658" y="29337"/>
                </a:lnTo>
                <a:lnTo>
                  <a:pt x="57658" y="29845"/>
                </a:lnTo>
                <a:lnTo>
                  <a:pt x="57785" y="30226"/>
                </a:lnTo>
                <a:lnTo>
                  <a:pt x="57912" y="30480"/>
                </a:lnTo>
                <a:lnTo>
                  <a:pt x="58039" y="30988"/>
                </a:lnTo>
                <a:lnTo>
                  <a:pt x="58166" y="31369"/>
                </a:lnTo>
                <a:lnTo>
                  <a:pt x="77978" y="81661"/>
                </a:lnTo>
                <a:lnTo>
                  <a:pt x="78232" y="82042"/>
                </a:lnTo>
                <a:lnTo>
                  <a:pt x="78359" y="82423"/>
                </a:lnTo>
                <a:lnTo>
                  <a:pt x="78740" y="82677"/>
                </a:lnTo>
                <a:lnTo>
                  <a:pt x="78994" y="82931"/>
                </a:lnTo>
                <a:lnTo>
                  <a:pt x="79375" y="83185"/>
                </a:lnTo>
                <a:lnTo>
                  <a:pt x="80010" y="83312"/>
                </a:lnTo>
                <a:lnTo>
                  <a:pt x="80518" y="83439"/>
                </a:lnTo>
                <a:lnTo>
                  <a:pt x="82042" y="83693"/>
                </a:lnTo>
                <a:lnTo>
                  <a:pt x="89408" y="83693"/>
                </a:lnTo>
                <a:lnTo>
                  <a:pt x="90170" y="83566"/>
                </a:lnTo>
                <a:lnTo>
                  <a:pt x="90678" y="83439"/>
                </a:lnTo>
                <a:lnTo>
                  <a:pt x="91186" y="83185"/>
                </a:lnTo>
                <a:lnTo>
                  <a:pt x="91694" y="83058"/>
                </a:lnTo>
                <a:lnTo>
                  <a:pt x="91948" y="82677"/>
                </a:lnTo>
                <a:lnTo>
                  <a:pt x="92456" y="82169"/>
                </a:lnTo>
                <a:lnTo>
                  <a:pt x="92583" y="81661"/>
                </a:lnTo>
                <a:lnTo>
                  <a:pt x="95855" y="73406"/>
                </a:lnTo>
                <a:lnTo>
                  <a:pt x="85725" y="73406"/>
                </a:lnTo>
                <a:lnTo>
                  <a:pt x="85471" y="72771"/>
                </a:lnTo>
                <a:lnTo>
                  <a:pt x="68961" y="29083"/>
                </a:lnTo>
                <a:lnTo>
                  <a:pt x="68834" y="28829"/>
                </a:lnTo>
                <a:lnTo>
                  <a:pt x="68707" y="28448"/>
                </a:lnTo>
                <a:lnTo>
                  <a:pt x="68453" y="28194"/>
                </a:lnTo>
                <a:lnTo>
                  <a:pt x="68326" y="27940"/>
                </a:lnTo>
                <a:lnTo>
                  <a:pt x="67564" y="27686"/>
                </a:lnTo>
                <a:lnTo>
                  <a:pt x="67183" y="27432"/>
                </a:lnTo>
                <a:lnTo>
                  <a:pt x="66548" y="27432"/>
                </a:lnTo>
                <a:lnTo>
                  <a:pt x="65786" y="27305"/>
                </a:lnTo>
                <a:close/>
              </a:path>
              <a:path w="144779" h="104139">
                <a:moveTo>
                  <a:pt x="111125" y="27305"/>
                </a:moveTo>
                <a:lnTo>
                  <a:pt x="105156" y="27305"/>
                </a:lnTo>
                <a:lnTo>
                  <a:pt x="104521" y="27432"/>
                </a:lnTo>
                <a:lnTo>
                  <a:pt x="103886" y="27432"/>
                </a:lnTo>
                <a:lnTo>
                  <a:pt x="103505" y="27686"/>
                </a:lnTo>
                <a:lnTo>
                  <a:pt x="102743" y="27940"/>
                </a:lnTo>
                <a:lnTo>
                  <a:pt x="102616" y="28194"/>
                </a:lnTo>
                <a:lnTo>
                  <a:pt x="102362" y="28448"/>
                </a:lnTo>
                <a:lnTo>
                  <a:pt x="102235" y="28829"/>
                </a:lnTo>
                <a:lnTo>
                  <a:pt x="102108" y="29083"/>
                </a:lnTo>
                <a:lnTo>
                  <a:pt x="85852" y="72771"/>
                </a:lnTo>
                <a:lnTo>
                  <a:pt x="85725" y="73406"/>
                </a:lnTo>
                <a:lnTo>
                  <a:pt x="95855" y="73406"/>
                </a:lnTo>
                <a:lnTo>
                  <a:pt x="112522" y="31369"/>
                </a:lnTo>
                <a:lnTo>
                  <a:pt x="112522" y="31115"/>
                </a:lnTo>
                <a:lnTo>
                  <a:pt x="112649" y="30861"/>
                </a:lnTo>
                <a:lnTo>
                  <a:pt x="112649" y="30607"/>
                </a:lnTo>
                <a:lnTo>
                  <a:pt x="112776" y="30353"/>
                </a:lnTo>
                <a:lnTo>
                  <a:pt x="112776" y="30226"/>
                </a:lnTo>
                <a:lnTo>
                  <a:pt x="112903" y="29972"/>
                </a:lnTo>
                <a:lnTo>
                  <a:pt x="112903" y="29464"/>
                </a:lnTo>
                <a:lnTo>
                  <a:pt x="113030" y="29210"/>
                </a:lnTo>
                <a:lnTo>
                  <a:pt x="113030" y="28575"/>
                </a:lnTo>
                <a:lnTo>
                  <a:pt x="112903" y="28321"/>
                </a:lnTo>
                <a:lnTo>
                  <a:pt x="112776" y="28194"/>
                </a:lnTo>
                <a:lnTo>
                  <a:pt x="112649" y="27940"/>
                </a:lnTo>
                <a:lnTo>
                  <a:pt x="112395" y="27686"/>
                </a:lnTo>
                <a:lnTo>
                  <a:pt x="111633" y="27432"/>
                </a:lnTo>
                <a:lnTo>
                  <a:pt x="111125" y="27305"/>
                </a:lnTo>
                <a:close/>
              </a:path>
              <a:path w="144779" h="104139">
                <a:moveTo>
                  <a:pt x="64008" y="27178"/>
                </a:moveTo>
                <a:lnTo>
                  <a:pt x="61849" y="27178"/>
                </a:lnTo>
                <a:lnTo>
                  <a:pt x="60960" y="27305"/>
                </a:lnTo>
                <a:lnTo>
                  <a:pt x="65024" y="27305"/>
                </a:lnTo>
                <a:lnTo>
                  <a:pt x="64008" y="27178"/>
                </a:lnTo>
                <a:close/>
              </a:path>
              <a:path w="144779" h="104139">
                <a:moveTo>
                  <a:pt x="108966" y="27178"/>
                </a:moveTo>
                <a:lnTo>
                  <a:pt x="106807" y="27178"/>
                </a:lnTo>
                <a:lnTo>
                  <a:pt x="105918" y="27305"/>
                </a:lnTo>
                <a:lnTo>
                  <a:pt x="109855" y="27305"/>
                </a:lnTo>
                <a:lnTo>
                  <a:pt x="108966" y="27178"/>
                </a:lnTo>
                <a:close/>
              </a:path>
              <a:path w="144779" h="104139">
                <a:moveTo>
                  <a:pt x="127635" y="103632"/>
                </a:moveTo>
                <a:lnTo>
                  <a:pt x="123571" y="103632"/>
                </a:lnTo>
                <a:lnTo>
                  <a:pt x="124460" y="103759"/>
                </a:lnTo>
                <a:lnTo>
                  <a:pt x="127000" y="103759"/>
                </a:lnTo>
                <a:lnTo>
                  <a:pt x="127635" y="103632"/>
                </a:lnTo>
                <a:close/>
              </a:path>
              <a:path w="144779" h="104139">
                <a:moveTo>
                  <a:pt x="127254" y="0"/>
                </a:moveTo>
                <a:lnTo>
                  <a:pt x="124587" y="0"/>
                </a:lnTo>
                <a:lnTo>
                  <a:pt x="123825" y="127"/>
                </a:lnTo>
                <a:lnTo>
                  <a:pt x="123190" y="254"/>
                </a:lnTo>
                <a:lnTo>
                  <a:pt x="122682" y="254"/>
                </a:lnTo>
                <a:lnTo>
                  <a:pt x="122174" y="508"/>
                </a:lnTo>
                <a:lnTo>
                  <a:pt x="121793" y="635"/>
                </a:lnTo>
                <a:lnTo>
                  <a:pt x="121412" y="889"/>
                </a:lnTo>
                <a:lnTo>
                  <a:pt x="121285" y="1143"/>
                </a:lnTo>
                <a:lnTo>
                  <a:pt x="121285" y="1397"/>
                </a:lnTo>
                <a:lnTo>
                  <a:pt x="121158" y="1778"/>
                </a:lnTo>
                <a:lnTo>
                  <a:pt x="132852" y="39272"/>
                </a:lnTo>
                <a:lnTo>
                  <a:pt x="133603" y="52073"/>
                </a:lnTo>
                <a:lnTo>
                  <a:pt x="132799" y="64513"/>
                </a:lnTo>
                <a:lnTo>
                  <a:pt x="130414" y="77285"/>
                </a:lnTo>
                <a:lnTo>
                  <a:pt x="126657" y="89370"/>
                </a:lnTo>
                <a:lnTo>
                  <a:pt x="121539" y="101092"/>
                </a:lnTo>
                <a:lnTo>
                  <a:pt x="121285" y="101600"/>
                </a:lnTo>
                <a:lnTo>
                  <a:pt x="121285" y="101981"/>
                </a:lnTo>
                <a:lnTo>
                  <a:pt x="121158" y="102235"/>
                </a:lnTo>
                <a:lnTo>
                  <a:pt x="121158" y="102616"/>
                </a:lnTo>
                <a:lnTo>
                  <a:pt x="122936" y="103632"/>
                </a:lnTo>
                <a:lnTo>
                  <a:pt x="128143" y="103632"/>
                </a:lnTo>
                <a:lnTo>
                  <a:pt x="130556" y="102489"/>
                </a:lnTo>
                <a:lnTo>
                  <a:pt x="132969" y="98425"/>
                </a:lnTo>
                <a:lnTo>
                  <a:pt x="141097" y="77851"/>
                </a:lnTo>
                <a:lnTo>
                  <a:pt x="142367" y="73660"/>
                </a:lnTo>
                <a:lnTo>
                  <a:pt x="143256" y="69342"/>
                </a:lnTo>
                <a:lnTo>
                  <a:pt x="144526" y="60706"/>
                </a:lnTo>
                <a:lnTo>
                  <a:pt x="144780" y="56261"/>
                </a:lnTo>
                <a:lnTo>
                  <a:pt x="144780" y="51816"/>
                </a:lnTo>
                <a:lnTo>
                  <a:pt x="136192" y="12660"/>
                </a:lnTo>
                <a:lnTo>
                  <a:pt x="129667" y="508"/>
                </a:lnTo>
                <a:lnTo>
                  <a:pt x="129413" y="381"/>
                </a:lnTo>
                <a:lnTo>
                  <a:pt x="129032" y="254"/>
                </a:lnTo>
                <a:lnTo>
                  <a:pt x="128524" y="127"/>
                </a:lnTo>
                <a:lnTo>
                  <a:pt x="127889" y="127"/>
                </a:lnTo>
                <a:lnTo>
                  <a:pt x="127254" y="0"/>
                </a:lnTo>
                <a:close/>
              </a:path>
            </a:pathLst>
          </a:custGeom>
          <a:solidFill>
            <a:srgbClr val="E6E6E6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0" name="object 120"/>
          <p:cNvSpPr/>
          <p:nvPr/>
        </p:nvSpPr>
        <p:spPr>
          <a:xfrm>
            <a:off x="4077519" y="3281650"/>
            <a:ext cx="124272" cy="53852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1" name="object 121"/>
          <p:cNvSpPr/>
          <p:nvPr/>
        </p:nvSpPr>
        <p:spPr>
          <a:xfrm>
            <a:off x="4079589" y="3293619"/>
            <a:ext cx="23588" cy="32793"/>
          </a:xfrm>
          <a:custGeom>
            <a:avLst/>
            <a:gdLst/>
            <a:ahLst/>
            <a:cxnLst/>
            <a:rect l="l" t="t" r="r" b="b"/>
            <a:pathLst>
              <a:path w="26035" h="36195">
                <a:moveTo>
                  <a:pt x="7239" y="25527"/>
                </a:moveTo>
                <a:lnTo>
                  <a:pt x="0" y="26289"/>
                </a:lnTo>
                <a:lnTo>
                  <a:pt x="508" y="29337"/>
                </a:lnTo>
                <a:lnTo>
                  <a:pt x="1778" y="31750"/>
                </a:lnTo>
                <a:lnTo>
                  <a:pt x="4064" y="33528"/>
                </a:lnTo>
                <a:lnTo>
                  <a:pt x="6223" y="35306"/>
                </a:lnTo>
                <a:lnTo>
                  <a:pt x="9017" y="36195"/>
                </a:lnTo>
                <a:lnTo>
                  <a:pt x="16891" y="36195"/>
                </a:lnTo>
                <a:lnTo>
                  <a:pt x="20320" y="34544"/>
                </a:lnTo>
                <a:lnTo>
                  <a:pt x="22733" y="31369"/>
                </a:lnTo>
                <a:lnTo>
                  <a:pt x="23368" y="30607"/>
                </a:lnTo>
                <a:lnTo>
                  <a:pt x="11303" y="30607"/>
                </a:lnTo>
                <a:lnTo>
                  <a:pt x="10160" y="30226"/>
                </a:lnTo>
                <a:lnTo>
                  <a:pt x="9144" y="29337"/>
                </a:lnTo>
                <a:lnTo>
                  <a:pt x="8128" y="28321"/>
                </a:lnTo>
                <a:lnTo>
                  <a:pt x="7493" y="27178"/>
                </a:lnTo>
                <a:lnTo>
                  <a:pt x="7239" y="25527"/>
                </a:lnTo>
                <a:close/>
              </a:path>
              <a:path w="26035" h="36195">
                <a:moveTo>
                  <a:pt x="24384" y="17018"/>
                </a:moveTo>
                <a:lnTo>
                  <a:pt x="14097" y="17018"/>
                </a:lnTo>
                <a:lnTo>
                  <a:pt x="15494" y="17526"/>
                </a:lnTo>
                <a:lnTo>
                  <a:pt x="16510" y="18669"/>
                </a:lnTo>
                <a:lnTo>
                  <a:pt x="17526" y="19685"/>
                </a:lnTo>
                <a:lnTo>
                  <a:pt x="18034" y="21336"/>
                </a:lnTo>
                <a:lnTo>
                  <a:pt x="18034" y="25908"/>
                </a:lnTo>
                <a:lnTo>
                  <a:pt x="17526" y="27686"/>
                </a:lnTo>
                <a:lnTo>
                  <a:pt x="16510" y="28956"/>
                </a:lnTo>
                <a:lnTo>
                  <a:pt x="15367" y="30099"/>
                </a:lnTo>
                <a:lnTo>
                  <a:pt x="14097" y="30607"/>
                </a:lnTo>
                <a:lnTo>
                  <a:pt x="23368" y="30607"/>
                </a:lnTo>
                <a:lnTo>
                  <a:pt x="24638" y="29083"/>
                </a:lnTo>
                <a:lnTo>
                  <a:pt x="25527" y="26416"/>
                </a:lnTo>
                <a:lnTo>
                  <a:pt x="25527" y="19939"/>
                </a:lnTo>
                <a:lnTo>
                  <a:pt x="24384" y="17018"/>
                </a:lnTo>
                <a:close/>
              </a:path>
              <a:path w="26035" h="36195">
                <a:moveTo>
                  <a:pt x="23749" y="0"/>
                </a:moveTo>
                <a:lnTo>
                  <a:pt x="4699" y="0"/>
                </a:lnTo>
                <a:lnTo>
                  <a:pt x="889" y="18796"/>
                </a:lnTo>
                <a:lnTo>
                  <a:pt x="6858" y="19558"/>
                </a:lnTo>
                <a:lnTo>
                  <a:pt x="8509" y="17907"/>
                </a:lnTo>
                <a:lnTo>
                  <a:pt x="10287" y="17018"/>
                </a:lnTo>
                <a:lnTo>
                  <a:pt x="24384" y="17018"/>
                </a:lnTo>
                <a:lnTo>
                  <a:pt x="22098" y="14859"/>
                </a:lnTo>
                <a:lnTo>
                  <a:pt x="19939" y="12573"/>
                </a:lnTo>
                <a:lnTo>
                  <a:pt x="9017" y="12573"/>
                </a:lnTo>
                <a:lnTo>
                  <a:pt x="10160" y="6477"/>
                </a:lnTo>
                <a:lnTo>
                  <a:pt x="23749" y="6477"/>
                </a:lnTo>
                <a:lnTo>
                  <a:pt x="23749" y="0"/>
                </a:lnTo>
                <a:close/>
              </a:path>
              <a:path w="26035" h="36195">
                <a:moveTo>
                  <a:pt x="17145" y="11430"/>
                </a:moveTo>
                <a:lnTo>
                  <a:pt x="12319" y="11430"/>
                </a:lnTo>
                <a:lnTo>
                  <a:pt x="10668" y="11811"/>
                </a:lnTo>
                <a:lnTo>
                  <a:pt x="9017" y="12573"/>
                </a:lnTo>
                <a:lnTo>
                  <a:pt x="19939" y="12573"/>
                </a:lnTo>
                <a:lnTo>
                  <a:pt x="17145" y="1143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2" name="object 122"/>
          <p:cNvSpPr/>
          <p:nvPr/>
        </p:nvSpPr>
        <p:spPr>
          <a:xfrm>
            <a:off x="4118828" y="3301672"/>
            <a:ext cx="63287" cy="33369"/>
          </a:xfrm>
          <a:custGeom>
            <a:avLst/>
            <a:gdLst/>
            <a:ahLst/>
            <a:cxnLst/>
            <a:rect l="l" t="t" r="r" b="b"/>
            <a:pathLst>
              <a:path w="69850" h="36829">
                <a:moveTo>
                  <a:pt x="7112" y="635"/>
                </a:moveTo>
                <a:lnTo>
                  <a:pt x="0" y="635"/>
                </a:lnTo>
                <a:lnTo>
                  <a:pt x="0" y="36703"/>
                </a:lnTo>
                <a:lnTo>
                  <a:pt x="7112" y="36703"/>
                </a:lnTo>
                <a:lnTo>
                  <a:pt x="7112" y="23495"/>
                </a:lnTo>
                <a:lnTo>
                  <a:pt x="24892" y="23495"/>
                </a:lnTo>
                <a:lnTo>
                  <a:pt x="24892" y="21717"/>
                </a:lnTo>
                <a:lnTo>
                  <a:pt x="10541" y="21717"/>
                </a:lnTo>
                <a:lnTo>
                  <a:pt x="9144" y="20955"/>
                </a:lnTo>
                <a:lnTo>
                  <a:pt x="8255" y="19304"/>
                </a:lnTo>
                <a:lnTo>
                  <a:pt x="7493" y="18161"/>
                </a:lnTo>
                <a:lnTo>
                  <a:pt x="7112" y="15748"/>
                </a:lnTo>
                <a:lnTo>
                  <a:pt x="7112" y="635"/>
                </a:lnTo>
                <a:close/>
              </a:path>
              <a:path w="69850" h="36829">
                <a:moveTo>
                  <a:pt x="18034" y="23495"/>
                </a:moveTo>
                <a:lnTo>
                  <a:pt x="7112" y="23495"/>
                </a:lnTo>
                <a:lnTo>
                  <a:pt x="8001" y="24892"/>
                </a:lnTo>
                <a:lnTo>
                  <a:pt x="8636" y="25908"/>
                </a:lnTo>
                <a:lnTo>
                  <a:pt x="9398" y="26289"/>
                </a:lnTo>
                <a:lnTo>
                  <a:pt x="10287" y="27051"/>
                </a:lnTo>
                <a:lnTo>
                  <a:pt x="11430" y="27305"/>
                </a:lnTo>
                <a:lnTo>
                  <a:pt x="13208" y="27305"/>
                </a:lnTo>
                <a:lnTo>
                  <a:pt x="13970" y="27178"/>
                </a:lnTo>
                <a:lnTo>
                  <a:pt x="15494" y="26416"/>
                </a:lnTo>
                <a:lnTo>
                  <a:pt x="16129" y="26035"/>
                </a:lnTo>
                <a:lnTo>
                  <a:pt x="16637" y="25527"/>
                </a:lnTo>
                <a:lnTo>
                  <a:pt x="17145" y="25146"/>
                </a:lnTo>
                <a:lnTo>
                  <a:pt x="17526" y="24384"/>
                </a:lnTo>
                <a:lnTo>
                  <a:pt x="18034" y="23495"/>
                </a:lnTo>
                <a:close/>
              </a:path>
              <a:path w="69850" h="36829">
                <a:moveTo>
                  <a:pt x="24892" y="23495"/>
                </a:moveTo>
                <a:lnTo>
                  <a:pt x="18034" y="23495"/>
                </a:lnTo>
                <a:lnTo>
                  <a:pt x="18034" y="26670"/>
                </a:lnTo>
                <a:lnTo>
                  <a:pt x="24892" y="26670"/>
                </a:lnTo>
                <a:lnTo>
                  <a:pt x="24892" y="23495"/>
                </a:lnTo>
                <a:close/>
              </a:path>
              <a:path w="69850" h="36829">
                <a:moveTo>
                  <a:pt x="24892" y="635"/>
                </a:moveTo>
                <a:lnTo>
                  <a:pt x="17526" y="635"/>
                </a:lnTo>
                <a:lnTo>
                  <a:pt x="17526" y="15367"/>
                </a:lnTo>
                <a:lnTo>
                  <a:pt x="17272" y="17399"/>
                </a:lnTo>
                <a:lnTo>
                  <a:pt x="16510" y="19431"/>
                </a:lnTo>
                <a:lnTo>
                  <a:pt x="15875" y="20320"/>
                </a:lnTo>
                <a:lnTo>
                  <a:pt x="14986" y="20828"/>
                </a:lnTo>
                <a:lnTo>
                  <a:pt x="14097" y="21463"/>
                </a:lnTo>
                <a:lnTo>
                  <a:pt x="13208" y="21717"/>
                </a:lnTo>
                <a:lnTo>
                  <a:pt x="24892" y="21717"/>
                </a:lnTo>
                <a:lnTo>
                  <a:pt x="24892" y="635"/>
                </a:lnTo>
                <a:close/>
              </a:path>
              <a:path w="69850" h="36829">
                <a:moveTo>
                  <a:pt x="35941" y="635"/>
                </a:moveTo>
                <a:lnTo>
                  <a:pt x="29337" y="635"/>
                </a:lnTo>
                <a:lnTo>
                  <a:pt x="29337" y="26670"/>
                </a:lnTo>
                <a:lnTo>
                  <a:pt x="36576" y="26670"/>
                </a:lnTo>
                <a:lnTo>
                  <a:pt x="36576" y="11557"/>
                </a:lnTo>
                <a:lnTo>
                  <a:pt x="36703" y="9652"/>
                </a:lnTo>
                <a:lnTo>
                  <a:pt x="37084" y="8636"/>
                </a:lnTo>
                <a:lnTo>
                  <a:pt x="37465" y="7493"/>
                </a:lnTo>
                <a:lnTo>
                  <a:pt x="38100" y="6731"/>
                </a:lnTo>
                <a:lnTo>
                  <a:pt x="38989" y="6096"/>
                </a:lnTo>
                <a:lnTo>
                  <a:pt x="39878" y="5588"/>
                </a:lnTo>
                <a:lnTo>
                  <a:pt x="40894" y="5334"/>
                </a:lnTo>
                <a:lnTo>
                  <a:pt x="69172" y="5334"/>
                </a:lnTo>
                <a:lnTo>
                  <a:pt x="68834" y="4572"/>
                </a:lnTo>
                <a:lnTo>
                  <a:pt x="68643" y="4191"/>
                </a:lnTo>
                <a:lnTo>
                  <a:pt x="35941" y="4191"/>
                </a:lnTo>
                <a:lnTo>
                  <a:pt x="35941" y="635"/>
                </a:lnTo>
                <a:close/>
              </a:path>
              <a:path w="69850" h="36829">
                <a:moveTo>
                  <a:pt x="57404" y="5334"/>
                </a:moveTo>
                <a:lnTo>
                  <a:pt x="42926" y="5334"/>
                </a:lnTo>
                <a:lnTo>
                  <a:pt x="43688" y="5461"/>
                </a:lnTo>
                <a:lnTo>
                  <a:pt x="44196" y="5842"/>
                </a:lnTo>
                <a:lnTo>
                  <a:pt x="45847" y="26670"/>
                </a:lnTo>
                <a:lnTo>
                  <a:pt x="53086" y="26670"/>
                </a:lnTo>
                <a:lnTo>
                  <a:pt x="53086" y="11684"/>
                </a:lnTo>
                <a:lnTo>
                  <a:pt x="53340" y="9906"/>
                </a:lnTo>
                <a:lnTo>
                  <a:pt x="54102" y="7620"/>
                </a:lnTo>
                <a:lnTo>
                  <a:pt x="54737" y="6731"/>
                </a:lnTo>
                <a:lnTo>
                  <a:pt x="55626" y="6223"/>
                </a:lnTo>
                <a:lnTo>
                  <a:pt x="56515" y="5588"/>
                </a:lnTo>
                <a:lnTo>
                  <a:pt x="57404" y="5334"/>
                </a:lnTo>
                <a:close/>
              </a:path>
              <a:path w="69850" h="36829">
                <a:moveTo>
                  <a:pt x="69172" y="5334"/>
                </a:moveTo>
                <a:lnTo>
                  <a:pt x="59817" y="5334"/>
                </a:lnTo>
                <a:lnTo>
                  <a:pt x="60833" y="5715"/>
                </a:lnTo>
                <a:lnTo>
                  <a:pt x="61595" y="6731"/>
                </a:lnTo>
                <a:lnTo>
                  <a:pt x="62103" y="7493"/>
                </a:lnTo>
                <a:lnTo>
                  <a:pt x="62357" y="9144"/>
                </a:lnTo>
                <a:lnTo>
                  <a:pt x="62357" y="26670"/>
                </a:lnTo>
                <a:lnTo>
                  <a:pt x="69596" y="26670"/>
                </a:lnTo>
                <a:lnTo>
                  <a:pt x="69596" y="7493"/>
                </a:lnTo>
                <a:lnTo>
                  <a:pt x="69342" y="5715"/>
                </a:lnTo>
                <a:lnTo>
                  <a:pt x="69172" y="5334"/>
                </a:lnTo>
                <a:close/>
              </a:path>
              <a:path w="69850" h="36829">
                <a:moveTo>
                  <a:pt x="46228" y="0"/>
                </a:moveTo>
                <a:lnTo>
                  <a:pt x="41148" y="0"/>
                </a:lnTo>
                <a:lnTo>
                  <a:pt x="38354" y="1397"/>
                </a:lnTo>
                <a:lnTo>
                  <a:pt x="35941" y="4191"/>
                </a:lnTo>
                <a:lnTo>
                  <a:pt x="52197" y="4191"/>
                </a:lnTo>
                <a:lnTo>
                  <a:pt x="46228" y="0"/>
                </a:lnTo>
                <a:close/>
              </a:path>
              <a:path w="69850" h="36829">
                <a:moveTo>
                  <a:pt x="62611" y="0"/>
                </a:moveTo>
                <a:lnTo>
                  <a:pt x="59055" y="0"/>
                </a:lnTo>
                <a:lnTo>
                  <a:pt x="57531" y="381"/>
                </a:lnTo>
                <a:lnTo>
                  <a:pt x="56134" y="1016"/>
                </a:lnTo>
                <a:lnTo>
                  <a:pt x="54737" y="1778"/>
                </a:lnTo>
                <a:lnTo>
                  <a:pt x="53467" y="2794"/>
                </a:lnTo>
                <a:lnTo>
                  <a:pt x="52197" y="4191"/>
                </a:lnTo>
                <a:lnTo>
                  <a:pt x="68643" y="4191"/>
                </a:lnTo>
                <a:lnTo>
                  <a:pt x="68072" y="3048"/>
                </a:lnTo>
                <a:lnTo>
                  <a:pt x="67056" y="1905"/>
                </a:lnTo>
                <a:lnTo>
                  <a:pt x="64262" y="381"/>
                </a:lnTo>
                <a:lnTo>
                  <a:pt x="62611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3" name="object 123"/>
          <p:cNvSpPr/>
          <p:nvPr/>
        </p:nvSpPr>
        <p:spPr>
          <a:xfrm>
            <a:off x="4099610" y="3332050"/>
            <a:ext cx="82849" cy="0"/>
          </a:xfrm>
          <a:custGeom>
            <a:avLst/>
            <a:gdLst/>
            <a:ahLst/>
            <a:cxnLst/>
            <a:rect l="l" t="t" r="r" b="b"/>
            <a:pathLst>
              <a:path w="91439">
                <a:moveTo>
                  <a:pt x="0" y="0"/>
                </a:moveTo>
                <a:lnTo>
                  <a:pt x="91440" y="0"/>
                </a:lnTo>
              </a:path>
            </a:pathLst>
          </a:custGeom>
          <a:ln w="583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4" name="object 124"/>
          <p:cNvSpPr/>
          <p:nvPr/>
        </p:nvSpPr>
        <p:spPr>
          <a:xfrm>
            <a:off x="4290161" y="3277508"/>
            <a:ext cx="131176" cy="111845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5" name="object 125"/>
          <p:cNvSpPr txBox="1"/>
          <p:nvPr/>
        </p:nvSpPr>
        <p:spPr>
          <a:xfrm>
            <a:off x="4279461" y="3274515"/>
            <a:ext cx="13347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26" name="object 126"/>
          <p:cNvSpPr/>
          <p:nvPr/>
        </p:nvSpPr>
        <p:spPr>
          <a:xfrm>
            <a:off x="5104837" y="3278889"/>
            <a:ext cx="157412" cy="111845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7" name="object 127"/>
          <p:cNvSpPr txBox="1"/>
          <p:nvPr/>
        </p:nvSpPr>
        <p:spPr>
          <a:xfrm>
            <a:off x="5094481" y="3274515"/>
            <a:ext cx="15591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28" name="object 128"/>
          <p:cNvSpPr/>
          <p:nvPr/>
        </p:nvSpPr>
        <p:spPr>
          <a:xfrm>
            <a:off x="5639209" y="3276127"/>
            <a:ext cx="129796" cy="56612"/>
          </a:xfrm>
          <a:prstGeom prst="rect">
            <a:avLst/>
          </a:prstGeom>
          <a:blipFill>
            <a:blip r:embed="rId2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9" name="object 129"/>
          <p:cNvSpPr/>
          <p:nvPr/>
        </p:nvSpPr>
        <p:spPr>
          <a:xfrm>
            <a:off x="5641394" y="3289475"/>
            <a:ext cx="24165" cy="32793"/>
          </a:xfrm>
          <a:custGeom>
            <a:avLst/>
            <a:gdLst/>
            <a:ahLst/>
            <a:cxnLst/>
            <a:rect l="l" t="t" r="r" b="b"/>
            <a:pathLst>
              <a:path w="26670" h="36195">
                <a:moveTo>
                  <a:pt x="7620" y="25527"/>
                </a:moveTo>
                <a:lnTo>
                  <a:pt x="0" y="26289"/>
                </a:lnTo>
                <a:lnTo>
                  <a:pt x="508" y="29337"/>
                </a:lnTo>
                <a:lnTo>
                  <a:pt x="1905" y="31750"/>
                </a:lnTo>
                <a:lnTo>
                  <a:pt x="6477" y="35306"/>
                </a:lnTo>
                <a:lnTo>
                  <a:pt x="9525" y="36195"/>
                </a:lnTo>
                <a:lnTo>
                  <a:pt x="17653" y="36195"/>
                </a:lnTo>
                <a:lnTo>
                  <a:pt x="21209" y="34544"/>
                </a:lnTo>
                <a:lnTo>
                  <a:pt x="24511" y="30607"/>
                </a:lnTo>
                <a:lnTo>
                  <a:pt x="11811" y="30607"/>
                </a:lnTo>
                <a:lnTo>
                  <a:pt x="10541" y="30226"/>
                </a:lnTo>
                <a:lnTo>
                  <a:pt x="9525" y="29337"/>
                </a:lnTo>
                <a:lnTo>
                  <a:pt x="8509" y="28321"/>
                </a:lnTo>
                <a:lnTo>
                  <a:pt x="7874" y="27178"/>
                </a:lnTo>
                <a:lnTo>
                  <a:pt x="7620" y="25527"/>
                </a:lnTo>
                <a:close/>
              </a:path>
              <a:path w="26670" h="36195">
                <a:moveTo>
                  <a:pt x="25527" y="17018"/>
                </a:moveTo>
                <a:lnTo>
                  <a:pt x="14732" y="17018"/>
                </a:lnTo>
                <a:lnTo>
                  <a:pt x="16129" y="17526"/>
                </a:lnTo>
                <a:lnTo>
                  <a:pt x="18288" y="19685"/>
                </a:lnTo>
                <a:lnTo>
                  <a:pt x="18923" y="21336"/>
                </a:lnTo>
                <a:lnTo>
                  <a:pt x="18923" y="25908"/>
                </a:lnTo>
                <a:lnTo>
                  <a:pt x="18288" y="27686"/>
                </a:lnTo>
                <a:lnTo>
                  <a:pt x="17272" y="28956"/>
                </a:lnTo>
                <a:lnTo>
                  <a:pt x="16129" y="30099"/>
                </a:lnTo>
                <a:lnTo>
                  <a:pt x="14732" y="30607"/>
                </a:lnTo>
                <a:lnTo>
                  <a:pt x="24511" y="30607"/>
                </a:lnTo>
                <a:lnTo>
                  <a:pt x="25781" y="29083"/>
                </a:lnTo>
                <a:lnTo>
                  <a:pt x="26670" y="26416"/>
                </a:lnTo>
                <a:lnTo>
                  <a:pt x="26670" y="19939"/>
                </a:lnTo>
                <a:lnTo>
                  <a:pt x="25527" y="17018"/>
                </a:lnTo>
                <a:close/>
              </a:path>
              <a:path w="26670" h="36195">
                <a:moveTo>
                  <a:pt x="24892" y="0"/>
                </a:moveTo>
                <a:lnTo>
                  <a:pt x="4826" y="0"/>
                </a:lnTo>
                <a:lnTo>
                  <a:pt x="1016" y="18796"/>
                </a:lnTo>
                <a:lnTo>
                  <a:pt x="7112" y="19558"/>
                </a:lnTo>
                <a:lnTo>
                  <a:pt x="8890" y="17907"/>
                </a:lnTo>
                <a:lnTo>
                  <a:pt x="10795" y="17018"/>
                </a:lnTo>
                <a:lnTo>
                  <a:pt x="25527" y="17018"/>
                </a:lnTo>
                <a:lnTo>
                  <a:pt x="23114" y="14859"/>
                </a:lnTo>
                <a:lnTo>
                  <a:pt x="20828" y="12573"/>
                </a:lnTo>
                <a:lnTo>
                  <a:pt x="9398" y="12573"/>
                </a:lnTo>
                <a:lnTo>
                  <a:pt x="10668" y="6477"/>
                </a:lnTo>
                <a:lnTo>
                  <a:pt x="24892" y="6477"/>
                </a:lnTo>
                <a:lnTo>
                  <a:pt x="24892" y="0"/>
                </a:lnTo>
                <a:close/>
              </a:path>
              <a:path w="26670" h="36195">
                <a:moveTo>
                  <a:pt x="18034" y="11430"/>
                </a:moveTo>
                <a:lnTo>
                  <a:pt x="12827" y="11430"/>
                </a:lnTo>
                <a:lnTo>
                  <a:pt x="11049" y="11811"/>
                </a:lnTo>
                <a:lnTo>
                  <a:pt x="9398" y="12573"/>
                </a:lnTo>
                <a:lnTo>
                  <a:pt x="20828" y="12573"/>
                </a:lnTo>
                <a:lnTo>
                  <a:pt x="18034" y="1143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0" name="object 130"/>
          <p:cNvSpPr/>
          <p:nvPr/>
        </p:nvSpPr>
        <p:spPr>
          <a:xfrm>
            <a:off x="5683397" y="3297531"/>
            <a:ext cx="65013" cy="33369"/>
          </a:xfrm>
          <a:custGeom>
            <a:avLst/>
            <a:gdLst/>
            <a:ahLst/>
            <a:cxnLst/>
            <a:rect l="l" t="t" r="r" b="b"/>
            <a:pathLst>
              <a:path w="71754" h="36829">
                <a:moveTo>
                  <a:pt x="7493" y="635"/>
                </a:moveTo>
                <a:lnTo>
                  <a:pt x="0" y="635"/>
                </a:lnTo>
                <a:lnTo>
                  <a:pt x="0" y="36703"/>
                </a:lnTo>
                <a:lnTo>
                  <a:pt x="7493" y="36703"/>
                </a:lnTo>
                <a:lnTo>
                  <a:pt x="7493" y="23495"/>
                </a:lnTo>
                <a:lnTo>
                  <a:pt x="26035" y="23495"/>
                </a:lnTo>
                <a:lnTo>
                  <a:pt x="26035" y="21717"/>
                </a:lnTo>
                <a:lnTo>
                  <a:pt x="11049" y="21717"/>
                </a:lnTo>
                <a:lnTo>
                  <a:pt x="9525" y="20955"/>
                </a:lnTo>
                <a:lnTo>
                  <a:pt x="8636" y="19304"/>
                </a:lnTo>
                <a:lnTo>
                  <a:pt x="7874" y="18161"/>
                </a:lnTo>
                <a:lnTo>
                  <a:pt x="7493" y="15748"/>
                </a:lnTo>
                <a:lnTo>
                  <a:pt x="7493" y="635"/>
                </a:lnTo>
                <a:close/>
              </a:path>
              <a:path w="71754" h="36829">
                <a:moveTo>
                  <a:pt x="18923" y="23495"/>
                </a:moveTo>
                <a:lnTo>
                  <a:pt x="7493" y="23495"/>
                </a:lnTo>
                <a:lnTo>
                  <a:pt x="8382" y="24892"/>
                </a:lnTo>
                <a:lnTo>
                  <a:pt x="9144" y="25908"/>
                </a:lnTo>
                <a:lnTo>
                  <a:pt x="9779" y="26289"/>
                </a:lnTo>
                <a:lnTo>
                  <a:pt x="10795" y="27051"/>
                </a:lnTo>
                <a:lnTo>
                  <a:pt x="11938" y="27305"/>
                </a:lnTo>
                <a:lnTo>
                  <a:pt x="13843" y="27305"/>
                </a:lnTo>
                <a:lnTo>
                  <a:pt x="17399" y="25527"/>
                </a:lnTo>
                <a:lnTo>
                  <a:pt x="17907" y="25146"/>
                </a:lnTo>
                <a:lnTo>
                  <a:pt x="18415" y="24384"/>
                </a:lnTo>
                <a:lnTo>
                  <a:pt x="18923" y="23495"/>
                </a:lnTo>
                <a:close/>
              </a:path>
              <a:path w="71754" h="36829">
                <a:moveTo>
                  <a:pt x="26035" y="23495"/>
                </a:moveTo>
                <a:lnTo>
                  <a:pt x="18923" y="23495"/>
                </a:lnTo>
                <a:lnTo>
                  <a:pt x="18923" y="26670"/>
                </a:lnTo>
                <a:lnTo>
                  <a:pt x="26035" y="26670"/>
                </a:lnTo>
                <a:lnTo>
                  <a:pt x="26035" y="23495"/>
                </a:lnTo>
                <a:close/>
              </a:path>
              <a:path w="71754" h="36829">
                <a:moveTo>
                  <a:pt x="26035" y="635"/>
                </a:moveTo>
                <a:lnTo>
                  <a:pt x="18415" y="635"/>
                </a:lnTo>
                <a:lnTo>
                  <a:pt x="18415" y="15367"/>
                </a:lnTo>
                <a:lnTo>
                  <a:pt x="18161" y="17399"/>
                </a:lnTo>
                <a:lnTo>
                  <a:pt x="17780" y="18415"/>
                </a:lnTo>
                <a:lnTo>
                  <a:pt x="17272" y="19431"/>
                </a:lnTo>
                <a:lnTo>
                  <a:pt x="16637" y="20320"/>
                </a:lnTo>
                <a:lnTo>
                  <a:pt x="15748" y="20828"/>
                </a:lnTo>
                <a:lnTo>
                  <a:pt x="14859" y="21463"/>
                </a:lnTo>
                <a:lnTo>
                  <a:pt x="13843" y="21717"/>
                </a:lnTo>
                <a:lnTo>
                  <a:pt x="26035" y="21717"/>
                </a:lnTo>
                <a:lnTo>
                  <a:pt x="26035" y="635"/>
                </a:lnTo>
                <a:close/>
              </a:path>
              <a:path w="71754" h="36829">
                <a:moveTo>
                  <a:pt x="36322" y="635"/>
                </a:moveTo>
                <a:lnTo>
                  <a:pt x="29337" y="635"/>
                </a:lnTo>
                <a:lnTo>
                  <a:pt x="29337" y="26670"/>
                </a:lnTo>
                <a:lnTo>
                  <a:pt x="36957" y="26670"/>
                </a:lnTo>
                <a:lnTo>
                  <a:pt x="36957" y="11557"/>
                </a:lnTo>
                <a:lnTo>
                  <a:pt x="37084" y="9652"/>
                </a:lnTo>
                <a:lnTo>
                  <a:pt x="41529" y="5334"/>
                </a:lnTo>
                <a:lnTo>
                  <a:pt x="71077" y="5334"/>
                </a:lnTo>
                <a:lnTo>
                  <a:pt x="70739" y="4572"/>
                </a:lnTo>
                <a:lnTo>
                  <a:pt x="70548" y="4191"/>
                </a:lnTo>
                <a:lnTo>
                  <a:pt x="36322" y="4191"/>
                </a:lnTo>
                <a:lnTo>
                  <a:pt x="36322" y="635"/>
                </a:lnTo>
                <a:close/>
              </a:path>
              <a:path w="71754" h="36829">
                <a:moveTo>
                  <a:pt x="58801" y="5334"/>
                </a:moveTo>
                <a:lnTo>
                  <a:pt x="43688" y="5334"/>
                </a:lnTo>
                <a:lnTo>
                  <a:pt x="44450" y="5461"/>
                </a:lnTo>
                <a:lnTo>
                  <a:pt x="44958" y="5842"/>
                </a:lnTo>
                <a:lnTo>
                  <a:pt x="46609" y="26670"/>
                </a:lnTo>
                <a:lnTo>
                  <a:pt x="54229" y="26670"/>
                </a:lnTo>
                <a:lnTo>
                  <a:pt x="54229" y="11684"/>
                </a:lnTo>
                <a:lnTo>
                  <a:pt x="54483" y="9906"/>
                </a:lnTo>
                <a:lnTo>
                  <a:pt x="55245" y="7620"/>
                </a:lnTo>
                <a:lnTo>
                  <a:pt x="56007" y="6731"/>
                </a:lnTo>
                <a:lnTo>
                  <a:pt x="56896" y="6223"/>
                </a:lnTo>
                <a:lnTo>
                  <a:pt x="57785" y="5588"/>
                </a:lnTo>
                <a:lnTo>
                  <a:pt x="58801" y="5334"/>
                </a:lnTo>
                <a:close/>
              </a:path>
              <a:path w="71754" h="36829">
                <a:moveTo>
                  <a:pt x="71077" y="5334"/>
                </a:moveTo>
                <a:lnTo>
                  <a:pt x="61341" y="5334"/>
                </a:lnTo>
                <a:lnTo>
                  <a:pt x="62484" y="5715"/>
                </a:lnTo>
                <a:lnTo>
                  <a:pt x="63119" y="6731"/>
                </a:lnTo>
                <a:lnTo>
                  <a:pt x="63627" y="7493"/>
                </a:lnTo>
                <a:lnTo>
                  <a:pt x="63881" y="9144"/>
                </a:lnTo>
                <a:lnTo>
                  <a:pt x="63881" y="26670"/>
                </a:lnTo>
                <a:lnTo>
                  <a:pt x="71501" y="26670"/>
                </a:lnTo>
                <a:lnTo>
                  <a:pt x="71501" y="7493"/>
                </a:lnTo>
                <a:lnTo>
                  <a:pt x="71247" y="5715"/>
                </a:lnTo>
                <a:lnTo>
                  <a:pt x="71077" y="5334"/>
                </a:lnTo>
                <a:close/>
              </a:path>
              <a:path w="71754" h="36829">
                <a:moveTo>
                  <a:pt x="47117" y="0"/>
                </a:moveTo>
                <a:lnTo>
                  <a:pt x="41783" y="0"/>
                </a:lnTo>
                <a:lnTo>
                  <a:pt x="38862" y="1397"/>
                </a:lnTo>
                <a:lnTo>
                  <a:pt x="36322" y="4191"/>
                </a:lnTo>
                <a:lnTo>
                  <a:pt x="53340" y="4191"/>
                </a:lnTo>
                <a:lnTo>
                  <a:pt x="47117" y="0"/>
                </a:lnTo>
                <a:close/>
              </a:path>
              <a:path w="71754" h="36829">
                <a:moveTo>
                  <a:pt x="64262" y="0"/>
                </a:moveTo>
                <a:lnTo>
                  <a:pt x="60452" y="0"/>
                </a:lnTo>
                <a:lnTo>
                  <a:pt x="58928" y="381"/>
                </a:lnTo>
                <a:lnTo>
                  <a:pt x="57404" y="1016"/>
                </a:lnTo>
                <a:lnTo>
                  <a:pt x="56007" y="1778"/>
                </a:lnTo>
                <a:lnTo>
                  <a:pt x="54610" y="2794"/>
                </a:lnTo>
                <a:lnTo>
                  <a:pt x="53340" y="4191"/>
                </a:lnTo>
                <a:lnTo>
                  <a:pt x="70548" y="4191"/>
                </a:lnTo>
                <a:lnTo>
                  <a:pt x="69977" y="3048"/>
                </a:lnTo>
                <a:lnTo>
                  <a:pt x="68961" y="1905"/>
                </a:lnTo>
                <a:lnTo>
                  <a:pt x="67437" y="1143"/>
                </a:lnTo>
                <a:lnTo>
                  <a:pt x="66040" y="381"/>
                </a:lnTo>
                <a:lnTo>
                  <a:pt x="64262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1" name="object 131"/>
          <p:cNvSpPr/>
          <p:nvPr/>
        </p:nvSpPr>
        <p:spPr>
          <a:xfrm>
            <a:off x="5662683" y="3327908"/>
            <a:ext cx="87451" cy="0"/>
          </a:xfrm>
          <a:custGeom>
            <a:avLst/>
            <a:gdLst/>
            <a:ahLst/>
            <a:cxnLst/>
            <a:rect l="l" t="t" r="r" b="b"/>
            <a:pathLst>
              <a:path w="96520">
                <a:moveTo>
                  <a:pt x="0" y="0"/>
                </a:moveTo>
                <a:lnTo>
                  <a:pt x="96014" y="0"/>
                </a:lnTo>
              </a:path>
            </a:pathLst>
          </a:custGeom>
          <a:ln w="583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2" name="object 132"/>
          <p:cNvSpPr/>
          <p:nvPr/>
        </p:nvSpPr>
        <p:spPr>
          <a:xfrm>
            <a:off x="5896041" y="3277508"/>
            <a:ext cx="183647" cy="111845"/>
          </a:xfrm>
          <a:prstGeom prst="rect">
            <a:avLst/>
          </a:prstGeom>
          <a:blipFill>
            <a:blip r:embed="rId3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3" name="object 133"/>
          <p:cNvSpPr txBox="1"/>
          <p:nvPr/>
        </p:nvSpPr>
        <p:spPr>
          <a:xfrm>
            <a:off x="5885683" y="3274515"/>
            <a:ext cx="183532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v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34" name="object 134"/>
          <p:cNvSpPr/>
          <p:nvPr/>
        </p:nvSpPr>
        <p:spPr>
          <a:xfrm>
            <a:off x="1525445" y="4779941"/>
            <a:ext cx="774631" cy="774055"/>
          </a:xfrm>
          <a:prstGeom prst="rect">
            <a:avLst/>
          </a:prstGeom>
          <a:blipFill>
            <a:blip r:embed="rId4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5" name="object 135"/>
          <p:cNvSpPr/>
          <p:nvPr/>
        </p:nvSpPr>
        <p:spPr>
          <a:xfrm>
            <a:off x="460844" y="4779941"/>
            <a:ext cx="1034222" cy="774055"/>
          </a:xfrm>
          <a:prstGeom prst="rect">
            <a:avLst/>
          </a:prstGeom>
          <a:blipFill>
            <a:blip r:embed="rId4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6" name="object 136"/>
          <p:cNvSpPr/>
          <p:nvPr/>
        </p:nvSpPr>
        <p:spPr>
          <a:xfrm>
            <a:off x="1412565" y="5518439"/>
            <a:ext cx="35671" cy="0"/>
          </a:xfrm>
          <a:custGeom>
            <a:avLst/>
            <a:gdLst/>
            <a:ahLst/>
            <a:cxnLst/>
            <a:rect l="l" t="t" r="r" b="b"/>
            <a:pathLst>
              <a:path w="39369">
                <a:moveTo>
                  <a:pt x="0" y="0"/>
                </a:moveTo>
                <a:lnTo>
                  <a:pt x="39370" y="0"/>
                </a:lnTo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7" name="object 137"/>
          <p:cNvSpPr/>
          <p:nvPr/>
        </p:nvSpPr>
        <p:spPr>
          <a:xfrm>
            <a:off x="490185" y="4819868"/>
            <a:ext cx="454286" cy="99417"/>
          </a:xfrm>
          <a:prstGeom prst="rect">
            <a:avLst/>
          </a:prstGeom>
          <a:blipFill>
            <a:blip r:embed="rId3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8" name="object 138"/>
          <p:cNvSpPr txBox="1"/>
          <p:nvPr/>
        </p:nvSpPr>
        <p:spPr>
          <a:xfrm>
            <a:off x="478680" y="4815724"/>
            <a:ext cx="450488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770" spc="-18" dirty="0">
                <a:solidFill>
                  <a:srgbClr val="00AF50"/>
                </a:solidFill>
                <a:latin typeface="Calibri"/>
                <a:cs typeface="Calibri"/>
              </a:rPr>
              <a:t>*/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*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139" name="object 139"/>
          <p:cNvSpPr/>
          <p:nvPr/>
        </p:nvSpPr>
        <p:spPr>
          <a:xfrm>
            <a:off x="484662" y="5417755"/>
            <a:ext cx="106321" cy="11184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0" name="object 140"/>
          <p:cNvSpPr txBox="1"/>
          <p:nvPr/>
        </p:nvSpPr>
        <p:spPr>
          <a:xfrm>
            <a:off x="473154" y="5414994"/>
            <a:ext cx="10873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41" name="object 141"/>
          <p:cNvSpPr/>
          <p:nvPr/>
        </p:nvSpPr>
        <p:spPr>
          <a:xfrm>
            <a:off x="1545120" y="5417755"/>
            <a:ext cx="132557" cy="111845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2" name="object 142"/>
          <p:cNvSpPr txBox="1"/>
          <p:nvPr/>
        </p:nvSpPr>
        <p:spPr>
          <a:xfrm>
            <a:off x="1533846" y="5414994"/>
            <a:ext cx="132327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43" name="object 143"/>
          <p:cNvSpPr/>
          <p:nvPr/>
        </p:nvSpPr>
        <p:spPr>
          <a:xfrm>
            <a:off x="1413945" y="5501987"/>
            <a:ext cx="45566" cy="16569"/>
          </a:xfrm>
          <a:prstGeom prst="rect">
            <a:avLst/>
          </a:prstGeom>
          <a:blipFill>
            <a:blip r:embed="rId2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4" name="object 144"/>
          <p:cNvSpPr/>
          <p:nvPr/>
        </p:nvSpPr>
        <p:spPr>
          <a:xfrm>
            <a:off x="1414636" y="5507393"/>
            <a:ext cx="6329" cy="7479"/>
          </a:xfrm>
          <a:custGeom>
            <a:avLst/>
            <a:gdLst/>
            <a:ahLst/>
            <a:cxnLst/>
            <a:rect l="l" t="t" r="r" b="b"/>
            <a:pathLst>
              <a:path w="6984" h="8254">
                <a:moveTo>
                  <a:pt x="1016" y="6350"/>
                </a:moveTo>
                <a:lnTo>
                  <a:pt x="0" y="6350"/>
                </a:lnTo>
                <a:lnTo>
                  <a:pt x="0" y="7239"/>
                </a:lnTo>
                <a:lnTo>
                  <a:pt x="127" y="7366"/>
                </a:lnTo>
                <a:lnTo>
                  <a:pt x="127" y="7493"/>
                </a:lnTo>
                <a:lnTo>
                  <a:pt x="381" y="7493"/>
                </a:lnTo>
                <a:lnTo>
                  <a:pt x="508" y="7620"/>
                </a:lnTo>
                <a:lnTo>
                  <a:pt x="762" y="7620"/>
                </a:lnTo>
                <a:lnTo>
                  <a:pt x="1016" y="7747"/>
                </a:lnTo>
                <a:lnTo>
                  <a:pt x="1524" y="7747"/>
                </a:lnTo>
                <a:lnTo>
                  <a:pt x="1778" y="7874"/>
                </a:lnTo>
                <a:lnTo>
                  <a:pt x="3937" y="7874"/>
                </a:lnTo>
                <a:lnTo>
                  <a:pt x="4953" y="7620"/>
                </a:lnTo>
                <a:lnTo>
                  <a:pt x="5334" y="7366"/>
                </a:lnTo>
                <a:lnTo>
                  <a:pt x="5715" y="7239"/>
                </a:lnTo>
                <a:lnTo>
                  <a:pt x="6096" y="6985"/>
                </a:lnTo>
                <a:lnTo>
                  <a:pt x="6350" y="6731"/>
                </a:lnTo>
                <a:lnTo>
                  <a:pt x="6392" y="6604"/>
                </a:lnTo>
                <a:lnTo>
                  <a:pt x="1651" y="6604"/>
                </a:lnTo>
                <a:lnTo>
                  <a:pt x="1397" y="6477"/>
                </a:lnTo>
                <a:lnTo>
                  <a:pt x="1143" y="6477"/>
                </a:lnTo>
                <a:lnTo>
                  <a:pt x="1016" y="6350"/>
                </a:lnTo>
                <a:close/>
              </a:path>
              <a:path w="6984" h="8254">
                <a:moveTo>
                  <a:pt x="6096" y="127"/>
                </a:moveTo>
                <a:lnTo>
                  <a:pt x="508" y="127"/>
                </a:lnTo>
                <a:lnTo>
                  <a:pt x="508" y="254"/>
                </a:lnTo>
                <a:lnTo>
                  <a:pt x="381" y="381"/>
                </a:lnTo>
                <a:lnTo>
                  <a:pt x="381" y="3937"/>
                </a:lnTo>
                <a:lnTo>
                  <a:pt x="508" y="4064"/>
                </a:lnTo>
                <a:lnTo>
                  <a:pt x="508" y="4191"/>
                </a:lnTo>
                <a:lnTo>
                  <a:pt x="3429" y="4191"/>
                </a:lnTo>
                <a:lnTo>
                  <a:pt x="3683" y="4318"/>
                </a:lnTo>
                <a:lnTo>
                  <a:pt x="3937" y="4318"/>
                </a:lnTo>
                <a:lnTo>
                  <a:pt x="4064" y="4445"/>
                </a:lnTo>
                <a:lnTo>
                  <a:pt x="4318" y="4572"/>
                </a:lnTo>
                <a:lnTo>
                  <a:pt x="4318" y="4699"/>
                </a:lnTo>
                <a:lnTo>
                  <a:pt x="4572" y="4953"/>
                </a:lnTo>
                <a:lnTo>
                  <a:pt x="4572" y="5715"/>
                </a:lnTo>
                <a:lnTo>
                  <a:pt x="4445" y="5969"/>
                </a:lnTo>
                <a:lnTo>
                  <a:pt x="4064" y="6350"/>
                </a:lnTo>
                <a:lnTo>
                  <a:pt x="3810" y="6477"/>
                </a:lnTo>
                <a:lnTo>
                  <a:pt x="3683" y="6477"/>
                </a:lnTo>
                <a:lnTo>
                  <a:pt x="3429" y="6604"/>
                </a:lnTo>
                <a:lnTo>
                  <a:pt x="6392" y="6604"/>
                </a:lnTo>
                <a:lnTo>
                  <a:pt x="6477" y="6350"/>
                </a:lnTo>
                <a:lnTo>
                  <a:pt x="6731" y="6096"/>
                </a:lnTo>
                <a:lnTo>
                  <a:pt x="6858" y="5715"/>
                </a:lnTo>
                <a:lnTo>
                  <a:pt x="6858" y="4826"/>
                </a:lnTo>
                <a:lnTo>
                  <a:pt x="6604" y="4318"/>
                </a:lnTo>
                <a:lnTo>
                  <a:pt x="6477" y="3937"/>
                </a:lnTo>
                <a:lnTo>
                  <a:pt x="6223" y="3810"/>
                </a:lnTo>
                <a:lnTo>
                  <a:pt x="5969" y="3556"/>
                </a:lnTo>
                <a:lnTo>
                  <a:pt x="4826" y="3175"/>
                </a:lnTo>
                <a:lnTo>
                  <a:pt x="4318" y="3048"/>
                </a:lnTo>
                <a:lnTo>
                  <a:pt x="2159" y="3048"/>
                </a:lnTo>
                <a:lnTo>
                  <a:pt x="2159" y="1397"/>
                </a:lnTo>
                <a:lnTo>
                  <a:pt x="5969" y="1397"/>
                </a:lnTo>
                <a:lnTo>
                  <a:pt x="6223" y="1143"/>
                </a:lnTo>
                <a:lnTo>
                  <a:pt x="6223" y="254"/>
                </a:lnTo>
                <a:lnTo>
                  <a:pt x="6096" y="254"/>
                </a:lnTo>
                <a:lnTo>
                  <a:pt x="6096" y="127"/>
                </a:lnTo>
                <a:close/>
              </a:path>
              <a:path w="6984" h="8254">
                <a:moveTo>
                  <a:pt x="508" y="6223"/>
                </a:moveTo>
                <a:lnTo>
                  <a:pt x="127" y="6223"/>
                </a:lnTo>
                <a:lnTo>
                  <a:pt x="127" y="6350"/>
                </a:lnTo>
                <a:lnTo>
                  <a:pt x="635" y="6350"/>
                </a:lnTo>
                <a:lnTo>
                  <a:pt x="508" y="6223"/>
                </a:lnTo>
                <a:close/>
              </a:path>
              <a:path w="6984" h="8254">
                <a:moveTo>
                  <a:pt x="5969" y="0"/>
                </a:moveTo>
                <a:lnTo>
                  <a:pt x="762" y="0"/>
                </a:lnTo>
                <a:lnTo>
                  <a:pt x="635" y="127"/>
                </a:lnTo>
                <a:lnTo>
                  <a:pt x="5969" y="127"/>
                </a:lnTo>
                <a:lnTo>
                  <a:pt x="5969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5" name="object 145"/>
          <p:cNvSpPr/>
          <p:nvPr/>
        </p:nvSpPr>
        <p:spPr>
          <a:xfrm>
            <a:off x="1425912" y="5509119"/>
            <a:ext cx="16108" cy="7479"/>
          </a:xfrm>
          <a:custGeom>
            <a:avLst/>
            <a:gdLst/>
            <a:ahLst/>
            <a:cxnLst/>
            <a:rect l="l" t="t" r="r" b="b"/>
            <a:pathLst>
              <a:path w="17780" h="8254">
                <a:moveTo>
                  <a:pt x="1778" y="7874"/>
                </a:moveTo>
                <a:lnTo>
                  <a:pt x="254" y="7874"/>
                </a:lnTo>
                <a:lnTo>
                  <a:pt x="254" y="8001"/>
                </a:lnTo>
                <a:lnTo>
                  <a:pt x="1778" y="8001"/>
                </a:lnTo>
                <a:lnTo>
                  <a:pt x="1778" y="7874"/>
                </a:lnTo>
                <a:close/>
              </a:path>
              <a:path w="17780" h="8254">
                <a:moveTo>
                  <a:pt x="2032" y="254"/>
                </a:moveTo>
                <a:lnTo>
                  <a:pt x="0" y="254"/>
                </a:lnTo>
                <a:lnTo>
                  <a:pt x="0" y="7874"/>
                </a:lnTo>
                <a:lnTo>
                  <a:pt x="2032" y="7874"/>
                </a:lnTo>
                <a:lnTo>
                  <a:pt x="2032" y="6350"/>
                </a:lnTo>
                <a:lnTo>
                  <a:pt x="1905" y="6223"/>
                </a:lnTo>
                <a:lnTo>
                  <a:pt x="1905" y="5588"/>
                </a:lnTo>
                <a:lnTo>
                  <a:pt x="4318" y="5588"/>
                </a:lnTo>
                <a:lnTo>
                  <a:pt x="5080" y="5080"/>
                </a:lnTo>
                <a:lnTo>
                  <a:pt x="6096" y="5080"/>
                </a:lnTo>
                <a:lnTo>
                  <a:pt x="6096" y="4699"/>
                </a:lnTo>
                <a:lnTo>
                  <a:pt x="2794" y="4699"/>
                </a:lnTo>
                <a:lnTo>
                  <a:pt x="2540" y="4572"/>
                </a:lnTo>
                <a:lnTo>
                  <a:pt x="2159" y="4191"/>
                </a:lnTo>
                <a:lnTo>
                  <a:pt x="2032" y="3937"/>
                </a:lnTo>
                <a:lnTo>
                  <a:pt x="2032" y="254"/>
                </a:lnTo>
                <a:close/>
              </a:path>
              <a:path w="17780" h="8254">
                <a:moveTo>
                  <a:pt x="4318" y="5588"/>
                </a:moveTo>
                <a:lnTo>
                  <a:pt x="1905" y="5588"/>
                </a:lnTo>
                <a:lnTo>
                  <a:pt x="2159" y="5842"/>
                </a:lnTo>
                <a:lnTo>
                  <a:pt x="2286" y="5842"/>
                </a:lnTo>
                <a:lnTo>
                  <a:pt x="2540" y="5969"/>
                </a:lnTo>
                <a:lnTo>
                  <a:pt x="3302" y="5969"/>
                </a:lnTo>
                <a:lnTo>
                  <a:pt x="3683" y="5842"/>
                </a:lnTo>
                <a:lnTo>
                  <a:pt x="3937" y="5715"/>
                </a:lnTo>
                <a:lnTo>
                  <a:pt x="4318" y="5588"/>
                </a:lnTo>
                <a:close/>
              </a:path>
              <a:path w="17780" h="8254">
                <a:moveTo>
                  <a:pt x="6096" y="5080"/>
                </a:moveTo>
                <a:lnTo>
                  <a:pt x="5080" y="5080"/>
                </a:lnTo>
                <a:lnTo>
                  <a:pt x="5207" y="5461"/>
                </a:lnTo>
                <a:lnTo>
                  <a:pt x="5334" y="5588"/>
                </a:lnTo>
                <a:lnTo>
                  <a:pt x="5715" y="5715"/>
                </a:lnTo>
                <a:lnTo>
                  <a:pt x="5969" y="5842"/>
                </a:lnTo>
                <a:lnTo>
                  <a:pt x="6350" y="5969"/>
                </a:lnTo>
                <a:lnTo>
                  <a:pt x="7620" y="5969"/>
                </a:lnTo>
                <a:lnTo>
                  <a:pt x="7747" y="5842"/>
                </a:lnTo>
                <a:lnTo>
                  <a:pt x="6223" y="5842"/>
                </a:lnTo>
                <a:lnTo>
                  <a:pt x="6223" y="5715"/>
                </a:lnTo>
                <a:lnTo>
                  <a:pt x="6096" y="5715"/>
                </a:lnTo>
                <a:lnTo>
                  <a:pt x="6096" y="5080"/>
                </a:lnTo>
                <a:close/>
              </a:path>
              <a:path w="17780" h="8254">
                <a:moveTo>
                  <a:pt x="8001" y="5715"/>
                </a:moveTo>
                <a:lnTo>
                  <a:pt x="6223" y="5715"/>
                </a:lnTo>
                <a:lnTo>
                  <a:pt x="6223" y="5842"/>
                </a:lnTo>
                <a:lnTo>
                  <a:pt x="8001" y="5842"/>
                </a:lnTo>
                <a:lnTo>
                  <a:pt x="8001" y="5715"/>
                </a:lnTo>
                <a:close/>
              </a:path>
              <a:path w="17780" h="8254">
                <a:moveTo>
                  <a:pt x="12700" y="5715"/>
                </a:moveTo>
                <a:lnTo>
                  <a:pt x="10922" y="5715"/>
                </a:lnTo>
                <a:lnTo>
                  <a:pt x="10922" y="5842"/>
                </a:lnTo>
                <a:lnTo>
                  <a:pt x="12700" y="5842"/>
                </a:lnTo>
                <a:lnTo>
                  <a:pt x="12700" y="5715"/>
                </a:lnTo>
                <a:close/>
              </a:path>
              <a:path w="17780" h="8254">
                <a:moveTo>
                  <a:pt x="17335" y="1270"/>
                </a:moveTo>
                <a:lnTo>
                  <a:pt x="14732" y="1270"/>
                </a:lnTo>
                <a:lnTo>
                  <a:pt x="14859" y="1397"/>
                </a:lnTo>
                <a:lnTo>
                  <a:pt x="14986" y="1397"/>
                </a:lnTo>
                <a:lnTo>
                  <a:pt x="15240" y="1651"/>
                </a:lnTo>
                <a:lnTo>
                  <a:pt x="15240" y="1778"/>
                </a:lnTo>
                <a:lnTo>
                  <a:pt x="15367" y="1905"/>
                </a:lnTo>
                <a:lnTo>
                  <a:pt x="15367" y="2032"/>
                </a:lnTo>
                <a:lnTo>
                  <a:pt x="15494" y="2159"/>
                </a:lnTo>
                <a:lnTo>
                  <a:pt x="15494" y="5715"/>
                </a:lnTo>
                <a:lnTo>
                  <a:pt x="15621" y="5842"/>
                </a:lnTo>
                <a:lnTo>
                  <a:pt x="17399" y="5842"/>
                </a:lnTo>
                <a:lnTo>
                  <a:pt x="17399" y="5715"/>
                </a:lnTo>
                <a:lnTo>
                  <a:pt x="17526" y="5715"/>
                </a:lnTo>
                <a:lnTo>
                  <a:pt x="17526" y="1905"/>
                </a:lnTo>
                <a:lnTo>
                  <a:pt x="17399" y="1651"/>
                </a:lnTo>
                <a:lnTo>
                  <a:pt x="17399" y="1397"/>
                </a:lnTo>
                <a:lnTo>
                  <a:pt x="17335" y="1270"/>
                </a:lnTo>
                <a:close/>
              </a:path>
              <a:path w="17780" h="8254">
                <a:moveTo>
                  <a:pt x="6858" y="254"/>
                </a:moveTo>
                <a:lnTo>
                  <a:pt x="6096" y="254"/>
                </a:lnTo>
                <a:lnTo>
                  <a:pt x="6096" y="5715"/>
                </a:lnTo>
                <a:lnTo>
                  <a:pt x="8128" y="5715"/>
                </a:lnTo>
                <a:lnTo>
                  <a:pt x="8128" y="4699"/>
                </a:lnTo>
                <a:lnTo>
                  <a:pt x="7112" y="4699"/>
                </a:lnTo>
                <a:lnTo>
                  <a:pt x="6985" y="4572"/>
                </a:lnTo>
                <a:lnTo>
                  <a:pt x="6985" y="4445"/>
                </a:lnTo>
                <a:lnTo>
                  <a:pt x="6858" y="4445"/>
                </a:lnTo>
                <a:lnTo>
                  <a:pt x="6858" y="254"/>
                </a:lnTo>
                <a:close/>
              </a:path>
              <a:path w="17780" h="8254">
                <a:moveTo>
                  <a:pt x="14097" y="1270"/>
                </a:moveTo>
                <a:lnTo>
                  <a:pt x="10033" y="1270"/>
                </a:lnTo>
                <a:lnTo>
                  <a:pt x="10160" y="1397"/>
                </a:lnTo>
                <a:lnTo>
                  <a:pt x="10287" y="1397"/>
                </a:lnTo>
                <a:lnTo>
                  <a:pt x="10541" y="1651"/>
                </a:lnTo>
                <a:lnTo>
                  <a:pt x="10541" y="1778"/>
                </a:lnTo>
                <a:lnTo>
                  <a:pt x="10668" y="1905"/>
                </a:lnTo>
                <a:lnTo>
                  <a:pt x="10668" y="2032"/>
                </a:lnTo>
                <a:lnTo>
                  <a:pt x="10795" y="2159"/>
                </a:lnTo>
                <a:lnTo>
                  <a:pt x="10795" y="5715"/>
                </a:lnTo>
                <a:lnTo>
                  <a:pt x="12827" y="5715"/>
                </a:lnTo>
                <a:lnTo>
                  <a:pt x="12827" y="2159"/>
                </a:lnTo>
                <a:lnTo>
                  <a:pt x="13335" y="1651"/>
                </a:lnTo>
                <a:lnTo>
                  <a:pt x="14097" y="1270"/>
                </a:lnTo>
                <a:close/>
              </a:path>
              <a:path w="17780" h="8254">
                <a:moveTo>
                  <a:pt x="6096" y="254"/>
                </a:moveTo>
                <a:lnTo>
                  <a:pt x="4826" y="254"/>
                </a:lnTo>
                <a:lnTo>
                  <a:pt x="4826" y="3810"/>
                </a:lnTo>
                <a:lnTo>
                  <a:pt x="4572" y="4191"/>
                </a:lnTo>
                <a:lnTo>
                  <a:pt x="4064" y="4445"/>
                </a:lnTo>
                <a:lnTo>
                  <a:pt x="3683" y="4572"/>
                </a:lnTo>
                <a:lnTo>
                  <a:pt x="3429" y="4699"/>
                </a:lnTo>
                <a:lnTo>
                  <a:pt x="6096" y="4699"/>
                </a:lnTo>
                <a:lnTo>
                  <a:pt x="6096" y="254"/>
                </a:lnTo>
                <a:close/>
              </a:path>
              <a:path w="17780" h="8254">
                <a:moveTo>
                  <a:pt x="7874" y="254"/>
                </a:moveTo>
                <a:lnTo>
                  <a:pt x="6858" y="254"/>
                </a:lnTo>
                <a:lnTo>
                  <a:pt x="6858" y="4445"/>
                </a:lnTo>
                <a:lnTo>
                  <a:pt x="6985" y="4445"/>
                </a:lnTo>
                <a:lnTo>
                  <a:pt x="6985" y="4572"/>
                </a:lnTo>
                <a:lnTo>
                  <a:pt x="7112" y="4699"/>
                </a:lnTo>
                <a:lnTo>
                  <a:pt x="8128" y="4699"/>
                </a:lnTo>
                <a:lnTo>
                  <a:pt x="8128" y="2159"/>
                </a:lnTo>
                <a:lnTo>
                  <a:pt x="8636" y="1651"/>
                </a:lnTo>
                <a:lnTo>
                  <a:pt x="9398" y="1270"/>
                </a:lnTo>
                <a:lnTo>
                  <a:pt x="17335" y="1270"/>
                </a:lnTo>
                <a:lnTo>
                  <a:pt x="17208" y="1016"/>
                </a:lnTo>
                <a:lnTo>
                  <a:pt x="12446" y="1016"/>
                </a:lnTo>
                <a:lnTo>
                  <a:pt x="12446" y="889"/>
                </a:lnTo>
                <a:lnTo>
                  <a:pt x="7874" y="889"/>
                </a:lnTo>
                <a:lnTo>
                  <a:pt x="7874" y="254"/>
                </a:lnTo>
                <a:close/>
              </a:path>
              <a:path w="17780" h="8254">
                <a:moveTo>
                  <a:pt x="15875" y="0"/>
                </a:moveTo>
                <a:lnTo>
                  <a:pt x="14351" y="0"/>
                </a:lnTo>
                <a:lnTo>
                  <a:pt x="14097" y="127"/>
                </a:lnTo>
                <a:lnTo>
                  <a:pt x="13970" y="127"/>
                </a:lnTo>
                <a:lnTo>
                  <a:pt x="13716" y="254"/>
                </a:lnTo>
                <a:lnTo>
                  <a:pt x="13462" y="254"/>
                </a:lnTo>
                <a:lnTo>
                  <a:pt x="13335" y="381"/>
                </a:lnTo>
                <a:lnTo>
                  <a:pt x="13081" y="508"/>
                </a:lnTo>
                <a:lnTo>
                  <a:pt x="12954" y="635"/>
                </a:lnTo>
                <a:lnTo>
                  <a:pt x="12700" y="762"/>
                </a:lnTo>
                <a:lnTo>
                  <a:pt x="12446" y="1016"/>
                </a:lnTo>
                <a:lnTo>
                  <a:pt x="17208" y="1016"/>
                </a:lnTo>
                <a:lnTo>
                  <a:pt x="17145" y="889"/>
                </a:lnTo>
                <a:lnTo>
                  <a:pt x="16510" y="254"/>
                </a:lnTo>
                <a:lnTo>
                  <a:pt x="16129" y="127"/>
                </a:lnTo>
                <a:lnTo>
                  <a:pt x="15875" y="0"/>
                </a:lnTo>
                <a:close/>
              </a:path>
              <a:path w="17780" h="8254">
                <a:moveTo>
                  <a:pt x="11049" y="0"/>
                </a:moveTo>
                <a:lnTo>
                  <a:pt x="9779" y="0"/>
                </a:lnTo>
                <a:lnTo>
                  <a:pt x="8636" y="381"/>
                </a:lnTo>
                <a:lnTo>
                  <a:pt x="7874" y="889"/>
                </a:lnTo>
                <a:lnTo>
                  <a:pt x="12446" y="889"/>
                </a:lnTo>
                <a:lnTo>
                  <a:pt x="12446" y="762"/>
                </a:lnTo>
                <a:lnTo>
                  <a:pt x="12065" y="381"/>
                </a:lnTo>
                <a:lnTo>
                  <a:pt x="11811" y="381"/>
                </a:lnTo>
                <a:lnTo>
                  <a:pt x="11684" y="254"/>
                </a:lnTo>
                <a:lnTo>
                  <a:pt x="11430" y="127"/>
                </a:lnTo>
                <a:lnTo>
                  <a:pt x="11303" y="127"/>
                </a:lnTo>
                <a:lnTo>
                  <a:pt x="11049" y="0"/>
                </a:lnTo>
                <a:close/>
              </a:path>
              <a:path w="17780" h="8254">
                <a:moveTo>
                  <a:pt x="1905" y="127"/>
                </a:moveTo>
                <a:lnTo>
                  <a:pt x="127" y="127"/>
                </a:lnTo>
                <a:lnTo>
                  <a:pt x="127" y="254"/>
                </a:lnTo>
                <a:lnTo>
                  <a:pt x="1905" y="254"/>
                </a:lnTo>
                <a:lnTo>
                  <a:pt x="1905" y="127"/>
                </a:lnTo>
                <a:close/>
              </a:path>
              <a:path w="17780" h="8254">
                <a:moveTo>
                  <a:pt x="6223" y="127"/>
                </a:moveTo>
                <a:lnTo>
                  <a:pt x="4953" y="127"/>
                </a:lnTo>
                <a:lnTo>
                  <a:pt x="4953" y="254"/>
                </a:lnTo>
                <a:lnTo>
                  <a:pt x="6223" y="254"/>
                </a:lnTo>
                <a:lnTo>
                  <a:pt x="6223" y="127"/>
                </a:lnTo>
                <a:close/>
              </a:path>
              <a:path w="17780" h="8254">
                <a:moveTo>
                  <a:pt x="6731" y="127"/>
                </a:moveTo>
                <a:lnTo>
                  <a:pt x="6223" y="127"/>
                </a:lnTo>
                <a:lnTo>
                  <a:pt x="6223" y="254"/>
                </a:lnTo>
                <a:lnTo>
                  <a:pt x="6731" y="254"/>
                </a:lnTo>
                <a:lnTo>
                  <a:pt x="6731" y="127"/>
                </a:lnTo>
                <a:close/>
              </a:path>
              <a:path w="17780" h="8254">
                <a:moveTo>
                  <a:pt x="7747" y="127"/>
                </a:moveTo>
                <a:lnTo>
                  <a:pt x="6731" y="127"/>
                </a:lnTo>
                <a:lnTo>
                  <a:pt x="6731" y="254"/>
                </a:lnTo>
                <a:lnTo>
                  <a:pt x="7747" y="254"/>
                </a:lnTo>
                <a:lnTo>
                  <a:pt x="7747" y="12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6" name="object 146"/>
          <p:cNvSpPr/>
          <p:nvPr/>
        </p:nvSpPr>
        <p:spPr>
          <a:xfrm>
            <a:off x="4274743" y="4779940"/>
            <a:ext cx="774631" cy="774631"/>
          </a:xfrm>
          <a:prstGeom prst="rect">
            <a:avLst/>
          </a:prstGeom>
          <a:blipFill>
            <a:blip r:embed="rId4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7" name="object 147"/>
          <p:cNvSpPr/>
          <p:nvPr/>
        </p:nvSpPr>
        <p:spPr>
          <a:xfrm>
            <a:off x="3473876" y="4779940"/>
            <a:ext cx="773250" cy="774631"/>
          </a:xfrm>
          <a:prstGeom prst="rect">
            <a:avLst/>
          </a:prstGeom>
          <a:blipFill>
            <a:blip r:embed="rId4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8" name="object 148"/>
          <p:cNvSpPr/>
          <p:nvPr/>
        </p:nvSpPr>
        <p:spPr>
          <a:xfrm>
            <a:off x="5085276" y="4781319"/>
            <a:ext cx="774631" cy="774631"/>
          </a:xfrm>
          <a:prstGeom prst="rect">
            <a:avLst/>
          </a:prstGeom>
          <a:blipFill>
            <a:blip r:embed="rId4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9" name="object 149"/>
          <p:cNvSpPr/>
          <p:nvPr/>
        </p:nvSpPr>
        <p:spPr>
          <a:xfrm>
            <a:off x="2403752" y="4779940"/>
            <a:ext cx="1034222" cy="774631"/>
          </a:xfrm>
          <a:prstGeom prst="rect">
            <a:avLst/>
          </a:prstGeom>
          <a:blipFill>
            <a:blip r:embed="rId4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0" name="object 150"/>
          <p:cNvSpPr/>
          <p:nvPr/>
        </p:nvSpPr>
        <p:spPr>
          <a:xfrm>
            <a:off x="3336027" y="5508543"/>
            <a:ext cx="36246" cy="0"/>
          </a:xfrm>
          <a:custGeom>
            <a:avLst/>
            <a:gdLst/>
            <a:ahLst/>
            <a:cxnLst/>
            <a:rect l="l" t="t" r="r" b="b"/>
            <a:pathLst>
              <a:path w="40004">
                <a:moveTo>
                  <a:pt x="0" y="0"/>
                </a:moveTo>
                <a:lnTo>
                  <a:pt x="39497" y="0"/>
                </a:lnTo>
              </a:path>
            </a:pathLst>
          </a:custGeom>
          <a:ln w="328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1" name="object 151"/>
          <p:cNvSpPr/>
          <p:nvPr/>
        </p:nvSpPr>
        <p:spPr>
          <a:xfrm>
            <a:off x="5883382" y="4779940"/>
            <a:ext cx="771869" cy="774631"/>
          </a:xfrm>
          <a:prstGeom prst="rect">
            <a:avLst/>
          </a:prstGeom>
          <a:blipFill>
            <a:blip r:embed="rId4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2" name="object 152"/>
          <p:cNvSpPr/>
          <p:nvPr/>
        </p:nvSpPr>
        <p:spPr>
          <a:xfrm>
            <a:off x="3773511" y="5261838"/>
            <a:ext cx="247394" cy="246244"/>
          </a:xfrm>
          <a:custGeom>
            <a:avLst/>
            <a:gdLst/>
            <a:ahLst/>
            <a:cxnLst/>
            <a:rect l="l" t="t" r="r" b="b"/>
            <a:pathLst>
              <a:path w="273050" h="271779">
                <a:moveTo>
                  <a:pt x="0" y="271274"/>
                </a:moveTo>
                <a:lnTo>
                  <a:pt x="272797" y="271274"/>
                </a:lnTo>
                <a:lnTo>
                  <a:pt x="272797" y="0"/>
                </a:lnTo>
                <a:lnTo>
                  <a:pt x="0" y="0"/>
                </a:lnTo>
                <a:lnTo>
                  <a:pt x="0" y="271274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3" name="object 153"/>
          <p:cNvSpPr/>
          <p:nvPr/>
        </p:nvSpPr>
        <p:spPr>
          <a:xfrm>
            <a:off x="5246831" y="4890402"/>
            <a:ext cx="246244" cy="246244"/>
          </a:xfrm>
          <a:custGeom>
            <a:avLst/>
            <a:gdLst/>
            <a:ahLst/>
            <a:cxnLst/>
            <a:rect l="l" t="t" r="r" b="b"/>
            <a:pathLst>
              <a:path w="271779" h="271779">
                <a:moveTo>
                  <a:pt x="0" y="271274"/>
                </a:moveTo>
                <a:lnTo>
                  <a:pt x="271269" y="271274"/>
                </a:lnTo>
                <a:lnTo>
                  <a:pt x="271269" y="0"/>
                </a:lnTo>
                <a:lnTo>
                  <a:pt x="0" y="0"/>
                </a:lnTo>
                <a:lnTo>
                  <a:pt x="0" y="271274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4" name="object 154"/>
          <p:cNvSpPr/>
          <p:nvPr/>
        </p:nvSpPr>
        <p:spPr>
          <a:xfrm>
            <a:off x="2435740" y="4810202"/>
            <a:ext cx="454284" cy="99417"/>
          </a:xfrm>
          <a:prstGeom prst="rect">
            <a:avLst/>
          </a:prstGeom>
          <a:blipFill>
            <a:blip r:embed="rId3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5" name="object 155"/>
          <p:cNvSpPr txBox="1"/>
          <p:nvPr/>
        </p:nvSpPr>
        <p:spPr>
          <a:xfrm>
            <a:off x="2424809" y="4806059"/>
            <a:ext cx="450488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TE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C</a:t>
            </a:r>
            <a:r>
              <a:rPr sz="770" spc="-9" dirty="0">
                <a:solidFill>
                  <a:srgbClr val="00AF50"/>
                </a:solidFill>
                <a:latin typeface="Calibri"/>
                <a:cs typeface="Calibri"/>
              </a:rPr>
              <a:t>PR</a:t>
            </a:r>
            <a:r>
              <a:rPr sz="770" spc="-14" dirty="0">
                <a:solidFill>
                  <a:srgbClr val="00AF50"/>
                </a:solidFill>
                <a:latin typeface="Calibri"/>
                <a:cs typeface="Calibri"/>
              </a:rPr>
              <a:t>1</a:t>
            </a:r>
            <a:r>
              <a:rPr sz="770" spc="-18" dirty="0">
                <a:solidFill>
                  <a:srgbClr val="00AF50"/>
                </a:solidFill>
                <a:latin typeface="Calibri"/>
                <a:cs typeface="Calibri"/>
              </a:rPr>
              <a:t>*/</a:t>
            </a:r>
            <a:r>
              <a:rPr sz="770" dirty="0">
                <a:solidFill>
                  <a:srgbClr val="00AF50"/>
                </a:solidFill>
                <a:latin typeface="Calibri"/>
                <a:cs typeface="Calibri"/>
              </a:rPr>
              <a:t>*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156" name="object 156"/>
          <p:cNvSpPr/>
          <p:nvPr/>
        </p:nvSpPr>
        <p:spPr>
          <a:xfrm>
            <a:off x="2420553" y="5412232"/>
            <a:ext cx="158793" cy="113226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7" name="object 157"/>
          <p:cNvSpPr txBox="1"/>
          <p:nvPr/>
        </p:nvSpPr>
        <p:spPr>
          <a:xfrm>
            <a:off x="2409621" y="5409471"/>
            <a:ext cx="15821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i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58" name="object 158"/>
          <p:cNvSpPr/>
          <p:nvPr/>
        </p:nvSpPr>
        <p:spPr>
          <a:xfrm>
            <a:off x="3329123" y="5414994"/>
            <a:ext cx="323108" cy="113226"/>
          </a:xfrm>
          <a:prstGeom prst="rect">
            <a:avLst/>
          </a:prstGeom>
          <a:blipFill>
            <a:blip r:embed="rId4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9" name="object 159"/>
          <p:cNvSpPr/>
          <p:nvPr/>
        </p:nvSpPr>
        <p:spPr>
          <a:xfrm>
            <a:off x="3330043" y="5492088"/>
            <a:ext cx="9781" cy="13232"/>
          </a:xfrm>
          <a:custGeom>
            <a:avLst/>
            <a:gdLst/>
            <a:ahLst/>
            <a:cxnLst/>
            <a:rect l="l" t="t" r="r" b="b"/>
            <a:pathLst>
              <a:path w="10795" h="14604">
                <a:moveTo>
                  <a:pt x="2921" y="10033"/>
                </a:moveTo>
                <a:lnTo>
                  <a:pt x="0" y="10287"/>
                </a:lnTo>
                <a:lnTo>
                  <a:pt x="127" y="11557"/>
                </a:lnTo>
                <a:lnTo>
                  <a:pt x="635" y="12446"/>
                </a:lnTo>
                <a:lnTo>
                  <a:pt x="1524" y="13208"/>
                </a:lnTo>
                <a:lnTo>
                  <a:pt x="2540" y="13843"/>
                </a:lnTo>
                <a:lnTo>
                  <a:pt x="3683" y="14224"/>
                </a:lnTo>
                <a:lnTo>
                  <a:pt x="6858" y="14224"/>
                </a:lnTo>
                <a:lnTo>
                  <a:pt x="8255" y="13589"/>
                </a:lnTo>
                <a:lnTo>
                  <a:pt x="9271" y="12319"/>
                </a:lnTo>
                <a:lnTo>
                  <a:pt x="9488" y="12065"/>
                </a:lnTo>
                <a:lnTo>
                  <a:pt x="4572" y="12065"/>
                </a:lnTo>
                <a:lnTo>
                  <a:pt x="4064" y="11811"/>
                </a:lnTo>
                <a:lnTo>
                  <a:pt x="3683" y="11557"/>
                </a:lnTo>
                <a:lnTo>
                  <a:pt x="3302" y="11176"/>
                </a:lnTo>
                <a:lnTo>
                  <a:pt x="3048" y="10668"/>
                </a:lnTo>
                <a:lnTo>
                  <a:pt x="2921" y="10033"/>
                </a:lnTo>
                <a:close/>
              </a:path>
              <a:path w="10795" h="14604">
                <a:moveTo>
                  <a:pt x="9887" y="6604"/>
                </a:moveTo>
                <a:lnTo>
                  <a:pt x="5715" y="6604"/>
                </a:lnTo>
                <a:lnTo>
                  <a:pt x="6350" y="6858"/>
                </a:lnTo>
                <a:lnTo>
                  <a:pt x="6731" y="7239"/>
                </a:lnTo>
                <a:lnTo>
                  <a:pt x="7112" y="7747"/>
                </a:lnTo>
                <a:lnTo>
                  <a:pt x="7366" y="8382"/>
                </a:lnTo>
                <a:lnTo>
                  <a:pt x="7366" y="10160"/>
                </a:lnTo>
                <a:lnTo>
                  <a:pt x="7112" y="10922"/>
                </a:lnTo>
                <a:lnTo>
                  <a:pt x="6731" y="11303"/>
                </a:lnTo>
                <a:lnTo>
                  <a:pt x="6350" y="11811"/>
                </a:lnTo>
                <a:lnTo>
                  <a:pt x="5715" y="12065"/>
                </a:lnTo>
                <a:lnTo>
                  <a:pt x="9488" y="12065"/>
                </a:lnTo>
                <a:lnTo>
                  <a:pt x="10033" y="11430"/>
                </a:lnTo>
                <a:lnTo>
                  <a:pt x="10414" y="10414"/>
                </a:lnTo>
                <a:lnTo>
                  <a:pt x="10414" y="7874"/>
                </a:lnTo>
                <a:lnTo>
                  <a:pt x="10033" y="6731"/>
                </a:lnTo>
                <a:lnTo>
                  <a:pt x="9887" y="6604"/>
                </a:lnTo>
                <a:close/>
              </a:path>
              <a:path w="10795" h="14604">
                <a:moveTo>
                  <a:pt x="9779" y="0"/>
                </a:moveTo>
                <a:lnTo>
                  <a:pt x="1905" y="0"/>
                </a:lnTo>
                <a:lnTo>
                  <a:pt x="254" y="7366"/>
                </a:lnTo>
                <a:lnTo>
                  <a:pt x="2794" y="7620"/>
                </a:lnTo>
                <a:lnTo>
                  <a:pt x="3429" y="6985"/>
                </a:lnTo>
                <a:lnTo>
                  <a:pt x="4191" y="6604"/>
                </a:lnTo>
                <a:lnTo>
                  <a:pt x="9887" y="6604"/>
                </a:lnTo>
                <a:lnTo>
                  <a:pt x="9017" y="5842"/>
                </a:lnTo>
                <a:lnTo>
                  <a:pt x="8128" y="4953"/>
                </a:lnTo>
                <a:lnTo>
                  <a:pt x="3683" y="4953"/>
                </a:lnTo>
                <a:lnTo>
                  <a:pt x="4064" y="2540"/>
                </a:lnTo>
                <a:lnTo>
                  <a:pt x="9779" y="2540"/>
                </a:lnTo>
                <a:lnTo>
                  <a:pt x="9779" y="0"/>
                </a:lnTo>
                <a:close/>
              </a:path>
              <a:path w="10795" h="14604">
                <a:moveTo>
                  <a:pt x="6985" y="4445"/>
                </a:moveTo>
                <a:lnTo>
                  <a:pt x="4953" y="4445"/>
                </a:lnTo>
                <a:lnTo>
                  <a:pt x="4318" y="4572"/>
                </a:lnTo>
                <a:lnTo>
                  <a:pt x="3683" y="4953"/>
                </a:lnTo>
                <a:lnTo>
                  <a:pt x="8128" y="4953"/>
                </a:lnTo>
                <a:lnTo>
                  <a:pt x="6985" y="4445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0" name="object 160"/>
          <p:cNvSpPr/>
          <p:nvPr/>
        </p:nvSpPr>
        <p:spPr>
          <a:xfrm>
            <a:off x="3346727" y="5495195"/>
            <a:ext cx="23588" cy="13232"/>
          </a:xfrm>
          <a:custGeom>
            <a:avLst/>
            <a:gdLst/>
            <a:ahLst/>
            <a:cxnLst/>
            <a:rect l="l" t="t" r="r" b="b"/>
            <a:pathLst>
              <a:path w="26035" h="14604">
                <a:moveTo>
                  <a:pt x="3048" y="254"/>
                </a:moveTo>
                <a:lnTo>
                  <a:pt x="0" y="254"/>
                </a:lnTo>
                <a:lnTo>
                  <a:pt x="0" y="14478"/>
                </a:lnTo>
                <a:lnTo>
                  <a:pt x="3048" y="14478"/>
                </a:lnTo>
                <a:lnTo>
                  <a:pt x="3048" y="9271"/>
                </a:lnTo>
                <a:lnTo>
                  <a:pt x="9398" y="9271"/>
                </a:lnTo>
                <a:lnTo>
                  <a:pt x="9398" y="8636"/>
                </a:lnTo>
                <a:lnTo>
                  <a:pt x="4445" y="8636"/>
                </a:lnTo>
                <a:lnTo>
                  <a:pt x="3810" y="8255"/>
                </a:lnTo>
                <a:lnTo>
                  <a:pt x="3429" y="7620"/>
                </a:lnTo>
                <a:lnTo>
                  <a:pt x="3175" y="7112"/>
                </a:lnTo>
                <a:lnTo>
                  <a:pt x="3048" y="6223"/>
                </a:lnTo>
                <a:lnTo>
                  <a:pt x="3048" y="254"/>
                </a:lnTo>
                <a:close/>
              </a:path>
              <a:path w="26035" h="14604">
                <a:moveTo>
                  <a:pt x="7493" y="9271"/>
                </a:moveTo>
                <a:lnTo>
                  <a:pt x="3048" y="9271"/>
                </a:lnTo>
                <a:lnTo>
                  <a:pt x="3302" y="9906"/>
                </a:lnTo>
                <a:lnTo>
                  <a:pt x="3683" y="10287"/>
                </a:lnTo>
                <a:lnTo>
                  <a:pt x="3937" y="10414"/>
                </a:lnTo>
                <a:lnTo>
                  <a:pt x="4318" y="10668"/>
                </a:lnTo>
                <a:lnTo>
                  <a:pt x="4699" y="10795"/>
                </a:lnTo>
                <a:lnTo>
                  <a:pt x="5588" y="10795"/>
                </a:lnTo>
                <a:lnTo>
                  <a:pt x="6096" y="10541"/>
                </a:lnTo>
                <a:lnTo>
                  <a:pt x="6477" y="10414"/>
                </a:lnTo>
                <a:lnTo>
                  <a:pt x="6985" y="10160"/>
                </a:lnTo>
                <a:lnTo>
                  <a:pt x="7112" y="9906"/>
                </a:lnTo>
                <a:lnTo>
                  <a:pt x="7366" y="9652"/>
                </a:lnTo>
                <a:lnTo>
                  <a:pt x="7493" y="9271"/>
                </a:lnTo>
                <a:close/>
              </a:path>
              <a:path w="26035" h="14604">
                <a:moveTo>
                  <a:pt x="9398" y="9271"/>
                </a:moveTo>
                <a:lnTo>
                  <a:pt x="7493" y="9271"/>
                </a:lnTo>
                <a:lnTo>
                  <a:pt x="7493" y="10541"/>
                </a:lnTo>
                <a:lnTo>
                  <a:pt x="9398" y="10541"/>
                </a:lnTo>
                <a:lnTo>
                  <a:pt x="9398" y="9271"/>
                </a:lnTo>
                <a:close/>
              </a:path>
              <a:path w="26035" h="14604">
                <a:moveTo>
                  <a:pt x="10287" y="254"/>
                </a:moveTo>
                <a:lnTo>
                  <a:pt x="9398" y="254"/>
                </a:lnTo>
                <a:lnTo>
                  <a:pt x="9398" y="10541"/>
                </a:lnTo>
                <a:lnTo>
                  <a:pt x="10287" y="10541"/>
                </a:lnTo>
                <a:lnTo>
                  <a:pt x="10287" y="254"/>
                </a:lnTo>
                <a:close/>
              </a:path>
              <a:path w="26035" h="14604">
                <a:moveTo>
                  <a:pt x="12065" y="254"/>
                </a:moveTo>
                <a:lnTo>
                  <a:pt x="10287" y="254"/>
                </a:lnTo>
                <a:lnTo>
                  <a:pt x="10287" y="10541"/>
                </a:lnTo>
                <a:lnTo>
                  <a:pt x="12319" y="10541"/>
                </a:lnTo>
                <a:lnTo>
                  <a:pt x="12319" y="4572"/>
                </a:lnTo>
                <a:lnTo>
                  <a:pt x="12446" y="3810"/>
                </a:lnTo>
                <a:lnTo>
                  <a:pt x="12700" y="3048"/>
                </a:lnTo>
                <a:lnTo>
                  <a:pt x="12954" y="2667"/>
                </a:lnTo>
                <a:lnTo>
                  <a:pt x="13335" y="2413"/>
                </a:lnTo>
                <a:lnTo>
                  <a:pt x="14097" y="2159"/>
                </a:lnTo>
                <a:lnTo>
                  <a:pt x="25823" y="2159"/>
                </a:lnTo>
                <a:lnTo>
                  <a:pt x="25654" y="1905"/>
                </a:lnTo>
                <a:lnTo>
                  <a:pt x="25552" y="1651"/>
                </a:lnTo>
                <a:lnTo>
                  <a:pt x="12065" y="1651"/>
                </a:lnTo>
                <a:lnTo>
                  <a:pt x="12065" y="254"/>
                </a:lnTo>
                <a:close/>
              </a:path>
              <a:path w="26035" h="14604">
                <a:moveTo>
                  <a:pt x="20955" y="2159"/>
                </a:moveTo>
                <a:lnTo>
                  <a:pt x="15240" y="2159"/>
                </a:lnTo>
                <a:lnTo>
                  <a:pt x="15748" y="2413"/>
                </a:lnTo>
                <a:lnTo>
                  <a:pt x="16002" y="2921"/>
                </a:lnTo>
                <a:lnTo>
                  <a:pt x="16129" y="3302"/>
                </a:lnTo>
                <a:lnTo>
                  <a:pt x="16129" y="10541"/>
                </a:lnTo>
                <a:lnTo>
                  <a:pt x="19177" y="10541"/>
                </a:lnTo>
                <a:lnTo>
                  <a:pt x="19177" y="4699"/>
                </a:lnTo>
                <a:lnTo>
                  <a:pt x="19304" y="3937"/>
                </a:lnTo>
                <a:lnTo>
                  <a:pt x="19431" y="3429"/>
                </a:lnTo>
                <a:lnTo>
                  <a:pt x="19558" y="3048"/>
                </a:lnTo>
                <a:lnTo>
                  <a:pt x="19812" y="2667"/>
                </a:lnTo>
                <a:lnTo>
                  <a:pt x="20193" y="2413"/>
                </a:lnTo>
                <a:lnTo>
                  <a:pt x="20955" y="2159"/>
                </a:lnTo>
                <a:close/>
              </a:path>
              <a:path w="26035" h="14604">
                <a:moveTo>
                  <a:pt x="25823" y="2159"/>
                </a:moveTo>
                <a:lnTo>
                  <a:pt x="21971" y="2159"/>
                </a:lnTo>
                <a:lnTo>
                  <a:pt x="22352" y="2286"/>
                </a:lnTo>
                <a:lnTo>
                  <a:pt x="22860" y="3048"/>
                </a:lnTo>
                <a:lnTo>
                  <a:pt x="22987" y="3683"/>
                </a:lnTo>
                <a:lnTo>
                  <a:pt x="22987" y="10541"/>
                </a:lnTo>
                <a:lnTo>
                  <a:pt x="25908" y="10541"/>
                </a:lnTo>
                <a:lnTo>
                  <a:pt x="25908" y="2286"/>
                </a:lnTo>
                <a:lnTo>
                  <a:pt x="25823" y="2159"/>
                </a:lnTo>
                <a:close/>
              </a:path>
              <a:path w="26035" h="14604">
                <a:moveTo>
                  <a:pt x="9398" y="254"/>
                </a:moveTo>
                <a:lnTo>
                  <a:pt x="7239" y="254"/>
                </a:lnTo>
                <a:lnTo>
                  <a:pt x="7239" y="6858"/>
                </a:lnTo>
                <a:lnTo>
                  <a:pt x="6985" y="7239"/>
                </a:lnTo>
                <a:lnTo>
                  <a:pt x="6858" y="7747"/>
                </a:lnTo>
                <a:lnTo>
                  <a:pt x="6604" y="8001"/>
                </a:lnTo>
                <a:lnTo>
                  <a:pt x="5842" y="8509"/>
                </a:lnTo>
                <a:lnTo>
                  <a:pt x="5461" y="8636"/>
                </a:lnTo>
                <a:lnTo>
                  <a:pt x="9398" y="8636"/>
                </a:lnTo>
                <a:lnTo>
                  <a:pt x="9398" y="254"/>
                </a:lnTo>
                <a:close/>
              </a:path>
              <a:path w="26035" h="14604">
                <a:moveTo>
                  <a:pt x="16383" y="0"/>
                </a:moveTo>
                <a:lnTo>
                  <a:pt x="14224" y="0"/>
                </a:lnTo>
                <a:lnTo>
                  <a:pt x="13081" y="635"/>
                </a:lnTo>
                <a:lnTo>
                  <a:pt x="12065" y="1651"/>
                </a:lnTo>
                <a:lnTo>
                  <a:pt x="18796" y="1651"/>
                </a:lnTo>
                <a:lnTo>
                  <a:pt x="16383" y="0"/>
                </a:lnTo>
                <a:close/>
              </a:path>
              <a:path w="26035" h="14604">
                <a:moveTo>
                  <a:pt x="23114" y="0"/>
                </a:moveTo>
                <a:lnTo>
                  <a:pt x="21590" y="0"/>
                </a:lnTo>
                <a:lnTo>
                  <a:pt x="20955" y="127"/>
                </a:lnTo>
                <a:lnTo>
                  <a:pt x="20447" y="381"/>
                </a:lnTo>
                <a:lnTo>
                  <a:pt x="19812" y="762"/>
                </a:lnTo>
                <a:lnTo>
                  <a:pt x="19304" y="1143"/>
                </a:lnTo>
                <a:lnTo>
                  <a:pt x="18796" y="1651"/>
                </a:lnTo>
                <a:lnTo>
                  <a:pt x="25552" y="1651"/>
                </a:lnTo>
                <a:lnTo>
                  <a:pt x="25400" y="1270"/>
                </a:lnTo>
                <a:lnTo>
                  <a:pt x="24892" y="762"/>
                </a:lnTo>
                <a:lnTo>
                  <a:pt x="24384" y="508"/>
                </a:lnTo>
                <a:lnTo>
                  <a:pt x="23749" y="127"/>
                </a:lnTo>
                <a:lnTo>
                  <a:pt x="23114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1" name="object 161"/>
          <p:cNvSpPr/>
          <p:nvPr/>
        </p:nvSpPr>
        <p:spPr>
          <a:xfrm>
            <a:off x="3502642" y="5423624"/>
            <a:ext cx="131178" cy="94354"/>
          </a:xfrm>
          <a:custGeom>
            <a:avLst/>
            <a:gdLst/>
            <a:ahLst/>
            <a:cxnLst/>
            <a:rect l="l" t="t" r="r" b="b"/>
            <a:pathLst>
              <a:path w="144779" h="104139">
                <a:moveTo>
                  <a:pt x="21209" y="103632"/>
                </a:moveTo>
                <a:lnTo>
                  <a:pt x="17272" y="103632"/>
                </a:lnTo>
                <a:lnTo>
                  <a:pt x="17780" y="103759"/>
                </a:lnTo>
                <a:lnTo>
                  <a:pt x="20320" y="103759"/>
                </a:lnTo>
                <a:lnTo>
                  <a:pt x="21209" y="103632"/>
                </a:lnTo>
                <a:close/>
              </a:path>
              <a:path w="144779" h="104139">
                <a:moveTo>
                  <a:pt x="20193" y="0"/>
                </a:moveTo>
                <a:lnTo>
                  <a:pt x="17399" y="0"/>
                </a:lnTo>
                <a:lnTo>
                  <a:pt x="16891" y="127"/>
                </a:lnTo>
                <a:lnTo>
                  <a:pt x="16256" y="127"/>
                </a:lnTo>
                <a:lnTo>
                  <a:pt x="1016" y="38735"/>
                </a:lnTo>
                <a:lnTo>
                  <a:pt x="254" y="43053"/>
                </a:lnTo>
                <a:lnTo>
                  <a:pt x="0" y="47498"/>
                </a:lnTo>
                <a:lnTo>
                  <a:pt x="0" y="56261"/>
                </a:lnTo>
                <a:lnTo>
                  <a:pt x="8001" y="90297"/>
                </a:lnTo>
                <a:lnTo>
                  <a:pt x="9779" y="94488"/>
                </a:lnTo>
                <a:lnTo>
                  <a:pt x="11811" y="98425"/>
                </a:lnTo>
                <a:lnTo>
                  <a:pt x="14224" y="102489"/>
                </a:lnTo>
                <a:lnTo>
                  <a:pt x="14351" y="102743"/>
                </a:lnTo>
                <a:lnTo>
                  <a:pt x="14478" y="102870"/>
                </a:lnTo>
                <a:lnTo>
                  <a:pt x="14986" y="103124"/>
                </a:lnTo>
                <a:lnTo>
                  <a:pt x="16129" y="103505"/>
                </a:lnTo>
                <a:lnTo>
                  <a:pt x="16637" y="103632"/>
                </a:lnTo>
                <a:lnTo>
                  <a:pt x="21844" y="103632"/>
                </a:lnTo>
                <a:lnTo>
                  <a:pt x="22860" y="103378"/>
                </a:lnTo>
                <a:lnTo>
                  <a:pt x="23241" y="103124"/>
                </a:lnTo>
                <a:lnTo>
                  <a:pt x="23495" y="102870"/>
                </a:lnTo>
                <a:lnTo>
                  <a:pt x="23622" y="102616"/>
                </a:lnTo>
                <a:lnTo>
                  <a:pt x="23622" y="101981"/>
                </a:lnTo>
                <a:lnTo>
                  <a:pt x="23495" y="101600"/>
                </a:lnTo>
                <a:lnTo>
                  <a:pt x="22935" y="100466"/>
                </a:lnTo>
                <a:lnTo>
                  <a:pt x="17962" y="88661"/>
                </a:lnTo>
                <a:lnTo>
                  <a:pt x="14319" y="76586"/>
                </a:lnTo>
                <a:lnTo>
                  <a:pt x="11946" y="64145"/>
                </a:lnTo>
                <a:lnTo>
                  <a:pt x="11176" y="51380"/>
                </a:lnTo>
                <a:lnTo>
                  <a:pt x="11972" y="38913"/>
                </a:lnTo>
                <a:lnTo>
                  <a:pt x="14348" y="26170"/>
                </a:lnTo>
                <a:lnTo>
                  <a:pt x="18126" y="14153"/>
                </a:lnTo>
                <a:lnTo>
                  <a:pt x="23368" y="2413"/>
                </a:lnTo>
                <a:lnTo>
                  <a:pt x="23495" y="2032"/>
                </a:lnTo>
                <a:lnTo>
                  <a:pt x="23622" y="1778"/>
                </a:lnTo>
                <a:lnTo>
                  <a:pt x="23622" y="1397"/>
                </a:lnTo>
                <a:lnTo>
                  <a:pt x="23368" y="889"/>
                </a:lnTo>
                <a:lnTo>
                  <a:pt x="22987" y="635"/>
                </a:lnTo>
                <a:lnTo>
                  <a:pt x="22606" y="508"/>
                </a:lnTo>
                <a:lnTo>
                  <a:pt x="22225" y="254"/>
                </a:lnTo>
                <a:lnTo>
                  <a:pt x="21590" y="254"/>
                </a:lnTo>
                <a:lnTo>
                  <a:pt x="20955" y="127"/>
                </a:lnTo>
                <a:lnTo>
                  <a:pt x="20193" y="0"/>
                </a:lnTo>
                <a:close/>
              </a:path>
              <a:path w="144779" h="104139">
                <a:moveTo>
                  <a:pt x="45085" y="83693"/>
                </a:moveTo>
                <a:lnTo>
                  <a:pt x="41275" y="83693"/>
                </a:lnTo>
                <a:lnTo>
                  <a:pt x="42164" y="83820"/>
                </a:lnTo>
                <a:lnTo>
                  <a:pt x="44196" y="83820"/>
                </a:lnTo>
                <a:lnTo>
                  <a:pt x="45085" y="83693"/>
                </a:lnTo>
                <a:close/>
              </a:path>
              <a:path w="144779" h="104139">
                <a:moveTo>
                  <a:pt x="45847" y="27305"/>
                </a:moveTo>
                <a:lnTo>
                  <a:pt x="40513" y="27305"/>
                </a:lnTo>
                <a:lnTo>
                  <a:pt x="39878" y="27432"/>
                </a:lnTo>
                <a:lnTo>
                  <a:pt x="38862" y="27686"/>
                </a:lnTo>
                <a:lnTo>
                  <a:pt x="38481" y="27813"/>
                </a:lnTo>
                <a:lnTo>
                  <a:pt x="38227" y="28067"/>
                </a:lnTo>
                <a:lnTo>
                  <a:pt x="38100" y="28321"/>
                </a:lnTo>
                <a:lnTo>
                  <a:pt x="37846" y="28575"/>
                </a:lnTo>
                <a:lnTo>
                  <a:pt x="37846" y="82550"/>
                </a:lnTo>
                <a:lnTo>
                  <a:pt x="38481" y="83185"/>
                </a:lnTo>
                <a:lnTo>
                  <a:pt x="38862" y="83312"/>
                </a:lnTo>
                <a:lnTo>
                  <a:pt x="39878" y="83566"/>
                </a:lnTo>
                <a:lnTo>
                  <a:pt x="40513" y="83693"/>
                </a:lnTo>
                <a:lnTo>
                  <a:pt x="45847" y="83693"/>
                </a:lnTo>
                <a:lnTo>
                  <a:pt x="48514" y="82296"/>
                </a:lnTo>
                <a:lnTo>
                  <a:pt x="48514" y="28829"/>
                </a:lnTo>
                <a:lnTo>
                  <a:pt x="48133" y="28067"/>
                </a:lnTo>
                <a:lnTo>
                  <a:pt x="47752" y="27813"/>
                </a:lnTo>
                <a:lnTo>
                  <a:pt x="46990" y="27559"/>
                </a:lnTo>
                <a:lnTo>
                  <a:pt x="46482" y="27432"/>
                </a:lnTo>
                <a:lnTo>
                  <a:pt x="45847" y="27305"/>
                </a:lnTo>
                <a:close/>
              </a:path>
              <a:path w="144779" h="104139">
                <a:moveTo>
                  <a:pt x="44196" y="27178"/>
                </a:moveTo>
                <a:lnTo>
                  <a:pt x="42164" y="27178"/>
                </a:lnTo>
                <a:lnTo>
                  <a:pt x="41275" y="27305"/>
                </a:lnTo>
                <a:lnTo>
                  <a:pt x="45085" y="27305"/>
                </a:lnTo>
                <a:lnTo>
                  <a:pt x="44196" y="27178"/>
                </a:lnTo>
                <a:close/>
              </a:path>
              <a:path w="144779" h="104139">
                <a:moveTo>
                  <a:pt x="45720" y="5461"/>
                </a:moveTo>
                <a:lnTo>
                  <a:pt x="40640" y="5461"/>
                </a:lnTo>
                <a:lnTo>
                  <a:pt x="38862" y="5842"/>
                </a:lnTo>
                <a:lnTo>
                  <a:pt x="37973" y="6604"/>
                </a:lnTo>
                <a:lnTo>
                  <a:pt x="36957" y="7493"/>
                </a:lnTo>
                <a:lnTo>
                  <a:pt x="36576" y="9017"/>
                </a:lnTo>
                <a:lnTo>
                  <a:pt x="36576" y="13589"/>
                </a:lnTo>
                <a:lnTo>
                  <a:pt x="36957" y="15113"/>
                </a:lnTo>
                <a:lnTo>
                  <a:pt x="37973" y="15875"/>
                </a:lnTo>
                <a:lnTo>
                  <a:pt x="38862" y="16637"/>
                </a:lnTo>
                <a:lnTo>
                  <a:pt x="40513" y="17018"/>
                </a:lnTo>
                <a:lnTo>
                  <a:pt x="45593" y="17018"/>
                </a:lnTo>
                <a:lnTo>
                  <a:pt x="47371" y="16637"/>
                </a:lnTo>
                <a:lnTo>
                  <a:pt x="48260" y="15875"/>
                </a:lnTo>
                <a:lnTo>
                  <a:pt x="49276" y="14986"/>
                </a:lnTo>
                <a:lnTo>
                  <a:pt x="49784" y="13462"/>
                </a:lnTo>
                <a:lnTo>
                  <a:pt x="49784" y="9017"/>
                </a:lnTo>
                <a:lnTo>
                  <a:pt x="49276" y="7493"/>
                </a:lnTo>
                <a:lnTo>
                  <a:pt x="48387" y="6604"/>
                </a:lnTo>
                <a:lnTo>
                  <a:pt x="47371" y="5842"/>
                </a:lnTo>
                <a:lnTo>
                  <a:pt x="45720" y="5461"/>
                </a:lnTo>
                <a:close/>
              </a:path>
              <a:path w="144779" h="104139">
                <a:moveTo>
                  <a:pt x="88519" y="83693"/>
                </a:moveTo>
                <a:lnTo>
                  <a:pt x="82931" y="83693"/>
                </a:lnTo>
                <a:lnTo>
                  <a:pt x="84074" y="83820"/>
                </a:lnTo>
                <a:lnTo>
                  <a:pt x="87630" y="83820"/>
                </a:lnTo>
                <a:lnTo>
                  <a:pt x="88519" y="83693"/>
                </a:lnTo>
                <a:close/>
              </a:path>
              <a:path w="144779" h="104139">
                <a:moveTo>
                  <a:pt x="65786" y="27305"/>
                </a:moveTo>
                <a:lnTo>
                  <a:pt x="59690" y="27305"/>
                </a:lnTo>
                <a:lnTo>
                  <a:pt x="59055" y="27432"/>
                </a:lnTo>
                <a:lnTo>
                  <a:pt x="58293" y="27686"/>
                </a:lnTo>
                <a:lnTo>
                  <a:pt x="58039" y="27940"/>
                </a:lnTo>
                <a:lnTo>
                  <a:pt x="57785" y="28067"/>
                </a:lnTo>
                <a:lnTo>
                  <a:pt x="57531" y="28575"/>
                </a:lnTo>
                <a:lnTo>
                  <a:pt x="57531" y="29210"/>
                </a:lnTo>
                <a:lnTo>
                  <a:pt x="57658" y="29337"/>
                </a:lnTo>
                <a:lnTo>
                  <a:pt x="57658" y="29845"/>
                </a:lnTo>
                <a:lnTo>
                  <a:pt x="57785" y="30226"/>
                </a:lnTo>
                <a:lnTo>
                  <a:pt x="57912" y="30480"/>
                </a:lnTo>
                <a:lnTo>
                  <a:pt x="58039" y="30988"/>
                </a:lnTo>
                <a:lnTo>
                  <a:pt x="58166" y="31369"/>
                </a:lnTo>
                <a:lnTo>
                  <a:pt x="77978" y="81661"/>
                </a:lnTo>
                <a:lnTo>
                  <a:pt x="78232" y="82042"/>
                </a:lnTo>
                <a:lnTo>
                  <a:pt x="78359" y="82423"/>
                </a:lnTo>
                <a:lnTo>
                  <a:pt x="78740" y="82677"/>
                </a:lnTo>
                <a:lnTo>
                  <a:pt x="78994" y="82931"/>
                </a:lnTo>
                <a:lnTo>
                  <a:pt x="79375" y="83185"/>
                </a:lnTo>
                <a:lnTo>
                  <a:pt x="80010" y="83312"/>
                </a:lnTo>
                <a:lnTo>
                  <a:pt x="80518" y="83439"/>
                </a:lnTo>
                <a:lnTo>
                  <a:pt x="81153" y="83566"/>
                </a:lnTo>
                <a:lnTo>
                  <a:pt x="82042" y="83693"/>
                </a:lnTo>
                <a:lnTo>
                  <a:pt x="89408" y="83693"/>
                </a:lnTo>
                <a:lnTo>
                  <a:pt x="90170" y="83566"/>
                </a:lnTo>
                <a:lnTo>
                  <a:pt x="90678" y="83439"/>
                </a:lnTo>
                <a:lnTo>
                  <a:pt x="91186" y="83185"/>
                </a:lnTo>
                <a:lnTo>
                  <a:pt x="91694" y="83058"/>
                </a:lnTo>
                <a:lnTo>
                  <a:pt x="91948" y="82677"/>
                </a:lnTo>
                <a:lnTo>
                  <a:pt x="92456" y="82169"/>
                </a:lnTo>
                <a:lnTo>
                  <a:pt x="92583" y="81661"/>
                </a:lnTo>
                <a:lnTo>
                  <a:pt x="95855" y="73406"/>
                </a:lnTo>
                <a:lnTo>
                  <a:pt x="85725" y="73406"/>
                </a:lnTo>
                <a:lnTo>
                  <a:pt x="85471" y="72771"/>
                </a:lnTo>
                <a:lnTo>
                  <a:pt x="68961" y="29083"/>
                </a:lnTo>
                <a:lnTo>
                  <a:pt x="68834" y="28829"/>
                </a:lnTo>
                <a:lnTo>
                  <a:pt x="68707" y="28448"/>
                </a:lnTo>
                <a:lnTo>
                  <a:pt x="68453" y="28194"/>
                </a:lnTo>
                <a:lnTo>
                  <a:pt x="68326" y="27940"/>
                </a:lnTo>
                <a:lnTo>
                  <a:pt x="67564" y="27686"/>
                </a:lnTo>
                <a:lnTo>
                  <a:pt x="67183" y="27432"/>
                </a:lnTo>
                <a:lnTo>
                  <a:pt x="66548" y="27432"/>
                </a:lnTo>
                <a:lnTo>
                  <a:pt x="65786" y="27305"/>
                </a:lnTo>
                <a:close/>
              </a:path>
              <a:path w="144779" h="104139">
                <a:moveTo>
                  <a:pt x="111125" y="27305"/>
                </a:moveTo>
                <a:lnTo>
                  <a:pt x="105156" y="27305"/>
                </a:lnTo>
                <a:lnTo>
                  <a:pt x="104521" y="27432"/>
                </a:lnTo>
                <a:lnTo>
                  <a:pt x="103886" y="27432"/>
                </a:lnTo>
                <a:lnTo>
                  <a:pt x="103505" y="27686"/>
                </a:lnTo>
                <a:lnTo>
                  <a:pt x="102743" y="27940"/>
                </a:lnTo>
                <a:lnTo>
                  <a:pt x="102616" y="28194"/>
                </a:lnTo>
                <a:lnTo>
                  <a:pt x="102362" y="28448"/>
                </a:lnTo>
                <a:lnTo>
                  <a:pt x="102235" y="28829"/>
                </a:lnTo>
                <a:lnTo>
                  <a:pt x="102108" y="29083"/>
                </a:lnTo>
                <a:lnTo>
                  <a:pt x="85852" y="72771"/>
                </a:lnTo>
                <a:lnTo>
                  <a:pt x="85725" y="73406"/>
                </a:lnTo>
                <a:lnTo>
                  <a:pt x="95855" y="73406"/>
                </a:lnTo>
                <a:lnTo>
                  <a:pt x="112522" y="31369"/>
                </a:lnTo>
                <a:lnTo>
                  <a:pt x="112522" y="31115"/>
                </a:lnTo>
                <a:lnTo>
                  <a:pt x="112649" y="30861"/>
                </a:lnTo>
                <a:lnTo>
                  <a:pt x="112649" y="30607"/>
                </a:lnTo>
                <a:lnTo>
                  <a:pt x="112776" y="30353"/>
                </a:lnTo>
                <a:lnTo>
                  <a:pt x="112776" y="30226"/>
                </a:lnTo>
                <a:lnTo>
                  <a:pt x="112903" y="29972"/>
                </a:lnTo>
                <a:lnTo>
                  <a:pt x="112903" y="29464"/>
                </a:lnTo>
                <a:lnTo>
                  <a:pt x="113030" y="29210"/>
                </a:lnTo>
                <a:lnTo>
                  <a:pt x="113030" y="28575"/>
                </a:lnTo>
                <a:lnTo>
                  <a:pt x="112903" y="28321"/>
                </a:lnTo>
                <a:lnTo>
                  <a:pt x="112776" y="28194"/>
                </a:lnTo>
                <a:lnTo>
                  <a:pt x="112649" y="27940"/>
                </a:lnTo>
                <a:lnTo>
                  <a:pt x="112395" y="27686"/>
                </a:lnTo>
                <a:lnTo>
                  <a:pt x="111633" y="27432"/>
                </a:lnTo>
                <a:lnTo>
                  <a:pt x="111125" y="27305"/>
                </a:lnTo>
                <a:close/>
              </a:path>
              <a:path w="144779" h="104139">
                <a:moveTo>
                  <a:pt x="64008" y="27178"/>
                </a:moveTo>
                <a:lnTo>
                  <a:pt x="61849" y="27178"/>
                </a:lnTo>
                <a:lnTo>
                  <a:pt x="60960" y="27305"/>
                </a:lnTo>
                <a:lnTo>
                  <a:pt x="65024" y="27305"/>
                </a:lnTo>
                <a:lnTo>
                  <a:pt x="64008" y="27178"/>
                </a:lnTo>
                <a:close/>
              </a:path>
              <a:path w="144779" h="104139">
                <a:moveTo>
                  <a:pt x="108966" y="27178"/>
                </a:moveTo>
                <a:lnTo>
                  <a:pt x="106807" y="27178"/>
                </a:lnTo>
                <a:lnTo>
                  <a:pt x="105918" y="27305"/>
                </a:lnTo>
                <a:lnTo>
                  <a:pt x="109855" y="27305"/>
                </a:lnTo>
                <a:lnTo>
                  <a:pt x="108966" y="27178"/>
                </a:lnTo>
                <a:close/>
              </a:path>
              <a:path w="144779" h="104139">
                <a:moveTo>
                  <a:pt x="127635" y="103632"/>
                </a:moveTo>
                <a:lnTo>
                  <a:pt x="123571" y="103632"/>
                </a:lnTo>
                <a:lnTo>
                  <a:pt x="124460" y="103759"/>
                </a:lnTo>
                <a:lnTo>
                  <a:pt x="127000" y="103759"/>
                </a:lnTo>
                <a:lnTo>
                  <a:pt x="127635" y="103632"/>
                </a:lnTo>
                <a:close/>
              </a:path>
              <a:path w="144779" h="104139">
                <a:moveTo>
                  <a:pt x="127254" y="0"/>
                </a:moveTo>
                <a:lnTo>
                  <a:pt x="124587" y="0"/>
                </a:lnTo>
                <a:lnTo>
                  <a:pt x="123825" y="127"/>
                </a:lnTo>
                <a:lnTo>
                  <a:pt x="123190" y="254"/>
                </a:lnTo>
                <a:lnTo>
                  <a:pt x="122682" y="254"/>
                </a:lnTo>
                <a:lnTo>
                  <a:pt x="122174" y="508"/>
                </a:lnTo>
                <a:lnTo>
                  <a:pt x="121793" y="635"/>
                </a:lnTo>
                <a:lnTo>
                  <a:pt x="121412" y="889"/>
                </a:lnTo>
                <a:lnTo>
                  <a:pt x="121285" y="1143"/>
                </a:lnTo>
                <a:lnTo>
                  <a:pt x="121285" y="1397"/>
                </a:lnTo>
                <a:lnTo>
                  <a:pt x="121158" y="1778"/>
                </a:lnTo>
                <a:lnTo>
                  <a:pt x="132852" y="39272"/>
                </a:lnTo>
                <a:lnTo>
                  <a:pt x="133603" y="52073"/>
                </a:lnTo>
                <a:lnTo>
                  <a:pt x="132799" y="64513"/>
                </a:lnTo>
                <a:lnTo>
                  <a:pt x="130414" y="77285"/>
                </a:lnTo>
                <a:lnTo>
                  <a:pt x="126657" y="89370"/>
                </a:lnTo>
                <a:lnTo>
                  <a:pt x="121539" y="101092"/>
                </a:lnTo>
                <a:lnTo>
                  <a:pt x="121285" y="101600"/>
                </a:lnTo>
                <a:lnTo>
                  <a:pt x="121285" y="101981"/>
                </a:lnTo>
                <a:lnTo>
                  <a:pt x="121158" y="102235"/>
                </a:lnTo>
                <a:lnTo>
                  <a:pt x="121158" y="102616"/>
                </a:lnTo>
                <a:lnTo>
                  <a:pt x="122936" y="103632"/>
                </a:lnTo>
                <a:lnTo>
                  <a:pt x="128143" y="103632"/>
                </a:lnTo>
                <a:lnTo>
                  <a:pt x="130556" y="102489"/>
                </a:lnTo>
                <a:lnTo>
                  <a:pt x="132969" y="98425"/>
                </a:lnTo>
                <a:lnTo>
                  <a:pt x="141097" y="77851"/>
                </a:lnTo>
                <a:lnTo>
                  <a:pt x="142367" y="73660"/>
                </a:lnTo>
                <a:lnTo>
                  <a:pt x="143256" y="69342"/>
                </a:lnTo>
                <a:lnTo>
                  <a:pt x="144526" y="60706"/>
                </a:lnTo>
                <a:lnTo>
                  <a:pt x="144780" y="56261"/>
                </a:lnTo>
                <a:lnTo>
                  <a:pt x="144780" y="51816"/>
                </a:lnTo>
                <a:lnTo>
                  <a:pt x="136192" y="12660"/>
                </a:lnTo>
                <a:lnTo>
                  <a:pt x="129667" y="508"/>
                </a:lnTo>
                <a:lnTo>
                  <a:pt x="129413" y="381"/>
                </a:lnTo>
                <a:lnTo>
                  <a:pt x="129032" y="254"/>
                </a:lnTo>
                <a:lnTo>
                  <a:pt x="128524" y="127"/>
                </a:lnTo>
                <a:lnTo>
                  <a:pt x="127889" y="127"/>
                </a:lnTo>
                <a:lnTo>
                  <a:pt x="127254" y="0"/>
                </a:lnTo>
                <a:close/>
              </a:path>
            </a:pathLst>
          </a:custGeom>
          <a:solidFill>
            <a:srgbClr val="E6E6E6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2" name="object 162"/>
          <p:cNvSpPr/>
          <p:nvPr/>
        </p:nvSpPr>
        <p:spPr>
          <a:xfrm>
            <a:off x="4092130" y="5423280"/>
            <a:ext cx="102756" cy="44185"/>
          </a:xfrm>
          <a:prstGeom prst="rect">
            <a:avLst/>
          </a:prstGeom>
          <a:blipFill>
            <a:blip r:embed="rId5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3" name="object 163"/>
          <p:cNvSpPr/>
          <p:nvPr/>
        </p:nvSpPr>
        <p:spPr>
          <a:xfrm>
            <a:off x="4295686" y="5419136"/>
            <a:ext cx="131176" cy="111845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4" name="object 164"/>
          <p:cNvSpPr txBox="1"/>
          <p:nvPr/>
        </p:nvSpPr>
        <p:spPr>
          <a:xfrm>
            <a:off x="4284984" y="5414994"/>
            <a:ext cx="133478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65" name="object 165"/>
          <p:cNvSpPr/>
          <p:nvPr/>
        </p:nvSpPr>
        <p:spPr>
          <a:xfrm>
            <a:off x="5104837" y="5424660"/>
            <a:ext cx="157412" cy="111845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6" name="object 166"/>
          <p:cNvSpPr txBox="1"/>
          <p:nvPr/>
        </p:nvSpPr>
        <p:spPr>
          <a:xfrm>
            <a:off x="5094481" y="5421898"/>
            <a:ext cx="155916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28" dirty="0">
                <a:solidFill>
                  <a:srgbClr val="E6E6E6"/>
                </a:solidFill>
                <a:latin typeface="Calibri"/>
                <a:cs typeface="Calibri"/>
              </a:rPr>
              <a:t>(v</a:t>
            </a:r>
            <a:r>
              <a:rPr sz="861" spc="-23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67" name="object 167"/>
          <p:cNvSpPr/>
          <p:nvPr/>
        </p:nvSpPr>
        <p:spPr>
          <a:xfrm>
            <a:off x="5662110" y="5428803"/>
            <a:ext cx="97230" cy="42804"/>
          </a:xfrm>
          <a:prstGeom prst="rect">
            <a:avLst/>
          </a:prstGeom>
          <a:blipFill>
            <a:blip r:embed="rId5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8" name="object 168"/>
          <p:cNvSpPr/>
          <p:nvPr/>
        </p:nvSpPr>
        <p:spPr>
          <a:xfrm>
            <a:off x="5900182" y="5412232"/>
            <a:ext cx="183647" cy="113226"/>
          </a:xfrm>
          <a:prstGeom prst="rect">
            <a:avLst/>
          </a:prstGeom>
          <a:blipFill>
            <a:blip r:embed="rId3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9" name="object 169"/>
          <p:cNvSpPr txBox="1"/>
          <p:nvPr/>
        </p:nvSpPr>
        <p:spPr>
          <a:xfrm>
            <a:off x="5889826" y="5409471"/>
            <a:ext cx="183532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18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14" dirty="0">
                <a:solidFill>
                  <a:srgbClr val="E6E6E6"/>
                </a:solidFill>
                <a:latin typeface="Calibri"/>
                <a:cs typeface="Calibri"/>
              </a:rPr>
              <a:t>vii</a:t>
            </a:r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70" name="object 170"/>
          <p:cNvSpPr txBox="1"/>
          <p:nvPr/>
        </p:nvSpPr>
        <p:spPr>
          <a:xfrm>
            <a:off x="288127" y="4497909"/>
            <a:ext cx="17029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9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18" dirty="0">
                <a:solidFill>
                  <a:srgbClr val="E6E6E6"/>
                </a:solidFill>
                <a:latin typeface="Calibri"/>
                <a:cs typeface="Calibri"/>
              </a:rPr>
              <a:t>v</a:t>
            </a:r>
            <a:r>
              <a:rPr sz="861" spc="23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171" name="object 171"/>
          <p:cNvSpPr txBox="1"/>
          <p:nvPr/>
        </p:nvSpPr>
        <p:spPr>
          <a:xfrm>
            <a:off x="3312668" y="4413288"/>
            <a:ext cx="62711" cy="2090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" b="1" dirty="0">
                <a:solidFill>
                  <a:srgbClr val="FFFFFF"/>
                </a:solidFill>
                <a:latin typeface="Arial"/>
                <a:cs typeface="Arial"/>
              </a:rPr>
              <a:t>5</a:t>
            </a:r>
            <a:r>
              <a:rPr sz="136" b="1" spc="5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136" b="1" spc="-28" dirty="0">
                <a:solidFill>
                  <a:srgbClr val="FFFFFF"/>
                </a:solidFill>
                <a:latin typeface="Arial"/>
                <a:cs typeface="Arial"/>
              </a:rPr>
              <a:t>µm</a:t>
            </a:r>
            <a:r>
              <a:rPr sz="136" b="1" dirty="0">
                <a:solidFill>
                  <a:srgbClr val="FFFFFF"/>
                </a:solidFill>
                <a:latin typeface="Arial"/>
                <a:cs typeface="Arial"/>
              </a:rPr>
              <a:t>.</a:t>
            </a:r>
            <a:endParaRPr sz="136">
              <a:latin typeface="Arial"/>
              <a:cs typeface="Arial"/>
            </a:endParaRPr>
          </a:p>
        </p:txBody>
      </p:sp>
      <p:sp>
        <p:nvSpPr>
          <p:cNvPr id="172" name="object 172"/>
          <p:cNvSpPr txBox="1"/>
          <p:nvPr/>
        </p:nvSpPr>
        <p:spPr>
          <a:xfrm>
            <a:off x="3463405" y="4346020"/>
            <a:ext cx="170299" cy="132472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61" spc="-5" dirty="0">
                <a:solidFill>
                  <a:srgbClr val="E6E6E6"/>
                </a:solidFill>
                <a:latin typeface="Calibri"/>
                <a:cs typeface="Calibri"/>
              </a:rPr>
              <a:t>(</a:t>
            </a:r>
            <a:r>
              <a:rPr sz="861" spc="-9" dirty="0">
                <a:solidFill>
                  <a:srgbClr val="E6E6E6"/>
                </a:solidFill>
                <a:latin typeface="Calibri"/>
                <a:cs typeface="Calibri"/>
              </a:rPr>
              <a:t>i</a:t>
            </a:r>
            <a:r>
              <a:rPr sz="861" spc="18" dirty="0">
                <a:solidFill>
                  <a:srgbClr val="E6E6E6"/>
                </a:solidFill>
                <a:latin typeface="Calibri"/>
                <a:cs typeface="Calibri"/>
              </a:rPr>
              <a:t>v</a:t>
            </a:r>
            <a:r>
              <a:rPr sz="861" spc="23" dirty="0">
                <a:solidFill>
                  <a:srgbClr val="E6E6E6"/>
                </a:solidFill>
                <a:latin typeface="Calibri"/>
                <a:cs typeface="Calibri"/>
              </a:rPr>
              <a:t>)</a:t>
            </a:r>
            <a:endParaRPr sz="861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038483" y="3419845"/>
            <a:ext cx="2110905" cy="211205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" name="object 3"/>
          <p:cNvSpPr/>
          <p:nvPr/>
        </p:nvSpPr>
        <p:spPr>
          <a:xfrm>
            <a:off x="1434658" y="3716699"/>
            <a:ext cx="316435" cy="317585"/>
          </a:xfrm>
          <a:custGeom>
            <a:avLst/>
            <a:gdLst/>
            <a:ahLst/>
            <a:cxnLst/>
            <a:rect l="l" t="t" r="r" b="b"/>
            <a:pathLst>
              <a:path w="349250" h="350520">
                <a:moveTo>
                  <a:pt x="0" y="350415"/>
                </a:moveTo>
                <a:lnTo>
                  <a:pt x="348942" y="350415"/>
                </a:lnTo>
                <a:lnTo>
                  <a:pt x="348942" y="0"/>
                </a:lnTo>
                <a:lnTo>
                  <a:pt x="0" y="0"/>
                </a:lnTo>
                <a:lnTo>
                  <a:pt x="0" y="350415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" name="object 4"/>
          <p:cNvSpPr/>
          <p:nvPr/>
        </p:nvSpPr>
        <p:spPr>
          <a:xfrm>
            <a:off x="2453575" y="4140477"/>
            <a:ext cx="316435" cy="316435"/>
          </a:xfrm>
          <a:custGeom>
            <a:avLst/>
            <a:gdLst/>
            <a:ahLst/>
            <a:cxnLst/>
            <a:rect l="l" t="t" r="r" b="b"/>
            <a:pathLst>
              <a:path w="349250" h="349250">
                <a:moveTo>
                  <a:pt x="0" y="348907"/>
                </a:moveTo>
                <a:lnTo>
                  <a:pt x="348932" y="348907"/>
                </a:lnTo>
                <a:lnTo>
                  <a:pt x="348932" y="0"/>
                </a:lnTo>
                <a:lnTo>
                  <a:pt x="0" y="0"/>
                </a:lnTo>
                <a:lnTo>
                  <a:pt x="0" y="348907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" name="object 5"/>
          <p:cNvSpPr/>
          <p:nvPr/>
        </p:nvSpPr>
        <p:spPr>
          <a:xfrm>
            <a:off x="1924842" y="3838082"/>
            <a:ext cx="316435" cy="317585"/>
          </a:xfrm>
          <a:custGeom>
            <a:avLst/>
            <a:gdLst/>
            <a:ahLst/>
            <a:cxnLst/>
            <a:rect l="l" t="t" r="r" b="b"/>
            <a:pathLst>
              <a:path w="349250" h="350520">
                <a:moveTo>
                  <a:pt x="0" y="350431"/>
                </a:moveTo>
                <a:lnTo>
                  <a:pt x="348932" y="350431"/>
                </a:lnTo>
                <a:lnTo>
                  <a:pt x="348932" y="0"/>
                </a:lnTo>
                <a:lnTo>
                  <a:pt x="0" y="0"/>
                </a:lnTo>
                <a:lnTo>
                  <a:pt x="0" y="350431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" name="object 6"/>
          <p:cNvSpPr/>
          <p:nvPr/>
        </p:nvSpPr>
        <p:spPr>
          <a:xfrm>
            <a:off x="2618009" y="5183018"/>
            <a:ext cx="240259" cy="117368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" name="object 7"/>
          <p:cNvSpPr txBox="1"/>
          <p:nvPr/>
        </p:nvSpPr>
        <p:spPr>
          <a:xfrm>
            <a:off x="2607077" y="5188542"/>
            <a:ext cx="238189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u="heavy" spc="-5" dirty="0">
                <a:solidFill>
                  <a:srgbClr val="FFFFFF"/>
                </a:solidFill>
                <a:latin typeface="Calibri"/>
                <a:cs typeface="Calibri"/>
              </a:rPr>
              <a:t>5</a:t>
            </a:r>
            <a:r>
              <a:rPr sz="816" b="1" u="heavy" spc="18" dirty="0">
                <a:solidFill>
                  <a:srgbClr val="FFFFFF"/>
                </a:solidFill>
                <a:latin typeface="Calibri"/>
                <a:cs typeface="Calibri"/>
              </a:rPr>
              <a:t> </a:t>
            </a:r>
            <a:r>
              <a:rPr sz="816" b="1" u="heavy" spc="-28" dirty="0">
                <a:solidFill>
                  <a:srgbClr val="FFFFFF"/>
                </a:solidFill>
                <a:latin typeface="Calibri"/>
                <a:cs typeface="Calibri"/>
              </a:rPr>
              <a:t>µm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759258" y="678716"/>
            <a:ext cx="160519" cy="20928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0" spc="-28" dirty="0">
                <a:latin typeface="Calibri"/>
                <a:cs typeface="Calibri"/>
              </a:rPr>
              <a:t>A.</a:t>
            </a:r>
            <a:endParaRPr sz="136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4229753" y="710131"/>
            <a:ext cx="441281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TE</a:t>
            </a:r>
            <a:r>
              <a:rPr sz="1087" spc="-18" dirty="0">
                <a:solidFill>
                  <a:srgbClr val="00B050"/>
                </a:solidFill>
                <a:latin typeface="Calibri"/>
                <a:cs typeface="Calibri"/>
              </a:rPr>
              <a:t>CP</a:t>
            </a:r>
            <a:r>
              <a:rPr sz="1087" spc="-28" dirty="0">
                <a:solidFill>
                  <a:srgbClr val="00B050"/>
                </a:solidFill>
                <a:latin typeface="Calibri"/>
                <a:cs typeface="Calibri"/>
              </a:rPr>
              <a:t>R</a:t>
            </a:r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1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4961925" y="710131"/>
            <a:ext cx="269832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33" dirty="0">
                <a:solidFill>
                  <a:srgbClr val="FF0000"/>
                </a:solidFill>
                <a:latin typeface="Calibri"/>
                <a:cs typeface="Calibri"/>
              </a:rPr>
              <a:t>G</a:t>
            </a:r>
            <a:r>
              <a:rPr sz="1087" spc="-23" dirty="0">
                <a:solidFill>
                  <a:srgbClr val="FF0000"/>
                </a:solidFill>
                <a:latin typeface="Calibri"/>
                <a:cs typeface="Calibri"/>
              </a:rPr>
              <a:t>al</a:t>
            </a:r>
            <a:r>
              <a:rPr sz="1087" spc="-9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759258" y="3209617"/>
            <a:ext cx="171451" cy="27193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360" spc="-33" dirty="0">
                <a:latin typeface="Calibri"/>
                <a:cs typeface="Calibri"/>
              </a:rPr>
              <a:t>B</a:t>
            </a:r>
            <a:r>
              <a:rPr sz="1767" dirty="0">
                <a:latin typeface="Calibri"/>
                <a:cs typeface="Calibri"/>
              </a:rPr>
              <a:t>.</a:t>
            </a:r>
            <a:endParaRPr sz="1767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4207661" y="3229295"/>
            <a:ext cx="441281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TE</a:t>
            </a:r>
            <a:r>
              <a:rPr sz="1087" spc="-18" dirty="0">
                <a:solidFill>
                  <a:srgbClr val="00B050"/>
                </a:solidFill>
                <a:latin typeface="Calibri"/>
                <a:cs typeface="Calibri"/>
              </a:rPr>
              <a:t>CP</a:t>
            </a:r>
            <a:r>
              <a:rPr sz="1087" spc="-28" dirty="0">
                <a:solidFill>
                  <a:srgbClr val="00B050"/>
                </a:solidFill>
                <a:latin typeface="Calibri"/>
                <a:cs typeface="Calibri"/>
              </a:rPr>
              <a:t>R</a:t>
            </a:r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1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4941213" y="3229295"/>
            <a:ext cx="269832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33" dirty="0">
                <a:solidFill>
                  <a:srgbClr val="FF0000"/>
                </a:solidFill>
                <a:latin typeface="Calibri"/>
                <a:cs typeface="Calibri"/>
              </a:rPr>
              <a:t>G</a:t>
            </a:r>
            <a:r>
              <a:rPr sz="1087" spc="-23" dirty="0">
                <a:solidFill>
                  <a:srgbClr val="FF0000"/>
                </a:solidFill>
                <a:latin typeface="Calibri"/>
                <a:cs typeface="Calibri"/>
              </a:rPr>
              <a:t>al</a:t>
            </a:r>
            <a:r>
              <a:rPr sz="1087" spc="-9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237033" y="6088528"/>
            <a:ext cx="6384499" cy="148527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1400"/>
              </a:lnSpc>
            </a:pPr>
            <a:r>
              <a:rPr sz="1087" b="1" spc="28" dirty="0">
                <a:latin typeface="Times New Roman"/>
                <a:cs typeface="Times New Roman"/>
              </a:rPr>
              <a:t>S</a:t>
            </a:r>
            <a:r>
              <a:rPr sz="1087" b="1" spc="1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p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9" dirty="0">
                <a:latin typeface="Times New Roman"/>
                <a:cs typeface="Times New Roman"/>
              </a:rPr>
              <a:t>le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a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3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fig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100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7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1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28" dirty="0">
                <a:latin typeface="Times New Roman"/>
                <a:cs typeface="Times New Roman"/>
              </a:rPr>
              <a:t>h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3" dirty="0">
                <a:latin typeface="Times New Roman"/>
                <a:cs typeface="Times New Roman"/>
              </a:rPr>
              <a:t>r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8" dirty="0">
                <a:latin typeface="Times New Roman"/>
                <a:cs typeface="Times New Roman"/>
              </a:rPr>
              <a:t>qu</a:t>
            </a:r>
            <a:r>
              <a:rPr sz="1087" b="1" spc="9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1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i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8" dirty="0">
                <a:latin typeface="Times New Roman"/>
                <a:cs typeface="Times New Roman"/>
              </a:rPr>
              <a:t>d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ces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T</a:t>
            </a:r>
            <a:r>
              <a:rPr sz="1087" b="1" spc="33" dirty="0">
                <a:latin typeface="Times New Roman"/>
                <a:cs typeface="Times New Roman"/>
              </a:rPr>
              <a:t>G1</a:t>
            </a:r>
            <a:r>
              <a:rPr sz="1087" b="1" spc="14" dirty="0">
                <a:latin typeface="Times New Roman"/>
                <a:cs typeface="Times New Roman"/>
              </a:rPr>
              <a:t>6</a:t>
            </a:r>
            <a:r>
              <a:rPr sz="1087" b="1" spc="28" dirty="0">
                <a:latin typeface="Times New Roman"/>
                <a:cs typeface="Times New Roman"/>
              </a:rPr>
              <a:t>L</a:t>
            </a:r>
            <a:r>
              <a:rPr sz="1087" b="1" spc="23" dirty="0">
                <a:latin typeface="Times New Roman"/>
                <a:cs typeface="Times New Roman"/>
              </a:rPr>
              <a:t>1</a:t>
            </a:r>
            <a:r>
              <a:rPr sz="1087" b="1" spc="9" dirty="0">
                <a:latin typeface="Times New Roman"/>
                <a:cs typeface="Times New Roman"/>
              </a:rPr>
              <a:t>-i</a:t>
            </a:r>
            <a:r>
              <a:rPr sz="1087" b="1" spc="28" dirty="0">
                <a:latin typeface="Times New Roman"/>
                <a:cs typeface="Times New Roman"/>
              </a:rPr>
              <a:t>nd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d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tr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9" dirty="0">
                <a:latin typeface="Times New Roman"/>
                <a:cs typeface="Times New Roman"/>
              </a:rPr>
              <a:t>sloc</a:t>
            </a:r>
            <a:r>
              <a:rPr sz="1087" b="1" spc="14" dirty="0">
                <a:latin typeface="Times New Roman"/>
                <a:cs typeface="Times New Roman"/>
              </a:rPr>
              <a:t>at</a:t>
            </a:r>
            <a:r>
              <a:rPr sz="1087" b="1" spc="18" dirty="0">
                <a:latin typeface="Times New Roman"/>
                <a:cs typeface="Times New Roman"/>
              </a:rPr>
              <a:t>i</a:t>
            </a:r>
            <a:r>
              <a:rPr sz="1087" b="1" spc="14" dirty="0">
                <a:latin typeface="Times New Roman"/>
                <a:cs typeface="Times New Roman"/>
              </a:rPr>
              <a:t>o</a:t>
            </a:r>
            <a:r>
              <a:rPr sz="1087" b="1" spc="23" dirty="0">
                <a:latin typeface="Times New Roman"/>
                <a:cs typeface="Times New Roman"/>
              </a:rPr>
              <a:t>n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1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of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95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TE</a:t>
            </a:r>
            <a:r>
              <a:rPr sz="1087" b="1" spc="18" dirty="0">
                <a:latin typeface="Times New Roman"/>
                <a:cs typeface="Times New Roman"/>
              </a:rPr>
              <a:t>C</a:t>
            </a:r>
            <a:r>
              <a:rPr sz="1087" b="1" spc="33" dirty="0">
                <a:latin typeface="Times New Roman"/>
                <a:cs typeface="Times New Roman"/>
              </a:rPr>
              <a:t>P</a:t>
            </a:r>
            <a:r>
              <a:rPr sz="1087" b="1" spc="18" dirty="0">
                <a:latin typeface="Times New Roman"/>
                <a:cs typeface="Times New Roman"/>
              </a:rPr>
              <a:t>R1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8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t</a:t>
            </a:r>
            <a:r>
              <a:rPr sz="1087" b="1" spc="18" dirty="0">
                <a:latin typeface="Times New Roman"/>
                <a:cs typeface="Times New Roman"/>
              </a:rPr>
              <a:t>o</a:t>
            </a:r>
            <a:r>
              <a:rPr sz="1087" b="1" spc="9" dirty="0">
                <a:latin typeface="Times New Roman"/>
                <a:cs typeface="Times New Roman"/>
              </a:rPr>
              <a:t> </a:t>
            </a:r>
            <a:r>
              <a:rPr sz="1087" b="1" spc="14" dirty="0">
                <a:latin typeface="Times New Roman"/>
                <a:cs typeface="Times New Roman"/>
              </a:rPr>
              <a:t>r</a:t>
            </a:r>
            <a:r>
              <a:rPr sz="1087" b="1" spc="28" dirty="0">
                <a:latin typeface="Times New Roman"/>
                <a:cs typeface="Times New Roman"/>
              </a:rPr>
              <a:t>up</a:t>
            </a:r>
            <a:r>
              <a:rPr sz="1087" b="1" spc="14" dirty="0">
                <a:latin typeface="Times New Roman"/>
                <a:cs typeface="Times New Roman"/>
              </a:rPr>
              <a:t>t</a:t>
            </a:r>
            <a:r>
              <a:rPr sz="1087" b="1" spc="28" dirty="0">
                <a:latin typeface="Times New Roman"/>
                <a:cs typeface="Times New Roman"/>
              </a:rPr>
              <a:t>u</a:t>
            </a:r>
            <a:r>
              <a:rPr sz="1087" b="1" spc="14" dirty="0">
                <a:latin typeface="Times New Roman"/>
                <a:cs typeface="Times New Roman"/>
              </a:rPr>
              <a:t>re</a:t>
            </a:r>
            <a:r>
              <a:rPr sz="1087" b="1" spc="23" dirty="0">
                <a:latin typeface="Times New Roman"/>
                <a:cs typeface="Times New Roman"/>
              </a:rPr>
              <a:t>d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14" dirty="0">
                <a:latin typeface="Times New Roman"/>
                <a:cs typeface="Times New Roman"/>
              </a:rPr>
              <a:t>ysoso</a:t>
            </a:r>
            <a:r>
              <a:rPr sz="1087" b="1" spc="41" dirty="0">
                <a:latin typeface="Times New Roman"/>
                <a:cs typeface="Times New Roman"/>
              </a:rPr>
              <a:t>m</a:t>
            </a:r>
            <a:r>
              <a:rPr sz="1087" b="1" spc="14" dirty="0">
                <a:latin typeface="Times New Roman"/>
                <a:cs typeface="Times New Roman"/>
              </a:rPr>
              <a:t>es</a:t>
            </a:r>
            <a:r>
              <a:rPr sz="1087" b="1" spc="9" dirty="0">
                <a:latin typeface="Times New Roman"/>
                <a:cs typeface="Times New Roman"/>
              </a:rPr>
              <a:t>.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1</a:t>
            </a:r>
            <a:r>
              <a:rPr sz="1087" spc="23" dirty="0">
                <a:latin typeface="Times New Roman"/>
                <a:cs typeface="Times New Roman"/>
              </a:rPr>
              <a:t>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9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8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F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1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b="1" spc="28" dirty="0">
                <a:latin typeface="Times New Roman"/>
                <a:cs typeface="Times New Roman"/>
              </a:rPr>
              <a:t>pa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13" dirty="0">
                <a:latin typeface="Times New Roman"/>
                <a:cs typeface="Times New Roman"/>
              </a:rPr>
              <a:t> </a:t>
            </a:r>
            <a:r>
              <a:rPr sz="1087" b="1" spc="23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0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r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0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ATG1</a:t>
            </a:r>
            <a:r>
              <a:rPr sz="1087" spc="18" dirty="0">
                <a:latin typeface="Times New Roman"/>
                <a:cs typeface="Times New Roman"/>
              </a:rPr>
              <a:t>6</a:t>
            </a:r>
            <a:r>
              <a:rPr sz="1087" spc="23" dirty="0">
                <a:latin typeface="Times New Roman"/>
                <a:cs typeface="Times New Roman"/>
              </a:rPr>
              <a:t>L1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spc="5" dirty="0">
                <a:latin typeface="Times New Roman"/>
                <a:cs typeface="Times New Roman"/>
              </a:rPr>
              <a:t>/</a:t>
            </a:r>
            <a:r>
              <a:rPr sz="1087" spc="18" dirty="0">
                <a:latin typeface="Times New Roman"/>
                <a:cs typeface="Times New Roman"/>
              </a:rPr>
              <a:t>-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0" dirty="0">
                <a:latin typeface="Times New Roman"/>
                <a:cs typeface="Times New Roman"/>
              </a:rPr>
              <a:t> </a:t>
            </a:r>
            <a:r>
              <a:rPr sz="1087" spc="41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0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exp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ssi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9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tr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a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-10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C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36" dirty="0">
                <a:latin typeface="Times New Roman"/>
                <a:cs typeface="Times New Roman"/>
              </a:rPr>
              <a:t>R</a:t>
            </a:r>
            <a:r>
              <a:rPr sz="1087" spc="28" dirty="0">
                <a:latin typeface="Times New Roman"/>
                <a:cs typeface="Times New Roman"/>
              </a:rPr>
              <a:t>1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TECPR1</a:t>
            </a:r>
            <a:r>
              <a:rPr sz="1087" spc="9" dirty="0">
                <a:latin typeface="Times New Roman"/>
                <a:cs typeface="Times New Roman"/>
              </a:rPr>
              <a:t>*/*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-36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B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w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u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23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ia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g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h</a:t>
            </a:r>
            <a:r>
              <a:rPr sz="1087" spc="9" dirty="0">
                <a:latin typeface="Times New Roman"/>
                <a:cs typeface="Times New Roman"/>
              </a:rPr>
              <a:t>lo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3" dirty="0">
                <a:latin typeface="Times New Roman"/>
                <a:cs typeface="Times New Roman"/>
              </a:rPr>
              <a:t>q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ine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00</a:t>
            </a:r>
            <a:r>
              <a:rPr sz="1087" spc="41" dirty="0">
                <a:latin typeface="Times New Roman"/>
                <a:cs typeface="Times New Roman"/>
              </a:rPr>
              <a:t>mM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2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3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rs.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36" dirty="0">
                <a:latin typeface="Times New Roman"/>
                <a:cs typeface="Times New Roman"/>
              </a:rPr>
              <a:t>C</a:t>
            </a:r>
            <a:r>
              <a:rPr sz="1087" spc="9" dirty="0">
                <a:latin typeface="Times New Roman"/>
                <a:cs typeface="Times New Roman"/>
              </a:rPr>
              <a:t>el</a:t>
            </a:r>
            <a:r>
              <a:rPr sz="1087" spc="5" dirty="0">
                <a:latin typeface="Times New Roman"/>
                <a:cs typeface="Times New Roman"/>
              </a:rPr>
              <a:t>l</a:t>
            </a:r>
            <a:r>
              <a:rPr sz="1087" spc="18" dirty="0">
                <a:latin typeface="Times New Roman"/>
                <a:cs typeface="Times New Roman"/>
              </a:rPr>
              <a:t>s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45" dirty="0">
                <a:latin typeface="Times New Roman"/>
                <a:cs typeface="Times New Roman"/>
              </a:rPr>
              <a:t>w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-1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f</a:t>
            </a:r>
            <a:r>
              <a:rPr sz="1087" spc="18" dirty="0">
                <a:latin typeface="Times New Roman"/>
                <a:cs typeface="Times New Roman"/>
              </a:rPr>
              <a:t>ixed</a:t>
            </a:r>
            <a:r>
              <a:rPr sz="1087" spc="9" dirty="0">
                <a:latin typeface="Times New Roman"/>
                <a:cs typeface="Times New Roman"/>
              </a:rPr>
              <a:t> 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t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f</a:t>
            </a:r>
            <a:r>
              <a:rPr sz="1087" spc="23" dirty="0">
                <a:latin typeface="Times New Roman"/>
                <a:cs typeface="Times New Roman"/>
              </a:rPr>
              <a:t>o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50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en</a:t>
            </a:r>
            <a:r>
              <a:rPr sz="1087" spc="33" dirty="0">
                <a:latin typeface="Times New Roman"/>
                <a:cs typeface="Times New Roman"/>
              </a:rPr>
              <a:t>d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ous</a:t>
            </a:r>
            <a:r>
              <a:rPr sz="1087" spc="3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T</a:t>
            </a:r>
            <a:r>
              <a:rPr sz="1087" spc="23" dirty="0">
                <a:latin typeface="Times New Roman"/>
                <a:cs typeface="Times New Roman"/>
              </a:rPr>
              <a:t>ECPR1</a:t>
            </a:r>
            <a:r>
              <a:rPr sz="1087" spc="3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spc="23" dirty="0">
                <a:latin typeface="Times New Roman"/>
                <a:cs typeface="Times New Roman"/>
              </a:rPr>
              <a:t>gr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18" dirty="0">
                <a:latin typeface="Times New Roman"/>
                <a:cs typeface="Times New Roman"/>
              </a:rPr>
              <a:t>en)</a:t>
            </a:r>
            <a:r>
              <a:rPr sz="1087" spc="23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28" dirty="0">
                <a:latin typeface="Times New Roman"/>
                <a:cs typeface="Times New Roman"/>
              </a:rPr>
              <a:t>d 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ec</a:t>
            </a:r>
            <a:r>
              <a:rPr sz="1087" spc="14" dirty="0">
                <a:latin typeface="Times New Roman"/>
                <a:cs typeface="Times New Roman"/>
              </a:rPr>
              <a:t>tin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3 </a:t>
            </a:r>
            <a:r>
              <a:rPr sz="1087" spc="14" dirty="0">
                <a:latin typeface="Times New Roman"/>
                <a:cs typeface="Times New Roman"/>
              </a:rPr>
              <a:t>(re</a:t>
            </a:r>
            <a:r>
              <a:rPr sz="1087" spc="1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S</a:t>
            </a:r>
            <a:r>
              <a:rPr lang="en-GB" sz="1087" spc="18" dirty="0">
                <a:latin typeface="Times New Roman"/>
                <a:cs typeface="Times New Roman"/>
              </a:rPr>
              <a:t>c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4" dirty="0">
                <a:latin typeface="Times New Roman"/>
                <a:cs typeface="Times New Roman"/>
              </a:rPr>
              <a:t>l</a:t>
            </a:r>
            <a:r>
              <a:rPr lang="en-GB" sz="1087" spc="18" dirty="0">
                <a:latin typeface="Times New Roman"/>
                <a:cs typeface="Times New Roman"/>
              </a:rPr>
              <a:t>e</a:t>
            </a:r>
            <a:r>
              <a:rPr lang="en-GB" sz="1087" spc="-5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b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8" dirty="0">
                <a:latin typeface="Times New Roman"/>
                <a:cs typeface="Times New Roman"/>
              </a:rPr>
              <a:t>r</a:t>
            </a:r>
            <a:r>
              <a:rPr lang="en-GB" sz="1087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5</a:t>
            </a:r>
            <a:r>
              <a:rPr lang="en-GB" sz="1087" spc="33" dirty="0">
                <a:latin typeface="Symbol"/>
                <a:cs typeface="Symbol"/>
              </a:rPr>
              <a:t></a:t>
            </a:r>
            <a:r>
              <a:rPr lang="en-GB" sz="1087" spc="18" dirty="0">
                <a:latin typeface="Times New Roman"/>
                <a:cs typeface="Times New Roman"/>
              </a:rPr>
              <a:t>m</a:t>
            </a:r>
            <a:r>
              <a:rPr sz="1087" spc="14" dirty="0">
                <a:latin typeface="Times New Roman"/>
                <a:cs typeface="Times New Roman"/>
              </a:rPr>
              <a:t>.</a:t>
            </a:r>
            <a:r>
              <a:rPr sz="1087" dirty="0">
                <a:latin typeface="Times New Roman"/>
                <a:cs typeface="Times New Roman"/>
              </a:rPr>
              <a:t>  </a:t>
            </a:r>
            <a:r>
              <a:rPr sz="1087" spc="-86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Re</a:t>
            </a:r>
            <a:r>
              <a:rPr sz="1087" spc="18" dirty="0">
                <a:latin typeface="Times New Roman"/>
                <a:cs typeface="Times New Roman"/>
              </a:rPr>
              <a:t>g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ons</a:t>
            </a:r>
            <a:r>
              <a:rPr sz="1087" spc="2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f</a:t>
            </a:r>
            <a:r>
              <a:rPr sz="1087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te</a:t>
            </a:r>
            <a:r>
              <a:rPr sz="1087" spc="23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est</a:t>
            </a:r>
            <a:r>
              <a:rPr sz="1087" spc="36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14" dirty="0">
                <a:latin typeface="Times New Roman"/>
                <a:cs typeface="Times New Roman"/>
              </a:rPr>
              <a:t> the</a:t>
            </a:r>
            <a:r>
              <a:rPr sz="1087" spc="9" dirty="0">
                <a:latin typeface="Times New Roman"/>
                <a:cs typeface="Times New Roman"/>
              </a:rPr>
              <a:t> rig</a:t>
            </a:r>
            <a:r>
              <a:rPr sz="1087" spc="18" dirty="0">
                <a:latin typeface="Times New Roman"/>
                <a:cs typeface="Times New Roman"/>
              </a:rPr>
              <a:t>h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7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h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6" dirty="0">
                <a:latin typeface="Times New Roman"/>
                <a:cs typeface="Times New Roman"/>
              </a:rPr>
              <a:t>w</a:t>
            </a:r>
            <a:r>
              <a:rPr sz="1087" spc="83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hat</a:t>
            </a:r>
            <a:r>
              <a:rPr sz="1087" spc="7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s</a:t>
            </a:r>
            <a:r>
              <a:rPr sz="1087" spc="33" dirty="0">
                <a:latin typeface="Times New Roman"/>
                <a:cs typeface="Times New Roman"/>
              </a:rPr>
              <a:t>m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l</a:t>
            </a:r>
            <a:r>
              <a:rPr sz="1087" spc="113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18" dirty="0">
                <a:latin typeface="Times New Roman"/>
                <a:cs typeface="Times New Roman"/>
              </a:rPr>
              <a:t>u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4" dirty="0">
                <a:latin typeface="Times New Roman"/>
                <a:cs typeface="Times New Roman"/>
              </a:rPr>
              <a:t>ta</a:t>
            </a:r>
            <a:r>
              <a:rPr sz="1087" spc="73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con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18" dirty="0">
                <a:latin typeface="Times New Roman"/>
                <a:cs typeface="Times New Roman"/>
              </a:rPr>
              <a:t>ning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l</a:t>
            </a:r>
            <a:r>
              <a:rPr sz="1087" spc="9" dirty="0">
                <a:latin typeface="Times New Roman"/>
                <a:cs typeface="Times New Roman"/>
              </a:rPr>
              <a:t>ect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73" dirty="0">
                <a:latin typeface="Times New Roman"/>
                <a:cs typeface="Times New Roman"/>
              </a:rPr>
              <a:t> </a:t>
            </a:r>
            <a:r>
              <a:rPr sz="1087" spc="28" dirty="0">
                <a:latin typeface="Times New Roman"/>
                <a:cs typeface="Times New Roman"/>
              </a:rPr>
              <a:t>3</a:t>
            </a:r>
            <a:r>
              <a:rPr sz="1087" spc="109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re</a:t>
            </a:r>
            <a:r>
              <a:rPr sz="1087" spc="9" dirty="0">
                <a:latin typeface="Times New Roman"/>
                <a:cs typeface="Times New Roman"/>
              </a:rPr>
              <a:t>c</a:t>
            </a:r>
            <a:r>
              <a:rPr sz="1087" spc="18" dirty="0">
                <a:latin typeface="Times New Roman"/>
                <a:cs typeface="Times New Roman"/>
              </a:rPr>
              <a:t>r</a:t>
            </a:r>
            <a:r>
              <a:rPr sz="1087" spc="23" dirty="0">
                <a:latin typeface="Times New Roman"/>
                <a:cs typeface="Times New Roman"/>
              </a:rPr>
              <a:t>u</a:t>
            </a:r>
            <a:r>
              <a:rPr sz="1087" spc="14" dirty="0">
                <a:latin typeface="Times New Roman"/>
                <a:cs typeface="Times New Roman"/>
              </a:rPr>
              <a:t>i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45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en</a:t>
            </a:r>
            <a:r>
              <a:rPr sz="1087" spc="33" dirty="0">
                <a:latin typeface="Times New Roman"/>
                <a:cs typeface="Times New Roman"/>
              </a:rPr>
              <a:t>d</a:t>
            </a:r>
            <a:r>
              <a:rPr sz="1087" spc="18" dirty="0">
                <a:latin typeface="Times New Roman"/>
                <a:cs typeface="Times New Roman"/>
              </a:rPr>
              <a:t>o</a:t>
            </a:r>
            <a:r>
              <a:rPr sz="1087" spc="33" dirty="0">
                <a:latin typeface="Times New Roman"/>
                <a:cs typeface="Times New Roman"/>
              </a:rPr>
              <a:t>g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33" dirty="0">
                <a:latin typeface="Times New Roman"/>
                <a:cs typeface="Times New Roman"/>
              </a:rPr>
              <a:t>n</a:t>
            </a:r>
            <a:r>
              <a:rPr sz="1087" spc="18" dirty="0">
                <a:latin typeface="Times New Roman"/>
                <a:cs typeface="Times New Roman"/>
              </a:rPr>
              <a:t>ous</a:t>
            </a:r>
            <a:r>
              <a:rPr sz="1087" spc="68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C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23" dirty="0">
                <a:latin typeface="Times New Roman"/>
                <a:cs typeface="Times New Roman"/>
              </a:rPr>
              <a:t>R1</a:t>
            </a:r>
            <a:r>
              <a:rPr sz="1087" spc="109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(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86" dirty="0">
                <a:latin typeface="Times New Roman"/>
                <a:cs typeface="Times New Roman"/>
              </a:rPr>
              <a:t> </a:t>
            </a:r>
            <a:r>
              <a:rPr sz="1087" b="1" spc="18" dirty="0">
                <a:latin typeface="Times New Roman"/>
                <a:cs typeface="Times New Roman"/>
              </a:rPr>
              <a:t>A</a:t>
            </a:r>
            <a:r>
              <a:rPr sz="1087" spc="18" dirty="0">
                <a:latin typeface="Times New Roman"/>
                <a:cs typeface="Times New Roman"/>
              </a:rPr>
              <a:t>)</a:t>
            </a:r>
            <a:r>
              <a:rPr sz="1087" spc="118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b</a:t>
            </a:r>
            <a:r>
              <a:rPr sz="1087" spc="33" dirty="0">
                <a:latin typeface="Times New Roman"/>
                <a:cs typeface="Times New Roman"/>
              </a:rPr>
              <a:t>u</a:t>
            </a:r>
            <a:r>
              <a:rPr sz="1087" spc="9" dirty="0">
                <a:latin typeface="Times New Roman"/>
                <a:cs typeface="Times New Roman"/>
              </a:rPr>
              <a:t>t</a:t>
            </a:r>
            <a:r>
              <a:rPr sz="1087" spc="86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not</a:t>
            </a:r>
            <a:r>
              <a:rPr sz="1087" spc="95" dirty="0">
                <a:latin typeface="Times New Roman"/>
                <a:cs typeface="Times New Roman"/>
              </a:rPr>
              <a:t> </a:t>
            </a:r>
            <a:r>
              <a:rPr sz="1087" spc="14" dirty="0">
                <a:latin typeface="Times New Roman"/>
                <a:cs typeface="Times New Roman"/>
              </a:rPr>
              <a:t>tru</a:t>
            </a:r>
            <a:r>
              <a:rPr sz="1087" spc="18" dirty="0">
                <a:latin typeface="Times New Roman"/>
                <a:cs typeface="Times New Roman"/>
              </a:rPr>
              <a:t>nc</a:t>
            </a:r>
            <a:r>
              <a:rPr sz="1087" spc="9" dirty="0">
                <a:latin typeface="Times New Roman"/>
                <a:cs typeface="Times New Roman"/>
              </a:rPr>
              <a:t>a</a:t>
            </a:r>
            <a:r>
              <a:rPr sz="1087" spc="14" dirty="0">
                <a:latin typeface="Times New Roman"/>
                <a:cs typeface="Times New Roman"/>
              </a:rPr>
              <a:t>t</a:t>
            </a:r>
            <a:r>
              <a:rPr sz="1087" spc="9" dirty="0">
                <a:latin typeface="Times New Roman"/>
                <a:cs typeface="Times New Roman"/>
              </a:rPr>
              <a:t>e</a:t>
            </a:r>
            <a:r>
              <a:rPr sz="1087" spc="28" dirty="0">
                <a:latin typeface="Times New Roman"/>
                <a:cs typeface="Times New Roman"/>
              </a:rPr>
              <a:t>d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23" dirty="0">
                <a:latin typeface="Times New Roman"/>
                <a:cs typeface="Times New Roman"/>
              </a:rPr>
              <a:t>TEC</a:t>
            </a:r>
            <a:r>
              <a:rPr sz="1087" spc="33" dirty="0">
                <a:latin typeface="Times New Roman"/>
                <a:cs typeface="Times New Roman"/>
              </a:rPr>
              <a:t>P</a:t>
            </a:r>
            <a:r>
              <a:rPr sz="1087" spc="28" dirty="0">
                <a:latin typeface="Times New Roman"/>
                <a:cs typeface="Times New Roman"/>
              </a:rPr>
              <a:t>R</a:t>
            </a:r>
            <a:r>
              <a:rPr sz="1087" spc="9" dirty="0">
                <a:latin typeface="Times New Roman"/>
                <a:cs typeface="Times New Roman"/>
              </a:rPr>
              <a:t>1</a:t>
            </a:r>
            <a:r>
              <a:rPr sz="1087" spc="18" dirty="0">
                <a:latin typeface="Times New Roman"/>
                <a:cs typeface="Times New Roman"/>
              </a:rPr>
              <a:t>*</a:t>
            </a:r>
            <a:r>
              <a:rPr sz="1087" spc="14" dirty="0">
                <a:latin typeface="Times New Roman"/>
                <a:cs typeface="Times New Roman"/>
              </a:rPr>
              <a:t>/*</a:t>
            </a:r>
            <a:r>
              <a:rPr sz="1087" spc="9" dirty="0">
                <a:latin typeface="Times New Roman"/>
                <a:cs typeface="Times New Roman"/>
              </a:rPr>
              <a:t> </a:t>
            </a:r>
            <a:r>
              <a:rPr sz="1087" spc="18" dirty="0">
                <a:latin typeface="Times New Roman"/>
                <a:cs typeface="Times New Roman"/>
              </a:rPr>
              <a:t>(</a:t>
            </a:r>
            <a:r>
              <a:rPr sz="1087" b="1" spc="28" dirty="0">
                <a:latin typeface="Times New Roman"/>
                <a:cs typeface="Times New Roman"/>
              </a:rPr>
              <a:t>p</a:t>
            </a:r>
            <a:r>
              <a:rPr sz="1087" b="1" spc="14" dirty="0">
                <a:latin typeface="Times New Roman"/>
                <a:cs typeface="Times New Roman"/>
              </a:rPr>
              <a:t>a</a:t>
            </a:r>
            <a:r>
              <a:rPr sz="1087" b="1" spc="28" dirty="0">
                <a:latin typeface="Times New Roman"/>
                <a:cs typeface="Times New Roman"/>
              </a:rPr>
              <a:t>n</a:t>
            </a:r>
            <a:r>
              <a:rPr sz="1087" b="1" spc="14" dirty="0">
                <a:latin typeface="Times New Roman"/>
                <a:cs typeface="Times New Roman"/>
              </a:rPr>
              <a:t>e</a:t>
            </a:r>
            <a:r>
              <a:rPr sz="1087" b="1" spc="9" dirty="0">
                <a:latin typeface="Times New Roman"/>
                <a:cs typeface="Times New Roman"/>
              </a:rPr>
              <a:t>l</a:t>
            </a:r>
            <a:r>
              <a:rPr sz="1087" b="1" spc="-14" dirty="0">
                <a:latin typeface="Times New Roman"/>
                <a:cs typeface="Times New Roman"/>
              </a:rPr>
              <a:t> </a:t>
            </a:r>
            <a:r>
              <a:rPr sz="1087" b="1" spc="28" dirty="0">
                <a:latin typeface="Times New Roman"/>
                <a:cs typeface="Times New Roman"/>
              </a:rPr>
              <a:t>B</a:t>
            </a:r>
            <a:r>
              <a:rPr sz="1087" spc="14" dirty="0">
                <a:latin typeface="Times New Roman"/>
                <a:cs typeface="Times New Roman"/>
              </a:rPr>
              <a:t>).</a:t>
            </a:r>
            <a:endParaRPr sz="1087" dirty="0">
              <a:latin typeface="Times New Roman"/>
              <a:cs typeface="Times New Roman"/>
            </a:endParaRPr>
          </a:p>
        </p:txBody>
      </p:sp>
      <p:sp>
        <p:nvSpPr>
          <p:cNvPr id="15" name="object 15"/>
          <p:cNvSpPr/>
          <p:nvPr/>
        </p:nvSpPr>
        <p:spPr>
          <a:xfrm>
            <a:off x="3417494" y="4818141"/>
            <a:ext cx="634019" cy="634019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4098116" y="4813020"/>
            <a:ext cx="647827" cy="644434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/>
          <p:nvPr/>
        </p:nvSpPr>
        <p:spPr>
          <a:xfrm>
            <a:off x="4786218" y="4813020"/>
            <a:ext cx="647827" cy="644434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/>
          <p:nvPr/>
        </p:nvSpPr>
        <p:spPr>
          <a:xfrm>
            <a:off x="3417494" y="3435843"/>
            <a:ext cx="636320" cy="632176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/>
          <p:nvPr/>
        </p:nvSpPr>
        <p:spPr>
          <a:xfrm>
            <a:off x="4790820" y="3426059"/>
            <a:ext cx="639080" cy="643224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4098115" y="3426059"/>
            <a:ext cx="643224" cy="643224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4782765" y="899185"/>
            <a:ext cx="650370" cy="648978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/>
          <p:nvPr/>
        </p:nvSpPr>
        <p:spPr>
          <a:xfrm>
            <a:off x="4782764" y="1588402"/>
            <a:ext cx="653580" cy="645215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/>
          <p:nvPr/>
        </p:nvSpPr>
        <p:spPr>
          <a:xfrm>
            <a:off x="3404836" y="2286896"/>
            <a:ext cx="632292" cy="632292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/>
          <p:nvPr/>
        </p:nvSpPr>
        <p:spPr>
          <a:xfrm>
            <a:off x="4089485" y="2281716"/>
            <a:ext cx="650370" cy="648978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4786792" y="2281716"/>
            <a:ext cx="648978" cy="648978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/>
          <p:nvPr/>
        </p:nvSpPr>
        <p:spPr>
          <a:xfrm>
            <a:off x="3401959" y="1593628"/>
            <a:ext cx="639772" cy="635619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7" name="object 27"/>
          <p:cNvSpPr/>
          <p:nvPr/>
        </p:nvSpPr>
        <p:spPr>
          <a:xfrm>
            <a:off x="4093513" y="1584388"/>
            <a:ext cx="646101" cy="648886"/>
          </a:xfrm>
          <a:prstGeom prst="rect">
            <a:avLst/>
          </a:prstGeom>
          <a:blipFill>
            <a:blip r:embed="rId1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4089485" y="899185"/>
            <a:ext cx="650370" cy="648978"/>
          </a:xfrm>
          <a:prstGeom prst="rect">
            <a:avLst/>
          </a:prstGeom>
          <a:blipFill>
            <a:blip r:embed="rId1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 txBox="1"/>
          <p:nvPr/>
        </p:nvSpPr>
        <p:spPr>
          <a:xfrm>
            <a:off x="840382" y="3930310"/>
            <a:ext cx="132472" cy="103445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dirty="0">
                <a:latin typeface="Calibri"/>
                <a:cs typeface="Calibri"/>
              </a:rPr>
              <a:t>A</a:t>
            </a:r>
            <a:r>
              <a:rPr sz="861" spc="-9" dirty="0">
                <a:latin typeface="Calibri"/>
                <a:cs typeface="Calibri"/>
              </a:rPr>
              <a:t>T</a:t>
            </a:r>
            <a:r>
              <a:rPr sz="861" dirty="0">
                <a:latin typeface="Calibri"/>
                <a:cs typeface="Calibri"/>
              </a:rPr>
              <a:t>G16L1</a:t>
            </a:r>
            <a:r>
              <a:rPr sz="861" spc="-5" dirty="0">
                <a:latin typeface="Calibri"/>
                <a:cs typeface="Calibri"/>
              </a:rPr>
              <a:t>-</a:t>
            </a:r>
            <a:r>
              <a:rPr sz="861" spc="5" dirty="0">
                <a:latin typeface="Calibri"/>
                <a:cs typeface="Calibri"/>
              </a:rPr>
              <a:t>/</a:t>
            </a:r>
            <a:r>
              <a:rPr sz="861" dirty="0">
                <a:latin typeface="Calibri"/>
                <a:cs typeface="Calibri"/>
              </a:rPr>
              <a:t>-</a:t>
            </a:r>
            <a:r>
              <a:rPr sz="861" spc="9" dirty="0">
                <a:latin typeface="Times New Roman"/>
                <a:cs typeface="Times New Roman"/>
              </a:rPr>
              <a:t> </a:t>
            </a:r>
            <a:r>
              <a:rPr sz="861" spc="-18" dirty="0">
                <a:latin typeface="Calibri"/>
                <a:cs typeface="Calibri"/>
              </a:rPr>
              <a:t>T</a:t>
            </a:r>
            <a:r>
              <a:rPr sz="861" spc="-9" dirty="0">
                <a:latin typeface="Calibri"/>
                <a:cs typeface="Calibri"/>
              </a:rPr>
              <a:t>E</a:t>
            </a:r>
            <a:r>
              <a:rPr sz="861" spc="-14" dirty="0">
                <a:latin typeface="Calibri"/>
                <a:cs typeface="Calibri"/>
              </a:rPr>
              <a:t>C</a:t>
            </a:r>
            <a:r>
              <a:rPr sz="861" spc="-9" dirty="0">
                <a:latin typeface="Calibri"/>
                <a:cs typeface="Calibri"/>
              </a:rPr>
              <a:t>P</a:t>
            </a:r>
            <a:r>
              <a:rPr sz="861" dirty="0">
                <a:latin typeface="Calibri"/>
                <a:cs typeface="Calibri"/>
              </a:rPr>
              <a:t>R</a:t>
            </a:r>
            <a:r>
              <a:rPr sz="861" spc="-14" dirty="0">
                <a:latin typeface="Calibri"/>
                <a:cs typeface="Calibri"/>
              </a:rPr>
              <a:t>1</a:t>
            </a:r>
            <a:r>
              <a:rPr sz="861" spc="-18" dirty="0">
                <a:latin typeface="Calibri"/>
                <a:cs typeface="Calibri"/>
              </a:rPr>
              <a:t>*</a:t>
            </a:r>
            <a:r>
              <a:rPr sz="861" spc="-9" dirty="0">
                <a:latin typeface="Calibri"/>
                <a:cs typeface="Calibri"/>
              </a:rPr>
              <a:t>/</a:t>
            </a:r>
            <a:r>
              <a:rPr sz="861" dirty="0">
                <a:latin typeface="Calibri"/>
                <a:cs typeface="Calibri"/>
              </a:rPr>
              <a:t>*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843142" y="1715330"/>
            <a:ext cx="132472" cy="52643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1506"/>
            <a:r>
              <a:rPr sz="861" dirty="0">
                <a:latin typeface="Calibri"/>
                <a:cs typeface="Calibri"/>
              </a:rPr>
              <a:t>A</a:t>
            </a:r>
            <a:r>
              <a:rPr sz="861" spc="-9" dirty="0">
                <a:latin typeface="Calibri"/>
                <a:cs typeface="Calibri"/>
              </a:rPr>
              <a:t>T</a:t>
            </a:r>
            <a:r>
              <a:rPr sz="861" dirty="0">
                <a:latin typeface="Calibri"/>
                <a:cs typeface="Calibri"/>
              </a:rPr>
              <a:t>G16L</a:t>
            </a:r>
            <a:r>
              <a:rPr sz="861" spc="-5" dirty="0">
                <a:latin typeface="Calibri"/>
                <a:cs typeface="Calibri"/>
              </a:rPr>
              <a:t>1-</a:t>
            </a:r>
            <a:r>
              <a:rPr sz="861" spc="-18" dirty="0">
                <a:latin typeface="Calibri"/>
                <a:cs typeface="Calibri"/>
              </a:rPr>
              <a:t>/</a:t>
            </a:r>
            <a:r>
              <a:rPr sz="861" dirty="0">
                <a:latin typeface="Calibri"/>
                <a:cs typeface="Calibri"/>
              </a:rPr>
              <a:t>-</a:t>
            </a:r>
            <a:endParaRPr sz="861">
              <a:latin typeface="Calibri"/>
              <a:cs typeface="Calibri"/>
            </a:endParaRPr>
          </a:p>
        </p:txBody>
      </p:sp>
      <p:sp>
        <p:nvSpPr>
          <p:cNvPr id="31" name="object 31"/>
          <p:cNvSpPr/>
          <p:nvPr/>
        </p:nvSpPr>
        <p:spPr>
          <a:xfrm>
            <a:off x="1020070" y="888255"/>
            <a:ext cx="2112056" cy="2112631"/>
          </a:xfrm>
          <a:prstGeom prst="rect">
            <a:avLst/>
          </a:prstGeom>
          <a:blipFill>
            <a:blip r:embed="rId1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1958787" y="1266593"/>
            <a:ext cx="316435" cy="316435"/>
          </a:xfrm>
          <a:custGeom>
            <a:avLst/>
            <a:gdLst/>
            <a:ahLst/>
            <a:cxnLst/>
            <a:rect l="l" t="t" r="r" b="b"/>
            <a:pathLst>
              <a:path w="349250" h="349250">
                <a:moveTo>
                  <a:pt x="0" y="348997"/>
                </a:moveTo>
                <a:lnTo>
                  <a:pt x="348907" y="348997"/>
                </a:lnTo>
                <a:lnTo>
                  <a:pt x="348907" y="0"/>
                </a:lnTo>
                <a:lnTo>
                  <a:pt x="0" y="0"/>
                </a:lnTo>
                <a:lnTo>
                  <a:pt x="0" y="348997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2448858" y="2264914"/>
            <a:ext cx="247394" cy="246244"/>
          </a:xfrm>
          <a:custGeom>
            <a:avLst/>
            <a:gdLst/>
            <a:ahLst/>
            <a:cxnLst/>
            <a:rect l="l" t="t" r="r" b="b"/>
            <a:pathLst>
              <a:path w="273050" h="271780">
                <a:moveTo>
                  <a:pt x="0" y="271274"/>
                </a:moveTo>
                <a:lnTo>
                  <a:pt x="272722" y="271274"/>
                </a:lnTo>
                <a:lnTo>
                  <a:pt x="272722" y="0"/>
                </a:lnTo>
                <a:lnTo>
                  <a:pt x="0" y="0"/>
                </a:lnTo>
                <a:lnTo>
                  <a:pt x="0" y="271274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/>
          <p:nvPr/>
        </p:nvSpPr>
        <p:spPr>
          <a:xfrm>
            <a:off x="1388630" y="2263537"/>
            <a:ext cx="422872" cy="422872"/>
          </a:xfrm>
          <a:custGeom>
            <a:avLst/>
            <a:gdLst/>
            <a:ahLst/>
            <a:cxnLst/>
            <a:rect l="l" t="t" r="r" b="b"/>
            <a:pathLst>
              <a:path w="466725" h="466725">
                <a:moveTo>
                  <a:pt x="0" y="466342"/>
                </a:moveTo>
                <a:lnTo>
                  <a:pt x="466214" y="466342"/>
                </a:lnTo>
                <a:lnTo>
                  <a:pt x="466214" y="0"/>
                </a:lnTo>
                <a:lnTo>
                  <a:pt x="0" y="0"/>
                </a:lnTo>
                <a:lnTo>
                  <a:pt x="0" y="466342"/>
                </a:lnTo>
                <a:close/>
              </a:path>
            </a:pathLst>
          </a:custGeom>
          <a:ln w="3175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5" name="object 35"/>
          <p:cNvSpPr/>
          <p:nvPr/>
        </p:nvSpPr>
        <p:spPr>
          <a:xfrm>
            <a:off x="1119833" y="959135"/>
            <a:ext cx="869907" cy="149127"/>
          </a:xfrm>
          <a:prstGeom prst="rect">
            <a:avLst/>
          </a:prstGeom>
          <a:blipFill>
            <a:blip r:embed="rId2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 txBox="1"/>
          <p:nvPr/>
        </p:nvSpPr>
        <p:spPr>
          <a:xfrm>
            <a:off x="1108605" y="963048"/>
            <a:ext cx="804320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5" dirty="0">
                <a:solidFill>
                  <a:srgbClr val="00B050"/>
                </a:solidFill>
                <a:latin typeface="Calibri"/>
                <a:cs typeface="Calibri"/>
              </a:rPr>
              <a:t>T</a:t>
            </a:r>
            <a:r>
              <a:rPr sz="1087" dirty="0">
                <a:solidFill>
                  <a:srgbClr val="00B050"/>
                </a:solidFill>
                <a:latin typeface="Calibri"/>
                <a:cs typeface="Calibri"/>
              </a:rPr>
              <a:t>E</a:t>
            </a:r>
            <a:r>
              <a:rPr sz="1087" spc="-5" dirty="0">
                <a:solidFill>
                  <a:srgbClr val="00B050"/>
                </a:solidFill>
                <a:latin typeface="Calibri"/>
                <a:cs typeface="Calibri"/>
              </a:rPr>
              <a:t>C</a:t>
            </a:r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PR1</a:t>
            </a:r>
            <a:r>
              <a:rPr sz="1087" spc="-63" dirty="0">
                <a:solidFill>
                  <a:srgbClr val="00B050"/>
                </a:solidFill>
                <a:latin typeface="Times New Roman"/>
                <a:cs typeface="Times New Roman"/>
              </a:rPr>
              <a:t> </a:t>
            </a:r>
            <a:r>
              <a:rPr sz="1087" dirty="0">
                <a:latin typeface="Calibri"/>
                <a:cs typeface="Calibri"/>
              </a:rPr>
              <a:t>/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-33" dirty="0">
                <a:solidFill>
                  <a:srgbClr val="FF0000"/>
                </a:solidFill>
                <a:latin typeface="Calibri"/>
                <a:cs typeface="Calibri"/>
              </a:rPr>
              <a:t>G</a:t>
            </a:r>
            <a:r>
              <a:rPr sz="1087" spc="-23" dirty="0">
                <a:solidFill>
                  <a:srgbClr val="FF0000"/>
                </a:solidFill>
                <a:latin typeface="Calibri"/>
                <a:cs typeface="Calibri"/>
              </a:rPr>
              <a:t>al</a:t>
            </a:r>
            <a:r>
              <a:rPr sz="1087" spc="-9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1087">
              <a:latin typeface="Calibri"/>
              <a:cs typeface="Calibri"/>
            </a:endParaRPr>
          </a:p>
        </p:txBody>
      </p:sp>
      <p:sp>
        <p:nvSpPr>
          <p:cNvPr id="37" name="object 37"/>
          <p:cNvSpPr/>
          <p:nvPr/>
        </p:nvSpPr>
        <p:spPr>
          <a:xfrm>
            <a:off x="2695333" y="2667191"/>
            <a:ext cx="238879" cy="117368"/>
          </a:xfrm>
          <a:prstGeom prst="rect">
            <a:avLst/>
          </a:prstGeom>
          <a:blipFill>
            <a:blip r:embed="rId2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 txBox="1"/>
          <p:nvPr/>
        </p:nvSpPr>
        <p:spPr>
          <a:xfrm>
            <a:off x="2684401" y="2672139"/>
            <a:ext cx="238189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u="heavy" spc="-5" dirty="0">
                <a:solidFill>
                  <a:srgbClr val="FFFFFF"/>
                </a:solidFill>
                <a:latin typeface="Calibri"/>
                <a:cs typeface="Calibri"/>
              </a:rPr>
              <a:t>5</a:t>
            </a:r>
            <a:r>
              <a:rPr sz="816" b="1" u="heavy" spc="18" dirty="0">
                <a:solidFill>
                  <a:srgbClr val="FFFFFF"/>
                </a:solidFill>
                <a:latin typeface="Calibri"/>
                <a:cs typeface="Calibri"/>
              </a:rPr>
              <a:t> </a:t>
            </a:r>
            <a:r>
              <a:rPr sz="816" b="1" u="heavy" spc="-28" dirty="0">
                <a:solidFill>
                  <a:srgbClr val="FFFFFF"/>
                </a:solidFill>
                <a:latin typeface="Calibri"/>
                <a:cs typeface="Calibri"/>
              </a:rPr>
              <a:t>µm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39" name="object 39"/>
          <p:cNvSpPr/>
          <p:nvPr/>
        </p:nvSpPr>
        <p:spPr>
          <a:xfrm>
            <a:off x="3397932" y="906090"/>
            <a:ext cx="631718" cy="631718"/>
          </a:xfrm>
          <a:prstGeom prst="rect">
            <a:avLst/>
          </a:prstGeom>
          <a:blipFill>
            <a:blip r:embed="rId2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/>
          <p:nvPr/>
        </p:nvSpPr>
        <p:spPr>
          <a:xfrm>
            <a:off x="3417494" y="4129350"/>
            <a:ext cx="634019" cy="634019"/>
          </a:xfrm>
          <a:prstGeom prst="rect">
            <a:avLst/>
          </a:prstGeom>
          <a:blipFill>
            <a:blip r:embed="rId2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1" name="object 41"/>
          <p:cNvSpPr/>
          <p:nvPr/>
        </p:nvSpPr>
        <p:spPr>
          <a:xfrm>
            <a:off x="4102143" y="4123679"/>
            <a:ext cx="643224" cy="648780"/>
          </a:xfrm>
          <a:prstGeom prst="rect">
            <a:avLst/>
          </a:prstGeom>
          <a:blipFill>
            <a:blip r:embed="rId2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4790821" y="4131650"/>
            <a:ext cx="645525" cy="645525"/>
          </a:xfrm>
          <a:prstGeom prst="rect">
            <a:avLst/>
          </a:prstGeom>
          <a:blipFill>
            <a:blip r:embed="rId2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 txBox="1"/>
          <p:nvPr/>
        </p:nvSpPr>
        <p:spPr>
          <a:xfrm>
            <a:off x="1109986" y="3484745"/>
            <a:ext cx="804320" cy="16729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1087" spc="-5" dirty="0">
                <a:solidFill>
                  <a:srgbClr val="00B050"/>
                </a:solidFill>
                <a:latin typeface="Calibri"/>
                <a:cs typeface="Calibri"/>
              </a:rPr>
              <a:t>T</a:t>
            </a:r>
            <a:r>
              <a:rPr sz="1087" dirty="0">
                <a:solidFill>
                  <a:srgbClr val="00B050"/>
                </a:solidFill>
                <a:latin typeface="Calibri"/>
                <a:cs typeface="Calibri"/>
              </a:rPr>
              <a:t>E</a:t>
            </a:r>
            <a:r>
              <a:rPr sz="1087" spc="-5" dirty="0">
                <a:solidFill>
                  <a:srgbClr val="00B050"/>
                </a:solidFill>
                <a:latin typeface="Calibri"/>
                <a:cs typeface="Calibri"/>
              </a:rPr>
              <a:t>C</a:t>
            </a:r>
            <a:r>
              <a:rPr sz="1087" spc="-9" dirty="0">
                <a:solidFill>
                  <a:srgbClr val="00B050"/>
                </a:solidFill>
                <a:latin typeface="Calibri"/>
                <a:cs typeface="Calibri"/>
              </a:rPr>
              <a:t>PR1</a:t>
            </a:r>
            <a:r>
              <a:rPr sz="1087" spc="-63" dirty="0">
                <a:solidFill>
                  <a:srgbClr val="00B050"/>
                </a:solidFill>
                <a:latin typeface="Times New Roman"/>
                <a:cs typeface="Times New Roman"/>
              </a:rPr>
              <a:t> </a:t>
            </a:r>
            <a:r>
              <a:rPr sz="1087" dirty="0">
                <a:latin typeface="Calibri"/>
                <a:cs typeface="Calibri"/>
              </a:rPr>
              <a:t>/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-33" dirty="0">
                <a:solidFill>
                  <a:srgbClr val="FF0000"/>
                </a:solidFill>
                <a:latin typeface="Calibri"/>
                <a:cs typeface="Calibri"/>
              </a:rPr>
              <a:t>G</a:t>
            </a:r>
            <a:r>
              <a:rPr sz="1087" spc="-23" dirty="0">
                <a:solidFill>
                  <a:srgbClr val="FF0000"/>
                </a:solidFill>
                <a:latin typeface="Calibri"/>
                <a:cs typeface="Calibri"/>
              </a:rPr>
              <a:t>al</a:t>
            </a:r>
            <a:r>
              <a:rPr sz="1087" spc="-9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endParaRPr sz="1087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76630" y="8208012"/>
            <a:ext cx="6485184" cy="123264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 marR="4602" algn="just">
              <a:lnSpc>
                <a:spcPct val="151400"/>
              </a:lnSpc>
            </a:pPr>
            <a:r>
              <a:rPr sz="1087" b="1" dirty="0">
                <a:latin typeface="Times New Roman"/>
                <a:cs typeface="Times New Roman"/>
              </a:rPr>
              <a:t>Su</a:t>
            </a:r>
            <a:r>
              <a:rPr sz="1087" b="1" spc="-9" dirty="0">
                <a:latin typeface="Times New Roman"/>
                <a:cs typeface="Times New Roman"/>
              </a:rPr>
              <a:t>p</a:t>
            </a:r>
            <a:r>
              <a:rPr sz="1087" b="1" dirty="0">
                <a:latin typeface="Times New Roman"/>
                <a:cs typeface="Times New Roman"/>
              </a:rPr>
              <a:t>p</a:t>
            </a:r>
            <a:r>
              <a:rPr sz="1087" b="1" spc="-9" dirty="0">
                <a:latin typeface="Times New Roman"/>
                <a:cs typeface="Times New Roman"/>
              </a:rPr>
              <a:t>lem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</a:t>
            </a:r>
            <a:r>
              <a:rPr sz="1087" b="1" spc="-5" dirty="0">
                <a:latin typeface="Times New Roman"/>
                <a:cs typeface="Times New Roman"/>
              </a:rPr>
              <a:t>tal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figu</a:t>
            </a:r>
            <a:r>
              <a:rPr sz="1087" b="1" spc="-14" dirty="0">
                <a:latin typeface="Times New Roman"/>
                <a:cs typeface="Times New Roman"/>
              </a:rPr>
              <a:t>r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8. </a:t>
            </a:r>
            <a:r>
              <a:rPr sz="1087" b="1" spc="-113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R</a:t>
            </a:r>
            <a:r>
              <a:rPr sz="1087" b="1" spc="-9" dirty="0">
                <a:latin typeface="Times New Roman"/>
                <a:cs typeface="Times New Roman"/>
              </a:rPr>
              <a:t>e</a:t>
            </a:r>
            <a:r>
              <a:rPr sz="1087" b="1" spc="-14" dirty="0">
                <a:latin typeface="Times New Roman"/>
                <a:cs typeface="Times New Roman"/>
              </a:rPr>
              <a:t>cr</a:t>
            </a:r>
            <a:r>
              <a:rPr sz="1087" b="1" dirty="0">
                <a:latin typeface="Times New Roman"/>
                <a:cs typeface="Times New Roman"/>
              </a:rPr>
              <a:t>u</a:t>
            </a:r>
            <a:r>
              <a:rPr sz="1087" b="1" spc="-5" dirty="0">
                <a:latin typeface="Times New Roman"/>
                <a:cs typeface="Times New Roman"/>
              </a:rPr>
              <a:t>itm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nt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of </a:t>
            </a:r>
            <a:r>
              <a:rPr sz="1087" b="1" spc="-86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galectin-</a:t>
            </a:r>
            <a:r>
              <a:rPr sz="1087" b="1" dirty="0">
                <a:latin typeface="Times New Roman"/>
                <a:cs typeface="Times New Roman"/>
              </a:rPr>
              <a:t>3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and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spc="-9" dirty="0">
                <a:latin typeface="Times New Roman"/>
                <a:cs typeface="Times New Roman"/>
              </a:rPr>
              <a:t>GF</a:t>
            </a:r>
            <a:r>
              <a:rPr sz="1087" b="1" spc="-5" dirty="0">
                <a:latin typeface="Times New Roman"/>
                <a:cs typeface="Times New Roman"/>
              </a:rPr>
              <a:t>P-</a:t>
            </a:r>
            <a:r>
              <a:rPr sz="1087" b="1" spc="-9" dirty="0">
                <a:latin typeface="Times New Roman"/>
                <a:cs typeface="Times New Roman"/>
              </a:rPr>
              <a:t>lysen</a:t>
            </a:r>
            <a:r>
              <a:rPr sz="1087" b="1" spc="-14" dirty="0">
                <a:latin typeface="Times New Roman"/>
                <a:cs typeface="Times New Roman"/>
              </a:rPr>
              <a:t>i</a:t>
            </a:r>
            <a:r>
              <a:rPr sz="1087" b="1" dirty="0">
                <a:latin typeface="Times New Roman"/>
                <a:cs typeface="Times New Roman"/>
              </a:rPr>
              <a:t>n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to </a:t>
            </a:r>
            <a:r>
              <a:rPr sz="1087" b="1" spc="-103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lysoso</a:t>
            </a:r>
            <a:r>
              <a:rPr sz="1087" b="1" spc="5" dirty="0">
                <a:latin typeface="Times New Roman"/>
                <a:cs typeface="Times New Roman"/>
              </a:rPr>
              <a:t>m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s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c</a:t>
            </a:r>
            <a:r>
              <a:rPr sz="1087" b="1" spc="-9" dirty="0">
                <a:latin typeface="Times New Roman"/>
                <a:cs typeface="Times New Roman"/>
              </a:rPr>
              <a:t>o</a:t>
            </a:r>
            <a:r>
              <a:rPr sz="1087" b="1" spc="-14" dirty="0">
                <a:latin typeface="Times New Roman"/>
                <a:cs typeface="Times New Roman"/>
              </a:rPr>
              <a:t>rre</a:t>
            </a:r>
            <a:r>
              <a:rPr sz="1087" b="1" spc="-5" dirty="0">
                <a:latin typeface="Times New Roman"/>
                <a:cs typeface="Times New Roman"/>
              </a:rPr>
              <a:t>lat</a:t>
            </a:r>
            <a:r>
              <a:rPr sz="1087" b="1" spc="-18" dirty="0">
                <a:latin typeface="Times New Roman"/>
                <a:cs typeface="Times New Roman"/>
              </a:rPr>
              <a:t>e</a:t>
            </a:r>
            <a:r>
              <a:rPr sz="1087" b="1" dirty="0">
                <a:latin typeface="Times New Roman"/>
                <a:cs typeface="Times New Roman"/>
              </a:rPr>
              <a:t>s </a:t>
            </a:r>
            <a:r>
              <a:rPr sz="1087" b="1" spc="-91" dirty="0">
                <a:latin typeface="Times New Roman"/>
                <a:cs typeface="Times New Roman"/>
              </a:rPr>
              <a:t> </a:t>
            </a:r>
            <a:r>
              <a:rPr sz="1087" b="1" spc="-5" dirty="0">
                <a:latin typeface="Times New Roman"/>
                <a:cs typeface="Times New Roman"/>
              </a:rPr>
              <a:t>wit</a:t>
            </a:r>
            <a:r>
              <a:rPr sz="1087" b="1" dirty="0">
                <a:latin typeface="Times New Roman"/>
                <a:cs typeface="Times New Roman"/>
              </a:rPr>
              <a:t>h </a:t>
            </a:r>
            <a:r>
              <a:rPr sz="1087" b="1" spc="-100" dirty="0">
                <a:latin typeface="Times New Roman"/>
                <a:cs typeface="Times New Roman"/>
              </a:rPr>
              <a:t> </a:t>
            </a:r>
            <a:r>
              <a:rPr sz="1087" b="1" spc="-14" dirty="0">
                <a:latin typeface="Times New Roman"/>
                <a:cs typeface="Times New Roman"/>
              </a:rPr>
              <a:t>re</a:t>
            </a:r>
            <a:r>
              <a:rPr sz="1087" b="1" spc="-5" dirty="0">
                <a:latin typeface="Times New Roman"/>
                <a:cs typeface="Times New Roman"/>
              </a:rPr>
              <a:t>lease</a:t>
            </a:r>
            <a:r>
              <a:rPr sz="1087" b="1" dirty="0">
                <a:latin typeface="Times New Roman"/>
                <a:cs typeface="Times New Roman"/>
              </a:rPr>
              <a:t> </a:t>
            </a:r>
            <a:r>
              <a:rPr sz="1087" b="1" spc="-109" dirty="0">
                <a:latin typeface="Times New Roman"/>
                <a:cs typeface="Times New Roman"/>
              </a:rPr>
              <a:t> </a:t>
            </a:r>
            <a:r>
              <a:rPr sz="1087" b="1" dirty="0">
                <a:latin typeface="Times New Roman"/>
                <a:cs typeface="Times New Roman"/>
              </a:rPr>
              <a:t>of d</a:t>
            </a:r>
            <a:r>
              <a:rPr sz="1087" b="1" spc="-14" dirty="0">
                <a:latin typeface="Times New Roman"/>
                <a:cs typeface="Times New Roman"/>
              </a:rPr>
              <a:t>e</a:t>
            </a:r>
            <a:r>
              <a:rPr sz="1087" b="1" spc="-5" dirty="0">
                <a:latin typeface="Times New Roman"/>
                <a:cs typeface="Times New Roman"/>
              </a:rPr>
              <a:t>xt</a:t>
            </a:r>
            <a:r>
              <a:rPr sz="1087" b="1" spc="-18" dirty="0">
                <a:latin typeface="Times New Roman"/>
                <a:cs typeface="Times New Roman"/>
              </a:rPr>
              <a:t>r</a:t>
            </a:r>
            <a:r>
              <a:rPr sz="1087" b="1" dirty="0">
                <a:latin typeface="Times New Roman"/>
                <a:cs typeface="Times New Roman"/>
              </a:rPr>
              <a:t>an. </a:t>
            </a:r>
            <a:r>
              <a:rPr sz="1087" b="1" spc="-41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ATG16L1-/</a:t>
            </a:r>
            <a:r>
              <a:rPr sz="1087" dirty="0">
                <a:latin typeface="Times New Roman"/>
                <a:cs typeface="Times New Roman"/>
              </a:rPr>
              <a:t>-</a:t>
            </a:r>
            <a:r>
              <a:rPr sz="1087" spc="-36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ME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41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9" dirty="0">
                <a:latin typeface="Times New Roman"/>
                <a:cs typeface="Times New Roman"/>
              </a:rPr>
              <a:t>xpr</a:t>
            </a:r>
            <a:r>
              <a:rPr sz="1087" spc="-18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ss</a:t>
            </a:r>
            <a:r>
              <a:rPr sz="1087" dirty="0">
                <a:latin typeface="Times New Roman"/>
                <a:cs typeface="Times New Roman"/>
              </a:rPr>
              <a:t>ing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G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spc="9" dirty="0">
                <a:latin typeface="Times New Roman"/>
                <a:cs typeface="Times New Roman"/>
              </a:rPr>
              <a:t>P</a:t>
            </a:r>
            <a:r>
              <a:rPr sz="1087" spc="-5" dirty="0">
                <a:latin typeface="Times New Roman"/>
                <a:cs typeface="Times New Roman"/>
              </a:rPr>
              <a:t>-</a:t>
            </a:r>
            <a:r>
              <a:rPr sz="1087" dirty="0">
                <a:latin typeface="Times New Roman"/>
                <a:cs typeface="Times New Roman"/>
              </a:rPr>
              <a:t>lys</a:t>
            </a:r>
            <a:r>
              <a:rPr sz="1087" spc="-5" dirty="0">
                <a:latin typeface="Times New Roman"/>
                <a:cs typeface="Times New Roman"/>
              </a:rPr>
              <a:t>e</a:t>
            </a:r>
            <a:r>
              <a:rPr sz="1087" spc="-9" dirty="0">
                <a:latin typeface="Times New Roman"/>
                <a:cs typeface="Times New Roman"/>
              </a:rPr>
              <a:t>nin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w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re</a:t>
            </a:r>
            <a:r>
              <a:rPr sz="1087" spc="-54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spc="-5" dirty="0">
                <a:latin typeface="Times New Roman"/>
                <a:cs typeface="Times New Roman"/>
              </a:rPr>
              <a:t>ultur</a:t>
            </a:r>
            <a:r>
              <a:rPr sz="1087" spc="-18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in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D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xt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5" dirty="0">
                <a:latin typeface="Times New Roman"/>
                <a:cs typeface="Times New Roman"/>
              </a:rPr>
              <a:t>n</a:t>
            </a:r>
            <a:r>
              <a:rPr sz="1087" spc="-5" dirty="0">
                <a:latin typeface="Times New Roman"/>
                <a:cs typeface="Times New Roman"/>
              </a:rPr>
              <a:t>-</a:t>
            </a:r>
            <a:r>
              <a:rPr sz="1087" spc="-9" dirty="0">
                <a:latin typeface="Times New Roman"/>
                <a:cs typeface="Times New Roman"/>
              </a:rPr>
              <a:t>R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baseline="31250" dirty="0">
                <a:latin typeface="Times New Roman"/>
                <a:cs typeface="Times New Roman"/>
              </a:rPr>
              <a:t>R </a:t>
            </a:r>
            <a:r>
              <a:rPr sz="1087" spc="34" baseline="31250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(300mg/ml)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to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lab</a:t>
            </a:r>
            <a:r>
              <a:rPr sz="1087" spc="-18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l</a:t>
            </a:r>
            <a:r>
              <a:rPr sz="1087" spc="-45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lysos</a:t>
            </a:r>
            <a:r>
              <a:rPr sz="1087" spc="-9" dirty="0">
                <a:latin typeface="Times New Roman"/>
                <a:cs typeface="Times New Roman"/>
              </a:rPr>
              <a:t>om</a:t>
            </a:r>
            <a:r>
              <a:rPr sz="1087" spc="-23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s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incub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ted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wit</a:t>
            </a:r>
            <a:r>
              <a:rPr sz="1087" spc="-9" dirty="0">
                <a:latin typeface="Times New Roman"/>
                <a:cs typeface="Times New Roman"/>
              </a:rPr>
              <a:t>h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spc="-9" dirty="0">
                <a:latin typeface="Times New Roman"/>
                <a:cs typeface="Times New Roman"/>
              </a:rPr>
              <a:t>hloroquine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(200µM)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for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15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o</a:t>
            </a:r>
            <a:r>
              <a:rPr sz="1087" dirty="0">
                <a:latin typeface="Times New Roman"/>
                <a:cs typeface="Times New Roman"/>
              </a:rPr>
              <a:t>r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40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minutes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3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indi</a:t>
            </a:r>
            <a:r>
              <a:rPr sz="1087" spc="-14" dirty="0">
                <a:latin typeface="Times New Roman"/>
                <a:cs typeface="Times New Roman"/>
              </a:rPr>
              <a:t>ca</a:t>
            </a:r>
            <a:r>
              <a:rPr sz="1087" spc="-5" dirty="0">
                <a:latin typeface="Times New Roman"/>
                <a:cs typeface="Times New Roman"/>
              </a:rPr>
              <a:t>ted.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-18" dirty="0">
                <a:latin typeface="Times New Roman"/>
                <a:cs typeface="Times New Roman"/>
              </a:rPr>
              <a:t>I</a:t>
            </a:r>
            <a:r>
              <a:rPr sz="1087" spc="-9" dirty="0">
                <a:latin typeface="Times New Roman"/>
                <a:cs typeface="Times New Roman"/>
              </a:rPr>
              <a:t>mag</a:t>
            </a:r>
            <a:r>
              <a:rPr sz="1087" spc="-18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s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sho</a:t>
            </a:r>
            <a:r>
              <a:rPr sz="1087" dirty="0">
                <a:latin typeface="Times New Roman"/>
                <a:cs typeface="Times New Roman"/>
              </a:rPr>
              <a:t>w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dis</a:t>
            </a:r>
            <a:r>
              <a:rPr sz="1087" dirty="0">
                <a:latin typeface="Times New Roman"/>
                <a:cs typeface="Times New Roman"/>
              </a:rPr>
              <a:t>t</a:t>
            </a:r>
            <a:r>
              <a:rPr sz="1087" spc="-5" dirty="0">
                <a:latin typeface="Times New Roman"/>
                <a:cs typeface="Times New Roman"/>
              </a:rPr>
              <a:t>ributi</a:t>
            </a:r>
            <a:r>
              <a:rPr sz="1087" dirty="0">
                <a:latin typeface="Times New Roman"/>
                <a:cs typeface="Times New Roman"/>
              </a:rPr>
              <a:t>on</a:t>
            </a:r>
            <a:r>
              <a:rPr sz="1087" spc="-23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of</a:t>
            </a:r>
            <a:r>
              <a:rPr sz="1087" spc="-2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G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spc="14" dirty="0">
                <a:latin typeface="Times New Roman"/>
                <a:cs typeface="Times New Roman"/>
              </a:rPr>
              <a:t>P</a:t>
            </a:r>
            <a:r>
              <a:rPr sz="1087" spc="-5" dirty="0">
                <a:latin typeface="Times New Roman"/>
                <a:cs typeface="Times New Roman"/>
              </a:rPr>
              <a:t>-lysenin, D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-5" dirty="0">
                <a:latin typeface="Times New Roman"/>
                <a:cs typeface="Times New Roman"/>
              </a:rPr>
              <a:t>xtr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</a:t>
            </a:r>
            <a:r>
              <a:rPr sz="1087" spc="-5" dirty="0">
                <a:latin typeface="Times New Roman"/>
                <a:cs typeface="Times New Roman"/>
              </a:rPr>
              <a:t>-</a:t>
            </a:r>
            <a:r>
              <a:rPr sz="1087" spc="-9" dirty="0">
                <a:latin typeface="Times New Roman"/>
                <a:cs typeface="Times New Roman"/>
              </a:rPr>
              <a:t>R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</a:t>
            </a:r>
            <a:r>
              <a:rPr sz="1087" baseline="31250" dirty="0">
                <a:latin typeface="Times New Roman"/>
                <a:cs typeface="Times New Roman"/>
              </a:rPr>
              <a:t>R </a:t>
            </a:r>
            <a:r>
              <a:rPr sz="1087" spc="-88" baseline="31250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le</a:t>
            </a:r>
            <a:r>
              <a:rPr sz="1087" spc="-18" dirty="0">
                <a:latin typeface="Times New Roman"/>
                <a:cs typeface="Times New Roman"/>
              </a:rPr>
              <a:t>c</a:t>
            </a:r>
            <a:r>
              <a:rPr sz="1087" dirty="0">
                <a:latin typeface="Times New Roman"/>
                <a:cs typeface="Times New Roman"/>
              </a:rPr>
              <a:t>t</a:t>
            </a:r>
            <a:r>
              <a:rPr sz="1087" spc="-5" dirty="0">
                <a:latin typeface="Times New Roman"/>
                <a:cs typeface="Times New Roman"/>
              </a:rPr>
              <a:t>in-</a:t>
            </a:r>
            <a:r>
              <a:rPr sz="1087" dirty="0">
                <a:latin typeface="Times New Roman"/>
                <a:cs typeface="Times New Roman"/>
              </a:rPr>
              <a:t>3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(</a:t>
            </a:r>
            <a:r>
              <a:rPr sz="1087" spc="-9" dirty="0">
                <a:latin typeface="Times New Roman"/>
                <a:cs typeface="Times New Roman"/>
              </a:rPr>
              <a:t>f</a:t>
            </a:r>
            <a:r>
              <a:rPr sz="1087" spc="-5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r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r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dirty="0">
                <a:latin typeface="Times New Roman"/>
                <a:cs typeface="Times New Roman"/>
              </a:rPr>
              <a:t>d).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Aste</a:t>
            </a:r>
            <a:r>
              <a:rPr sz="1087" dirty="0">
                <a:latin typeface="Times New Roman"/>
                <a:cs typeface="Times New Roman"/>
              </a:rPr>
              <a:t>risks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i</a:t>
            </a:r>
            <a:r>
              <a:rPr sz="1087" spc="-9" dirty="0">
                <a:latin typeface="Times New Roman"/>
                <a:cs typeface="Times New Roman"/>
              </a:rPr>
              <a:t>ndic</a:t>
            </a:r>
            <a:r>
              <a:rPr sz="1087" spc="-18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te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dirty="0">
                <a:latin typeface="Times New Roman"/>
                <a:cs typeface="Times New Roman"/>
              </a:rPr>
              <a:t>pu</a:t>
            </a:r>
            <a:r>
              <a:rPr sz="1087" spc="9" dirty="0">
                <a:latin typeface="Times New Roman"/>
                <a:cs typeface="Times New Roman"/>
              </a:rPr>
              <a:t>n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spc="-5" dirty="0">
                <a:latin typeface="Times New Roman"/>
                <a:cs typeface="Times New Roman"/>
              </a:rPr>
              <a:t>ta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positive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5" dirty="0">
                <a:latin typeface="Times New Roman"/>
                <a:cs typeface="Times New Roman"/>
              </a:rPr>
              <a:t>f</a:t>
            </a:r>
            <a:r>
              <a:rPr sz="1087" dirty="0">
                <a:latin typeface="Times New Roman"/>
                <a:cs typeface="Times New Roman"/>
              </a:rPr>
              <a:t>or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lysenin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dirty="0">
                <a:latin typeface="Times New Roman"/>
                <a:cs typeface="Times New Roman"/>
              </a:rPr>
              <a:t>nd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spc="-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le</a:t>
            </a:r>
            <a:r>
              <a:rPr sz="1087" spc="-14" dirty="0">
                <a:latin typeface="Times New Roman"/>
                <a:cs typeface="Times New Roman"/>
              </a:rPr>
              <a:t>c</a:t>
            </a:r>
            <a:r>
              <a:rPr sz="1087" spc="-5" dirty="0">
                <a:latin typeface="Times New Roman"/>
                <a:cs typeface="Times New Roman"/>
              </a:rPr>
              <a:t>ti</a:t>
            </a:r>
            <a:r>
              <a:rPr sz="1087" spc="28" dirty="0">
                <a:latin typeface="Times New Roman"/>
                <a:cs typeface="Times New Roman"/>
              </a:rPr>
              <a:t>n</a:t>
            </a:r>
            <a:r>
              <a:rPr sz="1087" spc="-5" dirty="0">
                <a:latin typeface="Times New Roman"/>
                <a:cs typeface="Times New Roman"/>
              </a:rPr>
              <a:t>-</a:t>
            </a:r>
            <a:r>
              <a:rPr sz="1087" dirty="0">
                <a:latin typeface="Times New Roman"/>
                <a:cs typeface="Times New Roman"/>
              </a:rPr>
              <a:t>3</a:t>
            </a:r>
            <a:r>
              <a:rPr sz="1087" spc="28" dirty="0">
                <a:latin typeface="Times New Roman"/>
                <a:cs typeface="Times New Roman"/>
              </a:rPr>
              <a:t> </a:t>
            </a:r>
            <a:r>
              <a:rPr sz="1087" spc="-5" dirty="0">
                <a:latin typeface="Times New Roman"/>
                <a:cs typeface="Times New Roman"/>
              </a:rPr>
              <a:t>that</a:t>
            </a:r>
            <a:r>
              <a:rPr sz="1087" spc="18" dirty="0">
                <a:latin typeface="Times New Roman"/>
                <a:cs typeface="Times New Roman"/>
              </a:rPr>
              <a:t> 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5" dirty="0">
                <a:latin typeface="Times New Roman"/>
                <a:cs typeface="Times New Roman"/>
              </a:rPr>
              <a:t>r</a:t>
            </a:r>
            <a:r>
              <a:rPr sz="1087" spc="-9" dirty="0">
                <a:latin typeface="Times New Roman"/>
                <a:cs typeface="Times New Roman"/>
              </a:rPr>
              <a:t>e</a:t>
            </a:r>
            <a:r>
              <a:rPr sz="1087" spc="14" dirty="0">
                <a:latin typeface="Times New Roman"/>
                <a:cs typeface="Times New Roman"/>
              </a:rPr>
              <a:t> </a:t>
            </a:r>
            <a:r>
              <a:rPr sz="1087" spc="9" dirty="0">
                <a:latin typeface="Times New Roman"/>
                <a:cs typeface="Times New Roman"/>
              </a:rPr>
              <a:t>n</a:t>
            </a:r>
            <a:r>
              <a:rPr sz="1087" spc="-14" dirty="0">
                <a:latin typeface="Times New Roman"/>
                <a:cs typeface="Times New Roman"/>
              </a:rPr>
              <a:t>e</a:t>
            </a:r>
            <a:r>
              <a:rPr sz="1087" spc="-9" dirty="0">
                <a:latin typeface="Times New Roman"/>
                <a:cs typeface="Times New Roman"/>
              </a:rPr>
              <a:t>g</a:t>
            </a:r>
            <a:r>
              <a:rPr sz="1087" spc="-14" dirty="0">
                <a:latin typeface="Times New Roman"/>
                <a:cs typeface="Times New Roman"/>
              </a:rPr>
              <a:t>a</a:t>
            </a:r>
            <a:r>
              <a:rPr sz="1087" spc="-5" dirty="0">
                <a:latin typeface="Times New Roman"/>
                <a:cs typeface="Times New Roman"/>
              </a:rPr>
              <a:t>tive</a:t>
            </a:r>
            <a:r>
              <a:rPr lang="en-GB" sz="1087" spc="-5" dirty="0">
                <a:latin typeface="Times New Roman"/>
                <a:cs typeface="Times New Roman"/>
              </a:rPr>
              <a:t> </a:t>
            </a:r>
            <a:r>
              <a:rPr lang="en-GB" sz="1087" dirty="0">
                <a:latin typeface="Times New Roman"/>
                <a:cs typeface="Times New Roman"/>
              </a:rPr>
              <a:t>for</a:t>
            </a:r>
            <a:r>
              <a:rPr lang="en-GB" sz="1087" spc="-9" dirty="0">
                <a:latin typeface="Times New Roman"/>
                <a:cs typeface="Times New Roman"/>
              </a:rPr>
              <a:t> d</a:t>
            </a:r>
            <a:r>
              <a:rPr lang="en-GB" sz="1087" spc="-14" dirty="0">
                <a:latin typeface="Times New Roman"/>
                <a:cs typeface="Times New Roman"/>
              </a:rPr>
              <a:t>e</a:t>
            </a:r>
            <a:r>
              <a:rPr lang="en-GB" sz="1087" spc="-5" dirty="0">
                <a:latin typeface="Times New Roman"/>
                <a:cs typeface="Times New Roman"/>
              </a:rPr>
              <a:t>xtr</a:t>
            </a:r>
            <a:r>
              <a:rPr lang="en-GB" sz="1087" spc="-18" dirty="0">
                <a:latin typeface="Times New Roman"/>
                <a:cs typeface="Times New Roman"/>
              </a:rPr>
              <a:t>a</a:t>
            </a:r>
            <a:r>
              <a:rPr lang="en-GB" sz="1087" dirty="0">
                <a:latin typeface="Times New Roman"/>
                <a:cs typeface="Times New Roman"/>
              </a:rPr>
              <a:t>n. </a:t>
            </a:r>
            <a:r>
              <a:rPr lang="en-GB" sz="1087" spc="33" dirty="0">
                <a:latin typeface="Times New Roman"/>
                <a:cs typeface="Times New Roman"/>
              </a:rPr>
              <a:t>S</a:t>
            </a:r>
            <a:r>
              <a:rPr lang="en-GB" sz="1087" spc="18" dirty="0">
                <a:latin typeface="Times New Roman"/>
                <a:cs typeface="Times New Roman"/>
              </a:rPr>
              <a:t>c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4" dirty="0">
                <a:latin typeface="Times New Roman"/>
                <a:cs typeface="Times New Roman"/>
              </a:rPr>
              <a:t>l</a:t>
            </a:r>
            <a:r>
              <a:rPr lang="en-GB" sz="1087" spc="18" dirty="0">
                <a:latin typeface="Times New Roman"/>
                <a:cs typeface="Times New Roman"/>
              </a:rPr>
              <a:t>e</a:t>
            </a:r>
            <a:r>
              <a:rPr lang="en-GB" sz="1087" spc="-5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b</a:t>
            </a:r>
            <a:r>
              <a:rPr lang="en-GB" sz="1087" spc="9" dirty="0">
                <a:latin typeface="Times New Roman"/>
                <a:cs typeface="Times New Roman"/>
              </a:rPr>
              <a:t>a</a:t>
            </a:r>
            <a:r>
              <a:rPr lang="en-GB" sz="1087" spc="18" dirty="0">
                <a:latin typeface="Times New Roman"/>
                <a:cs typeface="Times New Roman"/>
              </a:rPr>
              <a:t>r</a:t>
            </a:r>
            <a:r>
              <a:rPr lang="en-GB" sz="1087" dirty="0">
                <a:latin typeface="Times New Roman"/>
                <a:cs typeface="Times New Roman"/>
              </a:rPr>
              <a:t> </a:t>
            </a:r>
            <a:r>
              <a:rPr lang="en-GB" sz="1087" spc="33" dirty="0">
                <a:latin typeface="Times New Roman"/>
                <a:cs typeface="Times New Roman"/>
              </a:rPr>
              <a:t>5</a:t>
            </a:r>
            <a:r>
              <a:rPr lang="en-GB" sz="1087" spc="33" dirty="0">
                <a:latin typeface="Symbol"/>
                <a:cs typeface="Symbol"/>
              </a:rPr>
              <a:t></a:t>
            </a:r>
            <a:r>
              <a:rPr lang="en-GB" sz="1087" spc="18" dirty="0">
                <a:latin typeface="Times New Roman"/>
                <a:cs typeface="Times New Roman"/>
              </a:rPr>
              <a:t>m.</a:t>
            </a:r>
            <a:endParaRPr lang="en-GB" sz="1087" dirty="0">
              <a:latin typeface="Times New Roman"/>
              <a:cs typeface="Times New Roman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268731" y="4583519"/>
            <a:ext cx="380296" cy="13939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06" b="1" spc="-14" dirty="0">
                <a:latin typeface="Calibri"/>
                <a:cs typeface="Calibri"/>
              </a:rPr>
              <a:t>C</a:t>
            </a:r>
            <a:r>
              <a:rPr sz="906" b="1" spc="-5" dirty="0">
                <a:latin typeface="Calibri"/>
                <a:cs typeface="Calibri"/>
              </a:rPr>
              <a:t>h</a:t>
            </a:r>
            <a:r>
              <a:rPr sz="906" b="1" spc="-9" dirty="0">
                <a:latin typeface="Calibri"/>
                <a:cs typeface="Calibri"/>
              </a:rPr>
              <a:t>q</a:t>
            </a:r>
            <a:r>
              <a:rPr sz="906" b="1" spc="-23" dirty="0">
                <a:latin typeface="Times New Roman"/>
                <a:cs typeface="Times New Roman"/>
              </a:rPr>
              <a:t> </a:t>
            </a:r>
            <a:r>
              <a:rPr sz="906" b="1" spc="-5" dirty="0">
                <a:latin typeface="Calibri"/>
                <a:cs typeface="Calibri"/>
              </a:rPr>
              <a:t>40’</a:t>
            </a:r>
            <a:endParaRPr sz="906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3439933" y="4634609"/>
            <a:ext cx="546568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5" dirty="0">
                <a:solidFill>
                  <a:srgbClr val="00B050"/>
                </a:solidFill>
                <a:latin typeface="Calibri"/>
                <a:cs typeface="Calibri"/>
              </a:rPr>
              <a:t>Lyse</a:t>
            </a:r>
            <a:r>
              <a:rPr sz="816" b="1" spc="-9" dirty="0">
                <a:solidFill>
                  <a:srgbClr val="00B050"/>
                </a:solidFill>
                <a:latin typeface="Calibri"/>
                <a:cs typeface="Calibri"/>
              </a:rPr>
              <a:t>nin</a:t>
            </a:r>
            <a:r>
              <a:rPr sz="816" b="1" dirty="0">
                <a:solidFill>
                  <a:srgbClr val="00B050"/>
                </a:solidFill>
                <a:latin typeface="Calibri"/>
                <a:cs typeface="Calibri"/>
              </a:rPr>
              <a:t>-</a:t>
            </a:r>
            <a:r>
              <a:rPr sz="816" b="1" spc="-5" dirty="0">
                <a:solidFill>
                  <a:srgbClr val="00B050"/>
                </a:solidFill>
                <a:latin typeface="Calibri"/>
                <a:cs typeface="Calibri"/>
              </a:rPr>
              <a:t>GFP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4168997" y="4630466"/>
            <a:ext cx="367638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5" dirty="0">
                <a:solidFill>
                  <a:srgbClr val="FF0000"/>
                </a:solidFill>
                <a:latin typeface="Calibri"/>
                <a:cs typeface="Calibri"/>
              </a:rPr>
              <a:t>D</a:t>
            </a:r>
            <a:r>
              <a:rPr sz="816" b="1" dirty="0">
                <a:solidFill>
                  <a:srgbClr val="FF0000"/>
                </a:solidFill>
                <a:latin typeface="Calibri"/>
                <a:cs typeface="Calibri"/>
              </a:rPr>
              <a:t>e</a:t>
            </a:r>
            <a:r>
              <a:rPr sz="816" b="1" spc="-9" dirty="0">
                <a:solidFill>
                  <a:srgbClr val="FF0000"/>
                </a:solidFill>
                <a:latin typeface="Calibri"/>
                <a:cs typeface="Calibri"/>
              </a:rPr>
              <a:t>x</a:t>
            </a:r>
            <a:r>
              <a:rPr sz="816" b="1" dirty="0">
                <a:solidFill>
                  <a:srgbClr val="FF0000"/>
                </a:solidFill>
                <a:latin typeface="Calibri"/>
                <a:cs typeface="Calibri"/>
              </a:rPr>
              <a:t>tr</a:t>
            </a:r>
            <a:r>
              <a:rPr sz="816" b="1" spc="-5" dirty="0">
                <a:solidFill>
                  <a:srgbClr val="FF0000"/>
                </a:solidFill>
                <a:latin typeface="Calibri"/>
                <a:cs typeface="Calibri"/>
              </a:rPr>
              <a:t>an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4837652" y="4630466"/>
            <a:ext cx="218052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9" dirty="0">
                <a:solidFill>
                  <a:srgbClr val="FF00FF"/>
                </a:solidFill>
                <a:latin typeface="Calibri"/>
                <a:cs typeface="Calibri"/>
              </a:rPr>
              <a:t>Gal</a:t>
            </a:r>
            <a:r>
              <a:rPr sz="816" b="1" spc="-5" dirty="0">
                <a:solidFill>
                  <a:srgbClr val="FF00FF"/>
                </a:solidFill>
                <a:latin typeface="Calibri"/>
                <a:cs typeface="Calibri"/>
              </a:rPr>
              <a:t>3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3438090" y="4774841"/>
            <a:ext cx="554421" cy="146771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" name="object 8"/>
          <p:cNvSpPr/>
          <p:nvPr/>
        </p:nvSpPr>
        <p:spPr>
          <a:xfrm>
            <a:off x="4066358" y="4774841"/>
            <a:ext cx="554421" cy="1467715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" name="object 9"/>
          <p:cNvSpPr/>
          <p:nvPr/>
        </p:nvSpPr>
        <p:spPr>
          <a:xfrm>
            <a:off x="4704175" y="4774841"/>
            <a:ext cx="554421" cy="1467715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" name="object 10"/>
          <p:cNvSpPr/>
          <p:nvPr/>
        </p:nvSpPr>
        <p:spPr>
          <a:xfrm>
            <a:off x="2804761" y="4774841"/>
            <a:ext cx="554421" cy="1467715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" name="object 11"/>
          <p:cNvSpPr/>
          <p:nvPr/>
        </p:nvSpPr>
        <p:spPr>
          <a:xfrm>
            <a:off x="3033745" y="517208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" name="object 12"/>
          <p:cNvSpPr/>
          <p:nvPr/>
        </p:nvSpPr>
        <p:spPr>
          <a:xfrm>
            <a:off x="2837672" y="5501525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586" y="33274"/>
                </a:lnTo>
                <a:lnTo>
                  <a:pt x="76705" y="33274"/>
                </a:lnTo>
                <a:lnTo>
                  <a:pt x="76705" y="17399"/>
                </a:lnTo>
                <a:lnTo>
                  <a:pt x="116205" y="17399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008" y="33274"/>
                </a:lnTo>
                <a:lnTo>
                  <a:pt x="64008" y="17399"/>
                </a:lnTo>
                <a:close/>
              </a:path>
              <a:path w="140335" h="50800">
                <a:moveTo>
                  <a:pt x="116205" y="17399"/>
                </a:moveTo>
                <a:lnTo>
                  <a:pt x="76705" y="17399"/>
                </a:lnTo>
                <a:lnTo>
                  <a:pt x="76705" y="33274"/>
                </a:lnTo>
                <a:lnTo>
                  <a:pt x="116586" y="33274"/>
                </a:lnTo>
                <a:lnTo>
                  <a:pt x="140208" y="25400"/>
                </a:lnTo>
                <a:lnTo>
                  <a:pt x="116205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" name="object 13"/>
          <p:cNvSpPr/>
          <p:nvPr/>
        </p:nvSpPr>
        <p:spPr>
          <a:xfrm>
            <a:off x="2901074" y="5874801"/>
            <a:ext cx="46026" cy="147286"/>
          </a:xfrm>
          <a:custGeom>
            <a:avLst/>
            <a:gdLst/>
            <a:ahLst/>
            <a:cxnLst/>
            <a:rect l="l" t="t" r="r" b="b"/>
            <a:pathLst>
              <a:path w="50800" h="162559">
                <a:moveTo>
                  <a:pt x="33274" y="63500"/>
                </a:moveTo>
                <a:lnTo>
                  <a:pt x="17399" y="63500"/>
                </a:lnTo>
                <a:lnTo>
                  <a:pt x="17399" y="162054"/>
                </a:lnTo>
                <a:lnTo>
                  <a:pt x="33274" y="162054"/>
                </a:lnTo>
                <a:lnTo>
                  <a:pt x="33274" y="63500"/>
                </a:lnTo>
                <a:close/>
              </a:path>
              <a:path w="50800" h="162559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2559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" name="object 14"/>
          <p:cNvSpPr/>
          <p:nvPr/>
        </p:nvSpPr>
        <p:spPr>
          <a:xfrm>
            <a:off x="3685140" y="5174390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332" y="33401"/>
                </a:lnTo>
                <a:lnTo>
                  <a:pt x="76835" y="33401"/>
                </a:lnTo>
                <a:lnTo>
                  <a:pt x="76835" y="17526"/>
                </a:lnTo>
                <a:lnTo>
                  <a:pt x="116713" y="17526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135" y="33401"/>
                </a:lnTo>
                <a:lnTo>
                  <a:pt x="64135" y="17526"/>
                </a:lnTo>
                <a:close/>
              </a:path>
              <a:path w="140335" h="50800">
                <a:moveTo>
                  <a:pt x="116713" y="17526"/>
                </a:moveTo>
                <a:lnTo>
                  <a:pt x="76835" y="17526"/>
                </a:lnTo>
                <a:lnTo>
                  <a:pt x="76835" y="33401"/>
                </a:lnTo>
                <a:lnTo>
                  <a:pt x="116332" y="33401"/>
                </a:lnTo>
                <a:lnTo>
                  <a:pt x="140335" y="25400"/>
                </a:lnTo>
                <a:lnTo>
                  <a:pt x="116713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5" name="object 15"/>
          <p:cNvSpPr/>
          <p:nvPr/>
        </p:nvSpPr>
        <p:spPr>
          <a:xfrm>
            <a:off x="3489066" y="5510501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10" y="33401"/>
                </a:lnTo>
                <a:lnTo>
                  <a:pt x="76710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10" y="17526"/>
                </a:lnTo>
                <a:lnTo>
                  <a:pt x="76710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6" name="object 16"/>
          <p:cNvSpPr/>
          <p:nvPr/>
        </p:nvSpPr>
        <p:spPr>
          <a:xfrm>
            <a:off x="3552469" y="5877219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7" name="object 17"/>
          <p:cNvSpPr/>
          <p:nvPr/>
        </p:nvSpPr>
        <p:spPr>
          <a:xfrm>
            <a:off x="4927981" y="517208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8" name="object 18"/>
          <p:cNvSpPr/>
          <p:nvPr/>
        </p:nvSpPr>
        <p:spPr>
          <a:xfrm>
            <a:off x="4731905" y="550819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586" y="33274"/>
                </a:lnTo>
                <a:lnTo>
                  <a:pt x="76705" y="33274"/>
                </a:lnTo>
                <a:lnTo>
                  <a:pt x="76705" y="17399"/>
                </a:lnTo>
                <a:lnTo>
                  <a:pt x="116205" y="17399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008" y="33274"/>
                </a:lnTo>
                <a:lnTo>
                  <a:pt x="64008" y="17399"/>
                </a:lnTo>
                <a:close/>
              </a:path>
              <a:path w="140335" h="50800">
                <a:moveTo>
                  <a:pt x="116205" y="17399"/>
                </a:moveTo>
                <a:lnTo>
                  <a:pt x="76705" y="17399"/>
                </a:lnTo>
                <a:lnTo>
                  <a:pt x="76705" y="33274"/>
                </a:lnTo>
                <a:lnTo>
                  <a:pt x="116586" y="33274"/>
                </a:lnTo>
                <a:lnTo>
                  <a:pt x="140208" y="25400"/>
                </a:lnTo>
                <a:lnTo>
                  <a:pt x="116205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9" name="object 19"/>
          <p:cNvSpPr/>
          <p:nvPr/>
        </p:nvSpPr>
        <p:spPr>
          <a:xfrm>
            <a:off x="4795308" y="5888149"/>
            <a:ext cx="46026" cy="147286"/>
          </a:xfrm>
          <a:custGeom>
            <a:avLst/>
            <a:gdLst/>
            <a:ahLst/>
            <a:cxnLst/>
            <a:rect l="l" t="t" r="r" b="b"/>
            <a:pathLst>
              <a:path w="50800" h="162559">
                <a:moveTo>
                  <a:pt x="33274" y="63500"/>
                </a:moveTo>
                <a:lnTo>
                  <a:pt x="17399" y="63500"/>
                </a:lnTo>
                <a:lnTo>
                  <a:pt x="17399" y="162049"/>
                </a:lnTo>
                <a:lnTo>
                  <a:pt x="33274" y="162049"/>
                </a:lnTo>
                <a:lnTo>
                  <a:pt x="33274" y="63500"/>
                </a:lnTo>
                <a:close/>
              </a:path>
              <a:path w="50800" h="162559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2559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0" name="object 20"/>
          <p:cNvSpPr/>
          <p:nvPr/>
        </p:nvSpPr>
        <p:spPr>
          <a:xfrm>
            <a:off x="4302131" y="5174390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1" name="object 21"/>
          <p:cNvSpPr/>
          <p:nvPr/>
        </p:nvSpPr>
        <p:spPr>
          <a:xfrm>
            <a:off x="4105941" y="5510501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332" y="33401"/>
                </a:lnTo>
                <a:lnTo>
                  <a:pt x="76835" y="33401"/>
                </a:lnTo>
                <a:lnTo>
                  <a:pt x="76835" y="17526"/>
                </a:lnTo>
                <a:lnTo>
                  <a:pt x="116713" y="17526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135" y="33401"/>
                </a:lnTo>
                <a:lnTo>
                  <a:pt x="64135" y="17526"/>
                </a:lnTo>
                <a:close/>
              </a:path>
              <a:path w="140335" h="50800">
                <a:moveTo>
                  <a:pt x="116713" y="17526"/>
                </a:moveTo>
                <a:lnTo>
                  <a:pt x="76835" y="17526"/>
                </a:lnTo>
                <a:lnTo>
                  <a:pt x="76835" y="33401"/>
                </a:lnTo>
                <a:lnTo>
                  <a:pt x="116332" y="33401"/>
                </a:lnTo>
                <a:lnTo>
                  <a:pt x="140335" y="25400"/>
                </a:lnTo>
                <a:lnTo>
                  <a:pt x="116713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2" name="object 22"/>
          <p:cNvSpPr/>
          <p:nvPr/>
        </p:nvSpPr>
        <p:spPr>
          <a:xfrm>
            <a:off x="4169343" y="5883893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3" name="object 23"/>
          <p:cNvSpPr/>
          <p:nvPr/>
        </p:nvSpPr>
        <p:spPr>
          <a:xfrm>
            <a:off x="3617711" y="5065651"/>
            <a:ext cx="236117" cy="1546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4" name="object 24"/>
          <p:cNvSpPr/>
          <p:nvPr/>
        </p:nvSpPr>
        <p:spPr>
          <a:xfrm>
            <a:off x="3425778" y="5398425"/>
            <a:ext cx="236117" cy="1546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5" name="object 25"/>
          <p:cNvSpPr/>
          <p:nvPr/>
        </p:nvSpPr>
        <p:spPr>
          <a:xfrm>
            <a:off x="3540384" y="5898278"/>
            <a:ext cx="236117" cy="1546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6" name="object 26"/>
          <p:cNvSpPr txBox="1"/>
          <p:nvPr/>
        </p:nvSpPr>
        <p:spPr>
          <a:xfrm>
            <a:off x="3497925" y="5079804"/>
            <a:ext cx="278462" cy="101123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4602" algn="r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  <a:p>
            <a:pPr>
              <a:spcBef>
                <a:spcPts val="18"/>
              </a:spcBef>
            </a:pPr>
            <a:endParaRPr sz="1223">
              <a:latin typeface="Times New Roman"/>
              <a:cs typeface="Times New Roman"/>
            </a:endParaRPr>
          </a:p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97">
              <a:latin typeface="Times New Roman"/>
              <a:cs typeface="Times New Roman"/>
            </a:endParaRPr>
          </a:p>
          <a:p>
            <a:pPr>
              <a:spcBef>
                <a:spcPts val="20"/>
              </a:spcBef>
            </a:pPr>
            <a:endParaRPr sz="1360">
              <a:latin typeface="Times New Roman"/>
              <a:cs typeface="Times New Roman"/>
            </a:endParaRPr>
          </a:p>
          <a:p>
            <a:pPr marL="125994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27" name="object 27"/>
          <p:cNvSpPr/>
          <p:nvPr/>
        </p:nvSpPr>
        <p:spPr>
          <a:xfrm>
            <a:off x="4699457" y="6383017"/>
            <a:ext cx="554411" cy="804701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8" name="object 28"/>
          <p:cNvSpPr/>
          <p:nvPr/>
        </p:nvSpPr>
        <p:spPr>
          <a:xfrm>
            <a:off x="3438092" y="6383019"/>
            <a:ext cx="554416" cy="804699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29" name="object 29"/>
          <p:cNvSpPr/>
          <p:nvPr/>
        </p:nvSpPr>
        <p:spPr>
          <a:xfrm>
            <a:off x="4066357" y="6383017"/>
            <a:ext cx="554416" cy="804701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0" name="object 30"/>
          <p:cNvSpPr/>
          <p:nvPr/>
        </p:nvSpPr>
        <p:spPr>
          <a:xfrm>
            <a:off x="4699341" y="7308309"/>
            <a:ext cx="560377" cy="541966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1" name="object 31"/>
          <p:cNvSpPr/>
          <p:nvPr/>
        </p:nvSpPr>
        <p:spPr>
          <a:xfrm>
            <a:off x="3437862" y="7308892"/>
            <a:ext cx="554793" cy="541382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2" name="object 32"/>
          <p:cNvSpPr/>
          <p:nvPr/>
        </p:nvSpPr>
        <p:spPr>
          <a:xfrm>
            <a:off x="4066127" y="7308885"/>
            <a:ext cx="560273" cy="541392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3" name="object 33"/>
          <p:cNvSpPr/>
          <p:nvPr/>
        </p:nvSpPr>
        <p:spPr>
          <a:xfrm>
            <a:off x="2806602" y="6383017"/>
            <a:ext cx="554411" cy="804701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4" name="object 34"/>
          <p:cNvSpPr/>
          <p:nvPr/>
        </p:nvSpPr>
        <p:spPr>
          <a:xfrm>
            <a:off x="2800158" y="7308885"/>
            <a:ext cx="554796" cy="541392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5" name="object 35"/>
          <p:cNvSpPr/>
          <p:nvPr/>
        </p:nvSpPr>
        <p:spPr>
          <a:xfrm>
            <a:off x="2946871" y="6732742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6" name="object 36"/>
          <p:cNvSpPr/>
          <p:nvPr/>
        </p:nvSpPr>
        <p:spPr>
          <a:xfrm>
            <a:off x="3178270" y="6969552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7" name="object 37"/>
          <p:cNvSpPr/>
          <p:nvPr/>
        </p:nvSpPr>
        <p:spPr>
          <a:xfrm>
            <a:off x="3083569" y="7641083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8" name="object 38"/>
          <p:cNvSpPr/>
          <p:nvPr/>
        </p:nvSpPr>
        <p:spPr>
          <a:xfrm>
            <a:off x="3576402" y="6732168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39" name="object 39"/>
          <p:cNvSpPr/>
          <p:nvPr/>
        </p:nvSpPr>
        <p:spPr>
          <a:xfrm>
            <a:off x="3807802" y="6968861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0" name="object 40"/>
          <p:cNvSpPr/>
          <p:nvPr/>
        </p:nvSpPr>
        <p:spPr>
          <a:xfrm>
            <a:off x="3712986" y="7640392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1" name="object 41"/>
          <p:cNvSpPr/>
          <p:nvPr/>
        </p:nvSpPr>
        <p:spPr>
          <a:xfrm>
            <a:off x="4837767" y="6719165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2" name="object 42"/>
          <p:cNvSpPr/>
          <p:nvPr/>
        </p:nvSpPr>
        <p:spPr>
          <a:xfrm>
            <a:off x="5062954" y="6955858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3" name="object 43"/>
          <p:cNvSpPr/>
          <p:nvPr/>
        </p:nvSpPr>
        <p:spPr>
          <a:xfrm>
            <a:off x="4974352" y="7639817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401" y="63500"/>
                </a:moveTo>
                <a:lnTo>
                  <a:pt x="17526" y="63500"/>
                </a:lnTo>
                <a:lnTo>
                  <a:pt x="17526" y="161925"/>
                </a:lnTo>
                <a:lnTo>
                  <a:pt x="33401" y="161925"/>
                </a:lnTo>
                <a:lnTo>
                  <a:pt x="33401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4" name="object 44"/>
          <p:cNvSpPr/>
          <p:nvPr/>
        </p:nvSpPr>
        <p:spPr>
          <a:xfrm>
            <a:off x="4219971" y="6725954"/>
            <a:ext cx="46026" cy="146711"/>
          </a:xfrm>
          <a:custGeom>
            <a:avLst/>
            <a:gdLst/>
            <a:ahLst/>
            <a:cxnLst/>
            <a:rect l="l" t="t" r="r" b="b"/>
            <a:pathLst>
              <a:path w="50800" h="161925">
                <a:moveTo>
                  <a:pt x="33274" y="63500"/>
                </a:moveTo>
                <a:lnTo>
                  <a:pt x="17399" y="63500"/>
                </a:lnTo>
                <a:lnTo>
                  <a:pt x="17399" y="161925"/>
                </a:lnTo>
                <a:lnTo>
                  <a:pt x="33274" y="161925"/>
                </a:lnTo>
                <a:lnTo>
                  <a:pt x="33274" y="63500"/>
                </a:lnTo>
                <a:close/>
              </a:path>
              <a:path w="50800" h="16192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192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5" name="object 45"/>
          <p:cNvSpPr/>
          <p:nvPr/>
        </p:nvSpPr>
        <p:spPr>
          <a:xfrm>
            <a:off x="4451373" y="6962646"/>
            <a:ext cx="46026" cy="147286"/>
          </a:xfrm>
          <a:custGeom>
            <a:avLst/>
            <a:gdLst/>
            <a:ahLst/>
            <a:cxnLst/>
            <a:rect l="l" t="t" r="r" b="b"/>
            <a:pathLst>
              <a:path w="50800" h="162559">
                <a:moveTo>
                  <a:pt x="33274" y="63500"/>
                </a:moveTo>
                <a:lnTo>
                  <a:pt x="17399" y="63500"/>
                </a:lnTo>
                <a:lnTo>
                  <a:pt x="17399" y="162049"/>
                </a:lnTo>
                <a:lnTo>
                  <a:pt x="33274" y="162049"/>
                </a:lnTo>
                <a:lnTo>
                  <a:pt x="33274" y="63500"/>
                </a:lnTo>
                <a:close/>
              </a:path>
              <a:path w="50800" h="162559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2559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6" name="object 46"/>
          <p:cNvSpPr/>
          <p:nvPr/>
        </p:nvSpPr>
        <p:spPr>
          <a:xfrm>
            <a:off x="4356557" y="7634178"/>
            <a:ext cx="46026" cy="147286"/>
          </a:xfrm>
          <a:custGeom>
            <a:avLst/>
            <a:gdLst/>
            <a:ahLst/>
            <a:cxnLst/>
            <a:rect l="l" t="t" r="r" b="b"/>
            <a:pathLst>
              <a:path w="50800" h="162559">
                <a:moveTo>
                  <a:pt x="33401" y="63500"/>
                </a:moveTo>
                <a:lnTo>
                  <a:pt x="17526" y="63500"/>
                </a:lnTo>
                <a:lnTo>
                  <a:pt x="17526" y="162054"/>
                </a:lnTo>
                <a:lnTo>
                  <a:pt x="33401" y="162054"/>
                </a:lnTo>
                <a:lnTo>
                  <a:pt x="33401" y="63500"/>
                </a:lnTo>
                <a:close/>
              </a:path>
              <a:path w="50800" h="162559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62559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7" name="object 47"/>
          <p:cNvSpPr/>
          <p:nvPr/>
        </p:nvSpPr>
        <p:spPr>
          <a:xfrm>
            <a:off x="3566620" y="6765424"/>
            <a:ext cx="236117" cy="1546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48" name="object 48"/>
          <p:cNvSpPr txBox="1"/>
          <p:nvPr/>
        </p:nvSpPr>
        <p:spPr>
          <a:xfrm>
            <a:off x="3638768" y="6779919"/>
            <a:ext cx="86301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49" name="object 49"/>
          <p:cNvSpPr/>
          <p:nvPr/>
        </p:nvSpPr>
        <p:spPr>
          <a:xfrm>
            <a:off x="3700559" y="7669850"/>
            <a:ext cx="236117" cy="15464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0" name="object 50"/>
          <p:cNvSpPr txBox="1"/>
          <p:nvPr/>
        </p:nvSpPr>
        <p:spPr>
          <a:xfrm>
            <a:off x="3772706" y="7684347"/>
            <a:ext cx="86301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268731" y="847866"/>
            <a:ext cx="380296" cy="13939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06" b="1" spc="-14" dirty="0">
                <a:latin typeface="Calibri"/>
                <a:cs typeface="Calibri"/>
              </a:rPr>
              <a:t>C</a:t>
            </a:r>
            <a:r>
              <a:rPr sz="906" b="1" spc="-5" dirty="0">
                <a:latin typeface="Calibri"/>
                <a:cs typeface="Calibri"/>
              </a:rPr>
              <a:t>h</a:t>
            </a:r>
            <a:r>
              <a:rPr sz="906" b="1" spc="-9" dirty="0">
                <a:latin typeface="Calibri"/>
                <a:cs typeface="Calibri"/>
              </a:rPr>
              <a:t>q</a:t>
            </a:r>
            <a:r>
              <a:rPr sz="906" b="1" spc="-23" dirty="0">
                <a:latin typeface="Times New Roman"/>
                <a:cs typeface="Times New Roman"/>
              </a:rPr>
              <a:t> </a:t>
            </a:r>
            <a:r>
              <a:rPr sz="906" b="1" spc="-5" dirty="0">
                <a:latin typeface="Calibri"/>
                <a:cs typeface="Calibri"/>
              </a:rPr>
              <a:t>15’</a:t>
            </a:r>
            <a:endParaRPr sz="906">
              <a:latin typeface="Calibri"/>
              <a:cs typeface="Calibri"/>
            </a:endParaRPr>
          </a:p>
        </p:txBody>
      </p:sp>
      <p:sp>
        <p:nvSpPr>
          <p:cNvPr id="52" name="object 52"/>
          <p:cNvSpPr/>
          <p:nvPr/>
        </p:nvSpPr>
        <p:spPr>
          <a:xfrm>
            <a:off x="1254232" y="2647344"/>
            <a:ext cx="1467634" cy="1467623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3" name="object 53"/>
          <p:cNvSpPr txBox="1"/>
          <p:nvPr/>
        </p:nvSpPr>
        <p:spPr>
          <a:xfrm>
            <a:off x="1319843" y="3916468"/>
            <a:ext cx="230135" cy="1184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770" b="1" u="heavy" spc="-9" dirty="0">
                <a:solidFill>
                  <a:srgbClr val="FFFFFF"/>
                </a:solidFill>
                <a:latin typeface="Calibri"/>
                <a:cs typeface="Calibri"/>
              </a:rPr>
              <a:t>5</a:t>
            </a:r>
            <a:r>
              <a:rPr sz="770" b="1" u="heavy" spc="9" dirty="0">
                <a:solidFill>
                  <a:srgbClr val="FFFFFF"/>
                </a:solidFill>
                <a:latin typeface="Calibri"/>
                <a:cs typeface="Calibri"/>
              </a:rPr>
              <a:t> </a:t>
            </a:r>
            <a:r>
              <a:rPr sz="770" b="1" u="heavy" spc="-14" dirty="0">
                <a:solidFill>
                  <a:srgbClr val="FFFFFF"/>
                </a:solidFill>
                <a:latin typeface="Calibri"/>
                <a:cs typeface="Calibri"/>
              </a:rPr>
              <a:t>µm</a:t>
            </a:r>
            <a:endParaRPr sz="770">
              <a:latin typeface="Calibri"/>
              <a:cs typeface="Calibri"/>
            </a:endParaRPr>
          </a:p>
        </p:txBody>
      </p:sp>
      <p:sp>
        <p:nvSpPr>
          <p:cNvPr id="54" name="object 54"/>
          <p:cNvSpPr/>
          <p:nvPr/>
        </p:nvSpPr>
        <p:spPr>
          <a:xfrm>
            <a:off x="1347207" y="3244936"/>
            <a:ext cx="388926" cy="346927"/>
          </a:xfrm>
          <a:custGeom>
            <a:avLst/>
            <a:gdLst/>
            <a:ahLst/>
            <a:cxnLst/>
            <a:rect l="l" t="t" r="r" b="b"/>
            <a:pathLst>
              <a:path w="429260" h="382904">
                <a:moveTo>
                  <a:pt x="0" y="382915"/>
                </a:moveTo>
                <a:lnTo>
                  <a:pt x="428838" y="382915"/>
                </a:lnTo>
                <a:lnTo>
                  <a:pt x="428838" y="0"/>
                </a:lnTo>
                <a:lnTo>
                  <a:pt x="0" y="0"/>
                </a:lnTo>
                <a:lnTo>
                  <a:pt x="0" y="382915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5" name="object 55"/>
          <p:cNvSpPr/>
          <p:nvPr/>
        </p:nvSpPr>
        <p:spPr>
          <a:xfrm>
            <a:off x="1799650" y="2946676"/>
            <a:ext cx="388926" cy="347503"/>
          </a:xfrm>
          <a:custGeom>
            <a:avLst/>
            <a:gdLst/>
            <a:ahLst/>
            <a:cxnLst/>
            <a:rect l="l" t="t" r="r" b="b"/>
            <a:pathLst>
              <a:path w="429260" h="383539">
                <a:moveTo>
                  <a:pt x="0" y="382920"/>
                </a:moveTo>
                <a:lnTo>
                  <a:pt x="428843" y="382920"/>
                </a:lnTo>
                <a:lnTo>
                  <a:pt x="428843" y="0"/>
                </a:lnTo>
                <a:lnTo>
                  <a:pt x="0" y="0"/>
                </a:lnTo>
                <a:lnTo>
                  <a:pt x="0" y="382920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6" name="object 56"/>
          <p:cNvSpPr/>
          <p:nvPr/>
        </p:nvSpPr>
        <p:spPr>
          <a:xfrm>
            <a:off x="2223327" y="3381126"/>
            <a:ext cx="388926" cy="280764"/>
          </a:xfrm>
          <a:custGeom>
            <a:avLst/>
            <a:gdLst/>
            <a:ahLst/>
            <a:cxnLst/>
            <a:rect l="l" t="t" r="r" b="b"/>
            <a:pathLst>
              <a:path w="429260" h="309879">
                <a:moveTo>
                  <a:pt x="0" y="309432"/>
                </a:moveTo>
                <a:lnTo>
                  <a:pt x="428843" y="309432"/>
                </a:lnTo>
                <a:lnTo>
                  <a:pt x="428843" y="0"/>
                </a:lnTo>
                <a:lnTo>
                  <a:pt x="0" y="0"/>
                </a:lnTo>
                <a:lnTo>
                  <a:pt x="0" y="309432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57" name="object 57"/>
          <p:cNvSpPr txBox="1"/>
          <p:nvPr/>
        </p:nvSpPr>
        <p:spPr>
          <a:xfrm>
            <a:off x="3419221" y="896193"/>
            <a:ext cx="546568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5" dirty="0">
                <a:solidFill>
                  <a:srgbClr val="00B050"/>
                </a:solidFill>
                <a:latin typeface="Calibri"/>
                <a:cs typeface="Calibri"/>
              </a:rPr>
              <a:t>Lyse</a:t>
            </a:r>
            <a:r>
              <a:rPr sz="816" b="1" spc="-9" dirty="0">
                <a:solidFill>
                  <a:srgbClr val="00B050"/>
                </a:solidFill>
                <a:latin typeface="Calibri"/>
                <a:cs typeface="Calibri"/>
              </a:rPr>
              <a:t>nin</a:t>
            </a:r>
            <a:r>
              <a:rPr sz="816" b="1" dirty="0">
                <a:solidFill>
                  <a:srgbClr val="00B050"/>
                </a:solidFill>
                <a:latin typeface="Calibri"/>
                <a:cs typeface="Calibri"/>
              </a:rPr>
              <a:t>-</a:t>
            </a:r>
            <a:r>
              <a:rPr sz="816" b="1" spc="-5" dirty="0">
                <a:solidFill>
                  <a:srgbClr val="00B050"/>
                </a:solidFill>
                <a:latin typeface="Calibri"/>
                <a:cs typeface="Calibri"/>
              </a:rPr>
              <a:t>GFP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4135858" y="893432"/>
            <a:ext cx="367638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5" dirty="0">
                <a:solidFill>
                  <a:srgbClr val="FF0000"/>
                </a:solidFill>
                <a:latin typeface="Calibri"/>
                <a:cs typeface="Calibri"/>
              </a:rPr>
              <a:t>D</a:t>
            </a:r>
            <a:r>
              <a:rPr sz="816" b="1" dirty="0">
                <a:solidFill>
                  <a:srgbClr val="FF0000"/>
                </a:solidFill>
                <a:latin typeface="Calibri"/>
                <a:cs typeface="Calibri"/>
              </a:rPr>
              <a:t>e</a:t>
            </a:r>
            <a:r>
              <a:rPr sz="816" b="1" spc="-9" dirty="0">
                <a:solidFill>
                  <a:srgbClr val="FF0000"/>
                </a:solidFill>
                <a:latin typeface="Calibri"/>
                <a:cs typeface="Calibri"/>
              </a:rPr>
              <a:t>x</a:t>
            </a:r>
            <a:r>
              <a:rPr sz="816" b="1" dirty="0">
                <a:solidFill>
                  <a:srgbClr val="FF0000"/>
                </a:solidFill>
                <a:latin typeface="Calibri"/>
                <a:cs typeface="Calibri"/>
              </a:rPr>
              <a:t>tr</a:t>
            </a:r>
            <a:r>
              <a:rPr sz="816" b="1" spc="-5" dirty="0">
                <a:solidFill>
                  <a:srgbClr val="FF0000"/>
                </a:solidFill>
                <a:latin typeface="Calibri"/>
                <a:cs typeface="Calibri"/>
              </a:rPr>
              <a:t>an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4812799" y="893432"/>
            <a:ext cx="218052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9" dirty="0">
                <a:solidFill>
                  <a:srgbClr val="FF00FF"/>
                </a:solidFill>
                <a:latin typeface="Calibri"/>
                <a:cs typeface="Calibri"/>
              </a:rPr>
              <a:t>Gal</a:t>
            </a:r>
            <a:r>
              <a:rPr sz="816" b="1" spc="-5" dirty="0">
                <a:solidFill>
                  <a:srgbClr val="FF00FF"/>
                </a:solidFill>
                <a:latin typeface="Calibri"/>
                <a:cs typeface="Calibri"/>
              </a:rPr>
              <a:t>3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3001988" y="897574"/>
            <a:ext cx="178929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9" dirty="0">
                <a:latin typeface="Calibri"/>
                <a:cs typeface="Calibri"/>
              </a:rPr>
              <a:t>R</a:t>
            </a:r>
            <a:r>
              <a:rPr sz="816" b="1" dirty="0">
                <a:latin typeface="Calibri"/>
                <a:cs typeface="Calibri"/>
              </a:rPr>
              <a:t>O</a:t>
            </a:r>
            <a:r>
              <a:rPr sz="816" b="1" spc="-5" dirty="0">
                <a:latin typeface="Calibri"/>
                <a:cs typeface="Calibri"/>
              </a:rPr>
              <a:t>I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61" name="object 61"/>
          <p:cNvSpPr/>
          <p:nvPr/>
        </p:nvSpPr>
        <p:spPr>
          <a:xfrm>
            <a:off x="1253081" y="1025989"/>
            <a:ext cx="1465953" cy="1467680"/>
          </a:xfrm>
          <a:prstGeom prst="rect">
            <a:avLst/>
          </a:prstGeom>
          <a:blipFill>
            <a:blip r:embed="rId1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2" name="object 62"/>
          <p:cNvSpPr/>
          <p:nvPr/>
        </p:nvSpPr>
        <p:spPr>
          <a:xfrm>
            <a:off x="1733716" y="1109637"/>
            <a:ext cx="388926" cy="588567"/>
          </a:xfrm>
          <a:custGeom>
            <a:avLst/>
            <a:gdLst/>
            <a:ahLst/>
            <a:cxnLst/>
            <a:rect l="l" t="t" r="r" b="b"/>
            <a:pathLst>
              <a:path w="429260" h="649605">
                <a:moveTo>
                  <a:pt x="0" y="649485"/>
                </a:moveTo>
                <a:lnTo>
                  <a:pt x="428763" y="649485"/>
                </a:lnTo>
                <a:lnTo>
                  <a:pt x="428763" y="0"/>
                </a:lnTo>
                <a:lnTo>
                  <a:pt x="0" y="0"/>
                </a:lnTo>
                <a:lnTo>
                  <a:pt x="0" y="649485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3" name="object 63"/>
          <p:cNvSpPr/>
          <p:nvPr/>
        </p:nvSpPr>
        <p:spPr>
          <a:xfrm>
            <a:off x="2145081" y="1984088"/>
            <a:ext cx="388926" cy="301476"/>
          </a:xfrm>
          <a:custGeom>
            <a:avLst/>
            <a:gdLst/>
            <a:ahLst/>
            <a:cxnLst/>
            <a:rect l="l" t="t" r="r" b="b"/>
            <a:pathLst>
              <a:path w="429260" h="332739">
                <a:moveTo>
                  <a:pt x="0" y="332303"/>
                </a:moveTo>
                <a:lnTo>
                  <a:pt x="428763" y="332303"/>
                </a:lnTo>
                <a:lnTo>
                  <a:pt x="428763" y="0"/>
                </a:lnTo>
                <a:lnTo>
                  <a:pt x="0" y="0"/>
                </a:lnTo>
                <a:lnTo>
                  <a:pt x="0" y="332303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4" name="object 64"/>
          <p:cNvSpPr/>
          <p:nvPr/>
        </p:nvSpPr>
        <p:spPr>
          <a:xfrm>
            <a:off x="1338805" y="2414043"/>
            <a:ext cx="169724" cy="0"/>
          </a:xfrm>
          <a:custGeom>
            <a:avLst/>
            <a:gdLst/>
            <a:ahLst/>
            <a:cxnLst/>
            <a:rect l="l" t="t" r="r" b="b"/>
            <a:pathLst>
              <a:path w="187325">
                <a:moveTo>
                  <a:pt x="0" y="0"/>
                </a:moveTo>
                <a:lnTo>
                  <a:pt x="187198" y="0"/>
                </a:lnTo>
              </a:path>
            </a:pathLst>
          </a:custGeom>
          <a:ln w="11113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5" name="object 65"/>
          <p:cNvSpPr/>
          <p:nvPr/>
        </p:nvSpPr>
        <p:spPr>
          <a:xfrm>
            <a:off x="1328336" y="2301278"/>
            <a:ext cx="185027" cy="93894"/>
          </a:xfrm>
          <a:prstGeom prst="rect">
            <a:avLst/>
          </a:prstGeom>
          <a:blipFill>
            <a:blip r:embed="rId1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6" name="object 66"/>
          <p:cNvSpPr txBox="1"/>
          <p:nvPr/>
        </p:nvSpPr>
        <p:spPr>
          <a:xfrm>
            <a:off x="1317059" y="2301051"/>
            <a:ext cx="206545" cy="9759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634" b="1" spc="-5" dirty="0">
                <a:solidFill>
                  <a:srgbClr val="FFFFFF"/>
                </a:solidFill>
                <a:latin typeface="Arial"/>
                <a:cs typeface="Arial"/>
              </a:rPr>
              <a:t>5</a:t>
            </a:r>
            <a:r>
              <a:rPr sz="634" b="1" spc="14" dirty="0">
                <a:solidFill>
                  <a:srgbClr val="FFFFFF"/>
                </a:solidFill>
                <a:latin typeface="Times New Roman"/>
                <a:cs typeface="Times New Roman"/>
              </a:rPr>
              <a:t> </a:t>
            </a:r>
            <a:r>
              <a:rPr sz="634" b="1" spc="-14" dirty="0">
                <a:solidFill>
                  <a:srgbClr val="FFFFFF"/>
                </a:solidFill>
                <a:latin typeface="Arial"/>
                <a:cs typeface="Arial"/>
              </a:rPr>
              <a:t>µ</a:t>
            </a:r>
            <a:r>
              <a:rPr sz="634" b="1" spc="-9" dirty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sz="634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2982655" y="4637370"/>
            <a:ext cx="178929" cy="125547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816" b="1" spc="-9" dirty="0">
                <a:latin typeface="Calibri"/>
                <a:cs typeface="Calibri"/>
              </a:rPr>
              <a:t>R</a:t>
            </a:r>
            <a:r>
              <a:rPr sz="816" b="1" dirty="0">
                <a:latin typeface="Calibri"/>
                <a:cs typeface="Calibri"/>
              </a:rPr>
              <a:t>O</a:t>
            </a:r>
            <a:r>
              <a:rPr sz="816" b="1" spc="-5" dirty="0">
                <a:latin typeface="Calibri"/>
                <a:cs typeface="Calibri"/>
              </a:rPr>
              <a:t>I</a:t>
            </a:r>
            <a:endParaRPr sz="816">
              <a:latin typeface="Calibri"/>
              <a:cs typeface="Calibri"/>
            </a:endParaRPr>
          </a:p>
        </p:txBody>
      </p:sp>
      <p:sp>
        <p:nvSpPr>
          <p:cNvPr id="68" name="object 68"/>
          <p:cNvSpPr/>
          <p:nvPr/>
        </p:nvSpPr>
        <p:spPr>
          <a:xfrm>
            <a:off x="1255383" y="4776073"/>
            <a:ext cx="1467623" cy="1467634"/>
          </a:xfrm>
          <a:prstGeom prst="rect">
            <a:avLst/>
          </a:prstGeom>
          <a:blipFill>
            <a:blip r:embed="rId1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69" name="object 69"/>
          <p:cNvSpPr txBox="1"/>
          <p:nvPr/>
        </p:nvSpPr>
        <p:spPr>
          <a:xfrm>
            <a:off x="1327922" y="6084067"/>
            <a:ext cx="19273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589" b="1" u="sng" spc="14" dirty="0">
                <a:solidFill>
                  <a:srgbClr val="FFFFFF"/>
                </a:solidFill>
                <a:latin typeface="Calibri"/>
                <a:cs typeface="Calibri"/>
              </a:rPr>
              <a:t>5</a:t>
            </a:r>
            <a:r>
              <a:rPr sz="589" b="1" u="sng" spc="18" dirty="0">
                <a:solidFill>
                  <a:srgbClr val="FFFFFF"/>
                </a:solidFill>
                <a:latin typeface="Calibri"/>
                <a:cs typeface="Calibri"/>
              </a:rPr>
              <a:t> µm</a:t>
            </a:r>
            <a:endParaRPr sz="589">
              <a:latin typeface="Calibri"/>
              <a:cs typeface="Calibri"/>
            </a:endParaRPr>
          </a:p>
        </p:txBody>
      </p:sp>
      <p:sp>
        <p:nvSpPr>
          <p:cNvPr id="70" name="object 70"/>
          <p:cNvSpPr/>
          <p:nvPr/>
        </p:nvSpPr>
        <p:spPr>
          <a:xfrm>
            <a:off x="2301229" y="4878240"/>
            <a:ext cx="329667" cy="859552"/>
          </a:xfrm>
          <a:custGeom>
            <a:avLst/>
            <a:gdLst/>
            <a:ahLst/>
            <a:cxnLst/>
            <a:rect l="l" t="t" r="r" b="b"/>
            <a:pathLst>
              <a:path w="363855" h="948689">
                <a:moveTo>
                  <a:pt x="0" y="948143"/>
                </a:moveTo>
                <a:lnTo>
                  <a:pt x="363641" y="948143"/>
                </a:lnTo>
                <a:lnTo>
                  <a:pt x="363641" y="0"/>
                </a:lnTo>
                <a:lnTo>
                  <a:pt x="0" y="0"/>
                </a:lnTo>
                <a:lnTo>
                  <a:pt x="0" y="948143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1" name="object 71"/>
          <p:cNvSpPr/>
          <p:nvPr/>
        </p:nvSpPr>
        <p:spPr>
          <a:xfrm>
            <a:off x="1295195" y="6166142"/>
            <a:ext cx="258256" cy="84354"/>
          </a:xfrm>
          <a:prstGeom prst="rect">
            <a:avLst/>
          </a:prstGeom>
          <a:blipFill>
            <a:blip r:embed="rId2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2" name="object 72"/>
          <p:cNvSpPr/>
          <p:nvPr/>
        </p:nvSpPr>
        <p:spPr>
          <a:xfrm>
            <a:off x="1333399" y="6192617"/>
            <a:ext cx="180079" cy="0"/>
          </a:xfrm>
          <a:custGeom>
            <a:avLst/>
            <a:gdLst/>
            <a:ahLst/>
            <a:cxnLst/>
            <a:rect l="l" t="t" r="r" b="b"/>
            <a:pathLst>
              <a:path w="198755">
                <a:moveTo>
                  <a:pt x="0" y="0"/>
                </a:moveTo>
                <a:lnTo>
                  <a:pt x="198628" y="0"/>
                </a:lnTo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3" name="object 73"/>
          <p:cNvSpPr/>
          <p:nvPr/>
        </p:nvSpPr>
        <p:spPr>
          <a:xfrm>
            <a:off x="1249056" y="6382985"/>
            <a:ext cx="1467623" cy="1467634"/>
          </a:xfrm>
          <a:prstGeom prst="rect">
            <a:avLst/>
          </a:prstGeom>
          <a:blipFill>
            <a:blip r:embed="rId2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4" name="object 74"/>
          <p:cNvSpPr txBox="1"/>
          <p:nvPr/>
        </p:nvSpPr>
        <p:spPr>
          <a:xfrm>
            <a:off x="1343467" y="7688608"/>
            <a:ext cx="192737" cy="90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589" b="1" u="dbl" spc="14" dirty="0">
                <a:solidFill>
                  <a:srgbClr val="FFFFFF"/>
                </a:solidFill>
                <a:latin typeface="Calibri"/>
                <a:cs typeface="Calibri"/>
              </a:rPr>
              <a:t>5</a:t>
            </a:r>
            <a:r>
              <a:rPr sz="589" b="1" u="dbl" spc="18" dirty="0">
                <a:solidFill>
                  <a:srgbClr val="FFFFFF"/>
                </a:solidFill>
                <a:latin typeface="Calibri"/>
                <a:cs typeface="Calibri"/>
              </a:rPr>
              <a:t> µm</a:t>
            </a:r>
            <a:endParaRPr sz="589">
              <a:latin typeface="Calibri"/>
              <a:cs typeface="Calibri"/>
            </a:endParaRPr>
          </a:p>
        </p:txBody>
      </p:sp>
      <p:sp>
        <p:nvSpPr>
          <p:cNvPr id="75" name="object 75"/>
          <p:cNvSpPr/>
          <p:nvPr/>
        </p:nvSpPr>
        <p:spPr>
          <a:xfrm>
            <a:off x="1808051" y="7361032"/>
            <a:ext cx="329667" cy="447611"/>
          </a:xfrm>
          <a:custGeom>
            <a:avLst/>
            <a:gdLst/>
            <a:ahLst/>
            <a:cxnLst/>
            <a:rect l="l" t="t" r="r" b="b"/>
            <a:pathLst>
              <a:path w="363855" h="494029">
                <a:moveTo>
                  <a:pt x="0" y="493623"/>
                </a:moveTo>
                <a:lnTo>
                  <a:pt x="363636" y="493623"/>
                </a:lnTo>
                <a:lnTo>
                  <a:pt x="363636" y="0"/>
                </a:lnTo>
                <a:lnTo>
                  <a:pt x="0" y="0"/>
                </a:lnTo>
                <a:lnTo>
                  <a:pt x="0" y="493623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6" name="object 76"/>
          <p:cNvSpPr/>
          <p:nvPr/>
        </p:nvSpPr>
        <p:spPr>
          <a:xfrm>
            <a:off x="1482525" y="6538833"/>
            <a:ext cx="329667" cy="310106"/>
          </a:xfrm>
          <a:custGeom>
            <a:avLst/>
            <a:gdLst/>
            <a:ahLst/>
            <a:cxnLst/>
            <a:rect l="l" t="t" r="r" b="b"/>
            <a:pathLst>
              <a:path w="363855" h="342265">
                <a:moveTo>
                  <a:pt x="0" y="341908"/>
                </a:moveTo>
                <a:lnTo>
                  <a:pt x="363641" y="341908"/>
                </a:lnTo>
                <a:lnTo>
                  <a:pt x="363641" y="0"/>
                </a:lnTo>
                <a:lnTo>
                  <a:pt x="0" y="0"/>
                </a:lnTo>
                <a:lnTo>
                  <a:pt x="0" y="341908"/>
                </a:lnTo>
                <a:close/>
              </a:path>
            </a:pathLst>
          </a:custGeom>
          <a:ln w="1270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7" name="object 77"/>
          <p:cNvSpPr/>
          <p:nvPr/>
        </p:nvSpPr>
        <p:spPr>
          <a:xfrm>
            <a:off x="1313146" y="7767876"/>
            <a:ext cx="259614" cy="84354"/>
          </a:xfrm>
          <a:prstGeom prst="rect">
            <a:avLst/>
          </a:prstGeom>
          <a:blipFill>
            <a:blip r:embed="rId2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8" name="object 78"/>
          <p:cNvSpPr/>
          <p:nvPr/>
        </p:nvSpPr>
        <p:spPr>
          <a:xfrm>
            <a:off x="4062904" y="2652100"/>
            <a:ext cx="550322" cy="482495"/>
          </a:xfrm>
          <a:prstGeom prst="rect">
            <a:avLst/>
          </a:prstGeom>
          <a:blipFill>
            <a:blip r:embed="rId2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79" name="object 79"/>
          <p:cNvSpPr/>
          <p:nvPr/>
        </p:nvSpPr>
        <p:spPr>
          <a:xfrm>
            <a:off x="2805798" y="2654523"/>
            <a:ext cx="550319" cy="482487"/>
          </a:xfrm>
          <a:prstGeom prst="rect">
            <a:avLst/>
          </a:prstGeom>
          <a:blipFill>
            <a:blip r:embed="rId2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0" name="object 80"/>
          <p:cNvSpPr/>
          <p:nvPr/>
        </p:nvSpPr>
        <p:spPr>
          <a:xfrm>
            <a:off x="3434984" y="2654523"/>
            <a:ext cx="550319" cy="482487"/>
          </a:xfrm>
          <a:prstGeom prst="rect">
            <a:avLst/>
          </a:prstGeom>
          <a:blipFill>
            <a:blip r:embed="rId2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1" name="object 81"/>
          <p:cNvSpPr/>
          <p:nvPr/>
        </p:nvSpPr>
        <p:spPr>
          <a:xfrm>
            <a:off x="4687488" y="2644965"/>
            <a:ext cx="550322" cy="482495"/>
          </a:xfrm>
          <a:prstGeom prst="rect">
            <a:avLst/>
          </a:prstGeom>
          <a:blipFill>
            <a:blip r:embed="rId2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2" name="object 82"/>
          <p:cNvSpPr/>
          <p:nvPr/>
        </p:nvSpPr>
        <p:spPr>
          <a:xfrm>
            <a:off x="4057841" y="3692835"/>
            <a:ext cx="555433" cy="427655"/>
          </a:xfrm>
          <a:prstGeom prst="rect">
            <a:avLst/>
          </a:prstGeom>
          <a:blipFill>
            <a:blip r:embed="rId2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3" name="object 83"/>
          <p:cNvSpPr/>
          <p:nvPr/>
        </p:nvSpPr>
        <p:spPr>
          <a:xfrm>
            <a:off x="2804762" y="3693065"/>
            <a:ext cx="550322" cy="427655"/>
          </a:xfrm>
          <a:prstGeom prst="rect">
            <a:avLst/>
          </a:prstGeom>
          <a:blipFill>
            <a:blip r:embed="rId2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4" name="object 84"/>
          <p:cNvSpPr/>
          <p:nvPr/>
        </p:nvSpPr>
        <p:spPr>
          <a:xfrm>
            <a:off x="3433489" y="3692831"/>
            <a:ext cx="550319" cy="427658"/>
          </a:xfrm>
          <a:prstGeom prst="rect">
            <a:avLst/>
          </a:prstGeom>
          <a:blipFill>
            <a:blip r:embed="rId2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5" name="object 85"/>
          <p:cNvSpPr/>
          <p:nvPr/>
        </p:nvSpPr>
        <p:spPr>
          <a:xfrm>
            <a:off x="4687489" y="3693065"/>
            <a:ext cx="550331" cy="427655"/>
          </a:xfrm>
          <a:prstGeom prst="rect">
            <a:avLst/>
          </a:prstGeom>
          <a:blipFill>
            <a:blip r:embed="rId3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6" name="object 86"/>
          <p:cNvSpPr/>
          <p:nvPr/>
        </p:nvSpPr>
        <p:spPr>
          <a:xfrm>
            <a:off x="4057612" y="3204032"/>
            <a:ext cx="550322" cy="427882"/>
          </a:xfrm>
          <a:prstGeom prst="rect">
            <a:avLst/>
          </a:prstGeom>
          <a:blipFill>
            <a:blip r:embed="rId3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7" name="object 87"/>
          <p:cNvSpPr/>
          <p:nvPr/>
        </p:nvSpPr>
        <p:spPr>
          <a:xfrm>
            <a:off x="2804762" y="3204371"/>
            <a:ext cx="550319" cy="427888"/>
          </a:xfrm>
          <a:prstGeom prst="rect">
            <a:avLst/>
          </a:prstGeom>
          <a:blipFill>
            <a:blip r:embed="rId3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8" name="object 88"/>
          <p:cNvSpPr/>
          <p:nvPr/>
        </p:nvSpPr>
        <p:spPr>
          <a:xfrm>
            <a:off x="3433719" y="3209319"/>
            <a:ext cx="550331" cy="427888"/>
          </a:xfrm>
          <a:prstGeom prst="rect">
            <a:avLst/>
          </a:prstGeom>
          <a:blipFill>
            <a:blip r:embed="rId3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89" name="object 89"/>
          <p:cNvSpPr/>
          <p:nvPr/>
        </p:nvSpPr>
        <p:spPr>
          <a:xfrm>
            <a:off x="4687490" y="3204038"/>
            <a:ext cx="550319" cy="427877"/>
          </a:xfrm>
          <a:prstGeom prst="rect">
            <a:avLst/>
          </a:prstGeom>
          <a:blipFill>
            <a:blip r:embed="rId3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0" name="object 90"/>
          <p:cNvSpPr/>
          <p:nvPr/>
        </p:nvSpPr>
        <p:spPr>
          <a:xfrm>
            <a:off x="2856312" y="3394877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332" y="33401"/>
                </a:lnTo>
                <a:lnTo>
                  <a:pt x="76835" y="33401"/>
                </a:lnTo>
                <a:lnTo>
                  <a:pt x="76835" y="17526"/>
                </a:lnTo>
                <a:lnTo>
                  <a:pt x="116713" y="17526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135" y="33401"/>
                </a:lnTo>
                <a:lnTo>
                  <a:pt x="64135" y="17526"/>
                </a:lnTo>
                <a:close/>
              </a:path>
              <a:path w="140335" h="50800">
                <a:moveTo>
                  <a:pt x="116713" y="17526"/>
                </a:moveTo>
                <a:lnTo>
                  <a:pt x="76835" y="17526"/>
                </a:lnTo>
                <a:lnTo>
                  <a:pt x="76835" y="33401"/>
                </a:lnTo>
                <a:lnTo>
                  <a:pt x="116332" y="33401"/>
                </a:lnTo>
                <a:lnTo>
                  <a:pt x="140335" y="25400"/>
                </a:lnTo>
                <a:lnTo>
                  <a:pt x="116713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1" name="object 91"/>
          <p:cNvSpPr/>
          <p:nvPr/>
        </p:nvSpPr>
        <p:spPr>
          <a:xfrm>
            <a:off x="3174128" y="2831968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526" y="59307"/>
                </a:moveTo>
                <a:lnTo>
                  <a:pt x="0" y="59307"/>
                </a:lnTo>
                <a:lnTo>
                  <a:pt x="25400" y="135507"/>
                </a:lnTo>
                <a:lnTo>
                  <a:pt x="46566" y="72007"/>
                </a:lnTo>
                <a:lnTo>
                  <a:pt x="17526" y="72007"/>
                </a:lnTo>
                <a:lnTo>
                  <a:pt x="17526" y="59307"/>
                </a:lnTo>
                <a:close/>
              </a:path>
              <a:path w="50800" h="135889">
                <a:moveTo>
                  <a:pt x="33401" y="0"/>
                </a:moveTo>
                <a:lnTo>
                  <a:pt x="17526" y="0"/>
                </a:lnTo>
                <a:lnTo>
                  <a:pt x="17526" y="72007"/>
                </a:lnTo>
                <a:lnTo>
                  <a:pt x="33401" y="72007"/>
                </a:lnTo>
                <a:lnTo>
                  <a:pt x="33401" y="0"/>
                </a:lnTo>
                <a:close/>
              </a:path>
              <a:path w="50800" h="135889">
                <a:moveTo>
                  <a:pt x="50800" y="59307"/>
                </a:moveTo>
                <a:lnTo>
                  <a:pt x="33401" y="59307"/>
                </a:lnTo>
                <a:lnTo>
                  <a:pt x="33401" y="72007"/>
                </a:lnTo>
                <a:lnTo>
                  <a:pt x="46566" y="72007"/>
                </a:lnTo>
                <a:lnTo>
                  <a:pt x="50800" y="5930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2" name="object 92"/>
          <p:cNvSpPr/>
          <p:nvPr/>
        </p:nvSpPr>
        <p:spPr>
          <a:xfrm>
            <a:off x="2856312" y="3877813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3" name="object 93"/>
          <p:cNvSpPr/>
          <p:nvPr/>
        </p:nvSpPr>
        <p:spPr>
          <a:xfrm>
            <a:off x="2916031" y="2683989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399" y="59184"/>
                </a:moveTo>
                <a:lnTo>
                  <a:pt x="0" y="59184"/>
                </a:lnTo>
                <a:lnTo>
                  <a:pt x="25400" y="135384"/>
                </a:lnTo>
                <a:lnTo>
                  <a:pt x="46566" y="71884"/>
                </a:lnTo>
                <a:lnTo>
                  <a:pt x="17399" y="71884"/>
                </a:lnTo>
                <a:lnTo>
                  <a:pt x="17399" y="59184"/>
                </a:lnTo>
                <a:close/>
              </a:path>
              <a:path w="50800" h="135889">
                <a:moveTo>
                  <a:pt x="33274" y="0"/>
                </a:moveTo>
                <a:lnTo>
                  <a:pt x="17399" y="0"/>
                </a:lnTo>
                <a:lnTo>
                  <a:pt x="17399" y="71884"/>
                </a:lnTo>
                <a:lnTo>
                  <a:pt x="33274" y="71884"/>
                </a:lnTo>
                <a:lnTo>
                  <a:pt x="33274" y="0"/>
                </a:lnTo>
                <a:close/>
              </a:path>
              <a:path w="50800" h="135889">
                <a:moveTo>
                  <a:pt x="50800" y="59184"/>
                </a:moveTo>
                <a:lnTo>
                  <a:pt x="33274" y="59184"/>
                </a:lnTo>
                <a:lnTo>
                  <a:pt x="33274" y="71884"/>
                </a:lnTo>
                <a:lnTo>
                  <a:pt x="46566" y="71884"/>
                </a:lnTo>
                <a:lnTo>
                  <a:pt x="50800" y="59184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4" name="object 94"/>
          <p:cNvSpPr/>
          <p:nvPr/>
        </p:nvSpPr>
        <p:spPr>
          <a:xfrm>
            <a:off x="3485269" y="3397408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5" name="object 95"/>
          <p:cNvSpPr/>
          <p:nvPr/>
        </p:nvSpPr>
        <p:spPr>
          <a:xfrm>
            <a:off x="3803084" y="2834497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526" y="59184"/>
                </a:moveTo>
                <a:lnTo>
                  <a:pt x="0" y="59184"/>
                </a:lnTo>
                <a:lnTo>
                  <a:pt x="25400" y="135384"/>
                </a:lnTo>
                <a:lnTo>
                  <a:pt x="46566" y="71884"/>
                </a:lnTo>
                <a:lnTo>
                  <a:pt x="17526" y="71884"/>
                </a:lnTo>
                <a:lnTo>
                  <a:pt x="17526" y="59184"/>
                </a:lnTo>
                <a:close/>
              </a:path>
              <a:path w="50800" h="135889">
                <a:moveTo>
                  <a:pt x="33401" y="0"/>
                </a:moveTo>
                <a:lnTo>
                  <a:pt x="17526" y="0"/>
                </a:lnTo>
                <a:lnTo>
                  <a:pt x="17526" y="71884"/>
                </a:lnTo>
                <a:lnTo>
                  <a:pt x="33401" y="71884"/>
                </a:lnTo>
                <a:lnTo>
                  <a:pt x="33401" y="0"/>
                </a:lnTo>
                <a:close/>
              </a:path>
              <a:path w="50800" h="135889">
                <a:moveTo>
                  <a:pt x="50800" y="59184"/>
                </a:moveTo>
                <a:lnTo>
                  <a:pt x="33401" y="59184"/>
                </a:lnTo>
                <a:lnTo>
                  <a:pt x="33401" y="71884"/>
                </a:lnTo>
                <a:lnTo>
                  <a:pt x="46566" y="71884"/>
                </a:lnTo>
                <a:lnTo>
                  <a:pt x="50800" y="59184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6" name="object 96"/>
          <p:cNvSpPr/>
          <p:nvPr/>
        </p:nvSpPr>
        <p:spPr>
          <a:xfrm>
            <a:off x="3485269" y="3880230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332" y="33401"/>
                </a:lnTo>
                <a:lnTo>
                  <a:pt x="76835" y="33401"/>
                </a:lnTo>
                <a:lnTo>
                  <a:pt x="76835" y="17526"/>
                </a:lnTo>
                <a:lnTo>
                  <a:pt x="116713" y="17526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135" y="33401"/>
                </a:lnTo>
                <a:lnTo>
                  <a:pt x="64135" y="17526"/>
                </a:lnTo>
                <a:close/>
              </a:path>
              <a:path w="140335" h="50800">
                <a:moveTo>
                  <a:pt x="116713" y="17526"/>
                </a:moveTo>
                <a:lnTo>
                  <a:pt x="76835" y="17526"/>
                </a:lnTo>
                <a:lnTo>
                  <a:pt x="76835" y="33401"/>
                </a:lnTo>
                <a:lnTo>
                  <a:pt x="116332" y="33401"/>
                </a:lnTo>
                <a:lnTo>
                  <a:pt x="140335" y="25400"/>
                </a:lnTo>
                <a:lnTo>
                  <a:pt x="116713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7" name="object 97"/>
          <p:cNvSpPr/>
          <p:nvPr/>
        </p:nvSpPr>
        <p:spPr>
          <a:xfrm>
            <a:off x="3544989" y="2686408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399" y="59307"/>
                </a:moveTo>
                <a:lnTo>
                  <a:pt x="0" y="59307"/>
                </a:lnTo>
                <a:lnTo>
                  <a:pt x="25400" y="135507"/>
                </a:lnTo>
                <a:lnTo>
                  <a:pt x="46566" y="72007"/>
                </a:lnTo>
                <a:lnTo>
                  <a:pt x="17399" y="72007"/>
                </a:lnTo>
                <a:lnTo>
                  <a:pt x="17399" y="59307"/>
                </a:lnTo>
                <a:close/>
              </a:path>
              <a:path w="50800" h="135889">
                <a:moveTo>
                  <a:pt x="33274" y="0"/>
                </a:moveTo>
                <a:lnTo>
                  <a:pt x="17399" y="0"/>
                </a:lnTo>
                <a:lnTo>
                  <a:pt x="17399" y="72007"/>
                </a:lnTo>
                <a:lnTo>
                  <a:pt x="33274" y="72007"/>
                </a:lnTo>
                <a:lnTo>
                  <a:pt x="33274" y="0"/>
                </a:lnTo>
                <a:close/>
              </a:path>
              <a:path w="50800" h="135889">
                <a:moveTo>
                  <a:pt x="50800" y="59307"/>
                </a:moveTo>
                <a:lnTo>
                  <a:pt x="33274" y="59307"/>
                </a:lnTo>
                <a:lnTo>
                  <a:pt x="33274" y="72007"/>
                </a:lnTo>
                <a:lnTo>
                  <a:pt x="46566" y="72007"/>
                </a:lnTo>
                <a:lnTo>
                  <a:pt x="50800" y="5930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8" name="object 98"/>
          <p:cNvSpPr/>
          <p:nvPr/>
        </p:nvSpPr>
        <p:spPr>
          <a:xfrm>
            <a:off x="4110428" y="3394877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10" y="33401"/>
                </a:lnTo>
                <a:lnTo>
                  <a:pt x="76710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10" y="17526"/>
                </a:lnTo>
                <a:lnTo>
                  <a:pt x="76710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99" name="object 99"/>
          <p:cNvSpPr/>
          <p:nvPr/>
        </p:nvSpPr>
        <p:spPr>
          <a:xfrm>
            <a:off x="4428130" y="2831968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526" y="59307"/>
                </a:moveTo>
                <a:lnTo>
                  <a:pt x="0" y="59307"/>
                </a:lnTo>
                <a:lnTo>
                  <a:pt x="25400" y="135507"/>
                </a:lnTo>
                <a:lnTo>
                  <a:pt x="46566" y="72007"/>
                </a:lnTo>
                <a:lnTo>
                  <a:pt x="17526" y="72007"/>
                </a:lnTo>
                <a:lnTo>
                  <a:pt x="17526" y="59307"/>
                </a:lnTo>
                <a:close/>
              </a:path>
              <a:path w="50800" h="135889">
                <a:moveTo>
                  <a:pt x="33401" y="0"/>
                </a:moveTo>
                <a:lnTo>
                  <a:pt x="17526" y="0"/>
                </a:lnTo>
                <a:lnTo>
                  <a:pt x="17526" y="72007"/>
                </a:lnTo>
                <a:lnTo>
                  <a:pt x="33401" y="72007"/>
                </a:lnTo>
                <a:lnTo>
                  <a:pt x="33401" y="0"/>
                </a:lnTo>
                <a:close/>
              </a:path>
              <a:path w="50800" h="135889">
                <a:moveTo>
                  <a:pt x="50800" y="59307"/>
                </a:moveTo>
                <a:lnTo>
                  <a:pt x="33401" y="59307"/>
                </a:lnTo>
                <a:lnTo>
                  <a:pt x="33401" y="72007"/>
                </a:lnTo>
                <a:lnTo>
                  <a:pt x="46566" y="72007"/>
                </a:lnTo>
                <a:lnTo>
                  <a:pt x="50800" y="5930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0" name="object 100"/>
          <p:cNvSpPr/>
          <p:nvPr/>
        </p:nvSpPr>
        <p:spPr>
          <a:xfrm>
            <a:off x="4110428" y="3877813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586" y="33274"/>
                </a:lnTo>
                <a:lnTo>
                  <a:pt x="76710" y="33274"/>
                </a:lnTo>
                <a:lnTo>
                  <a:pt x="76710" y="17399"/>
                </a:lnTo>
                <a:lnTo>
                  <a:pt x="116205" y="17399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008" y="33274"/>
                </a:lnTo>
                <a:lnTo>
                  <a:pt x="64008" y="17399"/>
                </a:lnTo>
                <a:close/>
              </a:path>
              <a:path w="140335" h="50800">
                <a:moveTo>
                  <a:pt x="116205" y="17399"/>
                </a:moveTo>
                <a:lnTo>
                  <a:pt x="76710" y="17399"/>
                </a:lnTo>
                <a:lnTo>
                  <a:pt x="76710" y="33274"/>
                </a:lnTo>
                <a:lnTo>
                  <a:pt x="116586" y="33274"/>
                </a:lnTo>
                <a:lnTo>
                  <a:pt x="140208" y="25400"/>
                </a:lnTo>
                <a:lnTo>
                  <a:pt x="116205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1" name="object 101"/>
          <p:cNvSpPr/>
          <p:nvPr/>
        </p:nvSpPr>
        <p:spPr>
          <a:xfrm>
            <a:off x="4170032" y="2683989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526" y="59184"/>
                </a:moveTo>
                <a:lnTo>
                  <a:pt x="0" y="59184"/>
                </a:lnTo>
                <a:lnTo>
                  <a:pt x="25400" y="135384"/>
                </a:lnTo>
                <a:lnTo>
                  <a:pt x="46566" y="71884"/>
                </a:lnTo>
                <a:lnTo>
                  <a:pt x="17526" y="71884"/>
                </a:lnTo>
                <a:lnTo>
                  <a:pt x="17526" y="59184"/>
                </a:lnTo>
                <a:close/>
              </a:path>
              <a:path w="50800" h="135889">
                <a:moveTo>
                  <a:pt x="33401" y="0"/>
                </a:moveTo>
                <a:lnTo>
                  <a:pt x="17526" y="0"/>
                </a:lnTo>
                <a:lnTo>
                  <a:pt x="17526" y="71884"/>
                </a:lnTo>
                <a:lnTo>
                  <a:pt x="33401" y="71884"/>
                </a:lnTo>
                <a:lnTo>
                  <a:pt x="33401" y="0"/>
                </a:lnTo>
                <a:close/>
              </a:path>
              <a:path w="50800" h="135889">
                <a:moveTo>
                  <a:pt x="50800" y="59184"/>
                </a:moveTo>
                <a:lnTo>
                  <a:pt x="33401" y="59184"/>
                </a:lnTo>
                <a:lnTo>
                  <a:pt x="33401" y="71884"/>
                </a:lnTo>
                <a:lnTo>
                  <a:pt x="46566" y="71884"/>
                </a:lnTo>
                <a:lnTo>
                  <a:pt x="50800" y="59184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2" name="object 102"/>
          <p:cNvSpPr/>
          <p:nvPr/>
        </p:nvSpPr>
        <p:spPr>
          <a:xfrm>
            <a:off x="4743988" y="3386822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3" name="object 103"/>
          <p:cNvSpPr/>
          <p:nvPr/>
        </p:nvSpPr>
        <p:spPr>
          <a:xfrm>
            <a:off x="5061802" y="2823916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399" y="59179"/>
                </a:moveTo>
                <a:lnTo>
                  <a:pt x="0" y="59179"/>
                </a:lnTo>
                <a:lnTo>
                  <a:pt x="25400" y="135379"/>
                </a:lnTo>
                <a:lnTo>
                  <a:pt x="46566" y="71879"/>
                </a:lnTo>
                <a:lnTo>
                  <a:pt x="17399" y="71879"/>
                </a:lnTo>
                <a:lnTo>
                  <a:pt x="17399" y="59179"/>
                </a:lnTo>
                <a:close/>
              </a:path>
              <a:path w="50800" h="135889">
                <a:moveTo>
                  <a:pt x="33274" y="0"/>
                </a:moveTo>
                <a:lnTo>
                  <a:pt x="17399" y="0"/>
                </a:lnTo>
                <a:lnTo>
                  <a:pt x="17399" y="71879"/>
                </a:lnTo>
                <a:lnTo>
                  <a:pt x="33274" y="71879"/>
                </a:lnTo>
                <a:lnTo>
                  <a:pt x="33274" y="0"/>
                </a:lnTo>
                <a:close/>
              </a:path>
              <a:path w="50800" h="135889">
                <a:moveTo>
                  <a:pt x="50800" y="59179"/>
                </a:moveTo>
                <a:lnTo>
                  <a:pt x="33274" y="59179"/>
                </a:lnTo>
                <a:lnTo>
                  <a:pt x="33274" y="71879"/>
                </a:lnTo>
                <a:lnTo>
                  <a:pt x="46566" y="71879"/>
                </a:lnTo>
                <a:lnTo>
                  <a:pt x="50800" y="5917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4" name="object 104"/>
          <p:cNvSpPr/>
          <p:nvPr/>
        </p:nvSpPr>
        <p:spPr>
          <a:xfrm>
            <a:off x="4743988" y="386975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586" y="33274"/>
                </a:lnTo>
                <a:lnTo>
                  <a:pt x="76705" y="33274"/>
                </a:lnTo>
                <a:lnTo>
                  <a:pt x="76705" y="17399"/>
                </a:lnTo>
                <a:lnTo>
                  <a:pt x="116205" y="17399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008" y="33274"/>
                </a:lnTo>
                <a:lnTo>
                  <a:pt x="64008" y="17399"/>
                </a:lnTo>
                <a:close/>
              </a:path>
              <a:path w="140335" h="50800">
                <a:moveTo>
                  <a:pt x="116205" y="17399"/>
                </a:moveTo>
                <a:lnTo>
                  <a:pt x="76705" y="17399"/>
                </a:lnTo>
                <a:lnTo>
                  <a:pt x="76705" y="33274"/>
                </a:lnTo>
                <a:lnTo>
                  <a:pt x="116586" y="33274"/>
                </a:lnTo>
                <a:lnTo>
                  <a:pt x="140208" y="25400"/>
                </a:lnTo>
                <a:lnTo>
                  <a:pt x="116205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5" name="object 105"/>
          <p:cNvSpPr/>
          <p:nvPr/>
        </p:nvSpPr>
        <p:spPr>
          <a:xfrm>
            <a:off x="4803593" y="2675934"/>
            <a:ext cx="46026" cy="123121"/>
          </a:xfrm>
          <a:custGeom>
            <a:avLst/>
            <a:gdLst/>
            <a:ahLst/>
            <a:cxnLst/>
            <a:rect l="l" t="t" r="r" b="b"/>
            <a:pathLst>
              <a:path w="50800" h="135889">
                <a:moveTo>
                  <a:pt x="17526" y="59184"/>
                </a:moveTo>
                <a:lnTo>
                  <a:pt x="0" y="59184"/>
                </a:lnTo>
                <a:lnTo>
                  <a:pt x="25400" y="135384"/>
                </a:lnTo>
                <a:lnTo>
                  <a:pt x="46566" y="71884"/>
                </a:lnTo>
                <a:lnTo>
                  <a:pt x="17526" y="71884"/>
                </a:lnTo>
                <a:lnTo>
                  <a:pt x="17526" y="59184"/>
                </a:lnTo>
                <a:close/>
              </a:path>
              <a:path w="50800" h="135889">
                <a:moveTo>
                  <a:pt x="33401" y="0"/>
                </a:moveTo>
                <a:lnTo>
                  <a:pt x="17526" y="0"/>
                </a:lnTo>
                <a:lnTo>
                  <a:pt x="17526" y="71884"/>
                </a:lnTo>
                <a:lnTo>
                  <a:pt x="33401" y="71884"/>
                </a:lnTo>
                <a:lnTo>
                  <a:pt x="33401" y="0"/>
                </a:lnTo>
                <a:close/>
              </a:path>
              <a:path w="50800" h="135889">
                <a:moveTo>
                  <a:pt x="50800" y="59184"/>
                </a:moveTo>
                <a:lnTo>
                  <a:pt x="33401" y="59184"/>
                </a:lnTo>
                <a:lnTo>
                  <a:pt x="33401" y="71884"/>
                </a:lnTo>
                <a:lnTo>
                  <a:pt x="46566" y="71884"/>
                </a:lnTo>
                <a:lnTo>
                  <a:pt x="50800" y="59184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6" name="object 106"/>
          <p:cNvSpPr/>
          <p:nvPr/>
        </p:nvSpPr>
        <p:spPr>
          <a:xfrm>
            <a:off x="3527958" y="2663049"/>
            <a:ext cx="236117" cy="154650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7" name="object 107"/>
          <p:cNvSpPr/>
          <p:nvPr/>
        </p:nvSpPr>
        <p:spPr>
          <a:xfrm>
            <a:off x="3656374" y="2805272"/>
            <a:ext cx="236117" cy="154650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8" name="object 108"/>
          <p:cNvSpPr/>
          <p:nvPr/>
        </p:nvSpPr>
        <p:spPr>
          <a:xfrm>
            <a:off x="3420255" y="3916820"/>
            <a:ext cx="236117" cy="156031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09" name="object 109"/>
          <p:cNvSpPr txBox="1"/>
          <p:nvPr/>
        </p:nvSpPr>
        <p:spPr>
          <a:xfrm>
            <a:off x="3492402" y="3930743"/>
            <a:ext cx="86301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110" name="object 110"/>
          <p:cNvSpPr/>
          <p:nvPr/>
        </p:nvSpPr>
        <p:spPr>
          <a:xfrm>
            <a:off x="3433373" y="1030040"/>
            <a:ext cx="550362" cy="917061"/>
          </a:xfrm>
          <a:prstGeom prst="rect">
            <a:avLst/>
          </a:prstGeom>
          <a:blipFill>
            <a:blip r:embed="rId3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1" name="object 111"/>
          <p:cNvSpPr/>
          <p:nvPr/>
        </p:nvSpPr>
        <p:spPr>
          <a:xfrm>
            <a:off x="4687489" y="1030040"/>
            <a:ext cx="550366" cy="917061"/>
          </a:xfrm>
          <a:prstGeom prst="rect">
            <a:avLst/>
          </a:prstGeom>
          <a:blipFill>
            <a:blip r:embed="rId3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2" name="object 112"/>
          <p:cNvSpPr/>
          <p:nvPr/>
        </p:nvSpPr>
        <p:spPr>
          <a:xfrm>
            <a:off x="4062905" y="1030040"/>
            <a:ext cx="550367" cy="917061"/>
          </a:xfrm>
          <a:prstGeom prst="rect">
            <a:avLst/>
          </a:prstGeom>
          <a:blipFill>
            <a:blip r:embed="rId3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3" name="object 113"/>
          <p:cNvSpPr/>
          <p:nvPr/>
        </p:nvSpPr>
        <p:spPr>
          <a:xfrm>
            <a:off x="2808215" y="1030097"/>
            <a:ext cx="550362" cy="917004"/>
          </a:xfrm>
          <a:prstGeom prst="rect">
            <a:avLst/>
          </a:prstGeom>
          <a:blipFill>
            <a:blip r:embed="rId3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4" name="object 114"/>
          <p:cNvSpPr/>
          <p:nvPr/>
        </p:nvSpPr>
        <p:spPr>
          <a:xfrm>
            <a:off x="3434639" y="2038834"/>
            <a:ext cx="550400" cy="458519"/>
          </a:xfrm>
          <a:prstGeom prst="rect">
            <a:avLst/>
          </a:prstGeom>
          <a:blipFill>
            <a:blip r:embed="rId3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5" name="object 115"/>
          <p:cNvSpPr/>
          <p:nvPr/>
        </p:nvSpPr>
        <p:spPr>
          <a:xfrm>
            <a:off x="4686339" y="2038834"/>
            <a:ext cx="550367" cy="458519"/>
          </a:xfrm>
          <a:prstGeom prst="rect">
            <a:avLst/>
          </a:prstGeom>
          <a:blipFill>
            <a:blip r:embed="rId4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6" name="object 116"/>
          <p:cNvSpPr/>
          <p:nvPr/>
        </p:nvSpPr>
        <p:spPr>
          <a:xfrm>
            <a:off x="4062904" y="2038810"/>
            <a:ext cx="550398" cy="458542"/>
          </a:xfrm>
          <a:prstGeom prst="rect">
            <a:avLst/>
          </a:prstGeom>
          <a:blipFill>
            <a:blip r:embed="rId4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7" name="object 117"/>
          <p:cNvSpPr/>
          <p:nvPr/>
        </p:nvSpPr>
        <p:spPr>
          <a:xfrm>
            <a:off x="2814541" y="2038834"/>
            <a:ext cx="550390" cy="458519"/>
          </a:xfrm>
          <a:prstGeom prst="rect">
            <a:avLst/>
          </a:prstGeom>
          <a:blipFill>
            <a:blip r:embed="rId4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8" name="object 118"/>
          <p:cNvSpPr/>
          <p:nvPr/>
        </p:nvSpPr>
        <p:spPr>
          <a:xfrm>
            <a:off x="2972760" y="115428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19" name="object 119"/>
          <p:cNvSpPr/>
          <p:nvPr/>
        </p:nvSpPr>
        <p:spPr>
          <a:xfrm>
            <a:off x="3083684" y="1818572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586" y="33274"/>
                </a:lnTo>
                <a:lnTo>
                  <a:pt x="76710" y="33274"/>
                </a:lnTo>
                <a:lnTo>
                  <a:pt x="76710" y="17399"/>
                </a:lnTo>
                <a:lnTo>
                  <a:pt x="116205" y="17399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008" y="33274"/>
                </a:lnTo>
                <a:lnTo>
                  <a:pt x="64008" y="17399"/>
                </a:lnTo>
                <a:close/>
              </a:path>
              <a:path w="140335" h="50800">
                <a:moveTo>
                  <a:pt x="116205" y="17399"/>
                </a:moveTo>
                <a:lnTo>
                  <a:pt x="76710" y="17399"/>
                </a:lnTo>
                <a:lnTo>
                  <a:pt x="76710" y="33274"/>
                </a:lnTo>
                <a:lnTo>
                  <a:pt x="116586" y="33274"/>
                </a:lnTo>
                <a:lnTo>
                  <a:pt x="140208" y="25400"/>
                </a:lnTo>
                <a:lnTo>
                  <a:pt x="116205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0" name="object 120"/>
          <p:cNvSpPr/>
          <p:nvPr/>
        </p:nvSpPr>
        <p:spPr>
          <a:xfrm>
            <a:off x="2921556" y="2327169"/>
            <a:ext cx="46026" cy="129452"/>
          </a:xfrm>
          <a:custGeom>
            <a:avLst/>
            <a:gdLst/>
            <a:ahLst/>
            <a:cxnLst/>
            <a:rect l="l" t="t" r="r" b="b"/>
            <a:pathLst>
              <a:path w="50800" h="142875">
                <a:moveTo>
                  <a:pt x="33401" y="63500"/>
                </a:moveTo>
                <a:lnTo>
                  <a:pt x="17526" y="63500"/>
                </a:lnTo>
                <a:lnTo>
                  <a:pt x="17526" y="142875"/>
                </a:lnTo>
                <a:lnTo>
                  <a:pt x="33401" y="142875"/>
                </a:lnTo>
                <a:lnTo>
                  <a:pt x="33401" y="63500"/>
                </a:lnTo>
                <a:close/>
              </a:path>
              <a:path w="50800" h="142875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2875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1" name="object 121"/>
          <p:cNvSpPr/>
          <p:nvPr/>
        </p:nvSpPr>
        <p:spPr>
          <a:xfrm>
            <a:off x="3053652" y="1448287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713" y="33274"/>
                </a:lnTo>
                <a:lnTo>
                  <a:pt x="76835" y="33274"/>
                </a:lnTo>
                <a:lnTo>
                  <a:pt x="76835" y="17399"/>
                </a:lnTo>
                <a:lnTo>
                  <a:pt x="116332" y="17399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399"/>
                </a:moveTo>
                <a:lnTo>
                  <a:pt x="0" y="17399"/>
                </a:lnTo>
                <a:lnTo>
                  <a:pt x="0" y="33274"/>
                </a:lnTo>
                <a:lnTo>
                  <a:pt x="64135" y="33274"/>
                </a:lnTo>
                <a:lnTo>
                  <a:pt x="64135" y="17399"/>
                </a:lnTo>
                <a:close/>
              </a:path>
              <a:path w="140335" h="50800">
                <a:moveTo>
                  <a:pt x="116332" y="17399"/>
                </a:moveTo>
                <a:lnTo>
                  <a:pt x="76835" y="17399"/>
                </a:lnTo>
                <a:lnTo>
                  <a:pt x="76835" y="33274"/>
                </a:lnTo>
                <a:lnTo>
                  <a:pt x="116713" y="33274"/>
                </a:lnTo>
                <a:lnTo>
                  <a:pt x="140335" y="25400"/>
                </a:lnTo>
                <a:lnTo>
                  <a:pt x="116332" y="1739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2" name="object 122"/>
          <p:cNvSpPr/>
          <p:nvPr/>
        </p:nvSpPr>
        <p:spPr>
          <a:xfrm>
            <a:off x="3162737" y="2268023"/>
            <a:ext cx="46026" cy="130026"/>
          </a:xfrm>
          <a:custGeom>
            <a:avLst/>
            <a:gdLst/>
            <a:ahLst/>
            <a:cxnLst/>
            <a:rect l="l" t="t" r="r" b="b"/>
            <a:pathLst>
              <a:path w="50800" h="143510">
                <a:moveTo>
                  <a:pt x="33401" y="63500"/>
                </a:moveTo>
                <a:lnTo>
                  <a:pt x="17526" y="63500"/>
                </a:lnTo>
                <a:lnTo>
                  <a:pt x="17526" y="143004"/>
                </a:lnTo>
                <a:lnTo>
                  <a:pt x="33401" y="143004"/>
                </a:lnTo>
                <a:lnTo>
                  <a:pt x="33401" y="63500"/>
                </a:lnTo>
                <a:close/>
              </a:path>
              <a:path w="50800" h="143510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3510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3" name="object 123"/>
          <p:cNvSpPr/>
          <p:nvPr/>
        </p:nvSpPr>
        <p:spPr>
          <a:xfrm>
            <a:off x="3594007" y="1155900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135" y="0"/>
                </a:moveTo>
                <a:lnTo>
                  <a:pt x="64135" y="50800"/>
                </a:lnTo>
                <a:lnTo>
                  <a:pt x="116332" y="33401"/>
                </a:lnTo>
                <a:lnTo>
                  <a:pt x="76835" y="33401"/>
                </a:lnTo>
                <a:lnTo>
                  <a:pt x="76835" y="17526"/>
                </a:lnTo>
                <a:lnTo>
                  <a:pt x="116713" y="17526"/>
                </a:lnTo>
                <a:lnTo>
                  <a:pt x="64135" y="0"/>
                </a:lnTo>
                <a:close/>
              </a:path>
              <a:path w="140335" h="50800">
                <a:moveTo>
                  <a:pt x="64135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135" y="33401"/>
                </a:lnTo>
                <a:lnTo>
                  <a:pt x="64135" y="17526"/>
                </a:lnTo>
                <a:close/>
              </a:path>
              <a:path w="140335" h="50800">
                <a:moveTo>
                  <a:pt x="116713" y="17526"/>
                </a:moveTo>
                <a:lnTo>
                  <a:pt x="76835" y="17526"/>
                </a:lnTo>
                <a:lnTo>
                  <a:pt x="76835" y="33401"/>
                </a:lnTo>
                <a:lnTo>
                  <a:pt x="116332" y="33401"/>
                </a:lnTo>
                <a:lnTo>
                  <a:pt x="140335" y="25400"/>
                </a:lnTo>
                <a:lnTo>
                  <a:pt x="116713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4" name="object 124"/>
          <p:cNvSpPr/>
          <p:nvPr/>
        </p:nvSpPr>
        <p:spPr>
          <a:xfrm>
            <a:off x="3704932" y="1820183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5" name="object 125"/>
          <p:cNvSpPr/>
          <p:nvPr/>
        </p:nvSpPr>
        <p:spPr>
          <a:xfrm>
            <a:off x="3542803" y="2328778"/>
            <a:ext cx="46026" cy="130026"/>
          </a:xfrm>
          <a:custGeom>
            <a:avLst/>
            <a:gdLst/>
            <a:ahLst/>
            <a:cxnLst/>
            <a:rect l="l" t="t" r="r" b="b"/>
            <a:pathLst>
              <a:path w="50800" h="143510">
                <a:moveTo>
                  <a:pt x="33401" y="63500"/>
                </a:moveTo>
                <a:lnTo>
                  <a:pt x="17526" y="63500"/>
                </a:lnTo>
                <a:lnTo>
                  <a:pt x="17526" y="142999"/>
                </a:lnTo>
                <a:lnTo>
                  <a:pt x="33401" y="142999"/>
                </a:lnTo>
                <a:lnTo>
                  <a:pt x="33401" y="63500"/>
                </a:lnTo>
                <a:close/>
              </a:path>
              <a:path w="50800" h="143510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3510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6" name="object 126"/>
          <p:cNvSpPr/>
          <p:nvPr/>
        </p:nvSpPr>
        <p:spPr>
          <a:xfrm>
            <a:off x="3675014" y="1449898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7" name="object 127"/>
          <p:cNvSpPr/>
          <p:nvPr/>
        </p:nvSpPr>
        <p:spPr>
          <a:xfrm>
            <a:off x="3784099" y="2269749"/>
            <a:ext cx="46026" cy="129452"/>
          </a:xfrm>
          <a:custGeom>
            <a:avLst/>
            <a:gdLst/>
            <a:ahLst/>
            <a:cxnLst/>
            <a:rect l="l" t="t" r="r" b="b"/>
            <a:pathLst>
              <a:path w="50800" h="142875">
                <a:moveTo>
                  <a:pt x="33274" y="63500"/>
                </a:moveTo>
                <a:lnTo>
                  <a:pt x="17399" y="63500"/>
                </a:lnTo>
                <a:lnTo>
                  <a:pt x="17399" y="142875"/>
                </a:lnTo>
                <a:lnTo>
                  <a:pt x="33274" y="142875"/>
                </a:lnTo>
                <a:lnTo>
                  <a:pt x="33274" y="63500"/>
                </a:lnTo>
                <a:close/>
              </a:path>
              <a:path w="50800" h="14287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287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8" name="object 128"/>
          <p:cNvSpPr/>
          <p:nvPr/>
        </p:nvSpPr>
        <p:spPr>
          <a:xfrm>
            <a:off x="4237003" y="1152563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10" y="33401"/>
                </a:lnTo>
                <a:lnTo>
                  <a:pt x="76710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10" y="17526"/>
                </a:lnTo>
                <a:lnTo>
                  <a:pt x="76710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29" name="object 129"/>
          <p:cNvSpPr/>
          <p:nvPr/>
        </p:nvSpPr>
        <p:spPr>
          <a:xfrm>
            <a:off x="4347811" y="1816846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0" name="object 130"/>
          <p:cNvSpPr/>
          <p:nvPr/>
        </p:nvSpPr>
        <p:spPr>
          <a:xfrm>
            <a:off x="4185683" y="2325441"/>
            <a:ext cx="46026" cy="130026"/>
          </a:xfrm>
          <a:custGeom>
            <a:avLst/>
            <a:gdLst/>
            <a:ahLst/>
            <a:cxnLst/>
            <a:rect l="l" t="t" r="r" b="b"/>
            <a:pathLst>
              <a:path w="50800" h="143510">
                <a:moveTo>
                  <a:pt x="33401" y="63500"/>
                </a:moveTo>
                <a:lnTo>
                  <a:pt x="17526" y="63500"/>
                </a:lnTo>
                <a:lnTo>
                  <a:pt x="17526" y="143004"/>
                </a:lnTo>
                <a:lnTo>
                  <a:pt x="33401" y="143004"/>
                </a:lnTo>
                <a:lnTo>
                  <a:pt x="33401" y="63500"/>
                </a:lnTo>
                <a:close/>
              </a:path>
              <a:path w="50800" h="143510">
                <a:moveTo>
                  <a:pt x="25400" y="0"/>
                </a:moveTo>
                <a:lnTo>
                  <a:pt x="0" y="76200"/>
                </a:lnTo>
                <a:lnTo>
                  <a:pt x="17526" y="76200"/>
                </a:lnTo>
                <a:lnTo>
                  <a:pt x="17526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3510">
                <a:moveTo>
                  <a:pt x="46566" y="63500"/>
                </a:moveTo>
                <a:lnTo>
                  <a:pt x="33401" y="63500"/>
                </a:lnTo>
                <a:lnTo>
                  <a:pt x="33401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1" name="object 131"/>
          <p:cNvSpPr/>
          <p:nvPr/>
        </p:nvSpPr>
        <p:spPr>
          <a:xfrm>
            <a:off x="4317894" y="1446561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2" name="object 132"/>
          <p:cNvSpPr/>
          <p:nvPr/>
        </p:nvSpPr>
        <p:spPr>
          <a:xfrm>
            <a:off x="4426978" y="2266412"/>
            <a:ext cx="46026" cy="129452"/>
          </a:xfrm>
          <a:custGeom>
            <a:avLst/>
            <a:gdLst/>
            <a:ahLst/>
            <a:cxnLst/>
            <a:rect l="l" t="t" r="r" b="b"/>
            <a:pathLst>
              <a:path w="50800" h="142875">
                <a:moveTo>
                  <a:pt x="33274" y="63500"/>
                </a:moveTo>
                <a:lnTo>
                  <a:pt x="17399" y="63500"/>
                </a:lnTo>
                <a:lnTo>
                  <a:pt x="17399" y="142875"/>
                </a:lnTo>
                <a:lnTo>
                  <a:pt x="33274" y="142875"/>
                </a:lnTo>
                <a:lnTo>
                  <a:pt x="33274" y="63500"/>
                </a:lnTo>
                <a:close/>
              </a:path>
              <a:path w="50800" h="142875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2875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3" name="object 133"/>
          <p:cNvSpPr/>
          <p:nvPr/>
        </p:nvSpPr>
        <p:spPr>
          <a:xfrm>
            <a:off x="4841105" y="1149226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10" y="33401"/>
                </a:lnTo>
                <a:lnTo>
                  <a:pt x="76710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10" y="17526"/>
                </a:lnTo>
                <a:lnTo>
                  <a:pt x="76710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4" name="object 134"/>
          <p:cNvSpPr/>
          <p:nvPr/>
        </p:nvSpPr>
        <p:spPr>
          <a:xfrm>
            <a:off x="4951914" y="1813509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10" y="33401"/>
                </a:lnTo>
                <a:lnTo>
                  <a:pt x="76710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10" y="17526"/>
                </a:lnTo>
                <a:lnTo>
                  <a:pt x="76710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5" name="object 135"/>
          <p:cNvSpPr/>
          <p:nvPr/>
        </p:nvSpPr>
        <p:spPr>
          <a:xfrm>
            <a:off x="4789901" y="2322105"/>
            <a:ext cx="46026" cy="130026"/>
          </a:xfrm>
          <a:custGeom>
            <a:avLst/>
            <a:gdLst/>
            <a:ahLst/>
            <a:cxnLst/>
            <a:rect l="l" t="t" r="r" b="b"/>
            <a:pathLst>
              <a:path w="50800" h="143510">
                <a:moveTo>
                  <a:pt x="33274" y="63500"/>
                </a:moveTo>
                <a:lnTo>
                  <a:pt x="17399" y="63500"/>
                </a:lnTo>
                <a:lnTo>
                  <a:pt x="17399" y="143004"/>
                </a:lnTo>
                <a:lnTo>
                  <a:pt x="33274" y="143004"/>
                </a:lnTo>
                <a:lnTo>
                  <a:pt x="33274" y="63500"/>
                </a:lnTo>
                <a:close/>
              </a:path>
              <a:path w="50800" h="143510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3510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6" name="object 136"/>
          <p:cNvSpPr/>
          <p:nvPr/>
        </p:nvSpPr>
        <p:spPr>
          <a:xfrm>
            <a:off x="4921996" y="1443224"/>
            <a:ext cx="127149" cy="46026"/>
          </a:xfrm>
          <a:custGeom>
            <a:avLst/>
            <a:gdLst/>
            <a:ahLst/>
            <a:cxnLst/>
            <a:rect l="l" t="t" r="r" b="b"/>
            <a:pathLst>
              <a:path w="140335" h="50800">
                <a:moveTo>
                  <a:pt x="64008" y="0"/>
                </a:moveTo>
                <a:lnTo>
                  <a:pt x="64008" y="50800"/>
                </a:lnTo>
                <a:lnTo>
                  <a:pt x="116205" y="33401"/>
                </a:lnTo>
                <a:lnTo>
                  <a:pt x="76705" y="33401"/>
                </a:lnTo>
                <a:lnTo>
                  <a:pt x="76705" y="17526"/>
                </a:lnTo>
                <a:lnTo>
                  <a:pt x="116586" y="17526"/>
                </a:lnTo>
                <a:lnTo>
                  <a:pt x="64008" y="0"/>
                </a:lnTo>
                <a:close/>
              </a:path>
              <a:path w="140335" h="50800">
                <a:moveTo>
                  <a:pt x="64008" y="17526"/>
                </a:moveTo>
                <a:lnTo>
                  <a:pt x="0" y="17526"/>
                </a:lnTo>
                <a:lnTo>
                  <a:pt x="0" y="33401"/>
                </a:lnTo>
                <a:lnTo>
                  <a:pt x="64008" y="33401"/>
                </a:lnTo>
                <a:lnTo>
                  <a:pt x="64008" y="17526"/>
                </a:lnTo>
                <a:close/>
              </a:path>
              <a:path w="140335" h="50800">
                <a:moveTo>
                  <a:pt x="116586" y="17526"/>
                </a:moveTo>
                <a:lnTo>
                  <a:pt x="76705" y="17526"/>
                </a:lnTo>
                <a:lnTo>
                  <a:pt x="76705" y="33401"/>
                </a:lnTo>
                <a:lnTo>
                  <a:pt x="116205" y="33401"/>
                </a:lnTo>
                <a:lnTo>
                  <a:pt x="140208" y="25400"/>
                </a:lnTo>
                <a:lnTo>
                  <a:pt x="116586" y="1752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7" name="object 137"/>
          <p:cNvSpPr/>
          <p:nvPr/>
        </p:nvSpPr>
        <p:spPr>
          <a:xfrm>
            <a:off x="5031081" y="2263075"/>
            <a:ext cx="46026" cy="130026"/>
          </a:xfrm>
          <a:custGeom>
            <a:avLst/>
            <a:gdLst/>
            <a:ahLst/>
            <a:cxnLst/>
            <a:rect l="l" t="t" r="r" b="b"/>
            <a:pathLst>
              <a:path w="50800" h="143510">
                <a:moveTo>
                  <a:pt x="33274" y="63500"/>
                </a:moveTo>
                <a:lnTo>
                  <a:pt x="17399" y="63500"/>
                </a:lnTo>
                <a:lnTo>
                  <a:pt x="17399" y="143004"/>
                </a:lnTo>
                <a:lnTo>
                  <a:pt x="33274" y="143004"/>
                </a:lnTo>
                <a:lnTo>
                  <a:pt x="33274" y="63500"/>
                </a:lnTo>
                <a:close/>
              </a:path>
              <a:path w="50800" h="143510">
                <a:moveTo>
                  <a:pt x="25400" y="0"/>
                </a:moveTo>
                <a:lnTo>
                  <a:pt x="0" y="76200"/>
                </a:lnTo>
                <a:lnTo>
                  <a:pt x="17399" y="76200"/>
                </a:lnTo>
                <a:lnTo>
                  <a:pt x="17399" y="63500"/>
                </a:lnTo>
                <a:lnTo>
                  <a:pt x="46566" y="63500"/>
                </a:lnTo>
                <a:lnTo>
                  <a:pt x="25400" y="0"/>
                </a:lnTo>
                <a:close/>
              </a:path>
              <a:path w="50800" h="143510">
                <a:moveTo>
                  <a:pt x="46566" y="63500"/>
                </a:moveTo>
                <a:lnTo>
                  <a:pt x="33274" y="63500"/>
                </a:lnTo>
                <a:lnTo>
                  <a:pt x="33274" y="76200"/>
                </a:lnTo>
                <a:lnTo>
                  <a:pt x="50800" y="76200"/>
                </a:lnTo>
                <a:lnTo>
                  <a:pt x="46566" y="6350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8" name="object 138"/>
          <p:cNvSpPr/>
          <p:nvPr/>
        </p:nvSpPr>
        <p:spPr>
          <a:xfrm>
            <a:off x="3612188" y="1493506"/>
            <a:ext cx="234736" cy="154650"/>
          </a:xfrm>
          <a:prstGeom prst="rect">
            <a:avLst/>
          </a:prstGeom>
          <a:blipFill>
            <a:blip r:embed="rId4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39" name="object 139"/>
          <p:cNvSpPr/>
          <p:nvPr/>
        </p:nvSpPr>
        <p:spPr>
          <a:xfrm>
            <a:off x="3521054" y="2367556"/>
            <a:ext cx="236117" cy="154650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sz="1631"/>
          </a:p>
        </p:txBody>
      </p:sp>
      <p:sp>
        <p:nvSpPr>
          <p:cNvPr id="140" name="object 140"/>
          <p:cNvSpPr txBox="1"/>
          <p:nvPr/>
        </p:nvSpPr>
        <p:spPr>
          <a:xfrm>
            <a:off x="3593200" y="2379752"/>
            <a:ext cx="222080" cy="602794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  <a:p>
            <a:pPr>
              <a:spcBef>
                <a:spcPts val="48"/>
              </a:spcBef>
            </a:pPr>
            <a:endParaRPr sz="951">
              <a:latin typeface="Times New Roman"/>
              <a:cs typeface="Times New Roman"/>
            </a:endParaRPr>
          </a:p>
          <a:p>
            <a:pPr marL="18411">
              <a:lnSpc>
                <a:spcPts val="1159"/>
              </a:lnSpc>
            </a:pPr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  <a:p>
            <a:pPr marL="146706">
              <a:lnSpc>
                <a:spcPts val="1159"/>
              </a:lnSpc>
            </a:pPr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3684334" y="1507084"/>
            <a:ext cx="86301" cy="15344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1506"/>
            <a:r>
              <a:rPr sz="997" b="1" dirty="0">
                <a:solidFill>
                  <a:srgbClr val="FFFFFF"/>
                </a:solidFill>
                <a:latin typeface="Calibri"/>
                <a:cs typeface="Calibri"/>
              </a:rPr>
              <a:t>*</a:t>
            </a:r>
            <a:endParaRPr sz="997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120</Words>
  <Application>Microsoft Office PowerPoint</Application>
  <PresentationFormat>A4 Paper (210x297 mm)</PresentationFormat>
  <Paragraphs>255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gency FB</vt:lpstr>
      <vt:lpstr>Aptos</vt:lpstr>
      <vt:lpstr>Arial</vt:lpstr>
      <vt:lpstr>Calibri</vt:lpstr>
      <vt:lpstr>Calibri Light</vt:lpstr>
      <vt:lpstr>Symbol</vt:lpstr>
      <vt:lpstr>Times New Roman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Wileman (MED - Staff)</dc:creator>
  <cp:lastModifiedBy>Srimeadhaa Omanakuttan (Integra)</cp:lastModifiedBy>
  <cp:revision>11</cp:revision>
  <dcterms:created xsi:type="dcterms:W3CDTF">2025-04-25T14:37:31Z</dcterms:created>
  <dcterms:modified xsi:type="dcterms:W3CDTF">2025-05-06T09:23:44Z</dcterms:modified>
</cp:coreProperties>
</file>